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1.xml" ContentType="application/vnd.openxmlformats-officedocument.drawingml.chartshapes+xml"/>
  <Override PartName="/ppt/notesSlides/notesSlide4.xml" ContentType="application/vnd.openxmlformats-officedocument.presentationml.notesSlide+xml"/>
  <Override PartName="/ppt/charts/chart3.xml" ContentType="application/vnd.openxmlformats-officedocument.drawingml.chart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56" r:id="rId2"/>
    <p:sldId id="257" r:id="rId3"/>
    <p:sldId id="258" r:id="rId4"/>
    <p:sldId id="261" r:id="rId5"/>
    <p:sldId id="268" r:id="rId6"/>
    <p:sldId id="269" r:id="rId7"/>
    <p:sldId id="266" r:id="rId8"/>
    <p:sldId id="270" r:id="rId9"/>
    <p:sldId id="267" r:id="rId10"/>
    <p:sldId id="264" r:id="rId11"/>
    <p:sldId id="265" r:id="rId12"/>
    <p:sldId id="260" r:id="rId13"/>
    <p:sldId id="262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sote, Deepak M" initials="KDM" lastIdx="2" clrIdx="0"/>
  <p:cmAuthor id="1" name="GK.Jay" initials="G" lastIdx="5" clrIdx="1">
    <p:extLst>
      <p:ext uri="{19B8F6BF-5375-455C-9EA6-DF929625EA0E}">
        <p15:presenceInfo xmlns:p15="http://schemas.microsoft.com/office/powerpoint/2012/main" userId="GK.Ja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9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eepakkasote06\Desktop\new%20leaf%20disc%20method\Final%20compiled%20results\Leaf%20disc%20water%20and%20MeOH%20mechanism.xlsx" TargetMode="External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eepakkasote06\Desktop\new%20leaf%20disc%20method\Final%20compiled%20results\Leaf%20disc%20water%20and%20MeOH%20mechanism.xlsx" TargetMode="External"/><Relationship Id="rId1" Type="http://schemas.openxmlformats.org/officeDocument/2006/relationships/themeOverride" Target="../theme/themeOverride4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eepakkasote06\Desktop\new%20leaf%20disc%20method\KMnO4%20reduing%20assay\Effect%20of%20ph%20on%20KmNO4%20stability.xls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012751531058618"/>
          <c:y val="6.5289442986293383E-2"/>
          <c:w val="0.62869116360454946"/>
          <c:h val="0.7344480898221055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1:5 dilution</c:v>
                </c:pt>
              </c:strCache>
            </c:strRef>
          </c:tx>
          <c:marker>
            <c:symbol val="none"/>
          </c:marker>
          <c:xVal>
            <c:numRef>
              <c:f>Sheet1!$A$3:$A$310</c:f>
              <c:numCache>
                <c:formatCode>General</c:formatCode>
                <c:ptCount val="308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</c:numCache>
            </c:numRef>
          </c:xVal>
          <c:yVal>
            <c:numRef>
              <c:f>Sheet1!$B$3:$B$310</c:f>
              <c:numCache>
                <c:formatCode>General</c:formatCode>
                <c:ptCount val="308"/>
                <c:pt idx="0">
                  <c:v>2.0539999999999998</c:v>
                </c:pt>
                <c:pt idx="1">
                  <c:v>2.0550000000000002</c:v>
                </c:pt>
                <c:pt idx="2">
                  <c:v>2.0529999999999999</c:v>
                </c:pt>
                <c:pt idx="3">
                  <c:v>2.0539999999999998</c:v>
                </c:pt>
                <c:pt idx="4">
                  <c:v>2.0529999999999999</c:v>
                </c:pt>
                <c:pt idx="5">
                  <c:v>2.0529999999999999</c:v>
                </c:pt>
                <c:pt idx="6">
                  <c:v>2.052</c:v>
                </c:pt>
                <c:pt idx="7">
                  <c:v>2.052</c:v>
                </c:pt>
                <c:pt idx="8">
                  <c:v>2.052</c:v>
                </c:pt>
                <c:pt idx="9">
                  <c:v>2.052</c:v>
                </c:pt>
                <c:pt idx="10">
                  <c:v>2.052</c:v>
                </c:pt>
                <c:pt idx="11">
                  <c:v>2.0510000000000002</c:v>
                </c:pt>
                <c:pt idx="12">
                  <c:v>2.0489999999999999</c:v>
                </c:pt>
                <c:pt idx="13">
                  <c:v>2.0510000000000002</c:v>
                </c:pt>
                <c:pt idx="14">
                  <c:v>2.0499999999999998</c:v>
                </c:pt>
                <c:pt idx="15">
                  <c:v>2.0499999999999998</c:v>
                </c:pt>
                <c:pt idx="16">
                  <c:v>2.0489999999999999</c:v>
                </c:pt>
                <c:pt idx="17">
                  <c:v>2.0489999999999999</c:v>
                </c:pt>
                <c:pt idx="18">
                  <c:v>2.0489999999999999</c:v>
                </c:pt>
                <c:pt idx="19">
                  <c:v>2.048</c:v>
                </c:pt>
                <c:pt idx="20">
                  <c:v>2.0489999999999999</c:v>
                </c:pt>
                <c:pt idx="21">
                  <c:v>2.048</c:v>
                </c:pt>
                <c:pt idx="22">
                  <c:v>2.0470000000000002</c:v>
                </c:pt>
                <c:pt idx="23">
                  <c:v>2.0470000000000002</c:v>
                </c:pt>
                <c:pt idx="24">
                  <c:v>2.0470000000000002</c:v>
                </c:pt>
                <c:pt idx="25">
                  <c:v>2.0470000000000002</c:v>
                </c:pt>
                <c:pt idx="26">
                  <c:v>2.0459999999999998</c:v>
                </c:pt>
                <c:pt idx="27">
                  <c:v>2.0459999999999998</c:v>
                </c:pt>
                <c:pt idx="28">
                  <c:v>2.0449999999999999</c:v>
                </c:pt>
                <c:pt idx="29">
                  <c:v>2.0459999999999998</c:v>
                </c:pt>
                <c:pt idx="30">
                  <c:v>2.0459999999999998</c:v>
                </c:pt>
                <c:pt idx="31">
                  <c:v>2.0449999999999999</c:v>
                </c:pt>
                <c:pt idx="32">
                  <c:v>2.0449999999999999</c:v>
                </c:pt>
                <c:pt idx="33">
                  <c:v>2.0449999999999999</c:v>
                </c:pt>
                <c:pt idx="34">
                  <c:v>2.0459999999999998</c:v>
                </c:pt>
                <c:pt idx="35">
                  <c:v>2.0449999999999999</c:v>
                </c:pt>
                <c:pt idx="36">
                  <c:v>2.0449999999999999</c:v>
                </c:pt>
                <c:pt idx="37">
                  <c:v>2.0449999999999999</c:v>
                </c:pt>
                <c:pt idx="38">
                  <c:v>2.0449999999999999</c:v>
                </c:pt>
                <c:pt idx="39">
                  <c:v>2.0449999999999999</c:v>
                </c:pt>
                <c:pt idx="40">
                  <c:v>2.0449999999999999</c:v>
                </c:pt>
                <c:pt idx="41">
                  <c:v>2.0459999999999998</c:v>
                </c:pt>
                <c:pt idx="42">
                  <c:v>2.048</c:v>
                </c:pt>
                <c:pt idx="43">
                  <c:v>2.0470000000000002</c:v>
                </c:pt>
                <c:pt idx="44">
                  <c:v>2.0470000000000002</c:v>
                </c:pt>
                <c:pt idx="45">
                  <c:v>2.0459999999999998</c:v>
                </c:pt>
                <c:pt idx="46">
                  <c:v>2.0459999999999998</c:v>
                </c:pt>
                <c:pt idx="47">
                  <c:v>2.0459999999999998</c:v>
                </c:pt>
                <c:pt idx="48">
                  <c:v>2.0459999999999998</c:v>
                </c:pt>
                <c:pt idx="49">
                  <c:v>2.0459999999999998</c:v>
                </c:pt>
                <c:pt idx="50">
                  <c:v>2.0459999999999998</c:v>
                </c:pt>
                <c:pt idx="51">
                  <c:v>2.0459999999999998</c:v>
                </c:pt>
                <c:pt idx="52">
                  <c:v>2.0449999999999999</c:v>
                </c:pt>
                <c:pt idx="53">
                  <c:v>2.044</c:v>
                </c:pt>
                <c:pt idx="54">
                  <c:v>2.0419999999999998</c:v>
                </c:pt>
                <c:pt idx="55">
                  <c:v>2.0419999999999998</c:v>
                </c:pt>
                <c:pt idx="56">
                  <c:v>2.0409999999999999</c:v>
                </c:pt>
                <c:pt idx="57">
                  <c:v>2.0419999999999998</c:v>
                </c:pt>
                <c:pt idx="58">
                  <c:v>2.0409999999999999</c:v>
                </c:pt>
                <c:pt idx="59">
                  <c:v>2.04</c:v>
                </c:pt>
                <c:pt idx="60">
                  <c:v>2.04</c:v>
                </c:pt>
                <c:pt idx="61">
                  <c:v>2.0379999999999998</c:v>
                </c:pt>
                <c:pt idx="62">
                  <c:v>2.0390000000000001</c:v>
                </c:pt>
                <c:pt idx="63">
                  <c:v>2.0390000000000001</c:v>
                </c:pt>
                <c:pt idx="64">
                  <c:v>2.0390000000000001</c:v>
                </c:pt>
                <c:pt idx="65">
                  <c:v>2.0390000000000001</c:v>
                </c:pt>
                <c:pt idx="66">
                  <c:v>2.0390000000000001</c:v>
                </c:pt>
                <c:pt idx="67">
                  <c:v>2.04</c:v>
                </c:pt>
                <c:pt idx="68">
                  <c:v>2.04</c:v>
                </c:pt>
                <c:pt idx="69">
                  <c:v>2.04</c:v>
                </c:pt>
                <c:pt idx="70">
                  <c:v>2.04</c:v>
                </c:pt>
                <c:pt idx="71">
                  <c:v>2.04</c:v>
                </c:pt>
                <c:pt idx="72">
                  <c:v>2.0409999999999999</c:v>
                </c:pt>
                <c:pt idx="73">
                  <c:v>2.0409999999999999</c:v>
                </c:pt>
                <c:pt idx="74">
                  <c:v>2.0409999999999999</c:v>
                </c:pt>
                <c:pt idx="75">
                  <c:v>2.0419999999999998</c:v>
                </c:pt>
                <c:pt idx="76">
                  <c:v>2.0409999999999999</c:v>
                </c:pt>
                <c:pt idx="77">
                  <c:v>2.04</c:v>
                </c:pt>
                <c:pt idx="78">
                  <c:v>2.0409999999999999</c:v>
                </c:pt>
                <c:pt idx="79">
                  <c:v>2.0409999999999999</c:v>
                </c:pt>
                <c:pt idx="80">
                  <c:v>2.0409999999999999</c:v>
                </c:pt>
                <c:pt idx="81">
                  <c:v>2.0409999999999999</c:v>
                </c:pt>
                <c:pt idx="82">
                  <c:v>2.0409999999999999</c:v>
                </c:pt>
                <c:pt idx="83">
                  <c:v>2.04</c:v>
                </c:pt>
                <c:pt idx="84">
                  <c:v>2.0409999999999999</c:v>
                </c:pt>
                <c:pt idx="85">
                  <c:v>2.04</c:v>
                </c:pt>
                <c:pt idx="86">
                  <c:v>2.04</c:v>
                </c:pt>
                <c:pt idx="87">
                  <c:v>2.0409999999999999</c:v>
                </c:pt>
                <c:pt idx="88">
                  <c:v>2.0409999999999999</c:v>
                </c:pt>
                <c:pt idx="89">
                  <c:v>2.04</c:v>
                </c:pt>
                <c:pt idx="90">
                  <c:v>2.04</c:v>
                </c:pt>
                <c:pt idx="91">
                  <c:v>2.0390000000000001</c:v>
                </c:pt>
                <c:pt idx="92">
                  <c:v>2.0390000000000001</c:v>
                </c:pt>
                <c:pt idx="93">
                  <c:v>2.0390000000000001</c:v>
                </c:pt>
                <c:pt idx="94">
                  <c:v>2.0379999999999998</c:v>
                </c:pt>
                <c:pt idx="95">
                  <c:v>2.0379999999999998</c:v>
                </c:pt>
                <c:pt idx="96">
                  <c:v>2.0379999999999998</c:v>
                </c:pt>
                <c:pt idx="97">
                  <c:v>2.0379999999999998</c:v>
                </c:pt>
                <c:pt idx="98">
                  <c:v>2.0379999999999998</c:v>
                </c:pt>
                <c:pt idx="99">
                  <c:v>2.0369999999999999</c:v>
                </c:pt>
                <c:pt idx="100">
                  <c:v>2.0369999999999999</c:v>
                </c:pt>
                <c:pt idx="101">
                  <c:v>2.0369999999999999</c:v>
                </c:pt>
                <c:pt idx="102">
                  <c:v>2.0369999999999999</c:v>
                </c:pt>
                <c:pt idx="103">
                  <c:v>2.0369999999999999</c:v>
                </c:pt>
                <c:pt idx="104">
                  <c:v>2.0369999999999999</c:v>
                </c:pt>
                <c:pt idx="105">
                  <c:v>2.036</c:v>
                </c:pt>
                <c:pt idx="106">
                  <c:v>2.0350000000000001</c:v>
                </c:pt>
                <c:pt idx="107">
                  <c:v>2.0350000000000001</c:v>
                </c:pt>
                <c:pt idx="108">
                  <c:v>2.0350000000000001</c:v>
                </c:pt>
                <c:pt idx="109">
                  <c:v>2.0350000000000001</c:v>
                </c:pt>
                <c:pt idx="110">
                  <c:v>2.0350000000000001</c:v>
                </c:pt>
                <c:pt idx="111">
                  <c:v>2.0350000000000001</c:v>
                </c:pt>
                <c:pt idx="112">
                  <c:v>2.0339999999999998</c:v>
                </c:pt>
                <c:pt idx="113">
                  <c:v>2.0339999999999998</c:v>
                </c:pt>
                <c:pt idx="114">
                  <c:v>2.0339999999999998</c:v>
                </c:pt>
                <c:pt idx="115">
                  <c:v>2.0329999999999999</c:v>
                </c:pt>
                <c:pt idx="116">
                  <c:v>2.0329999999999999</c:v>
                </c:pt>
                <c:pt idx="117">
                  <c:v>2.0329999999999999</c:v>
                </c:pt>
                <c:pt idx="118">
                  <c:v>2.0329999999999999</c:v>
                </c:pt>
                <c:pt idx="119">
                  <c:v>2.0310000000000001</c:v>
                </c:pt>
                <c:pt idx="120">
                  <c:v>2.0310000000000001</c:v>
                </c:pt>
                <c:pt idx="121">
                  <c:v>2.0329999999999999</c:v>
                </c:pt>
                <c:pt idx="122">
                  <c:v>2.032</c:v>
                </c:pt>
                <c:pt idx="123">
                  <c:v>2.032</c:v>
                </c:pt>
                <c:pt idx="124">
                  <c:v>2.0299999999999998</c:v>
                </c:pt>
                <c:pt idx="125">
                  <c:v>2.0299999999999998</c:v>
                </c:pt>
                <c:pt idx="126">
                  <c:v>2.0299999999999998</c:v>
                </c:pt>
                <c:pt idx="127">
                  <c:v>2.0299999999999998</c:v>
                </c:pt>
                <c:pt idx="128">
                  <c:v>2.0299999999999998</c:v>
                </c:pt>
                <c:pt idx="129">
                  <c:v>2.0310000000000001</c:v>
                </c:pt>
                <c:pt idx="130">
                  <c:v>2.0299999999999998</c:v>
                </c:pt>
                <c:pt idx="131">
                  <c:v>2.0289999999999999</c:v>
                </c:pt>
                <c:pt idx="132">
                  <c:v>2.028</c:v>
                </c:pt>
                <c:pt idx="133">
                  <c:v>2.0289999999999999</c:v>
                </c:pt>
                <c:pt idx="134">
                  <c:v>2.0299999999999998</c:v>
                </c:pt>
                <c:pt idx="135">
                  <c:v>2.028</c:v>
                </c:pt>
                <c:pt idx="136">
                  <c:v>2.0289999999999999</c:v>
                </c:pt>
                <c:pt idx="137">
                  <c:v>2.0270000000000001</c:v>
                </c:pt>
                <c:pt idx="138">
                  <c:v>2.028</c:v>
                </c:pt>
                <c:pt idx="139">
                  <c:v>2.028</c:v>
                </c:pt>
                <c:pt idx="140">
                  <c:v>2.028</c:v>
                </c:pt>
                <c:pt idx="141">
                  <c:v>2.0270000000000001</c:v>
                </c:pt>
                <c:pt idx="142">
                  <c:v>2.0259999999999998</c:v>
                </c:pt>
                <c:pt idx="143">
                  <c:v>2.0270000000000001</c:v>
                </c:pt>
                <c:pt idx="144">
                  <c:v>2.0270000000000001</c:v>
                </c:pt>
                <c:pt idx="145">
                  <c:v>2.0270000000000001</c:v>
                </c:pt>
                <c:pt idx="146">
                  <c:v>2.0270000000000001</c:v>
                </c:pt>
                <c:pt idx="147">
                  <c:v>2.0259999999999998</c:v>
                </c:pt>
                <c:pt idx="148">
                  <c:v>2.024</c:v>
                </c:pt>
                <c:pt idx="149">
                  <c:v>2.0249999999999999</c:v>
                </c:pt>
                <c:pt idx="150">
                  <c:v>2.0259999999999998</c:v>
                </c:pt>
                <c:pt idx="151">
                  <c:v>2.0249999999999999</c:v>
                </c:pt>
                <c:pt idx="152">
                  <c:v>2.0259999999999998</c:v>
                </c:pt>
                <c:pt idx="153">
                  <c:v>2.024</c:v>
                </c:pt>
                <c:pt idx="154">
                  <c:v>2.0230000000000001</c:v>
                </c:pt>
                <c:pt idx="155">
                  <c:v>2.024</c:v>
                </c:pt>
                <c:pt idx="156">
                  <c:v>2.0230000000000001</c:v>
                </c:pt>
                <c:pt idx="157">
                  <c:v>2.0219999999999998</c:v>
                </c:pt>
                <c:pt idx="158">
                  <c:v>2.0230000000000001</c:v>
                </c:pt>
                <c:pt idx="159">
                  <c:v>2.0219999999999998</c:v>
                </c:pt>
                <c:pt idx="160">
                  <c:v>2.0219999999999998</c:v>
                </c:pt>
                <c:pt idx="161">
                  <c:v>2.0219999999999998</c:v>
                </c:pt>
                <c:pt idx="162">
                  <c:v>2.0209999999999999</c:v>
                </c:pt>
                <c:pt idx="163">
                  <c:v>2.0209999999999999</c:v>
                </c:pt>
                <c:pt idx="164">
                  <c:v>2.02</c:v>
                </c:pt>
                <c:pt idx="165">
                  <c:v>2.02</c:v>
                </c:pt>
                <c:pt idx="166">
                  <c:v>2.0190000000000001</c:v>
                </c:pt>
                <c:pt idx="167">
                  <c:v>2.0190000000000001</c:v>
                </c:pt>
                <c:pt idx="168">
                  <c:v>2.0190000000000001</c:v>
                </c:pt>
                <c:pt idx="169">
                  <c:v>2.0179999999999998</c:v>
                </c:pt>
                <c:pt idx="170">
                  <c:v>2.0169999999999999</c:v>
                </c:pt>
                <c:pt idx="171">
                  <c:v>2.016</c:v>
                </c:pt>
                <c:pt idx="172">
                  <c:v>2.016</c:v>
                </c:pt>
                <c:pt idx="173">
                  <c:v>2.016</c:v>
                </c:pt>
                <c:pt idx="174">
                  <c:v>2.016</c:v>
                </c:pt>
                <c:pt idx="175">
                  <c:v>2.0139999999999998</c:v>
                </c:pt>
                <c:pt idx="176">
                  <c:v>2.0139999999999998</c:v>
                </c:pt>
                <c:pt idx="177">
                  <c:v>2.0150000000000001</c:v>
                </c:pt>
                <c:pt idx="178">
                  <c:v>2.0129999999999999</c:v>
                </c:pt>
                <c:pt idx="179">
                  <c:v>2.012</c:v>
                </c:pt>
                <c:pt idx="180">
                  <c:v>2.012</c:v>
                </c:pt>
                <c:pt idx="181">
                  <c:v>2.0099999999999998</c:v>
                </c:pt>
                <c:pt idx="182">
                  <c:v>2.0099999999999998</c:v>
                </c:pt>
                <c:pt idx="183">
                  <c:v>2.0099999999999998</c:v>
                </c:pt>
                <c:pt idx="184">
                  <c:v>2.008</c:v>
                </c:pt>
                <c:pt idx="185">
                  <c:v>2.008</c:v>
                </c:pt>
                <c:pt idx="186">
                  <c:v>2.0070000000000001</c:v>
                </c:pt>
                <c:pt idx="187">
                  <c:v>2.0059999999999998</c:v>
                </c:pt>
                <c:pt idx="188">
                  <c:v>2.0049999999999999</c:v>
                </c:pt>
                <c:pt idx="189">
                  <c:v>2.0030000000000001</c:v>
                </c:pt>
                <c:pt idx="190">
                  <c:v>2.0030000000000001</c:v>
                </c:pt>
                <c:pt idx="191">
                  <c:v>2.0009999999999999</c:v>
                </c:pt>
                <c:pt idx="192">
                  <c:v>2.0009999999999999</c:v>
                </c:pt>
                <c:pt idx="193">
                  <c:v>1.9990000000000001</c:v>
                </c:pt>
                <c:pt idx="194">
                  <c:v>1.9990000000000001</c:v>
                </c:pt>
                <c:pt idx="195">
                  <c:v>1.9970000000000001</c:v>
                </c:pt>
                <c:pt idx="196">
                  <c:v>1.9970000000000001</c:v>
                </c:pt>
                <c:pt idx="197">
                  <c:v>1.994</c:v>
                </c:pt>
                <c:pt idx="198">
                  <c:v>1.9930000000000001</c:v>
                </c:pt>
                <c:pt idx="199">
                  <c:v>1.9930000000000001</c:v>
                </c:pt>
                <c:pt idx="200">
                  <c:v>2.0019999999999998</c:v>
                </c:pt>
                <c:pt idx="201">
                  <c:v>2.0129999999999999</c:v>
                </c:pt>
                <c:pt idx="202">
                  <c:v>2.0099999999999998</c:v>
                </c:pt>
                <c:pt idx="203">
                  <c:v>2.008</c:v>
                </c:pt>
                <c:pt idx="204">
                  <c:v>2.0070000000000001</c:v>
                </c:pt>
                <c:pt idx="205">
                  <c:v>2.0049999999999999</c:v>
                </c:pt>
                <c:pt idx="206">
                  <c:v>2.0030000000000001</c:v>
                </c:pt>
                <c:pt idx="207">
                  <c:v>2</c:v>
                </c:pt>
                <c:pt idx="208">
                  <c:v>1.998</c:v>
                </c:pt>
                <c:pt idx="209">
                  <c:v>1.9950000000000001</c:v>
                </c:pt>
                <c:pt idx="210">
                  <c:v>1.994</c:v>
                </c:pt>
                <c:pt idx="211">
                  <c:v>1.9910000000000001</c:v>
                </c:pt>
                <c:pt idx="212">
                  <c:v>1.9890000000000001</c:v>
                </c:pt>
                <c:pt idx="213">
                  <c:v>1.9850000000000001</c:v>
                </c:pt>
                <c:pt idx="214">
                  <c:v>1.982</c:v>
                </c:pt>
                <c:pt idx="215">
                  <c:v>1.978</c:v>
                </c:pt>
                <c:pt idx="216">
                  <c:v>1.9750000000000001</c:v>
                </c:pt>
                <c:pt idx="217">
                  <c:v>1.9710000000000001</c:v>
                </c:pt>
                <c:pt idx="218">
                  <c:v>1.9670000000000001</c:v>
                </c:pt>
                <c:pt idx="219">
                  <c:v>1.962</c:v>
                </c:pt>
                <c:pt idx="220">
                  <c:v>1.958</c:v>
                </c:pt>
                <c:pt idx="221">
                  <c:v>1.954</c:v>
                </c:pt>
                <c:pt idx="222">
                  <c:v>1.95</c:v>
                </c:pt>
                <c:pt idx="223">
                  <c:v>1.9450000000000001</c:v>
                </c:pt>
                <c:pt idx="224">
                  <c:v>1.94</c:v>
                </c:pt>
                <c:pt idx="225">
                  <c:v>1.9359999999999999</c:v>
                </c:pt>
                <c:pt idx="226">
                  <c:v>1.93</c:v>
                </c:pt>
                <c:pt idx="227">
                  <c:v>1.925</c:v>
                </c:pt>
                <c:pt idx="228">
                  <c:v>1.919</c:v>
                </c:pt>
                <c:pt idx="229">
                  <c:v>1.9119999999999999</c:v>
                </c:pt>
                <c:pt idx="230">
                  <c:v>1.905</c:v>
                </c:pt>
                <c:pt idx="231">
                  <c:v>1.897</c:v>
                </c:pt>
                <c:pt idx="232">
                  <c:v>1.89</c:v>
                </c:pt>
                <c:pt idx="233">
                  <c:v>1.8819999999999999</c:v>
                </c:pt>
                <c:pt idx="234">
                  <c:v>1.873</c:v>
                </c:pt>
                <c:pt idx="235">
                  <c:v>1.8640000000000001</c:v>
                </c:pt>
                <c:pt idx="236">
                  <c:v>1.855</c:v>
                </c:pt>
                <c:pt idx="237">
                  <c:v>1.8440000000000001</c:v>
                </c:pt>
                <c:pt idx="238">
                  <c:v>1.8340000000000001</c:v>
                </c:pt>
                <c:pt idx="239">
                  <c:v>1.8240000000000001</c:v>
                </c:pt>
                <c:pt idx="240">
                  <c:v>1.8120000000000001</c:v>
                </c:pt>
                <c:pt idx="241">
                  <c:v>1.8009999999999999</c:v>
                </c:pt>
                <c:pt idx="242">
                  <c:v>1.7889999999999999</c:v>
                </c:pt>
                <c:pt idx="243">
                  <c:v>1.7769999999999999</c:v>
                </c:pt>
                <c:pt idx="244">
                  <c:v>1.7649999999999999</c:v>
                </c:pt>
                <c:pt idx="245">
                  <c:v>1.752</c:v>
                </c:pt>
                <c:pt idx="246">
                  <c:v>1.7390000000000001</c:v>
                </c:pt>
                <c:pt idx="247">
                  <c:v>1.7250000000000001</c:v>
                </c:pt>
                <c:pt idx="248">
                  <c:v>1.7110000000000001</c:v>
                </c:pt>
                <c:pt idx="249">
                  <c:v>1.6970000000000001</c:v>
                </c:pt>
                <c:pt idx="250">
                  <c:v>1.6819999999999999</c:v>
                </c:pt>
                <c:pt idx="251">
                  <c:v>1.667</c:v>
                </c:pt>
                <c:pt idx="252">
                  <c:v>1.651</c:v>
                </c:pt>
                <c:pt idx="253">
                  <c:v>1.635</c:v>
                </c:pt>
                <c:pt idx="254">
                  <c:v>1.62</c:v>
                </c:pt>
                <c:pt idx="255">
                  <c:v>1.6040000000000001</c:v>
                </c:pt>
                <c:pt idx="256">
                  <c:v>1.587</c:v>
                </c:pt>
                <c:pt idx="257">
                  <c:v>1.57</c:v>
                </c:pt>
                <c:pt idx="258">
                  <c:v>1.5529999999999999</c:v>
                </c:pt>
                <c:pt idx="259">
                  <c:v>1.536</c:v>
                </c:pt>
                <c:pt idx="260">
                  <c:v>1.52</c:v>
                </c:pt>
                <c:pt idx="261">
                  <c:v>1.502</c:v>
                </c:pt>
                <c:pt idx="262">
                  <c:v>1.486</c:v>
                </c:pt>
                <c:pt idx="263">
                  <c:v>1.468</c:v>
                </c:pt>
                <c:pt idx="264">
                  <c:v>1.45</c:v>
                </c:pt>
                <c:pt idx="265">
                  <c:v>1.4330000000000001</c:v>
                </c:pt>
                <c:pt idx="266">
                  <c:v>1.4159999999999999</c:v>
                </c:pt>
                <c:pt idx="267">
                  <c:v>1.3979999999999999</c:v>
                </c:pt>
                <c:pt idx="268">
                  <c:v>1.38</c:v>
                </c:pt>
                <c:pt idx="269">
                  <c:v>1.3620000000000001</c:v>
                </c:pt>
                <c:pt idx="270">
                  <c:v>1.3440000000000001</c:v>
                </c:pt>
                <c:pt idx="271">
                  <c:v>1.3260000000000001</c:v>
                </c:pt>
                <c:pt idx="272">
                  <c:v>1.3069999999999999</c:v>
                </c:pt>
                <c:pt idx="273">
                  <c:v>1.2889999999999999</c:v>
                </c:pt>
                <c:pt idx="274">
                  <c:v>1.27</c:v>
                </c:pt>
                <c:pt idx="275">
                  <c:v>1.25</c:v>
                </c:pt>
                <c:pt idx="276">
                  <c:v>1.232</c:v>
                </c:pt>
                <c:pt idx="277">
                  <c:v>1.2130000000000001</c:v>
                </c:pt>
                <c:pt idx="278">
                  <c:v>1.1950000000000001</c:v>
                </c:pt>
                <c:pt idx="279">
                  <c:v>1.177</c:v>
                </c:pt>
                <c:pt idx="280">
                  <c:v>1.159</c:v>
                </c:pt>
                <c:pt idx="281">
                  <c:v>1.141</c:v>
                </c:pt>
                <c:pt idx="282">
                  <c:v>1.1240000000000001</c:v>
                </c:pt>
                <c:pt idx="283">
                  <c:v>1.1060000000000001</c:v>
                </c:pt>
                <c:pt idx="284">
                  <c:v>1.089</c:v>
                </c:pt>
                <c:pt idx="285">
                  <c:v>1.0720000000000001</c:v>
                </c:pt>
                <c:pt idx="286">
                  <c:v>1.054</c:v>
                </c:pt>
                <c:pt idx="287">
                  <c:v>1.0369999999999999</c:v>
                </c:pt>
                <c:pt idx="288">
                  <c:v>1.02</c:v>
                </c:pt>
                <c:pt idx="289">
                  <c:v>1.0029999999999999</c:v>
                </c:pt>
                <c:pt idx="290">
                  <c:v>0.98499999999999999</c:v>
                </c:pt>
                <c:pt idx="291">
                  <c:v>0.96799999999999997</c:v>
                </c:pt>
                <c:pt idx="292">
                  <c:v>0.94899999999999995</c:v>
                </c:pt>
                <c:pt idx="293">
                  <c:v>0.93200000000000005</c:v>
                </c:pt>
                <c:pt idx="294">
                  <c:v>0.91500000000000004</c:v>
                </c:pt>
                <c:pt idx="295">
                  <c:v>0.89800000000000002</c:v>
                </c:pt>
                <c:pt idx="296">
                  <c:v>0.88100000000000001</c:v>
                </c:pt>
                <c:pt idx="297">
                  <c:v>0.86499999999999999</c:v>
                </c:pt>
                <c:pt idx="298">
                  <c:v>0.84899999999999998</c:v>
                </c:pt>
                <c:pt idx="299">
                  <c:v>0.83299999999999996</c:v>
                </c:pt>
                <c:pt idx="300">
                  <c:v>0.816999999999999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CCF8-4C26-A940-2CDBC6DE740D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1:10 dilution</c:v>
                </c:pt>
              </c:strCache>
            </c:strRef>
          </c:tx>
          <c:spPr>
            <a:ln>
              <a:prstDash val="sysDot"/>
            </a:ln>
          </c:spPr>
          <c:marker>
            <c:symbol val="none"/>
          </c:marker>
          <c:xVal>
            <c:numRef>
              <c:f>Sheet1!$A$3:$A$310</c:f>
              <c:numCache>
                <c:formatCode>General</c:formatCode>
                <c:ptCount val="308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</c:numCache>
            </c:numRef>
          </c:xVal>
          <c:yVal>
            <c:numRef>
              <c:f>Sheet1!$C$3:$C$310</c:f>
              <c:numCache>
                <c:formatCode>General</c:formatCode>
                <c:ptCount val="308"/>
                <c:pt idx="0">
                  <c:v>1.8240000000000001</c:v>
                </c:pt>
                <c:pt idx="1">
                  <c:v>1.8240000000000001</c:v>
                </c:pt>
                <c:pt idx="2">
                  <c:v>1.823</c:v>
                </c:pt>
                <c:pt idx="3">
                  <c:v>1.823</c:v>
                </c:pt>
                <c:pt idx="4">
                  <c:v>1.821</c:v>
                </c:pt>
                <c:pt idx="5">
                  <c:v>1.821</c:v>
                </c:pt>
                <c:pt idx="6">
                  <c:v>1.821</c:v>
                </c:pt>
                <c:pt idx="7">
                  <c:v>1.82</c:v>
                </c:pt>
                <c:pt idx="8">
                  <c:v>1.82</c:v>
                </c:pt>
                <c:pt idx="9">
                  <c:v>1.819</c:v>
                </c:pt>
                <c:pt idx="10">
                  <c:v>1.82</c:v>
                </c:pt>
                <c:pt idx="11">
                  <c:v>1.82</c:v>
                </c:pt>
                <c:pt idx="12">
                  <c:v>1.82</c:v>
                </c:pt>
                <c:pt idx="13">
                  <c:v>1.82</c:v>
                </c:pt>
                <c:pt idx="14">
                  <c:v>1.821</c:v>
                </c:pt>
                <c:pt idx="15">
                  <c:v>1.821</c:v>
                </c:pt>
                <c:pt idx="16">
                  <c:v>1.8220000000000001</c:v>
                </c:pt>
                <c:pt idx="17">
                  <c:v>1.8220000000000001</c:v>
                </c:pt>
                <c:pt idx="18">
                  <c:v>1.823</c:v>
                </c:pt>
                <c:pt idx="19">
                  <c:v>1.8240000000000001</c:v>
                </c:pt>
                <c:pt idx="20">
                  <c:v>1.825</c:v>
                </c:pt>
                <c:pt idx="21">
                  <c:v>1.8260000000000001</c:v>
                </c:pt>
                <c:pt idx="22">
                  <c:v>1.827</c:v>
                </c:pt>
                <c:pt idx="23">
                  <c:v>1.829</c:v>
                </c:pt>
                <c:pt idx="24">
                  <c:v>1.831</c:v>
                </c:pt>
                <c:pt idx="25">
                  <c:v>1.8320000000000001</c:v>
                </c:pt>
                <c:pt idx="26">
                  <c:v>1.8340000000000001</c:v>
                </c:pt>
                <c:pt idx="27">
                  <c:v>1.8360000000000001</c:v>
                </c:pt>
                <c:pt idx="28">
                  <c:v>1.8380000000000001</c:v>
                </c:pt>
                <c:pt idx="29">
                  <c:v>1.841</c:v>
                </c:pt>
                <c:pt idx="30">
                  <c:v>1.843</c:v>
                </c:pt>
                <c:pt idx="31">
                  <c:v>1.8460000000000001</c:v>
                </c:pt>
                <c:pt idx="32">
                  <c:v>1.8480000000000001</c:v>
                </c:pt>
                <c:pt idx="33">
                  <c:v>1.851</c:v>
                </c:pt>
                <c:pt idx="34">
                  <c:v>1.853</c:v>
                </c:pt>
                <c:pt idx="35">
                  <c:v>1.857</c:v>
                </c:pt>
                <c:pt idx="36">
                  <c:v>1.86</c:v>
                </c:pt>
                <c:pt idx="37">
                  <c:v>1.863</c:v>
                </c:pt>
                <c:pt idx="38">
                  <c:v>1.867</c:v>
                </c:pt>
                <c:pt idx="39">
                  <c:v>1.871</c:v>
                </c:pt>
                <c:pt idx="40">
                  <c:v>1.8740000000000001</c:v>
                </c:pt>
                <c:pt idx="41">
                  <c:v>1.879</c:v>
                </c:pt>
                <c:pt idx="42">
                  <c:v>1.8819999999999999</c:v>
                </c:pt>
                <c:pt idx="43">
                  <c:v>1.8859999999999999</c:v>
                </c:pt>
                <c:pt idx="44">
                  <c:v>1.889</c:v>
                </c:pt>
                <c:pt idx="45">
                  <c:v>1.8919999999999999</c:v>
                </c:pt>
                <c:pt idx="46">
                  <c:v>1.895</c:v>
                </c:pt>
                <c:pt idx="47">
                  <c:v>1.899</c:v>
                </c:pt>
                <c:pt idx="48">
                  <c:v>1.9019999999999999</c:v>
                </c:pt>
                <c:pt idx="49">
                  <c:v>1.9059999999999999</c:v>
                </c:pt>
                <c:pt idx="50">
                  <c:v>1.909</c:v>
                </c:pt>
                <c:pt idx="51">
                  <c:v>1.9119999999999999</c:v>
                </c:pt>
                <c:pt idx="52">
                  <c:v>1.9139999999999999</c:v>
                </c:pt>
                <c:pt idx="53">
                  <c:v>1.917</c:v>
                </c:pt>
                <c:pt idx="54">
                  <c:v>1.919</c:v>
                </c:pt>
                <c:pt idx="55">
                  <c:v>1.921</c:v>
                </c:pt>
                <c:pt idx="56">
                  <c:v>1.9239999999999999</c:v>
                </c:pt>
                <c:pt idx="57">
                  <c:v>1.925</c:v>
                </c:pt>
                <c:pt idx="58">
                  <c:v>1.9259999999999999</c:v>
                </c:pt>
                <c:pt idx="59">
                  <c:v>1.9279999999999999</c:v>
                </c:pt>
                <c:pt idx="60">
                  <c:v>1.929</c:v>
                </c:pt>
                <c:pt idx="61">
                  <c:v>1.93</c:v>
                </c:pt>
                <c:pt idx="62">
                  <c:v>1.9319999999999999</c:v>
                </c:pt>
                <c:pt idx="63">
                  <c:v>1.9350000000000001</c:v>
                </c:pt>
                <c:pt idx="64">
                  <c:v>1.9359999999999999</c:v>
                </c:pt>
                <c:pt idx="65">
                  <c:v>1.9370000000000001</c:v>
                </c:pt>
                <c:pt idx="66">
                  <c:v>1.9379999999999999</c:v>
                </c:pt>
                <c:pt idx="67">
                  <c:v>1.9390000000000001</c:v>
                </c:pt>
                <c:pt idx="68">
                  <c:v>1.94</c:v>
                </c:pt>
                <c:pt idx="69">
                  <c:v>1.94</c:v>
                </c:pt>
                <c:pt idx="70">
                  <c:v>1.94</c:v>
                </c:pt>
                <c:pt idx="71">
                  <c:v>1.94</c:v>
                </c:pt>
                <c:pt idx="72">
                  <c:v>1.9410000000000001</c:v>
                </c:pt>
                <c:pt idx="73">
                  <c:v>1.94</c:v>
                </c:pt>
                <c:pt idx="74">
                  <c:v>1.94</c:v>
                </c:pt>
                <c:pt idx="75">
                  <c:v>1.9379999999999999</c:v>
                </c:pt>
                <c:pt idx="76">
                  <c:v>1.9370000000000001</c:v>
                </c:pt>
                <c:pt idx="77">
                  <c:v>1.9350000000000001</c:v>
                </c:pt>
                <c:pt idx="78">
                  <c:v>1.9339999999999999</c:v>
                </c:pt>
                <c:pt idx="79">
                  <c:v>1.9319999999999999</c:v>
                </c:pt>
                <c:pt idx="80">
                  <c:v>1.931</c:v>
                </c:pt>
                <c:pt idx="81">
                  <c:v>1.929</c:v>
                </c:pt>
                <c:pt idx="82">
                  <c:v>1.9259999999999999</c:v>
                </c:pt>
                <c:pt idx="83">
                  <c:v>1.9239999999999999</c:v>
                </c:pt>
                <c:pt idx="84">
                  <c:v>1.921</c:v>
                </c:pt>
                <c:pt idx="85">
                  <c:v>1.919</c:v>
                </c:pt>
                <c:pt idx="86">
                  <c:v>1.9159999999999999</c:v>
                </c:pt>
                <c:pt idx="87">
                  <c:v>1.913</c:v>
                </c:pt>
                <c:pt idx="88">
                  <c:v>1.91</c:v>
                </c:pt>
                <c:pt idx="89">
                  <c:v>1.907</c:v>
                </c:pt>
                <c:pt idx="90">
                  <c:v>1.903</c:v>
                </c:pt>
                <c:pt idx="91">
                  <c:v>1.899</c:v>
                </c:pt>
                <c:pt idx="92">
                  <c:v>1.8959999999999999</c:v>
                </c:pt>
                <c:pt idx="93">
                  <c:v>1.8919999999999999</c:v>
                </c:pt>
                <c:pt idx="94">
                  <c:v>1.889</c:v>
                </c:pt>
                <c:pt idx="95">
                  <c:v>1.885</c:v>
                </c:pt>
                <c:pt idx="96">
                  <c:v>1.881</c:v>
                </c:pt>
                <c:pt idx="97">
                  <c:v>1.877</c:v>
                </c:pt>
                <c:pt idx="98">
                  <c:v>1.8740000000000001</c:v>
                </c:pt>
                <c:pt idx="99">
                  <c:v>1.87</c:v>
                </c:pt>
                <c:pt idx="100">
                  <c:v>1.8660000000000001</c:v>
                </c:pt>
                <c:pt idx="101">
                  <c:v>1.863</c:v>
                </c:pt>
                <c:pt idx="102">
                  <c:v>1.86</c:v>
                </c:pt>
                <c:pt idx="103">
                  <c:v>1.8560000000000001</c:v>
                </c:pt>
                <c:pt idx="104">
                  <c:v>1.8520000000000001</c:v>
                </c:pt>
                <c:pt idx="105">
                  <c:v>1.849</c:v>
                </c:pt>
                <c:pt idx="106">
                  <c:v>1.845</c:v>
                </c:pt>
                <c:pt idx="107">
                  <c:v>1.8420000000000001</c:v>
                </c:pt>
                <c:pt idx="108">
                  <c:v>1.839</c:v>
                </c:pt>
                <c:pt idx="109">
                  <c:v>1.8360000000000001</c:v>
                </c:pt>
                <c:pt idx="110">
                  <c:v>1.833</c:v>
                </c:pt>
                <c:pt idx="111">
                  <c:v>1.83</c:v>
                </c:pt>
                <c:pt idx="112">
                  <c:v>1.827</c:v>
                </c:pt>
                <c:pt idx="113">
                  <c:v>1.8240000000000001</c:v>
                </c:pt>
                <c:pt idx="114">
                  <c:v>1.8220000000000001</c:v>
                </c:pt>
                <c:pt idx="115">
                  <c:v>1.819</c:v>
                </c:pt>
                <c:pt idx="116">
                  <c:v>1.8169999999999999</c:v>
                </c:pt>
                <c:pt idx="117">
                  <c:v>1.8149999999999999</c:v>
                </c:pt>
                <c:pt idx="118">
                  <c:v>1.8129999999999999</c:v>
                </c:pt>
                <c:pt idx="119">
                  <c:v>1.8109999999999999</c:v>
                </c:pt>
                <c:pt idx="120">
                  <c:v>1.81</c:v>
                </c:pt>
                <c:pt idx="121">
                  <c:v>1.8089999999999999</c:v>
                </c:pt>
                <c:pt idx="122">
                  <c:v>1.8080000000000001</c:v>
                </c:pt>
                <c:pt idx="123">
                  <c:v>1.8069999999999999</c:v>
                </c:pt>
                <c:pt idx="124">
                  <c:v>1.806</c:v>
                </c:pt>
                <c:pt idx="125">
                  <c:v>1.806</c:v>
                </c:pt>
                <c:pt idx="126">
                  <c:v>1.806</c:v>
                </c:pt>
                <c:pt idx="127">
                  <c:v>1.8069999999999999</c:v>
                </c:pt>
                <c:pt idx="128">
                  <c:v>1.8069999999999999</c:v>
                </c:pt>
                <c:pt idx="129">
                  <c:v>1.8069999999999999</c:v>
                </c:pt>
                <c:pt idx="130">
                  <c:v>1.8080000000000001</c:v>
                </c:pt>
                <c:pt idx="131">
                  <c:v>1.8089999999999999</c:v>
                </c:pt>
                <c:pt idx="132">
                  <c:v>1.8109999999999999</c:v>
                </c:pt>
                <c:pt idx="133">
                  <c:v>1.8129999999999999</c:v>
                </c:pt>
                <c:pt idx="134">
                  <c:v>1.8140000000000001</c:v>
                </c:pt>
                <c:pt idx="135">
                  <c:v>1.8149999999999999</c:v>
                </c:pt>
                <c:pt idx="136">
                  <c:v>1.8169999999999999</c:v>
                </c:pt>
                <c:pt idx="137">
                  <c:v>1.819</c:v>
                </c:pt>
                <c:pt idx="138">
                  <c:v>1.821</c:v>
                </c:pt>
                <c:pt idx="139">
                  <c:v>1.823</c:v>
                </c:pt>
                <c:pt idx="140">
                  <c:v>1.8240000000000001</c:v>
                </c:pt>
                <c:pt idx="141">
                  <c:v>1.8260000000000001</c:v>
                </c:pt>
                <c:pt idx="142">
                  <c:v>1.8280000000000001</c:v>
                </c:pt>
                <c:pt idx="143">
                  <c:v>1.83</c:v>
                </c:pt>
                <c:pt idx="144">
                  <c:v>1.8320000000000001</c:v>
                </c:pt>
                <c:pt idx="145">
                  <c:v>1.833</c:v>
                </c:pt>
                <c:pt idx="146">
                  <c:v>1.835</c:v>
                </c:pt>
                <c:pt idx="147">
                  <c:v>1.8360000000000001</c:v>
                </c:pt>
                <c:pt idx="148">
                  <c:v>1.8360000000000001</c:v>
                </c:pt>
                <c:pt idx="149">
                  <c:v>1.837</c:v>
                </c:pt>
                <c:pt idx="150">
                  <c:v>1.8380000000000001</c:v>
                </c:pt>
                <c:pt idx="151">
                  <c:v>1.8380000000000001</c:v>
                </c:pt>
                <c:pt idx="152">
                  <c:v>1.8380000000000001</c:v>
                </c:pt>
                <c:pt idx="153">
                  <c:v>1.837</c:v>
                </c:pt>
                <c:pt idx="154">
                  <c:v>1.837</c:v>
                </c:pt>
                <c:pt idx="155">
                  <c:v>1.835</c:v>
                </c:pt>
                <c:pt idx="156">
                  <c:v>1.8340000000000001</c:v>
                </c:pt>
                <c:pt idx="157">
                  <c:v>1.8320000000000001</c:v>
                </c:pt>
                <c:pt idx="158">
                  <c:v>1.83</c:v>
                </c:pt>
                <c:pt idx="159">
                  <c:v>1.8280000000000001</c:v>
                </c:pt>
                <c:pt idx="160">
                  <c:v>1.825</c:v>
                </c:pt>
                <c:pt idx="161">
                  <c:v>1.8220000000000001</c:v>
                </c:pt>
                <c:pt idx="162">
                  <c:v>1.819</c:v>
                </c:pt>
                <c:pt idx="163">
                  <c:v>1.8149999999999999</c:v>
                </c:pt>
                <c:pt idx="164">
                  <c:v>1.8109999999999999</c:v>
                </c:pt>
                <c:pt idx="165">
                  <c:v>1.806</c:v>
                </c:pt>
                <c:pt idx="166">
                  <c:v>1.802</c:v>
                </c:pt>
                <c:pt idx="167">
                  <c:v>1.796</c:v>
                </c:pt>
                <c:pt idx="168">
                  <c:v>1.7909999999999999</c:v>
                </c:pt>
                <c:pt idx="169">
                  <c:v>1.7849999999999999</c:v>
                </c:pt>
                <c:pt idx="170">
                  <c:v>1.7789999999999999</c:v>
                </c:pt>
                <c:pt idx="171">
                  <c:v>1.7729999999999999</c:v>
                </c:pt>
                <c:pt idx="172">
                  <c:v>1.766</c:v>
                </c:pt>
                <c:pt idx="173">
                  <c:v>1.7589999999999999</c:v>
                </c:pt>
                <c:pt idx="174">
                  <c:v>1.752</c:v>
                </c:pt>
                <c:pt idx="175">
                  <c:v>1.7450000000000001</c:v>
                </c:pt>
                <c:pt idx="176">
                  <c:v>1.7370000000000001</c:v>
                </c:pt>
                <c:pt idx="177">
                  <c:v>1.7290000000000001</c:v>
                </c:pt>
                <c:pt idx="178">
                  <c:v>1.7210000000000001</c:v>
                </c:pt>
                <c:pt idx="179">
                  <c:v>1.714</c:v>
                </c:pt>
                <c:pt idx="180">
                  <c:v>1.7050000000000001</c:v>
                </c:pt>
                <c:pt idx="181">
                  <c:v>1.6970000000000001</c:v>
                </c:pt>
                <c:pt idx="182">
                  <c:v>1.6890000000000001</c:v>
                </c:pt>
                <c:pt idx="183">
                  <c:v>1.681</c:v>
                </c:pt>
                <c:pt idx="184">
                  <c:v>1.6739999999999999</c:v>
                </c:pt>
                <c:pt idx="185">
                  <c:v>1.665</c:v>
                </c:pt>
                <c:pt idx="186">
                  <c:v>1.657</c:v>
                </c:pt>
                <c:pt idx="187">
                  <c:v>1.649</c:v>
                </c:pt>
                <c:pt idx="188">
                  <c:v>1.64</c:v>
                </c:pt>
                <c:pt idx="189">
                  <c:v>1.6319999999999999</c:v>
                </c:pt>
                <c:pt idx="190">
                  <c:v>1.6240000000000001</c:v>
                </c:pt>
                <c:pt idx="191">
                  <c:v>1.6160000000000001</c:v>
                </c:pt>
                <c:pt idx="192">
                  <c:v>1.607</c:v>
                </c:pt>
                <c:pt idx="193">
                  <c:v>1.599</c:v>
                </c:pt>
                <c:pt idx="194">
                  <c:v>1.591</c:v>
                </c:pt>
                <c:pt idx="195">
                  <c:v>1.5820000000000001</c:v>
                </c:pt>
                <c:pt idx="196">
                  <c:v>1.575</c:v>
                </c:pt>
                <c:pt idx="197">
                  <c:v>1.5660000000000001</c:v>
                </c:pt>
                <c:pt idx="198">
                  <c:v>1.5580000000000001</c:v>
                </c:pt>
                <c:pt idx="199">
                  <c:v>1.556</c:v>
                </c:pt>
                <c:pt idx="200">
                  <c:v>1.55</c:v>
                </c:pt>
                <c:pt idx="201">
                  <c:v>1.542</c:v>
                </c:pt>
                <c:pt idx="202">
                  <c:v>1.534</c:v>
                </c:pt>
                <c:pt idx="203">
                  <c:v>1.5249999999999999</c:v>
                </c:pt>
                <c:pt idx="204">
                  <c:v>1.518</c:v>
                </c:pt>
                <c:pt idx="205">
                  <c:v>1.5089999999999999</c:v>
                </c:pt>
                <c:pt idx="206">
                  <c:v>1.5009999999999999</c:v>
                </c:pt>
                <c:pt idx="207">
                  <c:v>1.4930000000000001</c:v>
                </c:pt>
                <c:pt idx="208">
                  <c:v>1.484</c:v>
                </c:pt>
                <c:pt idx="209">
                  <c:v>1.4750000000000001</c:v>
                </c:pt>
                <c:pt idx="210">
                  <c:v>1.4670000000000001</c:v>
                </c:pt>
                <c:pt idx="211">
                  <c:v>1.4570000000000001</c:v>
                </c:pt>
                <c:pt idx="212">
                  <c:v>1.448</c:v>
                </c:pt>
                <c:pt idx="213">
                  <c:v>1.4379999999999999</c:v>
                </c:pt>
                <c:pt idx="214">
                  <c:v>1.4279999999999999</c:v>
                </c:pt>
                <c:pt idx="215">
                  <c:v>1.4179999999999999</c:v>
                </c:pt>
                <c:pt idx="216">
                  <c:v>1.4079999999999999</c:v>
                </c:pt>
                <c:pt idx="217">
                  <c:v>1.397</c:v>
                </c:pt>
                <c:pt idx="218">
                  <c:v>1.3859999999999999</c:v>
                </c:pt>
                <c:pt idx="219">
                  <c:v>1.375</c:v>
                </c:pt>
                <c:pt idx="220">
                  <c:v>1.3640000000000001</c:v>
                </c:pt>
                <c:pt idx="221">
                  <c:v>1.3540000000000001</c:v>
                </c:pt>
                <c:pt idx="222">
                  <c:v>1.343</c:v>
                </c:pt>
                <c:pt idx="223">
                  <c:v>1.333</c:v>
                </c:pt>
                <c:pt idx="224">
                  <c:v>1.3220000000000001</c:v>
                </c:pt>
                <c:pt idx="225">
                  <c:v>1.3109999999999999</c:v>
                </c:pt>
                <c:pt idx="226">
                  <c:v>1.3</c:v>
                </c:pt>
                <c:pt idx="227">
                  <c:v>1.288</c:v>
                </c:pt>
                <c:pt idx="228">
                  <c:v>1.276</c:v>
                </c:pt>
                <c:pt idx="229">
                  <c:v>1.2629999999999999</c:v>
                </c:pt>
                <c:pt idx="230">
                  <c:v>1.2509999999999999</c:v>
                </c:pt>
                <c:pt idx="231">
                  <c:v>1.238</c:v>
                </c:pt>
                <c:pt idx="232">
                  <c:v>1.224</c:v>
                </c:pt>
                <c:pt idx="233">
                  <c:v>1.2110000000000001</c:v>
                </c:pt>
                <c:pt idx="234">
                  <c:v>1.198</c:v>
                </c:pt>
                <c:pt idx="235">
                  <c:v>1.1830000000000001</c:v>
                </c:pt>
                <c:pt idx="236">
                  <c:v>1.169</c:v>
                </c:pt>
                <c:pt idx="237">
                  <c:v>1.155</c:v>
                </c:pt>
                <c:pt idx="238">
                  <c:v>1.141</c:v>
                </c:pt>
                <c:pt idx="239">
                  <c:v>1.127</c:v>
                </c:pt>
                <c:pt idx="240">
                  <c:v>1.1140000000000001</c:v>
                </c:pt>
                <c:pt idx="241">
                  <c:v>1.1000000000000001</c:v>
                </c:pt>
                <c:pt idx="242">
                  <c:v>1.087</c:v>
                </c:pt>
                <c:pt idx="243">
                  <c:v>1.073</c:v>
                </c:pt>
                <c:pt idx="244">
                  <c:v>1.06</c:v>
                </c:pt>
                <c:pt idx="245">
                  <c:v>1.046</c:v>
                </c:pt>
                <c:pt idx="246">
                  <c:v>1.0329999999999999</c:v>
                </c:pt>
                <c:pt idx="247">
                  <c:v>1.0189999999999999</c:v>
                </c:pt>
                <c:pt idx="248">
                  <c:v>1.0049999999999999</c:v>
                </c:pt>
                <c:pt idx="249">
                  <c:v>0.99099999999999999</c:v>
                </c:pt>
                <c:pt idx="250">
                  <c:v>0.97799999999999998</c:v>
                </c:pt>
                <c:pt idx="251">
                  <c:v>0.96399999999999997</c:v>
                </c:pt>
                <c:pt idx="252">
                  <c:v>0.95099999999999996</c:v>
                </c:pt>
                <c:pt idx="253">
                  <c:v>0.93799999999999994</c:v>
                </c:pt>
                <c:pt idx="254">
                  <c:v>0.92400000000000004</c:v>
                </c:pt>
                <c:pt idx="255">
                  <c:v>0.91100000000000003</c:v>
                </c:pt>
                <c:pt idx="256">
                  <c:v>0.89800000000000002</c:v>
                </c:pt>
                <c:pt idx="257">
                  <c:v>0.88500000000000001</c:v>
                </c:pt>
                <c:pt idx="258">
                  <c:v>0.873</c:v>
                </c:pt>
                <c:pt idx="259">
                  <c:v>0.86</c:v>
                </c:pt>
                <c:pt idx="260">
                  <c:v>0.84699999999999998</c:v>
                </c:pt>
                <c:pt idx="261">
                  <c:v>0.83499999999999996</c:v>
                </c:pt>
                <c:pt idx="262">
                  <c:v>0.82299999999999995</c:v>
                </c:pt>
                <c:pt idx="263">
                  <c:v>0.81</c:v>
                </c:pt>
                <c:pt idx="264">
                  <c:v>0.79900000000000004</c:v>
                </c:pt>
                <c:pt idx="265">
                  <c:v>0.78700000000000003</c:v>
                </c:pt>
                <c:pt idx="266">
                  <c:v>0.77500000000000002</c:v>
                </c:pt>
                <c:pt idx="267">
                  <c:v>0.76300000000000001</c:v>
                </c:pt>
                <c:pt idx="268">
                  <c:v>0.751</c:v>
                </c:pt>
                <c:pt idx="269">
                  <c:v>0.73899999999999999</c:v>
                </c:pt>
                <c:pt idx="270">
                  <c:v>0.72699999999999998</c:v>
                </c:pt>
                <c:pt idx="271">
                  <c:v>0.71499999999999997</c:v>
                </c:pt>
                <c:pt idx="272">
                  <c:v>0.70299999999999996</c:v>
                </c:pt>
                <c:pt idx="273">
                  <c:v>0.69099999999999995</c:v>
                </c:pt>
                <c:pt idx="274">
                  <c:v>0.68</c:v>
                </c:pt>
                <c:pt idx="275">
                  <c:v>0.66800000000000004</c:v>
                </c:pt>
                <c:pt idx="276">
                  <c:v>0.65700000000000003</c:v>
                </c:pt>
                <c:pt idx="277">
                  <c:v>0.64600000000000002</c:v>
                </c:pt>
                <c:pt idx="278">
                  <c:v>0.63400000000000001</c:v>
                </c:pt>
                <c:pt idx="279">
                  <c:v>0.623</c:v>
                </c:pt>
                <c:pt idx="280">
                  <c:v>0.623</c:v>
                </c:pt>
                <c:pt idx="281">
                  <c:v>0.61199999999999999</c:v>
                </c:pt>
                <c:pt idx="282">
                  <c:v>0.60099999999999998</c:v>
                </c:pt>
                <c:pt idx="283">
                  <c:v>0.59099999999999997</c:v>
                </c:pt>
                <c:pt idx="284">
                  <c:v>0.58099999999999996</c:v>
                </c:pt>
                <c:pt idx="285">
                  <c:v>0.56999999999999995</c:v>
                </c:pt>
                <c:pt idx="286">
                  <c:v>0.56000000000000005</c:v>
                </c:pt>
                <c:pt idx="287">
                  <c:v>0.55000000000000004</c:v>
                </c:pt>
                <c:pt idx="288">
                  <c:v>0.54</c:v>
                </c:pt>
                <c:pt idx="289">
                  <c:v>0.52900000000000003</c:v>
                </c:pt>
                <c:pt idx="290">
                  <c:v>0.51900000000000002</c:v>
                </c:pt>
                <c:pt idx="291">
                  <c:v>0.50900000000000001</c:v>
                </c:pt>
                <c:pt idx="292">
                  <c:v>0.499</c:v>
                </c:pt>
                <c:pt idx="293">
                  <c:v>0.48899999999999999</c:v>
                </c:pt>
                <c:pt idx="294">
                  <c:v>0.47899999999999998</c:v>
                </c:pt>
                <c:pt idx="295">
                  <c:v>0.46899999999999997</c:v>
                </c:pt>
                <c:pt idx="296">
                  <c:v>0.45900000000000002</c:v>
                </c:pt>
                <c:pt idx="297">
                  <c:v>0.45</c:v>
                </c:pt>
                <c:pt idx="298">
                  <c:v>0.44</c:v>
                </c:pt>
                <c:pt idx="299">
                  <c:v>0.43099999999999999</c:v>
                </c:pt>
                <c:pt idx="300">
                  <c:v>0.42199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CCF8-4C26-A940-2CDBC6DE740D}"/>
            </c:ext>
          </c:extLst>
        </c:ser>
        <c:ser>
          <c:idx val="2"/>
          <c:order val="2"/>
          <c:tx>
            <c:strRef>
              <c:f>Sheet1!$D$2</c:f>
              <c:strCache>
                <c:ptCount val="1"/>
                <c:pt idx="0">
                  <c:v>1:15 dilution</c:v>
                </c:pt>
              </c:strCache>
            </c:strRef>
          </c:tx>
          <c:spPr>
            <a:ln>
              <a:prstDash val="sysDash"/>
            </a:ln>
          </c:spPr>
          <c:marker>
            <c:symbol val="none"/>
          </c:marker>
          <c:xVal>
            <c:numRef>
              <c:f>Sheet1!$A$3:$A$310</c:f>
              <c:numCache>
                <c:formatCode>General</c:formatCode>
                <c:ptCount val="308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</c:numCache>
            </c:numRef>
          </c:xVal>
          <c:yVal>
            <c:numRef>
              <c:f>Sheet1!$D$3:$D$310</c:f>
              <c:numCache>
                <c:formatCode>General</c:formatCode>
                <c:ptCount val="308"/>
                <c:pt idx="0">
                  <c:v>1.397</c:v>
                </c:pt>
                <c:pt idx="1">
                  <c:v>1.397</c:v>
                </c:pt>
                <c:pt idx="2">
                  <c:v>1.3959999999999999</c:v>
                </c:pt>
                <c:pt idx="3">
                  <c:v>1.395</c:v>
                </c:pt>
                <c:pt idx="4">
                  <c:v>1.3939999999999999</c:v>
                </c:pt>
                <c:pt idx="5">
                  <c:v>1.393</c:v>
                </c:pt>
                <c:pt idx="6">
                  <c:v>1.3919999999999999</c:v>
                </c:pt>
                <c:pt idx="7">
                  <c:v>1.3919999999999999</c:v>
                </c:pt>
                <c:pt idx="8">
                  <c:v>1.391</c:v>
                </c:pt>
                <c:pt idx="9">
                  <c:v>1.391</c:v>
                </c:pt>
                <c:pt idx="10">
                  <c:v>1.39</c:v>
                </c:pt>
                <c:pt idx="11">
                  <c:v>1.39</c:v>
                </c:pt>
                <c:pt idx="12">
                  <c:v>1.39</c:v>
                </c:pt>
                <c:pt idx="13">
                  <c:v>1.39</c:v>
                </c:pt>
                <c:pt idx="14">
                  <c:v>1.39</c:v>
                </c:pt>
                <c:pt idx="15">
                  <c:v>1.391</c:v>
                </c:pt>
                <c:pt idx="16">
                  <c:v>1.391</c:v>
                </c:pt>
                <c:pt idx="17">
                  <c:v>1.3919999999999999</c:v>
                </c:pt>
                <c:pt idx="18">
                  <c:v>1.393</c:v>
                </c:pt>
                <c:pt idx="19">
                  <c:v>1.3939999999999999</c:v>
                </c:pt>
                <c:pt idx="20">
                  <c:v>1.395</c:v>
                </c:pt>
                <c:pt idx="21">
                  <c:v>1.3959999999999999</c:v>
                </c:pt>
                <c:pt idx="22">
                  <c:v>1.3979999999999999</c:v>
                </c:pt>
                <c:pt idx="23">
                  <c:v>1.4</c:v>
                </c:pt>
                <c:pt idx="24">
                  <c:v>1.401</c:v>
                </c:pt>
                <c:pt idx="25">
                  <c:v>1.403</c:v>
                </c:pt>
                <c:pt idx="26">
                  <c:v>1.405</c:v>
                </c:pt>
                <c:pt idx="27">
                  <c:v>1.4079999999999999</c:v>
                </c:pt>
                <c:pt idx="28">
                  <c:v>1.41</c:v>
                </c:pt>
                <c:pt idx="29">
                  <c:v>1.413</c:v>
                </c:pt>
                <c:pt idx="30">
                  <c:v>1.4159999999999999</c:v>
                </c:pt>
                <c:pt idx="31">
                  <c:v>1.419</c:v>
                </c:pt>
                <c:pt idx="32">
                  <c:v>1.423</c:v>
                </c:pt>
                <c:pt idx="33">
                  <c:v>1.4259999999999999</c:v>
                </c:pt>
                <c:pt idx="34">
                  <c:v>1.43</c:v>
                </c:pt>
                <c:pt idx="35">
                  <c:v>1.4339999999999999</c:v>
                </c:pt>
                <c:pt idx="36">
                  <c:v>1.4390000000000001</c:v>
                </c:pt>
                <c:pt idx="37">
                  <c:v>1.4430000000000001</c:v>
                </c:pt>
                <c:pt idx="38">
                  <c:v>1.448</c:v>
                </c:pt>
                <c:pt idx="39">
                  <c:v>1.4530000000000001</c:v>
                </c:pt>
                <c:pt idx="40">
                  <c:v>1.458</c:v>
                </c:pt>
                <c:pt idx="41">
                  <c:v>1.462</c:v>
                </c:pt>
                <c:pt idx="42">
                  <c:v>1.4690000000000001</c:v>
                </c:pt>
                <c:pt idx="43">
                  <c:v>1.474</c:v>
                </c:pt>
                <c:pt idx="44">
                  <c:v>1.4790000000000001</c:v>
                </c:pt>
                <c:pt idx="45">
                  <c:v>1.4850000000000001</c:v>
                </c:pt>
                <c:pt idx="46">
                  <c:v>1.4910000000000001</c:v>
                </c:pt>
                <c:pt idx="47">
                  <c:v>1.496</c:v>
                </c:pt>
                <c:pt idx="48">
                  <c:v>1.502</c:v>
                </c:pt>
                <c:pt idx="49">
                  <c:v>1.5089999999999999</c:v>
                </c:pt>
                <c:pt idx="50">
                  <c:v>1.514</c:v>
                </c:pt>
                <c:pt idx="51">
                  <c:v>1.5209999999999999</c:v>
                </c:pt>
                <c:pt idx="52">
                  <c:v>1.5269999999999999</c:v>
                </c:pt>
                <c:pt idx="53">
                  <c:v>1.532</c:v>
                </c:pt>
                <c:pt idx="54">
                  <c:v>1.538</c:v>
                </c:pt>
                <c:pt idx="55">
                  <c:v>1.5429999999999999</c:v>
                </c:pt>
                <c:pt idx="56">
                  <c:v>1.548</c:v>
                </c:pt>
                <c:pt idx="57">
                  <c:v>1.5529999999999999</c:v>
                </c:pt>
                <c:pt idx="58">
                  <c:v>1.5569999999999999</c:v>
                </c:pt>
                <c:pt idx="59">
                  <c:v>1.5609999999999999</c:v>
                </c:pt>
                <c:pt idx="60">
                  <c:v>1.5649999999999999</c:v>
                </c:pt>
                <c:pt idx="61">
                  <c:v>1.5680000000000001</c:v>
                </c:pt>
                <c:pt idx="62">
                  <c:v>1.5720000000000001</c:v>
                </c:pt>
                <c:pt idx="63">
                  <c:v>1.575</c:v>
                </c:pt>
                <c:pt idx="64">
                  <c:v>1.5780000000000001</c:v>
                </c:pt>
                <c:pt idx="65">
                  <c:v>1.5820000000000001</c:v>
                </c:pt>
                <c:pt idx="66">
                  <c:v>1.5840000000000001</c:v>
                </c:pt>
                <c:pt idx="67">
                  <c:v>1.5860000000000001</c:v>
                </c:pt>
                <c:pt idx="68">
                  <c:v>1.5880000000000001</c:v>
                </c:pt>
                <c:pt idx="69">
                  <c:v>1.589</c:v>
                </c:pt>
                <c:pt idx="70">
                  <c:v>1.59</c:v>
                </c:pt>
                <c:pt idx="71">
                  <c:v>1.59</c:v>
                </c:pt>
                <c:pt idx="72">
                  <c:v>1.59</c:v>
                </c:pt>
                <c:pt idx="73">
                  <c:v>1.59</c:v>
                </c:pt>
                <c:pt idx="74">
                  <c:v>1.589</c:v>
                </c:pt>
                <c:pt idx="75">
                  <c:v>1.587</c:v>
                </c:pt>
                <c:pt idx="76">
                  <c:v>1.585</c:v>
                </c:pt>
                <c:pt idx="77">
                  <c:v>1.5820000000000001</c:v>
                </c:pt>
                <c:pt idx="78">
                  <c:v>1.579</c:v>
                </c:pt>
                <c:pt idx="79">
                  <c:v>1.5760000000000001</c:v>
                </c:pt>
                <c:pt idx="80">
                  <c:v>1.5720000000000001</c:v>
                </c:pt>
                <c:pt idx="81">
                  <c:v>1.5680000000000001</c:v>
                </c:pt>
                <c:pt idx="82">
                  <c:v>1.5640000000000001</c:v>
                </c:pt>
                <c:pt idx="83">
                  <c:v>1.5589999999999999</c:v>
                </c:pt>
                <c:pt idx="84">
                  <c:v>1.554</c:v>
                </c:pt>
                <c:pt idx="85">
                  <c:v>1.5489999999999999</c:v>
                </c:pt>
                <c:pt idx="86">
                  <c:v>1.544</c:v>
                </c:pt>
                <c:pt idx="87">
                  <c:v>1.538</c:v>
                </c:pt>
                <c:pt idx="88">
                  <c:v>1.5329999999999999</c:v>
                </c:pt>
                <c:pt idx="89">
                  <c:v>1.5269999999999999</c:v>
                </c:pt>
                <c:pt idx="90">
                  <c:v>1.52</c:v>
                </c:pt>
                <c:pt idx="91">
                  <c:v>1.514</c:v>
                </c:pt>
                <c:pt idx="92">
                  <c:v>1.5069999999999999</c:v>
                </c:pt>
                <c:pt idx="93">
                  <c:v>1.5009999999999999</c:v>
                </c:pt>
                <c:pt idx="94">
                  <c:v>1.494</c:v>
                </c:pt>
                <c:pt idx="95">
                  <c:v>1.488</c:v>
                </c:pt>
                <c:pt idx="96">
                  <c:v>1.482</c:v>
                </c:pt>
                <c:pt idx="97">
                  <c:v>1.4750000000000001</c:v>
                </c:pt>
                <c:pt idx="98">
                  <c:v>1.4690000000000001</c:v>
                </c:pt>
                <c:pt idx="99">
                  <c:v>1.4630000000000001</c:v>
                </c:pt>
                <c:pt idx="100">
                  <c:v>1.4570000000000001</c:v>
                </c:pt>
                <c:pt idx="101">
                  <c:v>1.4510000000000001</c:v>
                </c:pt>
                <c:pt idx="102">
                  <c:v>1.446</c:v>
                </c:pt>
                <c:pt idx="103">
                  <c:v>1.44</c:v>
                </c:pt>
                <c:pt idx="104">
                  <c:v>1.4350000000000001</c:v>
                </c:pt>
                <c:pt idx="105">
                  <c:v>1.429</c:v>
                </c:pt>
                <c:pt idx="106">
                  <c:v>1.4239999999999999</c:v>
                </c:pt>
                <c:pt idx="107">
                  <c:v>1.42</c:v>
                </c:pt>
                <c:pt idx="108">
                  <c:v>1.415</c:v>
                </c:pt>
                <c:pt idx="109">
                  <c:v>1.41</c:v>
                </c:pt>
                <c:pt idx="110">
                  <c:v>1.405</c:v>
                </c:pt>
                <c:pt idx="111">
                  <c:v>1.401</c:v>
                </c:pt>
                <c:pt idx="112">
                  <c:v>1.397</c:v>
                </c:pt>
                <c:pt idx="113">
                  <c:v>1.3919999999999999</c:v>
                </c:pt>
                <c:pt idx="114">
                  <c:v>1.389</c:v>
                </c:pt>
                <c:pt idx="115">
                  <c:v>1.385</c:v>
                </c:pt>
                <c:pt idx="116">
                  <c:v>1.3819999999999999</c:v>
                </c:pt>
                <c:pt idx="117">
                  <c:v>1.379</c:v>
                </c:pt>
                <c:pt idx="118">
                  <c:v>1.3759999999999999</c:v>
                </c:pt>
                <c:pt idx="119">
                  <c:v>1.3740000000000001</c:v>
                </c:pt>
                <c:pt idx="120">
                  <c:v>1.3720000000000001</c:v>
                </c:pt>
                <c:pt idx="121">
                  <c:v>1.37</c:v>
                </c:pt>
                <c:pt idx="122">
                  <c:v>1.3680000000000001</c:v>
                </c:pt>
                <c:pt idx="123">
                  <c:v>1.367</c:v>
                </c:pt>
                <c:pt idx="124">
                  <c:v>1.3660000000000001</c:v>
                </c:pt>
                <c:pt idx="125">
                  <c:v>1.3660000000000001</c:v>
                </c:pt>
                <c:pt idx="126">
                  <c:v>1.365</c:v>
                </c:pt>
                <c:pt idx="127">
                  <c:v>1.3660000000000001</c:v>
                </c:pt>
                <c:pt idx="128">
                  <c:v>1.3660000000000001</c:v>
                </c:pt>
                <c:pt idx="129">
                  <c:v>1.367</c:v>
                </c:pt>
                <c:pt idx="130">
                  <c:v>1.3680000000000001</c:v>
                </c:pt>
                <c:pt idx="131">
                  <c:v>1.369</c:v>
                </c:pt>
                <c:pt idx="132">
                  <c:v>1.371</c:v>
                </c:pt>
                <c:pt idx="133">
                  <c:v>1.373</c:v>
                </c:pt>
                <c:pt idx="134">
                  <c:v>1.375</c:v>
                </c:pt>
                <c:pt idx="135">
                  <c:v>1.3779999999999999</c:v>
                </c:pt>
                <c:pt idx="136">
                  <c:v>1.38</c:v>
                </c:pt>
                <c:pt idx="137">
                  <c:v>1.383</c:v>
                </c:pt>
                <c:pt idx="138">
                  <c:v>1.3859999999999999</c:v>
                </c:pt>
                <c:pt idx="139">
                  <c:v>1.389</c:v>
                </c:pt>
                <c:pt idx="140">
                  <c:v>1.393</c:v>
                </c:pt>
                <c:pt idx="141">
                  <c:v>1.3959999999999999</c:v>
                </c:pt>
                <c:pt idx="142">
                  <c:v>1.399</c:v>
                </c:pt>
                <c:pt idx="143">
                  <c:v>1.4019999999999999</c:v>
                </c:pt>
                <c:pt idx="144">
                  <c:v>1.405</c:v>
                </c:pt>
                <c:pt idx="145">
                  <c:v>1.407</c:v>
                </c:pt>
                <c:pt idx="146">
                  <c:v>1.41</c:v>
                </c:pt>
                <c:pt idx="147">
                  <c:v>1.413</c:v>
                </c:pt>
                <c:pt idx="148">
                  <c:v>1.415</c:v>
                </c:pt>
                <c:pt idx="149">
                  <c:v>1.417</c:v>
                </c:pt>
                <c:pt idx="150">
                  <c:v>1.4179999999999999</c:v>
                </c:pt>
                <c:pt idx="151">
                  <c:v>1.419</c:v>
                </c:pt>
                <c:pt idx="152">
                  <c:v>1.42</c:v>
                </c:pt>
                <c:pt idx="153">
                  <c:v>1.42</c:v>
                </c:pt>
                <c:pt idx="154">
                  <c:v>1.42</c:v>
                </c:pt>
                <c:pt idx="155">
                  <c:v>1.42</c:v>
                </c:pt>
                <c:pt idx="156">
                  <c:v>1.419</c:v>
                </c:pt>
                <c:pt idx="157">
                  <c:v>1.417</c:v>
                </c:pt>
                <c:pt idx="158">
                  <c:v>1.415</c:v>
                </c:pt>
                <c:pt idx="159">
                  <c:v>1.4119999999999999</c:v>
                </c:pt>
                <c:pt idx="160">
                  <c:v>1.409</c:v>
                </c:pt>
                <c:pt idx="161">
                  <c:v>1.405</c:v>
                </c:pt>
                <c:pt idx="162">
                  <c:v>1.401</c:v>
                </c:pt>
                <c:pt idx="163">
                  <c:v>1.3959999999999999</c:v>
                </c:pt>
                <c:pt idx="164">
                  <c:v>1.391</c:v>
                </c:pt>
                <c:pt idx="165">
                  <c:v>1.3859999999999999</c:v>
                </c:pt>
                <c:pt idx="166">
                  <c:v>1.38</c:v>
                </c:pt>
                <c:pt idx="167">
                  <c:v>1.3740000000000001</c:v>
                </c:pt>
                <c:pt idx="168">
                  <c:v>1.367</c:v>
                </c:pt>
                <c:pt idx="169">
                  <c:v>1.36</c:v>
                </c:pt>
                <c:pt idx="170">
                  <c:v>1.3520000000000001</c:v>
                </c:pt>
                <c:pt idx="171">
                  <c:v>1.345</c:v>
                </c:pt>
                <c:pt idx="172">
                  <c:v>1.337</c:v>
                </c:pt>
                <c:pt idx="173">
                  <c:v>1.3280000000000001</c:v>
                </c:pt>
                <c:pt idx="174">
                  <c:v>1.32</c:v>
                </c:pt>
                <c:pt idx="175">
                  <c:v>1.3109999999999999</c:v>
                </c:pt>
                <c:pt idx="176">
                  <c:v>1.3029999999999999</c:v>
                </c:pt>
                <c:pt idx="177">
                  <c:v>1.294</c:v>
                </c:pt>
                <c:pt idx="178">
                  <c:v>1.2849999999999999</c:v>
                </c:pt>
                <c:pt idx="179">
                  <c:v>1.276</c:v>
                </c:pt>
                <c:pt idx="180">
                  <c:v>1.2669999999999999</c:v>
                </c:pt>
                <c:pt idx="181">
                  <c:v>1.258</c:v>
                </c:pt>
                <c:pt idx="182">
                  <c:v>1.2490000000000001</c:v>
                </c:pt>
                <c:pt idx="183">
                  <c:v>1.2410000000000001</c:v>
                </c:pt>
                <c:pt idx="184">
                  <c:v>1.232</c:v>
                </c:pt>
                <c:pt idx="185">
                  <c:v>1.224</c:v>
                </c:pt>
                <c:pt idx="186">
                  <c:v>1.2150000000000001</c:v>
                </c:pt>
                <c:pt idx="187">
                  <c:v>1.2070000000000001</c:v>
                </c:pt>
                <c:pt idx="188">
                  <c:v>1.198</c:v>
                </c:pt>
                <c:pt idx="189">
                  <c:v>1.19</c:v>
                </c:pt>
                <c:pt idx="190">
                  <c:v>1.1819999999999999</c:v>
                </c:pt>
                <c:pt idx="191">
                  <c:v>1.1739999999999999</c:v>
                </c:pt>
                <c:pt idx="192">
                  <c:v>1.1659999999999999</c:v>
                </c:pt>
                <c:pt idx="193">
                  <c:v>1.1579999999999999</c:v>
                </c:pt>
                <c:pt idx="194">
                  <c:v>1.1499999999999999</c:v>
                </c:pt>
                <c:pt idx="195">
                  <c:v>1.143</c:v>
                </c:pt>
                <c:pt idx="196">
                  <c:v>1.135</c:v>
                </c:pt>
                <c:pt idx="197">
                  <c:v>1.1279999999999999</c:v>
                </c:pt>
                <c:pt idx="198">
                  <c:v>1.1200000000000001</c:v>
                </c:pt>
                <c:pt idx="199">
                  <c:v>1.113</c:v>
                </c:pt>
                <c:pt idx="200">
                  <c:v>1.1080000000000001</c:v>
                </c:pt>
                <c:pt idx="201">
                  <c:v>1.1000000000000001</c:v>
                </c:pt>
                <c:pt idx="202">
                  <c:v>1.093</c:v>
                </c:pt>
                <c:pt idx="203">
                  <c:v>1.087</c:v>
                </c:pt>
                <c:pt idx="204">
                  <c:v>1.08</c:v>
                </c:pt>
                <c:pt idx="205">
                  <c:v>1.073</c:v>
                </c:pt>
                <c:pt idx="206">
                  <c:v>1.0660000000000001</c:v>
                </c:pt>
                <c:pt idx="207">
                  <c:v>1.0589999999999999</c:v>
                </c:pt>
                <c:pt idx="208">
                  <c:v>1.0529999999999999</c:v>
                </c:pt>
                <c:pt idx="209">
                  <c:v>1.046</c:v>
                </c:pt>
                <c:pt idx="210">
                  <c:v>1.038</c:v>
                </c:pt>
                <c:pt idx="211">
                  <c:v>1.03</c:v>
                </c:pt>
                <c:pt idx="212">
                  <c:v>1.0229999999999999</c:v>
                </c:pt>
                <c:pt idx="213">
                  <c:v>1.0149999999999999</c:v>
                </c:pt>
                <c:pt idx="214">
                  <c:v>1.0069999999999999</c:v>
                </c:pt>
                <c:pt idx="215">
                  <c:v>0.999</c:v>
                </c:pt>
                <c:pt idx="216">
                  <c:v>0.99099999999999999</c:v>
                </c:pt>
                <c:pt idx="217">
                  <c:v>0.98199999999999998</c:v>
                </c:pt>
                <c:pt idx="218">
                  <c:v>0.97399999999999998</c:v>
                </c:pt>
                <c:pt idx="219">
                  <c:v>0.96499999999999997</c:v>
                </c:pt>
                <c:pt idx="220">
                  <c:v>0.95699999999999996</c:v>
                </c:pt>
                <c:pt idx="221">
                  <c:v>0.94899999999999995</c:v>
                </c:pt>
                <c:pt idx="222">
                  <c:v>0.94</c:v>
                </c:pt>
                <c:pt idx="223">
                  <c:v>0.93200000000000005</c:v>
                </c:pt>
                <c:pt idx="224">
                  <c:v>0.92400000000000004</c:v>
                </c:pt>
                <c:pt idx="225">
                  <c:v>0.91600000000000004</c:v>
                </c:pt>
                <c:pt idx="226">
                  <c:v>0.90700000000000003</c:v>
                </c:pt>
                <c:pt idx="227">
                  <c:v>0.89800000000000002</c:v>
                </c:pt>
                <c:pt idx="228">
                  <c:v>0.88900000000000001</c:v>
                </c:pt>
                <c:pt idx="229">
                  <c:v>0.88</c:v>
                </c:pt>
                <c:pt idx="230">
                  <c:v>0.87</c:v>
                </c:pt>
                <c:pt idx="231">
                  <c:v>0.86099999999999999</c:v>
                </c:pt>
                <c:pt idx="232">
                  <c:v>0.85099999999999998</c:v>
                </c:pt>
                <c:pt idx="233">
                  <c:v>0.84099999999999997</c:v>
                </c:pt>
                <c:pt idx="234">
                  <c:v>0.83099999999999996</c:v>
                </c:pt>
                <c:pt idx="235">
                  <c:v>0.82099999999999995</c:v>
                </c:pt>
                <c:pt idx="236">
                  <c:v>0.81100000000000005</c:v>
                </c:pt>
                <c:pt idx="237">
                  <c:v>0.80100000000000005</c:v>
                </c:pt>
                <c:pt idx="238">
                  <c:v>0.79</c:v>
                </c:pt>
                <c:pt idx="239">
                  <c:v>0.77900000000000003</c:v>
                </c:pt>
                <c:pt idx="240">
                  <c:v>0.76900000000000002</c:v>
                </c:pt>
                <c:pt idx="241">
                  <c:v>0.75900000000000001</c:v>
                </c:pt>
                <c:pt idx="242">
                  <c:v>0.749</c:v>
                </c:pt>
                <c:pt idx="243">
                  <c:v>0.73899999999999999</c:v>
                </c:pt>
                <c:pt idx="244">
                  <c:v>0.73</c:v>
                </c:pt>
                <c:pt idx="245">
                  <c:v>0.72</c:v>
                </c:pt>
                <c:pt idx="246">
                  <c:v>0.71</c:v>
                </c:pt>
                <c:pt idx="247">
                  <c:v>0.7</c:v>
                </c:pt>
                <c:pt idx="248">
                  <c:v>0.69099999999999995</c:v>
                </c:pt>
                <c:pt idx="249">
                  <c:v>0.68100000000000005</c:v>
                </c:pt>
                <c:pt idx="250">
                  <c:v>0.67100000000000004</c:v>
                </c:pt>
                <c:pt idx="251">
                  <c:v>0.66200000000000003</c:v>
                </c:pt>
                <c:pt idx="252">
                  <c:v>0.65200000000000002</c:v>
                </c:pt>
                <c:pt idx="253">
                  <c:v>0.64200000000000002</c:v>
                </c:pt>
                <c:pt idx="254">
                  <c:v>0.63300000000000001</c:v>
                </c:pt>
                <c:pt idx="255">
                  <c:v>0.623</c:v>
                </c:pt>
                <c:pt idx="256">
                  <c:v>0.61399999999999999</c:v>
                </c:pt>
                <c:pt idx="257">
                  <c:v>0.60499999999999998</c:v>
                </c:pt>
                <c:pt idx="258">
                  <c:v>0.59499999999999997</c:v>
                </c:pt>
                <c:pt idx="259">
                  <c:v>0.58599999999999997</c:v>
                </c:pt>
                <c:pt idx="260">
                  <c:v>0.57799999999999996</c:v>
                </c:pt>
                <c:pt idx="261">
                  <c:v>0.56899999999999995</c:v>
                </c:pt>
                <c:pt idx="262">
                  <c:v>0.56000000000000005</c:v>
                </c:pt>
                <c:pt idx="263">
                  <c:v>0.55200000000000005</c:v>
                </c:pt>
                <c:pt idx="264">
                  <c:v>0.54300000000000004</c:v>
                </c:pt>
                <c:pt idx="265">
                  <c:v>0.53500000000000003</c:v>
                </c:pt>
                <c:pt idx="266">
                  <c:v>0.52700000000000002</c:v>
                </c:pt>
                <c:pt idx="267">
                  <c:v>0.51800000000000002</c:v>
                </c:pt>
                <c:pt idx="268">
                  <c:v>0.51</c:v>
                </c:pt>
                <c:pt idx="269">
                  <c:v>0.502</c:v>
                </c:pt>
                <c:pt idx="270">
                  <c:v>0.49299999999999999</c:v>
                </c:pt>
                <c:pt idx="271">
                  <c:v>0.48499999999999999</c:v>
                </c:pt>
                <c:pt idx="272">
                  <c:v>0.47599999999999998</c:v>
                </c:pt>
                <c:pt idx="273">
                  <c:v>0.46800000000000003</c:v>
                </c:pt>
                <c:pt idx="274">
                  <c:v>0.46</c:v>
                </c:pt>
                <c:pt idx="275">
                  <c:v>0.45200000000000001</c:v>
                </c:pt>
                <c:pt idx="276">
                  <c:v>0.44400000000000001</c:v>
                </c:pt>
                <c:pt idx="277">
                  <c:v>0.436</c:v>
                </c:pt>
                <c:pt idx="278">
                  <c:v>0.42799999999999999</c:v>
                </c:pt>
                <c:pt idx="279">
                  <c:v>0.42</c:v>
                </c:pt>
                <c:pt idx="280">
                  <c:v>0.41299999999999998</c:v>
                </c:pt>
                <c:pt idx="281">
                  <c:v>0.40500000000000003</c:v>
                </c:pt>
                <c:pt idx="282">
                  <c:v>0.39700000000000002</c:v>
                </c:pt>
                <c:pt idx="283">
                  <c:v>0.39</c:v>
                </c:pt>
                <c:pt idx="284">
                  <c:v>0.38300000000000001</c:v>
                </c:pt>
                <c:pt idx="285">
                  <c:v>0.376</c:v>
                </c:pt>
                <c:pt idx="286">
                  <c:v>0.36899999999999999</c:v>
                </c:pt>
                <c:pt idx="287">
                  <c:v>0.36199999999999999</c:v>
                </c:pt>
                <c:pt idx="288">
                  <c:v>0.35399999999999998</c:v>
                </c:pt>
                <c:pt idx="289">
                  <c:v>0.34699999999999998</c:v>
                </c:pt>
                <c:pt idx="290">
                  <c:v>0.34</c:v>
                </c:pt>
                <c:pt idx="291">
                  <c:v>0.33300000000000002</c:v>
                </c:pt>
                <c:pt idx="292">
                  <c:v>0.32600000000000001</c:v>
                </c:pt>
                <c:pt idx="293">
                  <c:v>0.31900000000000001</c:v>
                </c:pt>
                <c:pt idx="294">
                  <c:v>0.313</c:v>
                </c:pt>
                <c:pt idx="295">
                  <c:v>0.30599999999999999</c:v>
                </c:pt>
                <c:pt idx="296">
                  <c:v>0.29899999999999999</c:v>
                </c:pt>
                <c:pt idx="297">
                  <c:v>0.29299999999999998</c:v>
                </c:pt>
                <c:pt idx="298">
                  <c:v>0.28599999999999998</c:v>
                </c:pt>
                <c:pt idx="299">
                  <c:v>0.28000000000000003</c:v>
                </c:pt>
                <c:pt idx="300">
                  <c:v>0.274000000000000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CCF8-4C26-A940-2CDBC6DE740D}"/>
            </c:ext>
          </c:extLst>
        </c:ser>
        <c:ser>
          <c:idx val="3"/>
          <c:order val="3"/>
          <c:tx>
            <c:strRef>
              <c:f>Sheet1!$E$2</c:f>
              <c:strCache>
                <c:ptCount val="1"/>
                <c:pt idx="0">
                  <c:v>1:20 dilution</c:v>
                </c:pt>
              </c:strCache>
            </c:strRef>
          </c:tx>
          <c:spPr>
            <a:ln>
              <a:prstDash val="dash"/>
            </a:ln>
          </c:spPr>
          <c:marker>
            <c:symbol val="none"/>
          </c:marker>
          <c:xVal>
            <c:numRef>
              <c:f>Sheet1!$A$3:$A$310</c:f>
              <c:numCache>
                <c:formatCode>General</c:formatCode>
                <c:ptCount val="308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</c:numCache>
            </c:numRef>
          </c:xVal>
          <c:yVal>
            <c:numRef>
              <c:f>Sheet1!$E$3:$E$310</c:f>
              <c:numCache>
                <c:formatCode>General</c:formatCode>
                <c:ptCount val="308"/>
                <c:pt idx="0">
                  <c:v>1.103</c:v>
                </c:pt>
                <c:pt idx="1">
                  <c:v>1.103</c:v>
                </c:pt>
                <c:pt idx="2">
                  <c:v>1.1020000000000001</c:v>
                </c:pt>
                <c:pt idx="3">
                  <c:v>1.101</c:v>
                </c:pt>
                <c:pt idx="4">
                  <c:v>1.1000000000000001</c:v>
                </c:pt>
                <c:pt idx="5">
                  <c:v>1.099</c:v>
                </c:pt>
                <c:pt idx="6">
                  <c:v>1.0980000000000001</c:v>
                </c:pt>
                <c:pt idx="7">
                  <c:v>1.097</c:v>
                </c:pt>
                <c:pt idx="8">
                  <c:v>1.097</c:v>
                </c:pt>
                <c:pt idx="9">
                  <c:v>1.0960000000000001</c:v>
                </c:pt>
                <c:pt idx="10">
                  <c:v>1.0960000000000001</c:v>
                </c:pt>
                <c:pt idx="11">
                  <c:v>1.095</c:v>
                </c:pt>
                <c:pt idx="12">
                  <c:v>1.095</c:v>
                </c:pt>
                <c:pt idx="13">
                  <c:v>1.095</c:v>
                </c:pt>
                <c:pt idx="14">
                  <c:v>1.095</c:v>
                </c:pt>
                <c:pt idx="15">
                  <c:v>1.095</c:v>
                </c:pt>
                <c:pt idx="16">
                  <c:v>1.0960000000000001</c:v>
                </c:pt>
                <c:pt idx="17">
                  <c:v>1.0960000000000001</c:v>
                </c:pt>
                <c:pt idx="18">
                  <c:v>1.0960000000000001</c:v>
                </c:pt>
                <c:pt idx="19">
                  <c:v>1.097</c:v>
                </c:pt>
                <c:pt idx="20">
                  <c:v>1.0980000000000001</c:v>
                </c:pt>
                <c:pt idx="21">
                  <c:v>1.099</c:v>
                </c:pt>
                <c:pt idx="22">
                  <c:v>1.1000000000000001</c:v>
                </c:pt>
                <c:pt idx="23">
                  <c:v>1.1020000000000001</c:v>
                </c:pt>
                <c:pt idx="24">
                  <c:v>1.103</c:v>
                </c:pt>
                <c:pt idx="25">
                  <c:v>1.105</c:v>
                </c:pt>
                <c:pt idx="26">
                  <c:v>1.107</c:v>
                </c:pt>
                <c:pt idx="27">
                  <c:v>1.109</c:v>
                </c:pt>
                <c:pt idx="28">
                  <c:v>1.1100000000000001</c:v>
                </c:pt>
                <c:pt idx="29">
                  <c:v>1.113</c:v>
                </c:pt>
                <c:pt idx="30">
                  <c:v>1.115</c:v>
                </c:pt>
                <c:pt idx="31">
                  <c:v>1.1180000000000001</c:v>
                </c:pt>
                <c:pt idx="32">
                  <c:v>1.121</c:v>
                </c:pt>
                <c:pt idx="33">
                  <c:v>1.1240000000000001</c:v>
                </c:pt>
                <c:pt idx="34">
                  <c:v>1.127</c:v>
                </c:pt>
                <c:pt idx="35">
                  <c:v>1.131</c:v>
                </c:pt>
                <c:pt idx="36">
                  <c:v>1.135</c:v>
                </c:pt>
                <c:pt idx="37">
                  <c:v>1.139</c:v>
                </c:pt>
                <c:pt idx="38">
                  <c:v>1.143</c:v>
                </c:pt>
                <c:pt idx="39">
                  <c:v>1.147</c:v>
                </c:pt>
                <c:pt idx="40">
                  <c:v>1.1519999999999999</c:v>
                </c:pt>
                <c:pt idx="41">
                  <c:v>1.155</c:v>
                </c:pt>
                <c:pt idx="42">
                  <c:v>1.161</c:v>
                </c:pt>
                <c:pt idx="43">
                  <c:v>1.165</c:v>
                </c:pt>
                <c:pt idx="44">
                  <c:v>1.171</c:v>
                </c:pt>
                <c:pt idx="45">
                  <c:v>1.1759999999999999</c:v>
                </c:pt>
                <c:pt idx="46">
                  <c:v>1.181</c:v>
                </c:pt>
                <c:pt idx="47">
                  <c:v>1.1859999999999999</c:v>
                </c:pt>
                <c:pt idx="48">
                  <c:v>1.1919999999999999</c:v>
                </c:pt>
                <c:pt idx="49">
                  <c:v>1.1970000000000001</c:v>
                </c:pt>
                <c:pt idx="50">
                  <c:v>1.2030000000000001</c:v>
                </c:pt>
                <c:pt idx="51">
                  <c:v>1.2090000000000001</c:v>
                </c:pt>
                <c:pt idx="52">
                  <c:v>1.214</c:v>
                </c:pt>
                <c:pt idx="53">
                  <c:v>1.22</c:v>
                </c:pt>
                <c:pt idx="54">
                  <c:v>1.2250000000000001</c:v>
                </c:pt>
                <c:pt idx="55">
                  <c:v>1.23</c:v>
                </c:pt>
                <c:pt idx="56">
                  <c:v>1.2350000000000001</c:v>
                </c:pt>
                <c:pt idx="57">
                  <c:v>1.2390000000000001</c:v>
                </c:pt>
                <c:pt idx="58">
                  <c:v>1.2430000000000001</c:v>
                </c:pt>
                <c:pt idx="59">
                  <c:v>1.2470000000000001</c:v>
                </c:pt>
                <c:pt idx="60">
                  <c:v>1.25</c:v>
                </c:pt>
                <c:pt idx="61">
                  <c:v>1.254</c:v>
                </c:pt>
                <c:pt idx="62">
                  <c:v>1.2569999999999999</c:v>
                </c:pt>
                <c:pt idx="63">
                  <c:v>1.2609999999999999</c:v>
                </c:pt>
                <c:pt idx="64">
                  <c:v>1.264</c:v>
                </c:pt>
                <c:pt idx="65">
                  <c:v>1.2669999999999999</c:v>
                </c:pt>
                <c:pt idx="66">
                  <c:v>1.27</c:v>
                </c:pt>
                <c:pt idx="67">
                  <c:v>1.272</c:v>
                </c:pt>
                <c:pt idx="68">
                  <c:v>1.2729999999999999</c:v>
                </c:pt>
                <c:pt idx="69">
                  <c:v>1.274</c:v>
                </c:pt>
                <c:pt idx="70">
                  <c:v>1.2749999999999999</c:v>
                </c:pt>
                <c:pt idx="71">
                  <c:v>1.276</c:v>
                </c:pt>
                <c:pt idx="72">
                  <c:v>1.2749999999999999</c:v>
                </c:pt>
                <c:pt idx="73">
                  <c:v>1.2749999999999999</c:v>
                </c:pt>
                <c:pt idx="74">
                  <c:v>1.274</c:v>
                </c:pt>
                <c:pt idx="75">
                  <c:v>1.272</c:v>
                </c:pt>
                <c:pt idx="76">
                  <c:v>1.27</c:v>
                </c:pt>
                <c:pt idx="77">
                  <c:v>1.2669999999999999</c:v>
                </c:pt>
                <c:pt idx="78">
                  <c:v>1.264</c:v>
                </c:pt>
                <c:pt idx="79">
                  <c:v>1.26</c:v>
                </c:pt>
                <c:pt idx="80">
                  <c:v>1.2569999999999999</c:v>
                </c:pt>
                <c:pt idx="81">
                  <c:v>1.2529999999999999</c:v>
                </c:pt>
                <c:pt idx="82">
                  <c:v>1.248</c:v>
                </c:pt>
                <c:pt idx="83">
                  <c:v>1.244</c:v>
                </c:pt>
                <c:pt idx="84">
                  <c:v>1.2390000000000001</c:v>
                </c:pt>
                <c:pt idx="85">
                  <c:v>1.234</c:v>
                </c:pt>
                <c:pt idx="86">
                  <c:v>1.2290000000000001</c:v>
                </c:pt>
                <c:pt idx="87">
                  <c:v>1.2230000000000001</c:v>
                </c:pt>
                <c:pt idx="88">
                  <c:v>1.218</c:v>
                </c:pt>
                <c:pt idx="89">
                  <c:v>1.212</c:v>
                </c:pt>
                <c:pt idx="90">
                  <c:v>1.206</c:v>
                </c:pt>
                <c:pt idx="91">
                  <c:v>1.2</c:v>
                </c:pt>
                <c:pt idx="92">
                  <c:v>1.194</c:v>
                </c:pt>
                <c:pt idx="93">
                  <c:v>1.1879999999999999</c:v>
                </c:pt>
                <c:pt idx="94">
                  <c:v>1.1819999999999999</c:v>
                </c:pt>
                <c:pt idx="95">
                  <c:v>1.1759999999999999</c:v>
                </c:pt>
                <c:pt idx="96">
                  <c:v>1.169</c:v>
                </c:pt>
                <c:pt idx="97">
                  <c:v>1.163</c:v>
                </c:pt>
                <c:pt idx="98">
                  <c:v>1.157</c:v>
                </c:pt>
                <c:pt idx="99">
                  <c:v>1.1519999999999999</c:v>
                </c:pt>
                <c:pt idx="100">
                  <c:v>1.1459999999999999</c:v>
                </c:pt>
                <c:pt idx="101">
                  <c:v>1.141</c:v>
                </c:pt>
                <c:pt idx="102">
                  <c:v>1.1359999999999999</c:v>
                </c:pt>
                <c:pt idx="103">
                  <c:v>1.131</c:v>
                </c:pt>
                <c:pt idx="104">
                  <c:v>1.1259999999999999</c:v>
                </c:pt>
                <c:pt idx="105">
                  <c:v>1.121</c:v>
                </c:pt>
                <c:pt idx="106">
                  <c:v>1.1160000000000001</c:v>
                </c:pt>
                <c:pt idx="107">
                  <c:v>1.1120000000000001</c:v>
                </c:pt>
                <c:pt idx="108">
                  <c:v>1.107</c:v>
                </c:pt>
                <c:pt idx="109">
                  <c:v>1.103</c:v>
                </c:pt>
                <c:pt idx="110">
                  <c:v>1.099</c:v>
                </c:pt>
                <c:pt idx="111">
                  <c:v>1.095</c:v>
                </c:pt>
                <c:pt idx="112">
                  <c:v>1.091</c:v>
                </c:pt>
                <c:pt idx="113">
                  <c:v>1.0880000000000001</c:v>
                </c:pt>
                <c:pt idx="114">
                  <c:v>1.0840000000000001</c:v>
                </c:pt>
                <c:pt idx="115">
                  <c:v>1.081</c:v>
                </c:pt>
                <c:pt idx="116">
                  <c:v>1.0780000000000001</c:v>
                </c:pt>
                <c:pt idx="117">
                  <c:v>1.0760000000000001</c:v>
                </c:pt>
                <c:pt idx="118">
                  <c:v>1.073</c:v>
                </c:pt>
                <c:pt idx="119">
                  <c:v>1.071</c:v>
                </c:pt>
                <c:pt idx="120">
                  <c:v>1.069</c:v>
                </c:pt>
                <c:pt idx="121">
                  <c:v>1.0680000000000001</c:v>
                </c:pt>
                <c:pt idx="122">
                  <c:v>1.0660000000000001</c:v>
                </c:pt>
                <c:pt idx="123">
                  <c:v>1.0649999999999999</c:v>
                </c:pt>
                <c:pt idx="124">
                  <c:v>1.0649999999999999</c:v>
                </c:pt>
                <c:pt idx="125">
                  <c:v>1.0640000000000001</c:v>
                </c:pt>
                <c:pt idx="126">
                  <c:v>1.0640000000000001</c:v>
                </c:pt>
                <c:pt idx="127">
                  <c:v>1.0640000000000001</c:v>
                </c:pt>
                <c:pt idx="128">
                  <c:v>1.0649999999999999</c:v>
                </c:pt>
                <c:pt idx="129">
                  <c:v>1.0649999999999999</c:v>
                </c:pt>
                <c:pt idx="130">
                  <c:v>1.0660000000000001</c:v>
                </c:pt>
                <c:pt idx="131">
                  <c:v>1.0680000000000001</c:v>
                </c:pt>
                <c:pt idx="132">
                  <c:v>1.069</c:v>
                </c:pt>
                <c:pt idx="133">
                  <c:v>1.071</c:v>
                </c:pt>
                <c:pt idx="134">
                  <c:v>1.073</c:v>
                </c:pt>
                <c:pt idx="135">
                  <c:v>1.075</c:v>
                </c:pt>
                <c:pt idx="136">
                  <c:v>1.0780000000000001</c:v>
                </c:pt>
                <c:pt idx="137">
                  <c:v>1.08</c:v>
                </c:pt>
                <c:pt idx="138">
                  <c:v>1.083</c:v>
                </c:pt>
                <c:pt idx="139">
                  <c:v>1.0860000000000001</c:v>
                </c:pt>
                <c:pt idx="140">
                  <c:v>1.089</c:v>
                </c:pt>
                <c:pt idx="141">
                  <c:v>1.0920000000000001</c:v>
                </c:pt>
                <c:pt idx="142">
                  <c:v>1.095</c:v>
                </c:pt>
                <c:pt idx="143">
                  <c:v>1.0980000000000001</c:v>
                </c:pt>
                <c:pt idx="144">
                  <c:v>1.101</c:v>
                </c:pt>
                <c:pt idx="145">
                  <c:v>1.1040000000000001</c:v>
                </c:pt>
                <c:pt idx="146">
                  <c:v>1.1060000000000001</c:v>
                </c:pt>
                <c:pt idx="147">
                  <c:v>1.109</c:v>
                </c:pt>
                <c:pt idx="148">
                  <c:v>1.111</c:v>
                </c:pt>
                <c:pt idx="149">
                  <c:v>1.1120000000000001</c:v>
                </c:pt>
                <c:pt idx="150">
                  <c:v>1.1140000000000001</c:v>
                </c:pt>
                <c:pt idx="151">
                  <c:v>1.1160000000000001</c:v>
                </c:pt>
                <c:pt idx="152">
                  <c:v>1.1160000000000001</c:v>
                </c:pt>
                <c:pt idx="153">
                  <c:v>1.117</c:v>
                </c:pt>
                <c:pt idx="154">
                  <c:v>1.117</c:v>
                </c:pt>
                <c:pt idx="155">
                  <c:v>1.117</c:v>
                </c:pt>
                <c:pt idx="156">
                  <c:v>1.1160000000000001</c:v>
                </c:pt>
                <c:pt idx="157">
                  <c:v>1.1140000000000001</c:v>
                </c:pt>
                <c:pt idx="158">
                  <c:v>1.1120000000000001</c:v>
                </c:pt>
                <c:pt idx="159">
                  <c:v>1.1100000000000001</c:v>
                </c:pt>
                <c:pt idx="160">
                  <c:v>1.107</c:v>
                </c:pt>
                <c:pt idx="161">
                  <c:v>1.1040000000000001</c:v>
                </c:pt>
                <c:pt idx="162">
                  <c:v>1.1000000000000001</c:v>
                </c:pt>
                <c:pt idx="163">
                  <c:v>1.0960000000000001</c:v>
                </c:pt>
                <c:pt idx="164">
                  <c:v>1.0920000000000001</c:v>
                </c:pt>
                <c:pt idx="165">
                  <c:v>1.087</c:v>
                </c:pt>
                <c:pt idx="166">
                  <c:v>1.0820000000000001</c:v>
                </c:pt>
                <c:pt idx="167">
                  <c:v>1.0760000000000001</c:v>
                </c:pt>
                <c:pt idx="168">
                  <c:v>1.07</c:v>
                </c:pt>
                <c:pt idx="169">
                  <c:v>1.0640000000000001</c:v>
                </c:pt>
                <c:pt idx="170">
                  <c:v>1.0580000000000001</c:v>
                </c:pt>
                <c:pt idx="171">
                  <c:v>1.0509999999999999</c:v>
                </c:pt>
                <c:pt idx="172">
                  <c:v>1.044</c:v>
                </c:pt>
                <c:pt idx="173">
                  <c:v>1.0369999999999999</c:v>
                </c:pt>
                <c:pt idx="174">
                  <c:v>1.0289999999999999</c:v>
                </c:pt>
                <c:pt idx="175">
                  <c:v>1.022</c:v>
                </c:pt>
                <c:pt idx="176">
                  <c:v>1.0149999999999999</c:v>
                </c:pt>
                <c:pt idx="177">
                  <c:v>1.0069999999999999</c:v>
                </c:pt>
                <c:pt idx="178">
                  <c:v>0.999</c:v>
                </c:pt>
                <c:pt idx="179">
                  <c:v>0.99199999999999999</c:v>
                </c:pt>
                <c:pt idx="180">
                  <c:v>0.98399999999999999</c:v>
                </c:pt>
                <c:pt idx="181">
                  <c:v>0.97699999999999998</c:v>
                </c:pt>
                <c:pt idx="182">
                  <c:v>0.96899999999999997</c:v>
                </c:pt>
                <c:pt idx="183">
                  <c:v>0.96199999999999997</c:v>
                </c:pt>
                <c:pt idx="184">
                  <c:v>0.95499999999999996</c:v>
                </c:pt>
                <c:pt idx="185">
                  <c:v>0.94699999999999995</c:v>
                </c:pt>
                <c:pt idx="186">
                  <c:v>0.94099999999999995</c:v>
                </c:pt>
                <c:pt idx="187">
                  <c:v>0.93400000000000005</c:v>
                </c:pt>
                <c:pt idx="188">
                  <c:v>0.92700000000000005</c:v>
                </c:pt>
                <c:pt idx="189">
                  <c:v>0.92</c:v>
                </c:pt>
                <c:pt idx="190">
                  <c:v>0.91300000000000003</c:v>
                </c:pt>
                <c:pt idx="191">
                  <c:v>0.90600000000000003</c:v>
                </c:pt>
                <c:pt idx="192">
                  <c:v>0.9</c:v>
                </c:pt>
                <c:pt idx="193">
                  <c:v>0.89300000000000002</c:v>
                </c:pt>
                <c:pt idx="194">
                  <c:v>0.88700000000000001</c:v>
                </c:pt>
                <c:pt idx="195">
                  <c:v>0.88100000000000001</c:v>
                </c:pt>
                <c:pt idx="196">
                  <c:v>0.875</c:v>
                </c:pt>
                <c:pt idx="197">
                  <c:v>0.86899999999999999</c:v>
                </c:pt>
                <c:pt idx="198">
                  <c:v>0.86299999999999999</c:v>
                </c:pt>
                <c:pt idx="199">
                  <c:v>0.85699999999999998</c:v>
                </c:pt>
                <c:pt idx="200">
                  <c:v>0.85299999999999998</c:v>
                </c:pt>
                <c:pt idx="201">
                  <c:v>0.84599999999999997</c:v>
                </c:pt>
                <c:pt idx="202">
                  <c:v>0.84</c:v>
                </c:pt>
                <c:pt idx="203">
                  <c:v>0.83499999999999996</c:v>
                </c:pt>
                <c:pt idx="204">
                  <c:v>0.82899999999999996</c:v>
                </c:pt>
                <c:pt idx="205">
                  <c:v>0.82399999999999995</c:v>
                </c:pt>
                <c:pt idx="206">
                  <c:v>0.81899999999999995</c:v>
                </c:pt>
                <c:pt idx="207">
                  <c:v>0.81299999999999994</c:v>
                </c:pt>
                <c:pt idx="208">
                  <c:v>0.80800000000000005</c:v>
                </c:pt>
                <c:pt idx="209">
                  <c:v>0.80200000000000005</c:v>
                </c:pt>
                <c:pt idx="210">
                  <c:v>0.79600000000000004</c:v>
                </c:pt>
                <c:pt idx="211">
                  <c:v>0.79100000000000004</c:v>
                </c:pt>
                <c:pt idx="212">
                  <c:v>0.78500000000000003</c:v>
                </c:pt>
                <c:pt idx="213">
                  <c:v>0.77800000000000002</c:v>
                </c:pt>
                <c:pt idx="214">
                  <c:v>0.77200000000000002</c:v>
                </c:pt>
                <c:pt idx="215">
                  <c:v>0.76600000000000001</c:v>
                </c:pt>
                <c:pt idx="216">
                  <c:v>0.75900000000000001</c:v>
                </c:pt>
                <c:pt idx="217">
                  <c:v>0.752</c:v>
                </c:pt>
                <c:pt idx="218">
                  <c:v>0.745</c:v>
                </c:pt>
                <c:pt idx="219">
                  <c:v>0.73799999999999999</c:v>
                </c:pt>
                <c:pt idx="220">
                  <c:v>0.73199999999999998</c:v>
                </c:pt>
                <c:pt idx="221">
                  <c:v>0.72499999999999998</c:v>
                </c:pt>
                <c:pt idx="222">
                  <c:v>0.71799999999999997</c:v>
                </c:pt>
                <c:pt idx="223">
                  <c:v>0.71199999999999997</c:v>
                </c:pt>
                <c:pt idx="224">
                  <c:v>0.70599999999999996</c:v>
                </c:pt>
                <c:pt idx="225">
                  <c:v>0.69899999999999995</c:v>
                </c:pt>
                <c:pt idx="226">
                  <c:v>0.69299999999999995</c:v>
                </c:pt>
                <c:pt idx="227">
                  <c:v>0.68600000000000005</c:v>
                </c:pt>
                <c:pt idx="228">
                  <c:v>0.67900000000000005</c:v>
                </c:pt>
                <c:pt idx="229">
                  <c:v>0.67200000000000004</c:v>
                </c:pt>
                <c:pt idx="230">
                  <c:v>0.66400000000000003</c:v>
                </c:pt>
                <c:pt idx="231">
                  <c:v>0.65600000000000003</c:v>
                </c:pt>
                <c:pt idx="232">
                  <c:v>0.64900000000000002</c:v>
                </c:pt>
                <c:pt idx="233">
                  <c:v>0.64100000000000001</c:v>
                </c:pt>
                <c:pt idx="234">
                  <c:v>0.63300000000000001</c:v>
                </c:pt>
                <c:pt idx="235">
                  <c:v>0.625</c:v>
                </c:pt>
                <c:pt idx="236">
                  <c:v>0.61699999999999999</c:v>
                </c:pt>
                <c:pt idx="237">
                  <c:v>0.60899999999999999</c:v>
                </c:pt>
                <c:pt idx="238">
                  <c:v>0.60099999999999998</c:v>
                </c:pt>
                <c:pt idx="239">
                  <c:v>0.59299999999999997</c:v>
                </c:pt>
                <c:pt idx="240">
                  <c:v>0.58499999999999996</c:v>
                </c:pt>
                <c:pt idx="241">
                  <c:v>0.57699999999999996</c:v>
                </c:pt>
                <c:pt idx="242">
                  <c:v>0.56899999999999995</c:v>
                </c:pt>
                <c:pt idx="243">
                  <c:v>0.56200000000000006</c:v>
                </c:pt>
                <c:pt idx="244">
                  <c:v>0.55400000000000005</c:v>
                </c:pt>
                <c:pt idx="245">
                  <c:v>0.54600000000000004</c:v>
                </c:pt>
                <c:pt idx="246">
                  <c:v>0.53900000000000003</c:v>
                </c:pt>
                <c:pt idx="247">
                  <c:v>0.53100000000000003</c:v>
                </c:pt>
                <c:pt idx="248">
                  <c:v>0.52300000000000002</c:v>
                </c:pt>
                <c:pt idx="249">
                  <c:v>0.51600000000000001</c:v>
                </c:pt>
                <c:pt idx="250">
                  <c:v>0.50800000000000001</c:v>
                </c:pt>
                <c:pt idx="251">
                  <c:v>0.501</c:v>
                </c:pt>
                <c:pt idx="252">
                  <c:v>0.49299999999999999</c:v>
                </c:pt>
                <c:pt idx="253">
                  <c:v>0.48599999999999999</c:v>
                </c:pt>
                <c:pt idx="254">
                  <c:v>0.47799999999999998</c:v>
                </c:pt>
                <c:pt idx="255">
                  <c:v>0.47099999999999997</c:v>
                </c:pt>
                <c:pt idx="256">
                  <c:v>0.46400000000000002</c:v>
                </c:pt>
                <c:pt idx="257">
                  <c:v>0.45700000000000002</c:v>
                </c:pt>
                <c:pt idx="258">
                  <c:v>0.45</c:v>
                </c:pt>
                <c:pt idx="259">
                  <c:v>0.443</c:v>
                </c:pt>
                <c:pt idx="260">
                  <c:v>0.436</c:v>
                </c:pt>
                <c:pt idx="261">
                  <c:v>0.42899999999999999</c:v>
                </c:pt>
                <c:pt idx="262">
                  <c:v>0.42299999999999999</c:v>
                </c:pt>
                <c:pt idx="263">
                  <c:v>0.41599999999999998</c:v>
                </c:pt>
                <c:pt idx="264">
                  <c:v>0.40899999999999997</c:v>
                </c:pt>
                <c:pt idx="265">
                  <c:v>0.40300000000000002</c:v>
                </c:pt>
                <c:pt idx="266">
                  <c:v>0.39600000000000002</c:v>
                </c:pt>
                <c:pt idx="267">
                  <c:v>0.39</c:v>
                </c:pt>
                <c:pt idx="268">
                  <c:v>0.38300000000000001</c:v>
                </c:pt>
                <c:pt idx="269">
                  <c:v>0.377</c:v>
                </c:pt>
                <c:pt idx="270">
                  <c:v>0.37</c:v>
                </c:pt>
                <c:pt idx="271">
                  <c:v>0.36399999999999999</c:v>
                </c:pt>
                <c:pt idx="272">
                  <c:v>0.35799999999999998</c:v>
                </c:pt>
                <c:pt idx="273">
                  <c:v>0.35099999999999998</c:v>
                </c:pt>
                <c:pt idx="274">
                  <c:v>0.34499999999999997</c:v>
                </c:pt>
                <c:pt idx="275">
                  <c:v>0.33800000000000002</c:v>
                </c:pt>
                <c:pt idx="276">
                  <c:v>0.33200000000000002</c:v>
                </c:pt>
                <c:pt idx="277">
                  <c:v>0.32600000000000001</c:v>
                </c:pt>
                <c:pt idx="278">
                  <c:v>0.32</c:v>
                </c:pt>
                <c:pt idx="279">
                  <c:v>0.314</c:v>
                </c:pt>
                <c:pt idx="280">
                  <c:v>0.308</c:v>
                </c:pt>
                <c:pt idx="281">
                  <c:v>0.30199999999999999</c:v>
                </c:pt>
                <c:pt idx="282">
                  <c:v>0.29599999999999999</c:v>
                </c:pt>
                <c:pt idx="283">
                  <c:v>0.29099999999999998</c:v>
                </c:pt>
                <c:pt idx="284">
                  <c:v>0.28499999999999998</c:v>
                </c:pt>
                <c:pt idx="285">
                  <c:v>0.28000000000000003</c:v>
                </c:pt>
                <c:pt idx="286">
                  <c:v>0.27400000000000002</c:v>
                </c:pt>
                <c:pt idx="287">
                  <c:v>0.26900000000000002</c:v>
                </c:pt>
                <c:pt idx="288">
                  <c:v>0.26300000000000001</c:v>
                </c:pt>
                <c:pt idx="289">
                  <c:v>0.25800000000000001</c:v>
                </c:pt>
                <c:pt idx="290">
                  <c:v>0.252</c:v>
                </c:pt>
                <c:pt idx="291">
                  <c:v>0.247</c:v>
                </c:pt>
                <c:pt idx="292">
                  <c:v>0.24099999999999999</c:v>
                </c:pt>
                <c:pt idx="293">
                  <c:v>0.23599999999999999</c:v>
                </c:pt>
                <c:pt idx="294">
                  <c:v>0.23</c:v>
                </c:pt>
                <c:pt idx="295">
                  <c:v>0.22500000000000001</c:v>
                </c:pt>
                <c:pt idx="296">
                  <c:v>0.22</c:v>
                </c:pt>
                <c:pt idx="297">
                  <c:v>0.215</c:v>
                </c:pt>
                <c:pt idx="298">
                  <c:v>0.21</c:v>
                </c:pt>
                <c:pt idx="299">
                  <c:v>0.20499999999999999</c:v>
                </c:pt>
                <c:pt idx="300">
                  <c:v>0.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CCF8-4C26-A940-2CDBC6DE740D}"/>
            </c:ext>
          </c:extLst>
        </c:ser>
        <c:ser>
          <c:idx val="4"/>
          <c:order val="4"/>
          <c:tx>
            <c:strRef>
              <c:f>Sheet1!$F$2</c:f>
              <c:strCache>
                <c:ptCount val="1"/>
                <c:pt idx="0">
                  <c:v>1:30 dilution</c:v>
                </c:pt>
              </c:strCache>
            </c:strRef>
          </c:tx>
          <c:spPr>
            <a:ln>
              <a:prstDash val="dashDot"/>
            </a:ln>
          </c:spPr>
          <c:marker>
            <c:symbol val="none"/>
          </c:marker>
          <c:xVal>
            <c:numRef>
              <c:f>Sheet1!$A$3:$A$310</c:f>
              <c:numCache>
                <c:formatCode>General</c:formatCode>
                <c:ptCount val="308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</c:numCache>
            </c:numRef>
          </c:xVal>
          <c:yVal>
            <c:numRef>
              <c:f>Sheet1!$F$3:$F$310</c:f>
              <c:numCache>
                <c:formatCode>General</c:formatCode>
                <c:ptCount val="308"/>
                <c:pt idx="0">
                  <c:v>0.63800000000000001</c:v>
                </c:pt>
                <c:pt idx="1">
                  <c:v>0.63800000000000001</c:v>
                </c:pt>
                <c:pt idx="2">
                  <c:v>0.63700000000000001</c:v>
                </c:pt>
                <c:pt idx="3">
                  <c:v>0.63600000000000001</c:v>
                </c:pt>
                <c:pt idx="4">
                  <c:v>0.63500000000000001</c:v>
                </c:pt>
                <c:pt idx="5">
                  <c:v>0.63400000000000001</c:v>
                </c:pt>
                <c:pt idx="6">
                  <c:v>0.63400000000000001</c:v>
                </c:pt>
                <c:pt idx="7">
                  <c:v>0.63300000000000001</c:v>
                </c:pt>
                <c:pt idx="8">
                  <c:v>0.63200000000000001</c:v>
                </c:pt>
                <c:pt idx="9">
                  <c:v>0.63200000000000001</c:v>
                </c:pt>
                <c:pt idx="10">
                  <c:v>0.63100000000000001</c:v>
                </c:pt>
                <c:pt idx="11">
                  <c:v>0.63100000000000001</c:v>
                </c:pt>
                <c:pt idx="12">
                  <c:v>0.63</c:v>
                </c:pt>
                <c:pt idx="13">
                  <c:v>0.63</c:v>
                </c:pt>
                <c:pt idx="14">
                  <c:v>0.63</c:v>
                </c:pt>
                <c:pt idx="15">
                  <c:v>0.63</c:v>
                </c:pt>
                <c:pt idx="16">
                  <c:v>0.63</c:v>
                </c:pt>
                <c:pt idx="17">
                  <c:v>0.63</c:v>
                </c:pt>
                <c:pt idx="18">
                  <c:v>0.63</c:v>
                </c:pt>
                <c:pt idx="19">
                  <c:v>0.63</c:v>
                </c:pt>
                <c:pt idx="20">
                  <c:v>0.63100000000000001</c:v>
                </c:pt>
                <c:pt idx="21">
                  <c:v>0.63100000000000001</c:v>
                </c:pt>
                <c:pt idx="22">
                  <c:v>0.63200000000000001</c:v>
                </c:pt>
                <c:pt idx="23">
                  <c:v>0.63200000000000001</c:v>
                </c:pt>
                <c:pt idx="24">
                  <c:v>0.63300000000000001</c:v>
                </c:pt>
                <c:pt idx="25">
                  <c:v>0.63400000000000001</c:v>
                </c:pt>
                <c:pt idx="26">
                  <c:v>0.63500000000000001</c:v>
                </c:pt>
                <c:pt idx="27">
                  <c:v>0.63600000000000001</c:v>
                </c:pt>
                <c:pt idx="28">
                  <c:v>0.63700000000000001</c:v>
                </c:pt>
                <c:pt idx="29">
                  <c:v>0.63800000000000001</c:v>
                </c:pt>
                <c:pt idx="30">
                  <c:v>0.64</c:v>
                </c:pt>
                <c:pt idx="31">
                  <c:v>0.64100000000000001</c:v>
                </c:pt>
                <c:pt idx="32">
                  <c:v>0.64300000000000002</c:v>
                </c:pt>
                <c:pt idx="33">
                  <c:v>0.64400000000000002</c:v>
                </c:pt>
                <c:pt idx="34">
                  <c:v>0.64600000000000002</c:v>
                </c:pt>
                <c:pt idx="35">
                  <c:v>0.64900000000000002</c:v>
                </c:pt>
                <c:pt idx="36">
                  <c:v>0.65100000000000002</c:v>
                </c:pt>
                <c:pt idx="37">
                  <c:v>0.65300000000000002</c:v>
                </c:pt>
                <c:pt idx="38">
                  <c:v>0.65500000000000003</c:v>
                </c:pt>
                <c:pt idx="39">
                  <c:v>0.65800000000000003</c:v>
                </c:pt>
                <c:pt idx="40">
                  <c:v>0.66100000000000003</c:v>
                </c:pt>
                <c:pt idx="41">
                  <c:v>0.66200000000000003</c:v>
                </c:pt>
                <c:pt idx="42">
                  <c:v>0.66600000000000004</c:v>
                </c:pt>
                <c:pt idx="43">
                  <c:v>0.66900000000000004</c:v>
                </c:pt>
                <c:pt idx="44">
                  <c:v>0.67200000000000004</c:v>
                </c:pt>
                <c:pt idx="45">
                  <c:v>0.67500000000000004</c:v>
                </c:pt>
                <c:pt idx="46">
                  <c:v>0.67800000000000005</c:v>
                </c:pt>
                <c:pt idx="47">
                  <c:v>0.68100000000000005</c:v>
                </c:pt>
                <c:pt idx="48">
                  <c:v>0.68500000000000005</c:v>
                </c:pt>
                <c:pt idx="49">
                  <c:v>0.68799999999999994</c:v>
                </c:pt>
                <c:pt idx="50">
                  <c:v>0.69199999999999995</c:v>
                </c:pt>
                <c:pt idx="51">
                  <c:v>0.69499999999999995</c:v>
                </c:pt>
                <c:pt idx="52">
                  <c:v>0.69899999999999995</c:v>
                </c:pt>
                <c:pt idx="53">
                  <c:v>0.70199999999999996</c:v>
                </c:pt>
                <c:pt idx="54">
                  <c:v>0.70499999999999996</c:v>
                </c:pt>
                <c:pt idx="55">
                  <c:v>0.70799999999999996</c:v>
                </c:pt>
                <c:pt idx="56">
                  <c:v>0.71099999999999997</c:v>
                </c:pt>
                <c:pt idx="57">
                  <c:v>0.71399999999999997</c:v>
                </c:pt>
                <c:pt idx="58">
                  <c:v>0.71599999999999997</c:v>
                </c:pt>
                <c:pt idx="59">
                  <c:v>0.71799999999999997</c:v>
                </c:pt>
                <c:pt idx="60">
                  <c:v>0.72</c:v>
                </c:pt>
                <c:pt idx="61">
                  <c:v>0.72099999999999997</c:v>
                </c:pt>
                <c:pt idx="62">
                  <c:v>0.72299999999999998</c:v>
                </c:pt>
                <c:pt idx="63">
                  <c:v>0.72499999999999998</c:v>
                </c:pt>
                <c:pt idx="64">
                  <c:v>0.72699999999999998</c:v>
                </c:pt>
                <c:pt idx="65">
                  <c:v>0.72899999999999998</c:v>
                </c:pt>
                <c:pt idx="66">
                  <c:v>0.73099999999999998</c:v>
                </c:pt>
                <c:pt idx="67">
                  <c:v>0.73199999999999998</c:v>
                </c:pt>
                <c:pt idx="68">
                  <c:v>0.73299999999999998</c:v>
                </c:pt>
                <c:pt idx="69">
                  <c:v>0.73399999999999999</c:v>
                </c:pt>
                <c:pt idx="70">
                  <c:v>0.73399999999999999</c:v>
                </c:pt>
                <c:pt idx="71">
                  <c:v>0.73499999999999999</c:v>
                </c:pt>
                <c:pt idx="72">
                  <c:v>0.73399999999999999</c:v>
                </c:pt>
                <c:pt idx="73">
                  <c:v>0.73399999999999999</c:v>
                </c:pt>
                <c:pt idx="74">
                  <c:v>0.73299999999999998</c:v>
                </c:pt>
                <c:pt idx="75">
                  <c:v>0.73099999999999998</c:v>
                </c:pt>
                <c:pt idx="76">
                  <c:v>0.73</c:v>
                </c:pt>
                <c:pt idx="77">
                  <c:v>0.72799999999999998</c:v>
                </c:pt>
                <c:pt idx="78">
                  <c:v>0.72599999999999998</c:v>
                </c:pt>
                <c:pt idx="79">
                  <c:v>0.72299999999999998</c:v>
                </c:pt>
                <c:pt idx="80">
                  <c:v>0.72099999999999997</c:v>
                </c:pt>
                <c:pt idx="81">
                  <c:v>0.71799999999999997</c:v>
                </c:pt>
                <c:pt idx="82">
                  <c:v>0.71499999999999997</c:v>
                </c:pt>
                <c:pt idx="83">
                  <c:v>0.71199999999999997</c:v>
                </c:pt>
                <c:pt idx="84">
                  <c:v>0.70799999999999996</c:v>
                </c:pt>
                <c:pt idx="85">
                  <c:v>0.70499999999999996</c:v>
                </c:pt>
                <c:pt idx="86">
                  <c:v>0.70099999999999996</c:v>
                </c:pt>
                <c:pt idx="87">
                  <c:v>0.69799999999999995</c:v>
                </c:pt>
                <c:pt idx="88">
                  <c:v>0.69399999999999995</c:v>
                </c:pt>
                <c:pt idx="89">
                  <c:v>0.69</c:v>
                </c:pt>
                <c:pt idx="90">
                  <c:v>0.68600000000000005</c:v>
                </c:pt>
                <c:pt idx="91">
                  <c:v>0.68200000000000005</c:v>
                </c:pt>
                <c:pt idx="92">
                  <c:v>0.67800000000000005</c:v>
                </c:pt>
                <c:pt idx="93">
                  <c:v>0.67400000000000004</c:v>
                </c:pt>
                <c:pt idx="94">
                  <c:v>0.67</c:v>
                </c:pt>
                <c:pt idx="95">
                  <c:v>0.66600000000000004</c:v>
                </c:pt>
                <c:pt idx="96">
                  <c:v>0.66200000000000003</c:v>
                </c:pt>
                <c:pt idx="97">
                  <c:v>0.65800000000000003</c:v>
                </c:pt>
                <c:pt idx="98">
                  <c:v>0.65400000000000003</c:v>
                </c:pt>
                <c:pt idx="99">
                  <c:v>0.65</c:v>
                </c:pt>
                <c:pt idx="100">
                  <c:v>0.64700000000000002</c:v>
                </c:pt>
                <c:pt idx="101">
                  <c:v>0.64300000000000002</c:v>
                </c:pt>
                <c:pt idx="102">
                  <c:v>0.64</c:v>
                </c:pt>
                <c:pt idx="103">
                  <c:v>0.63700000000000001</c:v>
                </c:pt>
                <c:pt idx="104">
                  <c:v>0.63400000000000001</c:v>
                </c:pt>
                <c:pt idx="105">
                  <c:v>0.63100000000000001</c:v>
                </c:pt>
                <c:pt idx="106">
                  <c:v>0.628</c:v>
                </c:pt>
                <c:pt idx="107">
                  <c:v>0.625</c:v>
                </c:pt>
                <c:pt idx="108">
                  <c:v>0.622</c:v>
                </c:pt>
                <c:pt idx="109">
                  <c:v>0.61899999999999999</c:v>
                </c:pt>
                <c:pt idx="110">
                  <c:v>0.61699999999999999</c:v>
                </c:pt>
                <c:pt idx="111">
                  <c:v>0.61399999999999999</c:v>
                </c:pt>
                <c:pt idx="112">
                  <c:v>0.61199999999999999</c:v>
                </c:pt>
                <c:pt idx="113">
                  <c:v>0.60899999999999999</c:v>
                </c:pt>
                <c:pt idx="114">
                  <c:v>0.60699999999999998</c:v>
                </c:pt>
                <c:pt idx="115">
                  <c:v>0.60499999999999998</c:v>
                </c:pt>
                <c:pt idx="116">
                  <c:v>0.60399999999999998</c:v>
                </c:pt>
                <c:pt idx="117">
                  <c:v>0.60199999999999998</c:v>
                </c:pt>
                <c:pt idx="118">
                  <c:v>0.6</c:v>
                </c:pt>
                <c:pt idx="119">
                  <c:v>0.59899999999999998</c:v>
                </c:pt>
                <c:pt idx="120">
                  <c:v>0.59799999999999998</c:v>
                </c:pt>
                <c:pt idx="121">
                  <c:v>0.59699999999999998</c:v>
                </c:pt>
                <c:pt idx="122">
                  <c:v>0.59599999999999997</c:v>
                </c:pt>
                <c:pt idx="123">
                  <c:v>0.59499999999999997</c:v>
                </c:pt>
                <c:pt idx="124">
                  <c:v>0.59499999999999997</c:v>
                </c:pt>
                <c:pt idx="125">
                  <c:v>0.59499999999999997</c:v>
                </c:pt>
                <c:pt idx="126">
                  <c:v>0.59499999999999997</c:v>
                </c:pt>
                <c:pt idx="127">
                  <c:v>0.59499999999999997</c:v>
                </c:pt>
                <c:pt idx="128">
                  <c:v>0.59499999999999997</c:v>
                </c:pt>
                <c:pt idx="129">
                  <c:v>0.59599999999999997</c:v>
                </c:pt>
                <c:pt idx="130">
                  <c:v>0.59599999999999997</c:v>
                </c:pt>
                <c:pt idx="131">
                  <c:v>0.59699999999999998</c:v>
                </c:pt>
                <c:pt idx="132">
                  <c:v>0.59799999999999998</c:v>
                </c:pt>
                <c:pt idx="133">
                  <c:v>0.59899999999999998</c:v>
                </c:pt>
                <c:pt idx="134">
                  <c:v>0.60099999999999998</c:v>
                </c:pt>
                <c:pt idx="135">
                  <c:v>0.60199999999999998</c:v>
                </c:pt>
                <c:pt idx="136">
                  <c:v>0.60399999999999998</c:v>
                </c:pt>
                <c:pt idx="137">
                  <c:v>0.60599999999999998</c:v>
                </c:pt>
                <c:pt idx="138">
                  <c:v>0.60799999999999998</c:v>
                </c:pt>
                <c:pt idx="139">
                  <c:v>0.60899999999999999</c:v>
                </c:pt>
                <c:pt idx="140">
                  <c:v>0.61099999999999999</c:v>
                </c:pt>
                <c:pt idx="141">
                  <c:v>0.61299999999999999</c:v>
                </c:pt>
                <c:pt idx="142">
                  <c:v>0.61499999999999999</c:v>
                </c:pt>
                <c:pt idx="143">
                  <c:v>0.61699999999999999</c:v>
                </c:pt>
                <c:pt idx="144">
                  <c:v>0.61899999999999999</c:v>
                </c:pt>
                <c:pt idx="145">
                  <c:v>0.621</c:v>
                </c:pt>
                <c:pt idx="146">
                  <c:v>0.622</c:v>
                </c:pt>
                <c:pt idx="147">
                  <c:v>0.624</c:v>
                </c:pt>
                <c:pt idx="148">
                  <c:v>0.625</c:v>
                </c:pt>
                <c:pt idx="149">
                  <c:v>0.627</c:v>
                </c:pt>
                <c:pt idx="150">
                  <c:v>0.628</c:v>
                </c:pt>
                <c:pt idx="151">
                  <c:v>0.629</c:v>
                </c:pt>
                <c:pt idx="152">
                  <c:v>0.629</c:v>
                </c:pt>
                <c:pt idx="153">
                  <c:v>0.629</c:v>
                </c:pt>
                <c:pt idx="154">
                  <c:v>0.629</c:v>
                </c:pt>
                <c:pt idx="155">
                  <c:v>0.629</c:v>
                </c:pt>
                <c:pt idx="156">
                  <c:v>0.629</c:v>
                </c:pt>
                <c:pt idx="157">
                  <c:v>0.628</c:v>
                </c:pt>
                <c:pt idx="158">
                  <c:v>0.627</c:v>
                </c:pt>
                <c:pt idx="159">
                  <c:v>0.625</c:v>
                </c:pt>
                <c:pt idx="160">
                  <c:v>0.624</c:v>
                </c:pt>
                <c:pt idx="161">
                  <c:v>0.621</c:v>
                </c:pt>
                <c:pt idx="162">
                  <c:v>0.61899999999999999</c:v>
                </c:pt>
                <c:pt idx="163">
                  <c:v>0.61699999999999999</c:v>
                </c:pt>
                <c:pt idx="164">
                  <c:v>0.61399999999999999</c:v>
                </c:pt>
                <c:pt idx="165">
                  <c:v>0.61099999999999999</c:v>
                </c:pt>
                <c:pt idx="166">
                  <c:v>0.60799999999999998</c:v>
                </c:pt>
                <c:pt idx="167">
                  <c:v>0.60399999999999998</c:v>
                </c:pt>
                <c:pt idx="168">
                  <c:v>0.60099999999999998</c:v>
                </c:pt>
                <c:pt idx="169">
                  <c:v>0.59699999999999998</c:v>
                </c:pt>
                <c:pt idx="170">
                  <c:v>0.59299999999999997</c:v>
                </c:pt>
                <c:pt idx="171">
                  <c:v>0.58899999999999997</c:v>
                </c:pt>
                <c:pt idx="172">
                  <c:v>0.58399999999999996</c:v>
                </c:pt>
                <c:pt idx="173">
                  <c:v>0.57999999999999996</c:v>
                </c:pt>
                <c:pt idx="174">
                  <c:v>0.57499999999999996</c:v>
                </c:pt>
                <c:pt idx="175">
                  <c:v>0.57099999999999995</c:v>
                </c:pt>
                <c:pt idx="176">
                  <c:v>0.56599999999999995</c:v>
                </c:pt>
                <c:pt idx="177">
                  <c:v>0.56200000000000006</c:v>
                </c:pt>
                <c:pt idx="178">
                  <c:v>0.55700000000000005</c:v>
                </c:pt>
                <c:pt idx="179">
                  <c:v>0.55200000000000005</c:v>
                </c:pt>
                <c:pt idx="180">
                  <c:v>0.54800000000000004</c:v>
                </c:pt>
                <c:pt idx="181">
                  <c:v>0.54300000000000004</c:v>
                </c:pt>
                <c:pt idx="182">
                  <c:v>0.53900000000000003</c:v>
                </c:pt>
                <c:pt idx="183">
                  <c:v>0.53500000000000003</c:v>
                </c:pt>
                <c:pt idx="184">
                  <c:v>0.53</c:v>
                </c:pt>
                <c:pt idx="185">
                  <c:v>0.52600000000000002</c:v>
                </c:pt>
                <c:pt idx="186">
                  <c:v>0.52200000000000002</c:v>
                </c:pt>
                <c:pt idx="187">
                  <c:v>0.51800000000000002</c:v>
                </c:pt>
                <c:pt idx="188">
                  <c:v>0.51400000000000001</c:v>
                </c:pt>
                <c:pt idx="189">
                  <c:v>0.51</c:v>
                </c:pt>
                <c:pt idx="190">
                  <c:v>0.50600000000000001</c:v>
                </c:pt>
                <c:pt idx="191">
                  <c:v>0.502</c:v>
                </c:pt>
                <c:pt idx="192">
                  <c:v>0.498</c:v>
                </c:pt>
                <c:pt idx="193">
                  <c:v>0.49399999999999999</c:v>
                </c:pt>
                <c:pt idx="194">
                  <c:v>0.49</c:v>
                </c:pt>
                <c:pt idx="195">
                  <c:v>0.48699999999999999</c:v>
                </c:pt>
                <c:pt idx="196">
                  <c:v>0.48299999999999998</c:v>
                </c:pt>
                <c:pt idx="197">
                  <c:v>0.48</c:v>
                </c:pt>
                <c:pt idx="198">
                  <c:v>0.47599999999999998</c:v>
                </c:pt>
                <c:pt idx="199">
                  <c:v>0.47299999999999998</c:v>
                </c:pt>
                <c:pt idx="200">
                  <c:v>0.47</c:v>
                </c:pt>
                <c:pt idx="201">
                  <c:v>0.46600000000000003</c:v>
                </c:pt>
                <c:pt idx="202">
                  <c:v>0.46300000000000002</c:v>
                </c:pt>
                <c:pt idx="203">
                  <c:v>0.46</c:v>
                </c:pt>
                <c:pt idx="204">
                  <c:v>0.45700000000000002</c:v>
                </c:pt>
                <c:pt idx="205">
                  <c:v>0.45400000000000001</c:v>
                </c:pt>
                <c:pt idx="206">
                  <c:v>0.45100000000000001</c:v>
                </c:pt>
                <c:pt idx="207">
                  <c:v>0.44700000000000001</c:v>
                </c:pt>
                <c:pt idx="208">
                  <c:v>0.44400000000000001</c:v>
                </c:pt>
                <c:pt idx="209">
                  <c:v>0.441</c:v>
                </c:pt>
                <c:pt idx="210">
                  <c:v>0.438</c:v>
                </c:pt>
                <c:pt idx="211">
                  <c:v>0.434</c:v>
                </c:pt>
                <c:pt idx="212">
                  <c:v>0.43099999999999999</c:v>
                </c:pt>
                <c:pt idx="213">
                  <c:v>0.42699999999999999</c:v>
                </c:pt>
                <c:pt idx="214">
                  <c:v>0.42299999999999999</c:v>
                </c:pt>
                <c:pt idx="215">
                  <c:v>0.42</c:v>
                </c:pt>
                <c:pt idx="216">
                  <c:v>0.41599999999999998</c:v>
                </c:pt>
                <c:pt idx="217">
                  <c:v>0.41099999999999998</c:v>
                </c:pt>
                <c:pt idx="218">
                  <c:v>0.40699999999999997</c:v>
                </c:pt>
                <c:pt idx="219">
                  <c:v>0.40300000000000002</c:v>
                </c:pt>
                <c:pt idx="220">
                  <c:v>0.39900000000000002</c:v>
                </c:pt>
                <c:pt idx="221">
                  <c:v>0.39600000000000002</c:v>
                </c:pt>
                <c:pt idx="222">
                  <c:v>0.39200000000000002</c:v>
                </c:pt>
                <c:pt idx="223">
                  <c:v>0.38800000000000001</c:v>
                </c:pt>
                <c:pt idx="224">
                  <c:v>0.38500000000000001</c:v>
                </c:pt>
                <c:pt idx="225">
                  <c:v>0.38100000000000001</c:v>
                </c:pt>
                <c:pt idx="226">
                  <c:v>0.378</c:v>
                </c:pt>
                <c:pt idx="227">
                  <c:v>0.374</c:v>
                </c:pt>
                <c:pt idx="228">
                  <c:v>0.37</c:v>
                </c:pt>
                <c:pt idx="229">
                  <c:v>0.36599999999999999</c:v>
                </c:pt>
                <c:pt idx="230">
                  <c:v>0.36099999999999999</c:v>
                </c:pt>
                <c:pt idx="231">
                  <c:v>0.35699999999999998</c:v>
                </c:pt>
                <c:pt idx="232">
                  <c:v>0.35299999999999998</c:v>
                </c:pt>
                <c:pt idx="233">
                  <c:v>0.34799999999999998</c:v>
                </c:pt>
                <c:pt idx="234">
                  <c:v>0.34399999999999997</c:v>
                </c:pt>
                <c:pt idx="235">
                  <c:v>0.33900000000000002</c:v>
                </c:pt>
                <c:pt idx="236">
                  <c:v>0.33400000000000002</c:v>
                </c:pt>
                <c:pt idx="237">
                  <c:v>0.33</c:v>
                </c:pt>
                <c:pt idx="238">
                  <c:v>0.32500000000000001</c:v>
                </c:pt>
                <c:pt idx="239">
                  <c:v>0.32100000000000001</c:v>
                </c:pt>
                <c:pt idx="240">
                  <c:v>0.316</c:v>
                </c:pt>
                <c:pt idx="241">
                  <c:v>0.312</c:v>
                </c:pt>
                <c:pt idx="242">
                  <c:v>0.307</c:v>
                </c:pt>
                <c:pt idx="243">
                  <c:v>0.30299999999999999</c:v>
                </c:pt>
                <c:pt idx="244">
                  <c:v>0.29899999999999999</c:v>
                </c:pt>
                <c:pt idx="245">
                  <c:v>0.29399999999999998</c:v>
                </c:pt>
                <c:pt idx="246">
                  <c:v>0.28999999999999998</c:v>
                </c:pt>
                <c:pt idx="247">
                  <c:v>0.28599999999999998</c:v>
                </c:pt>
                <c:pt idx="248">
                  <c:v>0.28100000000000003</c:v>
                </c:pt>
                <c:pt idx="249">
                  <c:v>0.27700000000000002</c:v>
                </c:pt>
                <c:pt idx="250">
                  <c:v>0.27300000000000002</c:v>
                </c:pt>
                <c:pt idx="251">
                  <c:v>0.26900000000000002</c:v>
                </c:pt>
                <c:pt idx="252">
                  <c:v>0.26400000000000001</c:v>
                </c:pt>
                <c:pt idx="253">
                  <c:v>0.26</c:v>
                </c:pt>
                <c:pt idx="254">
                  <c:v>0.25600000000000001</c:v>
                </c:pt>
                <c:pt idx="255">
                  <c:v>0.252</c:v>
                </c:pt>
                <c:pt idx="256">
                  <c:v>0.248</c:v>
                </c:pt>
                <c:pt idx="257">
                  <c:v>0.24399999999999999</c:v>
                </c:pt>
                <c:pt idx="258">
                  <c:v>0.24</c:v>
                </c:pt>
                <c:pt idx="259">
                  <c:v>0.23599999999999999</c:v>
                </c:pt>
                <c:pt idx="260">
                  <c:v>0.23200000000000001</c:v>
                </c:pt>
                <c:pt idx="261">
                  <c:v>0.22800000000000001</c:v>
                </c:pt>
                <c:pt idx="262">
                  <c:v>0.224</c:v>
                </c:pt>
                <c:pt idx="263">
                  <c:v>0.221</c:v>
                </c:pt>
                <c:pt idx="264">
                  <c:v>0.217</c:v>
                </c:pt>
                <c:pt idx="265">
                  <c:v>0.21299999999999999</c:v>
                </c:pt>
                <c:pt idx="266">
                  <c:v>0.21</c:v>
                </c:pt>
                <c:pt idx="267">
                  <c:v>0.20599999999999999</c:v>
                </c:pt>
                <c:pt idx="268">
                  <c:v>0.20200000000000001</c:v>
                </c:pt>
                <c:pt idx="269">
                  <c:v>0.19900000000000001</c:v>
                </c:pt>
                <c:pt idx="270">
                  <c:v>0.19500000000000001</c:v>
                </c:pt>
                <c:pt idx="271">
                  <c:v>0.191</c:v>
                </c:pt>
                <c:pt idx="272">
                  <c:v>0.187</c:v>
                </c:pt>
                <c:pt idx="273">
                  <c:v>0.184</c:v>
                </c:pt>
                <c:pt idx="274">
                  <c:v>0.18</c:v>
                </c:pt>
                <c:pt idx="275">
                  <c:v>0.17699999999999999</c:v>
                </c:pt>
                <c:pt idx="276">
                  <c:v>0.17299999999999999</c:v>
                </c:pt>
                <c:pt idx="277">
                  <c:v>0.17</c:v>
                </c:pt>
                <c:pt idx="278">
                  <c:v>0.16600000000000001</c:v>
                </c:pt>
                <c:pt idx="279">
                  <c:v>0.16300000000000001</c:v>
                </c:pt>
                <c:pt idx="280">
                  <c:v>0.159</c:v>
                </c:pt>
                <c:pt idx="281">
                  <c:v>0.156</c:v>
                </c:pt>
                <c:pt idx="282">
                  <c:v>0.153</c:v>
                </c:pt>
                <c:pt idx="283">
                  <c:v>0.14899999999999999</c:v>
                </c:pt>
                <c:pt idx="284">
                  <c:v>0.14599999999999999</c:v>
                </c:pt>
                <c:pt idx="285">
                  <c:v>0.14299999999999999</c:v>
                </c:pt>
                <c:pt idx="286">
                  <c:v>0.14000000000000001</c:v>
                </c:pt>
                <c:pt idx="287">
                  <c:v>0.13700000000000001</c:v>
                </c:pt>
                <c:pt idx="288">
                  <c:v>0.13400000000000001</c:v>
                </c:pt>
                <c:pt idx="289">
                  <c:v>0.13</c:v>
                </c:pt>
                <c:pt idx="290">
                  <c:v>0.127</c:v>
                </c:pt>
                <c:pt idx="291">
                  <c:v>0.124</c:v>
                </c:pt>
                <c:pt idx="292">
                  <c:v>0.121</c:v>
                </c:pt>
                <c:pt idx="293">
                  <c:v>0.11799999999999999</c:v>
                </c:pt>
                <c:pt idx="294">
                  <c:v>0.115</c:v>
                </c:pt>
                <c:pt idx="295">
                  <c:v>0.112</c:v>
                </c:pt>
                <c:pt idx="296">
                  <c:v>0.109</c:v>
                </c:pt>
                <c:pt idx="297">
                  <c:v>0.106</c:v>
                </c:pt>
                <c:pt idx="298">
                  <c:v>0.10299999999999999</c:v>
                </c:pt>
                <c:pt idx="299">
                  <c:v>0.1</c:v>
                </c:pt>
                <c:pt idx="300">
                  <c:v>9.8000000000000004E-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CCF8-4C26-A940-2CDBC6DE7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41928"/>
        <c:axId val="646735656"/>
      </c:scatterChart>
      <c:valAx>
        <c:axId val="646741928"/>
        <c:scaling>
          <c:orientation val="minMax"/>
          <c:max val="800"/>
          <c:min val="5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avelength</a:t>
                </a:r>
                <a:r>
                  <a:rPr lang="en-US" baseline="0"/>
                  <a:t> (nm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46735656"/>
        <c:crosses val="autoZero"/>
        <c:crossBetween val="midCat"/>
      </c:valAx>
      <c:valAx>
        <c:axId val="6467356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46741928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75438801399825017"/>
          <c:y val="0.2629290609507145"/>
          <c:w val="0.22616754155730534"/>
          <c:h val="0.41858595800524934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9016404199475064E-2"/>
          <c:y val="2.8252405949256341E-2"/>
          <c:w val="0.84930314960629927"/>
          <c:h val="0.757711796442111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40 mg L⁻¹</c:v>
                </c:pt>
              </c:strCache>
            </c:strRef>
          </c:tx>
          <c:marker>
            <c:symbol val="none"/>
          </c:marker>
          <c:xVal>
            <c:numRef>
              <c:f>Sheet1!$A$3:$A$613</c:f>
              <c:numCache>
                <c:formatCode>General</c:formatCode>
                <c:ptCount val="61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  <c:pt idx="601">
                  <c:v>199</c:v>
                </c:pt>
                <c:pt idx="602">
                  <c:v>198</c:v>
                </c:pt>
                <c:pt idx="603">
                  <c:v>197</c:v>
                </c:pt>
                <c:pt idx="604">
                  <c:v>196</c:v>
                </c:pt>
                <c:pt idx="605">
                  <c:v>195</c:v>
                </c:pt>
                <c:pt idx="606">
                  <c:v>194</c:v>
                </c:pt>
                <c:pt idx="607">
                  <c:v>193</c:v>
                </c:pt>
                <c:pt idx="608">
                  <c:v>192</c:v>
                </c:pt>
                <c:pt idx="609">
                  <c:v>191</c:v>
                </c:pt>
                <c:pt idx="610">
                  <c:v>190</c:v>
                </c:pt>
              </c:numCache>
            </c:numRef>
          </c:xVal>
          <c:yVal>
            <c:numRef>
              <c:f>Sheet1!$B$3:$B$613</c:f>
              <c:numCache>
                <c:formatCode>General</c:formatCode>
                <c:ptCount val="611"/>
                <c:pt idx="0">
                  <c:v>3.5000000000000003E-2</c:v>
                </c:pt>
                <c:pt idx="1">
                  <c:v>3.5000000000000003E-2</c:v>
                </c:pt>
                <c:pt idx="2">
                  <c:v>3.5000000000000003E-2</c:v>
                </c:pt>
                <c:pt idx="3">
                  <c:v>3.5999999999999997E-2</c:v>
                </c:pt>
                <c:pt idx="4">
                  <c:v>3.5999999999999997E-2</c:v>
                </c:pt>
                <c:pt idx="5">
                  <c:v>3.6999999999999998E-2</c:v>
                </c:pt>
                <c:pt idx="6">
                  <c:v>3.6999999999999998E-2</c:v>
                </c:pt>
                <c:pt idx="7">
                  <c:v>3.7999999999999999E-2</c:v>
                </c:pt>
                <c:pt idx="8">
                  <c:v>3.9E-2</c:v>
                </c:pt>
                <c:pt idx="9">
                  <c:v>3.9E-2</c:v>
                </c:pt>
                <c:pt idx="10">
                  <c:v>0.04</c:v>
                </c:pt>
                <c:pt idx="11">
                  <c:v>4.1000000000000002E-2</c:v>
                </c:pt>
                <c:pt idx="12">
                  <c:v>4.1000000000000002E-2</c:v>
                </c:pt>
                <c:pt idx="13">
                  <c:v>4.2000000000000003E-2</c:v>
                </c:pt>
                <c:pt idx="14">
                  <c:v>4.2999999999999997E-2</c:v>
                </c:pt>
                <c:pt idx="15">
                  <c:v>4.3999999999999997E-2</c:v>
                </c:pt>
                <c:pt idx="16">
                  <c:v>4.3999999999999997E-2</c:v>
                </c:pt>
                <c:pt idx="17">
                  <c:v>4.4999999999999998E-2</c:v>
                </c:pt>
                <c:pt idx="18">
                  <c:v>4.5999999999999999E-2</c:v>
                </c:pt>
                <c:pt idx="19">
                  <c:v>4.7E-2</c:v>
                </c:pt>
                <c:pt idx="20">
                  <c:v>4.8000000000000001E-2</c:v>
                </c:pt>
                <c:pt idx="21">
                  <c:v>4.9000000000000002E-2</c:v>
                </c:pt>
                <c:pt idx="22">
                  <c:v>0.05</c:v>
                </c:pt>
                <c:pt idx="23">
                  <c:v>5.0999999999999997E-2</c:v>
                </c:pt>
                <c:pt idx="24">
                  <c:v>5.1999999999999998E-2</c:v>
                </c:pt>
                <c:pt idx="25">
                  <c:v>5.2999999999999999E-2</c:v>
                </c:pt>
                <c:pt idx="26">
                  <c:v>5.3999999999999999E-2</c:v>
                </c:pt>
                <c:pt idx="27">
                  <c:v>5.5E-2</c:v>
                </c:pt>
                <c:pt idx="28">
                  <c:v>5.6000000000000001E-2</c:v>
                </c:pt>
                <c:pt idx="29">
                  <c:v>5.7000000000000002E-2</c:v>
                </c:pt>
                <c:pt idx="30">
                  <c:v>5.8999999999999997E-2</c:v>
                </c:pt>
                <c:pt idx="31">
                  <c:v>0.06</c:v>
                </c:pt>
                <c:pt idx="32">
                  <c:v>6.0999999999999999E-2</c:v>
                </c:pt>
                <c:pt idx="33">
                  <c:v>6.3E-2</c:v>
                </c:pt>
                <c:pt idx="34">
                  <c:v>6.4000000000000001E-2</c:v>
                </c:pt>
                <c:pt idx="35">
                  <c:v>6.6000000000000003E-2</c:v>
                </c:pt>
                <c:pt idx="36">
                  <c:v>6.7000000000000004E-2</c:v>
                </c:pt>
                <c:pt idx="37">
                  <c:v>6.9000000000000006E-2</c:v>
                </c:pt>
                <c:pt idx="38">
                  <c:v>7.0000000000000007E-2</c:v>
                </c:pt>
                <c:pt idx="39">
                  <c:v>7.1999999999999995E-2</c:v>
                </c:pt>
                <c:pt idx="40">
                  <c:v>7.3999999999999996E-2</c:v>
                </c:pt>
                <c:pt idx="41">
                  <c:v>7.4999999999999997E-2</c:v>
                </c:pt>
                <c:pt idx="42">
                  <c:v>7.5999999999999998E-2</c:v>
                </c:pt>
                <c:pt idx="43">
                  <c:v>7.8E-2</c:v>
                </c:pt>
                <c:pt idx="44">
                  <c:v>7.9000000000000001E-2</c:v>
                </c:pt>
                <c:pt idx="45">
                  <c:v>8.1000000000000003E-2</c:v>
                </c:pt>
                <c:pt idx="46">
                  <c:v>8.3000000000000004E-2</c:v>
                </c:pt>
                <c:pt idx="47">
                  <c:v>8.5000000000000006E-2</c:v>
                </c:pt>
                <c:pt idx="48">
                  <c:v>8.5999999999999993E-2</c:v>
                </c:pt>
                <c:pt idx="49">
                  <c:v>8.7999999999999995E-2</c:v>
                </c:pt>
                <c:pt idx="50">
                  <c:v>0.09</c:v>
                </c:pt>
                <c:pt idx="51">
                  <c:v>9.1999999999999998E-2</c:v>
                </c:pt>
                <c:pt idx="52">
                  <c:v>9.2999999999999999E-2</c:v>
                </c:pt>
                <c:pt idx="53">
                  <c:v>9.5000000000000001E-2</c:v>
                </c:pt>
                <c:pt idx="54">
                  <c:v>9.7000000000000003E-2</c:v>
                </c:pt>
                <c:pt idx="55">
                  <c:v>9.8000000000000004E-2</c:v>
                </c:pt>
                <c:pt idx="56">
                  <c:v>9.9000000000000005E-2</c:v>
                </c:pt>
                <c:pt idx="57">
                  <c:v>0.1</c:v>
                </c:pt>
                <c:pt idx="58">
                  <c:v>0.10100000000000001</c:v>
                </c:pt>
                <c:pt idx="59">
                  <c:v>0.10199999999999999</c:v>
                </c:pt>
                <c:pt idx="60">
                  <c:v>0.10199999999999999</c:v>
                </c:pt>
                <c:pt idx="61">
                  <c:v>0.10299999999999999</c:v>
                </c:pt>
                <c:pt idx="62">
                  <c:v>0.105</c:v>
                </c:pt>
                <c:pt idx="63">
                  <c:v>0.107</c:v>
                </c:pt>
                <c:pt idx="64">
                  <c:v>0.109</c:v>
                </c:pt>
                <c:pt idx="65">
                  <c:v>0.111</c:v>
                </c:pt>
                <c:pt idx="66">
                  <c:v>0.113</c:v>
                </c:pt>
                <c:pt idx="67">
                  <c:v>0.115</c:v>
                </c:pt>
                <c:pt idx="68">
                  <c:v>0.11799999999999999</c:v>
                </c:pt>
                <c:pt idx="69">
                  <c:v>0.12</c:v>
                </c:pt>
                <c:pt idx="70">
                  <c:v>0.123</c:v>
                </c:pt>
                <c:pt idx="71">
                  <c:v>0.126</c:v>
                </c:pt>
                <c:pt idx="72">
                  <c:v>0.128</c:v>
                </c:pt>
                <c:pt idx="73">
                  <c:v>0.13100000000000001</c:v>
                </c:pt>
                <c:pt idx="74">
                  <c:v>0.13300000000000001</c:v>
                </c:pt>
                <c:pt idx="75">
                  <c:v>0.13600000000000001</c:v>
                </c:pt>
                <c:pt idx="76">
                  <c:v>0.13800000000000001</c:v>
                </c:pt>
                <c:pt idx="77">
                  <c:v>0.14099999999999999</c:v>
                </c:pt>
                <c:pt idx="78">
                  <c:v>0.14299999999999999</c:v>
                </c:pt>
                <c:pt idx="79">
                  <c:v>0.14599999999999999</c:v>
                </c:pt>
                <c:pt idx="80">
                  <c:v>0.14899999999999999</c:v>
                </c:pt>
                <c:pt idx="81">
                  <c:v>0.151</c:v>
                </c:pt>
                <c:pt idx="82">
                  <c:v>0.154</c:v>
                </c:pt>
                <c:pt idx="83">
                  <c:v>0.156</c:v>
                </c:pt>
                <c:pt idx="84">
                  <c:v>0.159</c:v>
                </c:pt>
                <c:pt idx="85">
                  <c:v>0.161</c:v>
                </c:pt>
                <c:pt idx="86">
                  <c:v>0.16400000000000001</c:v>
                </c:pt>
                <c:pt idx="87">
                  <c:v>0.16600000000000001</c:v>
                </c:pt>
                <c:pt idx="88">
                  <c:v>0.16900000000000001</c:v>
                </c:pt>
                <c:pt idx="89">
                  <c:v>0.17199999999999999</c:v>
                </c:pt>
                <c:pt idx="90">
                  <c:v>0.17399999999999999</c:v>
                </c:pt>
                <c:pt idx="91">
                  <c:v>0.17699999999999999</c:v>
                </c:pt>
                <c:pt idx="92">
                  <c:v>0.18</c:v>
                </c:pt>
                <c:pt idx="93">
                  <c:v>0.182</c:v>
                </c:pt>
                <c:pt idx="94">
                  <c:v>0.185</c:v>
                </c:pt>
                <c:pt idx="95">
                  <c:v>0.188</c:v>
                </c:pt>
                <c:pt idx="96">
                  <c:v>0.19</c:v>
                </c:pt>
                <c:pt idx="97">
                  <c:v>0.193</c:v>
                </c:pt>
                <c:pt idx="98">
                  <c:v>0.19600000000000001</c:v>
                </c:pt>
                <c:pt idx="99">
                  <c:v>0.19900000000000001</c:v>
                </c:pt>
                <c:pt idx="100">
                  <c:v>0.20100000000000001</c:v>
                </c:pt>
                <c:pt idx="101">
                  <c:v>0.20399999999999999</c:v>
                </c:pt>
                <c:pt idx="102">
                  <c:v>0.20599999999999999</c:v>
                </c:pt>
                <c:pt idx="103">
                  <c:v>0.20899999999999999</c:v>
                </c:pt>
                <c:pt idx="104">
                  <c:v>0.21199999999999999</c:v>
                </c:pt>
                <c:pt idx="105">
                  <c:v>0.214</c:v>
                </c:pt>
                <c:pt idx="106">
                  <c:v>0.217</c:v>
                </c:pt>
                <c:pt idx="107">
                  <c:v>0.219</c:v>
                </c:pt>
                <c:pt idx="108">
                  <c:v>0.222</c:v>
                </c:pt>
                <c:pt idx="109">
                  <c:v>0.22500000000000001</c:v>
                </c:pt>
                <c:pt idx="110">
                  <c:v>0.22700000000000001</c:v>
                </c:pt>
                <c:pt idx="111">
                  <c:v>0.23</c:v>
                </c:pt>
                <c:pt idx="112">
                  <c:v>0.23300000000000001</c:v>
                </c:pt>
                <c:pt idx="113">
                  <c:v>0.23599999999999999</c:v>
                </c:pt>
                <c:pt idx="114">
                  <c:v>0.23799999999999999</c:v>
                </c:pt>
                <c:pt idx="115">
                  <c:v>0.24099999999999999</c:v>
                </c:pt>
                <c:pt idx="116">
                  <c:v>0.24399999999999999</c:v>
                </c:pt>
                <c:pt idx="117">
                  <c:v>0.246</c:v>
                </c:pt>
                <c:pt idx="118">
                  <c:v>0.249</c:v>
                </c:pt>
                <c:pt idx="119">
                  <c:v>0.251</c:v>
                </c:pt>
                <c:pt idx="120">
                  <c:v>0.254</c:v>
                </c:pt>
                <c:pt idx="121">
                  <c:v>0.25700000000000001</c:v>
                </c:pt>
                <c:pt idx="122">
                  <c:v>0.25900000000000001</c:v>
                </c:pt>
                <c:pt idx="123">
                  <c:v>0.26200000000000001</c:v>
                </c:pt>
                <c:pt idx="124">
                  <c:v>0.26400000000000001</c:v>
                </c:pt>
                <c:pt idx="125">
                  <c:v>0.26700000000000002</c:v>
                </c:pt>
                <c:pt idx="126">
                  <c:v>0.26900000000000002</c:v>
                </c:pt>
                <c:pt idx="127">
                  <c:v>0.27200000000000002</c:v>
                </c:pt>
                <c:pt idx="128">
                  <c:v>0.27400000000000002</c:v>
                </c:pt>
                <c:pt idx="129">
                  <c:v>0.27700000000000002</c:v>
                </c:pt>
                <c:pt idx="130">
                  <c:v>0.27900000000000003</c:v>
                </c:pt>
                <c:pt idx="131">
                  <c:v>0.28199999999999997</c:v>
                </c:pt>
                <c:pt idx="132">
                  <c:v>0.28399999999999997</c:v>
                </c:pt>
                <c:pt idx="133">
                  <c:v>0.28699999999999998</c:v>
                </c:pt>
                <c:pt idx="134">
                  <c:v>0.28899999999999998</c:v>
                </c:pt>
                <c:pt idx="135">
                  <c:v>0.29199999999999998</c:v>
                </c:pt>
                <c:pt idx="136">
                  <c:v>0.29399999999999998</c:v>
                </c:pt>
                <c:pt idx="137">
                  <c:v>0.29599999999999999</c:v>
                </c:pt>
                <c:pt idx="138">
                  <c:v>0.29899999999999999</c:v>
                </c:pt>
                <c:pt idx="139">
                  <c:v>0.30099999999999999</c:v>
                </c:pt>
                <c:pt idx="140">
                  <c:v>0.30399999999999999</c:v>
                </c:pt>
                <c:pt idx="141">
                  <c:v>0.30599999999999999</c:v>
                </c:pt>
                <c:pt idx="142">
                  <c:v>0.308</c:v>
                </c:pt>
                <c:pt idx="143">
                  <c:v>0.31</c:v>
                </c:pt>
                <c:pt idx="144">
                  <c:v>0.312</c:v>
                </c:pt>
                <c:pt idx="145">
                  <c:v>0.314</c:v>
                </c:pt>
                <c:pt idx="146">
                  <c:v>0.317</c:v>
                </c:pt>
                <c:pt idx="147">
                  <c:v>0.31900000000000001</c:v>
                </c:pt>
                <c:pt idx="148">
                  <c:v>0.32100000000000001</c:v>
                </c:pt>
                <c:pt idx="149">
                  <c:v>0.32300000000000001</c:v>
                </c:pt>
                <c:pt idx="150">
                  <c:v>0.32600000000000001</c:v>
                </c:pt>
                <c:pt idx="151">
                  <c:v>0.32800000000000001</c:v>
                </c:pt>
                <c:pt idx="152">
                  <c:v>0.33</c:v>
                </c:pt>
                <c:pt idx="153">
                  <c:v>0.33200000000000002</c:v>
                </c:pt>
                <c:pt idx="154">
                  <c:v>0.33500000000000002</c:v>
                </c:pt>
                <c:pt idx="155">
                  <c:v>0.33700000000000002</c:v>
                </c:pt>
                <c:pt idx="156">
                  <c:v>0.33900000000000002</c:v>
                </c:pt>
                <c:pt idx="157">
                  <c:v>0.34100000000000003</c:v>
                </c:pt>
                <c:pt idx="158">
                  <c:v>0.34399999999999997</c:v>
                </c:pt>
                <c:pt idx="159">
                  <c:v>0.34599999999999997</c:v>
                </c:pt>
                <c:pt idx="160">
                  <c:v>0.34799999999999998</c:v>
                </c:pt>
                <c:pt idx="161">
                  <c:v>0.35</c:v>
                </c:pt>
                <c:pt idx="162">
                  <c:v>0.35299999999999998</c:v>
                </c:pt>
                <c:pt idx="163">
                  <c:v>0.35499999999999998</c:v>
                </c:pt>
                <c:pt idx="164">
                  <c:v>0.35699999999999998</c:v>
                </c:pt>
                <c:pt idx="165">
                  <c:v>0.35899999999999999</c:v>
                </c:pt>
                <c:pt idx="166">
                  <c:v>0.36099999999999999</c:v>
                </c:pt>
                <c:pt idx="167">
                  <c:v>0.36399999999999999</c:v>
                </c:pt>
                <c:pt idx="168">
                  <c:v>0.36599999999999999</c:v>
                </c:pt>
                <c:pt idx="169">
                  <c:v>0.36799999999999999</c:v>
                </c:pt>
                <c:pt idx="170">
                  <c:v>0.37</c:v>
                </c:pt>
                <c:pt idx="171">
                  <c:v>0.373</c:v>
                </c:pt>
                <c:pt idx="172">
                  <c:v>0.375</c:v>
                </c:pt>
                <c:pt idx="173">
                  <c:v>0.378</c:v>
                </c:pt>
                <c:pt idx="174">
                  <c:v>0.38</c:v>
                </c:pt>
                <c:pt idx="175">
                  <c:v>0.38200000000000001</c:v>
                </c:pt>
                <c:pt idx="176">
                  <c:v>0.38500000000000001</c:v>
                </c:pt>
                <c:pt idx="177">
                  <c:v>0.38700000000000001</c:v>
                </c:pt>
                <c:pt idx="178">
                  <c:v>0.39</c:v>
                </c:pt>
                <c:pt idx="179">
                  <c:v>0.39200000000000002</c:v>
                </c:pt>
                <c:pt idx="180">
                  <c:v>0.39500000000000002</c:v>
                </c:pt>
                <c:pt idx="181">
                  <c:v>0.39700000000000002</c:v>
                </c:pt>
                <c:pt idx="182">
                  <c:v>0.4</c:v>
                </c:pt>
                <c:pt idx="183">
                  <c:v>0.40200000000000002</c:v>
                </c:pt>
                <c:pt idx="184">
                  <c:v>0.40500000000000003</c:v>
                </c:pt>
                <c:pt idx="185">
                  <c:v>0.40699999999999997</c:v>
                </c:pt>
                <c:pt idx="186">
                  <c:v>0.41</c:v>
                </c:pt>
                <c:pt idx="187">
                  <c:v>0.41199999999999998</c:v>
                </c:pt>
                <c:pt idx="188">
                  <c:v>0.41499999999999998</c:v>
                </c:pt>
                <c:pt idx="189">
                  <c:v>0.41699999999999998</c:v>
                </c:pt>
                <c:pt idx="190">
                  <c:v>0.42</c:v>
                </c:pt>
                <c:pt idx="191">
                  <c:v>0.42299999999999999</c:v>
                </c:pt>
                <c:pt idx="192">
                  <c:v>0.42599999999999999</c:v>
                </c:pt>
                <c:pt idx="193">
                  <c:v>0.42799999999999999</c:v>
                </c:pt>
                <c:pt idx="194">
                  <c:v>0.43099999999999999</c:v>
                </c:pt>
                <c:pt idx="195">
                  <c:v>0.434</c:v>
                </c:pt>
                <c:pt idx="196">
                  <c:v>0.437</c:v>
                </c:pt>
                <c:pt idx="197">
                  <c:v>0.44</c:v>
                </c:pt>
                <c:pt idx="198">
                  <c:v>0.443</c:v>
                </c:pt>
                <c:pt idx="199">
                  <c:v>0.44600000000000001</c:v>
                </c:pt>
                <c:pt idx="200">
                  <c:v>0.44700000000000001</c:v>
                </c:pt>
                <c:pt idx="201">
                  <c:v>0.45100000000000001</c:v>
                </c:pt>
                <c:pt idx="202">
                  <c:v>0.45400000000000001</c:v>
                </c:pt>
                <c:pt idx="203">
                  <c:v>0.45700000000000002</c:v>
                </c:pt>
                <c:pt idx="204">
                  <c:v>0.46</c:v>
                </c:pt>
                <c:pt idx="205">
                  <c:v>0.46300000000000002</c:v>
                </c:pt>
                <c:pt idx="206">
                  <c:v>0.46600000000000003</c:v>
                </c:pt>
                <c:pt idx="207">
                  <c:v>0.46899999999999997</c:v>
                </c:pt>
                <c:pt idx="208">
                  <c:v>0.47199999999999998</c:v>
                </c:pt>
                <c:pt idx="209">
                  <c:v>0.47599999999999998</c:v>
                </c:pt>
                <c:pt idx="210">
                  <c:v>0.47899999999999998</c:v>
                </c:pt>
                <c:pt idx="211">
                  <c:v>0.48199999999999998</c:v>
                </c:pt>
                <c:pt idx="212">
                  <c:v>0.48599999999999999</c:v>
                </c:pt>
                <c:pt idx="213">
                  <c:v>0.48899999999999999</c:v>
                </c:pt>
                <c:pt idx="214">
                  <c:v>0.49199999999999999</c:v>
                </c:pt>
                <c:pt idx="215">
                  <c:v>0.496</c:v>
                </c:pt>
                <c:pt idx="216">
                  <c:v>0.499</c:v>
                </c:pt>
                <c:pt idx="217">
                  <c:v>0.502</c:v>
                </c:pt>
                <c:pt idx="218">
                  <c:v>0.50600000000000001</c:v>
                </c:pt>
                <c:pt idx="219">
                  <c:v>0.51</c:v>
                </c:pt>
                <c:pt idx="220">
                  <c:v>0.51300000000000001</c:v>
                </c:pt>
                <c:pt idx="221">
                  <c:v>0.51800000000000002</c:v>
                </c:pt>
                <c:pt idx="222">
                  <c:v>0.52200000000000002</c:v>
                </c:pt>
                <c:pt idx="223">
                  <c:v>0.52600000000000002</c:v>
                </c:pt>
                <c:pt idx="224">
                  <c:v>0.53100000000000003</c:v>
                </c:pt>
                <c:pt idx="225">
                  <c:v>0.53600000000000003</c:v>
                </c:pt>
                <c:pt idx="226">
                  <c:v>0.54100000000000004</c:v>
                </c:pt>
                <c:pt idx="227">
                  <c:v>0.54600000000000004</c:v>
                </c:pt>
                <c:pt idx="228">
                  <c:v>0.55100000000000005</c:v>
                </c:pt>
                <c:pt idx="229">
                  <c:v>0.55700000000000005</c:v>
                </c:pt>
                <c:pt idx="230">
                  <c:v>0.56200000000000006</c:v>
                </c:pt>
                <c:pt idx="231">
                  <c:v>0.56799999999999995</c:v>
                </c:pt>
                <c:pt idx="232">
                  <c:v>0.57399999999999995</c:v>
                </c:pt>
                <c:pt idx="233">
                  <c:v>0.57999999999999996</c:v>
                </c:pt>
                <c:pt idx="234">
                  <c:v>0.58599999999999997</c:v>
                </c:pt>
                <c:pt idx="235">
                  <c:v>0.59299999999999997</c:v>
                </c:pt>
                <c:pt idx="236">
                  <c:v>0.59899999999999998</c:v>
                </c:pt>
                <c:pt idx="237">
                  <c:v>0.60599999999999998</c:v>
                </c:pt>
                <c:pt idx="238">
                  <c:v>0.61399999999999999</c:v>
                </c:pt>
                <c:pt idx="239">
                  <c:v>0.621</c:v>
                </c:pt>
                <c:pt idx="240">
                  <c:v>0.629</c:v>
                </c:pt>
                <c:pt idx="241">
                  <c:v>0.63600000000000001</c:v>
                </c:pt>
                <c:pt idx="242">
                  <c:v>0.64400000000000002</c:v>
                </c:pt>
                <c:pt idx="243">
                  <c:v>0.65200000000000002</c:v>
                </c:pt>
                <c:pt idx="244">
                  <c:v>0.66</c:v>
                </c:pt>
                <c:pt idx="245">
                  <c:v>0.66800000000000004</c:v>
                </c:pt>
                <c:pt idx="246">
                  <c:v>0.67700000000000005</c:v>
                </c:pt>
                <c:pt idx="247">
                  <c:v>0.68500000000000005</c:v>
                </c:pt>
                <c:pt idx="248">
                  <c:v>0.69399999999999995</c:v>
                </c:pt>
                <c:pt idx="249">
                  <c:v>0.70399999999999996</c:v>
                </c:pt>
                <c:pt idx="250">
                  <c:v>0.71299999999999997</c:v>
                </c:pt>
                <c:pt idx="251">
                  <c:v>0.72299999999999998</c:v>
                </c:pt>
                <c:pt idx="252">
                  <c:v>0.73299999999999998</c:v>
                </c:pt>
                <c:pt idx="253">
                  <c:v>0.74399999999999999</c:v>
                </c:pt>
                <c:pt idx="254">
                  <c:v>0.754</c:v>
                </c:pt>
                <c:pt idx="255">
                  <c:v>0.76600000000000001</c:v>
                </c:pt>
                <c:pt idx="256">
                  <c:v>0.77600000000000002</c:v>
                </c:pt>
                <c:pt idx="257">
                  <c:v>0.78700000000000003</c:v>
                </c:pt>
                <c:pt idx="258">
                  <c:v>0.79800000000000004</c:v>
                </c:pt>
                <c:pt idx="259">
                  <c:v>0.80900000000000005</c:v>
                </c:pt>
                <c:pt idx="260">
                  <c:v>0.82</c:v>
                </c:pt>
                <c:pt idx="261">
                  <c:v>0.83099999999999996</c:v>
                </c:pt>
                <c:pt idx="262">
                  <c:v>0.84199999999999997</c:v>
                </c:pt>
                <c:pt idx="263">
                  <c:v>0.85199999999999998</c:v>
                </c:pt>
                <c:pt idx="264">
                  <c:v>0.86299999999999999</c:v>
                </c:pt>
                <c:pt idx="265">
                  <c:v>0.873</c:v>
                </c:pt>
                <c:pt idx="266">
                  <c:v>0.88300000000000001</c:v>
                </c:pt>
                <c:pt idx="267">
                  <c:v>0.89400000000000002</c:v>
                </c:pt>
                <c:pt idx="268">
                  <c:v>0.90400000000000003</c:v>
                </c:pt>
                <c:pt idx="269">
                  <c:v>0.91300000000000003</c:v>
                </c:pt>
                <c:pt idx="270">
                  <c:v>0.92300000000000004</c:v>
                </c:pt>
                <c:pt idx="271">
                  <c:v>0.93200000000000005</c:v>
                </c:pt>
                <c:pt idx="272">
                  <c:v>0.94099999999999995</c:v>
                </c:pt>
                <c:pt idx="273">
                  <c:v>0.95</c:v>
                </c:pt>
                <c:pt idx="274">
                  <c:v>0.95699999999999996</c:v>
                </c:pt>
                <c:pt idx="275">
                  <c:v>0.96399999999999997</c:v>
                </c:pt>
                <c:pt idx="276">
                  <c:v>0.97099999999999997</c:v>
                </c:pt>
                <c:pt idx="277">
                  <c:v>0.97699999999999998</c:v>
                </c:pt>
                <c:pt idx="278">
                  <c:v>0.98199999999999998</c:v>
                </c:pt>
                <c:pt idx="279">
                  <c:v>0.98699999999999999</c:v>
                </c:pt>
                <c:pt idx="280">
                  <c:v>0.99099999999999999</c:v>
                </c:pt>
                <c:pt idx="281">
                  <c:v>0.99399999999999999</c:v>
                </c:pt>
                <c:pt idx="282">
                  <c:v>0.996</c:v>
                </c:pt>
                <c:pt idx="283">
                  <c:v>0.998</c:v>
                </c:pt>
                <c:pt idx="284">
                  <c:v>0.999</c:v>
                </c:pt>
                <c:pt idx="285">
                  <c:v>0.999</c:v>
                </c:pt>
                <c:pt idx="286">
                  <c:v>0.998</c:v>
                </c:pt>
                <c:pt idx="287">
                  <c:v>0.996</c:v>
                </c:pt>
                <c:pt idx="288">
                  <c:v>0.99399999999999999</c:v>
                </c:pt>
                <c:pt idx="289">
                  <c:v>0.99099999999999999</c:v>
                </c:pt>
                <c:pt idx="290">
                  <c:v>0.98699999999999999</c:v>
                </c:pt>
                <c:pt idx="291">
                  <c:v>0.98199999999999998</c:v>
                </c:pt>
                <c:pt idx="292">
                  <c:v>0.97699999999999998</c:v>
                </c:pt>
                <c:pt idx="293">
                  <c:v>0.97099999999999997</c:v>
                </c:pt>
                <c:pt idx="294">
                  <c:v>0.96399999999999997</c:v>
                </c:pt>
                <c:pt idx="295">
                  <c:v>0.95599999999999996</c:v>
                </c:pt>
                <c:pt idx="296">
                  <c:v>0.94799999999999995</c:v>
                </c:pt>
                <c:pt idx="297">
                  <c:v>0.93899999999999995</c:v>
                </c:pt>
                <c:pt idx="298">
                  <c:v>0.92900000000000005</c:v>
                </c:pt>
                <c:pt idx="299">
                  <c:v>0.91900000000000004</c:v>
                </c:pt>
                <c:pt idx="300">
                  <c:v>0.90800000000000003</c:v>
                </c:pt>
                <c:pt idx="301">
                  <c:v>0.89800000000000002</c:v>
                </c:pt>
                <c:pt idx="302">
                  <c:v>0.88700000000000001</c:v>
                </c:pt>
                <c:pt idx="303">
                  <c:v>0.876</c:v>
                </c:pt>
                <c:pt idx="304">
                  <c:v>0.86399999999999999</c:v>
                </c:pt>
                <c:pt idx="305">
                  <c:v>0.85299999999999998</c:v>
                </c:pt>
                <c:pt idx="306">
                  <c:v>0.84099999999999997</c:v>
                </c:pt>
                <c:pt idx="307">
                  <c:v>0.82899999999999996</c:v>
                </c:pt>
                <c:pt idx="308">
                  <c:v>0.81599999999999995</c:v>
                </c:pt>
                <c:pt idx="309">
                  <c:v>0.80400000000000005</c:v>
                </c:pt>
                <c:pt idx="310">
                  <c:v>0.79100000000000004</c:v>
                </c:pt>
                <c:pt idx="311">
                  <c:v>0.77800000000000002</c:v>
                </c:pt>
                <c:pt idx="312">
                  <c:v>0.76500000000000001</c:v>
                </c:pt>
                <c:pt idx="313">
                  <c:v>0.752</c:v>
                </c:pt>
                <c:pt idx="314">
                  <c:v>0.73899999999999999</c:v>
                </c:pt>
                <c:pt idx="315">
                  <c:v>0.72499999999999998</c:v>
                </c:pt>
                <c:pt idx="316">
                  <c:v>0.71199999999999997</c:v>
                </c:pt>
                <c:pt idx="317">
                  <c:v>0.69899999999999995</c:v>
                </c:pt>
                <c:pt idx="318">
                  <c:v>0.68600000000000005</c:v>
                </c:pt>
                <c:pt idx="319">
                  <c:v>0.67300000000000004</c:v>
                </c:pt>
                <c:pt idx="320">
                  <c:v>0.66</c:v>
                </c:pt>
                <c:pt idx="321">
                  <c:v>0.64800000000000002</c:v>
                </c:pt>
                <c:pt idx="322">
                  <c:v>0.63600000000000001</c:v>
                </c:pt>
                <c:pt idx="323">
                  <c:v>0.623</c:v>
                </c:pt>
                <c:pt idx="324">
                  <c:v>0.61199999999999999</c:v>
                </c:pt>
                <c:pt idx="325">
                  <c:v>0.6</c:v>
                </c:pt>
                <c:pt idx="326">
                  <c:v>0.58799999999999997</c:v>
                </c:pt>
                <c:pt idx="327">
                  <c:v>0.57599999999999996</c:v>
                </c:pt>
                <c:pt idx="328">
                  <c:v>0.56499999999999995</c:v>
                </c:pt>
                <c:pt idx="329">
                  <c:v>0.55400000000000005</c:v>
                </c:pt>
                <c:pt idx="330">
                  <c:v>0.54300000000000004</c:v>
                </c:pt>
                <c:pt idx="331">
                  <c:v>0.53200000000000003</c:v>
                </c:pt>
                <c:pt idx="332">
                  <c:v>0.52100000000000002</c:v>
                </c:pt>
                <c:pt idx="333">
                  <c:v>0.51</c:v>
                </c:pt>
                <c:pt idx="334">
                  <c:v>0.5</c:v>
                </c:pt>
                <c:pt idx="335">
                  <c:v>0.49</c:v>
                </c:pt>
                <c:pt idx="336">
                  <c:v>0.48</c:v>
                </c:pt>
                <c:pt idx="337">
                  <c:v>0.47</c:v>
                </c:pt>
                <c:pt idx="338">
                  <c:v>0.46100000000000002</c:v>
                </c:pt>
                <c:pt idx="339">
                  <c:v>0.45100000000000001</c:v>
                </c:pt>
                <c:pt idx="340">
                  <c:v>0.442</c:v>
                </c:pt>
                <c:pt idx="341">
                  <c:v>0.434</c:v>
                </c:pt>
                <c:pt idx="342">
                  <c:v>0.42499999999999999</c:v>
                </c:pt>
                <c:pt idx="343">
                  <c:v>0.41699999999999998</c:v>
                </c:pt>
                <c:pt idx="344">
                  <c:v>0.40899999999999997</c:v>
                </c:pt>
                <c:pt idx="345">
                  <c:v>0.40200000000000002</c:v>
                </c:pt>
                <c:pt idx="346">
                  <c:v>0.39400000000000002</c:v>
                </c:pt>
                <c:pt idx="347">
                  <c:v>0.38700000000000001</c:v>
                </c:pt>
                <c:pt idx="348">
                  <c:v>0.38100000000000001</c:v>
                </c:pt>
                <c:pt idx="349">
                  <c:v>0.374</c:v>
                </c:pt>
                <c:pt idx="350">
                  <c:v>0.36699999999999999</c:v>
                </c:pt>
                <c:pt idx="351">
                  <c:v>0.36099999999999999</c:v>
                </c:pt>
                <c:pt idx="352">
                  <c:v>0.35499999999999998</c:v>
                </c:pt>
                <c:pt idx="353">
                  <c:v>0.34899999999999998</c:v>
                </c:pt>
                <c:pt idx="354">
                  <c:v>0.34399999999999997</c:v>
                </c:pt>
                <c:pt idx="355">
                  <c:v>0.33900000000000002</c:v>
                </c:pt>
                <c:pt idx="356">
                  <c:v>0.33400000000000002</c:v>
                </c:pt>
                <c:pt idx="357">
                  <c:v>0.32900000000000001</c:v>
                </c:pt>
                <c:pt idx="358">
                  <c:v>0.32500000000000001</c:v>
                </c:pt>
                <c:pt idx="359">
                  <c:v>0.32</c:v>
                </c:pt>
                <c:pt idx="360">
                  <c:v>0.316</c:v>
                </c:pt>
                <c:pt idx="361">
                  <c:v>0.312</c:v>
                </c:pt>
                <c:pt idx="362">
                  <c:v>0.308</c:v>
                </c:pt>
                <c:pt idx="363">
                  <c:v>0.30499999999999999</c:v>
                </c:pt>
                <c:pt idx="364">
                  <c:v>0.30199999999999999</c:v>
                </c:pt>
                <c:pt idx="365">
                  <c:v>0.29799999999999999</c:v>
                </c:pt>
                <c:pt idx="366">
                  <c:v>0.29499999999999998</c:v>
                </c:pt>
                <c:pt idx="367">
                  <c:v>0.29199999999999998</c:v>
                </c:pt>
                <c:pt idx="368">
                  <c:v>0.28899999999999998</c:v>
                </c:pt>
                <c:pt idx="369">
                  <c:v>0.28599999999999998</c:v>
                </c:pt>
                <c:pt idx="370">
                  <c:v>0.28299999999999997</c:v>
                </c:pt>
                <c:pt idx="371">
                  <c:v>0.28000000000000003</c:v>
                </c:pt>
                <c:pt idx="372">
                  <c:v>0.27700000000000002</c:v>
                </c:pt>
                <c:pt idx="373">
                  <c:v>0.27400000000000002</c:v>
                </c:pt>
                <c:pt idx="374">
                  <c:v>0.27200000000000002</c:v>
                </c:pt>
                <c:pt idx="375">
                  <c:v>0.26900000000000002</c:v>
                </c:pt>
                <c:pt idx="376">
                  <c:v>0.26600000000000001</c:v>
                </c:pt>
                <c:pt idx="377">
                  <c:v>0.26400000000000001</c:v>
                </c:pt>
                <c:pt idx="378">
                  <c:v>0.26100000000000001</c:v>
                </c:pt>
                <c:pt idx="379">
                  <c:v>0.25900000000000001</c:v>
                </c:pt>
                <c:pt idx="380">
                  <c:v>0.25700000000000001</c:v>
                </c:pt>
                <c:pt idx="381">
                  <c:v>0.254</c:v>
                </c:pt>
                <c:pt idx="382">
                  <c:v>0.252</c:v>
                </c:pt>
                <c:pt idx="383">
                  <c:v>0.25</c:v>
                </c:pt>
                <c:pt idx="384">
                  <c:v>0.248</c:v>
                </c:pt>
                <c:pt idx="385">
                  <c:v>0.247</c:v>
                </c:pt>
                <c:pt idx="386">
                  <c:v>0.245</c:v>
                </c:pt>
                <c:pt idx="387">
                  <c:v>0.24299999999999999</c:v>
                </c:pt>
                <c:pt idx="388">
                  <c:v>0.24199999999999999</c:v>
                </c:pt>
                <c:pt idx="389">
                  <c:v>0.24</c:v>
                </c:pt>
                <c:pt idx="390">
                  <c:v>0.23899999999999999</c:v>
                </c:pt>
                <c:pt idx="391">
                  <c:v>0.23699999999999999</c:v>
                </c:pt>
                <c:pt idx="392">
                  <c:v>0.23599999999999999</c:v>
                </c:pt>
                <c:pt idx="393">
                  <c:v>0.23499999999999999</c:v>
                </c:pt>
                <c:pt idx="394">
                  <c:v>0.23499999999999999</c:v>
                </c:pt>
                <c:pt idx="395">
                  <c:v>0.23400000000000001</c:v>
                </c:pt>
                <c:pt idx="396">
                  <c:v>0.23400000000000001</c:v>
                </c:pt>
                <c:pt idx="397">
                  <c:v>0.23300000000000001</c:v>
                </c:pt>
                <c:pt idx="398">
                  <c:v>0.23300000000000001</c:v>
                </c:pt>
                <c:pt idx="399">
                  <c:v>0.23300000000000001</c:v>
                </c:pt>
                <c:pt idx="400">
                  <c:v>0.23400000000000001</c:v>
                </c:pt>
                <c:pt idx="401">
                  <c:v>0.23400000000000001</c:v>
                </c:pt>
                <c:pt idx="402">
                  <c:v>0.23499999999999999</c:v>
                </c:pt>
                <c:pt idx="403">
                  <c:v>0.23599999999999999</c:v>
                </c:pt>
                <c:pt idx="404">
                  <c:v>0.23699999999999999</c:v>
                </c:pt>
                <c:pt idx="405">
                  <c:v>0.23799999999999999</c:v>
                </c:pt>
                <c:pt idx="406">
                  <c:v>0.24</c:v>
                </c:pt>
                <c:pt idx="407">
                  <c:v>0.24199999999999999</c:v>
                </c:pt>
                <c:pt idx="408">
                  <c:v>0.24399999999999999</c:v>
                </c:pt>
                <c:pt idx="409">
                  <c:v>0.246</c:v>
                </c:pt>
                <c:pt idx="410">
                  <c:v>0.249</c:v>
                </c:pt>
                <c:pt idx="411">
                  <c:v>0.252</c:v>
                </c:pt>
                <c:pt idx="412">
                  <c:v>0.255</c:v>
                </c:pt>
                <c:pt idx="413">
                  <c:v>0.25900000000000001</c:v>
                </c:pt>
                <c:pt idx="414">
                  <c:v>0.26300000000000001</c:v>
                </c:pt>
                <c:pt idx="415">
                  <c:v>0.26700000000000002</c:v>
                </c:pt>
                <c:pt idx="416">
                  <c:v>0.27200000000000002</c:v>
                </c:pt>
                <c:pt idx="417">
                  <c:v>0.27600000000000002</c:v>
                </c:pt>
                <c:pt idx="418">
                  <c:v>0.28100000000000003</c:v>
                </c:pt>
                <c:pt idx="419">
                  <c:v>0.28699999999999998</c:v>
                </c:pt>
                <c:pt idx="420">
                  <c:v>0.29199999999999998</c:v>
                </c:pt>
                <c:pt idx="421">
                  <c:v>0.3</c:v>
                </c:pt>
                <c:pt idx="422">
                  <c:v>0.32100000000000001</c:v>
                </c:pt>
                <c:pt idx="423">
                  <c:v>0.32700000000000001</c:v>
                </c:pt>
                <c:pt idx="424">
                  <c:v>0.33400000000000002</c:v>
                </c:pt>
                <c:pt idx="425">
                  <c:v>0.34</c:v>
                </c:pt>
                <c:pt idx="426">
                  <c:v>0.34699999999999998</c:v>
                </c:pt>
                <c:pt idx="427">
                  <c:v>0.35399999999999998</c:v>
                </c:pt>
                <c:pt idx="428">
                  <c:v>0.36199999999999999</c:v>
                </c:pt>
                <c:pt idx="429">
                  <c:v>0.37</c:v>
                </c:pt>
                <c:pt idx="430">
                  <c:v>0.378</c:v>
                </c:pt>
                <c:pt idx="431">
                  <c:v>0.38600000000000001</c:v>
                </c:pt>
                <c:pt idx="432">
                  <c:v>0.39400000000000002</c:v>
                </c:pt>
                <c:pt idx="433">
                  <c:v>0.40300000000000002</c:v>
                </c:pt>
                <c:pt idx="434">
                  <c:v>0.41199999999999998</c:v>
                </c:pt>
                <c:pt idx="435">
                  <c:v>0.42</c:v>
                </c:pt>
                <c:pt idx="436">
                  <c:v>0.43</c:v>
                </c:pt>
                <c:pt idx="437">
                  <c:v>0.439</c:v>
                </c:pt>
                <c:pt idx="438">
                  <c:v>0.44900000000000001</c:v>
                </c:pt>
                <c:pt idx="439">
                  <c:v>0.45900000000000002</c:v>
                </c:pt>
                <c:pt idx="440">
                  <c:v>0.46899999999999997</c:v>
                </c:pt>
                <c:pt idx="441">
                  <c:v>0.48</c:v>
                </c:pt>
                <c:pt idx="442">
                  <c:v>0.49199999999999999</c:v>
                </c:pt>
                <c:pt idx="443">
                  <c:v>0.504</c:v>
                </c:pt>
                <c:pt idx="444">
                  <c:v>0.51800000000000002</c:v>
                </c:pt>
                <c:pt idx="445">
                  <c:v>0.53300000000000003</c:v>
                </c:pt>
                <c:pt idx="446">
                  <c:v>0.54900000000000004</c:v>
                </c:pt>
                <c:pt idx="447">
                  <c:v>0.56799999999999995</c:v>
                </c:pt>
                <c:pt idx="448">
                  <c:v>0.58799999999999997</c:v>
                </c:pt>
                <c:pt idx="449">
                  <c:v>0.61099999999999999</c:v>
                </c:pt>
                <c:pt idx="450">
                  <c:v>0.63700000000000001</c:v>
                </c:pt>
                <c:pt idx="451">
                  <c:v>0.66600000000000004</c:v>
                </c:pt>
                <c:pt idx="452">
                  <c:v>0.69699999999999995</c:v>
                </c:pt>
                <c:pt idx="453">
                  <c:v>0.73099999999999998</c:v>
                </c:pt>
                <c:pt idx="454">
                  <c:v>0.76900000000000002</c:v>
                </c:pt>
                <c:pt idx="455">
                  <c:v>0.80900000000000005</c:v>
                </c:pt>
                <c:pt idx="456">
                  <c:v>0.85099999999999998</c:v>
                </c:pt>
                <c:pt idx="457">
                  <c:v>0.89400000000000002</c:v>
                </c:pt>
                <c:pt idx="458">
                  <c:v>0.93799999999999994</c:v>
                </c:pt>
                <c:pt idx="459">
                  <c:v>0.98799999999999999</c:v>
                </c:pt>
                <c:pt idx="460">
                  <c:v>1.0309999999999999</c:v>
                </c:pt>
                <c:pt idx="461">
                  <c:v>1.0649999999999999</c:v>
                </c:pt>
                <c:pt idx="462">
                  <c:v>1.1180000000000001</c:v>
                </c:pt>
                <c:pt idx="463">
                  <c:v>1.1579999999999999</c:v>
                </c:pt>
                <c:pt idx="464">
                  <c:v>1.196</c:v>
                </c:pt>
                <c:pt idx="465">
                  <c:v>1.2310000000000001</c:v>
                </c:pt>
                <c:pt idx="466">
                  <c:v>1.2629999999999999</c:v>
                </c:pt>
                <c:pt idx="467">
                  <c:v>1.294</c:v>
                </c:pt>
                <c:pt idx="468">
                  <c:v>1.3180000000000001</c:v>
                </c:pt>
                <c:pt idx="469">
                  <c:v>1.339</c:v>
                </c:pt>
                <c:pt idx="470">
                  <c:v>1.357</c:v>
                </c:pt>
                <c:pt idx="471">
                  <c:v>1.367</c:v>
                </c:pt>
                <c:pt idx="472">
                  <c:v>1.377</c:v>
                </c:pt>
                <c:pt idx="473">
                  <c:v>1.379</c:v>
                </c:pt>
                <c:pt idx="474">
                  <c:v>1.381</c:v>
                </c:pt>
                <c:pt idx="475">
                  <c:v>1.379</c:v>
                </c:pt>
                <c:pt idx="476">
                  <c:v>1.373</c:v>
                </c:pt>
                <c:pt idx="477">
                  <c:v>1.3640000000000001</c:v>
                </c:pt>
                <c:pt idx="478">
                  <c:v>1.355</c:v>
                </c:pt>
                <c:pt idx="479">
                  <c:v>1.3420000000000001</c:v>
                </c:pt>
                <c:pt idx="480">
                  <c:v>1.327</c:v>
                </c:pt>
                <c:pt idx="481">
                  <c:v>1.31</c:v>
                </c:pt>
                <c:pt idx="482">
                  <c:v>1.2929999999999999</c:v>
                </c:pt>
                <c:pt idx="483">
                  <c:v>1.2729999999999999</c:v>
                </c:pt>
                <c:pt idx="484">
                  <c:v>1.252</c:v>
                </c:pt>
                <c:pt idx="485">
                  <c:v>1.2310000000000001</c:v>
                </c:pt>
                <c:pt idx="486">
                  <c:v>1.2090000000000001</c:v>
                </c:pt>
                <c:pt idx="487">
                  <c:v>1.1850000000000001</c:v>
                </c:pt>
                <c:pt idx="488">
                  <c:v>1.159</c:v>
                </c:pt>
                <c:pt idx="489">
                  <c:v>1.133</c:v>
                </c:pt>
                <c:pt idx="490">
                  <c:v>1.107</c:v>
                </c:pt>
                <c:pt idx="491">
                  <c:v>1.081</c:v>
                </c:pt>
                <c:pt idx="492">
                  <c:v>1.0549999999999999</c:v>
                </c:pt>
                <c:pt idx="493">
                  <c:v>1.028</c:v>
                </c:pt>
                <c:pt idx="494">
                  <c:v>1.004</c:v>
                </c:pt>
                <c:pt idx="495">
                  <c:v>0.97899999999999998</c:v>
                </c:pt>
                <c:pt idx="496">
                  <c:v>0.95599999999999996</c:v>
                </c:pt>
                <c:pt idx="497">
                  <c:v>0.93200000000000005</c:v>
                </c:pt>
                <c:pt idx="498">
                  <c:v>0.91100000000000003</c:v>
                </c:pt>
                <c:pt idx="499">
                  <c:v>0.89100000000000001</c:v>
                </c:pt>
                <c:pt idx="500">
                  <c:v>0.872</c:v>
                </c:pt>
                <c:pt idx="501">
                  <c:v>0.85499999999999998</c:v>
                </c:pt>
                <c:pt idx="502">
                  <c:v>0.84</c:v>
                </c:pt>
                <c:pt idx="503">
                  <c:v>0.82599999999999996</c:v>
                </c:pt>
                <c:pt idx="504">
                  <c:v>0.81299999999999994</c:v>
                </c:pt>
                <c:pt idx="505">
                  <c:v>0.80100000000000005</c:v>
                </c:pt>
                <c:pt idx="506">
                  <c:v>0.79</c:v>
                </c:pt>
                <c:pt idx="507">
                  <c:v>0.78100000000000003</c:v>
                </c:pt>
                <c:pt idx="508">
                  <c:v>0.77100000000000002</c:v>
                </c:pt>
                <c:pt idx="509">
                  <c:v>0.76300000000000001</c:v>
                </c:pt>
                <c:pt idx="510">
                  <c:v>0.755</c:v>
                </c:pt>
                <c:pt idx="511">
                  <c:v>0.748</c:v>
                </c:pt>
                <c:pt idx="512">
                  <c:v>0.74099999999999999</c:v>
                </c:pt>
                <c:pt idx="513">
                  <c:v>0.73399999999999999</c:v>
                </c:pt>
                <c:pt idx="514">
                  <c:v>0.72799999999999998</c:v>
                </c:pt>
                <c:pt idx="515">
                  <c:v>0.72199999999999998</c:v>
                </c:pt>
                <c:pt idx="516">
                  <c:v>0.71699999999999997</c:v>
                </c:pt>
                <c:pt idx="517">
                  <c:v>0.71199999999999997</c:v>
                </c:pt>
                <c:pt idx="518">
                  <c:v>0.70699999999999996</c:v>
                </c:pt>
                <c:pt idx="519">
                  <c:v>0.70299999999999996</c:v>
                </c:pt>
                <c:pt idx="520">
                  <c:v>0.7</c:v>
                </c:pt>
                <c:pt idx="521">
                  <c:v>0.69799999999999995</c:v>
                </c:pt>
                <c:pt idx="522">
                  <c:v>0.69599999999999995</c:v>
                </c:pt>
                <c:pt idx="523">
                  <c:v>0.69499999999999995</c:v>
                </c:pt>
                <c:pt idx="524">
                  <c:v>0.69599999999999995</c:v>
                </c:pt>
                <c:pt idx="525">
                  <c:v>0.69799999999999995</c:v>
                </c:pt>
                <c:pt idx="526">
                  <c:v>0.70099999999999996</c:v>
                </c:pt>
                <c:pt idx="527">
                  <c:v>0.70599999999999996</c:v>
                </c:pt>
                <c:pt idx="528">
                  <c:v>0.71199999999999997</c:v>
                </c:pt>
                <c:pt idx="529">
                  <c:v>0.72099999999999997</c:v>
                </c:pt>
                <c:pt idx="530">
                  <c:v>0.73099999999999998</c:v>
                </c:pt>
                <c:pt idx="531">
                  <c:v>0.74399999999999999</c:v>
                </c:pt>
                <c:pt idx="532">
                  <c:v>0.75900000000000001</c:v>
                </c:pt>
                <c:pt idx="533">
                  <c:v>0.77500000000000002</c:v>
                </c:pt>
                <c:pt idx="534">
                  <c:v>0.79400000000000004</c:v>
                </c:pt>
                <c:pt idx="535">
                  <c:v>0.81399999999999995</c:v>
                </c:pt>
                <c:pt idx="536">
                  <c:v>0.83599999999999997</c:v>
                </c:pt>
                <c:pt idx="537">
                  <c:v>0.86</c:v>
                </c:pt>
                <c:pt idx="538">
                  <c:v>0.88500000000000001</c:v>
                </c:pt>
                <c:pt idx="539">
                  <c:v>0.91200000000000003</c:v>
                </c:pt>
                <c:pt idx="540">
                  <c:v>0.93899999999999995</c:v>
                </c:pt>
                <c:pt idx="541">
                  <c:v>0.96499999999999997</c:v>
                </c:pt>
                <c:pt idx="542">
                  <c:v>0.99299999999999999</c:v>
                </c:pt>
                <c:pt idx="543">
                  <c:v>1.02</c:v>
                </c:pt>
                <c:pt idx="544">
                  <c:v>1.0469999999999999</c:v>
                </c:pt>
                <c:pt idx="545">
                  <c:v>1.0740000000000001</c:v>
                </c:pt>
                <c:pt idx="546">
                  <c:v>1.101</c:v>
                </c:pt>
                <c:pt idx="547">
                  <c:v>1.1279999999999999</c:v>
                </c:pt>
                <c:pt idx="548">
                  <c:v>1.1539999999999999</c:v>
                </c:pt>
                <c:pt idx="549">
                  <c:v>1.181</c:v>
                </c:pt>
                <c:pt idx="550">
                  <c:v>1.2070000000000001</c:v>
                </c:pt>
                <c:pt idx="551">
                  <c:v>1.234</c:v>
                </c:pt>
                <c:pt idx="552">
                  <c:v>1.26</c:v>
                </c:pt>
                <c:pt idx="553">
                  <c:v>1.286</c:v>
                </c:pt>
                <c:pt idx="554">
                  <c:v>1.3109999999999999</c:v>
                </c:pt>
                <c:pt idx="555">
                  <c:v>1.337</c:v>
                </c:pt>
                <c:pt idx="556">
                  <c:v>1.361</c:v>
                </c:pt>
                <c:pt idx="557">
                  <c:v>1.385</c:v>
                </c:pt>
                <c:pt idx="558">
                  <c:v>1.407</c:v>
                </c:pt>
                <c:pt idx="559">
                  <c:v>1.431</c:v>
                </c:pt>
                <c:pt idx="560">
                  <c:v>1.4510000000000001</c:v>
                </c:pt>
                <c:pt idx="561">
                  <c:v>1.4690000000000001</c:v>
                </c:pt>
                <c:pt idx="562">
                  <c:v>1.486</c:v>
                </c:pt>
                <c:pt idx="563">
                  <c:v>1.5009999999999999</c:v>
                </c:pt>
                <c:pt idx="564">
                  <c:v>1.516</c:v>
                </c:pt>
                <c:pt idx="565">
                  <c:v>1.5289999999999999</c:v>
                </c:pt>
                <c:pt idx="566">
                  <c:v>1.5409999999999999</c:v>
                </c:pt>
                <c:pt idx="567">
                  <c:v>1.5529999999999999</c:v>
                </c:pt>
                <c:pt idx="568">
                  <c:v>1.5649999999999999</c:v>
                </c:pt>
                <c:pt idx="569">
                  <c:v>1.5760000000000001</c:v>
                </c:pt>
                <c:pt idx="570">
                  <c:v>1.5880000000000001</c:v>
                </c:pt>
                <c:pt idx="571">
                  <c:v>1.601</c:v>
                </c:pt>
                <c:pt idx="572">
                  <c:v>1.6140000000000001</c:v>
                </c:pt>
                <c:pt idx="573">
                  <c:v>1.63</c:v>
                </c:pt>
                <c:pt idx="574">
                  <c:v>1.647</c:v>
                </c:pt>
                <c:pt idx="575">
                  <c:v>1.667</c:v>
                </c:pt>
                <c:pt idx="576">
                  <c:v>1.6910000000000001</c:v>
                </c:pt>
                <c:pt idx="577">
                  <c:v>1.716</c:v>
                </c:pt>
                <c:pt idx="578">
                  <c:v>1.744</c:v>
                </c:pt>
                <c:pt idx="579">
                  <c:v>1.774</c:v>
                </c:pt>
                <c:pt idx="580">
                  <c:v>1.806</c:v>
                </c:pt>
                <c:pt idx="581">
                  <c:v>1.839</c:v>
                </c:pt>
                <c:pt idx="582">
                  <c:v>1.8759999999999999</c:v>
                </c:pt>
                <c:pt idx="583">
                  <c:v>1.9119999999999999</c:v>
                </c:pt>
                <c:pt idx="584">
                  <c:v>1.9530000000000001</c:v>
                </c:pt>
                <c:pt idx="585">
                  <c:v>1.9970000000000001</c:v>
                </c:pt>
                <c:pt idx="586">
                  <c:v>2.0430000000000001</c:v>
                </c:pt>
                <c:pt idx="587">
                  <c:v>2.097</c:v>
                </c:pt>
                <c:pt idx="588">
                  <c:v>2.1520000000000001</c:v>
                </c:pt>
                <c:pt idx="589">
                  <c:v>2.2130000000000001</c:v>
                </c:pt>
                <c:pt idx="590">
                  <c:v>2.2690000000000001</c:v>
                </c:pt>
                <c:pt idx="591">
                  <c:v>2.3220000000000001</c:v>
                </c:pt>
                <c:pt idx="592">
                  <c:v>2.3679999999999999</c:v>
                </c:pt>
                <c:pt idx="593">
                  <c:v>2.4089999999999998</c:v>
                </c:pt>
                <c:pt idx="594">
                  <c:v>2.444</c:v>
                </c:pt>
                <c:pt idx="595">
                  <c:v>2.4740000000000002</c:v>
                </c:pt>
                <c:pt idx="596">
                  <c:v>2.504</c:v>
                </c:pt>
                <c:pt idx="597">
                  <c:v>2.516</c:v>
                </c:pt>
                <c:pt idx="598">
                  <c:v>2.5289999999999999</c:v>
                </c:pt>
                <c:pt idx="599">
                  <c:v>2.5449999999999999</c:v>
                </c:pt>
                <c:pt idx="600">
                  <c:v>2.544</c:v>
                </c:pt>
                <c:pt idx="601">
                  <c:v>2.552</c:v>
                </c:pt>
                <c:pt idx="602">
                  <c:v>2.5569999999999999</c:v>
                </c:pt>
                <c:pt idx="603">
                  <c:v>2.5459999999999998</c:v>
                </c:pt>
                <c:pt idx="604">
                  <c:v>2.5409999999999999</c:v>
                </c:pt>
                <c:pt idx="605">
                  <c:v>2.5390000000000001</c:v>
                </c:pt>
                <c:pt idx="606">
                  <c:v>2.5390000000000001</c:v>
                </c:pt>
                <c:pt idx="607">
                  <c:v>2.5219999999999998</c:v>
                </c:pt>
                <c:pt idx="608">
                  <c:v>2.5169999999999999</c:v>
                </c:pt>
                <c:pt idx="609">
                  <c:v>2.5150000000000001</c:v>
                </c:pt>
                <c:pt idx="610">
                  <c:v>2.47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4CE-44B8-B45D-53E8FBE04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41536"/>
        <c:axId val="646746240"/>
      </c:scatterChart>
      <c:valAx>
        <c:axId val="646741536"/>
        <c:scaling>
          <c:orientation val="minMax"/>
          <c:max val="800"/>
          <c:min val="4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46746240"/>
        <c:crosses val="autoZero"/>
        <c:crossBetween val="midCat"/>
      </c:valAx>
      <c:valAx>
        <c:axId val="646746240"/>
        <c:scaling>
          <c:orientation val="minMax"/>
          <c:max val="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46741536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46084864391951"/>
          <c:y val="4.7154782735491389E-2"/>
          <c:w val="0.81319203849518806"/>
          <c:h val="0.7849901574803149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 mM</c:v>
                </c:pt>
              </c:strCache>
            </c:strRef>
          </c:tx>
          <c:marker>
            <c:symbol val="none"/>
          </c:marker>
          <c:xVal>
            <c:numRef>
              <c:f>Sheet1!$A$2:$A$612</c:f>
              <c:numCache>
                <c:formatCode>General</c:formatCode>
                <c:ptCount val="61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  <c:pt idx="601">
                  <c:v>199</c:v>
                </c:pt>
                <c:pt idx="602">
                  <c:v>198</c:v>
                </c:pt>
                <c:pt idx="603">
                  <c:v>197</c:v>
                </c:pt>
                <c:pt idx="604">
                  <c:v>196</c:v>
                </c:pt>
                <c:pt idx="605">
                  <c:v>195</c:v>
                </c:pt>
                <c:pt idx="606">
                  <c:v>194</c:v>
                </c:pt>
                <c:pt idx="607">
                  <c:v>193</c:v>
                </c:pt>
                <c:pt idx="608">
                  <c:v>192</c:v>
                </c:pt>
                <c:pt idx="609">
                  <c:v>191</c:v>
                </c:pt>
                <c:pt idx="610">
                  <c:v>190</c:v>
                </c:pt>
              </c:numCache>
            </c:numRef>
          </c:xVal>
          <c:yVal>
            <c:numRef>
              <c:f>Sheet1!$B$2:$B$612</c:f>
              <c:numCache>
                <c:formatCode>General</c:formatCode>
                <c:ptCount val="611"/>
                <c:pt idx="0">
                  <c:v>2E-3</c:v>
                </c:pt>
                <c:pt idx="1">
                  <c:v>2E-3</c:v>
                </c:pt>
                <c:pt idx="2">
                  <c:v>2E-3</c:v>
                </c:pt>
                <c:pt idx="3">
                  <c:v>2E-3</c:v>
                </c:pt>
                <c:pt idx="4">
                  <c:v>2E-3</c:v>
                </c:pt>
                <c:pt idx="5">
                  <c:v>2E-3</c:v>
                </c:pt>
                <c:pt idx="6">
                  <c:v>2E-3</c:v>
                </c:pt>
                <c:pt idx="7">
                  <c:v>2E-3</c:v>
                </c:pt>
                <c:pt idx="8">
                  <c:v>2E-3</c:v>
                </c:pt>
                <c:pt idx="9">
                  <c:v>2E-3</c:v>
                </c:pt>
                <c:pt idx="10">
                  <c:v>2E-3</c:v>
                </c:pt>
                <c:pt idx="11">
                  <c:v>2E-3</c:v>
                </c:pt>
                <c:pt idx="12">
                  <c:v>2E-3</c:v>
                </c:pt>
                <c:pt idx="13">
                  <c:v>2E-3</c:v>
                </c:pt>
                <c:pt idx="14">
                  <c:v>2E-3</c:v>
                </c:pt>
                <c:pt idx="15">
                  <c:v>2E-3</c:v>
                </c:pt>
                <c:pt idx="16">
                  <c:v>2E-3</c:v>
                </c:pt>
                <c:pt idx="17">
                  <c:v>2E-3</c:v>
                </c:pt>
                <c:pt idx="18">
                  <c:v>2E-3</c:v>
                </c:pt>
                <c:pt idx="19">
                  <c:v>2E-3</c:v>
                </c:pt>
                <c:pt idx="20">
                  <c:v>3.0000000000000001E-3</c:v>
                </c:pt>
                <c:pt idx="21">
                  <c:v>3.0000000000000001E-3</c:v>
                </c:pt>
                <c:pt idx="22">
                  <c:v>3.0000000000000001E-3</c:v>
                </c:pt>
                <c:pt idx="23">
                  <c:v>3.0000000000000001E-3</c:v>
                </c:pt>
                <c:pt idx="24">
                  <c:v>3.0000000000000001E-3</c:v>
                </c:pt>
                <c:pt idx="25">
                  <c:v>3.0000000000000001E-3</c:v>
                </c:pt>
                <c:pt idx="26">
                  <c:v>3.0000000000000001E-3</c:v>
                </c:pt>
                <c:pt idx="27">
                  <c:v>3.0000000000000001E-3</c:v>
                </c:pt>
                <c:pt idx="28">
                  <c:v>3.0000000000000001E-3</c:v>
                </c:pt>
                <c:pt idx="29">
                  <c:v>3.0000000000000001E-3</c:v>
                </c:pt>
                <c:pt idx="30">
                  <c:v>3.0000000000000001E-3</c:v>
                </c:pt>
                <c:pt idx="31">
                  <c:v>4.0000000000000001E-3</c:v>
                </c:pt>
                <c:pt idx="32">
                  <c:v>4.0000000000000001E-3</c:v>
                </c:pt>
                <c:pt idx="33">
                  <c:v>4.0000000000000001E-3</c:v>
                </c:pt>
                <c:pt idx="34">
                  <c:v>4.0000000000000001E-3</c:v>
                </c:pt>
                <c:pt idx="35">
                  <c:v>4.0000000000000001E-3</c:v>
                </c:pt>
                <c:pt idx="36">
                  <c:v>4.0000000000000001E-3</c:v>
                </c:pt>
                <c:pt idx="37">
                  <c:v>4.0000000000000001E-3</c:v>
                </c:pt>
                <c:pt idx="38">
                  <c:v>5.0000000000000001E-3</c:v>
                </c:pt>
                <c:pt idx="39">
                  <c:v>5.0000000000000001E-3</c:v>
                </c:pt>
                <c:pt idx="40">
                  <c:v>5.0000000000000001E-3</c:v>
                </c:pt>
                <c:pt idx="41">
                  <c:v>5.0000000000000001E-3</c:v>
                </c:pt>
                <c:pt idx="42">
                  <c:v>6.0000000000000001E-3</c:v>
                </c:pt>
                <c:pt idx="43">
                  <c:v>6.0000000000000001E-3</c:v>
                </c:pt>
                <c:pt idx="44">
                  <c:v>6.0000000000000001E-3</c:v>
                </c:pt>
                <c:pt idx="45">
                  <c:v>6.0000000000000001E-3</c:v>
                </c:pt>
                <c:pt idx="46">
                  <c:v>6.0000000000000001E-3</c:v>
                </c:pt>
                <c:pt idx="47">
                  <c:v>7.0000000000000001E-3</c:v>
                </c:pt>
                <c:pt idx="48">
                  <c:v>7.0000000000000001E-3</c:v>
                </c:pt>
                <c:pt idx="49">
                  <c:v>7.0000000000000001E-3</c:v>
                </c:pt>
                <c:pt idx="50">
                  <c:v>8.0000000000000002E-3</c:v>
                </c:pt>
                <c:pt idx="51">
                  <c:v>8.0000000000000002E-3</c:v>
                </c:pt>
                <c:pt idx="52">
                  <c:v>8.0000000000000002E-3</c:v>
                </c:pt>
                <c:pt idx="53">
                  <c:v>8.9999999999999993E-3</c:v>
                </c:pt>
                <c:pt idx="54">
                  <c:v>8.9999999999999993E-3</c:v>
                </c:pt>
                <c:pt idx="55">
                  <c:v>8.9999999999999993E-3</c:v>
                </c:pt>
                <c:pt idx="56">
                  <c:v>0.01</c:v>
                </c:pt>
                <c:pt idx="57">
                  <c:v>0.01</c:v>
                </c:pt>
                <c:pt idx="58">
                  <c:v>1.0999999999999999E-2</c:v>
                </c:pt>
                <c:pt idx="59">
                  <c:v>1.0999999999999999E-2</c:v>
                </c:pt>
                <c:pt idx="60">
                  <c:v>1.0999999999999999E-2</c:v>
                </c:pt>
                <c:pt idx="61">
                  <c:v>1.2E-2</c:v>
                </c:pt>
                <c:pt idx="62">
                  <c:v>1.2999999999999999E-2</c:v>
                </c:pt>
                <c:pt idx="63">
                  <c:v>1.2999999999999999E-2</c:v>
                </c:pt>
                <c:pt idx="64">
                  <c:v>1.2999999999999999E-2</c:v>
                </c:pt>
                <c:pt idx="65">
                  <c:v>1.4E-2</c:v>
                </c:pt>
                <c:pt idx="66">
                  <c:v>1.4999999999999999E-2</c:v>
                </c:pt>
                <c:pt idx="67">
                  <c:v>1.4999999999999999E-2</c:v>
                </c:pt>
                <c:pt idx="68">
                  <c:v>1.6E-2</c:v>
                </c:pt>
                <c:pt idx="69">
                  <c:v>1.6E-2</c:v>
                </c:pt>
                <c:pt idx="70">
                  <c:v>1.7000000000000001E-2</c:v>
                </c:pt>
                <c:pt idx="71">
                  <c:v>1.7000000000000001E-2</c:v>
                </c:pt>
                <c:pt idx="72">
                  <c:v>1.7999999999999999E-2</c:v>
                </c:pt>
                <c:pt idx="73">
                  <c:v>1.9E-2</c:v>
                </c:pt>
                <c:pt idx="74">
                  <c:v>1.9E-2</c:v>
                </c:pt>
                <c:pt idx="75">
                  <c:v>0.02</c:v>
                </c:pt>
                <c:pt idx="76">
                  <c:v>2.1000000000000001E-2</c:v>
                </c:pt>
                <c:pt idx="77">
                  <c:v>2.1000000000000001E-2</c:v>
                </c:pt>
                <c:pt idx="78">
                  <c:v>2.1999999999999999E-2</c:v>
                </c:pt>
                <c:pt idx="79">
                  <c:v>2.3E-2</c:v>
                </c:pt>
                <c:pt idx="80">
                  <c:v>2.3E-2</c:v>
                </c:pt>
                <c:pt idx="81">
                  <c:v>2.4E-2</c:v>
                </c:pt>
                <c:pt idx="82">
                  <c:v>2.5000000000000001E-2</c:v>
                </c:pt>
                <c:pt idx="83">
                  <c:v>2.5999999999999999E-2</c:v>
                </c:pt>
                <c:pt idx="84">
                  <c:v>2.5999999999999999E-2</c:v>
                </c:pt>
                <c:pt idx="85">
                  <c:v>2.7E-2</c:v>
                </c:pt>
                <c:pt idx="86">
                  <c:v>2.8000000000000001E-2</c:v>
                </c:pt>
                <c:pt idx="87">
                  <c:v>2.9000000000000001E-2</c:v>
                </c:pt>
                <c:pt idx="88">
                  <c:v>0.03</c:v>
                </c:pt>
                <c:pt idx="89">
                  <c:v>3.1E-2</c:v>
                </c:pt>
                <c:pt idx="90">
                  <c:v>3.2000000000000001E-2</c:v>
                </c:pt>
                <c:pt idx="91">
                  <c:v>3.3000000000000002E-2</c:v>
                </c:pt>
                <c:pt idx="92">
                  <c:v>3.4000000000000002E-2</c:v>
                </c:pt>
                <c:pt idx="93">
                  <c:v>3.5000000000000003E-2</c:v>
                </c:pt>
                <c:pt idx="94">
                  <c:v>3.5999999999999997E-2</c:v>
                </c:pt>
                <c:pt idx="95">
                  <c:v>3.6999999999999998E-2</c:v>
                </c:pt>
                <c:pt idx="96">
                  <c:v>3.7999999999999999E-2</c:v>
                </c:pt>
                <c:pt idx="97">
                  <c:v>0.04</c:v>
                </c:pt>
                <c:pt idx="98">
                  <c:v>4.1000000000000002E-2</c:v>
                </c:pt>
                <c:pt idx="99">
                  <c:v>4.2000000000000003E-2</c:v>
                </c:pt>
                <c:pt idx="100">
                  <c:v>4.2999999999999997E-2</c:v>
                </c:pt>
                <c:pt idx="101">
                  <c:v>4.4999999999999998E-2</c:v>
                </c:pt>
                <c:pt idx="102">
                  <c:v>4.5999999999999999E-2</c:v>
                </c:pt>
                <c:pt idx="103">
                  <c:v>4.7E-2</c:v>
                </c:pt>
                <c:pt idx="104">
                  <c:v>4.9000000000000002E-2</c:v>
                </c:pt>
                <c:pt idx="105">
                  <c:v>0.05</c:v>
                </c:pt>
                <c:pt idx="106">
                  <c:v>5.1999999999999998E-2</c:v>
                </c:pt>
                <c:pt idx="107">
                  <c:v>5.2999999999999999E-2</c:v>
                </c:pt>
                <c:pt idx="108">
                  <c:v>5.5E-2</c:v>
                </c:pt>
                <c:pt idx="109">
                  <c:v>5.7000000000000002E-2</c:v>
                </c:pt>
                <c:pt idx="110">
                  <c:v>5.8000000000000003E-2</c:v>
                </c:pt>
                <c:pt idx="111">
                  <c:v>0.06</c:v>
                </c:pt>
                <c:pt idx="112">
                  <c:v>6.2E-2</c:v>
                </c:pt>
                <c:pt idx="113">
                  <c:v>6.4000000000000001E-2</c:v>
                </c:pt>
                <c:pt idx="114">
                  <c:v>6.5000000000000002E-2</c:v>
                </c:pt>
                <c:pt idx="115">
                  <c:v>6.7000000000000004E-2</c:v>
                </c:pt>
                <c:pt idx="116">
                  <c:v>6.9000000000000006E-2</c:v>
                </c:pt>
                <c:pt idx="117">
                  <c:v>7.0999999999999994E-2</c:v>
                </c:pt>
                <c:pt idx="118">
                  <c:v>7.2999999999999995E-2</c:v>
                </c:pt>
                <c:pt idx="119">
                  <c:v>7.4999999999999997E-2</c:v>
                </c:pt>
                <c:pt idx="120">
                  <c:v>7.6999999999999999E-2</c:v>
                </c:pt>
                <c:pt idx="121">
                  <c:v>7.8E-2</c:v>
                </c:pt>
                <c:pt idx="122">
                  <c:v>0.08</c:v>
                </c:pt>
                <c:pt idx="123">
                  <c:v>8.2000000000000003E-2</c:v>
                </c:pt>
                <c:pt idx="124">
                  <c:v>8.4000000000000005E-2</c:v>
                </c:pt>
                <c:pt idx="125">
                  <c:v>8.5999999999999993E-2</c:v>
                </c:pt>
                <c:pt idx="126">
                  <c:v>8.7999999999999995E-2</c:v>
                </c:pt>
                <c:pt idx="127">
                  <c:v>8.8999999999999996E-2</c:v>
                </c:pt>
                <c:pt idx="128">
                  <c:v>9.0999999999999998E-2</c:v>
                </c:pt>
                <c:pt idx="129">
                  <c:v>9.2999999999999999E-2</c:v>
                </c:pt>
                <c:pt idx="130">
                  <c:v>9.5000000000000001E-2</c:v>
                </c:pt>
                <c:pt idx="131">
                  <c:v>9.7000000000000003E-2</c:v>
                </c:pt>
                <c:pt idx="132">
                  <c:v>9.9000000000000005E-2</c:v>
                </c:pt>
                <c:pt idx="133">
                  <c:v>0.10100000000000001</c:v>
                </c:pt>
                <c:pt idx="134">
                  <c:v>0.10299999999999999</c:v>
                </c:pt>
                <c:pt idx="135">
                  <c:v>0.105</c:v>
                </c:pt>
                <c:pt idx="136">
                  <c:v>0.107</c:v>
                </c:pt>
                <c:pt idx="137">
                  <c:v>0.109</c:v>
                </c:pt>
                <c:pt idx="138">
                  <c:v>0.111</c:v>
                </c:pt>
                <c:pt idx="139">
                  <c:v>0.114</c:v>
                </c:pt>
                <c:pt idx="140">
                  <c:v>0.11600000000000001</c:v>
                </c:pt>
                <c:pt idx="141">
                  <c:v>0.11799999999999999</c:v>
                </c:pt>
                <c:pt idx="142">
                  <c:v>0.12</c:v>
                </c:pt>
                <c:pt idx="143">
                  <c:v>0.122</c:v>
                </c:pt>
                <c:pt idx="144">
                  <c:v>0.124</c:v>
                </c:pt>
                <c:pt idx="145">
                  <c:v>0.126</c:v>
                </c:pt>
                <c:pt idx="146">
                  <c:v>0.128</c:v>
                </c:pt>
                <c:pt idx="147">
                  <c:v>0.13</c:v>
                </c:pt>
                <c:pt idx="148">
                  <c:v>0.13200000000000001</c:v>
                </c:pt>
                <c:pt idx="149">
                  <c:v>0.13400000000000001</c:v>
                </c:pt>
                <c:pt idx="150">
                  <c:v>0.13600000000000001</c:v>
                </c:pt>
                <c:pt idx="151">
                  <c:v>0.13800000000000001</c:v>
                </c:pt>
                <c:pt idx="152">
                  <c:v>0.14000000000000001</c:v>
                </c:pt>
                <c:pt idx="153">
                  <c:v>0.14199999999999999</c:v>
                </c:pt>
                <c:pt idx="154">
                  <c:v>0.14399999999999999</c:v>
                </c:pt>
                <c:pt idx="155">
                  <c:v>0.14599999999999999</c:v>
                </c:pt>
                <c:pt idx="156">
                  <c:v>0.14799999999999999</c:v>
                </c:pt>
                <c:pt idx="157">
                  <c:v>0.14899999999999999</c:v>
                </c:pt>
                <c:pt idx="158">
                  <c:v>0.151</c:v>
                </c:pt>
                <c:pt idx="159">
                  <c:v>0.153</c:v>
                </c:pt>
                <c:pt idx="160">
                  <c:v>0.155</c:v>
                </c:pt>
                <c:pt idx="161">
                  <c:v>0.156</c:v>
                </c:pt>
                <c:pt idx="162">
                  <c:v>0.158</c:v>
                </c:pt>
                <c:pt idx="163">
                  <c:v>0.159</c:v>
                </c:pt>
                <c:pt idx="164">
                  <c:v>0.161</c:v>
                </c:pt>
                <c:pt idx="165">
                  <c:v>0.16300000000000001</c:v>
                </c:pt>
                <c:pt idx="166">
                  <c:v>0.16400000000000001</c:v>
                </c:pt>
                <c:pt idx="167">
                  <c:v>0.16600000000000001</c:v>
                </c:pt>
                <c:pt idx="168">
                  <c:v>0.16700000000000001</c:v>
                </c:pt>
                <c:pt idx="169">
                  <c:v>0.16800000000000001</c:v>
                </c:pt>
                <c:pt idx="170">
                  <c:v>0.17</c:v>
                </c:pt>
                <c:pt idx="171">
                  <c:v>0.17100000000000001</c:v>
                </c:pt>
                <c:pt idx="172">
                  <c:v>0.17299999999999999</c:v>
                </c:pt>
                <c:pt idx="173">
                  <c:v>0.17399999999999999</c:v>
                </c:pt>
                <c:pt idx="174">
                  <c:v>0.17499999999999999</c:v>
                </c:pt>
                <c:pt idx="175">
                  <c:v>0.17699999999999999</c:v>
                </c:pt>
                <c:pt idx="176">
                  <c:v>0.17799999999999999</c:v>
                </c:pt>
                <c:pt idx="177">
                  <c:v>0.17899999999999999</c:v>
                </c:pt>
                <c:pt idx="178">
                  <c:v>0.18099999999999999</c:v>
                </c:pt>
                <c:pt idx="179">
                  <c:v>0.182</c:v>
                </c:pt>
                <c:pt idx="180">
                  <c:v>0.184</c:v>
                </c:pt>
                <c:pt idx="181">
                  <c:v>0.185</c:v>
                </c:pt>
                <c:pt idx="182">
                  <c:v>0.187</c:v>
                </c:pt>
                <c:pt idx="183">
                  <c:v>0.188</c:v>
                </c:pt>
                <c:pt idx="184">
                  <c:v>0.19</c:v>
                </c:pt>
                <c:pt idx="185">
                  <c:v>0.192</c:v>
                </c:pt>
                <c:pt idx="186">
                  <c:v>0.19400000000000001</c:v>
                </c:pt>
                <c:pt idx="187">
                  <c:v>0.19600000000000001</c:v>
                </c:pt>
                <c:pt idx="188">
                  <c:v>0.19800000000000001</c:v>
                </c:pt>
                <c:pt idx="189">
                  <c:v>0.2</c:v>
                </c:pt>
                <c:pt idx="190">
                  <c:v>0.20300000000000001</c:v>
                </c:pt>
                <c:pt idx="191">
                  <c:v>0.20499999999999999</c:v>
                </c:pt>
                <c:pt idx="192">
                  <c:v>0.20799999999999999</c:v>
                </c:pt>
                <c:pt idx="193">
                  <c:v>0.21099999999999999</c:v>
                </c:pt>
                <c:pt idx="194">
                  <c:v>0.214</c:v>
                </c:pt>
                <c:pt idx="195">
                  <c:v>0.218</c:v>
                </c:pt>
                <c:pt idx="196">
                  <c:v>0.221</c:v>
                </c:pt>
                <c:pt idx="197">
                  <c:v>0.22500000000000001</c:v>
                </c:pt>
                <c:pt idx="198">
                  <c:v>0.22800000000000001</c:v>
                </c:pt>
                <c:pt idx="199">
                  <c:v>0.23200000000000001</c:v>
                </c:pt>
                <c:pt idx="200">
                  <c:v>0.23499999999999999</c:v>
                </c:pt>
                <c:pt idx="201">
                  <c:v>0.23899999999999999</c:v>
                </c:pt>
                <c:pt idx="202">
                  <c:v>0.24299999999999999</c:v>
                </c:pt>
                <c:pt idx="203">
                  <c:v>0.248</c:v>
                </c:pt>
                <c:pt idx="204">
                  <c:v>0.252</c:v>
                </c:pt>
                <c:pt idx="205">
                  <c:v>0.25800000000000001</c:v>
                </c:pt>
                <c:pt idx="206">
                  <c:v>0.26400000000000001</c:v>
                </c:pt>
                <c:pt idx="207">
                  <c:v>0.27100000000000002</c:v>
                </c:pt>
                <c:pt idx="208">
                  <c:v>0.27900000000000003</c:v>
                </c:pt>
                <c:pt idx="209">
                  <c:v>0.28899999999999998</c:v>
                </c:pt>
                <c:pt idx="210">
                  <c:v>0.30199999999999999</c:v>
                </c:pt>
                <c:pt idx="211">
                  <c:v>0.316</c:v>
                </c:pt>
                <c:pt idx="212">
                  <c:v>0.33400000000000002</c:v>
                </c:pt>
                <c:pt idx="213">
                  <c:v>0.35499999999999998</c:v>
                </c:pt>
                <c:pt idx="214">
                  <c:v>0.38</c:v>
                </c:pt>
                <c:pt idx="215">
                  <c:v>0.41</c:v>
                </c:pt>
                <c:pt idx="216">
                  <c:v>0.44400000000000001</c:v>
                </c:pt>
                <c:pt idx="217">
                  <c:v>0.48499999999999999</c:v>
                </c:pt>
                <c:pt idx="218">
                  <c:v>0.53200000000000003</c:v>
                </c:pt>
                <c:pt idx="219">
                  <c:v>0.58399999999999996</c:v>
                </c:pt>
                <c:pt idx="220">
                  <c:v>0.64100000000000001</c:v>
                </c:pt>
                <c:pt idx="221">
                  <c:v>0.70799999999999996</c:v>
                </c:pt>
                <c:pt idx="222">
                  <c:v>0.77400000000000002</c:v>
                </c:pt>
                <c:pt idx="223">
                  <c:v>0.84299999999999997</c:v>
                </c:pt>
                <c:pt idx="224">
                  <c:v>0.91100000000000003</c:v>
                </c:pt>
                <c:pt idx="225">
                  <c:v>0.97799999999999998</c:v>
                </c:pt>
                <c:pt idx="226">
                  <c:v>1.042</c:v>
                </c:pt>
                <c:pt idx="227">
                  <c:v>1.1000000000000001</c:v>
                </c:pt>
                <c:pt idx="228">
                  <c:v>1.1519999999999999</c:v>
                </c:pt>
                <c:pt idx="229">
                  <c:v>1.196</c:v>
                </c:pt>
                <c:pt idx="230">
                  <c:v>1.232</c:v>
                </c:pt>
                <c:pt idx="231">
                  <c:v>1.2569999999999999</c:v>
                </c:pt>
                <c:pt idx="232">
                  <c:v>1.2729999999999999</c:v>
                </c:pt>
                <c:pt idx="233">
                  <c:v>1.2829999999999999</c:v>
                </c:pt>
                <c:pt idx="234">
                  <c:v>1.2869999999999999</c:v>
                </c:pt>
                <c:pt idx="235">
                  <c:v>1.2869999999999999</c:v>
                </c:pt>
                <c:pt idx="236">
                  <c:v>1.286</c:v>
                </c:pt>
                <c:pt idx="237">
                  <c:v>1.286</c:v>
                </c:pt>
                <c:pt idx="238">
                  <c:v>1.288</c:v>
                </c:pt>
                <c:pt idx="239">
                  <c:v>1.2949999999999999</c:v>
                </c:pt>
                <c:pt idx="240">
                  <c:v>1.3089999999999999</c:v>
                </c:pt>
                <c:pt idx="241">
                  <c:v>1.33</c:v>
                </c:pt>
                <c:pt idx="242">
                  <c:v>1.361</c:v>
                </c:pt>
                <c:pt idx="243">
                  <c:v>1.4</c:v>
                </c:pt>
                <c:pt idx="244">
                  <c:v>1.448</c:v>
                </c:pt>
                <c:pt idx="245">
                  <c:v>1.502</c:v>
                </c:pt>
                <c:pt idx="246">
                  <c:v>1.5620000000000001</c:v>
                </c:pt>
                <c:pt idx="247">
                  <c:v>1.6279999999999999</c:v>
                </c:pt>
                <c:pt idx="248">
                  <c:v>1.6879999999999999</c:v>
                </c:pt>
                <c:pt idx="249">
                  <c:v>1.742</c:v>
                </c:pt>
                <c:pt idx="250">
                  <c:v>1.788</c:v>
                </c:pt>
                <c:pt idx="251">
                  <c:v>1.8240000000000001</c:v>
                </c:pt>
                <c:pt idx="252">
                  <c:v>1.85</c:v>
                </c:pt>
                <c:pt idx="253">
                  <c:v>1.8680000000000001</c:v>
                </c:pt>
                <c:pt idx="254">
                  <c:v>1.877</c:v>
                </c:pt>
                <c:pt idx="255">
                  <c:v>1.879</c:v>
                </c:pt>
                <c:pt idx="256">
                  <c:v>1.8759999999999999</c:v>
                </c:pt>
                <c:pt idx="257">
                  <c:v>1.8680000000000001</c:v>
                </c:pt>
                <c:pt idx="258">
                  <c:v>1.8540000000000001</c:v>
                </c:pt>
                <c:pt idx="259">
                  <c:v>1.8380000000000001</c:v>
                </c:pt>
                <c:pt idx="260">
                  <c:v>1.819</c:v>
                </c:pt>
                <c:pt idx="261">
                  <c:v>1.8</c:v>
                </c:pt>
                <c:pt idx="262">
                  <c:v>1.782</c:v>
                </c:pt>
                <c:pt idx="263">
                  <c:v>1.768</c:v>
                </c:pt>
                <c:pt idx="264">
                  <c:v>1.758</c:v>
                </c:pt>
                <c:pt idx="265">
                  <c:v>1.756</c:v>
                </c:pt>
                <c:pt idx="266">
                  <c:v>1.76</c:v>
                </c:pt>
                <c:pt idx="267">
                  <c:v>1.772</c:v>
                </c:pt>
                <c:pt idx="268">
                  <c:v>1.79</c:v>
                </c:pt>
                <c:pt idx="269">
                  <c:v>1.8109999999999999</c:v>
                </c:pt>
                <c:pt idx="270">
                  <c:v>1.835</c:v>
                </c:pt>
                <c:pt idx="271">
                  <c:v>1.8560000000000001</c:v>
                </c:pt>
                <c:pt idx="272">
                  <c:v>1.8740000000000001</c:v>
                </c:pt>
                <c:pt idx="273">
                  <c:v>1.8879999999999999</c:v>
                </c:pt>
                <c:pt idx="274">
                  <c:v>1.897</c:v>
                </c:pt>
                <c:pt idx="275">
                  <c:v>1.8979999999999999</c:v>
                </c:pt>
                <c:pt idx="276">
                  <c:v>1.895</c:v>
                </c:pt>
                <c:pt idx="277">
                  <c:v>1.8859999999999999</c:v>
                </c:pt>
                <c:pt idx="278">
                  <c:v>1.87</c:v>
                </c:pt>
                <c:pt idx="279">
                  <c:v>1.849</c:v>
                </c:pt>
                <c:pt idx="280">
                  <c:v>1.823</c:v>
                </c:pt>
                <c:pt idx="281">
                  <c:v>1.7929999999999999</c:v>
                </c:pt>
                <c:pt idx="282">
                  <c:v>1.76</c:v>
                </c:pt>
                <c:pt idx="283">
                  <c:v>1.726</c:v>
                </c:pt>
                <c:pt idx="284">
                  <c:v>1.694</c:v>
                </c:pt>
                <c:pt idx="285">
                  <c:v>1.665</c:v>
                </c:pt>
                <c:pt idx="286">
                  <c:v>1.643</c:v>
                </c:pt>
                <c:pt idx="287">
                  <c:v>1.6279999999999999</c:v>
                </c:pt>
                <c:pt idx="288">
                  <c:v>1.62</c:v>
                </c:pt>
                <c:pt idx="289">
                  <c:v>1.62</c:v>
                </c:pt>
                <c:pt idx="290">
                  <c:v>1.625</c:v>
                </c:pt>
                <c:pt idx="291">
                  <c:v>1.633</c:v>
                </c:pt>
                <c:pt idx="292">
                  <c:v>1.64</c:v>
                </c:pt>
                <c:pt idx="293">
                  <c:v>1.643</c:v>
                </c:pt>
                <c:pt idx="294">
                  <c:v>1.64</c:v>
                </c:pt>
                <c:pt idx="295">
                  <c:v>1.6279999999999999</c:v>
                </c:pt>
                <c:pt idx="296">
                  <c:v>1.607</c:v>
                </c:pt>
                <c:pt idx="297">
                  <c:v>1.577</c:v>
                </c:pt>
                <c:pt idx="298">
                  <c:v>1.536</c:v>
                </c:pt>
                <c:pt idx="299">
                  <c:v>1.49</c:v>
                </c:pt>
                <c:pt idx="300">
                  <c:v>1.4379999999999999</c:v>
                </c:pt>
                <c:pt idx="301">
                  <c:v>1.3839999999999999</c:v>
                </c:pt>
                <c:pt idx="302">
                  <c:v>1.331</c:v>
                </c:pt>
                <c:pt idx="303">
                  <c:v>1.2809999999999999</c:v>
                </c:pt>
                <c:pt idx="304">
                  <c:v>1.2350000000000001</c:v>
                </c:pt>
                <c:pt idx="305">
                  <c:v>1.1970000000000001</c:v>
                </c:pt>
                <c:pt idx="306">
                  <c:v>1.165</c:v>
                </c:pt>
                <c:pt idx="307">
                  <c:v>1.141</c:v>
                </c:pt>
                <c:pt idx="308">
                  <c:v>1.123</c:v>
                </c:pt>
                <c:pt idx="309">
                  <c:v>1.1100000000000001</c:v>
                </c:pt>
                <c:pt idx="310">
                  <c:v>1.099</c:v>
                </c:pt>
                <c:pt idx="311">
                  <c:v>1.0880000000000001</c:v>
                </c:pt>
                <c:pt idx="312">
                  <c:v>1.073</c:v>
                </c:pt>
                <c:pt idx="313">
                  <c:v>1.0529999999999999</c:v>
                </c:pt>
                <c:pt idx="314">
                  <c:v>1.0269999999999999</c:v>
                </c:pt>
                <c:pt idx="315">
                  <c:v>0.99299999999999999</c:v>
                </c:pt>
                <c:pt idx="316">
                  <c:v>0.95499999999999996</c:v>
                </c:pt>
                <c:pt idx="317">
                  <c:v>0.91100000000000003</c:v>
                </c:pt>
                <c:pt idx="318">
                  <c:v>0.86199999999999999</c:v>
                </c:pt>
                <c:pt idx="319">
                  <c:v>0.81699999999999995</c:v>
                </c:pt>
                <c:pt idx="320">
                  <c:v>0.77400000000000002</c:v>
                </c:pt>
                <c:pt idx="321">
                  <c:v>0.73399999999999999</c:v>
                </c:pt>
                <c:pt idx="322">
                  <c:v>0.69899999999999995</c:v>
                </c:pt>
                <c:pt idx="323">
                  <c:v>0.66900000000000004</c:v>
                </c:pt>
                <c:pt idx="324">
                  <c:v>0.64500000000000002</c:v>
                </c:pt>
                <c:pt idx="325">
                  <c:v>0.624</c:v>
                </c:pt>
                <c:pt idx="326">
                  <c:v>0.60699999999999998</c:v>
                </c:pt>
                <c:pt idx="327">
                  <c:v>0.59199999999999997</c:v>
                </c:pt>
                <c:pt idx="328">
                  <c:v>0.57799999999999996</c:v>
                </c:pt>
                <c:pt idx="329">
                  <c:v>0.56299999999999994</c:v>
                </c:pt>
                <c:pt idx="330">
                  <c:v>0.54500000000000004</c:v>
                </c:pt>
                <c:pt idx="331">
                  <c:v>0.52600000000000002</c:v>
                </c:pt>
                <c:pt idx="332">
                  <c:v>0.503</c:v>
                </c:pt>
                <c:pt idx="333">
                  <c:v>0.47799999999999998</c:v>
                </c:pt>
                <c:pt idx="334">
                  <c:v>0.45200000000000001</c:v>
                </c:pt>
                <c:pt idx="335">
                  <c:v>0.42399999999999999</c:v>
                </c:pt>
                <c:pt idx="336">
                  <c:v>0.39900000000000002</c:v>
                </c:pt>
                <c:pt idx="337">
                  <c:v>0.375</c:v>
                </c:pt>
                <c:pt idx="338">
                  <c:v>0.35299999999999998</c:v>
                </c:pt>
                <c:pt idx="339">
                  <c:v>0.33400000000000002</c:v>
                </c:pt>
                <c:pt idx="340">
                  <c:v>0.318</c:v>
                </c:pt>
                <c:pt idx="341">
                  <c:v>0.30399999999999999</c:v>
                </c:pt>
                <c:pt idx="342">
                  <c:v>0.29299999999999998</c:v>
                </c:pt>
                <c:pt idx="343">
                  <c:v>0.28199999999999997</c:v>
                </c:pt>
                <c:pt idx="344">
                  <c:v>0.27300000000000002</c:v>
                </c:pt>
                <c:pt idx="345">
                  <c:v>0.26300000000000001</c:v>
                </c:pt>
                <c:pt idx="346">
                  <c:v>0.253</c:v>
                </c:pt>
                <c:pt idx="347">
                  <c:v>0.24199999999999999</c:v>
                </c:pt>
                <c:pt idx="348">
                  <c:v>0.23</c:v>
                </c:pt>
                <c:pt idx="349">
                  <c:v>0.218</c:v>
                </c:pt>
                <c:pt idx="350">
                  <c:v>0.20599999999999999</c:v>
                </c:pt>
                <c:pt idx="351">
                  <c:v>0.193</c:v>
                </c:pt>
                <c:pt idx="352">
                  <c:v>0.18099999999999999</c:v>
                </c:pt>
                <c:pt idx="353">
                  <c:v>0.17</c:v>
                </c:pt>
                <c:pt idx="354">
                  <c:v>0.161</c:v>
                </c:pt>
                <c:pt idx="355">
                  <c:v>0.152</c:v>
                </c:pt>
                <c:pt idx="356">
                  <c:v>0.14499999999999999</c:v>
                </c:pt>
                <c:pt idx="357">
                  <c:v>0.13900000000000001</c:v>
                </c:pt>
                <c:pt idx="358">
                  <c:v>0.13300000000000001</c:v>
                </c:pt>
                <c:pt idx="359">
                  <c:v>0.128</c:v>
                </c:pt>
                <c:pt idx="360">
                  <c:v>0.123</c:v>
                </c:pt>
                <c:pt idx="361">
                  <c:v>0.11799999999999999</c:v>
                </c:pt>
                <c:pt idx="362">
                  <c:v>0.113</c:v>
                </c:pt>
                <c:pt idx="363">
                  <c:v>0.108</c:v>
                </c:pt>
                <c:pt idx="364">
                  <c:v>0.10299999999999999</c:v>
                </c:pt>
                <c:pt idx="365">
                  <c:v>9.8000000000000004E-2</c:v>
                </c:pt>
                <c:pt idx="366">
                  <c:v>9.2999999999999999E-2</c:v>
                </c:pt>
                <c:pt idx="367">
                  <c:v>8.8999999999999996E-2</c:v>
                </c:pt>
                <c:pt idx="368">
                  <c:v>8.5000000000000006E-2</c:v>
                </c:pt>
                <c:pt idx="369">
                  <c:v>8.2000000000000003E-2</c:v>
                </c:pt>
                <c:pt idx="370">
                  <c:v>7.9000000000000001E-2</c:v>
                </c:pt>
                <c:pt idx="371">
                  <c:v>7.6999999999999999E-2</c:v>
                </c:pt>
                <c:pt idx="372">
                  <c:v>7.3999999999999996E-2</c:v>
                </c:pt>
                <c:pt idx="373">
                  <c:v>7.1999999999999995E-2</c:v>
                </c:pt>
                <c:pt idx="374">
                  <c:v>7.0999999999999994E-2</c:v>
                </c:pt>
                <c:pt idx="375">
                  <c:v>6.9000000000000006E-2</c:v>
                </c:pt>
                <c:pt idx="376">
                  <c:v>6.7000000000000004E-2</c:v>
                </c:pt>
                <c:pt idx="377">
                  <c:v>6.6000000000000003E-2</c:v>
                </c:pt>
                <c:pt idx="378">
                  <c:v>6.5000000000000002E-2</c:v>
                </c:pt>
                <c:pt idx="379">
                  <c:v>6.4000000000000001E-2</c:v>
                </c:pt>
                <c:pt idx="380">
                  <c:v>6.3E-2</c:v>
                </c:pt>
                <c:pt idx="381">
                  <c:v>6.3E-2</c:v>
                </c:pt>
                <c:pt idx="382">
                  <c:v>6.3E-2</c:v>
                </c:pt>
                <c:pt idx="383">
                  <c:v>6.3E-2</c:v>
                </c:pt>
                <c:pt idx="384">
                  <c:v>6.4000000000000001E-2</c:v>
                </c:pt>
                <c:pt idx="385">
                  <c:v>6.5000000000000002E-2</c:v>
                </c:pt>
                <c:pt idx="386">
                  <c:v>6.7000000000000004E-2</c:v>
                </c:pt>
                <c:pt idx="387">
                  <c:v>6.9000000000000006E-2</c:v>
                </c:pt>
                <c:pt idx="388">
                  <c:v>7.0999999999999994E-2</c:v>
                </c:pt>
                <c:pt idx="389">
                  <c:v>7.3999999999999996E-2</c:v>
                </c:pt>
                <c:pt idx="390">
                  <c:v>7.6999999999999999E-2</c:v>
                </c:pt>
                <c:pt idx="391">
                  <c:v>8.1000000000000003E-2</c:v>
                </c:pt>
                <c:pt idx="392">
                  <c:v>8.5000000000000006E-2</c:v>
                </c:pt>
                <c:pt idx="393">
                  <c:v>0.09</c:v>
                </c:pt>
                <c:pt idx="394">
                  <c:v>9.6000000000000002E-2</c:v>
                </c:pt>
                <c:pt idx="395">
                  <c:v>0.10199999999999999</c:v>
                </c:pt>
                <c:pt idx="396">
                  <c:v>0.109</c:v>
                </c:pt>
                <c:pt idx="397">
                  <c:v>0.11700000000000001</c:v>
                </c:pt>
                <c:pt idx="398">
                  <c:v>0.125</c:v>
                </c:pt>
                <c:pt idx="399">
                  <c:v>0.13400000000000001</c:v>
                </c:pt>
                <c:pt idx="400">
                  <c:v>0.14399999999999999</c:v>
                </c:pt>
                <c:pt idx="401">
                  <c:v>0.154</c:v>
                </c:pt>
                <c:pt idx="402">
                  <c:v>0.16500000000000001</c:v>
                </c:pt>
                <c:pt idx="403">
                  <c:v>0.17699999999999999</c:v>
                </c:pt>
                <c:pt idx="404">
                  <c:v>0.189</c:v>
                </c:pt>
                <c:pt idx="405">
                  <c:v>0.20200000000000001</c:v>
                </c:pt>
                <c:pt idx="406">
                  <c:v>0.215</c:v>
                </c:pt>
                <c:pt idx="407">
                  <c:v>0.22900000000000001</c:v>
                </c:pt>
                <c:pt idx="408">
                  <c:v>0.24399999999999999</c:v>
                </c:pt>
                <c:pt idx="409">
                  <c:v>0.26100000000000001</c:v>
                </c:pt>
                <c:pt idx="410">
                  <c:v>0.28000000000000003</c:v>
                </c:pt>
                <c:pt idx="411">
                  <c:v>0.29799999999999999</c:v>
                </c:pt>
                <c:pt idx="412">
                  <c:v>0.318</c:v>
                </c:pt>
                <c:pt idx="413">
                  <c:v>0.33900000000000002</c:v>
                </c:pt>
                <c:pt idx="414">
                  <c:v>0.35899999999999999</c:v>
                </c:pt>
                <c:pt idx="415">
                  <c:v>0.38100000000000001</c:v>
                </c:pt>
                <c:pt idx="416">
                  <c:v>0.40300000000000002</c:v>
                </c:pt>
                <c:pt idx="417">
                  <c:v>0.42599999999999999</c:v>
                </c:pt>
                <c:pt idx="418">
                  <c:v>0.44900000000000001</c:v>
                </c:pt>
                <c:pt idx="419">
                  <c:v>0.47199999999999998</c:v>
                </c:pt>
                <c:pt idx="420">
                  <c:v>0.495</c:v>
                </c:pt>
                <c:pt idx="421">
                  <c:v>0.51200000000000001</c:v>
                </c:pt>
                <c:pt idx="422">
                  <c:v>0.54200000000000004</c:v>
                </c:pt>
                <c:pt idx="423">
                  <c:v>0.56799999999999995</c:v>
                </c:pt>
                <c:pt idx="424">
                  <c:v>0.59399999999999997</c:v>
                </c:pt>
                <c:pt idx="425">
                  <c:v>0.62</c:v>
                </c:pt>
                <c:pt idx="426">
                  <c:v>0.64600000000000002</c:v>
                </c:pt>
                <c:pt idx="427">
                  <c:v>0.67300000000000004</c:v>
                </c:pt>
                <c:pt idx="428">
                  <c:v>0.69599999999999995</c:v>
                </c:pt>
                <c:pt idx="429">
                  <c:v>0.72299999999999998</c:v>
                </c:pt>
                <c:pt idx="430">
                  <c:v>0.748</c:v>
                </c:pt>
                <c:pt idx="431">
                  <c:v>0.77300000000000002</c:v>
                </c:pt>
                <c:pt idx="432">
                  <c:v>0.80100000000000005</c:v>
                </c:pt>
                <c:pt idx="433">
                  <c:v>0.82699999999999996</c:v>
                </c:pt>
                <c:pt idx="434">
                  <c:v>0.85399999999999998</c:v>
                </c:pt>
                <c:pt idx="435">
                  <c:v>0.879</c:v>
                </c:pt>
                <c:pt idx="436">
                  <c:v>0.90500000000000003</c:v>
                </c:pt>
                <c:pt idx="437">
                  <c:v>0.92700000000000005</c:v>
                </c:pt>
                <c:pt idx="438">
                  <c:v>0.95099999999999996</c:v>
                </c:pt>
                <c:pt idx="439">
                  <c:v>0.97099999999999997</c:v>
                </c:pt>
                <c:pt idx="440">
                  <c:v>0.99199999999999999</c:v>
                </c:pt>
                <c:pt idx="441">
                  <c:v>1.012</c:v>
                </c:pt>
                <c:pt idx="442">
                  <c:v>1.032</c:v>
                </c:pt>
                <c:pt idx="443">
                  <c:v>1.052</c:v>
                </c:pt>
                <c:pt idx="444">
                  <c:v>1.069</c:v>
                </c:pt>
                <c:pt idx="445">
                  <c:v>1.087</c:v>
                </c:pt>
                <c:pt idx="446">
                  <c:v>1.101</c:v>
                </c:pt>
                <c:pt idx="447">
                  <c:v>1.113</c:v>
                </c:pt>
                <c:pt idx="448">
                  <c:v>1.1299999999999999</c:v>
                </c:pt>
                <c:pt idx="449">
                  <c:v>1.139</c:v>
                </c:pt>
                <c:pt idx="450">
                  <c:v>1.1479999999999999</c:v>
                </c:pt>
                <c:pt idx="451">
                  <c:v>1.159</c:v>
                </c:pt>
                <c:pt idx="452">
                  <c:v>1.173</c:v>
                </c:pt>
                <c:pt idx="453">
                  <c:v>1.18</c:v>
                </c:pt>
                <c:pt idx="454">
                  <c:v>1.1870000000000001</c:v>
                </c:pt>
                <c:pt idx="455">
                  <c:v>1.1950000000000001</c:v>
                </c:pt>
                <c:pt idx="456">
                  <c:v>1.2010000000000001</c:v>
                </c:pt>
                <c:pt idx="457">
                  <c:v>1.2</c:v>
                </c:pt>
                <c:pt idx="458">
                  <c:v>1.2030000000000001</c:v>
                </c:pt>
                <c:pt idx="459">
                  <c:v>1.21</c:v>
                </c:pt>
                <c:pt idx="460">
                  <c:v>1.214</c:v>
                </c:pt>
                <c:pt idx="461">
                  <c:v>1.2350000000000001</c:v>
                </c:pt>
                <c:pt idx="462">
                  <c:v>1.254</c:v>
                </c:pt>
                <c:pt idx="463">
                  <c:v>1.264</c:v>
                </c:pt>
                <c:pt idx="464">
                  <c:v>1.2749999999999999</c:v>
                </c:pt>
                <c:pt idx="465">
                  <c:v>1.2869999999999999</c:v>
                </c:pt>
                <c:pt idx="466">
                  <c:v>1.2969999999999999</c:v>
                </c:pt>
                <c:pt idx="467">
                  <c:v>1.3029999999999999</c:v>
                </c:pt>
                <c:pt idx="468">
                  <c:v>1.3069999999999999</c:v>
                </c:pt>
                <c:pt idx="469">
                  <c:v>1.3129999999999999</c:v>
                </c:pt>
                <c:pt idx="470">
                  <c:v>1.3160000000000001</c:v>
                </c:pt>
                <c:pt idx="471">
                  <c:v>1.333</c:v>
                </c:pt>
                <c:pt idx="472">
                  <c:v>1.3560000000000001</c:v>
                </c:pt>
                <c:pt idx="473">
                  <c:v>1.379</c:v>
                </c:pt>
                <c:pt idx="474">
                  <c:v>1.401</c:v>
                </c:pt>
                <c:pt idx="475">
                  <c:v>1.413</c:v>
                </c:pt>
                <c:pt idx="476">
                  <c:v>1.419</c:v>
                </c:pt>
                <c:pt idx="477">
                  <c:v>1.42</c:v>
                </c:pt>
                <c:pt idx="478">
                  <c:v>1.425</c:v>
                </c:pt>
                <c:pt idx="479">
                  <c:v>1.4410000000000001</c:v>
                </c:pt>
                <c:pt idx="480">
                  <c:v>1.464</c:v>
                </c:pt>
                <c:pt idx="481">
                  <c:v>1.4930000000000001</c:v>
                </c:pt>
                <c:pt idx="482">
                  <c:v>1.512</c:v>
                </c:pt>
                <c:pt idx="483">
                  <c:v>1.522</c:v>
                </c:pt>
                <c:pt idx="484">
                  <c:v>1.5229999999999999</c:v>
                </c:pt>
                <c:pt idx="485">
                  <c:v>1.516</c:v>
                </c:pt>
                <c:pt idx="486">
                  <c:v>1.5129999999999999</c:v>
                </c:pt>
                <c:pt idx="487">
                  <c:v>1.52</c:v>
                </c:pt>
                <c:pt idx="488">
                  <c:v>1.5389999999999999</c:v>
                </c:pt>
                <c:pt idx="489">
                  <c:v>1.556</c:v>
                </c:pt>
                <c:pt idx="490">
                  <c:v>1.5629999999999999</c:v>
                </c:pt>
                <c:pt idx="491">
                  <c:v>1.5580000000000001</c:v>
                </c:pt>
                <c:pt idx="492">
                  <c:v>1.544</c:v>
                </c:pt>
                <c:pt idx="493">
                  <c:v>1.524</c:v>
                </c:pt>
                <c:pt idx="494">
                  <c:v>1.5169999999999999</c:v>
                </c:pt>
                <c:pt idx="495">
                  <c:v>1.512</c:v>
                </c:pt>
                <c:pt idx="496">
                  <c:v>1.51</c:v>
                </c:pt>
                <c:pt idx="497">
                  <c:v>1.502</c:v>
                </c:pt>
                <c:pt idx="498">
                  <c:v>1.4790000000000001</c:v>
                </c:pt>
                <c:pt idx="499">
                  <c:v>1.4450000000000001</c:v>
                </c:pt>
                <c:pt idx="500">
                  <c:v>1.41</c:v>
                </c:pt>
                <c:pt idx="501">
                  <c:v>1.3819999999999999</c:v>
                </c:pt>
                <c:pt idx="502">
                  <c:v>1.3580000000000001</c:v>
                </c:pt>
                <c:pt idx="503">
                  <c:v>1.331</c:v>
                </c:pt>
                <c:pt idx="504">
                  <c:v>1.2969999999999999</c:v>
                </c:pt>
                <c:pt idx="505">
                  <c:v>1.254</c:v>
                </c:pt>
                <c:pt idx="506">
                  <c:v>1.204</c:v>
                </c:pt>
                <c:pt idx="507">
                  <c:v>1.1559999999999999</c:v>
                </c:pt>
                <c:pt idx="508">
                  <c:v>1.1120000000000001</c:v>
                </c:pt>
                <c:pt idx="509">
                  <c:v>1.069</c:v>
                </c:pt>
                <c:pt idx="510">
                  <c:v>1.024</c:v>
                </c:pt>
                <c:pt idx="511">
                  <c:v>0.97299999999999998</c:v>
                </c:pt>
                <c:pt idx="512">
                  <c:v>0.91800000000000004</c:v>
                </c:pt>
                <c:pt idx="513">
                  <c:v>0.86599999999999999</c:v>
                </c:pt>
                <c:pt idx="514">
                  <c:v>0.81799999999999995</c:v>
                </c:pt>
                <c:pt idx="515">
                  <c:v>0.77400000000000002</c:v>
                </c:pt>
                <c:pt idx="516">
                  <c:v>0.72799999999999998</c:v>
                </c:pt>
                <c:pt idx="517">
                  <c:v>0.68300000000000005</c:v>
                </c:pt>
                <c:pt idx="518">
                  <c:v>0.63800000000000001</c:v>
                </c:pt>
                <c:pt idx="519">
                  <c:v>0.59799999999999998</c:v>
                </c:pt>
                <c:pt idx="520">
                  <c:v>0.56399999999999995</c:v>
                </c:pt>
                <c:pt idx="521">
                  <c:v>0.53400000000000003</c:v>
                </c:pt>
                <c:pt idx="522">
                  <c:v>0.505</c:v>
                </c:pt>
                <c:pt idx="523">
                  <c:v>0.47799999999999998</c:v>
                </c:pt>
                <c:pt idx="524">
                  <c:v>0.45300000000000001</c:v>
                </c:pt>
                <c:pt idx="525">
                  <c:v>0.432</c:v>
                </c:pt>
                <c:pt idx="526">
                  <c:v>0.41599999999999998</c:v>
                </c:pt>
                <c:pt idx="527">
                  <c:v>0.40200000000000002</c:v>
                </c:pt>
                <c:pt idx="528">
                  <c:v>0.39100000000000001</c:v>
                </c:pt>
                <c:pt idx="529">
                  <c:v>0.38200000000000001</c:v>
                </c:pt>
                <c:pt idx="530">
                  <c:v>0.377</c:v>
                </c:pt>
                <c:pt idx="531">
                  <c:v>0.376</c:v>
                </c:pt>
                <c:pt idx="532">
                  <c:v>0.378</c:v>
                </c:pt>
                <c:pt idx="533">
                  <c:v>0.38300000000000001</c:v>
                </c:pt>
                <c:pt idx="534">
                  <c:v>0.39</c:v>
                </c:pt>
                <c:pt idx="535">
                  <c:v>0.4</c:v>
                </c:pt>
                <c:pt idx="536">
                  <c:v>0.41299999999999998</c:v>
                </c:pt>
                <c:pt idx="537">
                  <c:v>0.42899999999999999</c:v>
                </c:pt>
                <c:pt idx="538">
                  <c:v>0.44800000000000001</c:v>
                </c:pt>
                <c:pt idx="539">
                  <c:v>0.46800000000000003</c:v>
                </c:pt>
                <c:pt idx="540">
                  <c:v>0.49</c:v>
                </c:pt>
                <c:pt idx="541">
                  <c:v>0.51500000000000001</c:v>
                </c:pt>
                <c:pt idx="542">
                  <c:v>0.54200000000000004</c:v>
                </c:pt>
                <c:pt idx="543">
                  <c:v>0.56999999999999995</c:v>
                </c:pt>
                <c:pt idx="544">
                  <c:v>0.6</c:v>
                </c:pt>
                <c:pt idx="545">
                  <c:v>0.63100000000000001</c:v>
                </c:pt>
                <c:pt idx="546">
                  <c:v>0.66500000000000004</c:v>
                </c:pt>
                <c:pt idx="547">
                  <c:v>0.7</c:v>
                </c:pt>
                <c:pt idx="548">
                  <c:v>0.73699999999999999</c:v>
                </c:pt>
                <c:pt idx="549">
                  <c:v>0.77500000000000002</c:v>
                </c:pt>
                <c:pt idx="550">
                  <c:v>0.81599999999999995</c:v>
                </c:pt>
                <c:pt idx="551">
                  <c:v>0.85699999999999998</c:v>
                </c:pt>
                <c:pt idx="552">
                  <c:v>0.89900000000000002</c:v>
                </c:pt>
                <c:pt idx="553">
                  <c:v>0.94199999999999995</c:v>
                </c:pt>
                <c:pt idx="554">
                  <c:v>0.98599999999999999</c:v>
                </c:pt>
                <c:pt idx="555">
                  <c:v>1.03</c:v>
                </c:pt>
                <c:pt idx="556">
                  <c:v>1.0740000000000001</c:v>
                </c:pt>
                <c:pt idx="557">
                  <c:v>1.1180000000000001</c:v>
                </c:pt>
                <c:pt idx="558">
                  <c:v>1.1599999999999999</c:v>
                </c:pt>
                <c:pt idx="559">
                  <c:v>1.204</c:v>
                </c:pt>
                <c:pt idx="560">
                  <c:v>1.2430000000000001</c:v>
                </c:pt>
                <c:pt idx="561">
                  <c:v>1.2789999999999999</c:v>
                </c:pt>
                <c:pt idx="562">
                  <c:v>1.3140000000000001</c:v>
                </c:pt>
                <c:pt idx="563">
                  <c:v>1.3460000000000001</c:v>
                </c:pt>
                <c:pt idx="564">
                  <c:v>1.377</c:v>
                </c:pt>
                <c:pt idx="565">
                  <c:v>1.405</c:v>
                </c:pt>
                <c:pt idx="566">
                  <c:v>1.431</c:v>
                </c:pt>
                <c:pt idx="567">
                  <c:v>1.456</c:v>
                </c:pt>
                <c:pt idx="568">
                  <c:v>1.4790000000000001</c:v>
                </c:pt>
                <c:pt idx="569">
                  <c:v>1.5</c:v>
                </c:pt>
                <c:pt idx="570">
                  <c:v>1.52</c:v>
                </c:pt>
                <c:pt idx="571">
                  <c:v>1.538</c:v>
                </c:pt>
                <c:pt idx="572">
                  <c:v>1.5549999999999999</c:v>
                </c:pt>
                <c:pt idx="573">
                  <c:v>1.573</c:v>
                </c:pt>
                <c:pt idx="574">
                  <c:v>1.59</c:v>
                </c:pt>
                <c:pt idx="575">
                  <c:v>1.6060000000000001</c:v>
                </c:pt>
                <c:pt idx="576">
                  <c:v>1.6240000000000001</c:v>
                </c:pt>
                <c:pt idx="577">
                  <c:v>1.6419999999999999</c:v>
                </c:pt>
                <c:pt idx="578">
                  <c:v>1.6619999999999999</c:v>
                </c:pt>
                <c:pt idx="579">
                  <c:v>1.6819999999999999</c:v>
                </c:pt>
                <c:pt idx="580">
                  <c:v>1.7050000000000001</c:v>
                </c:pt>
                <c:pt idx="581">
                  <c:v>1.732</c:v>
                </c:pt>
                <c:pt idx="582">
                  <c:v>1.758</c:v>
                </c:pt>
                <c:pt idx="583">
                  <c:v>1.79</c:v>
                </c:pt>
                <c:pt idx="584">
                  <c:v>1.827</c:v>
                </c:pt>
                <c:pt idx="585">
                  <c:v>1.869</c:v>
                </c:pt>
                <c:pt idx="586">
                  <c:v>1.917</c:v>
                </c:pt>
                <c:pt idx="587">
                  <c:v>1.972</c:v>
                </c:pt>
                <c:pt idx="588">
                  <c:v>2.0339999999999998</c:v>
                </c:pt>
                <c:pt idx="589">
                  <c:v>2.0960000000000001</c:v>
                </c:pt>
                <c:pt idx="590">
                  <c:v>2.1680000000000001</c:v>
                </c:pt>
                <c:pt idx="591">
                  <c:v>2.2389999999999999</c:v>
                </c:pt>
                <c:pt idx="592">
                  <c:v>2.31</c:v>
                </c:pt>
                <c:pt idx="593">
                  <c:v>2.3650000000000002</c:v>
                </c:pt>
                <c:pt idx="594">
                  <c:v>2.4209999999999998</c:v>
                </c:pt>
                <c:pt idx="595">
                  <c:v>2.4620000000000002</c:v>
                </c:pt>
                <c:pt idx="596">
                  <c:v>2.4849999999999999</c:v>
                </c:pt>
                <c:pt idx="597">
                  <c:v>2.5</c:v>
                </c:pt>
                <c:pt idx="598">
                  <c:v>2.5150000000000001</c:v>
                </c:pt>
                <c:pt idx="599">
                  <c:v>2.5179999999999998</c:v>
                </c:pt>
                <c:pt idx="600">
                  <c:v>2.5169999999999999</c:v>
                </c:pt>
                <c:pt idx="601">
                  <c:v>2.5099999999999998</c:v>
                </c:pt>
                <c:pt idx="602">
                  <c:v>2.5</c:v>
                </c:pt>
                <c:pt idx="603">
                  <c:v>2.4929999999999999</c:v>
                </c:pt>
                <c:pt idx="604">
                  <c:v>2.4849999999999999</c:v>
                </c:pt>
                <c:pt idx="605">
                  <c:v>2.4820000000000002</c:v>
                </c:pt>
                <c:pt idx="606">
                  <c:v>2.4689999999999999</c:v>
                </c:pt>
                <c:pt idx="607">
                  <c:v>2.4540000000000002</c:v>
                </c:pt>
                <c:pt idx="608">
                  <c:v>2.4420000000000002</c:v>
                </c:pt>
                <c:pt idx="609">
                  <c:v>2.4180000000000001</c:v>
                </c:pt>
                <c:pt idx="610">
                  <c:v>2.38600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18C9-4E99-A1AE-ACBC1A0BA61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0.5 mM</c:v>
                </c:pt>
              </c:strCache>
            </c:strRef>
          </c:tx>
          <c:spPr>
            <a:ln>
              <a:prstDash val="sysDot"/>
            </a:ln>
          </c:spPr>
          <c:marker>
            <c:symbol val="none"/>
          </c:marker>
          <c:xVal>
            <c:numRef>
              <c:f>Sheet1!$A$2:$A$612</c:f>
              <c:numCache>
                <c:formatCode>General</c:formatCode>
                <c:ptCount val="61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  <c:pt idx="601">
                  <c:v>199</c:v>
                </c:pt>
                <c:pt idx="602">
                  <c:v>198</c:v>
                </c:pt>
                <c:pt idx="603">
                  <c:v>197</c:v>
                </c:pt>
                <c:pt idx="604">
                  <c:v>196</c:v>
                </c:pt>
                <c:pt idx="605">
                  <c:v>195</c:v>
                </c:pt>
                <c:pt idx="606">
                  <c:v>194</c:v>
                </c:pt>
                <c:pt idx="607">
                  <c:v>193</c:v>
                </c:pt>
                <c:pt idx="608">
                  <c:v>192</c:v>
                </c:pt>
                <c:pt idx="609">
                  <c:v>191</c:v>
                </c:pt>
                <c:pt idx="610">
                  <c:v>190</c:v>
                </c:pt>
              </c:numCache>
            </c:numRef>
          </c:xVal>
          <c:yVal>
            <c:numRef>
              <c:f>Sheet1!$C$2:$C$612</c:f>
              <c:numCache>
                <c:formatCode>General</c:formatCode>
                <c:ptCount val="611"/>
                <c:pt idx="0">
                  <c:v>1E-3</c:v>
                </c:pt>
                <c:pt idx="1">
                  <c:v>1E-3</c:v>
                </c:pt>
                <c:pt idx="2">
                  <c:v>1E-3</c:v>
                </c:pt>
                <c:pt idx="3">
                  <c:v>1E-3</c:v>
                </c:pt>
                <c:pt idx="4">
                  <c:v>1E-3</c:v>
                </c:pt>
                <c:pt idx="5">
                  <c:v>1E-3</c:v>
                </c:pt>
                <c:pt idx="6">
                  <c:v>1E-3</c:v>
                </c:pt>
                <c:pt idx="7">
                  <c:v>1E-3</c:v>
                </c:pt>
                <c:pt idx="8">
                  <c:v>1E-3</c:v>
                </c:pt>
                <c:pt idx="9">
                  <c:v>1E-3</c:v>
                </c:pt>
                <c:pt idx="10">
                  <c:v>1E-3</c:v>
                </c:pt>
                <c:pt idx="11">
                  <c:v>1E-3</c:v>
                </c:pt>
                <c:pt idx="12">
                  <c:v>1E-3</c:v>
                </c:pt>
                <c:pt idx="13">
                  <c:v>1E-3</c:v>
                </c:pt>
                <c:pt idx="14">
                  <c:v>1E-3</c:v>
                </c:pt>
                <c:pt idx="15">
                  <c:v>1E-3</c:v>
                </c:pt>
                <c:pt idx="16">
                  <c:v>1E-3</c:v>
                </c:pt>
                <c:pt idx="17">
                  <c:v>1E-3</c:v>
                </c:pt>
                <c:pt idx="18">
                  <c:v>1E-3</c:v>
                </c:pt>
                <c:pt idx="19">
                  <c:v>1E-3</c:v>
                </c:pt>
                <c:pt idx="20">
                  <c:v>2E-3</c:v>
                </c:pt>
                <c:pt idx="21">
                  <c:v>2E-3</c:v>
                </c:pt>
                <c:pt idx="22">
                  <c:v>2E-3</c:v>
                </c:pt>
                <c:pt idx="23">
                  <c:v>2E-3</c:v>
                </c:pt>
                <c:pt idx="24">
                  <c:v>2E-3</c:v>
                </c:pt>
                <c:pt idx="25">
                  <c:v>2E-3</c:v>
                </c:pt>
                <c:pt idx="26">
                  <c:v>2E-3</c:v>
                </c:pt>
                <c:pt idx="27">
                  <c:v>2E-3</c:v>
                </c:pt>
                <c:pt idx="28">
                  <c:v>2E-3</c:v>
                </c:pt>
                <c:pt idx="29">
                  <c:v>2E-3</c:v>
                </c:pt>
                <c:pt idx="30">
                  <c:v>2E-3</c:v>
                </c:pt>
                <c:pt idx="31">
                  <c:v>2E-3</c:v>
                </c:pt>
                <c:pt idx="32">
                  <c:v>2E-3</c:v>
                </c:pt>
                <c:pt idx="33">
                  <c:v>2E-3</c:v>
                </c:pt>
                <c:pt idx="34">
                  <c:v>2E-3</c:v>
                </c:pt>
                <c:pt idx="35">
                  <c:v>2E-3</c:v>
                </c:pt>
                <c:pt idx="36">
                  <c:v>2E-3</c:v>
                </c:pt>
                <c:pt idx="37">
                  <c:v>3.0000000000000001E-3</c:v>
                </c:pt>
                <c:pt idx="38">
                  <c:v>3.0000000000000001E-3</c:v>
                </c:pt>
                <c:pt idx="39">
                  <c:v>3.0000000000000001E-3</c:v>
                </c:pt>
                <c:pt idx="40">
                  <c:v>3.0000000000000001E-3</c:v>
                </c:pt>
                <c:pt idx="41">
                  <c:v>3.0000000000000001E-3</c:v>
                </c:pt>
                <c:pt idx="42">
                  <c:v>3.0000000000000001E-3</c:v>
                </c:pt>
                <c:pt idx="43">
                  <c:v>3.0000000000000001E-3</c:v>
                </c:pt>
                <c:pt idx="44">
                  <c:v>3.0000000000000001E-3</c:v>
                </c:pt>
                <c:pt idx="45">
                  <c:v>3.0000000000000001E-3</c:v>
                </c:pt>
                <c:pt idx="46">
                  <c:v>4.0000000000000001E-3</c:v>
                </c:pt>
                <c:pt idx="47">
                  <c:v>4.0000000000000001E-3</c:v>
                </c:pt>
                <c:pt idx="48">
                  <c:v>4.0000000000000001E-3</c:v>
                </c:pt>
                <c:pt idx="49">
                  <c:v>4.0000000000000001E-3</c:v>
                </c:pt>
                <c:pt idx="50">
                  <c:v>4.0000000000000001E-3</c:v>
                </c:pt>
                <c:pt idx="51">
                  <c:v>4.0000000000000001E-3</c:v>
                </c:pt>
                <c:pt idx="52">
                  <c:v>4.0000000000000001E-3</c:v>
                </c:pt>
                <c:pt idx="53">
                  <c:v>5.0000000000000001E-3</c:v>
                </c:pt>
                <c:pt idx="54">
                  <c:v>5.0000000000000001E-3</c:v>
                </c:pt>
                <c:pt idx="55">
                  <c:v>5.0000000000000001E-3</c:v>
                </c:pt>
                <c:pt idx="56">
                  <c:v>5.0000000000000001E-3</c:v>
                </c:pt>
                <c:pt idx="57">
                  <c:v>5.0000000000000001E-3</c:v>
                </c:pt>
                <c:pt idx="58">
                  <c:v>6.0000000000000001E-3</c:v>
                </c:pt>
                <c:pt idx="59">
                  <c:v>6.0000000000000001E-3</c:v>
                </c:pt>
                <c:pt idx="60">
                  <c:v>6.0000000000000001E-3</c:v>
                </c:pt>
                <c:pt idx="61">
                  <c:v>6.0000000000000001E-3</c:v>
                </c:pt>
                <c:pt idx="62">
                  <c:v>7.0000000000000001E-3</c:v>
                </c:pt>
                <c:pt idx="63">
                  <c:v>7.0000000000000001E-3</c:v>
                </c:pt>
                <c:pt idx="64">
                  <c:v>7.0000000000000001E-3</c:v>
                </c:pt>
                <c:pt idx="65">
                  <c:v>7.0000000000000001E-3</c:v>
                </c:pt>
                <c:pt idx="66">
                  <c:v>8.0000000000000002E-3</c:v>
                </c:pt>
                <c:pt idx="67">
                  <c:v>8.0000000000000002E-3</c:v>
                </c:pt>
                <c:pt idx="68">
                  <c:v>8.0000000000000002E-3</c:v>
                </c:pt>
                <c:pt idx="69">
                  <c:v>8.0000000000000002E-3</c:v>
                </c:pt>
                <c:pt idx="70">
                  <c:v>8.9999999999999993E-3</c:v>
                </c:pt>
                <c:pt idx="71">
                  <c:v>8.9999999999999993E-3</c:v>
                </c:pt>
                <c:pt idx="72">
                  <c:v>8.9999999999999993E-3</c:v>
                </c:pt>
                <c:pt idx="73">
                  <c:v>0.01</c:v>
                </c:pt>
                <c:pt idx="74">
                  <c:v>0.01</c:v>
                </c:pt>
                <c:pt idx="75">
                  <c:v>0.01</c:v>
                </c:pt>
                <c:pt idx="76">
                  <c:v>1.0999999999999999E-2</c:v>
                </c:pt>
                <c:pt idx="77">
                  <c:v>1.0999999999999999E-2</c:v>
                </c:pt>
                <c:pt idx="78">
                  <c:v>1.0999999999999999E-2</c:v>
                </c:pt>
                <c:pt idx="79">
                  <c:v>1.2E-2</c:v>
                </c:pt>
                <c:pt idx="80">
                  <c:v>1.2E-2</c:v>
                </c:pt>
                <c:pt idx="81">
                  <c:v>1.2E-2</c:v>
                </c:pt>
                <c:pt idx="82">
                  <c:v>1.2999999999999999E-2</c:v>
                </c:pt>
                <c:pt idx="83">
                  <c:v>1.2999999999999999E-2</c:v>
                </c:pt>
                <c:pt idx="84">
                  <c:v>1.2999999999999999E-2</c:v>
                </c:pt>
                <c:pt idx="85">
                  <c:v>1.4E-2</c:v>
                </c:pt>
                <c:pt idx="86">
                  <c:v>1.4E-2</c:v>
                </c:pt>
                <c:pt idx="87">
                  <c:v>1.4999999999999999E-2</c:v>
                </c:pt>
                <c:pt idx="88">
                  <c:v>1.4999999999999999E-2</c:v>
                </c:pt>
                <c:pt idx="89">
                  <c:v>1.6E-2</c:v>
                </c:pt>
                <c:pt idx="90">
                  <c:v>1.6E-2</c:v>
                </c:pt>
                <c:pt idx="91">
                  <c:v>1.7000000000000001E-2</c:v>
                </c:pt>
                <c:pt idx="92">
                  <c:v>1.7000000000000001E-2</c:v>
                </c:pt>
                <c:pt idx="93">
                  <c:v>1.7999999999999999E-2</c:v>
                </c:pt>
                <c:pt idx="94">
                  <c:v>1.7999999999999999E-2</c:v>
                </c:pt>
                <c:pt idx="95">
                  <c:v>1.9E-2</c:v>
                </c:pt>
                <c:pt idx="96">
                  <c:v>1.9E-2</c:v>
                </c:pt>
                <c:pt idx="97">
                  <c:v>0.02</c:v>
                </c:pt>
                <c:pt idx="98">
                  <c:v>2.1000000000000001E-2</c:v>
                </c:pt>
                <c:pt idx="99">
                  <c:v>2.1000000000000001E-2</c:v>
                </c:pt>
                <c:pt idx="100">
                  <c:v>2.1999999999999999E-2</c:v>
                </c:pt>
                <c:pt idx="101">
                  <c:v>2.1999999999999999E-2</c:v>
                </c:pt>
                <c:pt idx="102">
                  <c:v>2.3E-2</c:v>
                </c:pt>
                <c:pt idx="103">
                  <c:v>2.4E-2</c:v>
                </c:pt>
                <c:pt idx="104">
                  <c:v>2.5000000000000001E-2</c:v>
                </c:pt>
                <c:pt idx="105">
                  <c:v>2.5000000000000001E-2</c:v>
                </c:pt>
                <c:pt idx="106">
                  <c:v>2.5999999999999999E-2</c:v>
                </c:pt>
                <c:pt idx="107">
                  <c:v>2.7E-2</c:v>
                </c:pt>
                <c:pt idx="108">
                  <c:v>2.8000000000000001E-2</c:v>
                </c:pt>
                <c:pt idx="109">
                  <c:v>2.8000000000000001E-2</c:v>
                </c:pt>
                <c:pt idx="110">
                  <c:v>2.9000000000000001E-2</c:v>
                </c:pt>
                <c:pt idx="111">
                  <c:v>0.03</c:v>
                </c:pt>
                <c:pt idx="112">
                  <c:v>3.1E-2</c:v>
                </c:pt>
                <c:pt idx="113">
                  <c:v>3.2000000000000001E-2</c:v>
                </c:pt>
                <c:pt idx="114">
                  <c:v>3.3000000000000002E-2</c:v>
                </c:pt>
                <c:pt idx="115">
                  <c:v>3.4000000000000002E-2</c:v>
                </c:pt>
                <c:pt idx="116">
                  <c:v>3.4000000000000002E-2</c:v>
                </c:pt>
                <c:pt idx="117">
                  <c:v>3.5000000000000003E-2</c:v>
                </c:pt>
                <c:pt idx="118">
                  <c:v>3.5999999999999997E-2</c:v>
                </c:pt>
                <c:pt idx="119">
                  <c:v>3.6999999999999998E-2</c:v>
                </c:pt>
                <c:pt idx="120">
                  <c:v>3.7999999999999999E-2</c:v>
                </c:pt>
                <c:pt idx="121">
                  <c:v>3.9E-2</c:v>
                </c:pt>
                <c:pt idx="122">
                  <c:v>0.04</c:v>
                </c:pt>
                <c:pt idx="123">
                  <c:v>4.1000000000000002E-2</c:v>
                </c:pt>
                <c:pt idx="124">
                  <c:v>4.2000000000000003E-2</c:v>
                </c:pt>
                <c:pt idx="125">
                  <c:v>4.2999999999999997E-2</c:v>
                </c:pt>
                <c:pt idx="126">
                  <c:v>4.2999999999999997E-2</c:v>
                </c:pt>
                <c:pt idx="127">
                  <c:v>4.3999999999999997E-2</c:v>
                </c:pt>
                <c:pt idx="128">
                  <c:v>4.4999999999999998E-2</c:v>
                </c:pt>
                <c:pt idx="129">
                  <c:v>4.5999999999999999E-2</c:v>
                </c:pt>
                <c:pt idx="130">
                  <c:v>4.7E-2</c:v>
                </c:pt>
                <c:pt idx="131">
                  <c:v>4.8000000000000001E-2</c:v>
                </c:pt>
                <c:pt idx="132">
                  <c:v>4.9000000000000002E-2</c:v>
                </c:pt>
                <c:pt idx="133">
                  <c:v>0.05</c:v>
                </c:pt>
                <c:pt idx="134">
                  <c:v>5.0999999999999997E-2</c:v>
                </c:pt>
                <c:pt idx="135">
                  <c:v>5.1999999999999998E-2</c:v>
                </c:pt>
                <c:pt idx="136">
                  <c:v>5.2999999999999999E-2</c:v>
                </c:pt>
                <c:pt idx="137">
                  <c:v>5.3999999999999999E-2</c:v>
                </c:pt>
                <c:pt idx="138">
                  <c:v>5.5E-2</c:v>
                </c:pt>
                <c:pt idx="139">
                  <c:v>5.6000000000000001E-2</c:v>
                </c:pt>
                <c:pt idx="140">
                  <c:v>5.7000000000000002E-2</c:v>
                </c:pt>
                <c:pt idx="141">
                  <c:v>5.8000000000000003E-2</c:v>
                </c:pt>
                <c:pt idx="142">
                  <c:v>5.8999999999999997E-2</c:v>
                </c:pt>
                <c:pt idx="143">
                  <c:v>0.06</c:v>
                </c:pt>
                <c:pt idx="144">
                  <c:v>6.0999999999999999E-2</c:v>
                </c:pt>
                <c:pt idx="145">
                  <c:v>6.2E-2</c:v>
                </c:pt>
                <c:pt idx="146">
                  <c:v>6.3E-2</c:v>
                </c:pt>
                <c:pt idx="147">
                  <c:v>6.4000000000000001E-2</c:v>
                </c:pt>
                <c:pt idx="148">
                  <c:v>6.5000000000000002E-2</c:v>
                </c:pt>
                <c:pt idx="149">
                  <c:v>6.6000000000000003E-2</c:v>
                </c:pt>
                <c:pt idx="150">
                  <c:v>6.7000000000000004E-2</c:v>
                </c:pt>
                <c:pt idx="151">
                  <c:v>6.8000000000000005E-2</c:v>
                </c:pt>
                <c:pt idx="152">
                  <c:v>6.9000000000000006E-2</c:v>
                </c:pt>
                <c:pt idx="153">
                  <c:v>7.0000000000000007E-2</c:v>
                </c:pt>
                <c:pt idx="154">
                  <c:v>7.0999999999999994E-2</c:v>
                </c:pt>
                <c:pt idx="155">
                  <c:v>7.1999999999999995E-2</c:v>
                </c:pt>
                <c:pt idx="156">
                  <c:v>7.2999999999999995E-2</c:v>
                </c:pt>
                <c:pt idx="157">
                  <c:v>7.3999999999999996E-2</c:v>
                </c:pt>
                <c:pt idx="158">
                  <c:v>7.4999999999999997E-2</c:v>
                </c:pt>
                <c:pt idx="159">
                  <c:v>7.5999999999999998E-2</c:v>
                </c:pt>
                <c:pt idx="160">
                  <c:v>7.5999999999999998E-2</c:v>
                </c:pt>
                <c:pt idx="161">
                  <c:v>7.6999999999999999E-2</c:v>
                </c:pt>
                <c:pt idx="162">
                  <c:v>7.8E-2</c:v>
                </c:pt>
                <c:pt idx="163">
                  <c:v>7.9000000000000001E-2</c:v>
                </c:pt>
                <c:pt idx="164">
                  <c:v>0.08</c:v>
                </c:pt>
                <c:pt idx="165">
                  <c:v>0.08</c:v>
                </c:pt>
                <c:pt idx="166">
                  <c:v>8.1000000000000003E-2</c:v>
                </c:pt>
                <c:pt idx="167">
                  <c:v>8.2000000000000003E-2</c:v>
                </c:pt>
                <c:pt idx="168">
                  <c:v>8.3000000000000004E-2</c:v>
                </c:pt>
                <c:pt idx="169">
                  <c:v>8.3000000000000004E-2</c:v>
                </c:pt>
                <c:pt idx="170">
                  <c:v>8.4000000000000005E-2</c:v>
                </c:pt>
                <c:pt idx="171">
                  <c:v>8.5000000000000006E-2</c:v>
                </c:pt>
                <c:pt idx="172">
                  <c:v>8.5000000000000006E-2</c:v>
                </c:pt>
                <c:pt idx="173">
                  <c:v>8.5999999999999993E-2</c:v>
                </c:pt>
                <c:pt idx="174">
                  <c:v>8.6999999999999994E-2</c:v>
                </c:pt>
                <c:pt idx="175">
                  <c:v>8.6999999999999994E-2</c:v>
                </c:pt>
                <c:pt idx="176">
                  <c:v>8.7999999999999995E-2</c:v>
                </c:pt>
                <c:pt idx="177">
                  <c:v>8.8999999999999996E-2</c:v>
                </c:pt>
                <c:pt idx="178">
                  <c:v>8.8999999999999996E-2</c:v>
                </c:pt>
                <c:pt idx="179">
                  <c:v>0.09</c:v>
                </c:pt>
                <c:pt idx="180">
                  <c:v>9.0999999999999998E-2</c:v>
                </c:pt>
                <c:pt idx="181">
                  <c:v>9.1999999999999998E-2</c:v>
                </c:pt>
                <c:pt idx="182">
                  <c:v>9.1999999999999998E-2</c:v>
                </c:pt>
                <c:pt idx="183">
                  <c:v>9.2999999999999999E-2</c:v>
                </c:pt>
                <c:pt idx="184">
                  <c:v>9.4E-2</c:v>
                </c:pt>
                <c:pt idx="185">
                  <c:v>9.5000000000000001E-2</c:v>
                </c:pt>
                <c:pt idx="186">
                  <c:v>9.6000000000000002E-2</c:v>
                </c:pt>
                <c:pt idx="187">
                  <c:v>9.7000000000000003E-2</c:v>
                </c:pt>
                <c:pt idx="188">
                  <c:v>9.8000000000000004E-2</c:v>
                </c:pt>
                <c:pt idx="189">
                  <c:v>9.9000000000000005E-2</c:v>
                </c:pt>
                <c:pt idx="190">
                  <c:v>0.1</c:v>
                </c:pt>
                <c:pt idx="191">
                  <c:v>0.10199999999999999</c:v>
                </c:pt>
                <c:pt idx="192">
                  <c:v>0.10299999999999999</c:v>
                </c:pt>
                <c:pt idx="193">
                  <c:v>0.105</c:v>
                </c:pt>
                <c:pt idx="194">
                  <c:v>0.106</c:v>
                </c:pt>
                <c:pt idx="195">
                  <c:v>0.108</c:v>
                </c:pt>
                <c:pt idx="196">
                  <c:v>0.109</c:v>
                </c:pt>
                <c:pt idx="197">
                  <c:v>0.111</c:v>
                </c:pt>
                <c:pt idx="198">
                  <c:v>0.113</c:v>
                </c:pt>
                <c:pt idx="199">
                  <c:v>0.115</c:v>
                </c:pt>
                <c:pt idx="200">
                  <c:v>0.11600000000000001</c:v>
                </c:pt>
                <c:pt idx="201">
                  <c:v>0.11799999999999999</c:v>
                </c:pt>
                <c:pt idx="202">
                  <c:v>0.12</c:v>
                </c:pt>
                <c:pt idx="203">
                  <c:v>0.122</c:v>
                </c:pt>
                <c:pt idx="204">
                  <c:v>0.125</c:v>
                </c:pt>
                <c:pt idx="205">
                  <c:v>0.128</c:v>
                </c:pt>
                <c:pt idx="206">
                  <c:v>0.13</c:v>
                </c:pt>
                <c:pt idx="207">
                  <c:v>0.13400000000000001</c:v>
                </c:pt>
                <c:pt idx="208">
                  <c:v>0.13800000000000001</c:v>
                </c:pt>
                <c:pt idx="209">
                  <c:v>0.14299999999999999</c:v>
                </c:pt>
                <c:pt idx="210">
                  <c:v>0.14899999999999999</c:v>
                </c:pt>
                <c:pt idx="211">
                  <c:v>0.157</c:v>
                </c:pt>
                <c:pt idx="212">
                  <c:v>0.16500000000000001</c:v>
                </c:pt>
                <c:pt idx="213">
                  <c:v>0.17599999999999999</c:v>
                </c:pt>
                <c:pt idx="214">
                  <c:v>0.188</c:v>
                </c:pt>
                <c:pt idx="215">
                  <c:v>0.20300000000000001</c:v>
                </c:pt>
                <c:pt idx="216">
                  <c:v>0.22</c:v>
                </c:pt>
                <c:pt idx="217">
                  <c:v>0.24</c:v>
                </c:pt>
                <c:pt idx="218">
                  <c:v>0.26300000000000001</c:v>
                </c:pt>
                <c:pt idx="219">
                  <c:v>0.28999999999999998</c:v>
                </c:pt>
                <c:pt idx="220">
                  <c:v>0.318</c:v>
                </c:pt>
                <c:pt idx="221">
                  <c:v>0.35199999999999998</c:v>
                </c:pt>
                <c:pt idx="222">
                  <c:v>0.38500000000000001</c:v>
                </c:pt>
                <c:pt idx="223">
                  <c:v>0.42</c:v>
                </c:pt>
                <c:pt idx="224">
                  <c:v>0.45500000000000002</c:v>
                </c:pt>
                <c:pt idx="225">
                  <c:v>0.49</c:v>
                </c:pt>
                <c:pt idx="226">
                  <c:v>0.52300000000000002</c:v>
                </c:pt>
                <c:pt idx="227">
                  <c:v>0.55400000000000005</c:v>
                </c:pt>
                <c:pt idx="228">
                  <c:v>0.58199999999999996</c:v>
                </c:pt>
                <c:pt idx="229">
                  <c:v>0.60499999999999998</c:v>
                </c:pt>
                <c:pt idx="230">
                  <c:v>0.624</c:v>
                </c:pt>
                <c:pt idx="231">
                  <c:v>0.63800000000000001</c:v>
                </c:pt>
                <c:pt idx="232">
                  <c:v>0.64800000000000002</c:v>
                </c:pt>
                <c:pt idx="233">
                  <c:v>0.65300000000000002</c:v>
                </c:pt>
                <c:pt idx="234">
                  <c:v>0.65600000000000003</c:v>
                </c:pt>
                <c:pt idx="235">
                  <c:v>0.65600000000000003</c:v>
                </c:pt>
                <c:pt idx="236">
                  <c:v>0.65500000000000003</c:v>
                </c:pt>
                <c:pt idx="237">
                  <c:v>0.65500000000000003</c:v>
                </c:pt>
                <c:pt idx="238">
                  <c:v>0.65700000000000003</c:v>
                </c:pt>
                <c:pt idx="239">
                  <c:v>0.66100000000000003</c:v>
                </c:pt>
                <c:pt idx="240">
                  <c:v>0.66900000000000004</c:v>
                </c:pt>
                <c:pt idx="241">
                  <c:v>0.68200000000000005</c:v>
                </c:pt>
                <c:pt idx="242">
                  <c:v>0.7</c:v>
                </c:pt>
                <c:pt idx="243">
                  <c:v>0.72399999999999998</c:v>
                </c:pt>
                <c:pt idx="244">
                  <c:v>0.753</c:v>
                </c:pt>
                <c:pt idx="245">
                  <c:v>0.78900000000000003</c:v>
                </c:pt>
                <c:pt idx="246">
                  <c:v>0.83</c:v>
                </c:pt>
                <c:pt idx="247">
                  <c:v>0.877</c:v>
                </c:pt>
                <c:pt idx="248">
                  <c:v>0.92500000000000004</c:v>
                </c:pt>
                <c:pt idx="249">
                  <c:v>0.97199999999999998</c:v>
                </c:pt>
                <c:pt idx="250">
                  <c:v>1.016</c:v>
                </c:pt>
                <c:pt idx="251">
                  <c:v>1.056</c:v>
                </c:pt>
                <c:pt idx="252">
                  <c:v>1.0880000000000001</c:v>
                </c:pt>
                <c:pt idx="253">
                  <c:v>1.1100000000000001</c:v>
                </c:pt>
                <c:pt idx="254">
                  <c:v>1.1240000000000001</c:v>
                </c:pt>
                <c:pt idx="255">
                  <c:v>1.127</c:v>
                </c:pt>
                <c:pt idx="256">
                  <c:v>1.123</c:v>
                </c:pt>
                <c:pt idx="257">
                  <c:v>1.111</c:v>
                </c:pt>
                <c:pt idx="258">
                  <c:v>1.093</c:v>
                </c:pt>
                <c:pt idx="259">
                  <c:v>1.0720000000000001</c:v>
                </c:pt>
                <c:pt idx="260">
                  <c:v>1.05</c:v>
                </c:pt>
                <c:pt idx="261">
                  <c:v>1.0289999999999999</c:v>
                </c:pt>
                <c:pt idx="262">
                  <c:v>1.0109999999999999</c:v>
                </c:pt>
                <c:pt idx="263">
                  <c:v>0.996</c:v>
                </c:pt>
                <c:pt idx="264">
                  <c:v>0.98699999999999999</c:v>
                </c:pt>
                <c:pt idx="265">
                  <c:v>0.98499999999999999</c:v>
                </c:pt>
                <c:pt idx="266">
                  <c:v>0.98899999999999999</c:v>
                </c:pt>
                <c:pt idx="267">
                  <c:v>1.0009999999999999</c:v>
                </c:pt>
                <c:pt idx="268">
                  <c:v>1.02</c:v>
                </c:pt>
                <c:pt idx="269">
                  <c:v>1.044</c:v>
                </c:pt>
                <c:pt idx="270">
                  <c:v>1.0720000000000001</c:v>
                </c:pt>
                <c:pt idx="271">
                  <c:v>1.101</c:v>
                </c:pt>
                <c:pt idx="272">
                  <c:v>1.127</c:v>
                </c:pt>
                <c:pt idx="273">
                  <c:v>1.1479999999999999</c:v>
                </c:pt>
                <c:pt idx="274">
                  <c:v>1.161</c:v>
                </c:pt>
                <c:pt idx="275">
                  <c:v>1.165</c:v>
                </c:pt>
                <c:pt idx="276">
                  <c:v>1.1599999999999999</c:v>
                </c:pt>
                <c:pt idx="277">
                  <c:v>1.1459999999999999</c:v>
                </c:pt>
                <c:pt idx="278">
                  <c:v>1.1240000000000001</c:v>
                </c:pt>
                <c:pt idx="279">
                  <c:v>1.095</c:v>
                </c:pt>
                <c:pt idx="280">
                  <c:v>1.0629999999999999</c:v>
                </c:pt>
                <c:pt idx="281">
                  <c:v>1.026</c:v>
                </c:pt>
                <c:pt idx="282">
                  <c:v>0.99199999999999999</c:v>
                </c:pt>
                <c:pt idx="283">
                  <c:v>0.96</c:v>
                </c:pt>
                <c:pt idx="284">
                  <c:v>0.93200000000000005</c:v>
                </c:pt>
                <c:pt idx="285">
                  <c:v>0.90800000000000003</c:v>
                </c:pt>
                <c:pt idx="286">
                  <c:v>0.89100000000000001</c:v>
                </c:pt>
                <c:pt idx="287">
                  <c:v>0.879</c:v>
                </c:pt>
                <c:pt idx="288">
                  <c:v>0.874</c:v>
                </c:pt>
                <c:pt idx="289">
                  <c:v>0.874</c:v>
                </c:pt>
                <c:pt idx="290">
                  <c:v>0.878</c:v>
                </c:pt>
                <c:pt idx="291">
                  <c:v>0.88400000000000001</c:v>
                </c:pt>
                <c:pt idx="292">
                  <c:v>0.89</c:v>
                </c:pt>
                <c:pt idx="293">
                  <c:v>0.89300000000000002</c:v>
                </c:pt>
                <c:pt idx="294">
                  <c:v>0.89</c:v>
                </c:pt>
                <c:pt idx="295">
                  <c:v>0.88100000000000001</c:v>
                </c:pt>
                <c:pt idx="296">
                  <c:v>0.86499999999999999</c:v>
                </c:pt>
                <c:pt idx="297">
                  <c:v>0.84299999999999997</c:v>
                </c:pt>
                <c:pt idx="298">
                  <c:v>0.81599999999999995</c:v>
                </c:pt>
                <c:pt idx="299">
                  <c:v>0.78400000000000003</c:v>
                </c:pt>
                <c:pt idx="300">
                  <c:v>0.751</c:v>
                </c:pt>
                <c:pt idx="301">
                  <c:v>0.71799999999999997</c:v>
                </c:pt>
                <c:pt idx="302">
                  <c:v>0.68700000000000006</c:v>
                </c:pt>
                <c:pt idx="303">
                  <c:v>0.65700000000000003</c:v>
                </c:pt>
                <c:pt idx="304">
                  <c:v>0.63200000000000001</c:v>
                </c:pt>
                <c:pt idx="305">
                  <c:v>0.61</c:v>
                </c:pt>
                <c:pt idx="306">
                  <c:v>0.59299999999999997</c:v>
                </c:pt>
                <c:pt idx="307">
                  <c:v>0.57999999999999996</c:v>
                </c:pt>
                <c:pt idx="308">
                  <c:v>0.56999999999999995</c:v>
                </c:pt>
                <c:pt idx="309">
                  <c:v>0.56299999999999994</c:v>
                </c:pt>
                <c:pt idx="310">
                  <c:v>0.55700000000000005</c:v>
                </c:pt>
                <c:pt idx="311">
                  <c:v>0.55100000000000005</c:v>
                </c:pt>
                <c:pt idx="312">
                  <c:v>0.54300000000000004</c:v>
                </c:pt>
                <c:pt idx="313">
                  <c:v>0.53300000000000003</c:v>
                </c:pt>
                <c:pt idx="314">
                  <c:v>0.51900000000000002</c:v>
                </c:pt>
                <c:pt idx="315">
                  <c:v>0.502</c:v>
                </c:pt>
                <c:pt idx="316">
                  <c:v>0.48099999999999998</c:v>
                </c:pt>
                <c:pt idx="317">
                  <c:v>0.45900000000000002</c:v>
                </c:pt>
                <c:pt idx="318">
                  <c:v>0.436</c:v>
                </c:pt>
                <c:pt idx="319">
                  <c:v>0.41199999999999998</c:v>
                </c:pt>
                <c:pt idx="320">
                  <c:v>0.39</c:v>
                </c:pt>
                <c:pt idx="321">
                  <c:v>0.371</c:v>
                </c:pt>
                <c:pt idx="322">
                  <c:v>0.35299999999999998</c:v>
                </c:pt>
                <c:pt idx="323">
                  <c:v>0.33800000000000002</c:v>
                </c:pt>
                <c:pt idx="324">
                  <c:v>0.32500000000000001</c:v>
                </c:pt>
                <c:pt idx="325">
                  <c:v>0.315</c:v>
                </c:pt>
                <c:pt idx="326">
                  <c:v>0.30599999999999999</c:v>
                </c:pt>
                <c:pt idx="327">
                  <c:v>0.29799999999999999</c:v>
                </c:pt>
                <c:pt idx="328">
                  <c:v>0.29099999999999998</c:v>
                </c:pt>
                <c:pt idx="329">
                  <c:v>0.28399999999999997</c:v>
                </c:pt>
                <c:pt idx="330">
                  <c:v>0.27600000000000002</c:v>
                </c:pt>
                <c:pt idx="331">
                  <c:v>0.26600000000000001</c:v>
                </c:pt>
                <c:pt idx="332">
                  <c:v>0.255</c:v>
                </c:pt>
                <c:pt idx="333">
                  <c:v>0.24299999999999999</c:v>
                </c:pt>
                <c:pt idx="334">
                  <c:v>0.23</c:v>
                </c:pt>
                <c:pt idx="335">
                  <c:v>0.216</c:v>
                </c:pt>
                <c:pt idx="336">
                  <c:v>0.20399999999999999</c:v>
                </c:pt>
                <c:pt idx="337">
                  <c:v>0.192</c:v>
                </c:pt>
                <c:pt idx="338">
                  <c:v>0.18099999999999999</c:v>
                </c:pt>
                <c:pt idx="339">
                  <c:v>0.17199999999999999</c:v>
                </c:pt>
                <c:pt idx="340">
                  <c:v>0.16400000000000001</c:v>
                </c:pt>
                <c:pt idx="341">
                  <c:v>0.158</c:v>
                </c:pt>
                <c:pt idx="342">
                  <c:v>0.152</c:v>
                </c:pt>
                <c:pt idx="343">
                  <c:v>0.14699999999999999</c:v>
                </c:pt>
                <c:pt idx="344">
                  <c:v>0.14299999999999999</c:v>
                </c:pt>
                <c:pt idx="345">
                  <c:v>0.13800000000000001</c:v>
                </c:pt>
                <c:pt idx="346">
                  <c:v>0.13300000000000001</c:v>
                </c:pt>
                <c:pt idx="347">
                  <c:v>0.128</c:v>
                </c:pt>
                <c:pt idx="348">
                  <c:v>0.122</c:v>
                </c:pt>
                <c:pt idx="349">
                  <c:v>0.11600000000000001</c:v>
                </c:pt>
                <c:pt idx="350">
                  <c:v>0.11</c:v>
                </c:pt>
                <c:pt idx="351">
                  <c:v>0.104</c:v>
                </c:pt>
                <c:pt idx="352">
                  <c:v>9.9000000000000005E-2</c:v>
                </c:pt>
                <c:pt idx="353">
                  <c:v>9.2999999999999999E-2</c:v>
                </c:pt>
                <c:pt idx="354">
                  <c:v>8.8999999999999996E-2</c:v>
                </c:pt>
                <c:pt idx="355">
                  <c:v>8.5000000000000006E-2</c:v>
                </c:pt>
                <c:pt idx="356">
                  <c:v>8.2000000000000003E-2</c:v>
                </c:pt>
                <c:pt idx="357">
                  <c:v>7.9000000000000001E-2</c:v>
                </c:pt>
                <c:pt idx="358">
                  <c:v>7.5999999999999998E-2</c:v>
                </c:pt>
                <c:pt idx="359">
                  <c:v>7.3999999999999996E-2</c:v>
                </c:pt>
                <c:pt idx="360">
                  <c:v>7.1999999999999995E-2</c:v>
                </c:pt>
                <c:pt idx="361">
                  <c:v>6.9000000000000006E-2</c:v>
                </c:pt>
                <c:pt idx="362">
                  <c:v>6.7000000000000004E-2</c:v>
                </c:pt>
                <c:pt idx="363">
                  <c:v>6.5000000000000002E-2</c:v>
                </c:pt>
                <c:pt idx="364">
                  <c:v>6.2E-2</c:v>
                </c:pt>
                <c:pt idx="365">
                  <c:v>0.06</c:v>
                </c:pt>
                <c:pt idx="366">
                  <c:v>5.8000000000000003E-2</c:v>
                </c:pt>
                <c:pt idx="367">
                  <c:v>5.6000000000000001E-2</c:v>
                </c:pt>
                <c:pt idx="368">
                  <c:v>5.3999999999999999E-2</c:v>
                </c:pt>
                <c:pt idx="369">
                  <c:v>5.2999999999999999E-2</c:v>
                </c:pt>
                <c:pt idx="370">
                  <c:v>5.0999999999999997E-2</c:v>
                </c:pt>
                <c:pt idx="371">
                  <c:v>0.05</c:v>
                </c:pt>
                <c:pt idx="372">
                  <c:v>4.9000000000000002E-2</c:v>
                </c:pt>
                <c:pt idx="373">
                  <c:v>4.9000000000000002E-2</c:v>
                </c:pt>
                <c:pt idx="374">
                  <c:v>4.8000000000000001E-2</c:v>
                </c:pt>
                <c:pt idx="375">
                  <c:v>4.7E-2</c:v>
                </c:pt>
                <c:pt idx="376">
                  <c:v>4.7E-2</c:v>
                </c:pt>
                <c:pt idx="377">
                  <c:v>4.5999999999999999E-2</c:v>
                </c:pt>
                <c:pt idx="378">
                  <c:v>4.5999999999999999E-2</c:v>
                </c:pt>
                <c:pt idx="379">
                  <c:v>4.4999999999999998E-2</c:v>
                </c:pt>
                <c:pt idx="380">
                  <c:v>4.4999999999999998E-2</c:v>
                </c:pt>
                <c:pt idx="381">
                  <c:v>4.4999999999999998E-2</c:v>
                </c:pt>
                <c:pt idx="382">
                  <c:v>4.4999999999999998E-2</c:v>
                </c:pt>
                <c:pt idx="383">
                  <c:v>4.5999999999999999E-2</c:v>
                </c:pt>
                <c:pt idx="384">
                  <c:v>4.5999999999999999E-2</c:v>
                </c:pt>
                <c:pt idx="385">
                  <c:v>4.7E-2</c:v>
                </c:pt>
                <c:pt idx="386">
                  <c:v>4.8000000000000001E-2</c:v>
                </c:pt>
                <c:pt idx="387">
                  <c:v>4.9000000000000002E-2</c:v>
                </c:pt>
                <c:pt idx="388">
                  <c:v>0.05</c:v>
                </c:pt>
                <c:pt idx="389">
                  <c:v>5.1999999999999998E-2</c:v>
                </c:pt>
                <c:pt idx="390">
                  <c:v>5.2999999999999999E-2</c:v>
                </c:pt>
                <c:pt idx="391">
                  <c:v>5.5E-2</c:v>
                </c:pt>
                <c:pt idx="392">
                  <c:v>5.7000000000000002E-2</c:v>
                </c:pt>
                <c:pt idx="393">
                  <c:v>0.06</c:v>
                </c:pt>
                <c:pt idx="394">
                  <c:v>6.3E-2</c:v>
                </c:pt>
                <c:pt idx="395">
                  <c:v>6.6000000000000003E-2</c:v>
                </c:pt>
                <c:pt idx="396">
                  <c:v>6.9000000000000006E-2</c:v>
                </c:pt>
                <c:pt idx="397">
                  <c:v>7.3999999999999996E-2</c:v>
                </c:pt>
                <c:pt idx="398">
                  <c:v>7.8E-2</c:v>
                </c:pt>
                <c:pt idx="399">
                  <c:v>8.2000000000000003E-2</c:v>
                </c:pt>
                <c:pt idx="400">
                  <c:v>8.6999999999999994E-2</c:v>
                </c:pt>
                <c:pt idx="401">
                  <c:v>9.1999999999999998E-2</c:v>
                </c:pt>
                <c:pt idx="402">
                  <c:v>9.8000000000000004E-2</c:v>
                </c:pt>
                <c:pt idx="403">
                  <c:v>0.104</c:v>
                </c:pt>
                <c:pt idx="404">
                  <c:v>0.109</c:v>
                </c:pt>
                <c:pt idx="405">
                  <c:v>0.11600000000000001</c:v>
                </c:pt>
                <c:pt idx="406">
                  <c:v>0.123</c:v>
                </c:pt>
                <c:pt idx="407">
                  <c:v>0.13</c:v>
                </c:pt>
                <c:pt idx="408">
                  <c:v>0.13700000000000001</c:v>
                </c:pt>
                <c:pt idx="409">
                  <c:v>0.14499999999999999</c:v>
                </c:pt>
                <c:pt idx="410">
                  <c:v>0.154</c:v>
                </c:pt>
                <c:pt idx="411">
                  <c:v>0.16300000000000001</c:v>
                </c:pt>
                <c:pt idx="412">
                  <c:v>0.17299999999999999</c:v>
                </c:pt>
                <c:pt idx="413">
                  <c:v>0.183</c:v>
                </c:pt>
                <c:pt idx="414">
                  <c:v>0.19400000000000001</c:v>
                </c:pt>
                <c:pt idx="415">
                  <c:v>0.20499999999999999</c:v>
                </c:pt>
                <c:pt idx="416">
                  <c:v>0.216</c:v>
                </c:pt>
                <c:pt idx="417">
                  <c:v>0.22700000000000001</c:v>
                </c:pt>
                <c:pt idx="418">
                  <c:v>0.23899999999999999</c:v>
                </c:pt>
                <c:pt idx="419">
                  <c:v>0.25</c:v>
                </c:pt>
                <c:pt idx="420">
                  <c:v>0.26200000000000001</c:v>
                </c:pt>
                <c:pt idx="421">
                  <c:v>0.27</c:v>
                </c:pt>
                <c:pt idx="422">
                  <c:v>0.28499999999999998</c:v>
                </c:pt>
                <c:pt idx="423">
                  <c:v>0.29799999999999999</c:v>
                </c:pt>
                <c:pt idx="424">
                  <c:v>0.311</c:v>
                </c:pt>
                <c:pt idx="425">
                  <c:v>0.32500000000000001</c:v>
                </c:pt>
                <c:pt idx="426">
                  <c:v>0.33800000000000002</c:v>
                </c:pt>
                <c:pt idx="427">
                  <c:v>0.35099999999999998</c:v>
                </c:pt>
                <c:pt idx="428">
                  <c:v>0.36399999999999999</c:v>
                </c:pt>
                <c:pt idx="429">
                  <c:v>0.377</c:v>
                </c:pt>
                <c:pt idx="430">
                  <c:v>0.39</c:v>
                </c:pt>
                <c:pt idx="431">
                  <c:v>0.40300000000000002</c:v>
                </c:pt>
                <c:pt idx="432">
                  <c:v>0.41699999999999998</c:v>
                </c:pt>
                <c:pt idx="433">
                  <c:v>0.43099999999999999</c:v>
                </c:pt>
                <c:pt idx="434">
                  <c:v>0.44500000000000001</c:v>
                </c:pt>
                <c:pt idx="435">
                  <c:v>0.45800000000000002</c:v>
                </c:pt>
                <c:pt idx="436">
                  <c:v>0.47199999999999998</c:v>
                </c:pt>
                <c:pt idx="437">
                  <c:v>0.48399999999999999</c:v>
                </c:pt>
                <c:pt idx="438">
                  <c:v>0.496</c:v>
                </c:pt>
                <c:pt idx="439">
                  <c:v>0.50700000000000001</c:v>
                </c:pt>
                <c:pt idx="440">
                  <c:v>0.51800000000000002</c:v>
                </c:pt>
                <c:pt idx="441">
                  <c:v>0.52900000000000003</c:v>
                </c:pt>
                <c:pt idx="442">
                  <c:v>0.54100000000000004</c:v>
                </c:pt>
                <c:pt idx="443">
                  <c:v>0.55100000000000005</c:v>
                </c:pt>
                <c:pt idx="444">
                  <c:v>0.56100000000000005</c:v>
                </c:pt>
                <c:pt idx="445">
                  <c:v>0.57099999999999995</c:v>
                </c:pt>
                <c:pt idx="446">
                  <c:v>0.57899999999999996</c:v>
                </c:pt>
                <c:pt idx="447">
                  <c:v>0.58599999999999997</c:v>
                </c:pt>
                <c:pt idx="448">
                  <c:v>0.59399999999999997</c:v>
                </c:pt>
                <c:pt idx="449">
                  <c:v>0.60099999999999998</c:v>
                </c:pt>
                <c:pt idx="450">
                  <c:v>0.60699999999999998</c:v>
                </c:pt>
                <c:pt idx="451">
                  <c:v>0.61299999999999999</c:v>
                </c:pt>
                <c:pt idx="452">
                  <c:v>0.61899999999999999</c:v>
                </c:pt>
                <c:pt idx="453">
                  <c:v>0.625</c:v>
                </c:pt>
                <c:pt idx="454">
                  <c:v>0.63100000000000001</c:v>
                </c:pt>
                <c:pt idx="455">
                  <c:v>0.63300000000000001</c:v>
                </c:pt>
                <c:pt idx="456">
                  <c:v>0.63700000000000001</c:v>
                </c:pt>
                <c:pt idx="457">
                  <c:v>0.64</c:v>
                </c:pt>
                <c:pt idx="458">
                  <c:v>0.64</c:v>
                </c:pt>
                <c:pt idx="459">
                  <c:v>0.64300000000000002</c:v>
                </c:pt>
                <c:pt idx="460">
                  <c:v>0.64600000000000002</c:v>
                </c:pt>
                <c:pt idx="461">
                  <c:v>0.65200000000000002</c:v>
                </c:pt>
                <c:pt idx="462">
                  <c:v>0.66</c:v>
                </c:pt>
                <c:pt idx="463">
                  <c:v>0.66500000000000004</c:v>
                </c:pt>
                <c:pt idx="464">
                  <c:v>0.67100000000000004</c:v>
                </c:pt>
                <c:pt idx="465">
                  <c:v>0.67700000000000005</c:v>
                </c:pt>
                <c:pt idx="466">
                  <c:v>0.68300000000000005</c:v>
                </c:pt>
                <c:pt idx="467">
                  <c:v>0.68799999999999994</c:v>
                </c:pt>
                <c:pt idx="468">
                  <c:v>0.69</c:v>
                </c:pt>
                <c:pt idx="469">
                  <c:v>0.69299999999999995</c:v>
                </c:pt>
                <c:pt idx="470">
                  <c:v>0.69799999999999995</c:v>
                </c:pt>
                <c:pt idx="471">
                  <c:v>0.70599999999999996</c:v>
                </c:pt>
                <c:pt idx="472">
                  <c:v>0.71899999999999997</c:v>
                </c:pt>
                <c:pt idx="473">
                  <c:v>0.73399999999999999</c:v>
                </c:pt>
                <c:pt idx="474">
                  <c:v>0.748</c:v>
                </c:pt>
                <c:pt idx="475">
                  <c:v>0.75700000000000001</c:v>
                </c:pt>
                <c:pt idx="476">
                  <c:v>0.76</c:v>
                </c:pt>
                <c:pt idx="477">
                  <c:v>0.76100000000000001</c:v>
                </c:pt>
                <c:pt idx="478">
                  <c:v>0.76400000000000001</c:v>
                </c:pt>
                <c:pt idx="479">
                  <c:v>0.77400000000000002</c:v>
                </c:pt>
                <c:pt idx="480">
                  <c:v>0.79100000000000004</c:v>
                </c:pt>
                <c:pt idx="481">
                  <c:v>0.80900000000000005</c:v>
                </c:pt>
                <c:pt idx="482">
                  <c:v>0.82499999999999996</c:v>
                </c:pt>
                <c:pt idx="483">
                  <c:v>0.83199999999999996</c:v>
                </c:pt>
                <c:pt idx="484">
                  <c:v>0.83099999999999996</c:v>
                </c:pt>
                <c:pt idx="485">
                  <c:v>0.82699999999999996</c:v>
                </c:pt>
                <c:pt idx="486">
                  <c:v>0.82599999999999996</c:v>
                </c:pt>
                <c:pt idx="487">
                  <c:v>0.83199999999999996</c:v>
                </c:pt>
                <c:pt idx="488">
                  <c:v>0.84299999999999997</c:v>
                </c:pt>
                <c:pt idx="489">
                  <c:v>0.85699999999999998</c:v>
                </c:pt>
                <c:pt idx="490">
                  <c:v>0.86299999999999999</c:v>
                </c:pt>
                <c:pt idx="491">
                  <c:v>0.86</c:v>
                </c:pt>
                <c:pt idx="492">
                  <c:v>0.84799999999999998</c:v>
                </c:pt>
                <c:pt idx="493">
                  <c:v>0.83599999999999997</c:v>
                </c:pt>
                <c:pt idx="494">
                  <c:v>0.82799999999999996</c:v>
                </c:pt>
                <c:pt idx="495">
                  <c:v>0.82599999999999996</c:v>
                </c:pt>
                <c:pt idx="496">
                  <c:v>0.82399999999999995</c:v>
                </c:pt>
                <c:pt idx="497">
                  <c:v>0.81799999999999995</c:v>
                </c:pt>
                <c:pt idx="498">
                  <c:v>0.80200000000000005</c:v>
                </c:pt>
                <c:pt idx="499">
                  <c:v>0.77800000000000002</c:v>
                </c:pt>
                <c:pt idx="500">
                  <c:v>0.75600000000000001</c:v>
                </c:pt>
                <c:pt idx="501">
                  <c:v>0.73699999999999999</c:v>
                </c:pt>
                <c:pt idx="502">
                  <c:v>0.72099999999999997</c:v>
                </c:pt>
                <c:pt idx="503">
                  <c:v>0.70499999999999996</c:v>
                </c:pt>
                <c:pt idx="504">
                  <c:v>0.68500000000000005</c:v>
                </c:pt>
                <c:pt idx="505">
                  <c:v>0.65900000000000003</c:v>
                </c:pt>
                <c:pt idx="506">
                  <c:v>0.63</c:v>
                </c:pt>
                <c:pt idx="507">
                  <c:v>0.60199999999999998</c:v>
                </c:pt>
                <c:pt idx="508">
                  <c:v>0.57599999999999996</c:v>
                </c:pt>
                <c:pt idx="509">
                  <c:v>0.55300000000000005</c:v>
                </c:pt>
                <c:pt idx="510">
                  <c:v>0.52800000000000002</c:v>
                </c:pt>
                <c:pt idx="511">
                  <c:v>0.501</c:v>
                </c:pt>
                <c:pt idx="512">
                  <c:v>0.47099999999999997</c:v>
                </c:pt>
                <c:pt idx="513">
                  <c:v>0.44400000000000001</c:v>
                </c:pt>
                <c:pt idx="514">
                  <c:v>0.41899999999999998</c:v>
                </c:pt>
                <c:pt idx="515">
                  <c:v>0.39700000000000002</c:v>
                </c:pt>
                <c:pt idx="516">
                  <c:v>0.375</c:v>
                </c:pt>
                <c:pt idx="517">
                  <c:v>0.35199999999999998</c:v>
                </c:pt>
                <c:pt idx="518">
                  <c:v>0.32900000000000001</c:v>
                </c:pt>
                <c:pt idx="519">
                  <c:v>0.309</c:v>
                </c:pt>
                <c:pt idx="520">
                  <c:v>0.29199999999999998</c:v>
                </c:pt>
                <c:pt idx="521">
                  <c:v>0.27600000000000002</c:v>
                </c:pt>
                <c:pt idx="522">
                  <c:v>0.26200000000000001</c:v>
                </c:pt>
                <c:pt idx="523">
                  <c:v>0.249</c:v>
                </c:pt>
                <c:pt idx="524">
                  <c:v>0.23599999999999999</c:v>
                </c:pt>
                <c:pt idx="525">
                  <c:v>0.22500000000000001</c:v>
                </c:pt>
                <c:pt idx="526">
                  <c:v>0.217</c:v>
                </c:pt>
                <c:pt idx="527">
                  <c:v>0.21099999999999999</c:v>
                </c:pt>
                <c:pt idx="528">
                  <c:v>0.20499999999999999</c:v>
                </c:pt>
                <c:pt idx="529">
                  <c:v>0.20100000000000001</c:v>
                </c:pt>
                <c:pt idx="530">
                  <c:v>0.19800000000000001</c:v>
                </c:pt>
                <c:pt idx="531">
                  <c:v>0.19800000000000001</c:v>
                </c:pt>
                <c:pt idx="532">
                  <c:v>0.19900000000000001</c:v>
                </c:pt>
                <c:pt idx="533">
                  <c:v>0.20100000000000001</c:v>
                </c:pt>
                <c:pt idx="534">
                  <c:v>0.20499999999999999</c:v>
                </c:pt>
                <c:pt idx="535">
                  <c:v>0.21</c:v>
                </c:pt>
                <c:pt idx="536">
                  <c:v>0.216</c:v>
                </c:pt>
                <c:pt idx="537">
                  <c:v>0.224</c:v>
                </c:pt>
                <c:pt idx="538">
                  <c:v>0.23300000000000001</c:v>
                </c:pt>
                <c:pt idx="539">
                  <c:v>0.24299999999999999</c:v>
                </c:pt>
                <c:pt idx="540">
                  <c:v>0.254</c:v>
                </c:pt>
                <c:pt idx="541">
                  <c:v>0.26600000000000001</c:v>
                </c:pt>
                <c:pt idx="542">
                  <c:v>0.28000000000000003</c:v>
                </c:pt>
                <c:pt idx="543">
                  <c:v>0.29399999999999998</c:v>
                </c:pt>
                <c:pt idx="544">
                  <c:v>0.309</c:v>
                </c:pt>
                <c:pt idx="545">
                  <c:v>0.32400000000000001</c:v>
                </c:pt>
                <c:pt idx="546">
                  <c:v>0.34100000000000003</c:v>
                </c:pt>
                <c:pt idx="547">
                  <c:v>0.35899999999999999</c:v>
                </c:pt>
                <c:pt idx="548">
                  <c:v>0.378</c:v>
                </c:pt>
                <c:pt idx="549">
                  <c:v>0.39700000000000002</c:v>
                </c:pt>
                <c:pt idx="550">
                  <c:v>0.41799999999999998</c:v>
                </c:pt>
                <c:pt idx="551">
                  <c:v>0.439</c:v>
                </c:pt>
                <c:pt idx="552">
                  <c:v>0.46100000000000002</c:v>
                </c:pt>
                <c:pt idx="553">
                  <c:v>0.48399999999999999</c:v>
                </c:pt>
                <c:pt idx="554">
                  <c:v>0.50700000000000001</c:v>
                </c:pt>
                <c:pt idx="555">
                  <c:v>0.53100000000000003</c:v>
                </c:pt>
                <c:pt idx="556">
                  <c:v>0.55500000000000005</c:v>
                </c:pt>
                <c:pt idx="557">
                  <c:v>0.57799999999999996</c:v>
                </c:pt>
                <c:pt idx="558">
                  <c:v>0.60199999999999998</c:v>
                </c:pt>
                <c:pt idx="559">
                  <c:v>0.628</c:v>
                </c:pt>
                <c:pt idx="560">
                  <c:v>0.65</c:v>
                </c:pt>
                <c:pt idx="561">
                  <c:v>0.67200000000000004</c:v>
                </c:pt>
                <c:pt idx="562">
                  <c:v>0.69299999999999995</c:v>
                </c:pt>
                <c:pt idx="563">
                  <c:v>0.71299999999999997</c:v>
                </c:pt>
                <c:pt idx="564">
                  <c:v>0.73299999999999998</c:v>
                </c:pt>
                <c:pt idx="565">
                  <c:v>0.751</c:v>
                </c:pt>
                <c:pt idx="566">
                  <c:v>0.76800000000000002</c:v>
                </c:pt>
                <c:pt idx="567">
                  <c:v>0.78500000000000003</c:v>
                </c:pt>
                <c:pt idx="568">
                  <c:v>0.8</c:v>
                </c:pt>
                <c:pt idx="569">
                  <c:v>0.81499999999999995</c:v>
                </c:pt>
                <c:pt idx="570">
                  <c:v>0.83</c:v>
                </c:pt>
                <c:pt idx="571">
                  <c:v>0.84299999999999997</c:v>
                </c:pt>
                <c:pt idx="572">
                  <c:v>0.85499999999999998</c:v>
                </c:pt>
                <c:pt idx="573">
                  <c:v>0.86599999999999999</c:v>
                </c:pt>
                <c:pt idx="574">
                  <c:v>0.877</c:v>
                </c:pt>
                <c:pt idx="575">
                  <c:v>0.88800000000000001</c:v>
                </c:pt>
                <c:pt idx="576">
                  <c:v>0.89900000000000002</c:v>
                </c:pt>
                <c:pt idx="577">
                  <c:v>0.91</c:v>
                </c:pt>
                <c:pt idx="578">
                  <c:v>0.92100000000000004</c:v>
                </c:pt>
                <c:pt idx="579">
                  <c:v>0.93300000000000005</c:v>
                </c:pt>
                <c:pt idx="580">
                  <c:v>0.94699999999999995</c:v>
                </c:pt>
                <c:pt idx="581">
                  <c:v>0.96099999999999997</c:v>
                </c:pt>
                <c:pt idx="582">
                  <c:v>0.97799999999999998</c:v>
                </c:pt>
                <c:pt idx="583">
                  <c:v>0.998</c:v>
                </c:pt>
                <c:pt idx="584">
                  <c:v>1.02</c:v>
                </c:pt>
                <c:pt idx="585">
                  <c:v>1.0469999999999999</c:v>
                </c:pt>
                <c:pt idx="586">
                  <c:v>1.0780000000000001</c:v>
                </c:pt>
                <c:pt idx="587">
                  <c:v>1.119</c:v>
                </c:pt>
                <c:pt idx="588">
                  <c:v>1.1639999999999999</c:v>
                </c:pt>
                <c:pt idx="589">
                  <c:v>1.2190000000000001</c:v>
                </c:pt>
                <c:pt idx="590">
                  <c:v>1.286</c:v>
                </c:pt>
                <c:pt idx="591">
                  <c:v>1.3660000000000001</c:v>
                </c:pt>
                <c:pt idx="592">
                  <c:v>1.4630000000000001</c:v>
                </c:pt>
                <c:pt idx="593">
                  <c:v>1.581</c:v>
                </c:pt>
                <c:pt idx="594">
                  <c:v>1.7210000000000001</c:v>
                </c:pt>
                <c:pt idx="595">
                  <c:v>1.877</c:v>
                </c:pt>
                <c:pt idx="596">
                  <c:v>2.0510000000000002</c:v>
                </c:pt>
                <c:pt idx="597">
                  <c:v>2.2130000000000001</c:v>
                </c:pt>
                <c:pt idx="598">
                  <c:v>2.3490000000000002</c:v>
                </c:pt>
                <c:pt idx="599">
                  <c:v>2.4460000000000002</c:v>
                </c:pt>
                <c:pt idx="600">
                  <c:v>2.4809999999999999</c:v>
                </c:pt>
                <c:pt idx="601">
                  <c:v>2.4990000000000001</c:v>
                </c:pt>
                <c:pt idx="602">
                  <c:v>2.4969999999999999</c:v>
                </c:pt>
                <c:pt idx="603">
                  <c:v>2.4820000000000002</c:v>
                </c:pt>
                <c:pt idx="604">
                  <c:v>2.4780000000000002</c:v>
                </c:pt>
                <c:pt idx="605">
                  <c:v>2.4670000000000001</c:v>
                </c:pt>
                <c:pt idx="606">
                  <c:v>2.4500000000000002</c:v>
                </c:pt>
                <c:pt idx="607">
                  <c:v>2.4380000000000002</c:v>
                </c:pt>
                <c:pt idx="608">
                  <c:v>2.4060000000000001</c:v>
                </c:pt>
                <c:pt idx="609">
                  <c:v>2.4020000000000001</c:v>
                </c:pt>
                <c:pt idx="610">
                  <c:v>2.3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18C9-4E99-A1AE-ACBC1A0BA61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0.25 mM</c:v>
                </c:pt>
              </c:strCache>
            </c:strRef>
          </c:tx>
          <c:spPr>
            <a:ln>
              <a:prstDash val="sysDash"/>
            </a:ln>
          </c:spPr>
          <c:marker>
            <c:symbol val="none"/>
          </c:marker>
          <c:xVal>
            <c:numRef>
              <c:f>Sheet1!$A$2:$A$612</c:f>
              <c:numCache>
                <c:formatCode>General</c:formatCode>
                <c:ptCount val="61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  <c:pt idx="601">
                  <c:v>199</c:v>
                </c:pt>
                <c:pt idx="602">
                  <c:v>198</c:v>
                </c:pt>
                <c:pt idx="603">
                  <c:v>197</c:v>
                </c:pt>
                <c:pt idx="604">
                  <c:v>196</c:v>
                </c:pt>
                <c:pt idx="605">
                  <c:v>195</c:v>
                </c:pt>
                <c:pt idx="606">
                  <c:v>194</c:v>
                </c:pt>
                <c:pt idx="607">
                  <c:v>193</c:v>
                </c:pt>
                <c:pt idx="608">
                  <c:v>192</c:v>
                </c:pt>
                <c:pt idx="609">
                  <c:v>191</c:v>
                </c:pt>
                <c:pt idx="610">
                  <c:v>190</c:v>
                </c:pt>
              </c:numCache>
            </c:numRef>
          </c:xVal>
          <c:yVal>
            <c:numRef>
              <c:f>Sheet1!$D$2:$D$612</c:f>
              <c:numCache>
                <c:formatCode>General</c:formatCode>
                <c:ptCount val="6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1E-3</c:v>
                </c:pt>
                <c:pt idx="17">
                  <c:v>1E-3</c:v>
                </c:pt>
                <c:pt idx="18">
                  <c:v>0</c:v>
                </c:pt>
                <c:pt idx="19">
                  <c:v>1E-3</c:v>
                </c:pt>
                <c:pt idx="20">
                  <c:v>1E-3</c:v>
                </c:pt>
                <c:pt idx="21">
                  <c:v>1E-3</c:v>
                </c:pt>
                <c:pt idx="22">
                  <c:v>1E-3</c:v>
                </c:pt>
                <c:pt idx="23">
                  <c:v>1E-3</c:v>
                </c:pt>
                <c:pt idx="24">
                  <c:v>1E-3</c:v>
                </c:pt>
                <c:pt idx="25">
                  <c:v>1E-3</c:v>
                </c:pt>
                <c:pt idx="26">
                  <c:v>1E-3</c:v>
                </c:pt>
                <c:pt idx="27">
                  <c:v>1E-3</c:v>
                </c:pt>
                <c:pt idx="28">
                  <c:v>1E-3</c:v>
                </c:pt>
                <c:pt idx="29">
                  <c:v>1E-3</c:v>
                </c:pt>
                <c:pt idx="30">
                  <c:v>1E-3</c:v>
                </c:pt>
                <c:pt idx="31">
                  <c:v>1E-3</c:v>
                </c:pt>
                <c:pt idx="32">
                  <c:v>1E-3</c:v>
                </c:pt>
                <c:pt idx="33">
                  <c:v>1E-3</c:v>
                </c:pt>
                <c:pt idx="34">
                  <c:v>1E-3</c:v>
                </c:pt>
                <c:pt idx="35">
                  <c:v>1E-3</c:v>
                </c:pt>
                <c:pt idx="36">
                  <c:v>1E-3</c:v>
                </c:pt>
                <c:pt idx="37">
                  <c:v>1E-3</c:v>
                </c:pt>
                <c:pt idx="38">
                  <c:v>1E-3</c:v>
                </c:pt>
                <c:pt idx="39">
                  <c:v>1E-3</c:v>
                </c:pt>
                <c:pt idx="40">
                  <c:v>1E-3</c:v>
                </c:pt>
                <c:pt idx="41">
                  <c:v>1E-3</c:v>
                </c:pt>
                <c:pt idx="42">
                  <c:v>1E-3</c:v>
                </c:pt>
                <c:pt idx="43">
                  <c:v>1E-3</c:v>
                </c:pt>
                <c:pt idx="44">
                  <c:v>1E-3</c:v>
                </c:pt>
                <c:pt idx="45">
                  <c:v>1E-3</c:v>
                </c:pt>
                <c:pt idx="46">
                  <c:v>2E-3</c:v>
                </c:pt>
                <c:pt idx="47">
                  <c:v>2E-3</c:v>
                </c:pt>
                <c:pt idx="48">
                  <c:v>2E-3</c:v>
                </c:pt>
                <c:pt idx="49">
                  <c:v>2E-3</c:v>
                </c:pt>
                <c:pt idx="50">
                  <c:v>2E-3</c:v>
                </c:pt>
                <c:pt idx="51">
                  <c:v>2E-3</c:v>
                </c:pt>
                <c:pt idx="52">
                  <c:v>2E-3</c:v>
                </c:pt>
                <c:pt idx="53">
                  <c:v>2E-3</c:v>
                </c:pt>
                <c:pt idx="54">
                  <c:v>2E-3</c:v>
                </c:pt>
                <c:pt idx="55">
                  <c:v>2E-3</c:v>
                </c:pt>
                <c:pt idx="56">
                  <c:v>2E-3</c:v>
                </c:pt>
                <c:pt idx="57">
                  <c:v>2E-3</c:v>
                </c:pt>
                <c:pt idx="58">
                  <c:v>3.0000000000000001E-3</c:v>
                </c:pt>
                <c:pt idx="59">
                  <c:v>3.0000000000000001E-3</c:v>
                </c:pt>
                <c:pt idx="60">
                  <c:v>3.0000000000000001E-3</c:v>
                </c:pt>
                <c:pt idx="61">
                  <c:v>3.0000000000000001E-3</c:v>
                </c:pt>
                <c:pt idx="62">
                  <c:v>3.0000000000000001E-3</c:v>
                </c:pt>
                <c:pt idx="63">
                  <c:v>3.0000000000000001E-3</c:v>
                </c:pt>
                <c:pt idx="64">
                  <c:v>3.0000000000000001E-3</c:v>
                </c:pt>
                <c:pt idx="65">
                  <c:v>4.0000000000000001E-3</c:v>
                </c:pt>
                <c:pt idx="66">
                  <c:v>4.0000000000000001E-3</c:v>
                </c:pt>
                <c:pt idx="67">
                  <c:v>4.0000000000000001E-3</c:v>
                </c:pt>
                <c:pt idx="68">
                  <c:v>4.0000000000000001E-3</c:v>
                </c:pt>
                <c:pt idx="69">
                  <c:v>4.0000000000000001E-3</c:v>
                </c:pt>
                <c:pt idx="70">
                  <c:v>4.0000000000000001E-3</c:v>
                </c:pt>
                <c:pt idx="71">
                  <c:v>4.0000000000000001E-3</c:v>
                </c:pt>
                <c:pt idx="72">
                  <c:v>5.0000000000000001E-3</c:v>
                </c:pt>
                <c:pt idx="73">
                  <c:v>5.0000000000000001E-3</c:v>
                </c:pt>
                <c:pt idx="74">
                  <c:v>5.0000000000000001E-3</c:v>
                </c:pt>
                <c:pt idx="75">
                  <c:v>5.0000000000000001E-3</c:v>
                </c:pt>
                <c:pt idx="76">
                  <c:v>5.0000000000000001E-3</c:v>
                </c:pt>
                <c:pt idx="77">
                  <c:v>5.0000000000000001E-3</c:v>
                </c:pt>
                <c:pt idx="78">
                  <c:v>5.0000000000000001E-3</c:v>
                </c:pt>
                <c:pt idx="79">
                  <c:v>6.0000000000000001E-3</c:v>
                </c:pt>
                <c:pt idx="80">
                  <c:v>6.0000000000000001E-3</c:v>
                </c:pt>
                <c:pt idx="81">
                  <c:v>6.0000000000000001E-3</c:v>
                </c:pt>
                <c:pt idx="82">
                  <c:v>6.0000000000000001E-3</c:v>
                </c:pt>
                <c:pt idx="83">
                  <c:v>6.0000000000000001E-3</c:v>
                </c:pt>
                <c:pt idx="84">
                  <c:v>7.0000000000000001E-3</c:v>
                </c:pt>
                <c:pt idx="85">
                  <c:v>7.0000000000000001E-3</c:v>
                </c:pt>
                <c:pt idx="86">
                  <c:v>7.0000000000000001E-3</c:v>
                </c:pt>
                <c:pt idx="87">
                  <c:v>7.0000000000000001E-3</c:v>
                </c:pt>
                <c:pt idx="88">
                  <c:v>7.0000000000000001E-3</c:v>
                </c:pt>
                <c:pt idx="89">
                  <c:v>8.0000000000000002E-3</c:v>
                </c:pt>
                <c:pt idx="90">
                  <c:v>8.0000000000000002E-3</c:v>
                </c:pt>
                <c:pt idx="91">
                  <c:v>8.0000000000000002E-3</c:v>
                </c:pt>
                <c:pt idx="92">
                  <c:v>8.0000000000000002E-3</c:v>
                </c:pt>
                <c:pt idx="93">
                  <c:v>8.9999999999999993E-3</c:v>
                </c:pt>
                <c:pt idx="94">
                  <c:v>8.9999999999999993E-3</c:v>
                </c:pt>
                <c:pt idx="95">
                  <c:v>8.9999999999999993E-3</c:v>
                </c:pt>
                <c:pt idx="96">
                  <c:v>8.9999999999999993E-3</c:v>
                </c:pt>
                <c:pt idx="97">
                  <c:v>0.01</c:v>
                </c:pt>
                <c:pt idx="98">
                  <c:v>0.01</c:v>
                </c:pt>
                <c:pt idx="99">
                  <c:v>0.01</c:v>
                </c:pt>
                <c:pt idx="100">
                  <c:v>1.0999999999999999E-2</c:v>
                </c:pt>
                <c:pt idx="101">
                  <c:v>1.0999999999999999E-2</c:v>
                </c:pt>
                <c:pt idx="102">
                  <c:v>1.0999999999999999E-2</c:v>
                </c:pt>
                <c:pt idx="103">
                  <c:v>1.2E-2</c:v>
                </c:pt>
                <c:pt idx="104">
                  <c:v>1.2E-2</c:v>
                </c:pt>
                <c:pt idx="105">
                  <c:v>1.2E-2</c:v>
                </c:pt>
                <c:pt idx="106">
                  <c:v>1.2999999999999999E-2</c:v>
                </c:pt>
                <c:pt idx="107">
                  <c:v>1.2999999999999999E-2</c:v>
                </c:pt>
                <c:pt idx="108">
                  <c:v>1.4E-2</c:v>
                </c:pt>
                <c:pt idx="109">
                  <c:v>1.4E-2</c:v>
                </c:pt>
                <c:pt idx="110">
                  <c:v>1.4E-2</c:v>
                </c:pt>
                <c:pt idx="111">
                  <c:v>1.4999999999999999E-2</c:v>
                </c:pt>
                <c:pt idx="112">
                  <c:v>1.4999999999999999E-2</c:v>
                </c:pt>
                <c:pt idx="113">
                  <c:v>1.6E-2</c:v>
                </c:pt>
                <c:pt idx="114">
                  <c:v>1.6E-2</c:v>
                </c:pt>
                <c:pt idx="115">
                  <c:v>1.7000000000000001E-2</c:v>
                </c:pt>
                <c:pt idx="116">
                  <c:v>1.7000000000000001E-2</c:v>
                </c:pt>
                <c:pt idx="117">
                  <c:v>1.7999999999999999E-2</c:v>
                </c:pt>
                <c:pt idx="118">
                  <c:v>1.7999999999999999E-2</c:v>
                </c:pt>
                <c:pt idx="119">
                  <c:v>1.7999999999999999E-2</c:v>
                </c:pt>
                <c:pt idx="120">
                  <c:v>1.9E-2</c:v>
                </c:pt>
                <c:pt idx="121">
                  <c:v>1.9E-2</c:v>
                </c:pt>
                <c:pt idx="122">
                  <c:v>0.02</c:v>
                </c:pt>
                <c:pt idx="123">
                  <c:v>0.02</c:v>
                </c:pt>
                <c:pt idx="124">
                  <c:v>2.1000000000000001E-2</c:v>
                </c:pt>
                <c:pt idx="125">
                  <c:v>2.1000000000000001E-2</c:v>
                </c:pt>
                <c:pt idx="126">
                  <c:v>2.1000000000000001E-2</c:v>
                </c:pt>
                <c:pt idx="127">
                  <c:v>2.1999999999999999E-2</c:v>
                </c:pt>
                <c:pt idx="128">
                  <c:v>2.1999999999999999E-2</c:v>
                </c:pt>
                <c:pt idx="129">
                  <c:v>2.3E-2</c:v>
                </c:pt>
                <c:pt idx="130">
                  <c:v>2.3E-2</c:v>
                </c:pt>
                <c:pt idx="131">
                  <c:v>2.4E-2</c:v>
                </c:pt>
                <c:pt idx="132">
                  <c:v>2.4E-2</c:v>
                </c:pt>
                <c:pt idx="133">
                  <c:v>2.5000000000000001E-2</c:v>
                </c:pt>
                <c:pt idx="134">
                  <c:v>2.5000000000000001E-2</c:v>
                </c:pt>
                <c:pt idx="135">
                  <c:v>2.5999999999999999E-2</c:v>
                </c:pt>
                <c:pt idx="136">
                  <c:v>2.5999999999999999E-2</c:v>
                </c:pt>
                <c:pt idx="137">
                  <c:v>2.7E-2</c:v>
                </c:pt>
                <c:pt idx="138">
                  <c:v>2.7E-2</c:v>
                </c:pt>
                <c:pt idx="139">
                  <c:v>2.8000000000000001E-2</c:v>
                </c:pt>
                <c:pt idx="140">
                  <c:v>2.8000000000000001E-2</c:v>
                </c:pt>
                <c:pt idx="141">
                  <c:v>2.9000000000000001E-2</c:v>
                </c:pt>
                <c:pt idx="142">
                  <c:v>2.9000000000000001E-2</c:v>
                </c:pt>
                <c:pt idx="143">
                  <c:v>0.03</c:v>
                </c:pt>
                <c:pt idx="144">
                  <c:v>0.03</c:v>
                </c:pt>
                <c:pt idx="145">
                  <c:v>3.1E-2</c:v>
                </c:pt>
                <c:pt idx="146">
                  <c:v>3.1E-2</c:v>
                </c:pt>
                <c:pt idx="147">
                  <c:v>3.2000000000000001E-2</c:v>
                </c:pt>
                <c:pt idx="148">
                  <c:v>3.2000000000000001E-2</c:v>
                </c:pt>
                <c:pt idx="149">
                  <c:v>3.3000000000000002E-2</c:v>
                </c:pt>
                <c:pt idx="150">
                  <c:v>3.3000000000000002E-2</c:v>
                </c:pt>
                <c:pt idx="151">
                  <c:v>3.4000000000000002E-2</c:v>
                </c:pt>
                <c:pt idx="152">
                  <c:v>3.4000000000000002E-2</c:v>
                </c:pt>
                <c:pt idx="153">
                  <c:v>3.5000000000000003E-2</c:v>
                </c:pt>
                <c:pt idx="154">
                  <c:v>3.5000000000000003E-2</c:v>
                </c:pt>
                <c:pt idx="155">
                  <c:v>3.5999999999999997E-2</c:v>
                </c:pt>
                <c:pt idx="156">
                  <c:v>3.5999999999999997E-2</c:v>
                </c:pt>
                <c:pt idx="157">
                  <c:v>3.6999999999999998E-2</c:v>
                </c:pt>
                <c:pt idx="158">
                  <c:v>3.6999999999999998E-2</c:v>
                </c:pt>
                <c:pt idx="159">
                  <c:v>3.6999999999999998E-2</c:v>
                </c:pt>
                <c:pt idx="160">
                  <c:v>3.7999999999999999E-2</c:v>
                </c:pt>
                <c:pt idx="161">
                  <c:v>3.7999999999999999E-2</c:v>
                </c:pt>
                <c:pt idx="162">
                  <c:v>3.9E-2</c:v>
                </c:pt>
                <c:pt idx="163">
                  <c:v>3.9E-2</c:v>
                </c:pt>
                <c:pt idx="164">
                  <c:v>3.9E-2</c:v>
                </c:pt>
                <c:pt idx="165">
                  <c:v>0.04</c:v>
                </c:pt>
                <c:pt idx="166">
                  <c:v>0.04</c:v>
                </c:pt>
                <c:pt idx="167">
                  <c:v>4.1000000000000002E-2</c:v>
                </c:pt>
                <c:pt idx="168">
                  <c:v>4.1000000000000002E-2</c:v>
                </c:pt>
                <c:pt idx="169">
                  <c:v>4.1000000000000002E-2</c:v>
                </c:pt>
                <c:pt idx="170">
                  <c:v>4.2000000000000003E-2</c:v>
                </c:pt>
                <c:pt idx="171">
                  <c:v>4.2000000000000003E-2</c:v>
                </c:pt>
                <c:pt idx="172">
                  <c:v>4.2000000000000003E-2</c:v>
                </c:pt>
                <c:pt idx="173">
                  <c:v>4.2999999999999997E-2</c:v>
                </c:pt>
                <c:pt idx="174">
                  <c:v>4.2999999999999997E-2</c:v>
                </c:pt>
                <c:pt idx="175">
                  <c:v>4.2999999999999997E-2</c:v>
                </c:pt>
                <c:pt idx="176">
                  <c:v>4.3999999999999997E-2</c:v>
                </c:pt>
                <c:pt idx="177">
                  <c:v>4.3999999999999997E-2</c:v>
                </c:pt>
                <c:pt idx="178">
                  <c:v>4.3999999999999997E-2</c:v>
                </c:pt>
                <c:pt idx="179">
                  <c:v>4.4999999999999998E-2</c:v>
                </c:pt>
                <c:pt idx="180">
                  <c:v>4.4999999999999998E-2</c:v>
                </c:pt>
                <c:pt idx="181">
                  <c:v>4.4999999999999998E-2</c:v>
                </c:pt>
                <c:pt idx="182">
                  <c:v>4.5999999999999999E-2</c:v>
                </c:pt>
                <c:pt idx="183">
                  <c:v>4.5999999999999999E-2</c:v>
                </c:pt>
                <c:pt idx="184">
                  <c:v>4.7E-2</c:v>
                </c:pt>
                <c:pt idx="185">
                  <c:v>4.7E-2</c:v>
                </c:pt>
                <c:pt idx="186">
                  <c:v>4.7E-2</c:v>
                </c:pt>
                <c:pt idx="187">
                  <c:v>4.8000000000000001E-2</c:v>
                </c:pt>
                <c:pt idx="188">
                  <c:v>4.9000000000000002E-2</c:v>
                </c:pt>
                <c:pt idx="189">
                  <c:v>4.9000000000000002E-2</c:v>
                </c:pt>
                <c:pt idx="190">
                  <c:v>0.05</c:v>
                </c:pt>
                <c:pt idx="191">
                  <c:v>0.05</c:v>
                </c:pt>
                <c:pt idx="192">
                  <c:v>5.0999999999999997E-2</c:v>
                </c:pt>
                <c:pt idx="193">
                  <c:v>5.1999999999999998E-2</c:v>
                </c:pt>
                <c:pt idx="194">
                  <c:v>5.2999999999999999E-2</c:v>
                </c:pt>
                <c:pt idx="195">
                  <c:v>5.3999999999999999E-2</c:v>
                </c:pt>
                <c:pt idx="196">
                  <c:v>5.3999999999999999E-2</c:v>
                </c:pt>
                <c:pt idx="197">
                  <c:v>5.5E-2</c:v>
                </c:pt>
                <c:pt idx="198">
                  <c:v>5.6000000000000001E-2</c:v>
                </c:pt>
                <c:pt idx="199">
                  <c:v>5.7000000000000002E-2</c:v>
                </c:pt>
                <c:pt idx="200">
                  <c:v>5.8000000000000003E-2</c:v>
                </c:pt>
                <c:pt idx="201">
                  <c:v>5.8999999999999997E-2</c:v>
                </c:pt>
                <c:pt idx="202">
                  <c:v>0.06</c:v>
                </c:pt>
                <c:pt idx="203">
                  <c:v>6.0999999999999999E-2</c:v>
                </c:pt>
                <c:pt idx="204">
                  <c:v>6.2E-2</c:v>
                </c:pt>
                <c:pt idx="205">
                  <c:v>6.3E-2</c:v>
                </c:pt>
                <c:pt idx="206">
                  <c:v>6.5000000000000002E-2</c:v>
                </c:pt>
                <c:pt idx="207">
                  <c:v>6.6000000000000003E-2</c:v>
                </c:pt>
                <c:pt idx="208">
                  <c:v>6.9000000000000006E-2</c:v>
                </c:pt>
                <c:pt idx="209">
                  <c:v>7.0999999999999994E-2</c:v>
                </c:pt>
                <c:pt idx="210">
                  <c:v>7.3999999999999996E-2</c:v>
                </c:pt>
                <c:pt idx="211">
                  <c:v>7.8E-2</c:v>
                </c:pt>
                <c:pt idx="212">
                  <c:v>8.2000000000000003E-2</c:v>
                </c:pt>
                <c:pt idx="213">
                  <c:v>8.6999999999999994E-2</c:v>
                </c:pt>
                <c:pt idx="214">
                  <c:v>9.2999999999999999E-2</c:v>
                </c:pt>
                <c:pt idx="215">
                  <c:v>0.10100000000000001</c:v>
                </c:pt>
                <c:pt idx="216">
                  <c:v>0.109</c:v>
                </c:pt>
                <c:pt idx="217">
                  <c:v>0.11899999999999999</c:v>
                </c:pt>
                <c:pt idx="218">
                  <c:v>0.13100000000000001</c:v>
                </c:pt>
                <c:pt idx="219">
                  <c:v>0.14499999999999999</c:v>
                </c:pt>
                <c:pt idx="220">
                  <c:v>0.159</c:v>
                </c:pt>
                <c:pt idx="221">
                  <c:v>0.17499999999999999</c:v>
                </c:pt>
                <c:pt idx="222">
                  <c:v>0.192</c:v>
                </c:pt>
                <c:pt idx="223">
                  <c:v>0.20899999999999999</c:v>
                </c:pt>
                <c:pt idx="224">
                  <c:v>0.22600000000000001</c:v>
                </c:pt>
                <c:pt idx="225">
                  <c:v>0.24399999999999999</c:v>
                </c:pt>
                <c:pt idx="226">
                  <c:v>0.26</c:v>
                </c:pt>
                <c:pt idx="227">
                  <c:v>0.27600000000000002</c:v>
                </c:pt>
                <c:pt idx="228">
                  <c:v>0.28999999999999998</c:v>
                </c:pt>
                <c:pt idx="229">
                  <c:v>0.30099999999999999</c:v>
                </c:pt>
                <c:pt idx="230">
                  <c:v>0.311</c:v>
                </c:pt>
                <c:pt idx="231">
                  <c:v>0.318</c:v>
                </c:pt>
                <c:pt idx="232">
                  <c:v>0.32300000000000001</c:v>
                </c:pt>
                <c:pt idx="233">
                  <c:v>0.32600000000000001</c:v>
                </c:pt>
                <c:pt idx="234">
                  <c:v>0.32700000000000001</c:v>
                </c:pt>
                <c:pt idx="235">
                  <c:v>0.32700000000000001</c:v>
                </c:pt>
                <c:pt idx="236">
                  <c:v>0.32700000000000001</c:v>
                </c:pt>
                <c:pt idx="237">
                  <c:v>0.32700000000000001</c:v>
                </c:pt>
                <c:pt idx="238">
                  <c:v>0.32700000000000001</c:v>
                </c:pt>
                <c:pt idx="239">
                  <c:v>0.33</c:v>
                </c:pt>
                <c:pt idx="240">
                  <c:v>0.33400000000000002</c:v>
                </c:pt>
                <c:pt idx="241">
                  <c:v>0.34</c:v>
                </c:pt>
                <c:pt idx="242">
                  <c:v>0.34899999999999998</c:v>
                </c:pt>
                <c:pt idx="243">
                  <c:v>0.36099999999999999</c:v>
                </c:pt>
                <c:pt idx="244">
                  <c:v>0.377</c:v>
                </c:pt>
                <c:pt idx="245">
                  <c:v>0.39500000000000002</c:v>
                </c:pt>
                <c:pt idx="246">
                  <c:v>0.41599999999999998</c:v>
                </c:pt>
                <c:pt idx="247">
                  <c:v>0.439</c:v>
                </c:pt>
                <c:pt idx="248">
                  <c:v>0.46300000000000002</c:v>
                </c:pt>
                <c:pt idx="249">
                  <c:v>0.48799999999999999</c:v>
                </c:pt>
                <c:pt idx="250">
                  <c:v>0.51200000000000001</c:v>
                </c:pt>
                <c:pt idx="251">
                  <c:v>0.53300000000000003</c:v>
                </c:pt>
                <c:pt idx="252">
                  <c:v>0.55000000000000004</c:v>
                </c:pt>
                <c:pt idx="253">
                  <c:v>0.56299999999999994</c:v>
                </c:pt>
                <c:pt idx="254">
                  <c:v>0.56999999999999995</c:v>
                </c:pt>
                <c:pt idx="255">
                  <c:v>0.57199999999999995</c:v>
                </c:pt>
                <c:pt idx="256">
                  <c:v>0.56999999999999995</c:v>
                </c:pt>
                <c:pt idx="257">
                  <c:v>0.56299999999999994</c:v>
                </c:pt>
                <c:pt idx="258">
                  <c:v>0.55400000000000005</c:v>
                </c:pt>
                <c:pt idx="259">
                  <c:v>0.54300000000000004</c:v>
                </c:pt>
                <c:pt idx="260">
                  <c:v>0.53100000000000003</c:v>
                </c:pt>
                <c:pt idx="261">
                  <c:v>0.52</c:v>
                </c:pt>
                <c:pt idx="262">
                  <c:v>0.51</c:v>
                </c:pt>
                <c:pt idx="263">
                  <c:v>0.503</c:v>
                </c:pt>
                <c:pt idx="264">
                  <c:v>0.498</c:v>
                </c:pt>
                <c:pt idx="265">
                  <c:v>0.496</c:v>
                </c:pt>
                <c:pt idx="266">
                  <c:v>0.499</c:v>
                </c:pt>
                <c:pt idx="267">
                  <c:v>0.505</c:v>
                </c:pt>
                <c:pt idx="268">
                  <c:v>0.51500000000000001</c:v>
                </c:pt>
                <c:pt idx="269">
                  <c:v>0.52800000000000002</c:v>
                </c:pt>
                <c:pt idx="270">
                  <c:v>0.54300000000000004</c:v>
                </c:pt>
                <c:pt idx="271">
                  <c:v>0.55900000000000005</c:v>
                </c:pt>
                <c:pt idx="272">
                  <c:v>0.57299999999999995</c:v>
                </c:pt>
                <c:pt idx="273">
                  <c:v>0.58399999999999996</c:v>
                </c:pt>
                <c:pt idx="274">
                  <c:v>0.59199999999999997</c:v>
                </c:pt>
                <c:pt idx="275">
                  <c:v>0.59399999999999997</c:v>
                </c:pt>
                <c:pt idx="276">
                  <c:v>0.59099999999999997</c:v>
                </c:pt>
                <c:pt idx="277">
                  <c:v>0.58399999999999996</c:v>
                </c:pt>
                <c:pt idx="278">
                  <c:v>0.57099999999999995</c:v>
                </c:pt>
                <c:pt idx="279">
                  <c:v>0.55600000000000005</c:v>
                </c:pt>
                <c:pt idx="280">
                  <c:v>0.53900000000000003</c:v>
                </c:pt>
                <c:pt idx="281">
                  <c:v>0.51900000000000002</c:v>
                </c:pt>
                <c:pt idx="282">
                  <c:v>0.501</c:v>
                </c:pt>
                <c:pt idx="283">
                  <c:v>0.48399999999999999</c:v>
                </c:pt>
                <c:pt idx="284">
                  <c:v>0.47</c:v>
                </c:pt>
                <c:pt idx="285">
                  <c:v>0.45800000000000002</c:v>
                </c:pt>
                <c:pt idx="286">
                  <c:v>0.44800000000000001</c:v>
                </c:pt>
                <c:pt idx="287">
                  <c:v>0.442</c:v>
                </c:pt>
                <c:pt idx="288">
                  <c:v>0.44</c:v>
                </c:pt>
                <c:pt idx="289">
                  <c:v>0.44</c:v>
                </c:pt>
                <c:pt idx="290">
                  <c:v>0.442</c:v>
                </c:pt>
                <c:pt idx="291">
                  <c:v>0.44500000000000001</c:v>
                </c:pt>
                <c:pt idx="292">
                  <c:v>0.44800000000000001</c:v>
                </c:pt>
                <c:pt idx="293">
                  <c:v>0.45</c:v>
                </c:pt>
                <c:pt idx="294">
                  <c:v>0.44900000000000001</c:v>
                </c:pt>
                <c:pt idx="295">
                  <c:v>0.44400000000000001</c:v>
                </c:pt>
                <c:pt idx="296">
                  <c:v>0.436</c:v>
                </c:pt>
                <c:pt idx="297">
                  <c:v>0.42499999999999999</c:v>
                </c:pt>
                <c:pt idx="298">
                  <c:v>0.41</c:v>
                </c:pt>
                <c:pt idx="299">
                  <c:v>0.39400000000000002</c:v>
                </c:pt>
                <c:pt idx="300">
                  <c:v>0.378</c:v>
                </c:pt>
                <c:pt idx="301">
                  <c:v>0.36099999999999999</c:v>
                </c:pt>
                <c:pt idx="302">
                  <c:v>0.34499999999999997</c:v>
                </c:pt>
                <c:pt idx="303">
                  <c:v>0.33</c:v>
                </c:pt>
                <c:pt idx="304">
                  <c:v>0.317</c:v>
                </c:pt>
                <c:pt idx="305">
                  <c:v>0.30599999999999999</c:v>
                </c:pt>
                <c:pt idx="306">
                  <c:v>0.29799999999999999</c:v>
                </c:pt>
                <c:pt idx="307">
                  <c:v>0.29099999999999998</c:v>
                </c:pt>
                <c:pt idx="308">
                  <c:v>0.28599999999999998</c:v>
                </c:pt>
                <c:pt idx="309">
                  <c:v>0.28299999999999997</c:v>
                </c:pt>
                <c:pt idx="310">
                  <c:v>0.28000000000000003</c:v>
                </c:pt>
                <c:pt idx="311">
                  <c:v>0.27700000000000002</c:v>
                </c:pt>
                <c:pt idx="312">
                  <c:v>0.27300000000000002</c:v>
                </c:pt>
                <c:pt idx="313">
                  <c:v>0.26800000000000002</c:v>
                </c:pt>
                <c:pt idx="314">
                  <c:v>0.26100000000000001</c:v>
                </c:pt>
                <c:pt idx="315">
                  <c:v>0.252</c:v>
                </c:pt>
                <c:pt idx="316">
                  <c:v>0.24199999999999999</c:v>
                </c:pt>
                <c:pt idx="317">
                  <c:v>0.23100000000000001</c:v>
                </c:pt>
                <c:pt idx="318">
                  <c:v>0.219</c:v>
                </c:pt>
                <c:pt idx="319">
                  <c:v>0.20799999999999999</c:v>
                </c:pt>
                <c:pt idx="320">
                  <c:v>0.19700000000000001</c:v>
                </c:pt>
                <c:pt idx="321">
                  <c:v>0.187</c:v>
                </c:pt>
                <c:pt idx="322">
                  <c:v>0.17899999999999999</c:v>
                </c:pt>
                <c:pt idx="323">
                  <c:v>0.17100000000000001</c:v>
                </c:pt>
                <c:pt idx="324">
                  <c:v>0.16500000000000001</c:v>
                </c:pt>
                <c:pt idx="325">
                  <c:v>0.16</c:v>
                </c:pt>
                <c:pt idx="326">
                  <c:v>0.155</c:v>
                </c:pt>
                <c:pt idx="327">
                  <c:v>0.152</c:v>
                </c:pt>
                <c:pt idx="328">
                  <c:v>0.14899999999999999</c:v>
                </c:pt>
                <c:pt idx="329">
                  <c:v>0.14499999999999999</c:v>
                </c:pt>
                <c:pt idx="330">
                  <c:v>0.14099999999999999</c:v>
                </c:pt>
                <c:pt idx="331">
                  <c:v>0.13600000000000001</c:v>
                </c:pt>
                <c:pt idx="332">
                  <c:v>0.13100000000000001</c:v>
                </c:pt>
                <c:pt idx="333">
                  <c:v>0.125</c:v>
                </c:pt>
                <c:pt idx="334">
                  <c:v>0.11799999999999999</c:v>
                </c:pt>
                <c:pt idx="335">
                  <c:v>0.112</c:v>
                </c:pt>
                <c:pt idx="336">
                  <c:v>0.106</c:v>
                </c:pt>
                <c:pt idx="337">
                  <c:v>0.1</c:v>
                </c:pt>
                <c:pt idx="338">
                  <c:v>9.5000000000000001E-2</c:v>
                </c:pt>
                <c:pt idx="339">
                  <c:v>0.09</c:v>
                </c:pt>
                <c:pt idx="340">
                  <c:v>8.6999999999999994E-2</c:v>
                </c:pt>
                <c:pt idx="341">
                  <c:v>8.4000000000000005E-2</c:v>
                </c:pt>
                <c:pt idx="342">
                  <c:v>8.1000000000000003E-2</c:v>
                </c:pt>
                <c:pt idx="343">
                  <c:v>7.8E-2</c:v>
                </c:pt>
                <c:pt idx="344">
                  <c:v>7.5999999999999998E-2</c:v>
                </c:pt>
                <c:pt idx="345">
                  <c:v>7.3999999999999996E-2</c:v>
                </c:pt>
                <c:pt idx="346">
                  <c:v>7.1999999999999995E-2</c:v>
                </c:pt>
                <c:pt idx="347">
                  <c:v>6.9000000000000006E-2</c:v>
                </c:pt>
                <c:pt idx="348">
                  <c:v>6.6000000000000003E-2</c:v>
                </c:pt>
                <c:pt idx="349">
                  <c:v>6.4000000000000001E-2</c:v>
                </c:pt>
                <c:pt idx="350">
                  <c:v>6.0999999999999999E-2</c:v>
                </c:pt>
                <c:pt idx="351">
                  <c:v>5.8000000000000003E-2</c:v>
                </c:pt>
                <c:pt idx="352">
                  <c:v>5.5E-2</c:v>
                </c:pt>
                <c:pt idx="353">
                  <c:v>5.2999999999999999E-2</c:v>
                </c:pt>
                <c:pt idx="354">
                  <c:v>5.0999999999999997E-2</c:v>
                </c:pt>
                <c:pt idx="355">
                  <c:v>4.9000000000000002E-2</c:v>
                </c:pt>
                <c:pt idx="356">
                  <c:v>4.7E-2</c:v>
                </c:pt>
                <c:pt idx="357">
                  <c:v>4.5999999999999999E-2</c:v>
                </c:pt>
                <c:pt idx="358">
                  <c:v>4.4999999999999998E-2</c:v>
                </c:pt>
                <c:pt idx="359">
                  <c:v>4.3999999999999997E-2</c:v>
                </c:pt>
                <c:pt idx="360">
                  <c:v>4.2999999999999997E-2</c:v>
                </c:pt>
                <c:pt idx="361">
                  <c:v>4.2000000000000003E-2</c:v>
                </c:pt>
                <c:pt idx="362">
                  <c:v>4.1000000000000002E-2</c:v>
                </c:pt>
                <c:pt idx="363">
                  <c:v>3.9E-2</c:v>
                </c:pt>
                <c:pt idx="364">
                  <c:v>3.9E-2</c:v>
                </c:pt>
                <c:pt idx="365">
                  <c:v>3.7999999999999999E-2</c:v>
                </c:pt>
                <c:pt idx="366">
                  <c:v>3.6999999999999998E-2</c:v>
                </c:pt>
                <c:pt idx="367">
                  <c:v>3.5999999999999997E-2</c:v>
                </c:pt>
                <c:pt idx="368">
                  <c:v>3.5000000000000003E-2</c:v>
                </c:pt>
                <c:pt idx="369">
                  <c:v>3.4000000000000002E-2</c:v>
                </c:pt>
                <c:pt idx="370">
                  <c:v>3.4000000000000002E-2</c:v>
                </c:pt>
                <c:pt idx="371">
                  <c:v>3.3000000000000002E-2</c:v>
                </c:pt>
                <c:pt idx="372">
                  <c:v>3.3000000000000002E-2</c:v>
                </c:pt>
                <c:pt idx="373">
                  <c:v>3.3000000000000002E-2</c:v>
                </c:pt>
                <c:pt idx="374">
                  <c:v>3.3000000000000002E-2</c:v>
                </c:pt>
                <c:pt idx="375">
                  <c:v>3.2000000000000001E-2</c:v>
                </c:pt>
                <c:pt idx="376">
                  <c:v>3.2000000000000001E-2</c:v>
                </c:pt>
                <c:pt idx="377">
                  <c:v>3.2000000000000001E-2</c:v>
                </c:pt>
                <c:pt idx="378">
                  <c:v>3.2000000000000001E-2</c:v>
                </c:pt>
                <c:pt idx="379">
                  <c:v>3.2000000000000001E-2</c:v>
                </c:pt>
                <c:pt idx="380">
                  <c:v>3.2000000000000001E-2</c:v>
                </c:pt>
                <c:pt idx="381">
                  <c:v>3.2000000000000001E-2</c:v>
                </c:pt>
                <c:pt idx="382">
                  <c:v>3.2000000000000001E-2</c:v>
                </c:pt>
                <c:pt idx="383">
                  <c:v>3.2000000000000001E-2</c:v>
                </c:pt>
                <c:pt idx="384">
                  <c:v>3.3000000000000002E-2</c:v>
                </c:pt>
                <c:pt idx="385">
                  <c:v>3.3000000000000002E-2</c:v>
                </c:pt>
                <c:pt idx="386">
                  <c:v>3.4000000000000002E-2</c:v>
                </c:pt>
                <c:pt idx="387">
                  <c:v>3.4000000000000002E-2</c:v>
                </c:pt>
                <c:pt idx="388">
                  <c:v>3.5000000000000003E-2</c:v>
                </c:pt>
                <c:pt idx="389">
                  <c:v>3.5999999999999997E-2</c:v>
                </c:pt>
                <c:pt idx="390">
                  <c:v>3.6999999999999998E-2</c:v>
                </c:pt>
                <c:pt idx="391">
                  <c:v>3.7999999999999999E-2</c:v>
                </c:pt>
                <c:pt idx="392">
                  <c:v>3.9E-2</c:v>
                </c:pt>
                <c:pt idx="393">
                  <c:v>0.04</c:v>
                </c:pt>
                <c:pt idx="394">
                  <c:v>4.2000000000000003E-2</c:v>
                </c:pt>
                <c:pt idx="395">
                  <c:v>4.2999999999999997E-2</c:v>
                </c:pt>
                <c:pt idx="396">
                  <c:v>4.4999999999999998E-2</c:v>
                </c:pt>
                <c:pt idx="397">
                  <c:v>4.7E-2</c:v>
                </c:pt>
                <c:pt idx="398">
                  <c:v>4.9000000000000002E-2</c:v>
                </c:pt>
                <c:pt idx="399">
                  <c:v>5.1999999999999998E-2</c:v>
                </c:pt>
                <c:pt idx="400">
                  <c:v>5.3999999999999999E-2</c:v>
                </c:pt>
                <c:pt idx="401">
                  <c:v>5.7000000000000002E-2</c:v>
                </c:pt>
                <c:pt idx="402">
                  <c:v>0.06</c:v>
                </c:pt>
                <c:pt idx="403">
                  <c:v>6.3E-2</c:v>
                </c:pt>
                <c:pt idx="404">
                  <c:v>6.6000000000000003E-2</c:v>
                </c:pt>
                <c:pt idx="405">
                  <c:v>6.9000000000000006E-2</c:v>
                </c:pt>
                <c:pt idx="406">
                  <c:v>7.1999999999999995E-2</c:v>
                </c:pt>
                <c:pt idx="407">
                  <c:v>7.5999999999999998E-2</c:v>
                </c:pt>
                <c:pt idx="408">
                  <c:v>7.9000000000000001E-2</c:v>
                </c:pt>
                <c:pt idx="409">
                  <c:v>8.4000000000000005E-2</c:v>
                </c:pt>
                <c:pt idx="410">
                  <c:v>8.7999999999999995E-2</c:v>
                </c:pt>
                <c:pt idx="411">
                  <c:v>9.2999999999999999E-2</c:v>
                </c:pt>
                <c:pt idx="412">
                  <c:v>9.8000000000000004E-2</c:v>
                </c:pt>
                <c:pt idx="413">
                  <c:v>0.10199999999999999</c:v>
                </c:pt>
                <c:pt idx="414">
                  <c:v>0.108</c:v>
                </c:pt>
                <c:pt idx="415">
                  <c:v>0.113</c:v>
                </c:pt>
                <c:pt idx="416">
                  <c:v>0.11899999999999999</c:v>
                </c:pt>
                <c:pt idx="417">
                  <c:v>0.125</c:v>
                </c:pt>
                <c:pt idx="418">
                  <c:v>0.13</c:v>
                </c:pt>
                <c:pt idx="419">
                  <c:v>0.13600000000000001</c:v>
                </c:pt>
                <c:pt idx="420">
                  <c:v>0.14199999999999999</c:v>
                </c:pt>
                <c:pt idx="421">
                  <c:v>0.14599999999999999</c:v>
                </c:pt>
                <c:pt idx="422">
                  <c:v>0.154</c:v>
                </c:pt>
                <c:pt idx="423">
                  <c:v>0.16</c:v>
                </c:pt>
                <c:pt idx="424">
                  <c:v>0.16700000000000001</c:v>
                </c:pt>
                <c:pt idx="425">
                  <c:v>0.17299999999999999</c:v>
                </c:pt>
                <c:pt idx="426">
                  <c:v>0.18</c:v>
                </c:pt>
                <c:pt idx="427">
                  <c:v>0.187</c:v>
                </c:pt>
                <c:pt idx="428">
                  <c:v>0.192</c:v>
                </c:pt>
                <c:pt idx="429">
                  <c:v>0.19900000000000001</c:v>
                </c:pt>
                <c:pt idx="430">
                  <c:v>0.20599999999999999</c:v>
                </c:pt>
                <c:pt idx="431">
                  <c:v>0.21299999999999999</c:v>
                </c:pt>
                <c:pt idx="432">
                  <c:v>0.219</c:v>
                </c:pt>
                <c:pt idx="433">
                  <c:v>0.22600000000000001</c:v>
                </c:pt>
                <c:pt idx="434">
                  <c:v>0.23300000000000001</c:v>
                </c:pt>
                <c:pt idx="435">
                  <c:v>0.24</c:v>
                </c:pt>
                <c:pt idx="436">
                  <c:v>0.247</c:v>
                </c:pt>
                <c:pt idx="437">
                  <c:v>0.253</c:v>
                </c:pt>
                <c:pt idx="438">
                  <c:v>0.25900000000000001</c:v>
                </c:pt>
                <c:pt idx="439">
                  <c:v>0.26500000000000001</c:v>
                </c:pt>
                <c:pt idx="440">
                  <c:v>0.27100000000000002</c:v>
                </c:pt>
                <c:pt idx="441">
                  <c:v>0.27600000000000002</c:v>
                </c:pt>
                <c:pt idx="442">
                  <c:v>0.28100000000000003</c:v>
                </c:pt>
                <c:pt idx="443">
                  <c:v>0.28599999999999998</c:v>
                </c:pt>
                <c:pt idx="444">
                  <c:v>0.29199999999999998</c:v>
                </c:pt>
                <c:pt idx="445">
                  <c:v>0.29699999999999999</c:v>
                </c:pt>
                <c:pt idx="446">
                  <c:v>0.30099999999999999</c:v>
                </c:pt>
                <c:pt idx="447">
                  <c:v>0.30499999999999999</c:v>
                </c:pt>
                <c:pt idx="448">
                  <c:v>0.308</c:v>
                </c:pt>
                <c:pt idx="449">
                  <c:v>0.311</c:v>
                </c:pt>
                <c:pt idx="450">
                  <c:v>0.315</c:v>
                </c:pt>
                <c:pt idx="451">
                  <c:v>0.318</c:v>
                </c:pt>
                <c:pt idx="452">
                  <c:v>0.32100000000000001</c:v>
                </c:pt>
                <c:pt idx="453">
                  <c:v>0.32400000000000001</c:v>
                </c:pt>
                <c:pt idx="454">
                  <c:v>0.32600000000000001</c:v>
                </c:pt>
                <c:pt idx="455">
                  <c:v>0.32800000000000001</c:v>
                </c:pt>
                <c:pt idx="456">
                  <c:v>0.33</c:v>
                </c:pt>
                <c:pt idx="457">
                  <c:v>0.33</c:v>
                </c:pt>
                <c:pt idx="458">
                  <c:v>0.33200000000000002</c:v>
                </c:pt>
                <c:pt idx="459">
                  <c:v>0.33300000000000002</c:v>
                </c:pt>
                <c:pt idx="460">
                  <c:v>0.33400000000000002</c:v>
                </c:pt>
                <c:pt idx="461">
                  <c:v>0.33700000000000002</c:v>
                </c:pt>
                <c:pt idx="462">
                  <c:v>0.34100000000000003</c:v>
                </c:pt>
                <c:pt idx="463">
                  <c:v>0.34300000000000003</c:v>
                </c:pt>
                <c:pt idx="464">
                  <c:v>0.34599999999999997</c:v>
                </c:pt>
                <c:pt idx="465">
                  <c:v>0.35</c:v>
                </c:pt>
                <c:pt idx="466">
                  <c:v>0.35299999999999998</c:v>
                </c:pt>
                <c:pt idx="467">
                  <c:v>0.35499999999999998</c:v>
                </c:pt>
                <c:pt idx="468">
                  <c:v>0.35599999999999998</c:v>
                </c:pt>
                <c:pt idx="469">
                  <c:v>0.35699999999999998</c:v>
                </c:pt>
                <c:pt idx="470">
                  <c:v>0.35899999999999999</c:v>
                </c:pt>
                <c:pt idx="471">
                  <c:v>0.36399999999999999</c:v>
                </c:pt>
                <c:pt idx="472">
                  <c:v>0.37</c:v>
                </c:pt>
                <c:pt idx="473">
                  <c:v>0.378</c:v>
                </c:pt>
                <c:pt idx="474">
                  <c:v>0.38500000000000001</c:v>
                </c:pt>
                <c:pt idx="475">
                  <c:v>0.38900000000000001</c:v>
                </c:pt>
                <c:pt idx="476">
                  <c:v>0.39100000000000001</c:v>
                </c:pt>
                <c:pt idx="477">
                  <c:v>0.39200000000000002</c:v>
                </c:pt>
                <c:pt idx="478">
                  <c:v>0.39400000000000002</c:v>
                </c:pt>
                <c:pt idx="479">
                  <c:v>0.39900000000000002</c:v>
                </c:pt>
                <c:pt idx="480">
                  <c:v>0.40699999999999997</c:v>
                </c:pt>
                <c:pt idx="481">
                  <c:v>0.41699999999999998</c:v>
                </c:pt>
                <c:pt idx="482">
                  <c:v>0.42399999999999999</c:v>
                </c:pt>
                <c:pt idx="483">
                  <c:v>0.42799999999999999</c:v>
                </c:pt>
                <c:pt idx="484">
                  <c:v>0.42699999999999999</c:v>
                </c:pt>
                <c:pt idx="485">
                  <c:v>0.42499999999999999</c:v>
                </c:pt>
                <c:pt idx="486">
                  <c:v>0.42399999999999999</c:v>
                </c:pt>
                <c:pt idx="487">
                  <c:v>0.42699999999999999</c:v>
                </c:pt>
                <c:pt idx="488">
                  <c:v>0.433</c:v>
                </c:pt>
                <c:pt idx="489">
                  <c:v>0.44</c:v>
                </c:pt>
                <c:pt idx="490">
                  <c:v>0.44400000000000001</c:v>
                </c:pt>
                <c:pt idx="491">
                  <c:v>0.442</c:v>
                </c:pt>
                <c:pt idx="492">
                  <c:v>0.435</c:v>
                </c:pt>
                <c:pt idx="493">
                  <c:v>0.42899999999999999</c:v>
                </c:pt>
                <c:pt idx="494">
                  <c:v>0.42499999999999999</c:v>
                </c:pt>
                <c:pt idx="495">
                  <c:v>0.42399999999999999</c:v>
                </c:pt>
                <c:pt idx="496">
                  <c:v>0.42299999999999999</c:v>
                </c:pt>
                <c:pt idx="497">
                  <c:v>0.41899999999999998</c:v>
                </c:pt>
                <c:pt idx="498">
                  <c:v>0.41099999999999998</c:v>
                </c:pt>
                <c:pt idx="499">
                  <c:v>0.39900000000000002</c:v>
                </c:pt>
                <c:pt idx="500">
                  <c:v>0.38800000000000001</c:v>
                </c:pt>
                <c:pt idx="501">
                  <c:v>0.378</c:v>
                </c:pt>
                <c:pt idx="502">
                  <c:v>0.37</c:v>
                </c:pt>
                <c:pt idx="503">
                  <c:v>0.36199999999999999</c:v>
                </c:pt>
                <c:pt idx="504">
                  <c:v>0.35099999999999998</c:v>
                </c:pt>
                <c:pt idx="505">
                  <c:v>0.33800000000000002</c:v>
                </c:pt>
                <c:pt idx="506">
                  <c:v>0.32300000000000001</c:v>
                </c:pt>
                <c:pt idx="507">
                  <c:v>0.309</c:v>
                </c:pt>
                <c:pt idx="508">
                  <c:v>0.29599999999999999</c:v>
                </c:pt>
                <c:pt idx="509">
                  <c:v>0.28399999999999997</c:v>
                </c:pt>
                <c:pt idx="510">
                  <c:v>0.27100000000000002</c:v>
                </c:pt>
                <c:pt idx="511">
                  <c:v>0.25700000000000001</c:v>
                </c:pt>
                <c:pt idx="512">
                  <c:v>0.24299999999999999</c:v>
                </c:pt>
                <c:pt idx="513">
                  <c:v>0.22900000000000001</c:v>
                </c:pt>
                <c:pt idx="514">
                  <c:v>0.216</c:v>
                </c:pt>
                <c:pt idx="515">
                  <c:v>0.20499999999999999</c:v>
                </c:pt>
                <c:pt idx="516">
                  <c:v>0.19400000000000001</c:v>
                </c:pt>
                <c:pt idx="517">
                  <c:v>0.183</c:v>
                </c:pt>
                <c:pt idx="518">
                  <c:v>0.17100000000000001</c:v>
                </c:pt>
                <c:pt idx="519">
                  <c:v>0.161</c:v>
                </c:pt>
                <c:pt idx="520">
                  <c:v>0.152</c:v>
                </c:pt>
                <c:pt idx="521">
                  <c:v>0.14499999999999999</c:v>
                </c:pt>
                <c:pt idx="522">
                  <c:v>0.13800000000000001</c:v>
                </c:pt>
                <c:pt idx="523">
                  <c:v>0.13100000000000001</c:v>
                </c:pt>
                <c:pt idx="524">
                  <c:v>0.125</c:v>
                </c:pt>
                <c:pt idx="525">
                  <c:v>0.11899999999999999</c:v>
                </c:pt>
                <c:pt idx="526">
                  <c:v>0.115</c:v>
                </c:pt>
                <c:pt idx="527">
                  <c:v>0.112</c:v>
                </c:pt>
                <c:pt idx="528">
                  <c:v>0.109</c:v>
                </c:pt>
                <c:pt idx="529">
                  <c:v>0.107</c:v>
                </c:pt>
                <c:pt idx="530">
                  <c:v>0.106</c:v>
                </c:pt>
                <c:pt idx="531">
                  <c:v>0.105</c:v>
                </c:pt>
                <c:pt idx="532">
                  <c:v>0.105</c:v>
                </c:pt>
                <c:pt idx="533">
                  <c:v>0.107</c:v>
                </c:pt>
                <c:pt idx="534">
                  <c:v>0.108</c:v>
                </c:pt>
                <c:pt idx="535">
                  <c:v>0.111</c:v>
                </c:pt>
                <c:pt idx="536">
                  <c:v>0.114</c:v>
                </c:pt>
                <c:pt idx="537">
                  <c:v>0.11799999999999999</c:v>
                </c:pt>
                <c:pt idx="538">
                  <c:v>0.123</c:v>
                </c:pt>
                <c:pt idx="539">
                  <c:v>0.128</c:v>
                </c:pt>
                <c:pt idx="540">
                  <c:v>0.13300000000000001</c:v>
                </c:pt>
                <c:pt idx="541">
                  <c:v>0.13900000000000001</c:v>
                </c:pt>
                <c:pt idx="542">
                  <c:v>0.14599999999999999</c:v>
                </c:pt>
                <c:pt idx="543">
                  <c:v>0.152</c:v>
                </c:pt>
                <c:pt idx="544">
                  <c:v>0.16</c:v>
                </c:pt>
                <c:pt idx="545">
                  <c:v>0.16700000000000001</c:v>
                </c:pt>
                <c:pt idx="546">
                  <c:v>0.17599999999999999</c:v>
                </c:pt>
                <c:pt idx="547">
                  <c:v>0.185</c:v>
                </c:pt>
                <c:pt idx="548">
                  <c:v>0.19400000000000001</c:v>
                </c:pt>
                <c:pt idx="549">
                  <c:v>0.20399999999999999</c:v>
                </c:pt>
                <c:pt idx="550">
                  <c:v>0.214</c:v>
                </c:pt>
                <c:pt idx="551">
                  <c:v>0.22500000000000001</c:v>
                </c:pt>
                <c:pt idx="552">
                  <c:v>0.23599999999999999</c:v>
                </c:pt>
                <c:pt idx="553">
                  <c:v>0.248</c:v>
                </c:pt>
                <c:pt idx="554">
                  <c:v>0.25900000000000001</c:v>
                </c:pt>
                <c:pt idx="555">
                  <c:v>0.27100000000000002</c:v>
                </c:pt>
                <c:pt idx="556">
                  <c:v>0.28299999999999997</c:v>
                </c:pt>
                <c:pt idx="557">
                  <c:v>0.29499999999999998</c:v>
                </c:pt>
                <c:pt idx="558">
                  <c:v>0.307</c:v>
                </c:pt>
                <c:pt idx="559">
                  <c:v>0.31900000000000001</c:v>
                </c:pt>
                <c:pt idx="560">
                  <c:v>0.33</c:v>
                </c:pt>
                <c:pt idx="561">
                  <c:v>0.34200000000000003</c:v>
                </c:pt>
                <c:pt idx="562">
                  <c:v>0.35199999999999998</c:v>
                </c:pt>
                <c:pt idx="563">
                  <c:v>0.36199999999999999</c:v>
                </c:pt>
                <c:pt idx="564">
                  <c:v>0.372</c:v>
                </c:pt>
                <c:pt idx="565">
                  <c:v>0.38100000000000001</c:v>
                </c:pt>
                <c:pt idx="566">
                  <c:v>0.39100000000000001</c:v>
                </c:pt>
                <c:pt idx="567">
                  <c:v>0.39900000000000002</c:v>
                </c:pt>
                <c:pt idx="568">
                  <c:v>0.40699999999999997</c:v>
                </c:pt>
                <c:pt idx="569">
                  <c:v>0.41399999999999998</c:v>
                </c:pt>
                <c:pt idx="570">
                  <c:v>0.42099999999999999</c:v>
                </c:pt>
                <c:pt idx="571">
                  <c:v>0.42699999999999999</c:v>
                </c:pt>
                <c:pt idx="572">
                  <c:v>0.434</c:v>
                </c:pt>
                <c:pt idx="573">
                  <c:v>0.439</c:v>
                </c:pt>
                <c:pt idx="574">
                  <c:v>0.44500000000000001</c:v>
                </c:pt>
                <c:pt idx="575">
                  <c:v>0.45</c:v>
                </c:pt>
                <c:pt idx="576">
                  <c:v>0.45500000000000002</c:v>
                </c:pt>
                <c:pt idx="577">
                  <c:v>0.46100000000000002</c:v>
                </c:pt>
                <c:pt idx="578">
                  <c:v>0.46700000000000003</c:v>
                </c:pt>
                <c:pt idx="579">
                  <c:v>0.47299999999999998</c:v>
                </c:pt>
                <c:pt idx="580">
                  <c:v>0.48</c:v>
                </c:pt>
                <c:pt idx="581">
                  <c:v>0.48699999999999999</c:v>
                </c:pt>
                <c:pt idx="582">
                  <c:v>0.496</c:v>
                </c:pt>
                <c:pt idx="583">
                  <c:v>0.505</c:v>
                </c:pt>
                <c:pt idx="584">
                  <c:v>0.51700000000000002</c:v>
                </c:pt>
                <c:pt idx="585">
                  <c:v>0.53</c:v>
                </c:pt>
                <c:pt idx="586">
                  <c:v>0.54600000000000004</c:v>
                </c:pt>
                <c:pt idx="587">
                  <c:v>0.56499999999999995</c:v>
                </c:pt>
                <c:pt idx="588">
                  <c:v>0.58799999999999997</c:v>
                </c:pt>
                <c:pt idx="589">
                  <c:v>0.61699999999999999</c:v>
                </c:pt>
                <c:pt idx="590">
                  <c:v>0.65100000000000002</c:v>
                </c:pt>
                <c:pt idx="591">
                  <c:v>0.69299999999999995</c:v>
                </c:pt>
                <c:pt idx="592">
                  <c:v>0.745</c:v>
                </c:pt>
                <c:pt idx="593">
                  <c:v>0.80900000000000005</c:v>
                </c:pt>
                <c:pt idx="594">
                  <c:v>0.88800000000000001</c:v>
                </c:pt>
                <c:pt idx="595">
                  <c:v>0.98399999999999999</c:v>
                </c:pt>
                <c:pt idx="596">
                  <c:v>1.1080000000000001</c:v>
                </c:pt>
                <c:pt idx="597">
                  <c:v>1.25</c:v>
                </c:pt>
                <c:pt idx="598">
                  <c:v>1.4139999999999999</c:v>
                </c:pt>
                <c:pt idx="599">
                  <c:v>1.597</c:v>
                </c:pt>
                <c:pt idx="600">
                  <c:v>1.788</c:v>
                </c:pt>
                <c:pt idx="601">
                  <c:v>1.9730000000000001</c:v>
                </c:pt>
                <c:pt idx="602">
                  <c:v>2.14</c:v>
                </c:pt>
                <c:pt idx="603">
                  <c:v>2.2610000000000001</c:v>
                </c:pt>
                <c:pt idx="604">
                  <c:v>2.3460000000000001</c:v>
                </c:pt>
                <c:pt idx="605">
                  <c:v>2.3679999999999999</c:v>
                </c:pt>
                <c:pt idx="606">
                  <c:v>2.3969999999999998</c:v>
                </c:pt>
                <c:pt idx="607">
                  <c:v>2.391</c:v>
                </c:pt>
                <c:pt idx="608">
                  <c:v>2.383</c:v>
                </c:pt>
                <c:pt idx="609">
                  <c:v>2.347</c:v>
                </c:pt>
                <c:pt idx="610">
                  <c:v>2.31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18C9-4E99-A1AE-ACBC1A0BA6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28600"/>
        <c:axId val="646756040"/>
      </c:scatterChart>
      <c:valAx>
        <c:axId val="646728600"/>
        <c:scaling>
          <c:orientation val="minMax"/>
          <c:max val="800"/>
          <c:min val="19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avelength</a:t>
                </a:r>
                <a:r>
                  <a:rPr lang="en-US" baseline="0"/>
                  <a:t> (nm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646756040"/>
        <c:crosses val="autoZero"/>
        <c:crossBetween val="midCat"/>
        <c:majorUnit val="190"/>
        <c:minorUnit val="50"/>
      </c:valAx>
      <c:valAx>
        <c:axId val="646756040"/>
        <c:scaling>
          <c:orientation val="minMax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bsorbance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646728600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Scanning spectra of various leaf discs suspended in water for 30 min </a:t>
            </a:r>
          </a:p>
        </c:rich>
      </c:tx>
      <c:layout>
        <c:manualLayout>
          <c:xMode val="edge"/>
          <c:yMode val="edge"/>
          <c:x val="0.21406249999999999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166967410323711"/>
          <c:y val="0.1951563867016623"/>
          <c:w val="0.73595199037620296"/>
          <c:h val="0.5886313429571303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water-F'!$B$2</c:f>
              <c:strCache>
                <c:ptCount val="1"/>
                <c:pt idx="0">
                  <c:v>Spinach </c:v>
                </c:pt>
              </c:strCache>
            </c:strRef>
          </c:tx>
          <c:spPr>
            <a:ln>
              <a:prstDash val="sysDash"/>
            </a:ln>
          </c:spPr>
          <c:marker>
            <c:symbol val="none"/>
          </c:marker>
          <c:xVal>
            <c:numRef>
              <c:f>'water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water-F'!$B$3:$B$603</c:f>
              <c:numCache>
                <c:formatCode>General</c:formatCode>
                <c:ptCount val="601"/>
                <c:pt idx="0">
                  <c:v>2E-3</c:v>
                </c:pt>
                <c:pt idx="1">
                  <c:v>2E-3</c:v>
                </c:pt>
                <c:pt idx="2">
                  <c:v>2E-3</c:v>
                </c:pt>
                <c:pt idx="3">
                  <c:v>2E-3</c:v>
                </c:pt>
                <c:pt idx="4">
                  <c:v>1E-3</c:v>
                </c:pt>
                <c:pt idx="5">
                  <c:v>1E-3</c:v>
                </c:pt>
                <c:pt idx="6">
                  <c:v>1E-3</c:v>
                </c:pt>
                <c:pt idx="7">
                  <c:v>1E-3</c:v>
                </c:pt>
                <c:pt idx="8">
                  <c:v>1E-3</c:v>
                </c:pt>
                <c:pt idx="9">
                  <c:v>1E-3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-1E-3</c:v>
                </c:pt>
                <c:pt idx="17">
                  <c:v>-1E-3</c:v>
                </c:pt>
                <c:pt idx="18">
                  <c:v>-1E-3</c:v>
                </c:pt>
                <c:pt idx="19">
                  <c:v>-1E-3</c:v>
                </c:pt>
                <c:pt idx="20">
                  <c:v>-1E-3</c:v>
                </c:pt>
                <c:pt idx="21">
                  <c:v>-1E-3</c:v>
                </c:pt>
                <c:pt idx="22">
                  <c:v>-2E-3</c:v>
                </c:pt>
                <c:pt idx="23">
                  <c:v>-2E-3</c:v>
                </c:pt>
                <c:pt idx="24">
                  <c:v>-2E-3</c:v>
                </c:pt>
                <c:pt idx="25">
                  <c:v>-2E-3</c:v>
                </c:pt>
                <c:pt idx="26">
                  <c:v>-2E-3</c:v>
                </c:pt>
                <c:pt idx="27">
                  <c:v>-2E-3</c:v>
                </c:pt>
                <c:pt idx="28">
                  <c:v>-3.0000000000000001E-3</c:v>
                </c:pt>
                <c:pt idx="29">
                  <c:v>-3.0000000000000001E-3</c:v>
                </c:pt>
                <c:pt idx="30">
                  <c:v>-3.0000000000000001E-3</c:v>
                </c:pt>
                <c:pt idx="31">
                  <c:v>-3.0000000000000001E-3</c:v>
                </c:pt>
                <c:pt idx="32">
                  <c:v>-3.0000000000000001E-3</c:v>
                </c:pt>
                <c:pt idx="33">
                  <c:v>-3.0000000000000001E-3</c:v>
                </c:pt>
                <c:pt idx="34">
                  <c:v>-3.0000000000000001E-3</c:v>
                </c:pt>
                <c:pt idx="35">
                  <c:v>-4.0000000000000001E-3</c:v>
                </c:pt>
                <c:pt idx="36">
                  <c:v>-4.0000000000000001E-3</c:v>
                </c:pt>
                <c:pt idx="37">
                  <c:v>-4.0000000000000001E-3</c:v>
                </c:pt>
                <c:pt idx="38">
                  <c:v>-4.0000000000000001E-3</c:v>
                </c:pt>
                <c:pt idx="39">
                  <c:v>-4.0000000000000001E-3</c:v>
                </c:pt>
                <c:pt idx="40">
                  <c:v>-4.0000000000000001E-3</c:v>
                </c:pt>
                <c:pt idx="41">
                  <c:v>-6.0000000000000001E-3</c:v>
                </c:pt>
                <c:pt idx="42">
                  <c:v>-8.0000000000000002E-3</c:v>
                </c:pt>
                <c:pt idx="43">
                  <c:v>-8.0000000000000002E-3</c:v>
                </c:pt>
                <c:pt idx="44">
                  <c:v>-8.0000000000000002E-3</c:v>
                </c:pt>
                <c:pt idx="45">
                  <c:v>-8.0000000000000002E-3</c:v>
                </c:pt>
                <c:pt idx="46">
                  <c:v>-8.0000000000000002E-3</c:v>
                </c:pt>
                <c:pt idx="47">
                  <c:v>-8.0000000000000002E-3</c:v>
                </c:pt>
                <c:pt idx="48">
                  <c:v>-8.0000000000000002E-3</c:v>
                </c:pt>
                <c:pt idx="49">
                  <c:v>-8.0000000000000002E-3</c:v>
                </c:pt>
                <c:pt idx="50">
                  <c:v>-8.0000000000000002E-3</c:v>
                </c:pt>
                <c:pt idx="51">
                  <c:v>-8.0000000000000002E-3</c:v>
                </c:pt>
                <c:pt idx="52">
                  <c:v>-8.0000000000000002E-3</c:v>
                </c:pt>
                <c:pt idx="53">
                  <c:v>-8.0000000000000002E-3</c:v>
                </c:pt>
                <c:pt idx="54">
                  <c:v>-8.9999999999999993E-3</c:v>
                </c:pt>
                <c:pt idx="55">
                  <c:v>-8.9999999999999993E-3</c:v>
                </c:pt>
                <c:pt idx="56">
                  <c:v>-0.01</c:v>
                </c:pt>
                <c:pt idx="57">
                  <c:v>-1.0999999999999999E-2</c:v>
                </c:pt>
                <c:pt idx="58">
                  <c:v>-1.2E-2</c:v>
                </c:pt>
                <c:pt idx="59">
                  <c:v>-1.2999999999999999E-2</c:v>
                </c:pt>
                <c:pt idx="60">
                  <c:v>-1.4999999999999999E-2</c:v>
                </c:pt>
                <c:pt idx="61">
                  <c:v>-1.6E-2</c:v>
                </c:pt>
                <c:pt idx="62">
                  <c:v>-1.6E-2</c:v>
                </c:pt>
                <c:pt idx="63">
                  <c:v>-1.6E-2</c:v>
                </c:pt>
                <c:pt idx="64">
                  <c:v>-1.7000000000000001E-2</c:v>
                </c:pt>
                <c:pt idx="65">
                  <c:v>-1.6E-2</c:v>
                </c:pt>
                <c:pt idx="66">
                  <c:v>-1.6E-2</c:v>
                </c:pt>
                <c:pt idx="67">
                  <c:v>-1.6E-2</c:v>
                </c:pt>
                <c:pt idx="68">
                  <c:v>-1.6E-2</c:v>
                </c:pt>
                <c:pt idx="69">
                  <c:v>-1.6E-2</c:v>
                </c:pt>
                <c:pt idx="70">
                  <c:v>-1.7000000000000001E-2</c:v>
                </c:pt>
                <c:pt idx="71">
                  <c:v>-1.7000000000000001E-2</c:v>
                </c:pt>
                <c:pt idx="72">
                  <c:v>-1.7000000000000001E-2</c:v>
                </c:pt>
                <c:pt idx="73">
                  <c:v>-1.7000000000000001E-2</c:v>
                </c:pt>
                <c:pt idx="74">
                  <c:v>-1.7000000000000001E-2</c:v>
                </c:pt>
                <c:pt idx="75">
                  <c:v>-1.7000000000000001E-2</c:v>
                </c:pt>
                <c:pt idx="76">
                  <c:v>-1.7000000000000001E-2</c:v>
                </c:pt>
                <c:pt idx="77">
                  <c:v>-1.7000000000000001E-2</c:v>
                </c:pt>
                <c:pt idx="78">
                  <c:v>-1.7000000000000001E-2</c:v>
                </c:pt>
                <c:pt idx="79">
                  <c:v>-1.7999999999999999E-2</c:v>
                </c:pt>
                <c:pt idx="80">
                  <c:v>-1.7999999999999999E-2</c:v>
                </c:pt>
                <c:pt idx="81">
                  <c:v>-1.7999999999999999E-2</c:v>
                </c:pt>
                <c:pt idx="82">
                  <c:v>-1.7999999999999999E-2</c:v>
                </c:pt>
                <c:pt idx="83">
                  <c:v>-1.7999999999999999E-2</c:v>
                </c:pt>
                <c:pt idx="84">
                  <c:v>-1.7999999999999999E-2</c:v>
                </c:pt>
                <c:pt idx="85">
                  <c:v>-1.7999999999999999E-2</c:v>
                </c:pt>
                <c:pt idx="86">
                  <c:v>-1.7999999999999999E-2</c:v>
                </c:pt>
                <c:pt idx="87">
                  <c:v>-1.9E-2</c:v>
                </c:pt>
                <c:pt idx="88">
                  <c:v>-1.9E-2</c:v>
                </c:pt>
                <c:pt idx="89">
                  <c:v>-1.9E-2</c:v>
                </c:pt>
                <c:pt idx="90">
                  <c:v>-1.9E-2</c:v>
                </c:pt>
                <c:pt idx="91">
                  <c:v>-1.9E-2</c:v>
                </c:pt>
                <c:pt idx="92">
                  <c:v>-1.9E-2</c:v>
                </c:pt>
                <c:pt idx="93">
                  <c:v>-1.9E-2</c:v>
                </c:pt>
                <c:pt idx="94">
                  <c:v>-1.9E-2</c:v>
                </c:pt>
                <c:pt idx="95">
                  <c:v>-1.9E-2</c:v>
                </c:pt>
                <c:pt idx="96">
                  <c:v>-0.02</c:v>
                </c:pt>
                <c:pt idx="97">
                  <c:v>-0.02</c:v>
                </c:pt>
                <c:pt idx="98">
                  <c:v>-0.02</c:v>
                </c:pt>
                <c:pt idx="99">
                  <c:v>-0.02</c:v>
                </c:pt>
                <c:pt idx="100">
                  <c:v>-0.02</c:v>
                </c:pt>
                <c:pt idx="101">
                  <c:v>-0.02</c:v>
                </c:pt>
                <c:pt idx="102">
                  <c:v>-0.02</c:v>
                </c:pt>
                <c:pt idx="103">
                  <c:v>-0.02</c:v>
                </c:pt>
                <c:pt idx="104">
                  <c:v>-0.02</c:v>
                </c:pt>
                <c:pt idx="105">
                  <c:v>-0.02</c:v>
                </c:pt>
                <c:pt idx="106">
                  <c:v>-0.02</c:v>
                </c:pt>
                <c:pt idx="107">
                  <c:v>-0.02</c:v>
                </c:pt>
                <c:pt idx="108">
                  <c:v>-0.02</c:v>
                </c:pt>
                <c:pt idx="109">
                  <c:v>-2.1000000000000001E-2</c:v>
                </c:pt>
                <c:pt idx="110">
                  <c:v>-2.1000000000000001E-2</c:v>
                </c:pt>
                <c:pt idx="111">
                  <c:v>-2.1000000000000001E-2</c:v>
                </c:pt>
                <c:pt idx="112">
                  <c:v>-2.1000000000000001E-2</c:v>
                </c:pt>
                <c:pt idx="113">
                  <c:v>-2.1000000000000001E-2</c:v>
                </c:pt>
                <c:pt idx="114">
                  <c:v>-2.1000000000000001E-2</c:v>
                </c:pt>
                <c:pt idx="115">
                  <c:v>-2.1000000000000001E-2</c:v>
                </c:pt>
                <c:pt idx="116">
                  <c:v>-2.1000000000000001E-2</c:v>
                </c:pt>
                <c:pt idx="117">
                  <c:v>-2.1000000000000001E-2</c:v>
                </c:pt>
                <c:pt idx="118">
                  <c:v>-2.1000000000000001E-2</c:v>
                </c:pt>
                <c:pt idx="119">
                  <c:v>-2.1000000000000001E-2</c:v>
                </c:pt>
                <c:pt idx="120">
                  <c:v>-2.1000000000000001E-2</c:v>
                </c:pt>
                <c:pt idx="121">
                  <c:v>-2.1000000000000001E-2</c:v>
                </c:pt>
                <c:pt idx="122">
                  <c:v>-2.1000000000000001E-2</c:v>
                </c:pt>
                <c:pt idx="123">
                  <c:v>-2.1000000000000001E-2</c:v>
                </c:pt>
                <c:pt idx="124">
                  <c:v>-2.1000000000000001E-2</c:v>
                </c:pt>
                <c:pt idx="125">
                  <c:v>-2.1000000000000001E-2</c:v>
                </c:pt>
                <c:pt idx="126">
                  <c:v>-2.1999999999999999E-2</c:v>
                </c:pt>
                <c:pt idx="127">
                  <c:v>-2.1999999999999999E-2</c:v>
                </c:pt>
                <c:pt idx="128">
                  <c:v>-2.1999999999999999E-2</c:v>
                </c:pt>
                <c:pt idx="129">
                  <c:v>-2.1999999999999999E-2</c:v>
                </c:pt>
                <c:pt idx="130">
                  <c:v>-2.1999999999999999E-2</c:v>
                </c:pt>
                <c:pt idx="131">
                  <c:v>-2.1999999999999999E-2</c:v>
                </c:pt>
                <c:pt idx="132">
                  <c:v>-2.1999999999999999E-2</c:v>
                </c:pt>
                <c:pt idx="133">
                  <c:v>-2.1999999999999999E-2</c:v>
                </c:pt>
                <c:pt idx="134">
                  <c:v>-2.3E-2</c:v>
                </c:pt>
                <c:pt idx="135">
                  <c:v>-2.3E-2</c:v>
                </c:pt>
                <c:pt idx="136">
                  <c:v>-2.3E-2</c:v>
                </c:pt>
                <c:pt idx="137">
                  <c:v>-2.3E-2</c:v>
                </c:pt>
                <c:pt idx="138">
                  <c:v>-2.3E-2</c:v>
                </c:pt>
                <c:pt idx="139">
                  <c:v>-2.3E-2</c:v>
                </c:pt>
                <c:pt idx="140">
                  <c:v>-2.3E-2</c:v>
                </c:pt>
                <c:pt idx="141">
                  <c:v>-2.3E-2</c:v>
                </c:pt>
                <c:pt idx="142">
                  <c:v>-2.3E-2</c:v>
                </c:pt>
                <c:pt idx="143">
                  <c:v>-2.3E-2</c:v>
                </c:pt>
                <c:pt idx="144">
                  <c:v>-2.3E-2</c:v>
                </c:pt>
                <c:pt idx="145">
                  <c:v>-2.4E-2</c:v>
                </c:pt>
                <c:pt idx="146">
                  <c:v>-2.4E-2</c:v>
                </c:pt>
                <c:pt idx="147">
                  <c:v>-2.4E-2</c:v>
                </c:pt>
                <c:pt idx="148">
                  <c:v>-2.4E-2</c:v>
                </c:pt>
                <c:pt idx="149">
                  <c:v>-2.4E-2</c:v>
                </c:pt>
                <c:pt idx="150">
                  <c:v>-2.4E-2</c:v>
                </c:pt>
                <c:pt idx="151">
                  <c:v>-2.4E-2</c:v>
                </c:pt>
                <c:pt idx="152">
                  <c:v>-2.4E-2</c:v>
                </c:pt>
                <c:pt idx="153">
                  <c:v>-2.4E-2</c:v>
                </c:pt>
                <c:pt idx="154">
                  <c:v>-2.4E-2</c:v>
                </c:pt>
                <c:pt idx="155">
                  <c:v>-2.4E-2</c:v>
                </c:pt>
                <c:pt idx="156">
                  <c:v>-2.4E-2</c:v>
                </c:pt>
                <c:pt idx="157">
                  <c:v>-2.4E-2</c:v>
                </c:pt>
                <c:pt idx="158">
                  <c:v>-2.4E-2</c:v>
                </c:pt>
                <c:pt idx="159">
                  <c:v>-2.4E-2</c:v>
                </c:pt>
                <c:pt idx="160">
                  <c:v>-2.5000000000000001E-2</c:v>
                </c:pt>
                <c:pt idx="161">
                  <c:v>-2.5000000000000001E-2</c:v>
                </c:pt>
                <c:pt idx="162">
                  <c:v>-2.5000000000000001E-2</c:v>
                </c:pt>
                <c:pt idx="163">
                  <c:v>-2.5000000000000001E-2</c:v>
                </c:pt>
                <c:pt idx="164">
                  <c:v>-2.5000000000000001E-2</c:v>
                </c:pt>
                <c:pt idx="165">
                  <c:v>-2.5000000000000001E-2</c:v>
                </c:pt>
                <c:pt idx="166">
                  <c:v>-2.5000000000000001E-2</c:v>
                </c:pt>
                <c:pt idx="167">
                  <c:v>-2.5000000000000001E-2</c:v>
                </c:pt>
                <c:pt idx="168">
                  <c:v>-2.5000000000000001E-2</c:v>
                </c:pt>
                <c:pt idx="169">
                  <c:v>-2.5000000000000001E-2</c:v>
                </c:pt>
                <c:pt idx="170">
                  <c:v>-2.5000000000000001E-2</c:v>
                </c:pt>
                <c:pt idx="171">
                  <c:v>-2.5000000000000001E-2</c:v>
                </c:pt>
                <c:pt idx="172">
                  <c:v>-2.5000000000000001E-2</c:v>
                </c:pt>
                <c:pt idx="173">
                  <c:v>-2.5000000000000001E-2</c:v>
                </c:pt>
                <c:pt idx="174">
                  <c:v>-2.5000000000000001E-2</c:v>
                </c:pt>
                <c:pt idx="175">
                  <c:v>-2.5000000000000001E-2</c:v>
                </c:pt>
                <c:pt idx="176">
                  <c:v>-2.5000000000000001E-2</c:v>
                </c:pt>
                <c:pt idx="177">
                  <c:v>-2.5000000000000001E-2</c:v>
                </c:pt>
                <c:pt idx="178">
                  <c:v>-2.5000000000000001E-2</c:v>
                </c:pt>
                <c:pt idx="179">
                  <c:v>-2.5000000000000001E-2</c:v>
                </c:pt>
                <c:pt idx="180">
                  <c:v>-2.5000000000000001E-2</c:v>
                </c:pt>
                <c:pt idx="181">
                  <c:v>-2.5000000000000001E-2</c:v>
                </c:pt>
                <c:pt idx="182">
                  <c:v>-2.5999999999999999E-2</c:v>
                </c:pt>
                <c:pt idx="183">
                  <c:v>-2.5999999999999999E-2</c:v>
                </c:pt>
                <c:pt idx="184">
                  <c:v>-2.5999999999999999E-2</c:v>
                </c:pt>
                <c:pt idx="185">
                  <c:v>-2.5999999999999999E-2</c:v>
                </c:pt>
                <c:pt idx="186">
                  <c:v>-2.5999999999999999E-2</c:v>
                </c:pt>
                <c:pt idx="187">
                  <c:v>-2.5999999999999999E-2</c:v>
                </c:pt>
                <c:pt idx="188">
                  <c:v>-2.5999999999999999E-2</c:v>
                </c:pt>
                <c:pt idx="189">
                  <c:v>-2.5999999999999999E-2</c:v>
                </c:pt>
                <c:pt idx="190">
                  <c:v>-2.5999999999999999E-2</c:v>
                </c:pt>
                <c:pt idx="191">
                  <c:v>-2.5999999999999999E-2</c:v>
                </c:pt>
                <c:pt idx="192">
                  <c:v>-2.5999999999999999E-2</c:v>
                </c:pt>
                <c:pt idx="193">
                  <c:v>-2.5999999999999999E-2</c:v>
                </c:pt>
                <c:pt idx="194">
                  <c:v>-2.5999999999999999E-2</c:v>
                </c:pt>
                <c:pt idx="195">
                  <c:v>-2.5999999999999999E-2</c:v>
                </c:pt>
                <c:pt idx="196">
                  <c:v>-2.5999999999999999E-2</c:v>
                </c:pt>
                <c:pt idx="197">
                  <c:v>-2.5999999999999999E-2</c:v>
                </c:pt>
                <c:pt idx="198">
                  <c:v>-2.5999999999999999E-2</c:v>
                </c:pt>
                <c:pt idx="199">
                  <c:v>-2.5999999999999999E-2</c:v>
                </c:pt>
                <c:pt idx="200">
                  <c:v>-2.7E-2</c:v>
                </c:pt>
                <c:pt idx="201">
                  <c:v>-2.7E-2</c:v>
                </c:pt>
                <c:pt idx="202">
                  <c:v>-2.7E-2</c:v>
                </c:pt>
                <c:pt idx="203">
                  <c:v>-2.7E-2</c:v>
                </c:pt>
                <c:pt idx="204">
                  <c:v>-2.7E-2</c:v>
                </c:pt>
                <c:pt idx="205">
                  <c:v>-2.7E-2</c:v>
                </c:pt>
                <c:pt idx="206">
                  <c:v>-2.7E-2</c:v>
                </c:pt>
                <c:pt idx="207">
                  <c:v>-2.8000000000000001E-2</c:v>
                </c:pt>
                <c:pt idx="208">
                  <c:v>-2.8000000000000001E-2</c:v>
                </c:pt>
                <c:pt idx="209">
                  <c:v>-2.8000000000000001E-2</c:v>
                </c:pt>
                <c:pt idx="210">
                  <c:v>-2.8000000000000001E-2</c:v>
                </c:pt>
                <c:pt idx="211">
                  <c:v>-2.8000000000000001E-2</c:v>
                </c:pt>
                <c:pt idx="212">
                  <c:v>-2.8000000000000001E-2</c:v>
                </c:pt>
                <c:pt idx="213">
                  <c:v>-2.9000000000000001E-2</c:v>
                </c:pt>
                <c:pt idx="214">
                  <c:v>-2.9000000000000001E-2</c:v>
                </c:pt>
                <c:pt idx="215">
                  <c:v>-2.9000000000000001E-2</c:v>
                </c:pt>
                <c:pt idx="216">
                  <c:v>-0.03</c:v>
                </c:pt>
                <c:pt idx="217">
                  <c:v>-3.1E-2</c:v>
                </c:pt>
                <c:pt idx="218">
                  <c:v>-3.1E-2</c:v>
                </c:pt>
                <c:pt idx="219">
                  <c:v>-3.1E-2</c:v>
                </c:pt>
                <c:pt idx="220">
                  <c:v>-3.2000000000000001E-2</c:v>
                </c:pt>
                <c:pt idx="221">
                  <c:v>-3.2000000000000001E-2</c:v>
                </c:pt>
                <c:pt idx="222">
                  <c:v>-3.2000000000000001E-2</c:v>
                </c:pt>
                <c:pt idx="223">
                  <c:v>-3.2000000000000001E-2</c:v>
                </c:pt>
                <c:pt idx="224">
                  <c:v>-3.1E-2</c:v>
                </c:pt>
                <c:pt idx="225">
                  <c:v>-3.1E-2</c:v>
                </c:pt>
                <c:pt idx="226">
                  <c:v>-3.1E-2</c:v>
                </c:pt>
                <c:pt idx="227">
                  <c:v>-3.1E-2</c:v>
                </c:pt>
                <c:pt idx="228">
                  <c:v>-3.1E-2</c:v>
                </c:pt>
                <c:pt idx="229">
                  <c:v>-3.1E-2</c:v>
                </c:pt>
                <c:pt idx="230">
                  <c:v>-3.1E-2</c:v>
                </c:pt>
                <c:pt idx="231">
                  <c:v>-3.1E-2</c:v>
                </c:pt>
                <c:pt idx="232">
                  <c:v>-3.1E-2</c:v>
                </c:pt>
                <c:pt idx="233">
                  <c:v>-3.1E-2</c:v>
                </c:pt>
                <c:pt idx="234">
                  <c:v>-3.1E-2</c:v>
                </c:pt>
                <c:pt idx="235">
                  <c:v>-3.1E-2</c:v>
                </c:pt>
                <c:pt idx="236">
                  <c:v>-3.1E-2</c:v>
                </c:pt>
                <c:pt idx="237">
                  <c:v>-3.1E-2</c:v>
                </c:pt>
                <c:pt idx="238">
                  <c:v>-3.1E-2</c:v>
                </c:pt>
                <c:pt idx="239">
                  <c:v>-3.1E-2</c:v>
                </c:pt>
                <c:pt idx="240">
                  <c:v>-3.1E-2</c:v>
                </c:pt>
                <c:pt idx="241">
                  <c:v>-3.1E-2</c:v>
                </c:pt>
                <c:pt idx="242">
                  <c:v>-3.1E-2</c:v>
                </c:pt>
                <c:pt idx="243">
                  <c:v>-3.1E-2</c:v>
                </c:pt>
                <c:pt idx="244">
                  <c:v>-3.1E-2</c:v>
                </c:pt>
                <c:pt idx="245">
                  <c:v>-3.1E-2</c:v>
                </c:pt>
                <c:pt idx="246">
                  <c:v>-3.1E-2</c:v>
                </c:pt>
                <c:pt idx="247">
                  <c:v>-3.1E-2</c:v>
                </c:pt>
                <c:pt idx="248">
                  <c:v>-3.1E-2</c:v>
                </c:pt>
                <c:pt idx="249">
                  <c:v>-3.1E-2</c:v>
                </c:pt>
                <c:pt idx="250">
                  <c:v>-3.1E-2</c:v>
                </c:pt>
                <c:pt idx="251">
                  <c:v>-3.1E-2</c:v>
                </c:pt>
                <c:pt idx="252">
                  <c:v>-3.1E-2</c:v>
                </c:pt>
                <c:pt idx="253">
                  <c:v>-3.1E-2</c:v>
                </c:pt>
                <c:pt idx="254">
                  <c:v>-3.1E-2</c:v>
                </c:pt>
                <c:pt idx="255">
                  <c:v>-3.1E-2</c:v>
                </c:pt>
                <c:pt idx="256">
                  <c:v>-3.1E-2</c:v>
                </c:pt>
                <c:pt idx="257">
                  <c:v>-3.1E-2</c:v>
                </c:pt>
                <c:pt idx="258">
                  <c:v>-3.1E-2</c:v>
                </c:pt>
                <c:pt idx="259">
                  <c:v>-3.1E-2</c:v>
                </c:pt>
                <c:pt idx="260">
                  <c:v>-3.1E-2</c:v>
                </c:pt>
                <c:pt idx="261">
                  <c:v>-3.2000000000000001E-2</c:v>
                </c:pt>
                <c:pt idx="262">
                  <c:v>-3.2000000000000001E-2</c:v>
                </c:pt>
                <c:pt idx="263">
                  <c:v>-3.2000000000000001E-2</c:v>
                </c:pt>
                <c:pt idx="264">
                  <c:v>-3.2000000000000001E-2</c:v>
                </c:pt>
                <c:pt idx="265">
                  <c:v>-3.2000000000000001E-2</c:v>
                </c:pt>
                <c:pt idx="266">
                  <c:v>-3.2000000000000001E-2</c:v>
                </c:pt>
                <c:pt idx="267">
                  <c:v>-3.2000000000000001E-2</c:v>
                </c:pt>
                <c:pt idx="268">
                  <c:v>-3.2000000000000001E-2</c:v>
                </c:pt>
                <c:pt idx="269">
                  <c:v>-3.2000000000000001E-2</c:v>
                </c:pt>
                <c:pt idx="270">
                  <c:v>-3.2000000000000001E-2</c:v>
                </c:pt>
                <c:pt idx="271">
                  <c:v>-3.2000000000000001E-2</c:v>
                </c:pt>
                <c:pt idx="272">
                  <c:v>-3.2000000000000001E-2</c:v>
                </c:pt>
                <c:pt idx="273">
                  <c:v>-3.2000000000000001E-2</c:v>
                </c:pt>
                <c:pt idx="274">
                  <c:v>-3.3000000000000002E-2</c:v>
                </c:pt>
                <c:pt idx="275">
                  <c:v>-3.3000000000000002E-2</c:v>
                </c:pt>
                <c:pt idx="276">
                  <c:v>-3.3000000000000002E-2</c:v>
                </c:pt>
                <c:pt idx="277">
                  <c:v>-3.3000000000000002E-2</c:v>
                </c:pt>
                <c:pt idx="278">
                  <c:v>-3.3000000000000002E-2</c:v>
                </c:pt>
                <c:pt idx="279">
                  <c:v>-3.3000000000000002E-2</c:v>
                </c:pt>
                <c:pt idx="280">
                  <c:v>-3.3000000000000002E-2</c:v>
                </c:pt>
                <c:pt idx="281">
                  <c:v>-3.3000000000000002E-2</c:v>
                </c:pt>
                <c:pt idx="282">
                  <c:v>-3.4000000000000002E-2</c:v>
                </c:pt>
                <c:pt idx="283">
                  <c:v>-3.4000000000000002E-2</c:v>
                </c:pt>
                <c:pt idx="284">
                  <c:v>-3.4000000000000002E-2</c:v>
                </c:pt>
                <c:pt idx="285">
                  <c:v>-3.4000000000000002E-2</c:v>
                </c:pt>
                <c:pt idx="286">
                  <c:v>-3.4000000000000002E-2</c:v>
                </c:pt>
                <c:pt idx="287">
                  <c:v>-3.4000000000000002E-2</c:v>
                </c:pt>
                <c:pt idx="288">
                  <c:v>-3.4000000000000002E-2</c:v>
                </c:pt>
                <c:pt idx="289">
                  <c:v>-3.5000000000000003E-2</c:v>
                </c:pt>
                <c:pt idx="290">
                  <c:v>-3.5000000000000003E-2</c:v>
                </c:pt>
                <c:pt idx="291">
                  <c:v>-3.5000000000000003E-2</c:v>
                </c:pt>
                <c:pt idx="292">
                  <c:v>-3.5000000000000003E-2</c:v>
                </c:pt>
                <c:pt idx="293">
                  <c:v>-3.5000000000000003E-2</c:v>
                </c:pt>
                <c:pt idx="294">
                  <c:v>-3.5000000000000003E-2</c:v>
                </c:pt>
                <c:pt idx="295">
                  <c:v>-3.5000000000000003E-2</c:v>
                </c:pt>
                <c:pt idx="296">
                  <c:v>-3.5000000000000003E-2</c:v>
                </c:pt>
                <c:pt idx="297">
                  <c:v>-3.5000000000000003E-2</c:v>
                </c:pt>
                <c:pt idx="298">
                  <c:v>-3.5000000000000003E-2</c:v>
                </c:pt>
                <c:pt idx="299">
                  <c:v>-3.5000000000000003E-2</c:v>
                </c:pt>
                <c:pt idx="300">
                  <c:v>-3.5999999999999997E-2</c:v>
                </c:pt>
                <c:pt idx="301">
                  <c:v>-3.5000000000000003E-2</c:v>
                </c:pt>
                <c:pt idx="302">
                  <c:v>-3.5999999999999997E-2</c:v>
                </c:pt>
                <c:pt idx="303">
                  <c:v>-3.5999999999999997E-2</c:v>
                </c:pt>
                <c:pt idx="304">
                  <c:v>-3.5999999999999997E-2</c:v>
                </c:pt>
                <c:pt idx="305">
                  <c:v>-3.5999999999999997E-2</c:v>
                </c:pt>
                <c:pt idx="306">
                  <c:v>-3.5999999999999997E-2</c:v>
                </c:pt>
                <c:pt idx="307">
                  <c:v>-3.5000000000000003E-2</c:v>
                </c:pt>
                <c:pt idx="308">
                  <c:v>-3.5000000000000003E-2</c:v>
                </c:pt>
                <c:pt idx="309">
                  <c:v>-3.5000000000000003E-2</c:v>
                </c:pt>
                <c:pt idx="310">
                  <c:v>-3.5000000000000003E-2</c:v>
                </c:pt>
                <c:pt idx="311">
                  <c:v>-3.5000000000000003E-2</c:v>
                </c:pt>
                <c:pt idx="312">
                  <c:v>-3.5000000000000003E-2</c:v>
                </c:pt>
                <c:pt idx="313">
                  <c:v>-3.5000000000000003E-2</c:v>
                </c:pt>
                <c:pt idx="314">
                  <c:v>-3.5000000000000003E-2</c:v>
                </c:pt>
                <c:pt idx="315">
                  <c:v>-3.5000000000000003E-2</c:v>
                </c:pt>
                <c:pt idx="316">
                  <c:v>-3.5000000000000003E-2</c:v>
                </c:pt>
                <c:pt idx="317">
                  <c:v>-3.5000000000000003E-2</c:v>
                </c:pt>
                <c:pt idx="318">
                  <c:v>-3.5000000000000003E-2</c:v>
                </c:pt>
                <c:pt idx="319">
                  <c:v>-3.5999999999999997E-2</c:v>
                </c:pt>
                <c:pt idx="320">
                  <c:v>-3.5999999999999997E-2</c:v>
                </c:pt>
                <c:pt idx="321">
                  <c:v>-3.5999999999999997E-2</c:v>
                </c:pt>
                <c:pt idx="322">
                  <c:v>-3.6999999999999998E-2</c:v>
                </c:pt>
                <c:pt idx="323">
                  <c:v>-3.6999999999999998E-2</c:v>
                </c:pt>
                <c:pt idx="324">
                  <c:v>-3.6999999999999998E-2</c:v>
                </c:pt>
                <c:pt idx="325">
                  <c:v>-3.6999999999999998E-2</c:v>
                </c:pt>
                <c:pt idx="326">
                  <c:v>-3.6999999999999998E-2</c:v>
                </c:pt>
                <c:pt idx="327">
                  <c:v>-3.6999999999999998E-2</c:v>
                </c:pt>
                <c:pt idx="328">
                  <c:v>-3.6999999999999998E-2</c:v>
                </c:pt>
                <c:pt idx="329">
                  <c:v>-3.6999999999999998E-2</c:v>
                </c:pt>
                <c:pt idx="330">
                  <c:v>-3.6999999999999998E-2</c:v>
                </c:pt>
                <c:pt idx="331">
                  <c:v>-3.7999999999999999E-2</c:v>
                </c:pt>
                <c:pt idx="332">
                  <c:v>-3.7999999999999999E-2</c:v>
                </c:pt>
                <c:pt idx="333">
                  <c:v>-3.7999999999999999E-2</c:v>
                </c:pt>
                <c:pt idx="334">
                  <c:v>-3.7999999999999999E-2</c:v>
                </c:pt>
                <c:pt idx="335">
                  <c:v>-3.7999999999999999E-2</c:v>
                </c:pt>
                <c:pt idx="336">
                  <c:v>-3.7999999999999999E-2</c:v>
                </c:pt>
                <c:pt idx="337">
                  <c:v>-3.7999999999999999E-2</c:v>
                </c:pt>
                <c:pt idx="338">
                  <c:v>-3.7999999999999999E-2</c:v>
                </c:pt>
                <c:pt idx="339">
                  <c:v>-3.7999999999999999E-2</c:v>
                </c:pt>
                <c:pt idx="340">
                  <c:v>-3.7999999999999999E-2</c:v>
                </c:pt>
                <c:pt idx="341">
                  <c:v>-3.7999999999999999E-2</c:v>
                </c:pt>
                <c:pt idx="342">
                  <c:v>-3.7999999999999999E-2</c:v>
                </c:pt>
                <c:pt idx="343">
                  <c:v>-3.7999999999999999E-2</c:v>
                </c:pt>
                <c:pt idx="344">
                  <c:v>-3.7999999999999999E-2</c:v>
                </c:pt>
                <c:pt idx="345">
                  <c:v>-3.9E-2</c:v>
                </c:pt>
                <c:pt idx="346">
                  <c:v>-3.9E-2</c:v>
                </c:pt>
                <c:pt idx="347">
                  <c:v>-3.9E-2</c:v>
                </c:pt>
                <c:pt idx="348">
                  <c:v>-3.9E-2</c:v>
                </c:pt>
                <c:pt idx="349">
                  <c:v>-3.9E-2</c:v>
                </c:pt>
                <c:pt idx="350">
                  <c:v>-3.9E-2</c:v>
                </c:pt>
                <c:pt idx="351">
                  <c:v>-3.9E-2</c:v>
                </c:pt>
                <c:pt idx="352">
                  <c:v>-3.9E-2</c:v>
                </c:pt>
                <c:pt idx="353">
                  <c:v>-3.9E-2</c:v>
                </c:pt>
                <c:pt idx="354">
                  <c:v>-3.9E-2</c:v>
                </c:pt>
                <c:pt idx="355">
                  <c:v>-3.9E-2</c:v>
                </c:pt>
                <c:pt idx="356">
                  <c:v>-3.9E-2</c:v>
                </c:pt>
                <c:pt idx="357">
                  <c:v>-3.9E-2</c:v>
                </c:pt>
                <c:pt idx="358">
                  <c:v>-3.9E-2</c:v>
                </c:pt>
                <c:pt idx="359">
                  <c:v>-3.9E-2</c:v>
                </c:pt>
                <c:pt idx="360">
                  <c:v>-3.9E-2</c:v>
                </c:pt>
                <c:pt idx="361">
                  <c:v>-3.9E-2</c:v>
                </c:pt>
                <c:pt idx="362">
                  <c:v>-3.9E-2</c:v>
                </c:pt>
                <c:pt idx="363">
                  <c:v>-3.9E-2</c:v>
                </c:pt>
                <c:pt idx="364">
                  <c:v>-3.9E-2</c:v>
                </c:pt>
                <c:pt idx="365">
                  <c:v>-3.9E-2</c:v>
                </c:pt>
                <c:pt idx="366">
                  <c:v>-0.04</c:v>
                </c:pt>
                <c:pt idx="367">
                  <c:v>-0.04</c:v>
                </c:pt>
                <c:pt idx="368">
                  <c:v>-0.04</c:v>
                </c:pt>
                <c:pt idx="369">
                  <c:v>-0.04</c:v>
                </c:pt>
                <c:pt idx="370">
                  <c:v>-0.04</c:v>
                </c:pt>
                <c:pt idx="371">
                  <c:v>-0.04</c:v>
                </c:pt>
                <c:pt idx="372">
                  <c:v>-0.04</c:v>
                </c:pt>
                <c:pt idx="373">
                  <c:v>-0.04</c:v>
                </c:pt>
                <c:pt idx="374">
                  <c:v>-0.04</c:v>
                </c:pt>
                <c:pt idx="375">
                  <c:v>-0.04</c:v>
                </c:pt>
                <c:pt idx="376">
                  <c:v>-0.04</c:v>
                </c:pt>
                <c:pt idx="377">
                  <c:v>-0.04</c:v>
                </c:pt>
                <c:pt idx="378">
                  <c:v>-0.04</c:v>
                </c:pt>
                <c:pt idx="379">
                  <c:v>-0.04</c:v>
                </c:pt>
                <c:pt idx="380">
                  <c:v>-0.04</c:v>
                </c:pt>
                <c:pt idx="381">
                  <c:v>-0.04</c:v>
                </c:pt>
                <c:pt idx="382">
                  <c:v>-0.04</c:v>
                </c:pt>
                <c:pt idx="383">
                  <c:v>-0.04</c:v>
                </c:pt>
                <c:pt idx="384">
                  <c:v>-0.04</c:v>
                </c:pt>
                <c:pt idx="385">
                  <c:v>-0.04</c:v>
                </c:pt>
                <c:pt idx="386">
                  <c:v>-0.04</c:v>
                </c:pt>
                <c:pt idx="387">
                  <c:v>-0.04</c:v>
                </c:pt>
                <c:pt idx="388">
                  <c:v>-0.04</c:v>
                </c:pt>
                <c:pt idx="389">
                  <c:v>-0.04</c:v>
                </c:pt>
                <c:pt idx="390">
                  <c:v>-0.04</c:v>
                </c:pt>
                <c:pt idx="391">
                  <c:v>-0.04</c:v>
                </c:pt>
                <c:pt idx="392">
                  <c:v>-0.04</c:v>
                </c:pt>
                <c:pt idx="393">
                  <c:v>-0.04</c:v>
                </c:pt>
                <c:pt idx="394">
                  <c:v>-0.04</c:v>
                </c:pt>
                <c:pt idx="395">
                  <c:v>-0.04</c:v>
                </c:pt>
                <c:pt idx="396">
                  <c:v>-0.04</c:v>
                </c:pt>
                <c:pt idx="397">
                  <c:v>-0.04</c:v>
                </c:pt>
                <c:pt idx="398">
                  <c:v>-3.9E-2</c:v>
                </c:pt>
                <c:pt idx="399">
                  <c:v>-3.9E-2</c:v>
                </c:pt>
                <c:pt idx="400">
                  <c:v>-3.9E-2</c:v>
                </c:pt>
                <c:pt idx="401">
                  <c:v>-3.9E-2</c:v>
                </c:pt>
                <c:pt idx="402">
                  <c:v>-3.7999999999999999E-2</c:v>
                </c:pt>
                <c:pt idx="403">
                  <c:v>-3.7999999999999999E-2</c:v>
                </c:pt>
                <c:pt idx="404">
                  <c:v>-3.7999999999999999E-2</c:v>
                </c:pt>
                <c:pt idx="405">
                  <c:v>-3.6999999999999998E-2</c:v>
                </c:pt>
                <c:pt idx="406">
                  <c:v>-3.6999999999999998E-2</c:v>
                </c:pt>
                <c:pt idx="407">
                  <c:v>-3.6999999999999998E-2</c:v>
                </c:pt>
                <c:pt idx="408">
                  <c:v>-3.5999999999999997E-2</c:v>
                </c:pt>
                <c:pt idx="409">
                  <c:v>-3.5999999999999997E-2</c:v>
                </c:pt>
                <c:pt idx="410">
                  <c:v>-3.5000000000000003E-2</c:v>
                </c:pt>
                <c:pt idx="411">
                  <c:v>-3.5000000000000003E-2</c:v>
                </c:pt>
                <c:pt idx="412">
                  <c:v>-3.4000000000000002E-2</c:v>
                </c:pt>
                <c:pt idx="413">
                  <c:v>-3.4000000000000002E-2</c:v>
                </c:pt>
                <c:pt idx="414">
                  <c:v>-3.3000000000000002E-2</c:v>
                </c:pt>
                <c:pt idx="415">
                  <c:v>-3.2000000000000001E-2</c:v>
                </c:pt>
                <c:pt idx="416">
                  <c:v>-3.2000000000000001E-2</c:v>
                </c:pt>
                <c:pt idx="417">
                  <c:v>-3.1E-2</c:v>
                </c:pt>
                <c:pt idx="418">
                  <c:v>-0.03</c:v>
                </c:pt>
                <c:pt idx="419">
                  <c:v>-0.03</c:v>
                </c:pt>
                <c:pt idx="420">
                  <c:v>-2.9000000000000001E-2</c:v>
                </c:pt>
                <c:pt idx="421">
                  <c:v>-2.5000000000000001E-2</c:v>
                </c:pt>
                <c:pt idx="422">
                  <c:v>-8.9999999999999993E-3</c:v>
                </c:pt>
                <c:pt idx="423">
                  <c:v>-8.0000000000000002E-3</c:v>
                </c:pt>
                <c:pt idx="424">
                  <c:v>-8.0000000000000002E-3</c:v>
                </c:pt>
                <c:pt idx="425">
                  <c:v>-7.0000000000000001E-3</c:v>
                </c:pt>
                <c:pt idx="426">
                  <c:v>-6.0000000000000001E-3</c:v>
                </c:pt>
                <c:pt idx="427">
                  <c:v>-5.0000000000000001E-3</c:v>
                </c:pt>
                <c:pt idx="428">
                  <c:v>-5.0000000000000001E-3</c:v>
                </c:pt>
                <c:pt idx="429">
                  <c:v>-4.0000000000000001E-3</c:v>
                </c:pt>
                <c:pt idx="430">
                  <c:v>-3.0000000000000001E-3</c:v>
                </c:pt>
                <c:pt idx="431">
                  <c:v>-2E-3</c:v>
                </c:pt>
                <c:pt idx="432">
                  <c:v>-1E-3</c:v>
                </c:pt>
                <c:pt idx="433">
                  <c:v>0</c:v>
                </c:pt>
                <c:pt idx="434">
                  <c:v>0</c:v>
                </c:pt>
                <c:pt idx="435">
                  <c:v>1E-3</c:v>
                </c:pt>
                <c:pt idx="436">
                  <c:v>2E-3</c:v>
                </c:pt>
                <c:pt idx="437">
                  <c:v>2E-3</c:v>
                </c:pt>
                <c:pt idx="438">
                  <c:v>3.0000000000000001E-3</c:v>
                </c:pt>
                <c:pt idx="439">
                  <c:v>4.0000000000000001E-3</c:v>
                </c:pt>
                <c:pt idx="440">
                  <c:v>5.0000000000000001E-3</c:v>
                </c:pt>
                <c:pt idx="441">
                  <c:v>6.0000000000000001E-3</c:v>
                </c:pt>
                <c:pt idx="442">
                  <c:v>7.0000000000000001E-3</c:v>
                </c:pt>
                <c:pt idx="443">
                  <c:v>7.0000000000000001E-3</c:v>
                </c:pt>
                <c:pt idx="444">
                  <c:v>8.0000000000000002E-3</c:v>
                </c:pt>
                <c:pt idx="445">
                  <c:v>8.9999999999999993E-3</c:v>
                </c:pt>
                <c:pt idx="446">
                  <c:v>8.9999999999999993E-3</c:v>
                </c:pt>
                <c:pt idx="447">
                  <c:v>0.01</c:v>
                </c:pt>
                <c:pt idx="448">
                  <c:v>1.0999999999999999E-2</c:v>
                </c:pt>
                <c:pt idx="449">
                  <c:v>1.0999999999999999E-2</c:v>
                </c:pt>
                <c:pt idx="450">
                  <c:v>1.2E-2</c:v>
                </c:pt>
                <c:pt idx="451">
                  <c:v>1.2999999999999999E-2</c:v>
                </c:pt>
                <c:pt idx="452">
                  <c:v>1.4E-2</c:v>
                </c:pt>
                <c:pt idx="453">
                  <c:v>1.4999999999999999E-2</c:v>
                </c:pt>
                <c:pt idx="454">
                  <c:v>1.4999999999999999E-2</c:v>
                </c:pt>
                <c:pt idx="455">
                  <c:v>1.6E-2</c:v>
                </c:pt>
                <c:pt idx="456">
                  <c:v>1.7000000000000001E-2</c:v>
                </c:pt>
                <c:pt idx="457">
                  <c:v>1.7000000000000001E-2</c:v>
                </c:pt>
                <c:pt idx="458">
                  <c:v>1.7999999999999999E-2</c:v>
                </c:pt>
                <c:pt idx="459">
                  <c:v>1.9E-2</c:v>
                </c:pt>
                <c:pt idx="460">
                  <c:v>1.9E-2</c:v>
                </c:pt>
                <c:pt idx="461">
                  <c:v>8.9999999999999993E-3</c:v>
                </c:pt>
                <c:pt idx="462">
                  <c:v>4.0000000000000001E-3</c:v>
                </c:pt>
                <c:pt idx="463">
                  <c:v>4.0000000000000001E-3</c:v>
                </c:pt>
                <c:pt idx="464">
                  <c:v>5.0000000000000001E-3</c:v>
                </c:pt>
                <c:pt idx="465">
                  <c:v>6.0000000000000001E-3</c:v>
                </c:pt>
                <c:pt idx="466">
                  <c:v>6.0000000000000001E-3</c:v>
                </c:pt>
                <c:pt idx="467">
                  <c:v>7.0000000000000001E-3</c:v>
                </c:pt>
                <c:pt idx="468">
                  <c:v>7.0000000000000001E-3</c:v>
                </c:pt>
                <c:pt idx="469">
                  <c:v>8.0000000000000002E-3</c:v>
                </c:pt>
                <c:pt idx="470">
                  <c:v>8.0000000000000002E-3</c:v>
                </c:pt>
                <c:pt idx="471">
                  <c:v>8.9999999999999993E-3</c:v>
                </c:pt>
                <c:pt idx="472">
                  <c:v>8.9999999999999993E-3</c:v>
                </c:pt>
                <c:pt idx="473">
                  <c:v>0.01</c:v>
                </c:pt>
                <c:pt idx="474">
                  <c:v>0.01</c:v>
                </c:pt>
                <c:pt idx="475">
                  <c:v>1.0999999999999999E-2</c:v>
                </c:pt>
                <c:pt idx="476">
                  <c:v>1.0999999999999999E-2</c:v>
                </c:pt>
                <c:pt idx="477">
                  <c:v>1.0999999999999999E-2</c:v>
                </c:pt>
                <c:pt idx="478">
                  <c:v>1.0999999999999999E-2</c:v>
                </c:pt>
                <c:pt idx="479">
                  <c:v>1.2E-2</c:v>
                </c:pt>
                <c:pt idx="480">
                  <c:v>1.2E-2</c:v>
                </c:pt>
                <c:pt idx="481">
                  <c:v>1.2E-2</c:v>
                </c:pt>
                <c:pt idx="482">
                  <c:v>1.2E-2</c:v>
                </c:pt>
                <c:pt idx="483">
                  <c:v>1.2E-2</c:v>
                </c:pt>
                <c:pt idx="484">
                  <c:v>1.2E-2</c:v>
                </c:pt>
                <c:pt idx="485">
                  <c:v>1.2E-2</c:v>
                </c:pt>
                <c:pt idx="486">
                  <c:v>1.2E-2</c:v>
                </c:pt>
                <c:pt idx="487">
                  <c:v>1.2E-2</c:v>
                </c:pt>
                <c:pt idx="488">
                  <c:v>1.2E-2</c:v>
                </c:pt>
                <c:pt idx="489">
                  <c:v>1.2E-2</c:v>
                </c:pt>
                <c:pt idx="490">
                  <c:v>1.0999999999999999E-2</c:v>
                </c:pt>
                <c:pt idx="491">
                  <c:v>1.0999999999999999E-2</c:v>
                </c:pt>
                <c:pt idx="492">
                  <c:v>1.0999999999999999E-2</c:v>
                </c:pt>
                <c:pt idx="493">
                  <c:v>0.01</c:v>
                </c:pt>
                <c:pt idx="494">
                  <c:v>0.01</c:v>
                </c:pt>
                <c:pt idx="495">
                  <c:v>0.01</c:v>
                </c:pt>
                <c:pt idx="496">
                  <c:v>0.01</c:v>
                </c:pt>
                <c:pt idx="497">
                  <c:v>8.9999999999999993E-3</c:v>
                </c:pt>
                <c:pt idx="498">
                  <c:v>8.9999999999999993E-3</c:v>
                </c:pt>
                <c:pt idx="499">
                  <c:v>8.9999999999999993E-3</c:v>
                </c:pt>
                <c:pt idx="500">
                  <c:v>8.9999999999999993E-3</c:v>
                </c:pt>
                <c:pt idx="501">
                  <c:v>8.9999999999999993E-3</c:v>
                </c:pt>
                <c:pt idx="502">
                  <c:v>0.01</c:v>
                </c:pt>
                <c:pt idx="503">
                  <c:v>0.01</c:v>
                </c:pt>
                <c:pt idx="504">
                  <c:v>1.0999999999999999E-2</c:v>
                </c:pt>
                <c:pt idx="505">
                  <c:v>1.0999999999999999E-2</c:v>
                </c:pt>
                <c:pt idx="506">
                  <c:v>1.2E-2</c:v>
                </c:pt>
                <c:pt idx="507">
                  <c:v>1.2999999999999999E-2</c:v>
                </c:pt>
                <c:pt idx="508">
                  <c:v>1.4E-2</c:v>
                </c:pt>
                <c:pt idx="509">
                  <c:v>1.4999999999999999E-2</c:v>
                </c:pt>
                <c:pt idx="510">
                  <c:v>1.6E-2</c:v>
                </c:pt>
                <c:pt idx="511">
                  <c:v>1.7000000000000001E-2</c:v>
                </c:pt>
                <c:pt idx="512">
                  <c:v>1.7999999999999999E-2</c:v>
                </c:pt>
                <c:pt idx="513">
                  <c:v>0.02</c:v>
                </c:pt>
                <c:pt idx="514">
                  <c:v>2.1000000000000001E-2</c:v>
                </c:pt>
                <c:pt idx="515">
                  <c:v>2.1999999999999999E-2</c:v>
                </c:pt>
                <c:pt idx="516">
                  <c:v>2.4E-2</c:v>
                </c:pt>
                <c:pt idx="517">
                  <c:v>2.5999999999999999E-2</c:v>
                </c:pt>
                <c:pt idx="518">
                  <c:v>2.7E-2</c:v>
                </c:pt>
                <c:pt idx="519">
                  <c:v>2.9000000000000001E-2</c:v>
                </c:pt>
                <c:pt idx="520">
                  <c:v>3.1E-2</c:v>
                </c:pt>
                <c:pt idx="521">
                  <c:v>3.3000000000000002E-2</c:v>
                </c:pt>
                <c:pt idx="522">
                  <c:v>3.5000000000000003E-2</c:v>
                </c:pt>
                <c:pt idx="523">
                  <c:v>3.6999999999999998E-2</c:v>
                </c:pt>
                <c:pt idx="524">
                  <c:v>3.9E-2</c:v>
                </c:pt>
                <c:pt idx="525">
                  <c:v>0.04</c:v>
                </c:pt>
                <c:pt idx="526">
                  <c:v>4.2000000000000003E-2</c:v>
                </c:pt>
                <c:pt idx="527">
                  <c:v>4.3999999999999997E-2</c:v>
                </c:pt>
                <c:pt idx="528">
                  <c:v>4.4999999999999998E-2</c:v>
                </c:pt>
                <c:pt idx="529">
                  <c:v>4.4999999999999998E-2</c:v>
                </c:pt>
                <c:pt idx="530">
                  <c:v>4.5999999999999999E-2</c:v>
                </c:pt>
                <c:pt idx="531">
                  <c:v>4.7E-2</c:v>
                </c:pt>
                <c:pt idx="532">
                  <c:v>4.7E-2</c:v>
                </c:pt>
                <c:pt idx="533">
                  <c:v>4.7E-2</c:v>
                </c:pt>
                <c:pt idx="534">
                  <c:v>4.5999999999999999E-2</c:v>
                </c:pt>
                <c:pt idx="535">
                  <c:v>4.5999999999999999E-2</c:v>
                </c:pt>
                <c:pt idx="536">
                  <c:v>4.5999999999999999E-2</c:v>
                </c:pt>
                <c:pt idx="537">
                  <c:v>4.4999999999999998E-2</c:v>
                </c:pt>
                <c:pt idx="538">
                  <c:v>4.3999999999999997E-2</c:v>
                </c:pt>
                <c:pt idx="539">
                  <c:v>4.3999999999999997E-2</c:v>
                </c:pt>
                <c:pt idx="540">
                  <c:v>4.2999999999999997E-2</c:v>
                </c:pt>
                <c:pt idx="541">
                  <c:v>4.2999999999999997E-2</c:v>
                </c:pt>
                <c:pt idx="542">
                  <c:v>4.2000000000000003E-2</c:v>
                </c:pt>
                <c:pt idx="543">
                  <c:v>4.1000000000000002E-2</c:v>
                </c:pt>
                <c:pt idx="544">
                  <c:v>0.04</c:v>
                </c:pt>
                <c:pt idx="545">
                  <c:v>0.04</c:v>
                </c:pt>
                <c:pt idx="546">
                  <c:v>3.9E-2</c:v>
                </c:pt>
                <c:pt idx="547">
                  <c:v>3.7999999999999999E-2</c:v>
                </c:pt>
                <c:pt idx="548">
                  <c:v>3.6999999999999998E-2</c:v>
                </c:pt>
                <c:pt idx="549">
                  <c:v>3.5999999999999997E-2</c:v>
                </c:pt>
                <c:pt idx="550">
                  <c:v>3.5000000000000003E-2</c:v>
                </c:pt>
                <c:pt idx="551">
                  <c:v>3.4000000000000002E-2</c:v>
                </c:pt>
                <c:pt idx="552">
                  <c:v>3.3000000000000002E-2</c:v>
                </c:pt>
                <c:pt idx="553">
                  <c:v>3.2000000000000001E-2</c:v>
                </c:pt>
                <c:pt idx="554">
                  <c:v>3.2000000000000001E-2</c:v>
                </c:pt>
                <c:pt idx="555">
                  <c:v>3.2000000000000001E-2</c:v>
                </c:pt>
                <c:pt idx="556">
                  <c:v>3.2000000000000001E-2</c:v>
                </c:pt>
                <c:pt idx="557">
                  <c:v>3.2000000000000001E-2</c:v>
                </c:pt>
                <c:pt idx="558">
                  <c:v>3.3000000000000002E-2</c:v>
                </c:pt>
                <c:pt idx="559">
                  <c:v>3.5000000000000003E-2</c:v>
                </c:pt>
                <c:pt idx="560">
                  <c:v>3.6999999999999998E-2</c:v>
                </c:pt>
                <c:pt idx="561">
                  <c:v>0.04</c:v>
                </c:pt>
                <c:pt idx="562">
                  <c:v>4.2999999999999997E-2</c:v>
                </c:pt>
                <c:pt idx="563">
                  <c:v>4.7E-2</c:v>
                </c:pt>
                <c:pt idx="564">
                  <c:v>5.0999999999999997E-2</c:v>
                </c:pt>
                <c:pt idx="565">
                  <c:v>5.7000000000000002E-2</c:v>
                </c:pt>
                <c:pt idx="566">
                  <c:v>6.3E-2</c:v>
                </c:pt>
                <c:pt idx="567">
                  <c:v>7.0000000000000007E-2</c:v>
                </c:pt>
                <c:pt idx="568">
                  <c:v>7.6999999999999999E-2</c:v>
                </c:pt>
                <c:pt idx="569">
                  <c:v>8.5999999999999993E-2</c:v>
                </c:pt>
                <c:pt idx="570">
                  <c:v>9.5000000000000001E-2</c:v>
                </c:pt>
                <c:pt idx="571">
                  <c:v>0.104</c:v>
                </c:pt>
                <c:pt idx="572">
                  <c:v>0.114</c:v>
                </c:pt>
                <c:pt idx="573">
                  <c:v>0.123</c:v>
                </c:pt>
                <c:pt idx="574">
                  <c:v>0.13300000000000001</c:v>
                </c:pt>
                <c:pt idx="575">
                  <c:v>0.14299999999999999</c:v>
                </c:pt>
                <c:pt idx="576">
                  <c:v>0.154</c:v>
                </c:pt>
                <c:pt idx="577">
                  <c:v>0.16500000000000001</c:v>
                </c:pt>
                <c:pt idx="578">
                  <c:v>0.17599999999999999</c:v>
                </c:pt>
                <c:pt idx="579">
                  <c:v>0.188</c:v>
                </c:pt>
                <c:pt idx="580">
                  <c:v>0.20100000000000001</c:v>
                </c:pt>
                <c:pt idx="581">
                  <c:v>0.215</c:v>
                </c:pt>
                <c:pt idx="582">
                  <c:v>0.22800000000000001</c:v>
                </c:pt>
                <c:pt idx="583">
                  <c:v>0.24299999999999999</c:v>
                </c:pt>
                <c:pt idx="584">
                  <c:v>0.25800000000000001</c:v>
                </c:pt>
                <c:pt idx="585">
                  <c:v>0.27400000000000002</c:v>
                </c:pt>
                <c:pt idx="586">
                  <c:v>0.28999999999999998</c:v>
                </c:pt>
                <c:pt idx="587">
                  <c:v>0.307</c:v>
                </c:pt>
                <c:pt idx="588">
                  <c:v>0.32400000000000001</c:v>
                </c:pt>
                <c:pt idx="589">
                  <c:v>0.34300000000000003</c:v>
                </c:pt>
                <c:pt idx="590">
                  <c:v>0.36199999999999999</c:v>
                </c:pt>
                <c:pt idx="591">
                  <c:v>0.38300000000000001</c:v>
                </c:pt>
                <c:pt idx="592">
                  <c:v>0.40500000000000003</c:v>
                </c:pt>
                <c:pt idx="593">
                  <c:v>0.42899999999999999</c:v>
                </c:pt>
                <c:pt idx="594">
                  <c:v>0.45600000000000002</c:v>
                </c:pt>
                <c:pt idx="595">
                  <c:v>0.48599999999999999</c:v>
                </c:pt>
                <c:pt idx="596">
                  <c:v>0.52100000000000002</c:v>
                </c:pt>
                <c:pt idx="597">
                  <c:v>0.55900000000000005</c:v>
                </c:pt>
                <c:pt idx="598">
                  <c:v>0.6</c:v>
                </c:pt>
                <c:pt idx="599">
                  <c:v>0.64500000000000002</c:v>
                </c:pt>
                <c:pt idx="600">
                  <c:v>0.691999999999999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E505-40FA-858A-3227CC8E4DA5}"/>
            </c:ext>
          </c:extLst>
        </c:ser>
        <c:ser>
          <c:idx val="1"/>
          <c:order val="1"/>
          <c:tx>
            <c:strRef>
              <c:f>'water-F'!$C$2</c:f>
              <c:strCache>
                <c:ptCount val="1"/>
                <c:pt idx="0">
                  <c:v>Kale </c:v>
                </c:pt>
              </c:strCache>
            </c:strRef>
          </c:tx>
          <c:marker>
            <c:symbol val="none"/>
          </c:marker>
          <c:xVal>
            <c:numRef>
              <c:f>'water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water-F'!$C$3:$C$603</c:f>
              <c:numCache>
                <c:formatCode>General</c:formatCode>
                <c:ptCount val="601"/>
                <c:pt idx="0">
                  <c:v>-1E-3</c:v>
                </c:pt>
                <c:pt idx="1">
                  <c:v>-1E-3</c:v>
                </c:pt>
                <c:pt idx="2">
                  <c:v>-1E-3</c:v>
                </c:pt>
                <c:pt idx="3">
                  <c:v>-1E-3</c:v>
                </c:pt>
                <c:pt idx="4">
                  <c:v>-1E-3</c:v>
                </c:pt>
                <c:pt idx="5">
                  <c:v>-1E-3</c:v>
                </c:pt>
                <c:pt idx="6">
                  <c:v>-1E-3</c:v>
                </c:pt>
                <c:pt idx="7">
                  <c:v>-2E-3</c:v>
                </c:pt>
                <c:pt idx="8">
                  <c:v>-2E-3</c:v>
                </c:pt>
                <c:pt idx="9">
                  <c:v>-2E-3</c:v>
                </c:pt>
                <c:pt idx="10">
                  <c:v>-2E-3</c:v>
                </c:pt>
                <c:pt idx="11">
                  <c:v>-2E-3</c:v>
                </c:pt>
                <c:pt idx="12">
                  <c:v>-2E-3</c:v>
                </c:pt>
                <c:pt idx="13">
                  <c:v>-3.0000000000000001E-3</c:v>
                </c:pt>
                <c:pt idx="14">
                  <c:v>-3.0000000000000001E-3</c:v>
                </c:pt>
                <c:pt idx="15">
                  <c:v>-3.0000000000000001E-3</c:v>
                </c:pt>
                <c:pt idx="16">
                  <c:v>-3.0000000000000001E-3</c:v>
                </c:pt>
                <c:pt idx="17">
                  <c:v>-3.0000000000000001E-3</c:v>
                </c:pt>
                <c:pt idx="18">
                  <c:v>-3.0000000000000001E-3</c:v>
                </c:pt>
                <c:pt idx="19">
                  <c:v>-4.0000000000000001E-3</c:v>
                </c:pt>
                <c:pt idx="20">
                  <c:v>-4.0000000000000001E-3</c:v>
                </c:pt>
                <c:pt idx="21">
                  <c:v>-4.0000000000000001E-3</c:v>
                </c:pt>
                <c:pt idx="22">
                  <c:v>-4.0000000000000001E-3</c:v>
                </c:pt>
                <c:pt idx="23">
                  <c:v>-4.0000000000000001E-3</c:v>
                </c:pt>
                <c:pt idx="24">
                  <c:v>-4.0000000000000001E-3</c:v>
                </c:pt>
                <c:pt idx="25">
                  <c:v>-4.0000000000000001E-3</c:v>
                </c:pt>
                <c:pt idx="26">
                  <c:v>-5.0000000000000001E-3</c:v>
                </c:pt>
                <c:pt idx="27">
                  <c:v>-5.0000000000000001E-3</c:v>
                </c:pt>
                <c:pt idx="28">
                  <c:v>-5.0000000000000001E-3</c:v>
                </c:pt>
                <c:pt idx="29">
                  <c:v>-5.0000000000000001E-3</c:v>
                </c:pt>
                <c:pt idx="30">
                  <c:v>-5.0000000000000001E-3</c:v>
                </c:pt>
                <c:pt idx="31">
                  <c:v>-5.0000000000000001E-3</c:v>
                </c:pt>
                <c:pt idx="32">
                  <c:v>-5.0000000000000001E-3</c:v>
                </c:pt>
                <c:pt idx="33">
                  <c:v>-5.0000000000000001E-3</c:v>
                </c:pt>
                <c:pt idx="34">
                  <c:v>-6.0000000000000001E-3</c:v>
                </c:pt>
                <c:pt idx="35">
                  <c:v>-6.0000000000000001E-3</c:v>
                </c:pt>
                <c:pt idx="36">
                  <c:v>-6.0000000000000001E-3</c:v>
                </c:pt>
                <c:pt idx="37">
                  <c:v>-6.0000000000000001E-3</c:v>
                </c:pt>
                <c:pt idx="38">
                  <c:v>-6.0000000000000001E-3</c:v>
                </c:pt>
                <c:pt idx="39">
                  <c:v>-6.0000000000000001E-3</c:v>
                </c:pt>
                <c:pt idx="40">
                  <c:v>-6.0000000000000001E-3</c:v>
                </c:pt>
                <c:pt idx="41">
                  <c:v>-6.0000000000000001E-3</c:v>
                </c:pt>
                <c:pt idx="42">
                  <c:v>-7.0000000000000001E-3</c:v>
                </c:pt>
                <c:pt idx="43">
                  <c:v>-7.0000000000000001E-3</c:v>
                </c:pt>
                <c:pt idx="44">
                  <c:v>-7.0000000000000001E-3</c:v>
                </c:pt>
                <c:pt idx="45">
                  <c:v>-7.0000000000000001E-3</c:v>
                </c:pt>
                <c:pt idx="46">
                  <c:v>-7.0000000000000001E-3</c:v>
                </c:pt>
                <c:pt idx="47">
                  <c:v>-7.0000000000000001E-3</c:v>
                </c:pt>
                <c:pt idx="48">
                  <c:v>-7.0000000000000001E-3</c:v>
                </c:pt>
                <c:pt idx="49">
                  <c:v>-7.0000000000000001E-3</c:v>
                </c:pt>
                <c:pt idx="50">
                  <c:v>-7.0000000000000001E-3</c:v>
                </c:pt>
                <c:pt idx="51">
                  <c:v>-7.0000000000000001E-3</c:v>
                </c:pt>
                <c:pt idx="52">
                  <c:v>-7.0000000000000001E-3</c:v>
                </c:pt>
                <c:pt idx="53">
                  <c:v>-8.0000000000000002E-3</c:v>
                </c:pt>
                <c:pt idx="54">
                  <c:v>-8.0000000000000002E-3</c:v>
                </c:pt>
                <c:pt idx="55">
                  <c:v>-8.9999999999999993E-3</c:v>
                </c:pt>
                <c:pt idx="56">
                  <c:v>-8.9999999999999993E-3</c:v>
                </c:pt>
                <c:pt idx="57">
                  <c:v>-0.01</c:v>
                </c:pt>
                <c:pt idx="58">
                  <c:v>-1.2E-2</c:v>
                </c:pt>
                <c:pt idx="59">
                  <c:v>-1.2999999999999999E-2</c:v>
                </c:pt>
                <c:pt idx="60">
                  <c:v>-1.4E-2</c:v>
                </c:pt>
                <c:pt idx="61">
                  <c:v>-1.4999999999999999E-2</c:v>
                </c:pt>
                <c:pt idx="62">
                  <c:v>-1.6E-2</c:v>
                </c:pt>
                <c:pt idx="63">
                  <c:v>-1.6E-2</c:v>
                </c:pt>
                <c:pt idx="64">
                  <c:v>-1.6E-2</c:v>
                </c:pt>
                <c:pt idx="65">
                  <c:v>-1.6E-2</c:v>
                </c:pt>
                <c:pt idx="66">
                  <c:v>-1.6E-2</c:v>
                </c:pt>
                <c:pt idx="67">
                  <c:v>-1.6E-2</c:v>
                </c:pt>
                <c:pt idx="68">
                  <c:v>-1.6E-2</c:v>
                </c:pt>
                <c:pt idx="69">
                  <c:v>-1.6E-2</c:v>
                </c:pt>
                <c:pt idx="70">
                  <c:v>-1.6E-2</c:v>
                </c:pt>
                <c:pt idx="71">
                  <c:v>-1.6E-2</c:v>
                </c:pt>
                <c:pt idx="72">
                  <c:v>-1.6E-2</c:v>
                </c:pt>
                <c:pt idx="73">
                  <c:v>-1.6E-2</c:v>
                </c:pt>
                <c:pt idx="74">
                  <c:v>-1.6E-2</c:v>
                </c:pt>
                <c:pt idx="75">
                  <c:v>-1.6E-2</c:v>
                </c:pt>
                <c:pt idx="76">
                  <c:v>-1.6E-2</c:v>
                </c:pt>
                <c:pt idx="77">
                  <c:v>-1.7000000000000001E-2</c:v>
                </c:pt>
                <c:pt idx="78">
                  <c:v>-1.7000000000000001E-2</c:v>
                </c:pt>
                <c:pt idx="79">
                  <c:v>-1.7000000000000001E-2</c:v>
                </c:pt>
                <c:pt idx="80">
                  <c:v>-1.7000000000000001E-2</c:v>
                </c:pt>
                <c:pt idx="81">
                  <c:v>-1.7000000000000001E-2</c:v>
                </c:pt>
                <c:pt idx="82">
                  <c:v>-1.7000000000000001E-2</c:v>
                </c:pt>
                <c:pt idx="83">
                  <c:v>-1.7000000000000001E-2</c:v>
                </c:pt>
                <c:pt idx="84">
                  <c:v>-1.7000000000000001E-2</c:v>
                </c:pt>
                <c:pt idx="85">
                  <c:v>-1.7000000000000001E-2</c:v>
                </c:pt>
                <c:pt idx="86">
                  <c:v>-1.7000000000000001E-2</c:v>
                </c:pt>
                <c:pt idx="87">
                  <c:v>-1.7999999999999999E-2</c:v>
                </c:pt>
                <c:pt idx="88">
                  <c:v>-1.7999999999999999E-2</c:v>
                </c:pt>
                <c:pt idx="89">
                  <c:v>-1.7999999999999999E-2</c:v>
                </c:pt>
                <c:pt idx="90">
                  <c:v>-1.7999999999999999E-2</c:v>
                </c:pt>
                <c:pt idx="91">
                  <c:v>-1.7999999999999999E-2</c:v>
                </c:pt>
                <c:pt idx="92">
                  <c:v>-1.7999999999999999E-2</c:v>
                </c:pt>
                <c:pt idx="93">
                  <c:v>-1.7999999999999999E-2</c:v>
                </c:pt>
                <c:pt idx="94">
                  <c:v>-1.7999999999999999E-2</c:v>
                </c:pt>
                <c:pt idx="95">
                  <c:v>-1.7999999999999999E-2</c:v>
                </c:pt>
                <c:pt idx="96">
                  <c:v>-1.7999999999999999E-2</c:v>
                </c:pt>
                <c:pt idx="97">
                  <c:v>-1.7999999999999999E-2</c:v>
                </c:pt>
                <c:pt idx="98">
                  <c:v>-1.9E-2</c:v>
                </c:pt>
                <c:pt idx="99">
                  <c:v>-1.9E-2</c:v>
                </c:pt>
                <c:pt idx="100">
                  <c:v>-1.9E-2</c:v>
                </c:pt>
                <c:pt idx="101">
                  <c:v>-1.9E-2</c:v>
                </c:pt>
                <c:pt idx="102">
                  <c:v>-1.9E-2</c:v>
                </c:pt>
                <c:pt idx="103">
                  <c:v>-1.9E-2</c:v>
                </c:pt>
                <c:pt idx="104">
                  <c:v>-1.9E-2</c:v>
                </c:pt>
                <c:pt idx="105">
                  <c:v>-1.9E-2</c:v>
                </c:pt>
                <c:pt idx="106">
                  <c:v>-1.9E-2</c:v>
                </c:pt>
                <c:pt idx="107">
                  <c:v>-1.9E-2</c:v>
                </c:pt>
                <c:pt idx="108">
                  <c:v>-1.9E-2</c:v>
                </c:pt>
                <c:pt idx="109">
                  <c:v>-1.9E-2</c:v>
                </c:pt>
                <c:pt idx="110">
                  <c:v>-1.9E-2</c:v>
                </c:pt>
                <c:pt idx="111">
                  <c:v>-1.9E-2</c:v>
                </c:pt>
                <c:pt idx="112">
                  <c:v>-1.9E-2</c:v>
                </c:pt>
                <c:pt idx="113">
                  <c:v>-1.9E-2</c:v>
                </c:pt>
                <c:pt idx="114">
                  <c:v>-1.9E-2</c:v>
                </c:pt>
                <c:pt idx="115">
                  <c:v>-1.9E-2</c:v>
                </c:pt>
                <c:pt idx="116">
                  <c:v>-0.02</c:v>
                </c:pt>
                <c:pt idx="117">
                  <c:v>-0.02</c:v>
                </c:pt>
                <c:pt idx="118">
                  <c:v>-0.02</c:v>
                </c:pt>
                <c:pt idx="119">
                  <c:v>-0.02</c:v>
                </c:pt>
                <c:pt idx="120">
                  <c:v>-0.02</c:v>
                </c:pt>
                <c:pt idx="121">
                  <c:v>-0.02</c:v>
                </c:pt>
                <c:pt idx="122">
                  <c:v>-0.02</c:v>
                </c:pt>
                <c:pt idx="123">
                  <c:v>-0.02</c:v>
                </c:pt>
                <c:pt idx="124">
                  <c:v>-0.02</c:v>
                </c:pt>
                <c:pt idx="125">
                  <c:v>-0.02</c:v>
                </c:pt>
                <c:pt idx="126">
                  <c:v>-0.02</c:v>
                </c:pt>
                <c:pt idx="127">
                  <c:v>-2.1000000000000001E-2</c:v>
                </c:pt>
                <c:pt idx="128">
                  <c:v>-2.1000000000000001E-2</c:v>
                </c:pt>
                <c:pt idx="129">
                  <c:v>-2.1000000000000001E-2</c:v>
                </c:pt>
                <c:pt idx="130">
                  <c:v>-2.1000000000000001E-2</c:v>
                </c:pt>
                <c:pt idx="131">
                  <c:v>-2.1000000000000001E-2</c:v>
                </c:pt>
                <c:pt idx="132">
                  <c:v>-2.1000000000000001E-2</c:v>
                </c:pt>
                <c:pt idx="133">
                  <c:v>-2.1000000000000001E-2</c:v>
                </c:pt>
                <c:pt idx="134">
                  <c:v>-2.1000000000000001E-2</c:v>
                </c:pt>
                <c:pt idx="135">
                  <c:v>-2.1000000000000001E-2</c:v>
                </c:pt>
                <c:pt idx="136">
                  <c:v>-2.1000000000000001E-2</c:v>
                </c:pt>
                <c:pt idx="137">
                  <c:v>-2.1999999999999999E-2</c:v>
                </c:pt>
                <c:pt idx="138">
                  <c:v>-2.1999999999999999E-2</c:v>
                </c:pt>
                <c:pt idx="139">
                  <c:v>-2.1999999999999999E-2</c:v>
                </c:pt>
                <c:pt idx="140">
                  <c:v>-2.1999999999999999E-2</c:v>
                </c:pt>
                <c:pt idx="141">
                  <c:v>-2.1999999999999999E-2</c:v>
                </c:pt>
                <c:pt idx="142">
                  <c:v>-2.1999999999999999E-2</c:v>
                </c:pt>
                <c:pt idx="143">
                  <c:v>-2.1999999999999999E-2</c:v>
                </c:pt>
                <c:pt idx="144">
                  <c:v>-2.1999999999999999E-2</c:v>
                </c:pt>
                <c:pt idx="145">
                  <c:v>-2.1999999999999999E-2</c:v>
                </c:pt>
                <c:pt idx="146">
                  <c:v>-2.1999999999999999E-2</c:v>
                </c:pt>
                <c:pt idx="147">
                  <c:v>-2.1999999999999999E-2</c:v>
                </c:pt>
                <c:pt idx="148">
                  <c:v>-2.1999999999999999E-2</c:v>
                </c:pt>
                <c:pt idx="149">
                  <c:v>-2.3E-2</c:v>
                </c:pt>
                <c:pt idx="150">
                  <c:v>-2.3E-2</c:v>
                </c:pt>
                <c:pt idx="151">
                  <c:v>-2.3E-2</c:v>
                </c:pt>
                <c:pt idx="152">
                  <c:v>-2.3E-2</c:v>
                </c:pt>
                <c:pt idx="153">
                  <c:v>-2.3E-2</c:v>
                </c:pt>
                <c:pt idx="154">
                  <c:v>-2.3E-2</c:v>
                </c:pt>
                <c:pt idx="155">
                  <c:v>-2.3E-2</c:v>
                </c:pt>
                <c:pt idx="156">
                  <c:v>-2.3E-2</c:v>
                </c:pt>
                <c:pt idx="157">
                  <c:v>-2.3E-2</c:v>
                </c:pt>
                <c:pt idx="158">
                  <c:v>-2.3E-2</c:v>
                </c:pt>
                <c:pt idx="159">
                  <c:v>-2.3E-2</c:v>
                </c:pt>
                <c:pt idx="160">
                  <c:v>-2.3E-2</c:v>
                </c:pt>
                <c:pt idx="161">
                  <c:v>-2.3E-2</c:v>
                </c:pt>
                <c:pt idx="162">
                  <c:v>-2.3E-2</c:v>
                </c:pt>
                <c:pt idx="163">
                  <c:v>-2.3E-2</c:v>
                </c:pt>
                <c:pt idx="164">
                  <c:v>-2.3E-2</c:v>
                </c:pt>
                <c:pt idx="165">
                  <c:v>-2.3E-2</c:v>
                </c:pt>
                <c:pt idx="166">
                  <c:v>-2.4E-2</c:v>
                </c:pt>
                <c:pt idx="167">
                  <c:v>-2.4E-2</c:v>
                </c:pt>
                <c:pt idx="168">
                  <c:v>-2.4E-2</c:v>
                </c:pt>
                <c:pt idx="169">
                  <c:v>-2.4E-2</c:v>
                </c:pt>
                <c:pt idx="170">
                  <c:v>-2.4E-2</c:v>
                </c:pt>
                <c:pt idx="171">
                  <c:v>-2.4E-2</c:v>
                </c:pt>
                <c:pt idx="172">
                  <c:v>-2.4E-2</c:v>
                </c:pt>
                <c:pt idx="173">
                  <c:v>-2.4E-2</c:v>
                </c:pt>
                <c:pt idx="174">
                  <c:v>-2.4E-2</c:v>
                </c:pt>
                <c:pt idx="175">
                  <c:v>-2.4E-2</c:v>
                </c:pt>
                <c:pt idx="176">
                  <c:v>-2.4E-2</c:v>
                </c:pt>
                <c:pt idx="177">
                  <c:v>-2.4E-2</c:v>
                </c:pt>
                <c:pt idx="178">
                  <c:v>-2.4E-2</c:v>
                </c:pt>
                <c:pt idx="179">
                  <c:v>-2.4E-2</c:v>
                </c:pt>
                <c:pt idx="180">
                  <c:v>-2.4E-2</c:v>
                </c:pt>
                <c:pt idx="181">
                  <c:v>-2.4E-2</c:v>
                </c:pt>
                <c:pt idx="182">
                  <c:v>-2.4E-2</c:v>
                </c:pt>
                <c:pt idx="183">
                  <c:v>-2.4E-2</c:v>
                </c:pt>
                <c:pt idx="184">
                  <c:v>-2.4E-2</c:v>
                </c:pt>
                <c:pt idx="185">
                  <c:v>-2.4E-2</c:v>
                </c:pt>
                <c:pt idx="186">
                  <c:v>-2.4E-2</c:v>
                </c:pt>
                <c:pt idx="187">
                  <c:v>-2.4E-2</c:v>
                </c:pt>
                <c:pt idx="188">
                  <c:v>-2.4E-2</c:v>
                </c:pt>
                <c:pt idx="189">
                  <c:v>-2.4E-2</c:v>
                </c:pt>
                <c:pt idx="190">
                  <c:v>-2.4E-2</c:v>
                </c:pt>
                <c:pt idx="191">
                  <c:v>-2.4E-2</c:v>
                </c:pt>
                <c:pt idx="192">
                  <c:v>-2.4E-2</c:v>
                </c:pt>
                <c:pt idx="193">
                  <c:v>-2.4E-2</c:v>
                </c:pt>
                <c:pt idx="194">
                  <c:v>-2.4E-2</c:v>
                </c:pt>
                <c:pt idx="195">
                  <c:v>-2.4E-2</c:v>
                </c:pt>
                <c:pt idx="196">
                  <c:v>-2.4E-2</c:v>
                </c:pt>
                <c:pt idx="197">
                  <c:v>-2.4E-2</c:v>
                </c:pt>
                <c:pt idx="198">
                  <c:v>-2.4E-2</c:v>
                </c:pt>
                <c:pt idx="199">
                  <c:v>-2.4E-2</c:v>
                </c:pt>
                <c:pt idx="200">
                  <c:v>-2.5000000000000001E-2</c:v>
                </c:pt>
                <c:pt idx="201">
                  <c:v>-2.5000000000000001E-2</c:v>
                </c:pt>
                <c:pt idx="202">
                  <c:v>-2.5000000000000001E-2</c:v>
                </c:pt>
                <c:pt idx="203">
                  <c:v>-2.5000000000000001E-2</c:v>
                </c:pt>
                <c:pt idx="204">
                  <c:v>-2.5000000000000001E-2</c:v>
                </c:pt>
                <c:pt idx="205">
                  <c:v>-2.5000000000000001E-2</c:v>
                </c:pt>
                <c:pt idx="206">
                  <c:v>-2.5000000000000001E-2</c:v>
                </c:pt>
                <c:pt idx="207">
                  <c:v>-2.5000000000000001E-2</c:v>
                </c:pt>
                <c:pt idx="208">
                  <c:v>-2.5999999999999999E-2</c:v>
                </c:pt>
                <c:pt idx="209">
                  <c:v>-2.5999999999999999E-2</c:v>
                </c:pt>
                <c:pt idx="210">
                  <c:v>-2.5999999999999999E-2</c:v>
                </c:pt>
                <c:pt idx="211">
                  <c:v>-2.5999999999999999E-2</c:v>
                </c:pt>
                <c:pt idx="212">
                  <c:v>-2.5999999999999999E-2</c:v>
                </c:pt>
                <c:pt idx="213">
                  <c:v>-2.5999999999999999E-2</c:v>
                </c:pt>
                <c:pt idx="214">
                  <c:v>-2.7E-2</c:v>
                </c:pt>
                <c:pt idx="215">
                  <c:v>-2.7E-2</c:v>
                </c:pt>
                <c:pt idx="216">
                  <c:v>-2.8000000000000001E-2</c:v>
                </c:pt>
                <c:pt idx="217">
                  <c:v>-2.8000000000000001E-2</c:v>
                </c:pt>
                <c:pt idx="218">
                  <c:v>-2.9000000000000001E-2</c:v>
                </c:pt>
                <c:pt idx="219">
                  <c:v>-2.9000000000000001E-2</c:v>
                </c:pt>
                <c:pt idx="220">
                  <c:v>-0.03</c:v>
                </c:pt>
                <c:pt idx="221">
                  <c:v>-0.03</c:v>
                </c:pt>
                <c:pt idx="222">
                  <c:v>-0.03</c:v>
                </c:pt>
                <c:pt idx="223">
                  <c:v>-0.03</c:v>
                </c:pt>
                <c:pt idx="224">
                  <c:v>-2.9000000000000001E-2</c:v>
                </c:pt>
                <c:pt idx="225">
                  <c:v>-2.9000000000000001E-2</c:v>
                </c:pt>
                <c:pt idx="226">
                  <c:v>-2.9000000000000001E-2</c:v>
                </c:pt>
                <c:pt idx="227">
                  <c:v>-2.9000000000000001E-2</c:v>
                </c:pt>
                <c:pt idx="228">
                  <c:v>-2.9000000000000001E-2</c:v>
                </c:pt>
                <c:pt idx="229">
                  <c:v>-2.9000000000000001E-2</c:v>
                </c:pt>
                <c:pt idx="230">
                  <c:v>-2.9000000000000001E-2</c:v>
                </c:pt>
                <c:pt idx="231">
                  <c:v>-2.9000000000000001E-2</c:v>
                </c:pt>
                <c:pt idx="232">
                  <c:v>-2.9000000000000001E-2</c:v>
                </c:pt>
                <c:pt idx="233">
                  <c:v>-2.9000000000000001E-2</c:v>
                </c:pt>
                <c:pt idx="234">
                  <c:v>-2.9000000000000001E-2</c:v>
                </c:pt>
                <c:pt idx="235">
                  <c:v>-2.8000000000000001E-2</c:v>
                </c:pt>
                <c:pt idx="236">
                  <c:v>-2.8000000000000001E-2</c:v>
                </c:pt>
                <c:pt idx="237">
                  <c:v>-2.8000000000000001E-2</c:v>
                </c:pt>
                <c:pt idx="238">
                  <c:v>-2.8000000000000001E-2</c:v>
                </c:pt>
                <c:pt idx="239">
                  <c:v>-2.8000000000000001E-2</c:v>
                </c:pt>
                <c:pt idx="240">
                  <c:v>-2.8000000000000001E-2</c:v>
                </c:pt>
                <c:pt idx="241">
                  <c:v>-2.8000000000000001E-2</c:v>
                </c:pt>
                <c:pt idx="242">
                  <c:v>-2.8000000000000001E-2</c:v>
                </c:pt>
                <c:pt idx="243">
                  <c:v>-2.8000000000000001E-2</c:v>
                </c:pt>
                <c:pt idx="244">
                  <c:v>-2.8000000000000001E-2</c:v>
                </c:pt>
                <c:pt idx="245">
                  <c:v>-2.8000000000000001E-2</c:v>
                </c:pt>
                <c:pt idx="246">
                  <c:v>-2.8000000000000001E-2</c:v>
                </c:pt>
                <c:pt idx="247">
                  <c:v>-2.8000000000000001E-2</c:v>
                </c:pt>
                <c:pt idx="248">
                  <c:v>-2.8000000000000001E-2</c:v>
                </c:pt>
                <c:pt idx="249">
                  <c:v>-2.8000000000000001E-2</c:v>
                </c:pt>
                <c:pt idx="250">
                  <c:v>-2.8000000000000001E-2</c:v>
                </c:pt>
                <c:pt idx="251">
                  <c:v>-2.8000000000000001E-2</c:v>
                </c:pt>
                <c:pt idx="252">
                  <c:v>-2.8000000000000001E-2</c:v>
                </c:pt>
                <c:pt idx="253">
                  <c:v>-2.8000000000000001E-2</c:v>
                </c:pt>
                <c:pt idx="254">
                  <c:v>-2.8000000000000001E-2</c:v>
                </c:pt>
                <c:pt idx="255">
                  <c:v>-2.8000000000000001E-2</c:v>
                </c:pt>
                <c:pt idx="256">
                  <c:v>-2.9000000000000001E-2</c:v>
                </c:pt>
                <c:pt idx="257">
                  <c:v>-2.8000000000000001E-2</c:v>
                </c:pt>
                <c:pt idx="258">
                  <c:v>-2.9000000000000001E-2</c:v>
                </c:pt>
                <c:pt idx="259">
                  <c:v>-2.9000000000000001E-2</c:v>
                </c:pt>
                <c:pt idx="260">
                  <c:v>-2.9000000000000001E-2</c:v>
                </c:pt>
                <c:pt idx="261">
                  <c:v>-2.9000000000000001E-2</c:v>
                </c:pt>
                <c:pt idx="262">
                  <c:v>-2.9000000000000001E-2</c:v>
                </c:pt>
                <c:pt idx="263">
                  <c:v>-2.9000000000000001E-2</c:v>
                </c:pt>
                <c:pt idx="264">
                  <c:v>-2.9000000000000001E-2</c:v>
                </c:pt>
                <c:pt idx="265">
                  <c:v>-2.9000000000000001E-2</c:v>
                </c:pt>
                <c:pt idx="266">
                  <c:v>-2.9000000000000001E-2</c:v>
                </c:pt>
                <c:pt idx="267">
                  <c:v>-2.9000000000000001E-2</c:v>
                </c:pt>
                <c:pt idx="268">
                  <c:v>-2.9000000000000001E-2</c:v>
                </c:pt>
                <c:pt idx="269">
                  <c:v>-2.9000000000000001E-2</c:v>
                </c:pt>
                <c:pt idx="270">
                  <c:v>-2.9000000000000001E-2</c:v>
                </c:pt>
                <c:pt idx="271">
                  <c:v>-2.9000000000000001E-2</c:v>
                </c:pt>
                <c:pt idx="272">
                  <c:v>-2.9000000000000001E-2</c:v>
                </c:pt>
                <c:pt idx="273">
                  <c:v>-2.9000000000000001E-2</c:v>
                </c:pt>
                <c:pt idx="274">
                  <c:v>-2.9000000000000001E-2</c:v>
                </c:pt>
                <c:pt idx="275">
                  <c:v>-2.9000000000000001E-2</c:v>
                </c:pt>
                <c:pt idx="276">
                  <c:v>-0.03</c:v>
                </c:pt>
                <c:pt idx="277">
                  <c:v>-0.03</c:v>
                </c:pt>
                <c:pt idx="278">
                  <c:v>-0.03</c:v>
                </c:pt>
                <c:pt idx="279">
                  <c:v>-0.03</c:v>
                </c:pt>
                <c:pt idx="280">
                  <c:v>-0.03</c:v>
                </c:pt>
                <c:pt idx="281">
                  <c:v>-0.03</c:v>
                </c:pt>
                <c:pt idx="282">
                  <c:v>-0.03</c:v>
                </c:pt>
                <c:pt idx="283">
                  <c:v>-0.03</c:v>
                </c:pt>
                <c:pt idx="284">
                  <c:v>-0.03</c:v>
                </c:pt>
                <c:pt idx="285">
                  <c:v>-3.1E-2</c:v>
                </c:pt>
                <c:pt idx="286">
                  <c:v>-3.1E-2</c:v>
                </c:pt>
                <c:pt idx="287">
                  <c:v>-3.1E-2</c:v>
                </c:pt>
                <c:pt idx="288">
                  <c:v>-3.1E-2</c:v>
                </c:pt>
                <c:pt idx="289">
                  <c:v>-3.1E-2</c:v>
                </c:pt>
                <c:pt idx="290">
                  <c:v>-3.1E-2</c:v>
                </c:pt>
                <c:pt idx="291">
                  <c:v>-3.1E-2</c:v>
                </c:pt>
                <c:pt idx="292">
                  <c:v>-3.1E-2</c:v>
                </c:pt>
                <c:pt idx="293">
                  <c:v>-3.2000000000000001E-2</c:v>
                </c:pt>
                <c:pt idx="294">
                  <c:v>-3.2000000000000001E-2</c:v>
                </c:pt>
                <c:pt idx="295">
                  <c:v>-3.2000000000000001E-2</c:v>
                </c:pt>
                <c:pt idx="296">
                  <c:v>-3.2000000000000001E-2</c:v>
                </c:pt>
                <c:pt idx="297">
                  <c:v>-3.2000000000000001E-2</c:v>
                </c:pt>
                <c:pt idx="298">
                  <c:v>-3.2000000000000001E-2</c:v>
                </c:pt>
                <c:pt idx="299">
                  <c:v>-3.2000000000000001E-2</c:v>
                </c:pt>
                <c:pt idx="300">
                  <c:v>-3.2000000000000001E-2</c:v>
                </c:pt>
                <c:pt idx="301">
                  <c:v>-3.2000000000000001E-2</c:v>
                </c:pt>
                <c:pt idx="302">
                  <c:v>-3.2000000000000001E-2</c:v>
                </c:pt>
                <c:pt idx="303">
                  <c:v>-3.2000000000000001E-2</c:v>
                </c:pt>
                <c:pt idx="304">
                  <c:v>-3.2000000000000001E-2</c:v>
                </c:pt>
                <c:pt idx="305">
                  <c:v>-3.2000000000000001E-2</c:v>
                </c:pt>
                <c:pt idx="306">
                  <c:v>-3.2000000000000001E-2</c:v>
                </c:pt>
                <c:pt idx="307">
                  <c:v>-3.2000000000000001E-2</c:v>
                </c:pt>
                <c:pt idx="308">
                  <c:v>-3.2000000000000001E-2</c:v>
                </c:pt>
                <c:pt idx="309">
                  <c:v>-3.2000000000000001E-2</c:v>
                </c:pt>
                <c:pt idx="310">
                  <c:v>-3.2000000000000001E-2</c:v>
                </c:pt>
                <c:pt idx="311">
                  <c:v>-3.1E-2</c:v>
                </c:pt>
                <c:pt idx="312">
                  <c:v>-3.1E-2</c:v>
                </c:pt>
                <c:pt idx="313">
                  <c:v>-3.1E-2</c:v>
                </c:pt>
                <c:pt idx="314">
                  <c:v>-3.1E-2</c:v>
                </c:pt>
                <c:pt idx="315">
                  <c:v>-3.1E-2</c:v>
                </c:pt>
                <c:pt idx="316">
                  <c:v>-3.1E-2</c:v>
                </c:pt>
                <c:pt idx="317">
                  <c:v>-3.1E-2</c:v>
                </c:pt>
                <c:pt idx="318">
                  <c:v>-3.1E-2</c:v>
                </c:pt>
                <c:pt idx="319">
                  <c:v>-3.2000000000000001E-2</c:v>
                </c:pt>
                <c:pt idx="320">
                  <c:v>-3.2000000000000001E-2</c:v>
                </c:pt>
                <c:pt idx="321">
                  <c:v>-3.2000000000000001E-2</c:v>
                </c:pt>
                <c:pt idx="322">
                  <c:v>-3.2000000000000001E-2</c:v>
                </c:pt>
                <c:pt idx="323">
                  <c:v>-3.3000000000000002E-2</c:v>
                </c:pt>
                <c:pt idx="324">
                  <c:v>-3.3000000000000002E-2</c:v>
                </c:pt>
                <c:pt idx="325">
                  <c:v>-3.3000000000000002E-2</c:v>
                </c:pt>
                <c:pt idx="326">
                  <c:v>-3.3000000000000002E-2</c:v>
                </c:pt>
                <c:pt idx="327">
                  <c:v>-3.3000000000000002E-2</c:v>
                </c:pt>
                <c:pt idx="328">
                  <c:v>-3.3000000000000002E-2</c:v>
                </c:pt>
                <c:pt idx="329">
                  <c:v>-3.3000000000000002E-2</c:v>
                </c:pt>
                <c:pt idx="330">
                  <c:v>-3.3000000000000002E-2</c:v>
                </c:pt>
                <c:pt idx="331">
                  <c:v>-3.3000000000000002E-2</c:v>
                </c:pt>
                <c:pt idx="332">
                  <c:v>-3.3000000000000002E-2</c:v>
                </c:pt>
                <c:pt idx="333">
                  <c:v>-3.3000000000000002E-2</c:v>
                </c:pt>
                <c:pt idx="334">
                  <c:v>-3.3000000000000002E-2</c:v>
                </c:pt>
                <c:pt idx="335">
                  <c:v>-3.3000000000000002E-2</c:v>
                </c:pt>
                <c:pt idx="336">
                  <c:v>-3.3000000000000002E-2</c:v>
                </c:pt>
                <c:pt idx="337">
                  <c:v>-3.3000000000000002E-2</c:v>
                </c:pt>
                <c:pt idx="338">
                  <c:v>-3.3000000000000002E-2</c:v>
                </c:pt>
                <c:pt idx="339">
                  <c:v>-3.3000000000000002E-2</c:v>
                </c:pt>
                <c:pt idx="340">
                  <c:v>-3.3000000000000002E-2</c:v>
                </c:pt>
                <c:pt idx="341">
                  <c:v>-3.3000000000000002E-2</c:v>
                </c:pt>
                <c:pt idx="342">
                  <c:v>-3.3000000000000002E-2</c:v>
                </c:pt>
                <c:pt idx="343">
                  <c:v>-3.4000000000000002E-2</c:v>
                </c:pt>
                <c:pt idx="344">
                  <c:v>-3.3000000000000002E-2</c:v>
                </c:pt>
                <c:pt idx="345">
                  <c:v>-3.3000000000000002E-2</c:v>
                </c:pt>
                <c:pt idx="346">
                  <c:v>-3.3000000000000002E-2</c:v>
                </c:pt>
                <c:pt idx="347">
                  <c:v>-3.3000000000000002E-2</c:v>
                </c:pt>
                <c:pt idx="348">
                  <c:v>-3.4000000000000002E-2</c:v>
                </c:pt>
                <c:pt idx="349">
                  <c:v>-3.3000000000000002E-2</c:v>
                </c:pt>
                <c:pt idx="350">
                  <c:v>-3.3000000000000002E-2</c:v>
                </c:pt>
                <c:pt idx="351">
                  <c:v>-3.3000000000000002E-2</c:v>
                </c:pt>
                <c:pt idx="352">
                  <c:v>-3.3000000000000002E-2</c:v>
                </c:pt>
                <c:pt idx="353">
                  <c:v>-3.3000000000000002E-2</c:v>
                </c:pt>
                <c:pt idx="354">
                  <c:v>-3.3000000000000002E-2</c:v>
                </c:pt>
                <c:pt idx="355">
                  <c:v>-3.3000000000000002E-2</c:v>
                </c:pt>
                <c:pt idx="356">
                  <c:v>-3.3000000000000002E-2</c:v>
                </c:pt>
                <c:pt idx="357">
                  <c:v>-3.3000000000000002E-2</c:v>
                </c:pt>
                <c:pt idx="358">
                  <c:v>-3.3000000000000002E-2</c:v>
                </c:pt>
                <c:pt idx="359">
                  <c:v>-3.3000000000000002E-2</c:v>
                </c:pt>
                <c:pt idx="360">
                  <c:v>-3.3000000000000002E-2</c:v>
                </c:pt>
                <c:pt idx="361">
                  <c:v>-3.3000000000000002E-2</c:v>
                </c:pt>
                <c:pt idx="362">
                  <c:v>-3.3000000000000002E-2</c:v>
                </c:pt>
                <c:pt idx="363">
                  <c:v>-3.3000000000000002E-2</c:v>
                </c:pt>
                <c:pt idx="364">
                  <c:v>-3.3000000000000002E-2</c:v>
                </c:pt>
                <c:pt idx="365">
                  <c:v>-3.3000000000000002E-2</c:v>
                </c:pt>
                <c:pt idx="366">
                  <c:v>-3.3000000000000002E-2</c:v>
                </c:pt>
                <c:pt idx="367">
                  <c:v>-3.3000000000000002E-2</c:v>
                </c:pt>
                <c:pt idx="368">
                  <c:v>-3.3000000000000002E-2</c:v>
                </c:pt>
                <c:pt idx="369">
                  <c:v>-3.3000000000000002E-2</c:v>
                </c:pt>
                <c:pt idx="370">
                  <c:v>-3.3000000000000002E-2</c:v>
                </c:pt>
                <c:pt idx="371">
                  <c:v>-3.3000000000000002E-2</c:v>
                </c:pt>
                <c:pt idx="372">
                  <c:v>-3.3000000000000002E-2</c:v>
                </c:pt>
                <c:pt idx="373">
                  <c:v>-3.3000000000000002E-2</c:v>
                </c:pt>
                <c:pt idx="374">
                  <c:v>-3.3000000000000002E-2</c:v>
                </c:pt>
                <c:pt idx="375">
                  <c:v>-3.3000000000000002E-2</c:v>
                </c:pt>
                <c:pt idx="376">
                  <c:v>-3.3000000000000002E-2</c:v>
                </c:pt>
                <c:pt idx="377">
                  <c:v>-3.3000000000000002E-2</c:v>
                </c:pt>
                <c:pt idx="378">
                  <c:v>-3.3000000000000002E-2</c:v>
                </c:pt>
                <c:pt idx="379">
                  <c:v>-3.3000000000000002E-2</c:v>
                </c:pt>
                <c:pt idx="380">
                  <c:v>-3.3000000000000002E-2</c:v>
                </c:pt>
                <c:pt idx="381">
                  <c:v>-3.3000000000000002E-2</c:v>
                </c:pt>
                <c:pt idx="382">
                  <c:v>-3.3000000000000002E-2</c:v>
                </c:pt>
                <c:pt idx="383">
                  <c:v>-3.3000000000000002E-2</c:v>
                </c:pt>
                <c:pt idx="384">
                  <c:v>-3.3000000000000002E-2</c:v>
                </c:pt>
                <c:pt idx="385">
                  <c:v>-3.3000000000000002E-2</c:v>
                </c:pt>
                <c:pt idx="386">
                  <c:v>-3.3000000000000002E-2</c:v>
                </c:pt>
                <c:pt idx="387">
                  <c:v>-3.2000000000000001E-2</c:v>
                </c:pt>
                <c:pt idx="388">
                  <c:v>-3.2000000000000001E-2</c:v>
                </c:pt>
                <c:pt idx="389">
                  <c:v>-3.2000000000000001E-2</c:v>
                </c:pt>
                <c:pt idx="390">
                  <c:v>-3.2000000000000001E-2</c:v>
                </c:pt>
                <c:pt idx="391">
                  <c:v>-3.2000000000000001E-2</c:v>
                </c:pt>
                <c:pt idx="392">
                  <c:v>-3.2000000000000001E-2</c:v>
                </c:pt>
                <c:pt idx="393">
                  <c:v>-3.2000000000000001E-2</c:v>
                </c:pt>
                <c:pt idx="394">
                  <c:v>-3.2000000000000001E-2</c:v>
                </c:pt>
                <c:pt idx="395">
                  <c:v>-3.1E-2</c:v>
                </c:pt>
                <c:pt idx="396">
                  <c:v>-3.1E-2</c:v>
                </c:pt>
                <c:pt idx="397">
                  <c:v>-3.1E-2</c:v>
                </c:pt>
                <c:pt idx="398">
                  <c:v>-0.03</c:v>
                </c:pt>
                <c:pt idx="399">
                  <c:v>-0.03</c:v>
                </c:pt>
                <c:pt idx="400">
                  <c:v>-0.03</c:v>
                </c:pt>
                <c:pt idx="401">
                  <c:v>-2.9000000000000001E-2</c:v>
                </c:pt>
                <c:pt idx="402">
                  <c:v>-2.9000000000000001E-2</c:v>
                </c:pt>
                <c:pt idx="403">
                  <c:v>-2.8000000000000001E-2</c:v>
                </c:pt>
                <c:pt idx="404">
                  <c:v>-2.7E-2</c:v>
                </c:pt>
                <c:pt idx="405">
                  <c:v>-2.7E-2</c:v>
                </c:pt>
                <c:pt idx="406">
                  <c:v>-2.5999999999999999E-2</c:v>
                </c:pt>
                <c:pt idx="407">
                  <c:v>-2.5000000000000001E-2</c:v>
                </c:pt>
                <c:pt idx="408">
                  <c:v>-2.5000000000000001E-2</c:v>
                </c:pt>
                <c:pt idx="409">
                  <c:v>-2.4E-2</c:v>
                </c:pt>
                <c:pt idx="410">
                  <c:v>-2.3E-2</c:v>
                </c:pt>
                <c:pt idx="411">
                  <c:v>-2.1999999999999999E-2</c:v>
                </c:pt>
                <c:pt idx="412">
                  <c:v>-2.1000000000000001E-2</c:v>
                </c:pt>
                <c:pt idx="413">
                  <c:v>-0.02</c:v>
                </c:pt>
                <c:pt idx="414">
                  <c:v>-1.9E-2</c:v>
                </c:pt>
                <c:pt idx="415">
                  <c:v>-1.7999999999999999E-2</c:v>
                </c:pt>
                <c:pt idx="416">
                  <c:v>-1.7000000000000001E-2</c:v>
                </c:pt>
                <c:pt idx="417">
                  <c:v>-1.6E-2</c:v>
                </c:pt>
                <c:pt idx="418">
                  <c:v>-1.4999999999999999E-2</c:v>
                </c:pt>
                <c:pt idx="419">
                  <c:v>-1.4E-2</c:v>
                </c:pt>
                <c:pt idx="420">
                  <c:v>-1.2E-2</c:v>
                </c:pt>
                <c:pt idx="421">
                  <c:v>-8.0000000000000002E-3</c:v>
                </c:pt>
                <c:pt idx="422">
                  <c:v>8.0000000000000002E-3</c:v>
                </c:pt>
                <c:pt idx="423">
                  <c:v>0.01</c:v>
                </c:pt>
                <c:pt idx="424">
                  <c:v>1.0999999999999999E-2</c:v>
                </c:pt>
                <c:pt idx="425">
                  <c:v>1.2E-2</c:v>
                </c:pt>
                <c:pt idx="426">
                  <c:v>1.4E-2</c:v>
                </c:pt>
                <c:pt idx="427">
                  <c:v>1.4999999999999999E-2</c:v>
                </c:pt>
                <c:pt idx="428">
                  <c:v>1.6E-2</c:v>
                </c:pt>
                <c:pt idx="429">
                  <c:v>1.7999999999999999E-2</c:v>
                </c:pt>
                <c:pt idx="430">
                  <c:v>0.02</c:v>
                </c:pt>
                <c:pt idx="431">
                  <c:v>2.1000000000000001E-2</c:v>
                </c:pt>
                <c:pt idx="432">
                  <c:v>2.1999999999999999E-2</c:v>
                </c:pt>
                <c:pt idx="433">
                  <c:v>2.3E-2</c:v>
                </c:pt>
                <c:pt idx="434">
                  <c:v>2.5000000000000001E-2</c:v>
                </c:pt>
                <c:pt idx="435">
                  <c:v>2.5999999999999999E-2</c:v>
                </c:pt>
                <c:pt idx="436">
                  <c:v>2.8000000000000001E-2</c:v>
                </c:pt>
                <c:pt idx="437">
                  <c:v>2.9000000000000001E-2</c:v>
                </c:pt>
                <c:pt idx="438">
                  <c:v>3.1E-2</c:v>
                </c:pt>
                <c:pt idx="439">
                  <c:v>3.2000000000000001E-2</c:v>
                </c:pt>
                <c:pt idx="440">
                  <c:v>3.3000000000000002E-2</c:v>
                </c:pt>
                <c:pt idx="441">
                  <c:v>3.5000000000000003E-2</c:v>
                </c:pt>
                <c:pt idx="442">
                  <c:v>3.5999999999999997E-2</c:v>
                </c:pt>
                <c:pt idx="443">
                  <c:v>3.6999999999999998E-2</c:v>
                </c:pt>
                <c:pt idx="444">
                  <c:v>3.7999999999999999E-2</c:v>
                </c:pt>
                <c:pt idx="445">
                  <c:v>0.04</c:v>
                </c:pt>
                <c:pt idx="446">
                  <c:v>4.1000000000000002E-2</c:v>
                </c:pt>
                <c:pt idx="447">
                  <c:v>4.2999999999999997E-2</c:v>
                </c:pt>
                <c:pt idx="448">
                  <c:v>4.3999999999999997E-2</c:v>
                </c:pt>
                <c:pt idx="449">
                  <c:v>4.4999999999999998E-2</c:v>
                </c:pt>
                <c:pt idx="450">
                  <c:v>4.5999999999999999E-2</c:v>
                </c:pt>
                <c:pt idx="451">
                  <c:v>4.8000000000000001E-2</c:v>
                </c:pt>
                <c:pt idx="452">
                  <c:v>4.9000000000000002E-2</c:v>
                </c:pt>
                <c:pt idx="453">
                  <c:v>0.05</c:v>
                </c:pt>
                <c:pt idx="454">
                  <c:v>5.1999999999999998E-2</c:v>
                </c:pt>
                <c:pt idx="455">
                  <c:v>5.2999999999999999E-2</c:v>
                </c:pt>
                <c:pt idx="456">
                  <c:v>5.3999999999999999E-2</c:v>
                </c:pt>
                <c:pt idx="457">
                  <c:v>5.6000000000000001E-2</c:v>
                </c:pt>
                <c:pt idx="458">
                  <c:v>5.7000000000000002E-2</c:v>
                </c:pt>
                <c:pt idx="459">
                  <c:v>5.8000000000000003E-2</c:v>
                </c:pt>
                <c:pt idx="460">
                  <c:v>5.8999999999999997E-2</c:v>
                </c:pt>
                <c:pt idx="461">
                  <c:v>4.9000000000000002E-2</c:v>
                </c:pt>
                <c:pt idx="462">
                  <c:v>4.3999999999999997E-2</c:v>
                </c:pt>
                <c:pt idx="463">
                  <c:v>4.4999999999999998E-2</c:v>
                </c:pt>
                <c:pt idx="464">
                  <c:v>4.7E-2</c:v>
                </c:pt>
                <c:pt idx="465">
                  <c:v>4.8000000000000001E-2</c:v>
                </c:pt>
                <c:pt idx="466">
                  <c:v>4.9000000000000002E-2</c:v>
                </c:pt>
                <c:pt idx="467">
                  <c:v>0.05</c:v>
                </c:pt>
                <c:pt idx="468">
                  <c:v>5.0999999999999997E-2</c:v>
                </c:pt>
                <c:pt idx="469">
                  <c:v>5.1999999999999998E-2</c:v>
                </c:pt>
                <c:pt idx="470">
                  <c:v>5.2999999999999999E-2</c:v>
                </c:pt>
                <c:pt idx="471">
                  <c:v>5.2999999999999999E-2</c:v>
                </c:pt>
                <c:pt idx="472">
                  <c:v>5.3999999999999999E-2</c:v>
                </c:pt>
                <c:pt idx="473">
                  <c:v>5.5E-2</c:v>
                </c:pt>
                <c:pt idx="474">
                  <c:v>5.6000000000000001E-2</c:v>
                </c:pt>
                <c:pt idx="475">
                  <c:v>5.6000000000000001E-2</c:v>
                </c:pt>
                <c:pt idx="476">
                  <c:v>5.7000000000000002E-2</c:v>
                </c:pt>
                <c:pt idx="477">
                  <c:v>5.7000000000000002E-2</c:v>
                </c:pt>
                <c:pt idx="478">
                  <c:v>5.8000000000000003E-2</c:v>
                </c:pt>
                <c:pt idx="479">
                  <c:v>5.8999999999999997E-2</c:v>
                </c:pt>
                <c:pt idx="480">
                  <c:v>5.8999999999999997E-2</c:v>
                </c:pt>
                <c:pt idx="481">
                  <c:v>5.8999999999999997E-2</c:v>
                </c:pt>
                <c:pt idx="482">
                  <c:v>0.06</c:v>
                </c:pt>
                <c:pt idx="483">
                  <c:v>0.06</c:v>
                </c:pt>
                <c:pt idx="484">
                  <c:v>0.06</c:v>
                </c:pt>
                <c:pt idx="485">
                  <c:v>6.0999999999999999E-2</c:v>
                </c:pt>
                <c:pt idx="486">
                  <c:v>6.0999999999999999E-2</c:v>
                </c:pt>
                <c:pt idx="487">
                  <c:v>6.0999999999999999E-2</c:v>
                </c:pt>
                <c:pt idx="488">
                  <c:v>6.0999999999999999E-2</c:v>
                </c:pt>
                <c:pt idx="489">
                  <c:v>6.0999999999999999E-2</c:v>
                </c:pt>
                <c:pt idx="490">
                  <c:v>6.0999999999999999E-2</c:v>
                </c:pt>
                <c:pt idx="491">
                  <c:v>6.0999999999999999E-2</c:v>
                </c:pt>
                <c:pt idx="492">
                  <c:v>6.2E-2</c:v>
                </c:pt>
                <c:pt idx="493">
                  <c:v>6.2E-2</c:v>
                </c:pt>
                <c:pt idx="494">
                  <c:v>6.2E-2</c:v>
                </c:pt>
                <c:pt idx="495">
                  <c:v>6.3E-2</c:v>
                </c:pt>
                <c:pt idx="496">
                  <c:v>6.3E-2</c:v>
                </c:pt>
                <c:pt idx="497">
                  <c:v>6.4000000000000001E-2</c:v>
                </c:pt>
                <c:pt idx="498">
                  <c:v>6.5000000000000002E-2</c:v>
                </c:pt>
                <c:pt idx="499">
                  <c:v>6.5000000000000002E-2</c:v>
                </c:pt>
                <c:pt idx="500">
                  <c:v>6.6000000000000003E-2</c:v>
                </c:pt>
                <c:pt idx="501">
                  <c:v>6.7000000000000004E-2</c:v>
                </c:pt>
                <c:pt idx="502">
                  <c:v>6.9000000000000006E-2</c:v>
                </c:pt>
                <c:pt idx="503">
                  <c:v>7.0000000000000007E-2</c:v>
                </c:pt>
                <c:pt idx="504">
                  <c:v>7.1999999999999995E-2</c:v>
                </c:pt>
                <c:pt idx="505">
                  <c:v>7.2999999999999995E-2</c:v>
                </c:pt>
                <c:pt idx="506">
                  <c:v>7.4999999999999997E-2</c:v>
                </c:pt>
                <c:pt idx="507">
                  <c:v>7.8E-2</c:v>
                </c:pt>
                <c:pt idx="508">
                  <c:v>0.08</c:v>
                </c:pt>
                <c:pt idx="509">
                  <c:v>8.3000000000000004E-2</c:v>
                </c:pt>
                <c:pt idx="510">
                  <c:v>8.5999999999999993E-2</c:v>
                </c:pt>
                <c:pt idx="511">
                  <c:v>8.8999999999999996E-2</c:v>
                </c:pt>
                <c:pt idx="512">
                  <c:v>9.0999999999999998E-2</c:v>
                </c:pt>
                <c:pt idx="513">
                  <c:v>9.2999999999999999E-2</c:v>
                </c:pt>
                <c:pt idx="514">
                  <c:v>9.5000000000000001E-2</c:v>
                </c:pt>
                <c:pt idx="515">
                  <c:v>9.7000000000000003E-2</c:v>
                </c:pt>
                <c:pt idx="516">
                  <c:v>9.8000000000000004E-2</c:v>
                </c:pt>
                <c:pt idx="517">
                  <c:v>0.1</c:v>
                </c:pt>
                <c:pt idx="518">
                  <c:v>0.10299999999999999</c:v>
                </c:pt>
                <c:pt idx="519">
                  <c:v>0.105</c:v>
                </c:pt>
                <c:pt idx="520">
                  <c:v>0.107</c:v>
                </c:pt>
                <c:pt idx="521">
                  <c:v>0.109</c:v>
                </c:pt>
                <c:pt idx="522">
                  <c:v>0.111</c:v>
                </c:pt>
                <c:pt idx="523">
                  <c:v>0.113</c:v>
                </c:pt>
                <c:pt idx="524">
                  <c:v>0.115</c:v>
                </c:pt>
                <c:pt idx="525">
                  <c:v>0.11700000000000001</c:v>
                </c:pt>
                <c:pt idx="526">
                  <c:v>0.12</c:v>
                </c:pt>
                <c:pt idx="527">
                  <c:v>0.122</c:v>
                </c:pt>
                <c:pt idx="528">
                  <c:v>0.124</c:v>
                </c:pt>
                <c:pt idx="529">
                  <c:v>0.126</c:v>
                </c:pt>
                <c:pt idx="530">
                  <c:v>0.128</c:v>
                </c:pt>
                <c:pt idx="531">
                  <c:v>0.129</c:v>
                </c:pt>
                <c:pt idx="532">
                  <c:v>0.13</c:v>
                </c:pt>
                <c:pt idx="533">
                  <c:v>0.13100000000000001</c:v>
                </c:pt>
                <c:pt idx="534">
                  <c:v>0.13100000000000001</c:v>
                </c:pt>
                <c:pt idx="535">
                  <c:v>0.13100000000000001</c:v>
                </c:pt>
                <c:pt idx="536">
                  <c:v>0.13100000000000001</c:v>
                </c:pt>
                <c:pt idx="537">
                  <c:v>0.13</c:v>
                </c:pt>
                <c:pt idx="538">
                  <c:v>0.13</c:v>
                </c:pt>
                <c:pt idx="539">
                  <c:v>0.13</c:v>
                </c:pt>
                <c:pt idx="540">
                  <c:v>0.13100000000000001</c:v>
                </c:pt>
                <c:pt idx="541">
                  <c:v>0.13100000000000001</c:v>
                </c:pt>
                <c:pt idx="542">
                  <c:v>0.13200000000000001</c:v>
                </c:pt>
                <c:pt idx="543">
                  <c:v>0.13300000000000001</c:v>
                </c:pt>
                <c:pt idx="544">
                  <c:v>0.13400000000000001</c:v>
                </c:pt>
                <c:pt idx="545">
                  <c:v>0.13500000000000001</c:v>
                </c:pt>
                <c:pt idx="546">
                  <c:v>0.13600000000000001</c:v>
                </c:pt>
                <c:pt idx="547">
                  <c:v>0.13800000000000001</c:v>
                </c:pt>
                <c:pt idx="548">
                  <c:v>0.14000000000000001</c:v>
                </c:pt>
                <c:pt idx="549">
                  <c:v>0.14199999999999999</c:v>
                </c:pt>
                <c:pt idx="550">
                  <c:v>0.14499999999999999</c:v>
                </c:pt>
                <c:pt idx="551">
                  <c:v>0.14699999999999999</c:v>
                </c:pt>
                <c:pt idx="552">
                  <c:v>0.15</c:v>
                </c:pt>
                <c:pt idx="553">
                  <c:v>0.154</c:v>
                </c:pt>
                <c:pt idx="554">
                  <c:v>0.157</c:v>
                </c:pt>
                <c:pt idx="555">
                  <c:v>0.161</c:v>
                </c:pt>
                <c:pt idx="556">
                  <c:v>0.16500000000000001</c:v>
                </c:pt>
                <c:pt idx="557">
                  <c:v>0.16900000000000001</c:v>
                </c:pt>
                <c:pt idx="558">
                  <c:v>0.17399999999999999</c:v>
                </c:pt>
                <c:pt idx="559">
                  <c:v>0.18</c:v>
                </c:pt>
                <c:pt idx="560">
                  <c:v>0.186</c:v>
                </c:pt>
                <c:pt idx="561">
                  <c:v>0.19400000000000001</c:v>
                </c:pt>
                <c:pt idx="562">
                  <c:v>0.20200000000000001</c:v>
                </c:pt>
                <c:pt idx="563">
                  <c:v>0.21199999999999999</c:v>
                </c:pt>
                <c:pt idx="564">
                  <c:v>0.224</c:v>
                </c:pt>
                <c:pt idx="565">
                  <c:v>0.23699999999999999</c:v>
                </c:pt>
                <c:pt idx="566">
                  <c:v>0.252</c:v>
                </c:pt>
                <c:pt idx="567">
                  <c:v>0.27</c:v>
                </c:pt>
                <c:pt idx="568">
                  <c:v>0.29099999999999998</c:v>
                </c:pt>
                <c:pt idx="569">
                  <c:v>0.314</c:v>
                </c:pt>
                <c:pt idx="570">
                  <c:v>0.34200000000000003</c:v>
                </c:pt>
                <c:pt idx="571">
                  <c:v>0.371</c:v>
                </c:pt>
                <c:pt idx="572">
                  <c:v>0.40400000000000003</c:v>
                </c:pt>
                <c:pt idx="573">
                  <c:v>0.44</c:v>
                </c:pt>
                <c:pt idx="574">
                  <c:v>0.48</c:v>
                </c:pt>
                <c:pt idx="575">
                  <c:v>0.52300000000000002</c:v>
                </c:pt>
                <c:pt idx="576">
                  <c:v>0.56799999999999995</c:v>
                </c:pt>
                <c:pt idx="577">
                  <c:v>0.61499999999999999</c:v>
                </c:pt>
                <c:pt idx="578">
                  <c:v>0.66500000000000004</c:v>
                </c:pt>
                <c:pt idx="579">
                  <c:v>0.71899999999999997</c:v>
                </c:pt>
                <c:pt idx="580">
                  <c:v>0.77</c:v>
                </c:pt>
                <c:pt idx="581">
                  <c:v>0.82199999999999995</c:v>
                </c:pt>
                <c:pt idx="582">
                  <c:v>0.875</c:v>
                </c:pt>
                <c:pt idx="583">
                  <c:v>0.92900000000000005</c:v>
                </c:pt>
                <c:pt idx="584">
                  <c:v>0.98499999999999999</c:v>
                </c:pt>
                <c:pt idx="585">
                  <c:v>1.0409999999999999</c:v>
                </c:pt>
                <c:pt idx="586">
                  <c:v>1.0980000000000001</c:v>
                </c:pt>
                <c:pt idx="587">
                  <c:v>1.157</c:v>
                </c:pt>
                <c:pt idx="588">
                  <c:v>1.216</c:v>
                </c:pt>
                <c:pt idx="589">
                  <c:v>1.2769999999999999</c:v>
                </c:pt>
                <c:pt idx="590">
                  <c:v>1.3380000000000001</c:v>
                </c:pt>
                <c:pt idx="591">
                  <c:v>1.3979999999999999</c:v>
                </c:pt>
                <c:pt idx="592">
                  <c:v>1.4590000000000001</c:v>
                </c:pt>
                <c:pt idx="593">
                  <c:v>1.5189999999999999</c:v>
                </c:pt>
                <c:pt idx="594">
                  <c:v>1.58</c:v>
                </c:pt>
                <c:pt idx="595">
                  <c:v>1.639</c:v>
                </c:pt>
                <c:pt idx="596">
                  <c:v>1.704</c:v>
                </c:pt>
                <c:pt idx="597">
                  <c:v>1.7669999999999999</c:v>
                </c:pt>
                <c:pt idx="598">
                  <c:v>1.827</c:v>
                </c:pt>
                <c:pt idx="599">
                  <c:v>1.885</c:v>
                </c:pt>
                <c:pt idx="600">
                  <c:v>1.94300000000000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E505-40FA-858A-3227CC8E4DA5}"/>
            </c:ext>
          </c:extLst>
        </c:ser>
        <c:ser>
          <c:idx val="2"/>
          <c:order val="2"/>
          <c:tx>
            <c:strRef>
              <c:f>'water-F'!$D$2</c:f>
              <c:strCache>
                <c:ptCount val="1"/>
                <c:pt idx="0">
                  <c:v>Collards </c:v>
                </c:pt>
              </c:strCache>
            </c:strRef>
          </c:tx>
          <c:spPr>
            <a:ln>
              <a:prstDash val="sysDot"/>
            </a:ln>
          </c:spPr>
          <c:marker>
            <c:symbol val="none"/>
          </c:marker>
          <c:xVal>
            <c:numRef>
              <c:f>'water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water-F'!$D$3:$D$603</c:f>
              <c:numCache>
                <c:formatCode>General</c:formatCode>
                <c:ptCount val="601"/>
                <c:pt idx="0">
                  <c:v>-1E-3</c:v>
                </c:pt>
                <c:pt idx="1">
                  <c:v>-1E-3</c:v>
                </c:pt>
                <c:pt idx="2">
                  <c:v>-2E-3</c:v>
                </c:pt>
                <c:pt idx="3">
                  <c:v>-2E-3</c:v>
                </c:pt>
                <c:pt idx="4">
                  <c:v>-2E-3</c:v>
                </c:pt>
                <c:pt idx="5">
                  <c:v>-2E-3</c:v>
                </c:pt>
                <c:pt idx="6">
                  <c:v>-2E-3</c:v>
                </c:pt>
                <c:pt idx="7">
                  <c:v>-2E-3</c:v>
                </c:pt>
                <c:pt idx="8">
                  <c:v>-3.0000000000000001E-3</c:v>
                </c:pt>
                <c:pt idx="9">
                  <c:v>-3.0000000000000001E-3</c:v>
                </c:pt>
                <c:pt idx="10">
                  <c:v>-3.0000000000000001E-3</c:v>
                </c:pt>
                <c:pt idx="11">
                  <c:v>-3.0000000000000001E-3</c:v>
                </c:pt>
                <c:pt idx="12">
                  <c:v>-3.0000000000000001E-3</c:v>
                </c:pt>
                <c:pt idx="13">
                  <c:v>-3.0000000000000001E-3</c:v>
                </c:pt>
                <c:pt idx="14">
                  <c:v>-4.0000000000000001E-3</c:v>
                </c:pt>
                <c:pt idx="15">
                  <c:v>-4.0000000000000001E-3</c:v>
                </c:pt>
                <c:pt idx="16">
                  <c:v>-4.0000000000000001E-3</c:v>
                </c:pt>
                <c:pt idx="17">
                  <c:v>-4.0000000000000001E-3</c:v>
                </c:pt>
                <c:pt idx="18">
                  <c:v>-4.0000000000000001E-3</c:v>
                </c:pt>
                <c:pt idx="19">
                  <c:v>-4.0000000000000001E-3</c:v>
                </c:pt>
                <c:pt idx="20">
                  <c:v>-5.0000000000000001E-3</c:v>
                </c:pt>
                <c:pt idx="21">
                  <c:v>-5.0000000000000001E-3</c:v>
                </c:pt>
                <c:pt idx="22">
                  <c:v>-5.0000000000000001E-3</c:v>
                </c:pt>
                <c:pt idx="23">
                  <c:v>-5.0000000000000001E-3</c:v>
                </c:pt>
                <c:pt idx="24">
                  <c:v>-5.0000000000000001E-3</c:v>
                </c:pt>
                <c:pt idx="25">
                  <c:v>-5.0000000000000001E-3</c:v>
                </c:pt>
                <c:pt idx="26">
                  <c:v>-5.0000000000000001E-3</c:v>
                </c:pt>
                <c:pt idx="27">
                  <c:v>-6.0000000000000001E-3</c:v>
                </c:pt>
                <c:pt idx="28">
                  <c:v>-6.0000000000000001E-3</c:v>
                </c:pt>
                <c:pt idx="29">
                  <c:v>-6.0000000000000001E-3</c:v>
                </c:pt>
                <c:pt idx="30">
                  <c:v>-6.0000000000000001E-3</c:v>
                </c:pt>
                <c:pt idx="31">
                  <c:v>-6.0000000000000001E-3</c:v>
                </c:pt>
                <c:pt idx="32">
                  <c:v>-6.0000000000000001E-3</c:v>
                </c:pt>
                <c:pt idx="33">
                  <c:v>-6.0000000000000001E-3</c:v>
                </c:pt>
                <c:pt idx="34">
                  <c:v>-6.0000000000000001E-3</c:v>
                </c:pt>
                <c:pt idx="35">
                  <c:v>-7.0000000000000001E-3</c:v>
                </c:pt>
                <c:pt idx="36">
                  <c:v>-7.0000000000000001E-3</c:v>
                </c:pt>
                <c:pt idx="37">
                  <c:v>-7.0000000000000001E-3</c:v>
                </c:pt>
                <c:pt idx="38">
                  <c:v>-7.0000000000000001E-3</c:v>
                </c:pt>
                <c:pt idx="39">
                  <c:v>-7.0000000000000001E-3</c:v>
                </c:pt>
                <c:pt idx="40">
                  <c:v>-7.0000000000000001E-3</c:v>
                </c:pt>
                <c:pt idx="41">
                  <c:v>-7.0000000000000001E-3</c:v>
                </c:pt>
                <c:pt idx="42">
                  <c:v>-8.0000000000000002E-3</c:v>
                </c:pt>
                <c:pt idx="43">
                  <c:v>-8.0000000000000002E-3</c:v>
                </c:pt>
                <c:pt idx="44">
                  <c:v>-8.0000000000000002E-3</c:v>
                </c:pt>
                <c:pt idx="45">
                  <c:v>-8.0000000000000002E-3</c:v>
                </c:pt>
                <c:pt idx="46">
                  <c:v>-8.0000000000000002E-3</c:v>
                </c:pt>
                <c:pt idx="47">
                  <c:v>-8.0000000000000002E-3</c:v>
                </c:pt>
                <c:pt idx="48">
                  <c:v>-8.0000000000000002E-3</c:v>
                </c:pt>
                <c:pt idx="49">
                  <c:v>-8.0000000000000002E-3</c:v>
                </c:pt>
                <c:pt idx="50">
                  <c:v>-8.0000000000000002E-3</c:v>
                </c:pt>
                <c:pt idx="51">
                  <c:v>-8.0000000000000002E-3</c:v>
                </c:pt>
                <c:pt idx="52">
                  <c:v>-8.0000000000000002E-3</c:v>
                </c:pt>
                <c:pt idx="53">
                  <c:v>-8.9999999999999993E-3</c:v>
                </c:pt>
                <c:pt idx="54">
                  <c:v>-8.9999999999999993E-3</c:v>
                </c:pt>
                <c:pt idx="55">
                  <c:v>-8.9999999999999993E-3</c:v>
                </c:pt>
                <c:pt idx="56">
                  <c:v>-0.01</c:v>
                </c:pt>
                <c:pt idx="57">
                  <c:v>-1.0999999999999999E-2</c:v>
                </c:pt>
                <c:pt idx="58">
                  <c:v>-1.2E-2</c:v>
                </c:pt>
                <c:pt idx="59">
                  <c:v>-1.4E-2</c:v>
                </c:pt>
                <c:pt idx="60">
                  <c:v>-1.4999999999999999E-2</c:v>
                </c:pt>
                <c:pt idx="61">
                  <c:v>-1.6E-2</c:v>
                </c:pt>
                <c:pt idx="62">
                  <c:v>-1.6E-2</c:v>
                </c:pt>
                <c:pt idx="63">
                  <c:v>-1.7000000000000001E-2</c:v>
                </c:pt>
                <c:pt idx="64">
                  <c:v>-1.7000000000000001E-2</c:v>
                </c:pt>
                <c:pt idx="65">
                  <c:v>-1.7000000000000001E-2</c:v>
                </c:pt>
                <c:pt idx="66">
                  <c:v>-1.7000000000000001E-2</c:v>
                </c:pt>
                <c:pt idx="67">
                  <c:v>-1.7000000000000001E-2</c:v>
                </c:pt>
                <c:pt idx="68">
                  <c:v>-1.7000000000000001E-2</c:v>
                </c:pt>
                <c:pt idx="69">
                  <c:v>-1.7000000000000001E-2</c:v>
                </c:pt>
                <c:pt idx="70">
                  <c:v>-1.7000000000000001E-2</c:v>
                </c:pt>
                <c:pt idx="71">
                  <c:v>-1.7000000000000001E-2</c:v>
                </c:pt>
                <c:pt idx="72">
                  <c:v>-1.7000000000000001E-2</c:v>
                </c:pt>
                <c:pt idx="73">
                  <c:v>-1.7000000000000001E-2</c:v>
                </c:pt>
                <c:pt idx="74">
                  <c:v>-1.7000000000000001E-2</c:v>
                </c:pt>
                <c:pt idx="75">
                  <c:v>-1.7000000000000001E-2</c:v>
                </c:pt>
                <c:pt idx="76">
                  <c:v>-1.7999999999999999E-2</c:v>
                </c:pt>
                <c:pt idx="77">
                  <c:v>-1.7999999999999999E-2</c:v>
                </c:pt>
                <c:pt idx="78">
                  <c:v>-1.7999999999999999E-2</c:v>
                </c:pt>
                <c:pt idx="79">
                  <c:v>-1.7999999999999999E-2</c:v>
                </c:pt>
                <c:pt idx="80">
                  <c:v>-1.7999999999999999E-2</c:v>
                </c:pt>
                <c:pt idx="81">
                  <c:v>-1.7999999999999999E-2</c:v>
                </c:pt>
                <c:pt idx="82">
                  <c:v>-1.7999999999999999E-2</c:v>
                </c:pt>
                <c:pt idx="83">
                  <c:v>-1.7999999999999999E-2</c:v>
                </c:pt>
                <c:pt idx="84">
                  <c:v>-1.7999999999999999E-2</c:v>
                </c:pt>
                <c:pt idx="85">
                  <c:v>-1.9E-2</c:v>
                </c:pt>
                <c:pt idx="86">
                  <c:v>-1.9E-2</c:v>
                </c:pt>
                <c:pt idx="87">
                  <c:v>-1.9E-2</c:v>
                </c:pt>
                <c:pt idx="88">
                  <c:v>-1.9E-2</c:v>
                </c:pt>
                <c:pt idx="89">
                  <c:v>-1.9E-2</c:v>
                </c:pt>
                <c:pt idx="90">
                  <c:v>-1.9E-2</c:v>
                </c:pt>
                <c:pt idx="91">
                  <c:v>-1.9E-2</c:v>
                </c:pt>
                <c:pt idx="92">
                  <c:v>-1.9E-2</c:v>
                </c:pt>
                <c:pt idx="93">
                  <c:v>-1.9E-2</c:v>
                </c:pt>
                <c:pt idx="94">
                  <c:v>-0.02</c:v>
                </c:pt>
                <c:pt idx="95">
                  <c:v>-0.02</c:v>
                </c:pt>
                <c:pt idx="96">
                  <c:v>-0.02</c:v>
                </c:pt>
                <c:pt idx="97">
                  <c:v>-0.02</c:v>
                </c:pt>
                <c:pt idx="98">
                  <c:v>-0.02</c:v>
                </c:pt>
                <c:pt idx="99">
                  <c:v>-0.02</c:v>
                </c:pt>
                <c:pt idx="100">
                  <c:v>-0.02</c:v>
                </c:pt>
                <c:pt idx="101">
                  <c:v>-0.02</c:v>
                </c:pt>
                <c:pt idx="102">
                  <c:v>-0.02</c:v>
                </c:pt>
                <c:pt idx="103">
                  <c:v>-0.02</c:v>
                </c:pt>
                <c:pt idx="104">
                  <c:v>-2.1000000000000001E-2</c:v>
                </c:pt>
                <c:pt idx="105">
                  <c:v>-2.1000000000000001E-2</c:v>
                </c:pt>
                <c:pt idx="106">
                  <c:v>-2.1000000000000001E-2</c:v>
                </c:pt>
                <c:pt idx="107">
                  <c:v>-2.1000000000000001E-2</c:v>
                </c:pt>
                <c:pt idx="108">
                  <c:v>-2.1000000000000001E-2</c:v>
                </c:pt>
                <c:pt idx="109">
                  <c:v>-2.1000000000000001E-2</c:v>
                </c:pt>
                <c:pt idx="110">
                  <c:v>-2.1000000000000001E-2</c:v>
                </c:pt>
                <c:pt idx="111">
                  <c:v>-2.1000000000000001E-2</c:v>
                </c:pt>
                <c:pt idx="112">
                  <c:v>-2.1000000000000001E-2</c:v>
                </c:pt>
                <c:pt idx="113">
                  <c:v>-2.1000000000000001E-2</c:v>
                </c:pt>
                <c:pt idx="114">
                  <c:v>-2.1999999999999999E-2</c:v>
                </c:pt>
                <c:pt idx="115">
                  <c:v>-2.1999999999999999E-2</c:v>
                </c:pt>
                <c:pt idx="116">
                  <c:v>-2.1999999999999999E-2</c:v>
                </c:pt>
                <c:pt idx="117">
                  <c:v>-2.1999999999999999E-2</c:v>
                </c:pt>
                <c:pt idx="118">
                  <c:v>-2.1999999999999999E-2</c:v>
                </c:pt>
                <c:pt idx="119">
                  <c:v>-2.1999999999999999E-2</c:v>
                </c:pt>
                <c:pt idx="120">
                  <c:v>-2.1999999999999999E-2</c:v>
                </c:pt>
                <c:pt idx="121">
                  <c:v>-2.1999999999999999E-2</c:v>
                </c:pt>
                <c:pt idx="122">
                  <c:v>-2.1999999999999999E-2</c:v>
                </c:pt>
                <c:pt idx="123">
                  <c:v>-2.1999999999999999E-2</c:v>
                </c:pt>
                <c:pt idx="124">
                  <c:v>-2.1999999999999999E-2</c:v>
                </c:pt>
                <c:pt idx="125">
                  <c:v>-2.1999999999999999E-2</c:v>
                </c:pt>
                <c:pt idx="126">
                  <c:v>-2.3E-2</c:v>
                </c:pt>
                <c:pt idx="127">
                  <c:v>-2.3E-2</c:v>
                </c:pt>
                <c:pt idx="128">
                  <c:v>-2.3E-2</c:v>
                </c:pt>
                <c:pt idx="129">
                  <c:v>-2.3E-2</c:v>
                </c:pt>
                <c:pt idx="130">
                  <c:v>-2.3E-2</c:v>
                </c:pt>
                <c:pt idx="131">
                  <c:v>-2.3E-2</c:v>
                </c:pt>
                <c:pt idx="132">
                  <c:v>-2.3E-2</c:v>
                </c:pt>
                <c:pt idx="133">
                  <c:v>-2.3E-2</c:v>
                </c:pt>
                <c:pt idx="134">
                  <c:v>-2.3E-2</c:v>
                </c:pt>
                <c:pt idx="135">
                  <c:v>-2.3E-2</c:v>
                </c:pt>
                <c:pt idx="136">
                  <c:v>-2.3E-2</c:v>
                </c:pt>
                <c:pt idx="137">
                  <c:v>-2.3E-2</c:v>
                </c:pt>
                <c:pt idx="138">
                  <c:v>-2.4E-2</c:v>
                </c:pt>
                <c:pt idx="139">
                  <c:v>-2.4E-2</c:v>
                </c:pt>
                <c:pt idx="140">
                  <c:v>-2.4E-2</c:v>
                </c:pt>
                <c:pt idx="141">
                  <c:v>-2.4E-2</c:v>
                </c:pt>
                <c:pt idx="142">
                  <c:v>-2.4E-2</c:v>
                </c:pt>
                <c:pt idx="143">
                  <c:v>-2.4E-2</c:v>
                </c:pt>
                <c:pt idx="144">
                  <c:v>-2.4E-2</c:v>
                </c:pt>
                <c:pt idx="145">
                  <c:v>-2.4E-2</c:v>
                </c:pt>
                <c:pt idx="146">
                  <c:v>-2.4E-2</c:v>
                </c:pt>
                <c:pt idx="147">
                  <c:v>-2.4E-2</c:v>
                </c:pt>
                <c:pt idx="148">
                  <c:v>-2.4E-2</c:v>
                </c:pt>
                <c:pt idx="149">
                  <c:v>-2.4E-2</c:v>
                </c:pt>
                <c:pt idx="150">
                  <c:v>-2.5000000000000001E-2</c:v>
                </c:pt>
                <c:pt idx="151">
                  <c:v>-2.5000000000000001E-2</c:v>
                </c:pt>
                <c:pt idx="152">
                  <c:v>-2.5000000000000001E-2</c:v>
                </c:pt>
                <c:pt idx="153">
                  <c:v>-2.5000000000000001E-2</c:v>
                </c:pt>
                <c:pt idx="154">
                  <c:v>-2.5000000000000001E-2</c:v>
                </c:pt>
                <c:pt idx="155">
                  <c:v>-2.5000000000000001E-2</c:v>
                </c:pt>
                <c:pt idx="156">
                  <c:v>-2.5000000000000001E-2</c:v>
                </c:pt>
                <c:pt idx="157">
                  <c:v>-2.5000000000000001E-2</c:v>
                </c:pt>
                <c:pt idx="158">
                  <c:v>-2.5000000000000001E-2</c:v>
                </c:pt>
                <c:pt idx="159">
                  <c:v>-2.5000000000000001E-2</c:v>
                </c:pt>
                <c:pt idx="160">
                  <c:v>-2.5000000000000001E-2</c:v>
                </c:pt>
                <c:pt idx="161">
                  <c:v>-2.5000000000000001E-2</c:v>
                </c:pt>
                <c:pt idx="162">
                  <c:v>-2.5000000000000001E-2</c:v>
                </c:pt>
                <c:pt idx="163">
                  <c:v>-2.5000000000000001E-2</c:v>
                </c:pt>
                <c:pt idx="164">
                  <c:v>-2.5000000000000001E-2</c:v>
                </c:pt>
                <c:pt idx="165">
                  <c:v>-2.5000000000000001E-2</c:v>
                </c:pt>
                <c:pt idx="166">
                  <c:v>-2.5999999999999999E-2</c:v>
                </c:pt>
                <c:pt idx="167">
                  <c:v>-2.5999999999999999E-2</c:v>
                </c:pt>
                <c:pt idx="168">
                  <c:v>-2.5999999999999999E-2</c:v>
                </c:pt>
                <c:pt idx="169">
                  <c:v>-2.5999999999999999E-2</c:v>
                </c:pt>
                <c:pt idx="170">
                  <c:v>-2.5999999999999999E-2</c:v>
                </c:pt>
                <c:pt idx="171">
                  <c:v>-2.5999999999999999E-2</c:v>
                </c:pt>
                <c:pt idx="172">
                  <c:v>-2.5999999999999999E-2</c:v>
                </c:pt>
                <c:pt idx="173">
                  <c:v>-2.5999999999999999E-2</c:v>
                </c:pt>
                <c:pt idx="174">
                  <c:v>-2.5999999999999999E-2</c:v>
                </c:pt>
                <c:pt idx="175">
                  <c:v>-2.5999999999999999E-2</c:v>
                </c:pt>
                <c:pt idx="176">
                  <c:v>-2.5999999999999999E-2</c:v>
                </c:pt>
                <c:pt idx="177">
                  <c:v>-2.5999999999999999E-2</c:v>
                </c:pt>
                <c:pt idx="178">
                  <c:v>-2.5999999999999999E-2</c:v>
                </c:pt>
                <c:pt idx="179">
                  <c:v>-2.5999999999999999E-2</c:v>
                </c:pt>
                <c:pt idx="180">
                  <c:v>-2.5999999999999999E-2</c:v>
                </c:pt>
                <c:pt idx="181">
                  <c:v>-2.5999999999999999E-2</c:v>
                </c:pt>
                <c:pt idx="182">
                  <c:v>-2.5999999999999999E-2</c:v>
                </c:pt>
                <c:pt idx="183">
                  <c:v>-2.5999999999999999E-2</c:v>
                </c:pt>
                <c:pt idx="184">
                  <c:v>-2.5999999999999999E-2</c:v>
                </c:pt>
                <c:pt idx="185">
                  <c:v>-2.5999999999999999E-2</c:v>
                </c:pt>
                <c:pt idx="186">
                  <c:v>-2.5999999999999999E-2</c:v>
                </c:pt>
                <c:pt idx="187">
                  <c:v>-2.5999999999999999E-2</c:v>
                </c:pt>
                <c:pt idx="188">
                  <c:v>-2.5999999999999999E-2</c:v>
                </c:pt>
                <c:pt idx="189">
                  <c:v>-2.5999999999999999E-2</c:v>
                </c:pt>
                <c:pt idx="190">
                  <c:v>-2.7E-2</c:v>
                </c:pt>
                <c:pt idx="191">
                  <c:v>-2.7E-2</c:v>
                </c:pt>
                <c:pt idx="192">
                  <c:v>-2.5999999999999999E-2</c:v>
                </c:pt>
                <c:pt idx="193">
                  <c:v>-2.5999999999999999E-2</c:v>
                </c:pt>
                <c:pt idx="194">
                  <c:v>-2.7E-2</c:v>
                </c:pt>
                <c:pt idx="195">
                  <c:v>-2.7E-2</c:v>
                </c:pt>
                <c:pt idx="196">
                  <c:v>-2.7E-2</c:v>
                </c:pt>
                <c:pt idx="197">
                  <c:v>-2.7E-2</c:v>
                </c:pt>
                <c:pt idx="198">
                  <c:v>-2.7E-2</c:v>
                </c:pt>
                <c:pt idx="199">
                  <c:v>-2.7E-2</c:v>
                </c:pt>
                <c:pt idx="200">
                  <c:v>-2.7E-2</c:v>
                </c:pt>
                <c:pt idx="201">
                  <c:v>-2.8000000000000001E-2</c:v>
                </c:pt>
                <c:pt idx="202">
                  <c:v>-2.8000000000000001E-2</c:v>
                </c:pt>
                <c:pt idx="203">
                  <c:v>-2.8000000000000001E-2</c:v>
                </c:pt>
                <c:pt idx="204">
                  <c:v>-2.8000000000000001E-2</c:v>
                </c:pt>
                <c:pt idx="205">
                  <c:v>-2.8000000000000001E-2</c:v>
                </c:pt>
                <c:pt idx="206">
                  <c:v>-2.8000000000000001E-2</c:v>
                </c:pt>
                <c:pt idx="207">
                  <c:v>-2.8000000000000001E-2</c:v>
                </c:pt>
                <c:pt idx="208">
                  <c:v>-2.8000000000000001E-2</c:v>
                </c:pt>
                <c:pt idx="209">
                  <c:v>-2.8000000000000001E-2</c:v>
                </c:pt>
                <c:pt idx="210">
                  <c:v>-2.8000000000000001E-2</c:v>
                </c:pt>
                <c:pt idx="211">
                  <c:v>-2.8000000000000001E-2</c:v>
                </c:pt>
                <c:pt idx="212">
                  <c:v>-2.8000000000000001E-2</c:v>
                </c:pt>
                <c:pt idx="213">
                  <c:v>-2.9000000000000001E-2</c:v>
                </c:pt>
                <c:pt idx="214">
                  <c:v>-2.9000000000000001E-2</c:v>
                </c:pt>
                <c:pt idx="215">
                  <c:v>-0.03</c:v>
                </c:pt>
                <c:pt idx="216">
                  <c:v>-0.03</c:v>
                </c:pt>
                <c:pt idx="217">
                  <c:v>-3.1E-2</c:v>
                </c:pt>
                <c:pt idx="218">
                  <c:v>-3.1E-2</c:v>
                </c:pt>
                <c:pt idx="219">
                  <c:v>-3.2000000000000001E-2</c:v>
                </c:pt>
                <c:pt idx="220">
                  <c:v>-3.2000000000000001E-2</c:v>
                </c:pt>
                <c:pt idx="221">
                  <c:v>-3.2000000000000001E-2</c:v>
                </c:pt>
                <c:pt idx="222">
                  <c:v>-3.2000000000000001E-2</c:v>
                </c:pt>
                <c:pt idx="223">
                  <c:v>-3.2000000000000001E-2</c:v>
                </c:pt>
                <c:pt idx="224">
                  <c:v>-3.2000000000000001E-2</c:v>
                </c:pt>
                <c:pt idx="225">
                  <c:v>-3.1E-2</c:v>
                </c:pt>
                <c:pt idx="226">
                  <c:v>-3.1E-2</c:v>
                </c:pt>
                <c:pt idx="227">
                  <c:v>-3.1E-2</c:v>
                </c:pt>
                <c:pt idx="228">
                  <c:v>-3.1E-2</c:v>
                </c:pt>
                <c:pt idx="229">
                  <c:v>-3.1E-2</c:v>
                </c:pt>
                <c:pt idx="230">
                  <c:v>-3.1E-2</c:v>
                </c:pt>
                <c:pt idx="231">
                  <c:v>-3.1E-2</c:v>
                </c:pt>
                <c:pt idx="232">
                  <c:v>-3.1E-2</c:v>
                </c:pt>
                <c:pt idx="233">
                  <c:v>-3.1E-2</c:v>
                </c:pt>
                <c:pt idx="234">
                  <c:v>-3.1E-2</c:v>
                </c:pt>
                <c:pt idx="235">
                  <c:v>-3.1E-2</c:v>
                </c:pt>
                <c:pt idx="236">
                  <c:v>-3.1E-2</c:v>
                </c:pt>
                <c:pt idx="237">
                  <c:v>-3.1E-2</c:v>
                </c:pt>
                <c:pt idx="238">
                  <c:v>-3.1E-2</c:v>
                </c:pt>
                <c:pt idx="239">
                  <c:v>-3.1E-2</c:v>
                </c:pt>
                <c:pt idx="240">
                  <c:v>-3.1E-2</c:v>
                </c:pt>
                <c:pt idx="241">
                  <c:v>-3.1E-2</c:v>
                </c:pt>
                <c:pt idx="242">
                  <c:v>-3.1E-2</c:v>
                </c:pt>
                <c:pt idx="243">
                  <c:v>-3.1E-2</c:v>
                </c:pt>
                <c:pt idx="244">
                  <c:v>-3.1E-2</c:v>
                </c:pt>
                <c:pt idx="245">
                  <c:v>-3.1E-2</c:v>
                </c:pt>
                <c:pt idx="246">
                  <c:v>-3.1E-2</c:v>
                </c:pt>
                <c:pt idx="247">
                  <c:v>-3.1E-2</c:v>
                </c:pt>
                <c:pt idx="248">
                  <c:v>-3.1E-2</c:v>
                </c:pt>
                <c:pt idx="249">
                  <c:v>-3.1E-2</c:v>
                </c:pt>
                <c:pt idx="250">
                  <c:v>-3.1E-2</c:v>
                </c:pt>
                <c:pt idx="251">
                  <c:v>-3.1E-2</c:v>
                </c:pt>
                <c:pt idx="252">
                  <c:v>-3.1E-2</c:v>
                </c:pt>
                <c:pt idx="253">
                  <c:v>-3.1E-2</c:v>
                </c:pt>
                <c:pt idx="254">
                  <c:v>-3.1E-2</c:v>
                </c:pt>
                <c:pt idx="255">
                  <c:v>-3.1E-2</c:v>
                </c:pt>
                <c:pt idx="256">
                  <c:v>-3.1E-2</c:v>
                </c:pt>
                <c:pt idx="257">
                  <c:v>-3.1E-2</c:v>
                </c:pt>
                <c:pt idx="258">
                  <c:v>-3.1E-2</c:v>
                </c:pt>
                <c:pt idx="259">
                  <c:v>-3.1E-2</c:v>
                </c:pt>
                <c:pt idx="260">
                  <c:v>-3.1E-2</c:v>
                </c:pt>
                <c:pt idx="261">
                  <c:v>-3.1E-2</c:v>
                </c:pt>
                <c:pt idx="262">
                  <c:v>-3.1E-2</c:v>
                </c:pt>
                <c:pt idx="263">
                  <c:v>-3.2000000000000001E-2</c:v>
                </c:pt>
                <c:pt idx="264">
                  <c:v>-3.2000000000000001E-2</c:v>
                </c:pt>
                <c:pt idx="265">
                  <c:v>-3.2000000000000001E-2</c:v>
                </c:pt>
                <c:pt idx="266">
                  <c:v>-3.2000000000000001E-2</c:v>
                </c:pt>
                <c:pt idx="267">
                  <c:v>-3.2000000000000001E-2</c:v>
                </c:pt>
                <c:pt idx="268">
                  <c:v>-3.2000000000000001E-2</c:v>
                </c:pt>
                <c:pt idx="269">
                  <c:v>-3.2000000000000001E-2</c:v>
                </c:pt>
                <c:pt idx="270">
                  <c:v>-3.2000000000000001E-2</c:v>
                </c:pt>
                <c:pt idx="271">
                  <c:v>-3.2000000000000001E-2</c:v>
                </c:pt>
                <c:pt idx="272">
                  <c:v>-3.2000000000000001E-2</c:v>
                </c:pt>
                <c:pt idx="273">
                  <c:v>-3.2000000000000001E-2</c:v>
                </c:pt>
                <c:pt idx="274">
                  <c:v>-3.2000000000000001E-2</c:v>
                </c:pt>
                <c:pt idx="275">
                  <c:v>-3.3000000000000002E-2</c:v>
                </c:pt>
                <c:pt idx="276">
                  <c:v>-3.3000000000000002E-2</c:v>
                </c:pt>
                <c:pt idx="277">
                  <c:v>-3.3000000000000002E-2</c:v>
                </c:pt>
                <c:pt idx="278">
                  <c:v>-3.3000000000000002E-2</c:v>
                </c:pt>
                <c:pt idx="279">
                  <c:v>-3.3000000000000002E-2</c:v>
                </c:pt>
                <c:pt idx="280">
                  <c:v>-3.3000000000000002E-2</c:v>
                </c:pt>
                <c:pt idx="281">
                  <c:v>-3.3000000000000002E-2</c:v>
                </c:pt>
                <c:pt idx="282">
                  <c:v>-3.4000000000000002E-2</c:v>
                </c:pt>
                <c:pt idx="283">
                  <c:v>-3.4000000000000002E-2</c:v>
                </c:pt>
                <c:pt idx="284">
                  <c:v>-3.4000000000000002E-2</c:v>
                </c:pt>
                <c:pt idx="285">
                  <c:v>-3.4000000000000002E-2</c:v>
                </c:pt>
                <c:pt idx="286">
                  <c:v>-3.4000000000000002E-2</c:v>
                </c:pt>
                <c:pt idx="287">
                  <c:v>-3.4000000000000002E-2</c:v>
                </c:pt>
                <c:pt idx="288">
                  <c:v>-3.4000000000000002E-2</c:v>
                </c:pt>
                <c:pt idx="289">
                  <c:v>-3.5000000000000003E-2</c:v>
                </c:pt>
                <c:pt idx="290">
                  <c:v>-3.5000000000000003E-2</c:v>
                </c:pt>
                <c:pt idx="291">
                  <c:v>-3.5000000000000003E-2</c:v>
                </c:pt>
                <c:pt idx="292">
                  <c:v>-3.5000000000000003E-2</c:v>
                </c:pt>
                <c:pt idx="293">
                  <c:v>-3.5000000000000003E-2</c:v>
                </c:pt>
                <c:pt idx="294">
                  <c:v>-3.5000000000000003E-2</c:v>
                </c:pt>
                <c:pt idx="295">
                  <c:v>-3.5000000000000003E-2</c:v>
                </c:pt>
                <c:pt idx="296">
                  <c:v>-3.5000000000000003E-2</c:v>
                </c:pt>
                <c:pt idx="297">
                  <c:v>-3.5999999999999997E-2</c:v>
                </c:pt>
                <c:pt idx="298">
                  <c:v>-3.5999999999999997E-2</c:v>
                </c:pt>
                <c:pt idx="299">
                  <c:v>-3.5999999999999997E-2</c:v>
                </c:pt>
                <c:pt idx="300">
                  <c:v>-3.5999999999999997E-2</c:v>
                </c:pt>
                <c:pt idx="301">
                  <c:v>-3.5999999999999997E-2</c:v>
                </c:pt>
                <c:pt idx="302">
                  <c:v>-3.5999999999999997E-2</c:v>
                </c:pt>
                <c:pt idx="303">
                  <c:v>-3.5999999999999997E-2</c:v>
                </c:pt>
                <c:pt idx="304">
                  <c:v>-3.5999999999999997E-2</c:v>
                </c:pt>
                <c:pt idx="305">
                  <c:v>-3.5999999999999997E-2</c:v>
                </c:pt>
                <c:pt idx="306">
                  <c:v>-3.5999999999999997E-2</c:v>
                </c:pt>
                <c:pt idx="307">
                  <c:v>-3.5999999999999997E-2</c:v>
                </c:pt>
                <c:pt idx="308">
                  <c:v>-3.5999999999999997E-2</c:v>
                </c:pt>
                <c:pt idx="309">
                  <c:v>-3.5999999999999997E-2</c:v>
                </c:pt>
                <c:pt idx="310">
                  <c:v>-3.5999999999999997E-2</c:v>
                </c:pt>
                <c:pt idx="311">
                  <c:v>-3.5000000000000003E-2</c:v>
                </c:pt>
                <c:pt idx="312">
                  <c:v>-3.5000000000000003E-2</c:v>
                </c:pt>
                <c:pt idx="313">
                  <c:v>-3.5000000000000003E-2</c:v>
                </c:pt>
                <c:pt idx="314">
                  <c:v>-3.5000000000000003E-2</c:v>
                </c:pt>
                <c:pt idx="315">
                  <c:v>-3.5000000000000003E-2</c:v>
                </c:pt>
                <c:pt idx="316">
                  <c:v>-3.5000000000000003E-2</c:v>
                </c:pt>
                <c:pt idx="317">
                  <c:v>-3.5000000000000003E-2</c:v>
                </c:pt>
                <c:pt idx="318">
                  <c:v>-3.5999999999999997E-2</c:v>
                </c:pt>
                <c:pt idx="319">
                  <c:v>-3.5999999999999997E-2</c:v>
                </c:pt>
                <c:pt idx="320">
                  <c:v>-3.5999999999999997E-2</c:v>
                </c:pt>
                <c:pt idx="321">
                  <c:v>-3.6999999999999998E-2</c:v>
                </c:pt>
                <c:pt idx="322">
                  <c:v>-3.6999999999999998E-2</c:v>
                </c:pt>
                <c:pt idx="323">
                  <c:v>-3.6999999999999998E-2</c:v>
                </c:pt>
                <c:pt idx="324">
                  <c:v>-3.6999999999999998E-2</c:v>
                </c:pt>
                <c:pt idx="325">
                  <c:v>-3.6999999999999998E-2</c:v>
                </c:pt>
                <c:pt idx="326">
                  <c:v>-3.7999999999999999E-2</c:v>
                </c:pt>
                <c:pt idx="327">
                  <c:v>-3.7999999999999999E-2</c:v>
                </c:pt>
                <c:pt idx="328">
                  <c:v>-3.7999999999999999E-2</c:v>
                </c:pt>
                <c:pt idx="329">
                  <c:v>-3.7999999999999999E-2</c:v>
                </c:pt>
                <c:pt idx="330">
                  <c:v>-3.7999999999999999E-2</c:v>
                </c:pt>
                <c:pt idx="331">
                  <c:v>-3.7999999999999999E-2</c:v>
                </c:pt>
                <c:pt idx="332">
                  <c:v>-3.7999999999999999E-2</c:v>
                </c:pt>
                <c:pt idx="333">
                  <c:v>-3.7999999999999999E-2</c:v>
                </c:pt>
                <c:pt idx="334">
                  <c:v>-3.7999999999999999E-2</c:v>
                </c:pt>
                <c:pt idx="335">
                  <c:v>-3.7999999999999999E-2</c:v>
                </c:pt>
                <c:pt idx="336">
                  <c:v>-3.7999999999999999E-2</c:v>
                </c:pt>
                <c:pt idx="337">
                  <c:v>-3.7999999999999999E-2</c:v>
                </c:pt>
                <c:pt idx="338">
                  <c:v>-3.7999999999999999E-2</c:v>
                </c:pt>
                <c:pt idx="339">
                  <c:v>-3.7999999999999999E-2</c:v>
                </c:pt>
                <c:pt idx="340">
                  <c:v>-3.7999999999999999E-2</c:v>
                </c:pt>
                <c:pt idx="341">
                  <c:v>-3.9E-2</c:v>
                </c:pt>
                <c:pt idx="342">
                  <c:v>-3.9E-2</c:v>
                </c:pt>
                <c:pt idx="343">
                  <c:v>-3.9E-2</c:v>
                </c:pt>
                <c:pt idx="344">
                  <c:v>-3.9E-2</c:v>
                </c:pt>
                <c:pt idx="345">
                  <c:v>-3.9E-2</c:v>
                </c:pt>
                <c:pt idx="346">
                  <c:v>-3.9E-2</c:v>
                </c:pt>
                <c:pt idx="347">
                  <c:v>-3.9E-2</c:v>
                </c:pt>
                <c:pt idx="348">
                  <c:v>-3.9E-2</c:v>
                </c:pt>
                <c:pt idx="349">
                  <c:v>-3.9E-2</c:v>
                </c:pt>
                <c:pt idx="350">
                  <c:v>-3.9E-2</c:v>
                </c:pt>
                <c:pt idx="351">
                  <c:v>-3.9E-2</c:v>
                </c:pt>
                <c:pt idx="352">
                  <c:v>-3.9E-2</c:v>
                </c:pt>
                <c:pt idx="353">
                  <c:v>-3.9E-2</c:v>
                </c:pt>
                <c:pt idx="354">
                  <c:v>-3.9E-2</c:v>
                </c:pt>
                <c:pt idx="355">
                  <c:v>-3.9E-2</c:v>
                </c:pt>
                <c:pt idx="356">
                  <c:v>-0.04</c:v>
                </c:pt>
                <c:pt idx="357">
                  <c:v>-0.04</c:v>
                </c:pt>
                <c:pt idx="358">
                  <c:v>-0.04</c:v>
                </c:pt>
                <c:pt idx="359">
                  <c:v>-0.04</c:v>
                </c:pt>
                <c:pt idx="360">
                  <c:v>-0.04</c:v>
                </c:pt>
                <c:pt idx="361">
                  <c:v>-0.04</c:v>
                </c:pt>
                <c:pt idx="362">
                  <c:v>-0.04</c:v>
                </c:pt>
                <c:pt idx="363">
                  <c:v>-0.04</c:v>
                </c:pt>
                <c:pt idx="364">
                  <c:v>-0.04</c:v>
                </c:pt>
                <c:pt idx="365">
                  <c:v>-0.04</c:v>
                </c:pt>
                <c:pt idx="366">
                  <c:v>-0.04</c:v>
                </c:pt>
                <c:pt idx="367">
                  <c:v>-0.04</c:v>
                </c:pt>
                <c:pt idx="368">
                  <c:v>-0.04</c:v>
                </c:pt>
                <c:pt idx="369">
                  <c:v>-0.04</c:v>
                </c:pt>
                <c:pt idx="370">
                  <c:v>-0.04</c:v>
                </c:pt>
                <c:pt idx="371">
                  <c:v>-0.04</c:v>
                </c:pt>
                <c:pt idx="372">
                  <c:v>-4.1000000000000002E-2</c:v>
                </c:pt>
                <c:pt idx="373">
                  <c:v>-0.04</c:v>
                </c:pt>
                <c:pt idx="374">
                  <c:v>-4.1000000000000002E-2</c:v>
                </c:pt>
                <c:pt idx="375">
                  <c:v>-4.1000000000000002E-2</c:v>
                </c:pt>
                <c:pt idx="376">
                  <c:v>-4.1000000000000002E-2</c:v>
                </c:pt>
                <c:pt idx="377">
                  <c:v>-4.1000000000000002E-2</c:v>
                </c:pt>
                <c:pt idx="378">
                  <c:v>-4.1000000000000002E-2</c:v>
                </c:pt>
                <c:pt idx="379">
                  <c:v>-4.1000000000000002E-2</c:v>
                </c:pt>
                <c:pt idx="380">
                  <c:v>-4.1000000000000002E-2</c:v>
                </c:pt>
                <c:pt idx="381">
                  <c:v>-4.1000000000000002E-2</c:v>
                </c:pt>
                <c:pt idx="382">
                  <c:v>-4.1000000000000002E-2</c:v>
                </c:pt>
                <c:pt idx="383">
                  <c:v>-4.1000000000000002E-2</c:v>
                </c:pt>
                <c:pt idx="384">
                  <c:v>-4.1000000000000002E-2</c:v>
                </c:pt>
                <c:pt idx="385">
                  <c:v>-4.1000000000000002E-2</c:v>
                </c:pt>
                <c:pt idx="386">
                  <c:v>-4.1000000000000002E-2</c:v>
                </c:pt>
                <c:pt idx="387">
                  <c:v>-4.1000000000000002E-2</c:v>
                </c:pt>
                <c:pt idx="388">
                  <c:v>-4.1000000000000002E-2</c:v>
                </c:pt>
                <c:pt idx="389">
                  <c:v>-4.1000000000000002E-2</c:v>
                </c:pt>
                <c:pt idx="390">
                  <c:v>-4.1000000000000002E-2</c:v>
                </c:pt>
                <c:pt idx="391">
                  <c:v>-4.1000000000000002E-2</c:v>
                </c:pt>
                <c:pt idx="392">
                  <c:v>-4.1000000000000002E-2</c:v>
                </c:pt>
                <c:pt idx="393">
                  <c:v>-4.1000000000000002E-2</c:v>
                </c:pt>
                <c:pt idx="394">
                  <c:v>-0.04</c:v>
                </c:pt>
                <c:pt idx="395">
                  <c:v>-0.04</c:v>
                </c:pt>
                <c:pt idx="396">
                  <c:v>-0.04</c:v>
                </c:pt>
                <c:pt idx="397">
                  <c:v>-0.04</c:v>
                </c:pt>
                <c:pt idx="398">
                  <c:v>-0.04</c:v>
                </c:pt>
                <c:pt idx="399">
                  <c:v>-3.9E-2</c:v>
                </c:pt>
                <c:pt idx="400">
                  <c:v>-3.9E-2</c:v>
                </c:pt>
                <c:pt idx="401">
                  <c:v>-3.9E-2</c:v>
                </c:pt>
                <c:pt idx="402">
                  <c:v>-3.7999999999999999E-2</c:v>
                </c:pt>
                <c:pt idx="403">
                  <c:v>-3.7999999999999999E-2</c:v>
                </c:pt>
                <c:pt idx="404">
                  <c:v>-3.6999999999999998E-2</c:v>
                </c:pt>
                <c:pt idx="405">
                  <c:v>-3.6999999999999998E-2</c:v>
                </c:pt>
                <c:pt idx="406">
                  <c:v>-3.5999999999999997E-2</c:v>
                </c:pt>
                <c:pt idx="407">
                  <c:v>-3.5999999999999997E-2</c:v>
                </c:pt>
                <c:pt idx="408">
                  <c:v>-3.5000000000000003E-2</c:v>
                </c:pt>
                <c:pt idx="409">
                  <c:v>-3.4000000000000002E-2</c:v>
                </c:pt>
                <c:pt idx="410">
                  <c:v>-3.4000000000000002E-2</c:v>
                </c:pt>
                <c:pt idx="411">
                  <c:v>-3.3000000000000002E-2</c:v>
                </c:pt>
                <c:pt idx="412">
                  <c:v>-3.2000000000000001E-2</c:v>
                </c:pt>
                <c:pt idx="413">
                  <c:v>-3.1E-2</c:v>
                </c:pt>
                <c:pt idx="414">
                  <c:v>-0.03</c:v>
                </c:pt>
                <c:pt idx="415">
                  <c:v>-2.9000000000000001E-2</c:v>
                </c:pt>
                <c:pt idx="416">
                  <c:v>-2.8000000000000001E-2</c:v>
                </c:pt>
                <c:pt idx="417">
                  <c:v>-2.7E-2</c:v>
                </c:pt>
                <c:pt idx="418">
                  <c:v>-2.5999999999999999E-2</c:v>
                </c:pt>
                <c:pt idx="419">
                  <c:v>-2.5000000000000001E-2</c:v>
                </c:pt>
                <c:pt idx="420">
                  <c:v>-2.4E-2</c:v>
                </c:pt>
                <c:pt idx="421">
                  <c:v>-1.9E-2</c:v>
                </c:pt>
                <c:pt idx="422">
                  <c:v>-3.0000000000000001E-3</c:v>
                </c:pt>
                <c:pt idx="423">
                  <c:v>-2E-3</c:v>
                </c:pt>
                <c:pt idx="424">
                  <c:v>-1E-3</c:v>
                </c:pt>
                <c:pt idx="425">
                  <c:v>1E-3</c:v>
                </c:pt>
                <c:pt idx="426">
                  <c:v>3.0000000000000001E-3</c:v>
                </c:pt>
                <c:pt idx="427">
                  <c:v>3.0000000000000001E-3</c:v>
                </c:pt>
                <c:pt idx="428">
                  <c:v>5.0000000000000001E-3</c:v>
                </c:pt>
                <c:pt idx="429">
                  <c:v>6.0000000000000001E-3</c:v>
                </c:pt>
                <c:pt idx="430">
                  <c:v>8.0000000000000002E-3</c:v>
                </c:pt>
                <c:pt idx="431">
                  <c:v>8.9999999999999993E-3</c:v>
                </c:pt>
                <c:pt idx="432">
                  <c:v>1.0999999999999999E-2</c:v>
                </c:pt>
                <c:pt idx="433">
                  <c:v>1.2E-2</c:v>
                </c:pt>
                <c:pt idx="434">
                  <c:v>1.4E-2</c:v>
                </c:pt>
                <c:pt idx="435">
                  <c:v>1.4999999999999999E-2</c:v>
                </c:pt>
                <c:pt idx="436">
                  <c:v>1.6E-2</c:v>
                </c:pt>
                <c:pt idx="437">
                  <c:v>1.7999999999999999E-2</c:v>
                </c:pt>
                <c:pt idx="438">
                  <c:v>1.9E-2</c:v>
                </c:pt>
                <c:pt idx="439">
                  <c:v>0.02</c:v>
                </c:pt>
                <c:pt idx="440">
                  <c:v>2.1000000000000001E-2</c:v>
                </c:pt>
                <c:pt idx="441">
                  <c:v>2.1999999999999999E-2</c:v>
                </c:pt>
                <c:pt idx="442">
                  <c:v>2.4E-2</c:v>
                </c:pt>
                <c:pt idx="443">
                  <c:v>2.5000000000000001E-2</c:v>
                </c:pt>
                <c:pt idx="444">
                  <c:v>2.5999999999999999E-2</c:v>
                </c:pt>
                <c:pt idx="445">
                  <c:v>2.7E-2</c:v>
                </c:pt>
                <c:pt idx="446">
                  <c:v>2.8000000000000001E-2</c:v>
                </c:pt>
                <c:pt idx="447">
                  <c:v>2.9000000000000001E-2</c:v>
                </c:pt>
                <c:pt idx="448">
                  <c:v>0.03</c:v>
                </c:pt>
                <c:pt idx="449">
                  <c:v>3.2000000000000001E-2</c:v>
                </c:pt>
                <c:pt idx="450">
                  <c:v>3.2000000000000001E-2</c:v>
                </c:pt>
                <c:pt idx="451">
                  <c:v>3.3000000000000002E-2</c:v>
                </c:pt>
                <c:pt idx="452">
                  <c:v>3.4000000000000002E-2</c:v>
                </c:pt>
                <c:pt idx="453">
                  <c:v>3.5000000000000003E-2</c:v>
                </c:pt>
                <c:pt idx="454">
                  <c:v>3.5999999999999997E-2</c:v>
                </c:pt>
                <c:pt idx="455">
                  <c:v>3.6999999999999998E-2</c:v>
                </c:pt>
                <c:pt idx="456">
                  <c:v>3.7999999999999999E-2</c:v>
                </c:pt>
                <c:pt idx="457">
                  <c:v>3.7999999999999999E-2</c:v>
                </c:pt>
                <c:pt idx="458">
                  <c:v>3.9E-2</c:v>
                </c:pt>
                <c:pt idx="459">
                  <c:v>0.04</c:v>
                </c:pt>
                <c:pt idx="460">
                  <c:v>4.1000000000000002E-2</c:v>
                </c:pt>
                <c:pt idx="461">
                  <c:v>0.03</c:v>
                </c:pt>
                <c:pt idx="462">
                  <c:v>2.5000000000000001E-2</c:v>
                </c:pt>
                <c:pt idx="463">
                  <c:v>2.5000000000000001E-2</c:v>
                </c:pt>
                <c:pt idx="464">
                  <c:v>2.5999999999999999E-2</c:v>
                </c:pt>
                <c:pt idx="465">
                  <c:v>2.5999999999999999E-2</c:v>
                </c:pt>
                <c:pt idx="466">
                  <c:v>2.7E-2</c:v>
                </c:pt>
                <c:pt idx="467">
                  <c:v>2.7E-2</c:v>
                </c:pt>
                <c:pt idx="468">
                  <c:v>2.8000000000000001E-2</c:v>
                </c:pt>
                <c:pt idx="469">
                  <c:v>2.8000000000000001E-2</c:v>
                </c:pt>
                <c:pt idx="470">
                  <c:v>2.8000000000000001E-2</c:v>
                </c:pt>
                <c:pt idx="471">
                  <c:v>2.8000000000000001E-2</c:v>
                </c:pt>
                <c:pt idx="472">
                  <c:v>2.9000000000000001E-2</c:v>
                </c:pt>
                <c:pt idx="473">
                  <c:v>2.9000000000000001E-2</c:v>
                </c:pt>
                <c:pt idx="474">
                  <c:v>2.9000000000000001E-2</c:v>
                </c:pt>
                <c:pt idx="475">
                  <c:v>2.9000000000000001E-2</c:v>
                </c:pt>
                <c:pt idx="476">
                  <c:v>2.9000000000000001E-2</c:v>
                </c:pt>
                <c:pt idx="477">
                  <c:v>2.9000000000000001E-2</c:v>
                </c:pt>
                <c:pt idx="478">
                  <c:v>2.9000000000000001E-2</c:v>
                </c:pt>
                <c:pt idx="479">
                  <c:v>2.9000000000000001E-2</c:v>
                </c:pt>
                <c:pt idx="480">
                  <c:v>2.9000000000000001E-2</c:v>
                </c:pt>
                <c:pt idx="481">
                  <c:v>2.8000000000000001E-2</c:v>
                </c:pt>
                <c:pt idx="482">
                  <c:v>2.8000000000000001E-2</c:v>
                </c:pt>
                <c:pt idx="483">
                  <c:v>2.8000000000000001E-2</c:v>
                </c:pt>
                <c:pt idx="484">
                  <c:v>2.7E-2</c:v>
                </c:pt>
                <c:pt idx="485">
                  <c:v>2.7E-2</c:v>
                </c:pt>
                <c:pt idx="486">
                  <c:v>2.5999999999999999E-2</c:v>
                </c:pt>
                <c:pt idx="487">
                  <c:v>2.5999999999999999E-2</c:v>
                </c:pt>
                <c:pt idx="488">
                  <c:v>2.5000000000000001E-2</c:v>
                </c:pt>
                <c:pt idx="489">
                  <c:v>2.5000000000000001E-2</c:v>
                </c:pt>
                <c:pt idx="490">
                  <c:v>2.5000000000000001E-2</c:v>
                </c:pt>
                <c:pt idx="491">
                  <c:v>2.4E-2</c:v>
                </c:pt>
                <c:pt idx="492">
                  <c:v>2.4E-2</c:v>
                </c:pt>
                <c:pt idx="493">
                  <c:v>2.3E-2</c:v>
                </c:pt>
                <c:pt idx="494">
                  <c:v>2.3E-2</c:v>
                </c:pt>
                <c:pt idx="495">
                  <c:v>2.3E-2</c:v>
                </c:pt>
                <c:pt idx="496">
                  <c:v>2.1999999999999999E-2</c:v>
                </c:pt>
                <c:pt idx="497">
                  <c:v>2.1999999999999999E-2</c:v>
                </c:pt>
                <c:pt idx="498">
                  <c:v>2.1999999999999999E-2</c:v>
                </c:pt>
                <c:pt idx="499">
                  <c:v>2.1999999999999999E-2</c:v>
                </c:pt>
                <c:pt idx="500">
                  <c:v>2.1999999999999999E-2</c:v>
                </c:pt>
                <c:pt idx="501">
                  <c:v>2.1999999999999999E-2</c:v>
                </c:pt>
                <c:pt idx="502">
                  <c:v>2.1999999999999999E-2</c:v>
                </c:pt>
                <c:pt idx="503">
                  <c:v>2.1999999999999999E-2</c:v>
                </c:pt>
                <c:pt idx="504">
                  <c:v>2.3E-2</c:v>
                </c:pt>
                <c:pt idx="505">
                  <c:v>2.3E-2</c:v>
                </c:pt>
                <c:pt idx="506">
                  <c:v>2.3E-2</c:v>
                </c:pt>
                <c:pt idx="507">
                  <c:v>2.4E-2</c:v>
                </c:pt>
                <c:pt idx="508">
                  <c:v>2.4E-2</c:v>
                </c:pt>
                <c:pt idx="509">
                  <c:v>2.5000000000000001E-2</c:v>
                </c:pt>
                <c:pt idx="510">
                  <c:v>2.5000000000000001E-2</c:v>
                </c:pt>
                <c:pt idx="511">
                  <c:v>2.5999999999999999E-2</c:v>
                </c:pt>
                <c:pt idx="512">
                  <c:v>2.5999999999999999E-2</c:v>
                </c:pt>
                <c:pt idx="513">
                  <c:v>2.7E-2</c:v>
                </c:pt>
                <c:pt idx="514">
                  <c:v>2.7E-2</c:v>
                </c:pt>
                <c:pt idx="515">
                  <c:v>2.7E-2</c:v>
                </c:pt>
                <c:pt idx="516">
                  <c:v>2.8000000000000001E-2</c:v>
                </c:pt>
                <c:pt idx="517">
                  <c:v>2.9000000000000001E-2</c:v>
                </c:pt>
                <c:pt idx="518">
                  <c:v>2.9000000000000001E-2</c:v>
                </c:pt>
                <c:pt idx="519">
                  <c:v>0.03</c:v>
                </c:pt>
                <c:pt idx="520">
                  <c:v>3.1E-2</c:v>
                </c:pt>
                <c:pt idx="521">
                  <c:v>3.2000000000000001E-2</c:v>
                </c:pt>
                <c:pt idx="522">
                  <c:v>3.4000000000000002E-2</c:v>
                </c:pt>
                <c:pt idx="523">
                  <c:v>3.5999999999999997E-2</c:v>
                </c:pt>
                <c:pt idx="524">
                  <c:v>3.6999999999999998E-2</c:v>
                </c:pt>
                <c:pt idx="525">
                  <c:v>3.9E-2</c:v>
                </c:pt>
                <c:pt idx="526">
                  <c:v>4.2000000000000003E-2</c:v>
                </c:pt>
                <c:pt idx="527">
                  <c:v>4.3999999999999997E-2</c:v>
                </c:pt>
                <c:pt idx="528">
                  <c:v>4.5999999999999999E-2</c:v>
                </c:pt>
                <c:pt idx="529">
                  <c:v>4.9000000000000002E-2</c:v>
                </c:pt>
                <c:pt idx="530">
                  <c:v>0.05</c:v>
                </c:pt>
                <c:pt idx="531">
                  <c:v>5.1999999999999998E-2</c:v>
                </c:pt>
                <c:pt idx="532">
                  <c:v>5.2999999999999999E-2</c:v>
                </c:pt>
                <c:pt idx="533">
                  <c:v>5.2999999999999999E-2</c:v>
                </c:pt>
                <c:pt idx="534">
                  <c:v>5.2999999999999999E-2</c:v>
                </c:pt>
                <c:pt idx="535">
                  <c:v>5.2999999999999999E-2</c:v>
                </c:pt>
                <c:pt idx="536">
                  <c:v>5.1999999999999998E-2</c:v>
                </c:pt>
                <c:pt idx="537">
                  <c:v>5.0999999999999997E-2</c:v>
                </c:pt>
                <c:pt idx="538">
                  <c:v>5.0999999999999997E-2</c:v>
                </c:pt>
                <c:pt idx="539">
                  <c:v>0.05</c:v>
                </c:pt>
                <c:pt idx="540">
                  <c:v>0.05</c:v>
                </c:pt>
                <c:pt idx="541">
                  <c:v>4.9000000000000002E-2</c:v>
                </c:pt>
                <c:pt idx="542">
                  <c:v>4.9000000000000002E-2</c:v>
                </c:pt>
                <c:pt idx="543">
                  <c:v>4.9000000000000002E-2</c:v>
                </c:pt>
                <c:pt idx="544">
                  <c:v>4.9000000000000002E-2</c:v>
                </c:pt>
                <c:pt idx="545">
                  <c:v>0.05</c:v>
                </c:pt>
                <c:pt idx="546">
                  <c:v>0.05</c:v>
                </c:pt>
                <c:pt idx="547">
                  <c:v>5.0999999999999997E-2</c:v>
                </c:pt>
                <c:pt idx="548">
                  <c:v>5.1999999999999998E-2</c:v>
                </c:pt>
                <c:pt idx="549">
                  <c:v>5.2999999999999999E-2</c:v>
                </c:pt>
                <c:pt idx="550">
                  <c:v>5.3999999999999999E-2</c:v>
                </c:pt>
                <c:pt idx="551">
                  <c:v>5.5E-2</c:v>
                </c:pt>
                <c:pt idx="552">
                  <c:v>5.7000000000000002E-2</c:v>
                </c:pt>
                <c:pt idx="553">
                  <c:v>5.8000000000000003E-2</c:v>
                </c:pt>
                <c:pt idx="554">
                  <c:v>0.06</c:v>
                </c:pt>
                <c:pt idx="555">
                  <c:v>6.0999999999999999E-2</c:v>
                </c:pt>
                <c:pt idx="556">
                  <c:v>6.3E-2</c:v>
                </c:pt>
                <c:pt idx="557">
                  <c:v>6.5000000000000002E-2</c:v>
                </c:pt>
                <c:pt idx="558">
                  <c:v>6.7000000000000004E-2</c:v>
                </c:pt>
                <c:pt idx="559">
                  <c:v>6.9000000000000006E-2</c:v>
                </c:pt>
                <c:pt idx="560">
                  <c:v>7.0999999999999994E-2</c:v>
                </c:pt>
                <c:pt idx="561">
                  <c:v>7.2999999999999995E-2</c:v>
                </c:pt>
                <c:pt idx="562">
                  <c:v>7.5999999999999998E-2</c:v>
                </c:pt>
                <c:pt idx="563">
                  <c:v>7.9000000000000001E-2</c:v>
                </c:pt>
                <c:pt idx="564">
                  <c:v>8.3000000000000004E-2</c:v>
                </c:pt>
                <c:pt idx="565">
                  <c:v>8.6999999999999994E-2</c:v>
                </c:pt>
                <c:pt idx="566">
                  <c:v>9.1999999999999998E-2</c:v>
                </c:pt>
                <c:pt idx="567">
                  <c:v>9.8000000000000004E-2</c:v>
                </c:pt>
                <c:pt idx="568">
                  <c:v>0.104</c:v>
                </c:pt>
                <c:pt idx="569">
                  <c:v>0.111</c:v>
                </c:pt>
                <c:pt idx="570">
                  <c:v>0.11799999999999999</c:v>
                </c:pt>
                <c:pt idx="571">
                  <c:v>0.126</c:v>
                </c:pt>
                <c:pt idx="572">
                  <c:v>0.13400000000000001</c:v>
                </c:pt>
                <c:pt idx="573">
                  <c:v>0.14299999999999999</c:v>
                </c:pt>
                <c:pt idx="574">
                  <c:v>0.153</c:v>
                </c:pt>
                <c:pt idx="575">
                  <c:v>0.16200000000000001</c:v>
                </c:pt>
                <c:pt idx="576">
                  <c:v>0.17299999999999999</c:v>
                </c:pt>
                <c:pt idx="577">
                  <c:v>0.184</c:v>
                </c:pt>
                <c:pt idx="578">
                  <c:v>0.19500000000000001</c:v>
                </c:pt>
                <c:pt idx="579">
                  <c:v>0.20599999999999999</c:v>
                </c:pt>
                <c:pt idx="580">
                  <c:v>0.217</c:v>
                </c:pt>
                <c:pt idx="581">
                  <c:v>0.22800000000000001</c:v>
                </c:pt>
                <c:pt idx="582">
                  <c:v>0.24</c:v>
                </c:pt>
                <c:pt idx="583">
                  <c:v>0.252</c:v>
                </c:pt>
                <c:pt idx="584">
                  <c:v>0.26500000000000001</c:v>
                </c:pt>
                <c:pt idx="585">
                  <c:v>0.27900000000000003</c:v>
                </c:pt>
                <c:pt idx="586">
                  <c:v>0.29299999999999998</c:v>
                </c:pt>
                <c:pt idx="587">
                  <c:v>0.31</c:v>
                </c:pt>
                <c:pt idx="588">
                  <c:v>0.32600000000000001</c:v>
                </c:pt>
                <c:pt idx="589">
                  <c:v>0.34399999999999997</c:v>
                </c:pt>
                <c:pt idx="590">
                  <c:v>0.36199999999999999</c:v>
                </c:pt>
                <c:pt idx="591">
                  <c:v>0.38100000000000001</c:v>
                </c:pt>
                <c:pt idx="592">
                  <c:v>0.40100000000000002</c:v>
                </c:pt>
                <c:pt idx="593">
                  <c:v>0.42199999999999999</c:v>
                </c:pt>
                <c:pt idx="594">
                  <c:v>0.443</c:v>
                </c:pt>
                <c:pt idx="595">
                  <c:v>0.46600000000000003</c:v>
                </c:pt>
                <c:pt idx="596">
                  <c:v>0.49</c:v>
                </c:pt>
                <c:pt idx="597">
                  <c:v>0.51500000000000001</c:v>
                </c:pt>
                <c:pt idx="598">
                  <c:v>0.54200000000000004</c:v>
                </c:pt>
                <c:pt idx="599">
                  <c:v>0.56999999999999995</c:v>
                </c:pt>
                <c:pt idx="600">
                  <c:v>0.598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E505-40FA-858A-3227CC8E4DA5}"/>
            </c:ext>
          </c:extLst>
        </c:ser>
        <c:ser>
          <c:idx val="3"/>
          <c:order val="3"/>
          <c:tx>
            <c:strRef>
              <c:f>'water-F'!$E$2</c:f>
              <c:strCache>
                <c:ptCount val="1"/>
                <c:pt idx="0">
                  <c:v>Mustard </c:v>
                </c:pt>
              </c:strCache>
            </c:strRef>
          </c:tx>
          <c:spPr>
            <a:ln>
              <a:prstDash val="dash"/>
            </a:ln>
          </c:spPr>
          <c:marker>
            <c:symbol val="none"/>
          </c:marker>
          <c:xVal>
            <c:numRef>
              <c:f>'water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water-F'!$E$3:$E$603</c:f>
              <c:numCache>
                <c:formatCode>General</c:formatCode>
                <c:ptCount val="601"/>
                <c:pt idx="0">
                  <c:v>-4.0000000000000001E-3</c:v>
                </c:pt>
                <c:pt idx="1">
                  <c:v>-4.0000000000000001E-3</c:v>
                </c:pt>
                <c:pt idx="2">
                  <c:v>-4.0000000000000001E-3</c:v>
                </c:pt>
                <c:pt idx="3">
                  <c:v>-4.0000000000000001E-3</c:v>
                </c:pt>
                <c:pt idx="4">
                  <c:v>-4.0000000000000001E-3</c:v>
                </c:pt>
                <c:pt idx="5">
                  <c:v>-4.0000000000000001E-3</c:v>
                </c:pt>
                <c:pt idx="6">
                  <c:v>-5.0000000000000001E-3</c:v>
                </c:pt>
                <c:pt idx="7">
                  <c:v>-5.0000000000000001E-3</c:v>
                </c:pt>
                <c:pt idx="8">
                  <c:v>-5.0000000000000001E-3</c:v>
                </c:pt>
                <c:pt idx="9">
                  <c:v>-5.0000000000000001E-3</c:v>
                </c:pt>
                <c:pt idx="10">
                  <c:v>-5.0000000000000001E-3</c:v>
                </c:pt>
                <c:pt idx="11">
                  <c:v>-6.0000000000000001E-3</c:v>
                </c:pt>
                <c:pt idx="12">
                  <c:v>-6.0000000000000001E-3</c:v>
                </c:pt>
                <c:pt idx="13">
                  <c:v>-6.0000000000000001E-3</c:v>
                </c:pt>
                <c:pt idx="14">
                  <c:v>-6.0000000000000001E-3</c:v>
                </c:pt>
                <c:pt idx="15">
                  <c:v>-6.0000000000000001E-3</c:v>
                </c:pt>
                <c:pt idx="16">
                  <c:v>-6.0000000000000001E-3</c:v>
                </c:pt>
                <c:pt idx="17">
                  <c:v>-7.0000000000000001E-3</c:v>
                </c:pt>
                <c:pt idx="18">
                  <c:v>-7.0000000000000001E-3</c:v>
                </c:pt>
                <c:pt idx="19">
                  <c:v>-7.0000000000000001E-3</c:v>
                </c:pt>
                <c:pt idx="20">
                  <c:v>-7.0000000000000001E-3</c:v>
                </c:pt>
                <c:pt idx="21">
                  <c:v>-7.0000000000000001E-3</c:v>
                </c:pt>
                <c:pt idx="22">
                  <c:v>-7.0000000000000001E-3</c:v>
                </c:pt>
                <c:pt idx="23">
                  <c:v>-8.0000000000000002E-3</c:v>
                </c:pt>
                <c:pt idx="24">
                  <c:v>-8.0000000000000002E-3</c:v>
                </c:pt>
                <c:pt idx="25">
                  <c:v>-8.0000000000000002E-3</c:v>
                </c:pt>
                <c:pt idx="26">
                  <c:v>-8.0000000000000002E-3</c:v>
                </c:pt>
                <c:pt idx="27">
                  <c:v>-8.0000000000000002E-3</c:v>
                </c:pt>
                <c:pt idx="28">
                  <c:v>-8.0000000000000002E-3</c:v>
                </c:pt>
                <c:pt idx="29">
                  <c:v>-8.0000000000000002E-3</c:v>
                </c:pt>
                <c:pt idx="30">
                  <c:v>-8.9999999999999993E-3</c:v>
                </c:pt>
                <c:pt idx="31">
                  <c:v>-8.9999999999999993E-3</c:v>
                </c:pt>
                <c:pt idx="32">
                  <c:v>-8.9999999999999993E-3</c:v>
                </c:pt>
                <c:pt idx="33">
                  <c:v>-8.9999999999999993E-3</c:v>
                </c:pt>
                <c:pt idx="34">
                  <c:v>-8.9999999999999993E-3</c:v>
                </c:pt>
                <c:pt idx="35">
                  <c:v>-8.9999999999999993E-3</c:v>
                </c:pt>
                <c:pt idx="36">
                  <c:v>-8.9999999999999993E-3</c:v>
                </c:pt>
                <c:pt idx="37">
                  <c:v>-8.9999999999999993E-3</c:v>
                </c:pt>
                <c:pt idx="38">
                  <c:v>-8.9999999999999993E-3</c:v>
                </c:pt>
                <c:pt idx="39">
                  <c:v>-8.9999999999999993E-3</c:v>
                </c:pt>
                <c:pt idx="40">
                  <c:v>-8.0000000000000002E-3</c:v>
                </c:pt>
                <c:pt idx="41">
                  <c:v>-8.0000000000000002E-3</c:v>
                </c:pt>
                <c:pt idx="42">
                  <c:v>-7.0000000000000001E-3</c:v>
                </c:pt>
                <c:pt idx="43">
                  <c:v>-7.0000000000000001E-3</c:v>
                </c:pt>
                <c:pt idx="44">
                  <c:v>-7.0000000000000001E-3</c:v>
                </c:pt>
                <c:pt idx="45">
                  <c:v>-7.0000000000000001E-3</c:v>
                </c:pt>
                <c:pt idx="46">
                  <c:v>-7.0000000000000001E-3</c:v>
                </c:pt>
                <c:pt idx="47">
                  <c:v>-7.0000000000000001E-3</c:v>
                </c:pt>
                <c:pt idx="48">
                  <c:v>-7.0000000000000001E-3</c:v>
                </c:pt>
                <c:pt idx="49">
                  <c:v>-7.0000000000000001E-3</c:v>
                </c:pt>
                <c:pt idx="50">
                  <c:v>-7.0000000000000001E-3</c:v>
                </c:pt>
                <c:pt idx="51">
                  <c:v>-7.0000000000000001E-3</c:v>
                </c:pt>
                <c:pt idx="52">
                  <c:v>-7.0000000000000001E-3</c:v>
                </c:pt>
                <c:pt idx="53">
                  <c:v>-8.0000000000000002E-3</c:v>
                </c:pt>
                <c:pt idx="54">
                  <c:v>-8.0000000000000002E-3</c:v>
                </c:pt>
                <c:pt idx="55">
                  <c:v>-8.9999999999999993E-3</c:v>
                </c:pt>
                <c:pt idx="56">
                  <c:v>-8.9999999999999993E-3</c:v>
                </c:pt>
                <c:pt idx="57">
                  <c:v>-0.01</c:v>
                </c:pt>
                <c:pt idx="58">
                  <c:v>-1.2E-2</c:v>
                </c:pt>
                <c:pt idx="59">
                  <c:v>-1.2999999999999999E-2</c:v>
                </c:pt>
                <c:pt idx="60">
                  <c:v>-1.4E-2</c:v>
                </c:pt>
                <c:pt idx="61">
                  <c:v>-1.4999999999999999E-2</c:v>
                </c:pt>
                <c:pt idx="62">
                  <c:v>-1.6E-2</c:v>
                </c:pt>
                <c:pt idx="63">
                  <c:v>-1.6E-2</c:v>
                </c:pt>
                <c:pt idx="64">
                  <c:v>-1.6E-2</c:v>
                </c:pt>
                <c:pt idx="65">
                  <c:v>-1.6E-2</c:v>
                </c:pt>
                <c:pt idx="66">
                  <c:v>-1.6E-2</c:v>
                </c:pt>
                <c:pt idx="67">
                  <c:v>-1.6E-2</c:v>
                </c:pt>
                <c:pt idx="68">
                  <c:v>-1.6E-2</c:v>
                </c:pt>
                <c:pt idx="69">
                  <c:v>-1.6E-2</c:v>
                </c:pt>
                <c:pt idx="70">
                  <c:v>-1.6E-2</c:v>
                </c:pt>
                <c:pt idx="71">
                  <c:v>-1.7000000000000001E-2</c:v>
                </c:pt>
                <c:pt idx="72">
                  <c:v>-1.7000000000000001E-2</c:v>
                </c:pt>
                <c:pt idx="73">
                  <c:v>-1.7000000000000001E-2</c:v>
                </c:pt>
                <c:pt idx="74">
                  <c:v>-1.7000000000000001E-2</c:v>
                </c:pt>
                <c:pt idx="75">
                  <c:v>-1.7000000000000001E-2</c:v>
                </c:pt>
                <c:pt idx="76">
                  <c:v>-1.7000000000000001E-2</c:v>
                </c:pt>
                <c:pt idx="77">
                  <c:v>-1.7000000000000001E-2</c:v>
                </c:pt>
                <c:pt idx="78">
                  <c:v>-1.7999999999999999E-2</c:v>
                </c:pt>
                <c:pt idx="79">
                  <c:v>-1.7999999999999999E-2</c:v>
                </c:pt>
                <c:pt idx="80">
                  <c:v>-1.7999999999999999E-2</c:v>
                </c:pt>
                <c:pt idx="81">
                  <c:v>-1.7999999999999999E-2</c:v>
                </c:pt>
                <c:pt idx="82">
                  <c:v>-1.7999999999999999E-2</c:v>
                </c:pt>
                <c:pt idx="83">
                  <c:v>-1.7999999999999999E-2</c:v>
                </c:pt>
                <c:pt idx="84">
                  <c:v>-1.9E-2</c:v>
                </c:pt>
                <c:pt idx="85">
                  <c:v>-1.9E-2</c:v>
                </c:pt>
                <c:pt idx="86">
                  <c:v>-1.9E-2</c:v>
                </c:pt>
                <c:pt idx="87">
                  <c:v>-1.9E-2</c:v>
                </c:pt>
                <c:pt idx="88">
                  <c:v>-0.02</c:v>
                </c:pt>
                <c:pt idx="89">
                  <c:v>-0.02</c:v>
                </c:pt>
                <c:pt idx="90">
                  <c:v>-0.02</c:v>
                </c:pt>
                <c:pt idx="91">
                  <c:v>-0.02</c:v>
                </c:pt>
                <c:pt idx="92">
                  <c:v>-2.1000000000000001E-2</c:v>
                </c:pt>
                <c:pt idx="93">
                  <c:v>-2.1000000000000001E-2</c:v>
                </c:pt>
                <c:pt idx="94">
                  <c:v>-2.1000000000000001E-2</c:v>
                </c:pt>
                <c:pt idx="95">
                  <c:v>-2.1999999999999999E-2</c:v>
                </c:pt>
                <c:pt idx="96">
                  <c:v>-2.1999999999999999E-2</c:v>
                </c:pt>
                <c:pt idx="97">
                  <c:v>-2.1999999999999999E-2</c:v>
                </c:pt>
                <c:pt idx="98">
                  <c:v>-2.1999999999999999E-2</c:v>
                </c:pt>
                <c:pt idx="99">
                  <c:v>-2.3E-2</c:v>
                </c:pt>
                <c:pt idx="100">
                  <c:v>-2.3E-2</c:v>
                </c:pt>
                <c:pt idx="101">
                  <c:v>-2.3E-2</c:v>
                </c:pt>
                <c:pt idx="102">
                  <c:v>-2.3E-2</c:v>
                </c:pt>
                <c:pt idx="103">
                  <c:v>-2.3E-2</c:v>
                </c:pt>
                <c:pt idx="104">
                  <c:v>-2.3E-2</c:v>
                </c:pt>
                <c:pt idx="105">
                  <c:v>-2.3E-2</c:v>
                </c:pt>
                <c:pt idx="106">
                  <c:v>-2.4E-2</c:v>
                </c:pt>
                <c:pt idx="107">
                  <c:v>-2.4E-2</c:v>
                </c:pt>
                <c:pt idx="108">
                  <c:v>-2.4E-2</c:v>
                </c:pt>
                <c:pt idx="109">
                  <c:v>-2.4E-2</c:v>
                </c:pt>
                <c:pt idx="110">
                  <c:v>-2.4E-2</c:v>
                </c:pt>
                <c:pt idx="111">
                  <c:v>-2.4E-2</c:v>
                </c:pt>
                <c:pt idx="112">
                  <c:v>-2.4E-2</c:v>
                </c:pt>
                <c:pt idx="113">
                  <c:v>-2.4E-2</c:v>
                </c:pt>
                <c:pt idx="114">
                  <c:v>-2.4E-2</c:v>
                </c:pt>
                <c:pt idx="115">
                  <c:v>-2.4E-2</c:v>
                </c:pt>
                <c:pt idx="116">
                  <c:v>-2.4E-2</c:v>
                </c:pt>
                <c:pt idx="117">
                  <c:v>-2.4E-2</c:v>
                </c:pt>
                <c:pt idx="118">
                  <c:v>-2.4E-2</c:v>
                </c:pt>
                <c:pt idx="119">
                  <c:v>-2.5000000000000001E-2</c:v>
                </c:pt>
                <c:pt idx="120">
                  <c:v>-2.5000000000000001E-2</c:v>
                </c:pt>
                <c:pt idx="121">
                  <c:v>-2.5000000000000001E-2</c:v>
                </c:pt>
                <c:pt idx="122">
                  <c:v>-2.5000000000000001E-2</c:v>
                </c:pt>
                <c:pt idx="123">
                  <c:v>-2.5000000000000001E-2</c:v>
                </c:pt>
                <c:pt idx="124">
                  <c:v>-2.5000000000000001E-2</c:v>
                </c:pt>
                <c:pt idx="125">
                  <c:v>-2.5000000000000001E-2</c:v>
                </c:pt>
                <c:pt idx="126">
                  <c:v>-2.5000000000000001E-2</c:v>
                </c:pt>
                <c:pt idx="127">
                  <c:v>-2.5000000000000001E-2</c:v>
                </c:pt>
                <c:pt idx="128">
                  <c:v>-2.5000000000000001E-2</c:v>
                </c:pt>
                <c:pt idx="129">
                  <c:v>-2.5000000000000001E-2</c:v>
                </c:pt>
                <c:pt idx="130">
                  <c:v>-2.5999999999999999E-2</c:v>
                </c:pt>
                <c:pt idx="131">
                  <c:v>-2.5999999999999999E-2</c:v>
                </c:pt>
                <c:pt idx="132">
                  <c:v>-2.5999999999999999E-2</c:v>
                </c:pt>
                <c:pt idx="133">
                  <c:v>-2.5999999999999999E-2</c:v>
                </c:pt>
                <c:pt idx="134">
                  <c:v>-2.5999999999999999E-2</c:v>
                </c:pt>
                <c:pt idx="135">
                  <c:v>-2.5999999999999999E-2</c:v>
                </c:pt>
                <c:pt idx="136">
                  <c:v>-2.5999999999999999E-2</c:v>
                </c:pt>
                <c:pt idx="137">
                  <c:v>-2.5999999999999999E-2</c:v>
                </c:pt>
                <c:pt idx="138">
                  <c:v>-2.5999999999999999E-2</c:v>
                </c:pt>
                <c:pt idx="139">
                  <c:v>-2.5999999999999999E-2</c:v>
                </c:pt>
                <c:pt idx="140">
                  <c:v>-2.5999999999999999E-2</c:v>
                </c:pt>
                <c:pt idx="141">
                  <c:v>-2.5999999999999999E-2</c:v>
                </c:pt>
                <c:pt idx="142">
                  <c:v>-2.5999999999999999E-2</c:v>
                </c:pt>
                <c:pt idx="143">
                  <c:v>-2.7E-2</c:v>
                </c:pt>
                <c:pt idx="144">
                  <c:v>-2.7E-2</c:v>
                </c:pt>
                <c:pt idx="145">
                  <c:v>-2.7E-2</c:v>
                </c:pt>
                <c:pt idx="146">
                  <c:v>-2.7E-2</c:v>
                </c:pt>
                <c:pt idx="147">
                  <c:v>-2.7E-2</c:v>
                </c:pt>
                <c:pt idx="148">
                  <c:v>-2.7E-2</c:v>
                </c:pt>
                <c:pt idx="149">
                  <c:v>-2.7E-2</c:v>
                </c:pt>
                <c:pt idx="150">
                  <c:v>-2.7E-2</c:v>
                </c:pt>
                <c:pt idx="151">
                  <c:v>-2.7E-2</c:v>
                </c:pt>
                <c:pt idx="152">
                  <c:v>-2.7E-2</c:v>
                </c:pt>
                <c:pt idx="153">
                  <c:v>-2.7E-2</c:v>
                </c:pt>
                <c:pt idx="154">
                  <c:v>-2.7E-2</c:v>
                </c:pt>
                <c:pt idx="155">
                  <c:v>-2.7E-2</c:v>
                </c:pt>
                <c:pt idx="156">
                  <c:v>-2.7E-2</c:v>
                </c:pt>
                <c:pt idx="157">
                  <c:v>-2.7E-2</c:v>
                </c:pt>
                <c:pt idx="158">
                  <c:v>-2.7E-2</c:v>
                </c:pt>
                <c:pt idx="159">
                  <c:v>-2.7E-2</c:v>
                </c:pt>
                <c:pt idx="160">
                  <c:v>-2.8000000000000001E-2</c:v>
                </c:pt>
                <c:pt idx="161">
                  <c:v>-2.8000000000000001E-2</c:v>
                </c:pt>
                <c:pt idx="162">
                  <c:v>-2.8000000000000001E-2</c:v>
                </c:pt>
                <c:pt idx="163">
                  <c:v>-2.8000000000000001E-2</c:v>
                </c:pt>
                <c:pt idx="164">
                  <c:v>-2.8000000000000001E-2</c:v>
                </c:pt>
                <c:pt idx="165">
                  <c:v>-2.8000000000000001E-2</c:v>
                </c:pt>
                <c:pt idx="166">
                  <c:v>-2.8000000000000001E-2</c:v>
                </c:pt>
                <c:pt idx="167">
                  <c:v>-2.8000000000000001E-2</c:v>
                </c:pt>
                <c:pt idx="168">
                  <c:v>-2.8000000000000001E-2</c:v>
                </c:pt>
                <c:pt idx="169">
                  <c:v>-2.8000000000000001E-2</c:v>
                </c:pt>
                <c:pt idx="170">
                  <c:v>-2.8000000000000001E-2</c:v>
                </c:pt>
                <c:pt idx="171">
                  <c:v>-2.8000000000000001E-2</c:v>
                </c:pt>
                <c:pt idx="172">
                  <c:v>-2.8000000000000001E-2</c:v>
                </c:pt>
                <c:pt idx="173">
                  <c:v>-2.8000000000000001E-2</c:v>
                </c:pt>
                <c:pt idx="174">
                  <c:v>-2.8000000000000001E-2</c:v>
                </c:pt>
                <c:pt idx="175">
                  <c:v>-2.8000000000000001E-2</c:v>
                </c:pt>
                <c:pt idx="176">
                  <c:v>-2.8000000000000001E-2</c:v>
                </c:pt>
                <c:pt idx="177">
                  <c:v>-2.8000000000000001E-2</c:v>
                </c:pt>
                <c:pt idx="178">
                  <c:v>-2.8000000000000001E-2</c:v>
                </c:pt>
                <c:pt idx="179">
                  <c:v>-2.8000000000000001E-2</c:v>
                </c:pt>
                <c:pt idx="180">
                  <c:v>-2.8000000000000001E-2</c:v>
                </c:pt>
                <c:pt idx="181">
                  <c:v>-2.8000000000000001E-2</c:v>
                </c:pt>
                <c:pt idx="182">
                  <c:v>-2.9000000000000001E-2</c:v>
                </c:pt>
                <c:pt idx="183">
                  <c:v>-2.8000000000000001E-2</c:v>
                </c:pt>
                <c:pt idx="184">
                  <c:v>-2.9000000000000001E-2</c:v>
                </c:pt>
                <c:pt idx="185">
                  <c:v>-2.8000000000000001E-2</c:v>
                </c:pt>
                <c:pt idx="186">
                  <c:v>-2.9000000000000001E-2</c:v>
                </c:pt>
                <c:pt idx="187">
                  <c:v>-2.9000000000000001E-2</c:v>
                </c:pt>
                <c:pt idx="188">
                  <c:v>-2.9000000000000001E-2</c:v>
                </c:pt>
                <c:pt idx="189">
                  <c:v>-2.9000000000000001E-2</c:v>
                </c:pt>
                <c:pt idx="190">
                  <c:v>-2.9000000000000001E-2</c:v>
                </c:pt>
                <c:pt idx="191">
                  <c:v>-2.9000000000000001E-2</c:v>
                </c:pt>
                <c:pt idx="192">
                  <c:v>-2.9000000000000001E-2</c:v>
                </c:pt>
                <c:pt idx="193">
                  <c:v>-2.9000000000000001E-2</c:v>
                </c:pt>
                <c:pt idx="194">
                  <c:v>-2.9000000000000001E-2</c:v>
                </c:pt>
                <c:pt idx="195">
                  <c:v>-2.9000000000000001E-2</c:v>
                </c:pt>
                <c:pt idx="196">
                  <c:v>-2.9000000000000001E-2</c:v>
                </c:pt>
                <c:pt idx="197">
                  <c:v>-2.9000000000000001E-2</c:v>
                </c:pt>
                <c:pt idx="198">
                  <c:v>-2.9000000000000001E-2</c:v>
                </c:pt>
                <c:pt idx="199">
                  <c:v>-2.9000000000000001E-2</c:v>
                </c:pt>
                <c:pt idx="200">
                  <c:v>-2.9000000000000001E-2</c:v>
                </c:pt>
                <c:pt idx="201">
                  <c:v>-0.03</c:v>
                </c:pt>
                <c:pt idx="202">
                  <c:v>-0.03</c:v>
                </c:pt>
                <c:pt idx="203">
                  <c:v>-0.03</c:v>
                </c:pt>
                <c:pt idx="204">
                  <c:v>-0.03</c:v>
                </c:pt>
                <c:pt idx="205">
                  <c:v>-0.03</c:v>
                </c:pt>
                <c:pt idx="206">
                  <c:v>-0.03</c:v>
                </c:pt>
                <c:pt idx="207">
                  <c:v>-0.03</c:v>
                </c:pt>
                <c:pt idx="208">
                  <c:v>-0.03</c:v>
                </c:pt>
                <c:pt idx="209">
                  <c:v>-0.03</c:v>
                </c:pt>
                <c:pt idx="210">
                  <c:v>-0.03</c:v>
                </c:pt>
                <c:pt idx="211">
                  <c:v>-3.1E-2</c:v>
                </c:pt>
                <c:pt idx="212">
                  <c:v>-3.1E-2</c:v>
                </c:pt>
                <c:pt idx="213">
                  <c:v>-3.1E-2</c:v>
                </c:pt>
                <c:pt idx="214">
                  <c:v>-3.2000000000000001E-2</c:v>
                </c:pt>
                <c:pt idx="215">
                  <c:v>-3.2000000000000001E-2</c:v>
                </c:pt>
                <c:pt idx="216">
                  <c:v>-3.2000000000000001E-2</c:v>
                </c:pt>
                <c:pt idx="217">
                  <c:v>-3.3000000000000002E-2</c:v>
                </c:pt>
                <c:pt idx="218">
                  <c:v>-3.4000000000000002E-2</c:v>
                </c:pt>
                <c:pt idx="219">
                  <c:v>-3.4000000000000002E-2</c:v>
                </c:pt>
                <c:pt idx="220">
                  <c:v>-3.4000000000000002E-2</c:v>
                </c:pt>
                <c:pt idx="221">
                  <c:v>-3.5000000000000003E-2</c:v>
                </c:pt>
                <c:pt idx="222">
                  <c:v>-3.5000000000000003E-2</c:v>
                </c:pt>
                <c:pt idx="223">
                  <c:v>-3.4000000000000002E-2</c:v>
                </c:pt>
                <c:pt idx="224">
                  <c:v>-3.4000000000000002E-2</c:v>
                </c:pt>
                <c:pt idx="225">
                  <c:v>-3.4000000000000002E-2</c:v>
                </c:pt>
                <c:pt idx="226">
                  <c:v>-3.4000000000000002E-2</c:v>
                </c:pt>
                <c:pt idx="227">
                  <c:v>-3.4000000000000002E-2</c:v>
                </c:pt>
                <c:pt idx="228">
                  <c:v>-3.4000000000000002E-2</c:v>
                </c:pt>
                <c:pt idx="229">
                  <c:v>-3.4000000000000002E-2</c:v>
                </c:pt>
                <c:pt idx="230">
                  <c:v>-3.4000000000000002E-2</c:v>
                </c:pt>
                <c:pt idx="231">
                  <c:v>-3.3000000000000002E-2</c:v>
                </c:pt>
                <c:pt idx="232">
                  <c:v>-3.3000000000000002E-2</c:v>
                </c:pt>
                <c:pt idx="233">
                  <c:v>-3.3000000000000002E-2</c:v>
                </c:pt>
                <c:pt idx="234">
                  <c:v>-3.3000000000000002E-2</c:v>
                </c:pt>
                <c:pt idx="235">
                  <c:v>-3.3000000000000002E-2</c:v>
                </c:pt>
                <c:pt idx="236">
                  <c:v>-3.3000000000000002E-2</c:v>
                </c:pt>
                <c:pt idx="237">
                  <c:v>-3.3000000000000002E-2</c:v>
                </c:pt>
                <c:pt idx="238">
                  <c:v>-3.3000000000000002E-2</c:v>
                </c:pt>
                <c:pt idx="239">
                  <c:v>-3.3000000000000002E-2</c:v>
                </c:pt>
                <c:pt idx="240">
                  <c:v>-3.3000000000000002E-2</c:v>
                </c:pt>
                <c:pt idx="241">
                  <c:v>-3.3000000000000002E-2</c:v>
                </c:pt>
                <c:pt idx="242">
                  <c:v>-3.3000000000000002E-2</c:v>
                </c:pt>
                <c:pt idx="243">
                  <c:v>-3.3000000000000002E-2</c:v>
                </c:pt>
                <c:pt idx="244">
                  <c:v>-3.3000000000000002E-2</c:v>
                </c:pt>
                <c:pt idx="245">
                  <c:v>-3.3000000000000002E-2</c:v>
                </c:pt>
                <c:pt idx="246">
                  <c:v>-3.3000000000000002E-2</c:v>
                </c:pt>
                <c:pt idx="247">
                  <c:v>-3.4000000000000002E-2</c:v>
                </c:pt>
                <c:pt idx="248">
                  <c:v>-3.4000000000000002E-2</c:v>
                </c:pt>
                <c:pt idx="249">
                  <c:v>-3.4000000000000002E-2</c:v>
                </c:pt>
                <c:pt idx="250">
                  <c:v>-3.4000000000000002E-2</c:v>
                </c:pt>
                <c:pt idx="251">
                  <c:v>-3.4000000000000002E-2</c:v>
                </c:pt>
                <c:pt idx="252">
                  <c:v>-3.4000000000000002E-2</c:v>
                </c:pt>
                <c:pt idx="253">
                  <c:v>-3.4000000000000002E-2</c:v>
                </c:pt>
                <c:pt idx="254">
                  <c:v>-3.4000000000000002E-2</c:v>
                </c:pt>
                <c:pt idx="255">
                  <c:v>-3.4000000000000002E-2</c:v>
                </c:pt>
                <c:pt idx="256">
                  <c:v>-3.4000000000000002E-2</c:v>
                </c:pt>
                <c:pt idx="257">
                  <c:v>-3.4000000000000002E-2</c:v>
                </c:pt>
                <c:pt idx="258">
                  <c:v>-3.4000000000000002E-2</c:v>
                </c:pt>
                <c:pt idx="259">
                  <c:v>-3.4000000000000002E-2</c:v>
                </c:pt>
                <c:pt idx="260">
                  <c:v>-3.4000000000000002E-2</c:v>
                </c:pt>
                <c:pt idx="261">
                  <c:v>-3.4000000000000002E-2</c:v>
                </c:pt>
                <c:pt idx="262">
                  <c:v>-3.4000000000000002E-2</c:v>
                </c:pt>
                <c:pt idx="263">
                  <c:v>-3.4000000000000002E-2</c:v>
                </c:pt>
                <c:pt idx="264">
                  <c:v>-3.4000000000000002E-2</c:v>
                </c:pt>
                <c:pt idx="265">
                  <c:v>-3.4000000000000002E-2</c:v>
                </c:pt>
                <c:pt idx="266">
                  <c:v>-3.4000000000000002E-2</c:v>
                </c:pt>
                <c:pt idx="267">
                  <c:v>-3.4000000000000002E-2</c:v>
                </c:pt>
                <c:pt idx="268">
                  <c:v>-3.4000000000000002E-2</c:v>
                </c:pt>
                <c:pt idx="269">
                  <c:v>-3.4000000000000002E-2</c:v>
                </c:pt>
                <c:pt idx="270">
                  <c:v>-3.4000000000000002E-2</c:v>
                </c:pt>
                <c:pt idx="271">
                  <c:v>-3.5000000000000003E-2</c:v>
                </c:pt>
                <c:pt idx="272">
                  <c:v>-3.5000000000000003E-2</c:v>
                </c:pt>
                <c:pt idx="273">
                  <c:v>-3.5000000000000003E-2</c:v>
                </c:pt>
                <c:pt idx="274">
                  <c:v>-3.5000000000000003E-2</c:v>
                </c:pt>
                <c:pt idx="275">
                  <c:v>-3.5000000000000003E-2</c:v>
                </c:pt>
                <c:pt idx="276">
                  <c:v>-3.5000000000000003E-2</c:v>
                </c:pt>
                <c:pt idx="277">
                  <c:v>-3.5000000000000003E-2</c:v>
                </c:pt>
                <c:pt idx="278">
                  <c:v>-3.5000000000000003E-2</c:v>
                </c:pt>
                <c:pt idx="279">
                  <c:v>-3.5999999999999997E-2</c:v>
                </c:pt>
                <c:pt idx="280">
                  <c:v>-3.5999999999999997E-2</c:v>
                </c:pt>
                <c:pt idx="281">
                  <c:v>-3.5999999999999997E-2</c:v>
                </c:pt>
                <c:pt idx="282">
                  <c:v>-3.5999999999999997E-2</c:v>
                </c:pt>
                <c:pt idx="283">
                  <c:v>-3.5999999999999997E-2</c:v>
                </c:pt>
                <c:pt idx="284">
                  <c:v>-3.5999999999999997E-2</c:v>
                </c:pt>
                <c:pt idx="285">
                  <c:v>-3.5999999999999997E-2</c:v>
                </c:pt>
                <c:pt idx="286">
                  <c:v>-3.6999999999999998E-2</c:v>
                </c:pt>
                <c:pt idx="287">
                  <c:v>-3.6999999999999998E-2</c:v>
                </c:pt>
                <c:pt idx="288">
                  <c:v>-3.6999999999999998E-2</c:v>
                </c:pt>
                <c:pt idx="289">
                  <c:v>-3.6999999999999998E-2</c:v>
                </c:pt>
                <c:pt idx="290">
                  <c:v>-3.6999999999999998E-2</c:v>
                </c:pt>
                <c:pt idx="291">
                  <c:v>-3.6999999999999998E-2</c:v>
                </c:pt>
                <c:pt idx="292">
                  <c:v>-3.6999999999999998E-2</c:v>
                </c:pt>
                <c:pt idx="293">
                  <c:v>-3.7999999999999999E-2</c:v>
                </c:pt>
                <c:pt idx="294">
                  <c:v>-3.7999999999999999E-2</c:v>
                </c:pt>
                <c:pt idx="295">
                  <c:v>-3.7999999999999999E-2</c:v>
                </c:pt>
                <c:pt idx="296">
                  <c:v>-3.7999999999999999E-2</c:v>
                </c:pt>
                <c:pt idx="297">
                  <c:v>-3.7999999999999999E-2</c:v>
                </c:pt>
                <c:pt idx="298">
                  <c:v>-3.7999999999999999E-2</c:v>
                </c:pt>
                <c:pt idx="299">
                  <c:v>-3.7999999999999999E-2</c:v>
                </c:pt>
                <c:pt idx="300">
                  <c:v>-3.7999999999999999E-2</c:v>
                </c:pt>
                <c:pt idx="301">
                  <c:v>-3.7999999999999999E-2</c:v>
                </c:pt>
                <c:pt idx="302">
                  <c:v>-3.7999999999999999E-2</c:v>
                </c:pt>
                <c:pt idx="303">
                  <c:v>-3.7999999999999999E-2</c:v>
                </c:pt>
                <c:pt idx="304">
                  <c:v>-3.7999999999999999E-2</c:v>
                </c:pt>
                <c:pt idx="305">
                  <c:v>-3.7999999999999999E-2</c:v>
                </c:pt>
                <c:pt idx="306">
                  <c:v>-3.7999999999999999E-2</c:v>
                </c:pt>
                <c:pt idx="307">
                  <c:v>-3.7999999999999999E-2</c:v>
                </c:pt>
                <c:pt idx="308">
                  <c:v>-3.7999999999999999E-2</c:v>
                </c:pt>
                <c:pt idx="309">
                  <c:v>-3.7999999999999999E-2</c:v>
                </c:pt>
                <c:pt idx="310">
                  <c:v>-3.7999999999999999E-2</c:v>
                </c:pt>
                <c:pt idx="311">
                  <c:v>-3.7999999999999999E-2</c:v>
                </c:pt>
                <c:pt idx="312">
                  <c:v>-3.7999999999999999E-2</c:v>
                </c:pt>
                <c:pt idx="313">
                  <c:v>-3.7999999999999999E-2</c:v>
                </c:pt>
                <c:pt idx="314">
                  <c:v>-3.7999999999999999E-2</c:v>
                </c:pt>
                <c:pt idx="315">
                  <c:v>-3.7999999999999999E-2</c:v>
                </c:pt>
                <c:pt idx="316">
                  <c:v>-3.7999999999999999E-2</c:v>
                </c:pt>
                <c:pt idx="317">
                  <c:v>-3.7999999999999999E-2</c:v>
                </c:pt>
                <c:pt idx="318">
                  <c:v>-3.7999999999999999E-2</c:v>
                </c:pt>
                <c:pt idx="319">
                  <c:v>-3.7999999999999999E-2</c:v>
                </c:pt>
                <c:pt idx="320">
                  <c:v>-3.7999999999999999E-2</c:v>
                </c:pt>
                <c:pt idx="321">
                  <c:v>-3.9E-2</c:v>
                </c:pt>
                <c:pt idx="322">
                  <c:v>-3.9E-2</c:v>
                </c:pt>
                <c:pt idx="323">
                  <c:v>-3.9E-2</c:v>
                </c:pt>
                <c:pt idx="324">
                  <c:v>-0.04</c:v>
                </c:pt>
                <c:pt idx="325">
                  <c:v>-0.04</c:v>
                </c:pt>
                <c:pt idx="326">
                  <c:v>-0.04</c:v>
                </c:pt>
                <c:pt idx="327">
                  <c:v>-0.04</c:v>
                </c:pt>
                <c:pt idx="328">
                  <c:v>-0.04</c:v>
                </c:pt>
                <c:pt idx="329">
                  <c:v>-0.04</c:v>
                </c:pt>
                <c:pt idx="330">
                  <c:v>-0.04</c:v>
                </c:pt>
                <c:pt idx="331">
                  <c:v>-0.04</c:v>
                </c:pt>
                <c:pt idx="332">
                  <c:v>-0.04</c:v>
                </c:pt>
                <c:pt idx="333">
                  <c:v>-0.04</c:v>
                </c:pt>
                <c:pt idx="334">
                  <c:v>-0.04</c:v>
                </c:pt>
                <c:pt idx="335">
                  <c:v>-0.04</c:v>
                </c:pt>
                <c:pt idx="336">
                  <c:v>-4.1000000000000002E-2</c:v>
                </c:pt>
                <c:pt idx="337">
                  <c:v>-4.1000000000000002E-2</c:v>
                </c:pt>
                <c:pt idx="338">
                  <c:v>-4.1000000000000002E-2</c:v>
                </c:pt>
                <c:pt idx="339">
                  <c:v>-4.1000000000000002E-2</c:v>
                </c:pt>
                <c:pt idx="340">
                  <c:v>-4.1000000000000002E-2</c:v>
                </c:pt>
                <c:pt idx="341">
                  <c:v>-4.1000000000000002E-2</c:v>
                </c:pt>
                <c:pt idx="342">
                  <c:v>-4.1000000000000002E-2</c:v>
                </c:pt>
                <c:pt idx="343">
                  <c:v>-4.1000000000000002E-2</c:v>
                </c:pt>
                <c:pt idx="344">
                  <c:v>-4.1000000000000002E-2</c:v>
                </c:pt>
                <c:pt idx="345">
                  <c:v>-4.1000000000000002E-2</c:v>
                </c:pt>
                <c:pt idx="346">
                  <c:v>-4.1000000000000002E-2</c:v>
                </c:pt>
                <c:pt idx="347">
                  <c:v>-4.1000000000000002E-2</c:v>
                </c:pt>
                <c:pt idx="348">
                  <c:v>-4.1000000000000002E-2</c:v>
                </c:pt>
                <c:pt idx="349">
                  <c:v>-4.1000000000000002E-2</c:v>
                </c:pt>
                <c:pt idx="350">
                  <c:v>-4.2000000000000003E-2</c:v>
                </c:pt>
                <c:pt idx="351">
                  <c:v>-4.2000000000000003E-2</c:v>
                </c:pt>
                <c:pt idx="352">
                  <c:v>-4.2000000000000003E-2</c:v>
                </c:pt>
                <c:pt idx="353">
                  <c:v>-4.2000000000000003E-2</c:v>
                </c:pt>
                <c:pt idx="354">
                  <c:v>-4.2000000000000003E-2</c:v>
                </c:pt>
                <c:pt idx="355">
                  <c:v>-4.2000000000000003E-2</c:v>
                </c:pt>
                <c:pt idx="356">
                  <c:v>-4.2000000000000003E-2</c:v>
                </c:pt>
                <c:pt idx="357">
                  <c:v>-4.2000000000000003E-2</c:v>
                </c:pt>
                <c:pt idx="358">
                  <c:v>-4.2000000000000003E-2</c:v>
                </c:pt>
                <c:pt idx="359">
                  <c:v>-4.2000000000000003E-2</c:v>
                </c:pt>
                <c:pt idx="360">
                  <c:v>-4.2000000000000003E-2</c:v>
                </c:pt>
                <c:pt idx="361">
                  <c:v>-4.2000000000000003E-2</c:v>
                </c:pt>
                <c:pt idx="362">
                  <c:v>-4.2000000000000003E-2</c:v>
                </c:pt>
                <c:pt idx="363">
                  <c:v>-4.2999999999999997E-2</c:v>
                </c:pt>
                <c:pt idx="364">
                  <c:v>-4.2999999999999997E-2</c:v>
                </c:pt>
                <c:pt idx="365">
                  <c:v>-4.2999999999999997E-2</c:v>
                </c:pt>
                <c:pt idx="366">
                  <c:v>-4.2999999999999997E-2</c:v>
                </c:pt>
                <c:pt idx="367">
                  <c:v>-4.2999999999999997E-2</c:v>
                </c:pt>
                <c:pt idx="368">
                  <c:v>-4.2999999999999997E-2</c:v>
                </c:pt>
                <c:pt idx="369">
                  <c:v>-4.2999999999999997E-2</c:v>
                </c:pt>
                <c:pt idx="370">
                  <c:v>-4.2999999999999997E-2</c:v>
                </c:pt>
                <c:pt idx="371">
                  <c:v>-4.2999999999999997E-2</c:v>
                </c:pt>
                <c:pt idx="372">
                  <c:v>-4.2999999999999997E-2</c:v>
                </c:pt>
                <c:pt idx="373">
                  <c:v>-4.2999999999999997E-2</c:v>
                </c:pt>
                <c:pt idx="374">
                  <c:v>-4.2999999999999997E-2</c:v>
                </c:pt>
                <c:pt idx="375">
                  <c:v>-4.2999999999999997E-2</c:v>
                </c:pt>
                <c:pt idx="376">
                  <c:v>-4.2999999999999997E-2</c:v>
                </c:pt>
                <c:pt idx="377">
                  <c:v>-4.2999999999999997E-2</c:v>
                </c:pt>
                <c:pt idx="378">
                  <c:v>-4.2999999999999997E-2</c:v>
                </c:pt>
                <c:pt idx="379">
                  <c:v>-4.2999999999999997E-2</c:v>
                </c:pt>
                <c:pt idx="380">
                  <c:v>-4.2999999999999997E-2</c:v>
                </c:pt>
                <c:pt idx="381">
                  <c:v>-4.2999999999999997E-2</c:v>
                </c:pt>
                <c:pt idx="382">
                  <c:v>-4.2999999999999997E-2</c:v>
                </c:pt>
                <c:pt idx="383">
                  <c:v>-4.2999999999999997E-2</c:v>
                </c:pt>
                <c:pt idx="384">
                  <c:v>-4.2999999999999997E-2</c:v>
                </c:pt>
                <c:pt idx="385">
                  <c:v>-4.2999999999999997E-2</c:v>
                </c:pt>
                <c:pt idx="386">
                  <c:v>-4.2999999999999997E-2</c:v>
                </c:pt>
                <c:pt idx="387">
                  <c:v>-4.2999999999999997E-2</c:v>
                </c:pt>
                <c:pt idx="388">
                  <c:v>-4.2999999999999997E-2</c:v>
                </c:pt>
                <c:pt idx="389">
                  <c:v>-4.2999999999999997E-2</c:v>
                </c:pt>
                <c:pt idx="390">
                  <c:v>-4.2999999999999997E-2</c:v>
                </c:pt>
                <c:pt idx="391">
                  <c:v>-4.2999999999999997E-2</c:v>
                </c:pt>
                <c:pt idx="392">
                  <c:v>-4.2999999999999997E-2</c:v>
                </c:pt>
                <c:pt idx="393">
                  <c:v>-4.2999999999999997E-2</c:v>
                </c:pt>
                <c:pt idx="394">
                  <c:v>-4.2999999999999997E-2</c:v>
                </c:pt>
                <c:pt idx="395">
                  <c:v>-4.2999999999999997E-2</c:v>
                </c:pt>
                <c:pt idx="396">
                  <c:v>-4.2000000000000003E-2</c:v>
                </c:pt>
                <c:pt idx="397">
                  <c:v>-4.2000000000000003E-2</c:v>
                </c:pt>
                <c:pt idx="398">
                  <c:v>-4.2000000000000003E-2</c:v>
                </c:pt>
                <c:pt idx="399">
                  <c:v>-4.1000000000000002E-2</c:v>
                </c:pt>
                <c:pt idx="400">
                  <c:v>-4.1000000000000002E-2</c:v>
                </c:pt>
                <c:pt idx="401">
                  <c:v>-0.04</c:v>
                </c:pt>
                <c:pt idx="402">
                  <c:v>-0.04</c:v>
                </c:pt>
                <c:pt idx="403">
                  <c:v>-3.9E-2</c:v>
                </c:pt>
                <c:pt idx="404">
                  <c:v>-3.9E-2</c:v>
                </c:pt>
                <c:pt idx="405">
                  <c:v>-3.7999999999999999E-2</c:v>
                </c:pt>
                <c:pt idx="406">
                  <c:v>-3.6999999999999998E-2</c:v>
                </c:pt>
                <c:pt idx="407">
                  <c:v>-3.5999999999999997E-2</c:v>
                </c:pt>
                <c:pt idx="408">
                  <c:v>-3.5999999999999997E-2</c:v>
                </c:pt>
                <c:pt idx="409">
                  <c:v>-3.5000000000000003E-2</c:v>
                </c:pt>
                <c:pt idx="410">
                  <c:v>-3.4000000000000002E-2</c:v>
                </c:pt>
                <c:pt idx="411">
                  <c:v>-3.3000000000000002E-2</c:v>
                </c:pt>
                <c:pt idx="412">
                  <c:v>-3.2000000000000001E-2</c:v>
                </c:pt>
                <c:pt idx="413">
                  <c:v>-0.03</c:v>
                </c:pt>
                <c:pt idx="414">
                  <c:v>-2.9000000000000001E-2</c:v>
                </c:pt>
                <c:pt idx="415">
                  <c:v>-2.8000000000000001E-2</c:v>
                </c:pt>
                <c:pt idx="416">
                  <c:v>-2.7E-2</c:v>
                </c:pt>
                <c:pt idx="417">
                  <c:v>-2.5000000000000001E-2</c:v>
                </c:pt>
                <c:pt idx="418">
                  <c:v>-2.4E-2</c:v>
                </c:pt>
                <c:pt idx="419">
                  <c:v>-2.1999999999999999E-2</c:v>
                </c:pt>
                <c:pt idx="420">
                  <c:v>-2.1000000000000001E-2</c:v>
                </c:pt>
                <c:pt idx="421">
                  <c:v>-1.6E-2</c:v>
                </c:pt>
                <c:pt idx="422">
                  <c:v>0</c:v>
                </c:pt>
                <c:pt idx="423">
                  <c:v>2E-3</c:v>
                </c:pt>
                <c:pt idx="424">
                  <c:v>3.0000000000000001E-3</c:v>
                </c:pt>
                <c:pt idx="425">
                  <c:v>5.0000000000000001E-3</c:v>
                </c:pt>
                <c:pt idx="426">
                  <c:v>7.0000000000000001E-3</c:v>
                </c:pt>
                <c:pt idx="427">
                  <c:v>8.9999999999999993E-3</c:v>
                </c:pt>
                <c:pt idx="428">
                  <c:v>0.01</c:v>
                </c:pt>
                <c:pt idx="429">
                  <c:v>1.0999999999999999E-2</c:v>
                </c:pt>
                <c:pt idx="430">
                  <c:v>1.2999999999999999E-2</c:v>
                </c:pt>
                <c:pt idx="431">
                  <c:v>1.6E-2</c:v>
                </c:pt>
                <c:pt idx="432">
                  <c:v>1.7000000000000001E-2</c:v>
                </c:pt>
                <c:pt idx="433">
                  <c:v>1.9E-2</c:v>
                </c:pt>
                <c:pt idx="434">
                  <c:v>0.02</c:v>
                </c:pt>
                <c:pt idx="435">
                  <c:v>2.1999999999999999E-2</c:v>
                </c:pt>
                <c:pt idx="436">
                  <c:v>2.4E-2</c:v>
                </c:pt>
                <c:pt idx="437">
                  <c:v>2.5999999999999999E-2</c:v>
                </c:pt>
                <c:pt idx="438">
                  <c:v>2.7E-2</c:v>
                </c:pt>
                <c:pt idx="439">
                  <c:v>2.9000000000000001E-2</c:v>
                </c:pt>
                <c:pt idx="440">
                  <c:v>0.03</c:v>
                </c:pt>
                <c:pt idx="441">
                  <c:v>3.2000000000000001E-2</c:v>
                </c:pt>
                <c:pt idx="442">
                  <c:v>3.4000000000000002E-2</c:v>
                </c:pt>
                <c:pt idx="443">
                  <c:v>3.5000000000000003E-2</c:v>
                </c:pt>
                <c:pt idx="444">
                  <c:v>3.6999999999999998E-2</c:v>
                </c:pt>
                <c:pt idx="445">
                  <c:v>3.9E-2</c:v>
                </c:pt>
                <c:pt idx="446">
                  <c:v>0.04</c:v>
                </c:pt>
                <c:pt idx="447">
                  <c:v>4.2000000000000003E-2</c:v>
                </c:pt>
                <c:pt idx="448">
                  <c:v>4.3999999999999997E-2</c:v>
                </c:pt>
                <c:pt idx="449">
                  <c:v>4.4999999999999998E-2</c:v>
                </c:pt>
                <c:pt idx="450">
                  <c:v>4.7E-2</c:v>
                </c:pt>
                <c:pt idx="451">
                  <c:v>4.8000000000000001E-2</c:v>
                </c:pt>
                <c:pt idx="452">
                  <c:v>0.05</c:v>
                </c:pt>
                <c:pt idx="453">
                  <c:v>5.1999999999999998E-2</c:v>
                </c:pt>
                <c:pt idx="454">
                  <c:v>5.2999999999999999E-2</c:v>
                </c:pt>
                <c:pt idx="455">
                  <c:v>5.5E-2</c:v>
                </c:pt>
                <c:pt idx="456">
                  <c:v>5.7000000000000002E-2</c:v>
                </c:pt>
                <c:pt idx="457">
                  <c:v>5.8000000000000003E-2</c:v>
                </c:pt>
                <c:pt idx="458">
                  <c:v>0.06</c:v>
                </c:pt>
                <c:pt idx="459">
                  <c:v>6.0999999999999999E-2</c:v>
                </c:pt>
                <c:pt idx="460">
                  <c:v>6.3E-2</c:v>
                </c:pt>
                <c:pt idx="461">
                  <c:v>5.2999999999999999E-2</c:v>
                </c:pt>
                <c:pt idx="462">
                  <c:v>4.9000000000000002E-2</c:v>
                </c:pt>
                <c:pt idx="463">
                  <c:v>5.0999999999999997E-2</c:v>
                </c:pt>
                <c:pt idx="464">
                  <c:v>5.1999999999999998E-2</c:v>
                </c:pt>
                <c:pt idx="465">
                  <c:v>5.3999999999999999E-2</c:v>
                </c:pt>
                <c:pt idx="466">
                  <c:v>5.5E-2</c:v>
                </c:pt>
                <c:pt idx="467">
                  <c:v>5.6000000000000001E-2</c:v>
                </c:pt>
                <c:pt idx="468">
                  <c:v>5.7000000000000002E-2</c:v>
                </c:pt>
                <c:pt idx="469">
                  <c:v>5.8999999999999997E-2</c:v>
                </c:pt>
                <c:pt idx="470">
                  <c:v>0.06</c:v>
                </c:pt>
                <c:pt idx="471">
                  <c:v>0.06</c:v>
                </c:pt>
                <c:pt idx="472">
                  <c:v>6.0999999999999999E-2</c:v>
                </c:pt>
                <c:pt idx="473">
                  <c:v>6.2E-2</c:v>
                </c:pt>
                <c:pt idx="474">
                  <c:v>6.3E-2</c:v>
                </c:pt>
                <c:pt idx="475">
                  <c:v>6.3E-2</c:v>
                </c:pt>
                <c:pt idx="476">
                  <c:v>6.3E-2</c:v>
                </c:pt>
                <c:pt idx="477">
                  <c:v>6.4000000000000001E-2</c:v>
                </c:pt>
                <c:pt idx="478">
                  <c:v>6.4000000000000001E-2</c:v>
                </c:pt>
                <c:pt idx="479">
                  <c:v>6.4000000000000001E-2</c:v>
                </c:pt>
                <c:pt idx="480">
                  <c:v>6.4000000000000001E-2</c:v>
                </c:pt>
                <c:pt idx="481">
                  <c:v>6.4000000000000001E-2</c:v>
                </c:pt>
                <c:pt idx="482">
                  <c:v>6.3E-2</c:v>
                </c:pt>
                <c:pt idx="483">
                  <c:v>6.3E-2</c:v>
                </c:pt>
                <c:pt idx="484">
                  <c:v>6.2E-2</c:v>
                </c:pt>
                <c:pt idx="485">
                  <c:v>6.2E-2</c:v>
                </c:pt>
                <c:pt idx="486">
                  <c:v>6.0999999999999999E-2</c:v>
                </c:pt>
                <c:pt idx="487">
                  <c:v>0.06</c:v>
                </c:pt>
                <c:pt idx="488">
                  <c:v>0.06</c:v>
                </c:pt>
                <c:pt idx="489">
                  <c:v>5.8999999999999997E-2</c:v>
                </c:pt>
                <c:pt idx="490">
                  <c:v>5.8000000000000003E-2</c:v>
                </c:pt>
                <c:pt idx="491">
                  <c:v>5.7000000000000002E-2</c:v>
                </c:pt>
                <c:pt idx="492">
                  <c:v>5.7000000000000002E-2</c:v>
                </c:pt>
                <c:pt idx="493">
                  <c:v>5.6000000000000001E-2</c:v>
                </c:pt>
                <c:pt idx="494">
                  <c:v>5.5E-2</c:v>
                </c:pt>
                <c:pt idx="495">
                  <c:v>5.3999999999999999E-2</c:v>
                </c:pt>
                <c:pt idx="496">
                  <c:v>5.2999999999999999E-2</c:v>
                </c:pt>
                <c:pt idx="497">
                  <c:v>5.2999999999999999E-2</c:v>
                </c:pt>
                <c:pt idx="498">
                  <c:v>5.1999999999999998E-2</c:v>
                </c:pt>
                <c:pt idx="499">
                  <c:v>5.0999999999999997E-2</c:v>
                </c:pt>
                <c:pt idx="500">
                  <c:v>5.0999999999999997E-2</c:v>
                </c:pt>
                <c:pt idx="501">
                  <c:v>0.05</c:v>
                </c:pt>
                <c:pt idx="502">
                  <c:v>0.05</c:v>
                </c:pt>
                <c:pt idx="503">
                  <c:v>4.9000000000000002E-2</c:v>
                </c:pt>
                <c:pt idx="504">
                  <c:v>4.9000000000000002E-2</c:v>
                </c:pt>
                <c:pt idx="505">
                  <c:v>4.9000000000000002E-2</c:v>
                </c:pt>
                <c:pt idx="506">
                  <c:v>4.8000000000000001E-2</c:v>
                </c:pt>
                <c:pt idx="507">
                  <c:v>4.8000000000000001E-2</c:v>
                </c:pt>
                <c:pt idx="508">
                  <c:v>4.8000000000000001E-2</c:v>
                </c:pt>
                <c:pt idx="509">
                  <c:v>4.8000000000000001E-2</c:v>
                </c:pt>
                <c:pt idx="510">
                  <c:v>4.8000000000000001E-2</c:v>
                </c:pt>
                <c:pt idx="511">
                  <c:v>4.7E-2</c:v>
                </c:pt>
                <c:pt idx="512">
                  <c:v>4.7E-2</c:v>
                </c:pt>
                <c:pt idx="513">
                  <c:v>4.7E-2</c:v>
                </c:pt>
                <c:pt idx="514">
                  <c:v>4.7E-2</c:v>
                </c:pt>
                <c:pt idx="515">
                  <c:v>4.5999999999999999E-2</c:v>
                </c:pt>
                <c:pt idx="516">
                  <c:v>4.5999999999999999E-2</c:v>
                </c:pt>
                <c:pt idx="517">
                  <c:v>4.5999999999999999E-2</c:v>
                </c:pt>
                <c:pt idx="518">
                  <c:v>4.5999999999999999E-2</c:v>
                </c:pt>
                <c:pt idx="519">
                  <c:v>4.5999999999999999E-2</c:v>
                </c:pt>
                <c:pt idx="520">
                  <c:v>4.5999999999999999E-2</c:v>
                </c:pt>
                <c:pt idx="521">
                  <c:v>4.7E-2</c:v>
                </c:pt>
                <c:pt idx="522">
                  <c:v>4.8000000000000001E-2</c:v>
                </c:pt>
                <c:pt idx="523">
                  <c:v>4.9000000000000002E-2</c:v>
                </c:pt>
                <c:pt idx="524">
                  <c:v>0.05</c:v>
                </c:pt>
                <c:pt idx="525">
                  <c:v>5.1999999999999998E-2</c:v>
                </c:pt>
                <c:pt idx="526">
                  <c:v>5.3999999999999999E-2</c:v>
                </c:pt>
                <c:pt idx="527">
                  <c:v>5.6000000000000001E-2</c:v>
                </c:pt>
                <c:pt idx="528">
                  <c:v>5.8999999999999997E-2</c:v>
                </c:pt>
                <c:pt idx="529">
                  <c:v>6.0999999999999999E-2</c:v>
                </c:pt>
                <c:pt idx="530">
                  <c:v>6.3E-2</c:v>
                </c:pt>
                <c:pt idx="531">
                  <c:v>6.5000000000000002E-2</c:v>
                </c:pt>
                <c:pt idx="532">
                  <c:v>6.6000000000000003E-2</c:v>
                </c:pt>
                <c:pt idx="533">
                  <c:v>6.7000000000000004E-2</c:v>
                </c:pt>
                <c:pt idx="534">
                  <c:v>6.8000000000000005E-2</c:v>
                </c:pt>
                <c:pt idx="535">
                  <c:v>6.8000000000000005E-2</c:v>
                </c:pt>
                <c:pt idx="536">
                  <c:v>6.8000000000000005E-2</c:v>
                </c:pt>
                <c:pt idx="537">
                  <c:v>6.8000000000000005E-2</c:v>
                </c:pt>
                <c:pt idx="538">
                  <c:v>6.7000000000000004E-2</c:v>
                </c:pt>
                <c:pt idx="539">
                  <c:v>6.8000000000000005E-2</c:v>
                </c:pt>
                <c:pt idx="540">
                  <c:v>6.8000000000000005E-2</c:v>
                </c:pt>
                <c:pt idx="541">
                  <c:v>6.8000000000000005E-2</c:v>
                </c:pt>
                <c:pt idx="542">
                  <c:v>6.9000000000000006E-2</c:v>
                </c:pt>
                <c:pt idx="543">
                  <c:v>7.0000000000000007E-2</c:v>
                </c:pt>
                <c:pt idx="544">
                  <c:v>7.0999999999999994E-2</c:v>
                </c:pt>
                <c:pt idx="545">
                  <c:v>7.2999999999999995E-2</c:v>
                </c:pt>
                <c:pt idx="546">
                  <c:v>7.3999999999999996E-2</c:v>
                </c:pt>
                <c:pt idx="547">
                  <c:v>7.5999999999999998E-2</c:v>
                </c:pt>
                <c:pt idx="548">
                  <c:v>7.6999999999999999E-2</c:v>
                </c:pt>
                <c:pt idx="549">
                  <c:v>7.8E-2</c:v>
                </c:pt>
                <c:pt idx="550">
                  <c:v>0.08</c:v>
                </c:pt>
                <c:pt idx="551">
                  <c:v>8.1000000000000003E-2</c:v>
                </c:pt>
                <c:pt idx="552">
                  <c:v>8.2000000000000003E-2</c:v>
                </c:pt>
                <c:pt idx="553">
                  <c:v>8.3000000000000004E-2</c:v>
                </c:pt>
                <c:pt idx="554">
                  <c:v>8.4000000000000005E-2</c:v>
                </c:pt>
                <c:pt idx="555">
                  <c:v>8.5999999999999993E-2</c:v>
                </c:pt>
                <c:pt idx="556">
                  <c:v>8.6999999999999994E-2</c:v>
                </c:pt>
                <c:pt idx="557">
                  <c:v>8.7999999999999995E-2</c:v>
                </c:pt>
                <c:pt idx="558">
                  <c:v>0.09</c:v>
                </c:pt>
                <c:pt idx="559">
                  <c:v>9.1999999999999998E-2</c:v>
                </c:pt>
                <c:pt idx="560">
                  <c:v>9.4E-2</c:v>
                </c:pt>
                <c:pt idx="561">
                  <c:v>9.6000000000000002E-2</c:v>
                </c:pt>
                <c:pt idx="562">
                  <c:v>9.9000000000000005E-2</c:v>
                </c:pt>
                <c:pt idx="563">
                  <c:v>0.10299999999999999</c:v>
                </c:pt>
                <c:pt idx="564">
                  <c:v>0.107</c:v>
                </c:pt>
                <c:pt idx="565">
                  <c:v>0.112</c:v>
                </c:pt>
                <c:pt idx="566">
                  <c:v>0.11799999999999999</c:v>
                </c:pt>
                <c:pt idx="567">
                  <c:v>0.125</c:v>
                </c:pt>
                <c:pt idx="568">
                  <c:v>0.13300000000000001</c:v>
                </c:pt>
                <c:pt idx="569">
                  <c:v>0.14199999999999999</c:v>
                </c:pt>
                <c:pt idx="570">
                  <c:v>0.152</c:v>
                </c:pt>
                <c:pt idx="571">
                  <c:v>0.16300000000000001</c:v>
                </c:pt>
                <c:pt idx="572">
                  <c:v>0.17499999999999999</c:v>
                </c:pt>
                <c:pt idx="573">
                  <c:v>0.188</c:v>
                </c:pt>
                <c:pt idx="574">
                  <c:v>0.20200000000000001</c:v>
                </c:pt>
                <c:pt idx="575">
                  <c:v>0.218</c:v>
                </c:pt>
                <c:pt idx="576">
                  <c:v>0.23400000000000001</c:v>
                </c:pt>
                <c:pt idx="577">
                  <c:v>0.252</c:v>
                </c:pt>
                <c:pt idx="578">
                  <c:v>0.27100000000000002</c:v>
                </c:pt>
                <c:pt idx="579">
                  <c:v>0.29099999999999998</c:v>
                </c:pt>
                <c:pt idx="580">
                  <c:v>0.311</c:v>
                </c:pt>
                <c:pt idx="581">
                  <c:v>0.33200000000000002</c:v>
                </c:pt>
                <c:pt idx="582">
                  <c:v>0.35399999999999998</c:v>
                </c:pt>
                <c:pt idx="583">
                  <c:v>0.377</c:v>
                </c:pt>
                <c:pt idx="584">
                  <c:v>0.40100000000000002</c:v>
                </c:pt>
                <c:pt idx="585">
                  <c:v>0.42499999999999999</c:v>
                </c:pt>
                <c:pt idx="586">
                  <c:v>0.45100000000000001</c:v>
                </c:pt>
                <c:pt idx="587">
                  <c:v>0.47899999999999998</c:v>
                </c:pt>
                <c:pt idx="588">
                  <c:v>0.50700000000000001</c:v>
                </c:pt>
                <c:pt idx="589">
                  <c:v>0.53500000000000003</c:v>
                </c:pt>
                <c:pt idx="590">
                  <c:v>0.56299999999999994</c:v>
                </c:pt>
                <c:pt idx="591">
                  <c:v>0.59199999999999997</c:v>
                </c:pt>
                <c:pt idx="592">
                  <c:v>0.62</c:v>
                </c:pt>
                <c:pt idx="593">
                  <c:v>0.64800000000000002</c:v>
                </c:pt>
                <c:pt idx="594">
                  <c:v>0.67500000000000004</c:v>
                </c:pt>
                <c:pt idx="595">
                  <c:v>0.70299999999999996</c:v>
                </c:pt>
                <c:pt idx="596">
                  <c:v>0.73</c:v>
                </c:pt>
                <c:pt idx="597">
                  <c:v>0.75700000000000001</c:v>
                </c:pt>
                <c:pt idx="598">
                  <c:v>0.78300000000000003</c:v>
                </c:pt>
                <c:pt idx="599">
                  <c:v>0.80900000000000005</c:v>
                </c:pt>
                <c:pt idx="600">
                  <c:v>0.8349999999999999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E505-40FA-858A-3227CC8E4DA5}"/>
            </c:ext>
          </c:extLst>
        </c:ser>
        <c:ser>
          <c:idx val="4"/>
          <c:order val="4"/>
          <c:tx>
            <c:strRef>
              <c:f>'water-F'!$F$2</c:f>
              <c:strCache>
                <c:ptCount val="1"/>
                <c:pt idx="0">
                  <c:v>Watermelon plant </c:v>
                </c:pt>
              </c:strCache>
            </c:strRef>
          </c:tx>
          <c:marker>
            <c:symbol val="none"/>
          </c:marker>
          <c:xVal>
            <c:numRef>
              <c:f>'water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water-F'!$F$3:$F$603</c:f>
              <c:numCache>
                <c:formatCode>General</c:formatCode>
                <c:ptCount val="601"/>
                <c:pt idx="0">
                  <c:v>1.6E-2</c:v>
                </c:pt>
                <c:pt idx="1">
                  <c:v>1.6E-2</c:v>
                </c:pt>
                <c:pt idx="2">
                  <c:v>1.6E-2</c:v>
                </c:pt>
                <c:pt idx="3">
                  <c:v>1.6E-2</c:v>
                </c:pt>
                <c:pt idx="4">
                  <c:v>1.6E-2</c:v>
                </c:pt>
                <c:pt idx="5">
                  <c:v>1.6E-2</c:v>
                </c:pt>
                <c:pt idx="6">
                  <c:v>1.6E-2</c:v>
                </c:pt>
                <c:pt idx="7">
                  <c:v>1.6E-2</c:v>
                </c:pt>
                <c:pt idx="8">
                  <c:v>1.6E-2</c:v>
                </c:pt>
                <c:pt idx="9">
                  <c:v>1.6E-2</c:v>
                </c:pt>
                <c:pt idx="10">
                  <c:v>1.6E-2</c:v>
                </c:pt>
                <c:pt idx="11">
                  <c:v>1.6E-2</c:v>
                </c:pt>
                <c:pt idx="12">
                  <c:v>1.6E-2</c:v>
                </c:pt>
                <c:pt idx="13">
                  <c:v>1.6E-2</c:v>
                </c:pt>
                <c:pt idx="14">
                  <c:v>1.6E-2</c:v>
                </c:pt>
                <c:pt idx="15">
                  <c:v>1.6E-2</c:v>
                </c:pt>
                <c:pt idx="16">
                  <c:v>1.6E-2</c:v>
                </c:pt>
                <c:pt idx="17">
                  <c:v>1.6E-2</c:v>
                </c:pt>
                <c:pt idx="18">
                  <c:v>1.6E-2</c:v>
                </c:pt>
                <c:pt idx="19">
                  <c:v>1.6E-2</c:v>
                </c:pt>
                <c:pt idx="20">
                  <c:v>1.6E-2</c:v>
                </c:pt>
                <c:pt idx="21">
                  <c:v>1.6E-2</c:v>
                </c:pt>
                <c:pt idx="22">
                  <c:v>1.6E-2</c:v>
                </c:pt>
                <c:pt idx="23">
                  <c:v>1.6E-2</c:v>
                </c:pt>
                <c:pt idx="24">
                  <c:v>1.6E-2</c:v>
                </c:pt>
                <c:pt idx="25">
                  <c:v>1.6E-2</c:v>
                </c:pt>
                <c:pt idx="26">
                  <c:v>1.6E-2</c:v>
                </c:pt>
                <c:pt idx="27">
                  <c:v>1.6E-2</c:v>
                </c:pt>
                <c:pt idx="28">
                  <c:v>1.6E-2</c:v>
                </c:pt>
                <c:pt idx="29">
                  <c:v>1.6E-2</c:v>
                </c:pt>
                <c:pt idx="30">
                  <c:v>1.6E-2</c:v>
                </c:pt>
                <c:pt idx="31">
                  <c:v>1.6E-2</c:v>
                </c:pt>
                <c:pt idx="32">
                  <c:v>1.6E-2</c:v>
                </c:pt>
                <c:pt idx="33">
                  <c:v>1.6E-2</c:v>
                </c:pt>
                <c:pt idx="34">
                  <c:v>1.6E-2</c:v>
                </c:pt>
                <c:pt idx="35">
                  <c:v>1.6E-2</c:v>
                </c:pt>
                <c:pt idx="36">
                  <c:v>1.6E-2</c:v>
                </c:pt>
                <c:pt idx="37">
                  <c:v>1.6E-2</c:v>
                </c:pt>
                <c:pt idx="38">
                  <c:v>1.6E-2</c:v>
                </c:pt>
                <c:pt idx="39">
                  <c:v>1.6E-2</c:v>
                </c:pt>
                <c:pt idx="40">
                  <c:v>1.6E-2</c:v>
                </c:pt>
                <c:pt idx="41">
                  <c:v>1.6E-2</c:v>
                </c:pt>
                <c:pt idx="42">
                  <c:v>1.4999999999999999E-2</c:v>
                </c:pt>
                <c:pt idx="43">
                  <c:v>1.4999999999999999E-2</c:v>
                </c:pt>
                <c:pt idx="44">
                  <c:v>1.6E-2</c:v>
                </c:pt>
                <c:pt idx="45">
                  <c:v>1.6E-2</c:v>
                </c:pt>
                <c:pt idx="46">
                  <c:v>1.6E-2</c:v>
                </c:pt>
                <c:pt idx="47">
                  <c:v>1.6E-2</c:v>
                </c:pt>
                <c:pt idx="48">
                  <c:v>1.4999999999999999E-2</c:v>
                </c:pt>
                <c:pt idx="49">
                  <c:v>1.4999999999999999E-2</c:v>
                </c:pt>
                <c:pt idx="50">
                  <c:v>1.4999999999999999E-2</c:v>
                </c:pt>
                <c:pt idx="51">
                  <c:v>1.6E-2</c:v>
                </c:pt>
                <c:pt idx="52">
                  <c:v>1.6E-2</c:v>
                </c:pt>
                <c:pt idx="53">
                  <c:v>1.6E-2</c:v>
                </c:pt>
                <c:pt idx="54">
                  <c:v>1.6E-2</c:v>
                </c:pt>
                <c:pt idx="55">
                  <c:v>1.4999999999999999E-2</c:v>
                </c:pt>
                <c:pt idx="56">
                  <c:v>1.4999999999999999E-2</c:v>
                </c:pt>
                <c:pt idx="57">
                  <c:v>1.4999999999999999E-2</c:v>
                </c:pt>
                <c:pt idx="58">
                  <c:v>1.4999999999999999E-2</c:v>
                </c:pt>
                <c:pt idx="59">
                  <c:v>1.4999999999999999E-2</c:v>
                </c:pt>
                <c:pt idx="60">
                  <c:v>1.4999999999999999E-2</c:v>
                </c:pt>
                <c:pt idx="61">
                  <c:v>1.4999999999999999E-2</c:v>
                </c:pt>
                <c:pt idx="62">
                  <c:v>1.4999999999999999E-2</c:v>
                </c:pt>
                <c:pt idx="63">
                  <c:v>1.4999999999999999E-2</c:v>
                </c:pt>
                <c:pt idx="64">
                  <c:v>1.4999999999999999E-2</c:v>
                </c:pt>
                <c:pt idx="65">
                  <c:v>1.4999999999999999E-2</c:v>
                </c:pt>
                <c:pt idx="66">
                  <c:v>1.4999999999999999E-2</c:v>
                </c:pt>
                <c:pt idx="67">
                  <c:v>1.4999999999999999E-2</c:v>
                </c:pt>
                <c:pt idx="68">
                  <c:v>1.4999999999999999E-2</c:v>
                </c:pt>
                <c:pt idx="69">
                  <c:v>1.4999999999999999E-2</c:v>
                </c:pt>
                <c:pt idx="70">
                  <c:v>1.4999999999999999E-2</c:v>
                </c:pt>
                <c:pt idx="71">
                  <c:v>1.4E-2</c:v>
                </c:pt>
                <c:pt idx="72">
                  <c:v>1.4E-2</c:v>
                </c:pt>
                <c:pt idx="73">
                  <c:v>1.4E-2</c:v>
                </c:pt>
                <c:pt idx="74">
                  <c:v>1.4E-2</c:v>
                </c:pt>
                <c:pt idx="75">
                  <c:v>1.4E-2</c:v>
                </c:pt>
                <c:pt idx="76">
                  <c:v>1.4E-2</c:v>
                </c:pt>
                <c:pt idx="77">
                  <c:v>1.4E-2</c:v>
                </c:pt>
                <c:pt idx="78">
                  <c:v>1.4E-2</c:v>
                </c:pt>
                <c:pt idx="79">
                  <c:v>1.4E-2</c:v>
                </c:pt>
                <c:pt idx="80">
                  <c:v>1.4E-2</c:v>
                </c:pt>
                <c:pt idx="81">
                  <c:v>1.4E-2</c:v>
                </c:pt>
                <c:pt idx="82">
                  <c:v>1.4E-2</c:v>
                </c:pt>
                <c:pt idx="83">
                  <c:v>1.4E-2</c:v>
                </c:pt>
                <c:pt idx="84">
                  <c:v>1.4E-2</c:v>
                </c:pt>
                <c:pt idx="85">
                  <c:v>1.4E-2</c:v>
                </c:pt>
                <c:pt idx="86">
                  <c:v>1.2999999999999999E-2</c:v>
                </c:pt>
                <c:pt idx="87">
                  <c:v>1.2999999999999999E-2</c:v>
                </c:pt>
                <c:pt idx="88">
                  <c:v>1.2999999999999999E-2</c:v>
                </c:pt>
                <c:pt idx="89">
                  <c:v>1.2999999999999999E-2</c:v>
                </c:pt>
                <c:pt idx="90">
                  <c:v>1.2999999999999999E-2</c:v>
                </c:pt>
                <c:pt idx="91">
                  <c:v>1.2999999999999999E-2</c:v>
                </c:pt>
                <c:pt idx="92">
                  <c:v>1.2999999999999999E-2</c:v>
                </c:pt>
                <c:pt idx="93">
                  <c:v>1.2999999999999999E-2</c:v>
                </c:pt>
                <c:pt idx="94">
                  <c:v>1.2999999999999999E-2</c:v>
                </c:pt>
                <c:pt idx="95">
                  <c:v>1.2999999999999999E-2</c:v>
                </c:pt>
                <c:pt idx="96">
                  <c:v>1.2999999999999999E-2</c:v>
                </c:pt>
                <c:pt idx="97">
                  <c:v>1.2999999999999999E-2</c:v>
                </c:pt>
                <c:pt idx="98">
                  <c:v>1.2999999999999999E-2</c:v>
                </c:pt>
                <c:pt idx="99">
                  <c:v>1.2999999999999999E-2</c:v>
                </c:pt>
                <c:pt idx="100">
                  <c:v>1.2999999999999999E-2</c:v>
                </c:pt>
                <c:pt idx="101">
                  <c:v>1.2999999999999999E-2</c:v>
                </c:pt>
                <c:pt idx="102">
                  <c:v>1.2999999999999999E-2</c:v>
                </c:pt>
                <c:pt idx="103">
                  <c:v>1.2999999999999999E-2</c:v>
                </c:pt>
                <c:pt idx="104">
                  <c:v>1.4E-2</c:v>
                </c:pt>
                <c:pt idx="105">
                  <c:v>1.4E-2</c:v>
                </c:pt>
                <c:pt idx="106">
                  <c:v>1.4E-2</c:v>
                </c:pt>
                <c:pt idx="107">
                  <c:v>1.4E-2</c:v>
                </c:pt>
                <c:pt idx="108">
                  <c:v>1.4E-2</c:v>
                </c:pt>
                <c:pt idx="109">
                  <c:v>1.4E-2</c:v>
                </c:pt>
                <c:pt idx="110">
                  <c:v>1.4E-2</c:v>
                </c:pt>
                <c:pt idx="111">
                  <c:v>1.4E-2</c:v>
                </c:pt>
                <c:pt idx="112">
                  <c:v>1.4E-2</c:v>
                </c:pt>
                <c:pt idx="113">
                  <c:v>1.4E-2</c:v>
                </c:pt>
                <c:pt idx="114">
                  <c:v>1.4E-2</c:v>
                </c:pt>
                <c:pt idx="115">
                  <c:v>1.4E-2</c:v>
                </c:pt>
                <c:pt idx="116">
                  <c:v>1.4E-2</c:v>
                </c:pt>
                <c:pt idx="117">
                  <c:v>1.4E-2</c:v>
                </c:pt>
                <c:pt idx="118">
                  <c:v>1.4E-2</c:v>
                </c:pt>
                <c:pt idx="119">
                  <c:v>1.4E-2</c:v>
                </c:pt>
                <c:pt idx="120">
                  <c:v>1.4E-2</c:v>
                </c:pt>
                <c:pt idx="121">
                  <c:v>1.4E-2</c:v>
                </c:pt>
                <c:pt idx="122">
                  <c:v>1.4E-2</c:v>
                </c:pt>
                <c:pt idx="123">
                  <c:v>1.4E-2</c:v>
                </c:pt>
                <c:pt idx="124">
                  <c:v>1.4E-2</c:v>
                </c:pt>
                <c:pt idx="125">
                  <c:v>1.4E-2</c:v>
                </c:pt>
                <c:pt idx="126">
                  <c:v>1.2999999999999999E-2</c:v>
                </c:pt>
                <c:pt idx="127">
                  <c:v>1.2999999999999999E-2</c:v>
                </c:pt>
                <c:pt idx="128">
                  <c:v>1.2999999999999999E-2</c:v>
                </c:pt>
                <c:pt idx="129">
                  <c:v>1.2999999999999999E-2</c:v>
                </c:pt>
                <c:pt idx="130">
                  <c:v>1.2999999999999999E-2</c:v>
                </c:pt>
                <c:pt idx="131">
                  <c:v>1.2999999999999999E-2</c:v>
                </c:pt>
                <c:pt idx="132">
                  <c:v>1.2999999999999999E-2</c:v>
                </c:pt>
                <c:pt idx="133">
                  <c:v>1.2E-2</c:v>
                </c:pt>
                <c:pt idx="134">
                  <c:v>1.2E-2</c:v>
                </c:pt>
                <c:pt idx="135">
                  <c:v>1.2E-2</c:v>
                </c:pt>
                <c:pt idx="136">
                  <c:v>1.2E-2</c:v>
                </c:pt>
                <c:pt idx="137">
                  <c:v>1.2E-2</c:v>
                </c:pt>
                <c:pt idx="138">
                  <c:v>1.2E-2</c:v>
                </c:pt>
                <c:pt idx="139">
                  <c:v>1.0999999999999999E-2</c:v>
                </c:pt>
                <c:pt idx="140">
                  <c:v>1.0999999999999999E-2</c:v>
                </c:pt>
                <c:pt idx="141">
                  <c:v>1.0999999999999999E-2</c:v>
                </c:pt>
                <c:pt idx="142">
                  <c:v>1.0999999999999999E-2</c:v>
                </c:pt>
                <c:pt idx="143">
                  <c:v>1.0999999999999999E-2</c:v>
                </c:pt>
                <c:pt idx="144">
                  <c:v>1.0999999999999999E-2</c:v>
                </c:pt>
                <c:pt idx="145">
                  <c:v>1.0999999999999999E-2</c:v>
                </c:pt>
                <c:pt idx="146">
                  <c:v>1.0999999999999999E-2</c:v>
                </c:pt>
                <c:pt idx="147">
                  <c:v>1.0999999999999999E-2</c:v>
                </c:pt>
                <c:pt idx="148">
                  <c:v>0.01</c:v>
                </c:pt>
                <c:pt idx="149">
                  <c:v>0.01</c:v>
                </c:pt>
                <c:pt idx="150">
                  <c:v>0.01</c:v>
                </c:pt>
                <c:pt idx="151">
                  <c:v>0.01</c:v>
                </c:pt>
                <c:pt idx="152">
                  <c:v>0.01</c:v>
                </c:pt>
                <c:pt idx="153">
                  <c:v>0.01</c:v>
                </c:pt>
                <c:pt idx="154">
                  <c:v>0.01</c:v>
                </c:pt>
                <c:pt idx="155">
                  <c:v>0.01</c:v>
                </c:pt>
                <c:pt idx="156">
                  <c:v>0.01</c:v>
                </c:pt>
                <c:pt idx="157">
                  <c:v>0.01</c:v>
                </c:pt>
                <c:pt idx="158">
                  <c:v>0.01</c:v>
                </c:pt>
                <c:pt idx="159">
                  <c:v>0.01</c:v>
                </c:pt>
                <c:pt idx="160">
                  <c:v>0.01</c:v>
                </c:pt>
                <c:pt idx="161">
                  <c:v>8.9999999999999993E-3</c:v>
                </c:pt>
                <c:pt idx="162">
                  <c:v>8.9999999999999993E-3</c:v>
                </c:pt>
                <c:pt idx="163">
                  <c:v>8.9999999999999993E-3</c:v>
                </c:pt>
                <c:pt idx="164">
                  <c:v>8.9999999999999993E-3</c:v>
                </c:pt>
                <c:pt idx="165">
                  <c:v>8.9999999999999993E-3</c:v>
                </c:pt>
                <c:pt idx="166">
                  <c:v>8.9999999999999993E-3</c:v>
                </c:pt>
                <c:pt idx="167">
                  <c:v>8.9999999999999993E-3</c:v>
                </c:pt>
                <c:pt idx="168">
                  <c:v>8.9999999999999993E-3</c:v>
                </c:pt>
                <c:pt idx="169">
                  <c:v>8.9999999999999993E-3</c:v>
                </c:pt>
                <c:pt idx="170">
                  <c:v>8.9999999999999993E-3</c:v>
                </c:pt>
                <c:pt idx="171">
                  <c:v>8.9999999999999993E-3</c:v>
                </c:pt>
                <c:pt idx="172">
                  <c:v>8.9999999999999993E-3</c:v>
                </c:pt>
                <c:pt idx="173">
                  <c:v>8.9999999999999993E-3</c:v>
                </c:pt>
                <c:pt idx="174">
                  <c:v>8.9999999999999993E-3</c:v>
                </c:pt>
                <c:pt idx="175">
                  <c:v>8.9999999999999993E-3</c:v>
                </c:pt>
                <c:pt idx="176">
                  <c:v>8.9999999999999993E-3</c:v>
                </c:pt>
                <c:pt idx="177">
                  <c:v>8.9999999999999993E-3</c:v>
                </c:pt>
                <c:pt idx="178">
                  <c:v>8.9999999999999993E-3</c:v>
                </c:pt>
                <c:pt idx="179">
                  <c:v>8.9999999999999993E-3</c:v>
                </c:pt>
                <c:pt idx="180">
                  <c:v>8.9999999999999993E-3</c:v>
                </c:pt>
                <c:pt idx="181">
                  <c:v>8.9999999999999993E-3</c:v>
                </c:pt>
                <c:pt idx="182">
                  <c:v>8.9999999999999993E-3</c:v>
                </c:pt>
                <c:pt idx="183">
                  <c:v>8.9999999999999993E-3</c:v>
                </c:pt>
                <c:pt idx="184">
                  <c:v>8.9999999999999993E-3</c:v>
                </c:pt>
                <c:pt idx="185">
                  <c:v>8.9999999999999993E-3</c:v>
                </c:pt>
                <c:pt idx="186">
                  <c:v>8.9999999999999993E-3</c:v>
                </c:pt>
                <c:pt idx="187">
                  <c:v>8.9999999999999993E-3</c:v>
                </c:pt>
                <c:pt idx="188">
                  <c:v>8.9999999999999993E-3</c:v>
                </c:pt>
                <c:pt idx="189">
                  <c:v>8.9999999999999993E-3</c:v>
                </c:pt>
                <c:pt idx="190">
                  <c:v>8.9999999999999993E-3</c:v>
                </c:pt>
                <c:pt idx="191">
                  <c:v>8.9999999999999993E-3</c:v>
                </c:pt>
                <c:pt idx="192">
                  <c:v>8.9999999999999993E-3</c:v>
                </c:pt>
                <c:pt idx="193">
                  <c:v>8.9999999999999993E-3</c:v>
                </c:pt>
                <c:pt idx="194">
                  <c:v>8.9999999999999993E-3</c:v>
                </c:pt>
                <c:pt idx="195">
                  <c:v>8.9999999999999993E-3</c:v>
                </c:pt>
                <c:pt idx="196">
                  <c:v>8.9999999999999993E-3</c:v>
                </c:pt>
                <c:pt idx="197">
                  <c:v>8.9999999999999993E-3</c:v>
                </c:pt>
                <c:pt idx="198">
                  <c:v>8.9999999999999993E-3</c:v>
                </c:pt>
                <c:pt idx="199">
                  <c:v>8.9999999999999993E-3</c:v>
                </c:pt>
                <c:pt idx="200">
                  <c:v>8.9999999999999993E-3</c:v>
                </c:pt>
                <c:pt idx="201">
                  <c:v>8.9999999999999993E-3</c:v>
                </c:pt>
                <c:pt idx="202">
                  <c:v>8.9999999999999993E-3</c:v>
                </c:pt>
                <c:pt idx="203">
                  <c:v>8.9999999999999993E-3</c:v>
                </c:pt>
                <c:pt idx="204">
                  <c:v>8.9999999999999993E-3</c:v>
                </c:pt>
                <c:pt idx="205">
                  <c:v>8.9999999999999993E-3</c:v>
                </c:pt>
                <c:pt idx="206">
                  <c:v>8.9999999999999993E-3</c:v>
                </c:pt>
                <c:pt idx="207">
                  <c:v>8.9999999999999993E-3</c:v>
                </c:pt>
                <c:pt idx="208">
                  <c:v>8.9999999999999993E-3</c:v>
                </c:pt>
                <c:pt idx="209">
                  <c:v>8.9999999999999993E-3</c:v>
                </c:pt>
                <c:pt idx="210">
                  <c:v>8.9999999999999993E-3</c:v>
                </c:pt>
                <c:pt idx="211">
                  <c:v>8.9999999999999993E-3</c:v>
                </c:pt>
                <c:pt idx="212">
                  <c:v>8.9999999999999993E-3</c:v>
                </c:pt>
                <c:pt idx="213">
                  <c:v>8.9999999999999993E-3</c:v>
                </c:pt>
                <c:pt idx="214">
                  <c:v>8.9999999999999993E-3</c:v>
                </c:pt>
                <c:pt idx="215">
                  <c:v>8.9999999999999993E-3</c:v>
                </c:pt>
                <c:pt idx="216">
                  <c:v>8.9999999999999993E-3</c:v>
                </c:pt>
                <c:pt idx="217">
                  <c:v>8.9999999999999993E-3</c:v>
                </c:pt>
                <c:pt idx="218">
                  <c:v>8.9999999999999993E-3</c:v>
                </c:pt>
                <c:pt idx="219">
                  <c:v>8.9999999999999993E-3</c:v>
                </c:pt>
                <c:pt idx="220">
                  <c:v>8.9999999999999993E-3</c:v>
                </c:pt>
                <c:pt idx="221">
                  <c:v>8.9999999999999993E-3</c:v>
                </c:pt>
                <c:pt idx="222">
                  <c:v>8.9999999999999993E-3</c:v>
                </c:pt>
                <c:pt idx="223">
                  <c:v>8.9999999999999993E-3</c:v>
                </c:pt>
                <c:pt idx="224">
                  <c:v>8.9999999999999993E-3</c:v>
                </c:pt>
                <c:pt idx="225">
                  <c:v>8.9999999999999993E-3</c:v>
                </c:pt>
                <c:pt idx="226">
                  <c:v>8.9999999999999993E-3</c:v>
                </c:pt>
                <c:pt idx="227">
                  <c:v>8.9999999999999993E-3</c:v>
                </c:pt>
                <c:pt idx="228">
                  <c:v>8.9999999999999993E-3</c:v>
                </c:pt>
                <c:pt idx="229">
                  <c:v>8.9999999999999993E-3</c:v>
                </c:pt>
                <c:pt idx="230">
                  <c:v>8.9999999999999993E-3</c:v>
                </c:pt>
                <c:pt idx="231">
                  <c:v>8.9999999999999993E-3</c:v>
                </c:pt>
                <c:pt idx="232">
                  <c:v>8.9999999999999993E-3</c:v>
                </c:pt>
                <c:pt idx="233">
                  <c:v>8.9999999999999993E-3</c:v>
                </c:pt>
                <c:pt idx="234">
                  <c:v>8.9999999999999993E-3</c:v>
                </c:pt>
                <c:pt idx="235">
                  <c:v>8.9999999999999993E-3</c:v>
                </c:pt>
                <c:pt idx="236">
                  <c:v>8.9999999999999993E-3</c:v>
                </c:pt>
                <c:pt idx="237">
                  <c:v>8.9999999999999993E-3</c:v>
                </c:pt>
                <c:pt idx="238">
                  <c:v>8.9999999999999993E-3</c:v>
                </c:pt>
                <c:pt idx="239">
                  <c:v>8.9999999999999993E-3</c:v>
                </c:pt>
                <c:pt idx="240">
                  <c:v>8.9999999999999993E-3</c:v>
                </c:pt>
                <c:pt idx="241">
                  <c:v>8.9999999999999993E-3</c:v>
                </c:pt>
                <c:pt idx="242">
                  <c:v>8.9999999999999993E-3</c:v>
                </c:pt>
                <c:pt idx="243">
                  <c:v>8.9999999999999993E-3</c:v>
                </c:pt>
                <c:pt idx="244">
                  <c:v>8.9999999999999993E-3</c:v>
                </c:pt>
                <c:pt idx="245">
                  <c:v>8.9999999999999993E-3</c:v>
                </c:pt>
                <c:pt idx="246">
                  <c:v>8.9999999999999993E-3</c:v>
                </c:pt>
                <c:pt idx="247">
                  <c:v>8.9999999999999993E-3</c:v>
                </c:pt>
                <c:pt idx="248">
                  <c:v>8.9999999999999993E-3</c:v>
                </c:pt>
                <c:pt idx="249">
                  <c:v>8.9999999999999993E-3</c:v>
                </c:pt>
                <c:pt idx="250">
                  <c:v>8.9999999999999993E-3</c:v>
                </c:pt>
                <c:pt idx="251">
                  <c:v>8.9999999999999993E-3</c:v>
                </c:pt>
                <c:pt idx="252">
                  <c:v>8.9999999999999993E-3</c:v>
                </c:pt>
                <c:pt idx="253">
                  <c:v>8.9999999999999993E-3</c:v>
                </c:pt>
                <c:pt idx="254">
                  <c:v>8.9999999999999993E-3</c:v>
                </c:pt>
                <c:pt idx="255">
                  <c:v>8.9999999999999993E-3</c:v>
                </c:pt>
                <c:pt idx="256">
                  <c:v>8.9999999999999993E-3</c:v>
                </c:pt>
                <c:pt idx="257">
                  <c:v>8.0000000000000002E-3</c:v>
                </c:pt>
                <c:pt idx="258">
                  <c:v>8.0000000000000002E-3</c:v>
                </c:pt>
                <c:pt idx="259">
                  <c:v>8.0000000000000002E-3</c:v>
                </c:pt>
                <c:pt idx="260">
                  <c:v>8.0000000000000002E-3</c:v>
                </c:pt>
                <c:pt idx="261">
                  <c:v>8.0000000000000002E-3</c:v>
                </c:pt>
                <c:pt idx="262">
                  <c:v>8.0000000000000002E-3</c:v>
                </c:pt>
                <c:pt idx="263">
                  <c:v>8.0000000000000002E-3</c:v>
                </c:pt>
                <c:pt idx="264">
                  <c:v>8.0000000000000002E-3</c:v>
                </c:pt>
                <c:pt idx="265">
                  <c:v>8.0000000000000002E-3</c:v>
                </c:pt>
                <c:pt idx="266">
                  <c:v>8.0000000000000002E-3</c:v>
                </c:pt>
                <c:pt idx="267">
                  <c:v>8.0000000000000002E-3</c:v>
                </c:pt>
                <c:pt idx="268">
                  <c:v>8.0000000000000002E-3</c:v>
                </c:pt>
                <c:pt idx="269">
                  <c:v>8.0000000000000002E-3</c:v>
                </c:pt>
                <c:pt idx="270">
                  <c:v>8.0000000000000002E-3</c:v>
                </c:pt>
                <c:pt idx="271">
                  <c:v>8.0000000000000002E-3</c:v>
                </c:pt>
                <c:pt idx="272">
                  <c:v>8.0000000000000002E-3</c:v>
                </c:pt>
                <c:pt idx="273">
                  <c:v>8.0000000000000002E-3</c:v>
                </c:pt>
                <c:pt idx="274">
                  <c:v>8.0000000000000002E-3</c:v>
                </c:pt>
                <c:pt idx="275">
                  <c:v>8.0000000000000002E-3</c:v>
                </c:pt>
                <c:pt idx="276">
                  <c:v>8.0000000000000002E-3</c:v>
                </c:pt>
                <c:pt idx="277">
                  <c:v>8.0000000000000002E-3</c:v>
                </c:pt>
                <c:pt idx="278">
                  <c:v>8.0000000000000002E-3</c:v>
                </c:pt>
                <c:pt idx="279">
                  <c:v>8.0000000000000002E-3</c:v>
                </c:pt>
                <c:pt idx="280">
                  <c:v>8.0000000000000002E-3</c:v>
                </c:pt>
                <c:pt idx="281">
                  <c:v>8.0000000000000002E-3</c:v>
                </c:pt>
                <c:pt idx="282">
                  <c:v>8.0000000000000002E-3</c:v>
                </c:pt>
                <c:pt idx="283">
                  <c:v>8.0000000000000002E-3</c:v>
                </c:pt>
                <c:pt idx="284">
                  <c:v>8.0000000000000002E-3</c:v>
                </c:pt>
                <c:pt idx="285">
                  <c:v>8.0000000000000002E-3</c:v>
                </c:pt>
                <c:pt idx="286">
                  <c:v>8.0000000000000002E-3</c:v>
                </c:pt>
                <c:pt idx="287">
                  <c:v>8.0000000000000002E-3</c:v>
                </c:pt>
                <c:pt idx="288">
                  <c:v>8.9999999999999993E-3</c:v>
                </c:pt>
                <c:pt idx="289">
                  <c:v>8.9999999999999993E-3</c:v>
                </c:pt>
                <c:pt idx="290">
                  <c:v>8.9999999999999993E-3</c:v>
                </c:pt>
                <c:pt idx="291">
                  <c:v>8.9999999999999993E-3</c:v>
                </c:pt>
                <c:pt idx="292">
                  <c:v>8.9999999999999993E-3</c:v>
                </c:pt>
                <c:pt idx="293">
                  <c:v>8.9999999999999993E-3</c:v>
                </c:pt>
                <c:pt idx="294">
                  <c:v>8.9999999999999993E-3</c:v>
                </c:pt>
                <c:pt idx="295">
                  <c:v>8.9999999999999993E-3</c:v>
                </c:pt>
                <c:pt idx="296">
                  <c:v>8.9999999999999993E-3</c:v>
                </c:pt>
                <c:pt idx="297">
                  <c:v>8.9999999999999993E-3</c:v>
                </c:pt>
                <c:pt idx="298">
                  <c:v>8.9999999999999993E-3</c:v>
                </c:pt>
                <c:pt idx="299">
                  <c:v>8.9999999999999993E-3</c:v>
                </c:pt>
                <c:pt idx="300">
                  <c:v>0.01</c:v>
                </c:pt>
                <c:pt idx="301">
                  <c:v>0.01</c:v>
                </c:pt>
                <c:pt idx="302">
                  <c:v>0.01</c:v>
                </c:pt>
                <c:pt idx="303">
                  <c:v>0.01</c:v>
                </c:pt>
                <c:pt idx="304">
                  <c:v>0.01</c:v>
                </c:pt>
                <c:pt idx="305">
                  <c:v>0.01</c:v>
                </c:pt>
                <c:pt idx="306">
                  <c:v>0.01</c:v>
                </c:pt>
                <c:pt idx="307">
                  <c:v>0.01</c:v>
                </c:pt>
                <c:pt idx="308">
                  <c:v>0.01</c:v>
                </c:pt>
                <c:pt idx="309">
                  <c:v>0.01</c:v>
                </c:pt>
                <c:pt idx="310">
                  <c:v>1.0999999999999999E-2</c:v>
                </c:pt>
                <c:pt idx="311">
                  <c:v>1.0999999999999999E-2</c:v>
                </c:pt>
                <c:pt idx="312">
                  <c:v>1.0999999999999999E-2</c:v>
                </c:pt>
                <c:pt idx="313">
                  <c:v>1.0999999999999999E-2</c:v>
                </c:pt>
                <c:pt idx="314">
                  <c:v>1.0999999999999999E-2</c:v>
                </c:pt>
                <c:pt idx="315">
                  <c:v>1.0999999999999999E-2</c:v>
                </c:pt>
                <c:pt idx="316">
                  <c:v>1.0999999999999999E-2</c:v>
                </c:pt>
                <c:pt idx="317">
                  <c:v>1.0999999999999999E-2</c:v>
                </c:pt>
                <c:pt idx="318">
                  <c:v>1.0999999999999999E-2</c:v>
                </c:pt>
                <c:pt idx="319">
                  <c:v>1.0999999999999999E-2</c:v>
                </c:pt>
                <c:pt idx="320">
                  <c:v>1.2E-2</c:v>
                </c:pt>
                <c:pt idx="321">
                  <c:v>1.2E-2</c:v>
                </c:pt>
                <c:pt idx="322">
                  <c:v>1.2E-2</c:v>
                </c:pt>
                <c:pt idx="323">
                  <c:v>1.2E-2</c:v>
                </c:pt>
                <c:pt idx="324">
                  <c:v>1.2E-2</c:v>
                </c:pt>
                <c:pt idx="325">
                  <c:v>1.2E-2</c:v>
                </c:pt>
                <c:pt idx="326">
                  <c:v>1.2E-2</c:v>
                </c:pt>
                <c:pt idx="327">
                  <c:v>1.2E-2</c:v>
                </c:pt>
                <c:pt idx="328">
                  <c:v>1.2E-2</c:v>
                </c:pt>
                <c:pt idx="329">
                  <c:v>1.2E-2</c:v>
                </c:pt>
                <c:pt idx="330">
                  <c:v>1.2E-2</c:v>
                </c:pt>
                <c:pt idx="331">
                  <c:v>1.2E-2</c:v>
                </c:pt>
                <c:pt idx="332">
                  <c:v>1.2E-2</c:v>
                </c:pt>
                <c:pt idx="333">
                  <c:v>1.2E-2</c:v>
                </c:pt>
                <c:pt idx="334">
                  <c:v>1.2999999999999999E-2</c:v>
                </c:pt>
                <c:pt idx="335">
                  <c:v>1.2999999999999999E-2</c:v>
                </c:pt>
                <c:pt idx="336">
                  <c:v>1.2999999999999999E-2</c:v>
                </c:pt>
                <c:pt idx="337">
                  <c:v>1.2999999999999999E-2</c:v>
                </c:pt>
                <c:pt idx="338">
                  <c:v>1.2999999999999999E-2</c:v>
                </c:pt>
                <c:pt idx="339">
                  <c:v>1.2999999999999999E-2</c:v>
                </c:pt>
                <c:pt idx="340">
                  <c:v>1.2999999999999999E-2</c:v>
                </c:pt>
                <c:pt idx="341">
                  <c:v>1.2999999999999999E-2</c:v>
                </c:pt>
                <c:pt idx="342">
                  <c:v>1.2999999999999999E-2</c:v>
                </c:pt>
                <c:pt idx="343">
                  <c:v>1.2999999999999999E-2</c:v>
                </c:pt>
                <c:pt idx="344">
                  <c:v>1.2999999999999999E-2</c:v>
                </c:pt>
                <c:pt idx="345">
                  <c:v>1.4E-2</c:v>
                </c:pt>
                <c:pt idx="346">
                  <c:v>1.4E-2</c:v>
                </c:pt>
                <c:pt idx="347">
                  <c:v>1.4E-2</c:v>
                </c:pt>
                <c:pt idx="348">
                  <c:v>1.4E-2</c:v>
                </c:pt>
                <c:pt idx="349">
                  <c:v>1.4E-2</c:v>
                </c:pt>
                <c:pt idx="350">
                  <c:v>1.4E-2</c:v>
                </c:pt>
                <c:pt idx="351">
                  <c:v>1.4999999999999999E-2</c:v>
                </c:pt>
                <c:pt idx="352">
                  <c:v>1.4999999999999999E-2</c:v>
                </c:pt>
                <c:pt idx="353">
                  <c:v>1.4999999999999999E-2</c:v>
                </c:pt>
                <c:pt idx="354">
                  <c:v>1.4999999999999999E-2</c:v>
                </c:pt>
                <c:pt idx="355">
                  <c:v>1.6E-2</c:v>
                </c:pt>
                <c:pt idx="356">
                  <c:v>1.6E-2</c:v>
                </c:pt>
                <c:pt idx="357">
                  <c:v>1.6E-2</c:v>
                </c:pt>
                <c:pt idx="358">
                  <c:v>1.6E-2</c:v>
                </c:pt>
                <c:pt idx="359">
                  <c:v>1.6E-2</c:v>
                </c:pt>
                <c:pt idx="360">
                  <c:v>1.7000000000000001E-2</c:v>
                </c:pt>
                <c:pt idx="361">
                  <c:v>1.7000000000000001E-2</c:v>
                </c:pt>
                <c:pt idx="362">
                  <c:v>1.7000000000000001E-2</c:v>
                </c:pt>
                <c:pt idx="363">
                  <c:v>1.7000000000000001E-2</c:v>
                </c:pt>
                <c:pt idx="364">
                  <c:v>1.7000000000000001E-2</c:v>
                </c:pt>
                <c:pt idx="365">
                  <c:v>1.7999999999999999E-2</c:v>
                </c:pt>
                <c:pt idx="366">
                  <c:v>1.7999999999999999E-2</c:v>
                </c:pt>
                <c:pt idx="367">
                  <c:v>1.7999999999999999E-2</c:v>
                </c:pt>
                <c:pt idx="368">
                  <c:v>1.7999999999999999E-2</c:v>
                </c:pt>
                <c:pt idx="369">
                  <c:v>1.7999999999999999E-2</c:v>
                </c:pt>
                <c:pt idx="370">
                  <c:v>1.7999999999999999E-2</c:v>
                </c:pt>
                <c:pt idx="371">
                  <c:v>1.9E-2</c:v>
                </c:pt>
                <c:pt idx="372">
                  <c:v>1.9E-2</c:v>
                </c:pt>
                <c:pt idx="373">
                  <c:v>1.9E-2</c:v>
                </c:pt>
                <c:pt idx="374">
                  <c:v>0.02</c:v>
                </c:pt>
                <c:pt idx="375">
                  <c:v>0.02</c:v>
                </c:pt>
                <c:pt idx="376">
                  <c:v>0.02</c:v>
                </c:pt>
                <c:pt idx="377">
                  <c:v>2.1000000000000001E-2</c:v>
                </c:pt>
                <c:pt idx="378">
                  <c:v>2.1000000000000001E-2</c:v>
                </c:pt>
                <c:pt idx="379">
                  <c:v>2.1000000000000001E-2</c:v>
                </c:pt>
                <c:pt idx="380">
                  <c:v>2.1999999999999999E-2</c:v>
                </c:pt>
                <c:pt idx="381">
                  <c:v>2.1999999999999999E-2</c:v>
                </c:pt>
                <c:pt idx="382">
                  <c:v>2.1999999999999999E-2</c:v>
                </c:pt>
                <c:pt idx="383">
                  <c:v>2.3E-2</c:v>
                </c:pt>
                <c:pt idx="384">
                  <c:v>2.3E-2</c:v>
                </c:pt>
                <c:pt idx="385">
                  <c:v>2.4E-2</c:v>
                </c:pt>
                <c:pt idx="386">
                  <c:v>2.4E-2</c:v>
                </c:pt>
                <c:pt idx="387">
                  <c:v>2.4E-2</c:v>
                </c:pt>
                <c:pt idx="388">
                  <c:v>2.5000000000000001E-2</c:v>
                </c:pt>
                <c:pt idx="389">
                  <c:v>2.5000000000000001E-2</c:v>
                </c:pt>
                <c:pt idx="390">
                  <c:v>2.5999999999999999E-2</c:v>
                </c:pt>
                <c:pt idx="391">
                  <c:v>2.5999999999999999E-2</c:v>
                </c:pt>
                <c:pt idx="392">
                  <c:v>2.7E-2</c:v>
                </c:pt>
                <c:pt idx="393">
                  <c:v>2.7E-2</c:v>
                </c:pt>
                <c:pt idx="394">
                  <c:v>2.7E-2</c:v>
                </c:pt>
                <c:pt idx="395">
                  <c:v>2.8000000000000001E-2</c:v>
                </c:pt>
                <c:pt idx="396">
                  <c:v>2.8000000000000001E-2</c:v>
                </c:pt>
                <c:pt idx="397">
                  <c:v>2.9000000000000001E-2</c:v>
                </c:pt>
                <c:pt idx="398">
                  <c:v>2.9000000000000001E-2</c:v>
                </c:pt>
                <c:pt idx="399">
                  <c:v>0.03</c:v>
                </c:pt>
                <c:pt idx="400">
                  <c:v>0.03</c:v>
                </c:pt>
                <c:pt idx="401">
                  <c:v>3.1E-2</c:v>
                </c:pt>
                <c:pt idx="402">
                  <c:v>3.1E-2</c:v>
                </c:pt>
                <c:pt idx="403">
                  <c:v>3.2000000000000001E-2</c:v>
                </c:pt>
                <c:pt idx="404">
                  <c:v>3.2000000000000001E-2</c:v>
                </c:pt>
                <c:pt idx="405">
                  <c:v>3.3000000000000002E-2</c:v>
                </c:pt>
                <c:pt idx="406">
                  <c:v>3.3000000000000002E-2</c:v>
                </c:pt>
                <c:pt idx="407">
                  <c:v>3.4000000000000002E-2</c:v>
                </c:pt>
                <c:pt idx="408">
                  <c:v>3.4000000000000002E-2</c:v>
                </c:pt>
                <c:pt idx="409">
                  <c:v>3.4000000000000002E-2</c:v>
                </c:pt>
                <c:pt idx="410">
                  <c:v>3.5000000000000003E-2</c:v>
                </c:pt>
                <c:pt idx="411">
                  <c:v>3.5000000000000003E-2</c:v>
                </c:pt>
                <c:pt idx="412">
                  <c:v>3.5999999999999997E-2</c:v>
                </c:pt>
                <c:pt idx="413">
                  <c:v>3.5999999999999997E-2</c:v>
                </c:pt>
                <c:pt idx="414">
                  <c:v>3.6999999999999998E-2</c:v>
                </c:pt>
                <c:pt idx="415">
                  <c:v>3.6999999999999998E-2</c:v>
                </c:pt>
                <c:pt idx="416">
                  <c:v>3.7999999999999999E-2</c:v>
                </c:pt>
                <c:pt idx="417">
                  <c:v>3.7999999999999999E-2</c:v>
                </c:pt>
                <c:pt idx="418">
                  <c:v>3.9E-2</c:v>
                </c:pt>
                <c:pt idx="419">
                  <c:v>3.9E-2</c:v>
                </c:pt>
                <c:pt idx="420">
                  <c:v>3.9E-2</c:v>
                </c:pt>
                <c:pt idx="421">
                  <c:v>3.7999999999999999E-2</c:v>
                </c:pt>
                <c:pt idx="422">
                  <c:v>3.9E-2</c:v>
                </c:pt>
                <c:pt idx="423">
                  <c:v>0.04</c:v>
                </c:pt>
                <c:pt idx="424">
                  <c:v>0.04</c:v>
                </c:pt>
                <c:pt idx="425">
                  <c:v>4.1000000000000002E-2</c:v>
                </c:pt>
                <c:pt idx="426">
                  <c:v>4.2000000000000003E-2</c:v>
                </c:pt>
                <c:pt idx="427">
                  <c:v>4.2999999999999997E-2</c:v>
                </c:pt>
                <c:pt idx="428">
                  <c:v>4.2999999999999997E-2</c:v>
                </c:pt>
                <c:pt idx="429">
                  <c:v>4.3999999999999997E-2</c:v>
                </c:pt>
                <c:pt idx="430">
                  <c:v>4.4999999999999998E-2</c:v>
                </c:pt>
                <c:pt idx="431">
                  <c:v>4.5999999999999999E-2</c:v>
                </c:pt>
                <c:pt idx="432">
                  <c:v>4.5999999999999999E-2</c:v>
                </c:pt>
                <c:pt idx="433">
                  <c:v>4.8000000000000001E-2</c:v>
                </c:pt>
                <c:pt idx="434">
                  <c:v>4.9000000000000002E-2</c:v>
                </c:pt>
                <c:pt idx="435">
                  <c:v>0.05</c:v>
                </c:pt>
                <c:pt idx="436">
                  <c:v>5.0999999999999997E-2</c:v>
                </c:pt>
                <c:pt idx="437">
                  <c:v>5.2999999999999999E-2</c:v>
                </c:pt>
                <c:pt idx="438">
                  <c:v>5.5E-2</c:v>
                </c:pt>
                <c:pt idx="439">
                  <c:v>5.7000000000000002E-2</c:v>
                </c:pt>
                <c:pt idx="440">
                  <c:v>5.8999999999999997E-2</c:v>
                </c:pt>
                <c:pt idx="441">
                  <c:v>6.0999999999999999E-2</c:v>
                </c:pt>
                <c:pt idx="442">
                  <c:v>6.4000000000000001E-2</c:v>
                </c:pt>
                <c:pt idx="443">
                  <c:v>6.6000000000000003E-2</c:v>
                </c:pt>
                <c:pt idx="444">
                  <c:v>6.9000000000000006E-2</c:v>
                </c:pt>
                <c:pt idx="445">
                  <c:v>7.0999999999999994E-2</c:v>
                </c:pt>
                <c:pt idx="446">
                  <c:v>7.4999999999999997E-2</c:v>
                </c:pt>
                <c:pt idx="447">
                  <c:v>7.8E-2</c:v>
                </c:pt>
                <c:pt idx="448">
                  <c:v>8.1000000000000003E-2</c:v>
                </c:pt>
                <c:pt idx="449">
                  <c:v>8.4000000000000005E-2</c:v>
                </c:pt>
                <c:pt idx="450">
                  <c:v>8.7999999999999995E-2</c:v>
                </c:pt>
                <c:pt idx="451">
                  <c:v>9.1999999999999998E-2</c:v>
                </c:pt>
                <c:pt idx="452">
                  <c:v>9.6000000000000002E-2</c:v>
                </c:pt>
                <c:pt idx="453">
                  <c:v>9.9000000000000005E-2</c:v>
                </c:pt>
                <c:pt idx="454">
                  <c:v>0.10299999999999999</c:v>
                </c:pt>
                <c:pt idx="455">
                  <c:v>0.107</c:v>
                </c:pt>
                <c:pt idx="456">
                  <c:v>0.11</c:v>
                </c:pt>
                <c:pt idx="457">
                  <c:v>0.115</c:v>
                </c:pt>
                <c:pt idx="458">
                  <c:v>0.11799999999999999</c:v>
                </c:pt>
                <c:pt idx="459">
                  <c:v>0.122</c:v>
                </c:pt>
                <c:pt idx="460">
                  <c:v>0.125</c:v>
                </c:pt>
                <c:pt idx="461">
                  <c:v>0.13800000000000001</c:v>
                </c:pt>
                <c:pt idx="462">
                  <c:v>0.13500000000000001</c:v>
                </c:pt>
                <c:pt idx="463">
                  <c:v>0.13800000000000001</c:v>
                </c:pt>
                <c:pt idx="464">
                  <c:v>0.14099999999999999</c:v>
                </c:pt>
                <c:pt idx="465">
                  <c:v>0.14299999999999999</c:v>
                </c:pt>
                <c:pt idx="466">
                  <c:v>0.14499999999999999</c:v>
                </c:pt>
                <c:pt idx="467">
                  <c:v>0.14699999999999999</c:v>
                </c:pt>
                <c:pt idx="468">
                  <c:v>0.14799999999999999</c:v>
                </c:pt>
                <c:pt idx="469">
                  <c:v>0.15</c:v>
                </c:pt>
                <c:pt idx="470">
                  <c:v>0.15</c:v>
                </c:pt>
                <c:pt idx="471">
                  <c:v>0.151</c:v>
                </c:pt>
                <c:pt idx="472">
                  <c:v>0.152</c:v>
                </c:pt>
                <c:pt idx="473">
                  <c:v>0.152</c:v>
                </c:pt>
                <c:pt idx="474">
                  <c:v>0.151</c:v>
                </c:pt>
                <c:pt idx="475">
                  <c:v>0.151</c:v>
                </c:pt>
                <c:pt idx="476">
                  <c:v>0.151</c:v>
                </c:pt>
                <c:pt idx="477">
                  <c:v>0.15</c:v>
                </c:pt>
                <c:pt idx="478">
                  <c:v>0.14899999999999999</c:v>
                </c:pt>
                <c:pt idx="479">
                  <c:v>0.14699999999999999</c:v>
                </c:pt>
                <c:pt idx="480">
                  <c:v>0.14599999999999999</c:v>
                </c:pt>
                <c:pt idx="481">
                  <c:v>0.14399999999999999</c:v>
                </c:pt>
                <c:pt idx="482">
                  <c:v>0.14199999999999999</c:v>
                </c:pt>
                <c:pt idx="483">
                  <c:v>0.14000000000000001</c:v>
                </c:pt>
                <c:pt idx="484">
                  <c:v>0.13800000000000001</c:v>
                </c:pt>
                <c:pt idx="485">
                  <c:v>0.13600000000000001</c:v>
                </c:pt>
                <c:pt idx="486">
                  <c:v>0.13400000000000001</c:v>
                </c:pt>
                <c:pt idx="487">
                  <c:v>0.13100000000000001</c:v>
                </c:pt>
                <c:pt idx="488">
                  <c:v>0.129</c:v>
                </c:pt>
                <c:pt idx="489">
                  <c:v>0.127</c:v>
                </c:pt>
                <c:pt idx="490">
                  <c:v>0.124</c:v>
                </c:pt>
                <c:pt idx="491">
                  <c:v>0.122</c:v>
                </c:pt>
                <c:pt idx="492">
                  <c:v>0.11899999999999999</c:v>
                </c:pt>
                <c:pt idx="493">
                  <c:v>0.11700000000000001</c:v>
                </c:pt>
                <c:pt idx="494">
                  <c:v>0.115</c:v>
                </c:pt>
                <c:pt idx="495">
                  <c:v>0.112</c:v>
                </c:pt>
                <c:pt idx="496">
                  <c:v>0.11</c:v>
                </c:pt>
                <c:pt idx="497">
                  <c:v>0.108</c:v>
                </c:pt>
                <c:pt idx="498">
                  <c:v>0.105</c:v>
                </c:pt>
                <c:pt idx="499">
                  <c:v>0.10299999999999999</c:v>
                </c:pt>
                <c:pt idx="500">
                  <c:v>0.10100000000000001</c:v>
                </c:pt>
                <c:pt idx="501">
                  <c:v>0.1</c:v>
                </c:pt>
                <c:pt idx="502">
                  <c:v>9.8000000000000004E-2</c:v>
                </c:pt>
                <c:pt idx="503">
                  <c:v>9.7000000000000003E-2</c:v>
                </c:pt>
                <c:pt idx="504">
                  <c:v>9.5000000000000001E-2</c:v>
                </c:pt>
                <c:pt idx="505">
                  <c:v>9.4E-2</c:v>
                </c:pt>
                <c:pt idx="506">
                  <c:v>9.2999999999999999E-2</c:v>
                </c:pt>
                <c:pt idx="507">
                  <c:v>9.1999999999999998E-2</c:v>
                </c:pt>
                <c:pt idx="508">
                  <c:v>9.1999999999999998E-2</c:v>
                </c:pt>
                <c:pt idx="509">
                  <c:v>9.0999999999999998E-2</c:v>
                </c:pt>
                <c:pt idx="510">
                  <c:v>9.0999999999999998E-2</c:v>
                </c:pt>
                <c:pt idx="511">
                  <c:v>0.09</c:v>
                </c:pt>
                <c:pt idx="512">
                  <c:v>0.09</c:v>
                </c:pt>
                <c:pt idx="513">
                  <c:v>0.09</c:v>
                </c:pt>
                <c:pt idx="514">
                  <c:v>0.09</c:v>
                </c:pt>
                <c:pt idx="515">
                  <c:v>9.0999999999999998E-2</c:v>
                </c:pt>
                <c:pt idx="516">
                  <c:v>9.2999999999999999E-2</c:v>
                </c:pt>
                <c:pt idx="517">
                  <c:v>9.4E-2</c:v>
                </c:pt>
                <c:pt idx="518">
                  <c:v>9.7000000000000003E-2</c:v>
                </c:pt>
                <c:pt idx="519">
                  <c:v>0.1</c:v>
                </c:pt>
                <c:pt idx="520">
                  <c:v>0.10299999999999999</c:v>
                </c:pt>
                <c:pt idx="521">
                  <c:v>0.107</c:v>
                </c:pt>
                <c:pt idx="522">
                  <c:v>0.11</c:v>
                </c:pt>
                <c:pt idx="523">
                  <c:v>0.113</c:v>
                </c:pt>
                <c:pt idx="524">
                  <c:v>0.11700000000000001</c:v>
                </c:pt>
                <c:pt idx="525">
                  <c:v>0.11899999999999999</c:v>
                </c:pt>
                <c:pt idx="526">
                  <c:v>0.121</c:v>
                </c:pt>
                <c:pt idx="527">
                  <c:v>0.123</c:v>
                </c:pt>
                <c:pt idx="528">
                  <c:v>0.125</c:v>
                </c:pt>
                <c:pt idx="529">
                  <c:v>0.127</c:v>
                </c:pt>
                <c:pt idx="530">
                  <c:v>0.128</c:v>
                </c:pt>
                <c:pt idx="531">
                  <c:v>0.13</c:v>
                </c:pt>
                <c:pt idx="532">
                  <c:v>0.13100000000000001</c:v>
                </c:pt>
                <c:pt idx="533">
                  <c:v>0.13100000000000001</c:v>
                </c:pt>
                <c:pt idx="534">
                  <c:v>0.13</c:v>
                </c:pt>
                <c:pt idx="535">
                  <c:v>0.13</c:v>
                </c:pt>
                <c:pt idx="536">
                  <c:v>0.129</c:v>
                </c:pt>
                <c:pt idx="537">
                  <c:v>0.128</c:v>
                </c:pt>
                <c:pt idx="538">
                  <c:v>0.127</c:v>
                </c:pt>
                <c:pt idx="539">
                  <c:v>0.126</c:v>
                </c:pt>
                <c:pt idx="540">
                  <c:v>0.125</c:v>
                </c:pt>
                <c:pt idx="541">
                  <c:v>0.123</c:v>
                </c:pt>
                <c:pt idx="542">
                  <c:v>0.122</c:v>
                </c:pt>
                <c:pt idx="543">
                  <c:v>0.121</c:v>
                </c:pt>
                <c:pt idx="544">
                  <c:v>0.12</c:v>
                </c:pt>
                <c:pt idx="545">
                  <c:v>0.11899999999999999</c:v>
                </c:pt>
                <c:pt idx="546">
                  <c:v>0.11799999999999999</c:v>
                </c:pt>
                <c:pt idx="547">
                  <c:v>0.11799999999999999</c:v>
                </c:pt>
                <c:pt idx="548">
                  <c:v>0.11700000000000001</c:v>
                </c:pt>
                <c:pt idx="549">
                  <c:v>0.11700000000000001</c:v>
                </c:pt>
                <c:pt idx="550">
                  <c:v>0.11799999999999999</c:v>
                </c:pt>
                <c:pt idx="551">
                  <c:v>0.11799999999999999</c:v>
                </c:pt>
                <c:pt idx="552">
                  <c:v>0.11899999999999999</c:v>
                </c:pt>
                <c:pt idx="553">
                  <c:v>0.121</c:v>
                </c:pt>
                <c:pt idx="554">
                  <c:v>0.123</c:v>
                </c:pt>
                <c:pt idx="555">
                  <c:v>0.125</c:v>
                </c:pt>
                <c:pt idx="556">
                  <c:v>0.127</c:v>
                </c:pt>
                <c:pt idx="557">
                  <c:v>0.13100000000000001</c:v>
                </c:pt>
                <c:pt idx="558">
                  <c:v>0.13400000000000001</c:v>
                </c:pt>
                <c:pt idx="559">
                  <c:v>0.13900000000000001</c:v>
                </c:pt>
                <c:pt idx="560">
                  <c:v>0.14499999999999999</c:v>
                </c:pt>
                <c:pt idx="561">
                  <c:v>0.151</c:v>
                </c:pt>
                <c:pt idx="562">
                  <c:v>0.158</c:v>
                </c:pt>
                <c:pt idx="563">
                  <c:v>0.16700000000000001</c:v>
                </c:pt>
                <c:pt idx="564">
                  <c:v>0.17699999999999999</c:v>
                </c:pt>
                <c:pt idx="565">
                  <c:v>0.189</c:v>
                </c:pt>
                <c:pt idx="566">
                  <c:v>0.20399999999999999</c:v>
                </c:pt>
                <c:pt idx="567">
                  <c:v>0.222</c:v>
                </c:pt>
                <c:pt idx="568">
                  <c:v>0.24299999999999999</c:v>
                </c:pt>
                <c:pt idx="569">
                  <c:v>0.26700000000000002</c:v>
                </c:pt>
                <c:pt idx="570">
                  <c:v>0.29499999999999998</c:v>
                </c:pt>
                <c:pt idx="571">
                  <c:v>0.32300000000000001</c:v>
                </c:pt>
                <c:pt idx="572">
                  <c:v>0.35099999999999998</c:v>
                </c:pt>
                <c:pt idx="573">
                  <c:v>0.38</c:v>
                </c:pt>
                <c:pt idx="574">
                  <c:v>0.40699999999999997</c:v>
                </c:pt>
                <c:pt idx="575">
                  <c:v>0.434</c:v>
                </c:pt>
                <c:pt idx="576">
                  <c:v>0.45900000000000002</c:v>
                </c:pt>
                <c:pt idx="577">
                  <c:v>0.48299999999999998</c:v>
                </c:pt>
                <c:pt idx="578">
                  <c:v>0.50600000000000001</c:v>
                </c:pt>
                <c:pt idx="579">
                  <c:v>0.52700000000000002</c:v>
                </c:pt>
                <c:pt idx="580">
                  <c:v>0.54800000000000004</c:v>
                </c:pt>
                <c:pt idx="581">
                  <c:v>0.56799999999999995</c:v>
                </c:pt>
                <c:pt idx="582">
                  <c:v>0.58899999999999997</c:v>
                </c:pt>
                <c:pt idx="583">
                  <c:v>0.61299999999999999</c:v>
                </c:pt>
                <c:pt idx="584">
                  <c:v>0.63800000000000001</c:v>
                </c:pt>
                <c:pt idx="585">
                  <c:v>0.66200000000000003</c:v>
                </c:pt>
                <c:pt idx="586">
                  <c:v>0.68400000000000005</c:v>
                </c:pt>
                <c:pt idx="587">
                  <c:v>0.70799999999999996</c:v>
                </c:pt>
                <c:pt idx="588">
                  <c:v>0.73199999999999998</c:v>
                </c:pt>
                <c:pt idx="589">
                  <c:v>0.75600000000000001</c:v>
                </c:pt>
                <c:pt idx="590">
                  <c:v>0.78200000000000003</c:v>
                </c:pt>
                <c:pt idx="591">
                  <c:v>0.80700000000000005</c:v>
                </c:pt>
                <c:pt idx="592">
                  <c:v>0.83199999999999996</c:v>
                </c:pt>
                <c:pt idx="593">
                  <c:v>0.85899999999999999</c:v>
                </c:pt>
                <c:pt idx="594">
                  <c:v>0.88900000000000001</c:v>
                </c:pt>
                <c:pt idx="595">
                  <c:v>0.92100000000000004</c:v>
                </c:pt>
                <c:pt idx="596">
                  <c:v>0.95699999999999996</c:v>
                </c:pt>
                <c:pt idx="597">
                  <c:v>0.999</c:v>
                </c:pt>
                <c:pt idx="598">
                  <c:v>1.05</c:v>
                </c:pt>
                <c:pt idx="599">
                  <c:v>1.1120000000000001</c:v>
                </c:pt>
                <c:pt idx="600">
                  <c:v>1.1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E505-40FA-858A-3227CC8E4D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57608"/>
        <c:axId val="646729384"/>
      </c:scatterChart>
      <c:valAx>
        <c:axId val="646757608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avelength</a:t>
                </a:r>
                <a:r>
                  <a:rPr lang="en-US" baseline="0"/>
                  <a:t> (nm)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35672900262467194"/>
              <c:y val="0.894409448818897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46729384"/>
        <c:crosses val="autoZero"/>
        <c:crossBetween val="midCat"/>
      </c:valAx>
      <c:valAx>
        <c:axId val="64672938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sorbance </a:t>
                </a:r>
              </a:p>
            </c:rich>
          </c:tx>
          <c:layout>
            <c:manualLayout>
              <c:xMode val="edge"/>
              <c:yMode val="edge"/>
              <c:x val="1.317694663167104E-2"/>
              <c:y val="0.1796456692913385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46757608"/>
        <c:crosses val="autoZero"/>
        <c:crossBetween val="midCat"/>
        <c:majorUnit val="0.5"/>
      </c:valAx>
    </c:plotArea>
    <c:legend>
      <c:legendPos val="t"/>
      <c:layout>
        <c:manualLayout>
          <c:xMode val="edge"/>
          <c:yMode val="edge"/>
          <c:x val="0.59513888888888888"/>
          <c:y val="0.27083333333333331"/>
          <c:w val="0.4"/>
          <c:h val="0.34779800962379703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US" dirty="0"/>
              <a:t>Scanning spectra of various leaf discs suspended in methanol </a:t>
            </a:r>
            <a:r>
              <a:rPr lang="en-US" dirty="0" smtClean="0"/>
              <a:t>for 10 </a:t>
            </a:r>
            <a:r>
              <a:rPr lang="en-US" dirty="0"/>
              <a:t>min</a:t>
            </a:r>
          </a:p>
        </c:rich>
      </c:tx>
      <c:layout>
        <c:manualLayout>
          <c:xMode val="edge"/>
          <c:yMode val="edge"/>
          <c:x val="0.21406249999999999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166967410323711"/>
          <c:y val="0.1951563867016623"/>
          <c:w val="0.73942421259842517"/>
          <c:h val="0.5886313429571303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Methanol-F'!$B$2</c:f>
              <c:strCache>
                <c:ptCount val="1"/>
                <c:pt idx="0">
                  <c:v>Spinach </c:v>
                </c:pt>
              </c:strCache>
            </c:strRef>
          </c:tx>
          <c:spPr>
            <a:ln>
              <a:prstDash val="sysDash"/>
            </a:ln>
          </c:spPr>
          <c:marker>
            <c:symbol val="none"/>
          </c:marker>
          <c:xVal>
            <c:numRef>
              <c:f>'Methanol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Methanol-F'!$B$3:$B$603</c:f>
              <c:numCache>
                <c:formatCode>General</c:formatCode>
                <c:ptCount val="601"/>
                <c:pt idx="0">
                  <c:v>2E-3</c:v>
                </c:pt>
                <c:pt idx="1">
                  <c:v>2E-3</c:v>
                </c:pt>
                <c:pt idx="2">
                  <c:v>1E-3</c:v>
                </c:pt>
                <c:pt idx="3">
                  <c:v>1E-3</c:v>
                </c:pt>
                <c:pt idx="4">
                  <c:v>1E-3</c:v>
                </c:pt>
                <c:pt idx="5">
                  <c:v>1E-3</c:v>
                </c:pt>
                <c:pt idx="6">
                  <c:v>1E-3</c:v>
                </c:pt>
                <c:pt idx="7">
                  <c:v>1E-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-1E-3</c:v>
                </c:pt>
                <c:pt idx="15">
                  <c:v>-1E-3</c:v>
                </c:pt>
                <c:pt idx="16">
                  <c:v>-1E-3</c:v>
                </c:pt>
                <c:pt idx="17">
                  <c:v>-1E-3</c:v>
                </c:pt>
                <c:pt idx="18">
                  <c:v>-1E-3</c:v>
                </c:pt>
                <c:pt idx="19">
                  <c:v>-1E-3</c:v>
                </c:pt>
                <c:pt idx="20">
                  <c:v>-2E-3</c:v>
                </c:pt>
                <c:pt idx="21">
                  <c:v>-2E-3</c:v>
                </c:pt>
                <c:pt idx="22">
                  <c:v>-2E-3</c:v>
                </c:pt>
                <c:pt idx="23">
                  <c:v>-2E-3</c:v>
                </c:pt>
                <c:pt idx="24">
                  <c:v>-2E-3</c:v>
                </c:pt>
                <c:pt idx="25">
                  <c:v>-2E-3</c:v>
                </c:pt>
                <c:pt idx="26">
                  <c:v>-2E-3</c:v>
                </c:pt>
                <c:pt idx="27">
                  <c:v>-3.0000000000000001E-3</c:v>
                </c:pt>
                <c:pt idx="28">
                  <c:v>-3.0000000000000001E-3</c:v>
                </c:pt>
                <c:pt idx="29">
                  <c:v>-3.0000000000000001E-3</c:v>
                </c:pt>
                <c:pt idx="30">
                  <c:v>-3.0000000000000001E-3</c:v>
                </c:pt>
                <c:pt idx="31">
                  <c:v>-3.0000000000000001E-3</c:v>
                </c:pt>
                <c:pt idx="32">
                  <c:v>-3.0000000000000001E-3</c:v>
                </c:pt>
                <c:pt idx="33">
                  <c:v>-3.0000000000000001E-3</c:v>
                </c:pt>
                <c:pt idx="34">
                  <c:v>-3.0000000000000001E-3</c:v>
                </c:pt>
                <c:pt idx="35">
                  <c:v>-3.0000000000000001E-3</c:v>
                </c:pt>
                <c:pt idx="36">
                  <c:v>-4.0000000000000001E-3</c:v>
                </c:pt>
                <c:pt idx="37">
                  <c:v>-4.0000000000000001E-3</c:v>
                </c:pt>
                <c:pt idx="38">
                  <c:v>-4.0000000000000001E-3</c:v>
                </c:pt>
                <c:pt idx="39">
                  <c:v>-4.0000000000000001E-3</c:v>
                </c:pt>
                <c:pt idx="40">
                  <c:v>-4.0000000000000001E-3</c:v>
                </c:pt>
                <c:pt idx="41">
                  <c:v>-4.0000000000000001E-3</c:v>
                </c:pt>
                <c:pt idx="42">
                  <c:v>-5.0000000000000001E-3</c:v>
                </c:pt>
                <c:pt idx="43">
                  <c:v>-5.0000000000000001E-3</c:v>
                </c:pt>
                <c:pt idx="44">
                  <c:v>-5.0000000000000001E-3</c:v>
                </c:pt>
                <c:pt idx="45">
                  <c:v>-5.0000000000000001E-3</c:v>
                </c:pt>
                <c:pt idx="46">
                  <c:v>-5.0000000000000001E-3</c:v>
                </c:pt>
                <c:pt idx="47">
                  <c:v>-5.0000000000000001E-3</c:v>
                </c:pt>
                <c:pt idx="48">
                  <c:v>-5.0000000000000001E-3</c:v>
                </c:pt>
                <c:pt idx="49">
                  <c:v>-5.0000000000000001E-3</c:v>
                </c:pt>
                <c:pt idx="50">
                  <c:v>-5.0000000000000001E-3</c:v>
                </c:pt>
                <c:pt idx="51">
                  <c:v>-5.0000000000000001E-3</c:v>
                </c:pt>
                <c:pt idx="52">
                  <c:v>-6.0000000000000001E-3</c:v>
                </c:pt>
                <c:pt idx="53">
                  <c:v>-6.0000000000000001E-3</c:v>
                </c:pt>
                <c:pt idx="54">
                  <c:v>-6.0000000000000001E-3</c:v>
                </c:pt>
                <c:pt idx="55">
                  <c:v>-7.0000000000000001E-3</c:v>
                </c:pt>
                <c:pt idx="56">
                  <c:v>-7.0000000000000001E-3</c:v>
                </c:pt>
                <c:pt idx="57">
                  <c:v>-8.0000000000000002E-3</c:v>
                </c:pt>
                <c:pt idx="58">
                  <c:v>-8.9999999999999993E-3</c:v>
                </c:pt>
                <c:pt idx="59">
                  <c:v>-1.0999999999999999E-2</c:v>
                </c:pt>
                <c:pt idx="60">
                  <c:v>-1.2E-2</c:v>
                </c:pt>
                <c:pt idx="61">
                  <c:v>-1.2999999999999999E-2</c:v>
                </c:pt>
                <c:pt idx="62">
                  <c:v>-1.2999999999999999E-2</c:v>
                </c:pt>
                <c:pt idx="63">
                  <c:v>-1.4E-2</c:v>
                </c:pt>
                <c:pt idx="64">
                  <c:v>-1.4E-2</c:v>
                </c:pt>
                <c:pt idx="65">
                  <c:v>-1.2999999999999999E-2</c:v>
                </c:pt>
                <c:pt idx="66">
                  <c:v>-1.2999999999999999E-2</c:v>
                </c:pt>
                <c:pt idx="67">
                  <c:v>-1.2999999999999999E-2</c:v>
                </c:pt>
                <c:pt idx="68">
                  <c:v>-1.2999999999999999E-2</c:v>
                </c:pt>
                <c:pt idx="69">
                  <c:v>-1.2999999999999999E-2</c:v>
                </c:pt>
                <c:pt idx="70">
                  <c:v>-1.2999999999999999E-2</c:v>
                </c:pt>
                <c:pt idx="71">
                  <c:v>-1.4E-2</c:v>
                </c:pt>
                <c:pt idx="72">
                  <c:v>-1.4E-2</c:v>
                </c:pt>
                <c:pt idx="73">
                  <c:v>-1.4E-2</c:v>
                </c:pt>
                <c:pt idx="74">
                  <c:v>-1.4E-2</c:v>
                </c:pt>
                <c:pt idx="75">
                  <c:v>-1.4E-2</c:v>
                </c:pt>
                <c:pt idx="76">
                  <c:v>-1.4E-2</c:v>
                </c:pt>
                <c:pt idx="77">
                  <c:v>-1.4E-2</c:v>
                </c:pt>
                <c:pt idx="78">
                  <c:v>-1.4E-2</c:v>
                </c:pt>
                <c:pt idx="79">
                  <c:v>-1.4E-2</c:v>
                </c:pt>
                <c:pt idx="80">
                  <c:v>-1.4E-2</c:v>
                </c:pt>
                <c:pt idx="81">
                  <c:v>-1.4E-2</c:v>
                </c:pt>
                <c:pt idx="82">
                  <c:v>-1.4E-2</c:v>
                </c:pt>
                <c:pt idx="83">
                  <c:v>-1.4E-2</c:v>
                </c:pt>
                <c:pt idx="84">
                  <c:v>-1.4E-2</c:v>
                </c:pt>
                <c:pt idx="85">
                  <c:v>-1.4E-2</c:v>
                </c:pt>
                <c:pt idx="86">
                  <c:v>-1.4E-2</c:v>
                </c:pt>
                <c:pt idx="87">
                  <c:v>-1.4E-2</c:v>
                </c:pt>
                <c:pt idx="88">
                  <c:v>-1.4E-2</c:v>
                </c:pt>
                <c:pt idx="89">
                  <c:v>-1.4E-2</c:v>
                </c:pt>
                <c:pt idx="90">
                  <c:v>-1.4E-2</c:v>
                </c:pt>
                <c:pt idx="91">
                  <c:v>-1.4E-2</c:v>
                </c:pt>
                <c:pt idx="92">
                  <c:v>-1.4E-2</c:v>
                </c:pt>
                <c:pt idx="93">
                  <c:v>-1.4E-2</c:v>
                </c:pt>
                <c:pt idx="94">
                  <c:v>-1.4E-2</c:v>
                </c:pt>
                <c:pt idx="95">
                  <c:v>-1.4E-2</c:v>
                </c:pt>
                <c:pt idx="96">
                  <c:v>-1.4E-2</c:v>
                </c:pt>
                <c:pt idx="97">
                  <c:v>-1.4E-2</c:v>
                </c:pt>
                <c:pt idx="98">
                  <c:v>-1.2999999999999999E-2</c:v>
                </c:pt>
                <c:pt idx="99">
                  <c:v>-1.2999999999999999E-2</c:v>
                </c:pt>
                <c:pt idx="100">
                  <c:v>-1.2E-2</c:v>
                </c:pt>
                <c:pt idx="101">
                  <c:v>-1.2E-2</c:v>
                </c:pt>
                <c:pt idx="102">
                  <c:v>-1.0999999999999999E-2</c:v>
                </c:pt>
                <c:pt idx="103">
                  <c:v>-1.0999999999999999E-2</c:v>
                </c:pt>
                <c:pt idx="104">
                  <c:v>-0.01</c:v>
                </c:pt>
                <c:pt idx="105">
                  <c:v>-8.9999999999999993E-3</c:v>
                </c:pt>
                <c:pt idx="106">
                  <c:v>-8.0000000000000002E-3</c:v>
                </c:pt>
                <c:pt idx="107">
                  <c:v>-6.0000000000000001E-3</c:v>
                </c:pt>
                <c:pt idx="108">
                  <c:v>-4.0000000000000001E-3</c:v>
                </c:pt>
                <c:pt idx="109">
                  <c:v>-2E-3</c:v>
                </c:pt>
                <c:pt idx="110">
                  <c:v>1E-3</c:v>
                </c:pt>
                <c:pt idx="111">
                  <c:v>4.0000000000000001E-3</c:v>
                </c:pt>
                <c:pt idx="112">
                  <c:v>8.0000000000000002E-3</c:v>
                </c:pt>
                <c:pt idx="113">
                  <c:v>1.2999999999999999E-2</c:v>
                </c:pt>
                <c:pt idx="114">
                  <c:v>1.7999999999999999E-2</c:v>
                </c:pt>
                <c:pt idx="115">
                  <c:v>2.5000000000000001E-2</c:v>
                </c:pt>
                <c:pt idx="116">
                  <c:v>3.4000000000000002E-2</c:v>
                </c:pt>
                <c:pt idx="117">
                  <c:v>4.3999999999999997E-2</c:v>
                </c:pt>
                <c:pt idx="118">
                  <c:v>5.5E-2</c:v>
                </c:pt>
                <c:pt idx="119">
                  <c:v>6.8000000000000005E-2</c:v>
                </c:pt>
                <c:pt idx="120">
                  <c:v>8.2000000000000003E-2</c:v>
                </c:pt>
                <c:pt idx="121">
                  <c:v>9.8000000000000004E-2</c:v>
                </c:pt>
                <c:pt idx="122">
                  <c:v>0.11600000000000001</c:v>
                </c:pt>
                <c:pt idx="123">
                  <c:v>0.13500000000000001</c:v>
                </c:pt>
                <c:pt idx="124">
                  <c:v>0.156</c:v>
                </c:pt>
                <c:pt idx="125">
                  <c:v>0.17799999999999999</c:v>
                </c:pt>
                <c:pt idx="126">
                  <c:v>0.2</c:v>
                </c:pt>
                <c:pt idx="127">
                  <c:v>0.223</c:v>
                </c:pt>
                <c:pt idx="128">
                  <c:v>0.246</c:v>
                </c:pt>
                <c:pt idx="129">
                  <c:v>0.26900000000000002</c:v>
                </c:pt>
                <c:pt idx="130">
                  <c:v>0.28999999999999998</c:v>
                </c:pt>
                <c:pt idx="131">
                  <c:v>0.309</c:v>
                </c:pt>
                <c:pt idx="132">
                  <c:v>0.32500000000000001</c:v>
                </c:pt>
                <c:pt idx="133">
                  <c:v>0.33900000000000002</c:v>
                </c:pt>
                <c:pt idx="134">
                  <c:v>0.34699999999999998</c:v>
                </c:pt>
                <c:pt idx="135">
                  <c:v>0.35199999999999998</c:v>
                </c:pt>
                <c:pt idx="136">
                  <c:v>0.35299999999999998</c:v>
                </c:pt>
                <c:pt idx="137">
                  <c:v>0.35</c:v>
                </c:pt>
                <c:pt idx="138">
                  <c:v>0.34300000000000003</c:v>
                </c:pt>
                <c:pt idx="139">
                  <c:v>0.33200000000000002</c:v>
                </c:pt>
                <c:pt idx="140">
                  <c:v>0.32</c:v>
                </c:pt>
                <c:pt idx="141">
                  <c:v>0.30499999999999999</c:v>
                </c:pt>
                <c:pt idx="142">
                  <c:v>0.28899999999999998</c:v>
                </c:pt>
                <c:pt idx="143">
                  <c:v>0.27200000000000002</c:v>
                </c:pt>
                <c:pt idx="144">
                  <c:v>0.255</c:v>
                </c:pt>
                <c:pt idx="145">
                  <c:v>0.23899999999999999</c:v>
                </c:pt>
                <c:pt idx="146">
                  <c:v>0.222</c:v>
                </c:pt>
                <c:pt idx="147">
                  <c:v>0.20699999999999999</c:v>
                </c:pt>
                <c:pt idx="148">
                  <c:v>0.191</c:v>
                </c:pt>
                <c:pt idx="149">
                  <c:v>0.17799999999999999</c:v>
                </c:pt>
                <c:pt idx="150">
                  <c:v>0.16600000000000001</c:v>
                </c:pt>
                <c:pt idx="151">
                  <c:v>0.154</c:v>
                </c:pt>
                <c:pt idx="152">
                  <c:v>0.14399999999999999</c:v>
                </c:pt>
                <c:pt idx="153">
                  <c:v>0.13500000000000001</c:v>
                </c:pt>
                <c:pt idx="154">
                  <c:v>0.127</c:v>
                </c:pt>
                <c:pt idx="155">
                  <c:v>0.12</c:v>
                </c:pt>
                <c:pt idx="156">
                  <c:v>0.114</c:v>
                </c:pt>
                <c:pt idx="157">
                  <c:v>0.108</c:v>
                </c:pt>
                <c:pt idx="158">
                  <c:v>0.10299999999999999</c:v>
                </c:pt>
                <c:pt idx="159">
                  <c:v>9.8000000000000004E-2</c:v>
                </c:pt>
                <c:pt idx="160">
                  <c:v>9.4E-2</c:v>
                </c:pt>
                <c:pt idx="161">
                  <c:v>9.0999999999999998E-2</c:v>
                </c:pt>
                <c:pt idx="162">
                  <c:v>8.7999999999999995E-2</c:v>
                </c:pt>
                <c:pt idx="163">
                  <c:v>8.5000000000000006E-2</c:v>
                </c:pt>
                <c:pt idx="164">
                  <c:v>8.2000000000000003E-2</c:v>
                </c:pt>
                <c:pt idx="165">
                  <c:v>0.08</c:v>
                </c:pt>
                <c:pt idx="166">
                  <c:v>7.8E-2</c:v>
                </c:pt>
                <c:pt idx="167">
                  <c:v>7.5999999999999998E-2</c:v>
                </c:pt>
                <c:pt idx="168">
                  <c:v>7.4999999999999997E-2</c:v>
                </c:pt>
                <c:pt idx="169">
                  <c:v>7.3999999999999996E-2</c:v>
                </c:pt>
                <c:pt idx="170">
                  <c:v>7.2999999999999995E-2</c:v>
                </c:pt>
                <c:pt idx="171">
                  <c:v>7.1999999999999995E-2</c:v>
                </c:pt>
                <c:pt idx="172">
                  <c:v>7.1999999999999995E-2</c:v>
                </c:pt>
                <c:pt idx="173">
                  <c:v>7.1999999999999995E-2</c:v>
                </c:pt>
                <c:pt idx="174">
                  <c:v>7.1999999999999995E-2</c:v>
                </c:pt>
                <c:pt idx="175">
                  <c:v>7.1999999999999995E-2</c:v>
                </c:pt>
                <c:pt idx="176">
                  <c:v>7.1999999999999995E-2</c:v>
                </c:pt>
                <c:pt idx="177">
                  <c:v>7.1999999999999995E-2</c:v>
                </c:pt>
                <c:pt idx="178">
                  <c:v>7.2999999999999995E-2</c:v>
                </c:pt>
                <c:pt idx="179">
                  <c:v>7.2999999999999995E-2</c:v>
                </c:pt>
                <c:pt idx="180">
                  <c:v>7.3999999999999996E-2</c:v>
                </c:pt>
                <c:pt idx="181">
                  <c:v>7.3999999999999996E-2</c:v>
                </c:pt>
                <c:pt idx="182">
                  <c:v>7.3999999999999996E-2</c:v>
                </c:pt>
                <c:pt idx="183">
                  <c:v>7.3999999999999996E-2</c:v>
                </c:pt>
                <c:pt idx="184">
                  <c:v>7.3999999999999996E-2</c:v>
                </c:pt>
                <c:pt idx="185">
                  <c:v>7.3999999999999996E-2</c:v>
                </c:pt>
                <c:pt idx="186">
                  <c:v>7.3999999999999996E-2</c:v>
                </c:pt>
                <c:pt idx="187">
                  <c:v>7.2999999999999995E-2</c:v>
                </c:pt>
                <c:pt idx="188">
                  <c:v>7.2999999999999995E-2</c:v>
                </c:pt>
                <c:pt idx="189">
                  <c:v>7.1999999999999995E-2</c:v>
                </c:pt>
                <c:pt idx="190">
                  <c:v>7.0000000000000007E-2</c:v>
                </c:pt>
                <c:pt idx="191">
                  <c:v>6.9000000000000006E-2</c:v>
                </c:pt>
                <c:pt idx="192">
                  <c:v>6.7000000000000004E-2</c:v>
                </c:pt>
                <c:pt idx="193">
                  <c:v>6.6000000000000003E-2</c:v>
                </c:pt>
                <c:pt idx="194">
                  <c:v>6.4000000000000001E-2</c:v>
                </c:pt>
                <c:pt idx="195">
                  <c:v>6.2E-2</c:v>
                </c:pt>
                <c:pt idx="196">
                  <c:v>0.06</c:v>
                </c:pt>
                <c:pt idx="197">
                  <c:v>5.8000000000000003E-2</c:v>
                </c:pt>
                <c:pt idx="198">
                  <c:v>5.6000000000000001E-2</c:v>
                </c:pt>
                <c:pt idx="199">
                  <c:v>5.3999999999999999E-2</c:v>
                </c:pt>
                <c:pt idx="200">
                  <c:v>5.1999999999999998E-2</c:v>
                </c:pt>
                <c:pt idx="201">
                  <c:v>4.9000000000000002E-2</c:v>
                </c:pt>
                <c:pt idx="202">
                  <c:v>4.7E-2</c:v>
                </c:pt>
                <c:pt idx="203">
                  <c:v>4.4999999999999998E-2</c:v>
                </c:pt>
                <c:pt idx="204">
                  <c:v>4.3999999999999997E-2</c:v>
                </c:pt>
                <c:pt idx="205">
                  <c:v>4.2000000000000003E-2</c:v>
                </c:pt>
                <c:pt idx="206">
                  <c:v>0.04</c:v>
                </c:pt>
                <c:pt idx="207">
                  <c:v>3.9E-2</c:v>
                </c:pt>
                <c:pt idx="208">
                  <c:v>3.7999999999999999E-2</c:v>
                </c:pt>
                <c:pt idx="209">
                  <c:v>3.6999999999999998E-2</c:v>
                </c:pt>
                <c:pt idx="210">
                  <c:v>3.5000000000000003E-2</c:v>
                </c:pt>
                <c:pt idx="211">
                  <c:v>3.4000000000000002E-2</c:v>
                </c:pt>
                <c:pt idx="212">
                  <c:v>3.3000000000000002E-2</c:v>
                </c:pt>
                <c:pt idx="213">
                  <c:v>3.2000000000000001E-2</c:v>
                </c:pt>
                <c:pt idx="214">
                  <c:v>0.03</c:v>
                </c:pt>
                <c:pt idx="215">
                  <c:v>2.9000000000000001E-2</c:v>
                </c:pt>
                <c:pt idx="216">
                  <c:v>2.7E-2</c:v>
                </c:pt>
                <c:pt idx="217">
                  <c:v>2.5999999999999999E-2</c:v>
                </c:pt>
                <c:pt idx="218">
                  <c:v>2.5000000000000001E-2</c:v>
                </c:pt>
                <c:pt idx="219">
                  <c:v>2.3E-2</c:v>
                </c:pt>
                <c:pt idx="220">
                  <c:v>2.1999999999999999E-2</c:v>
                </c:pt>
                <c:pt idx="221">
                  <c:v>2.1000000000000001E-2</c:v>
                </c:pt>
                <c:pt idx="222">
                  <c:v>0.02</c:v>
                </c:pt>
                <c:pt idx="223">
                  <c:v>1.9E-2</c:v>
                </c:pt>
                <c:pt idx="224">
                  <c:v>1.9E-2</c:v>
                </c:pt>
                <c:pt idx="225">
                  <c:v>1.7999999999999999E-2</c:v>
                </c:pt>
                <c:pt idx="226">
                  <c:v>1.7000000000000001E-2</c:v>
                </c:pt>
                <c:pt idx="227">
                  <c:v>1.7000000000000001E-2</c:v>
                </c:pt>
                <c:pt idx="228">
                  <c:v>1.6E-2</c:v>
                </c:pt>
                <c:pt idx="229">
                  <c:v>1.4999999999999999E-2</c:v>
                </c:pt>
                <c:pt idx="230">
                  <c:v>1.4E-2</c:v>
                </c:pt>
                <c:pt idx="231">
                  <c:v>1.4E-2</c:v>
                </c:pt>
                <c:pt idx="232">
                  <c:v>1.2999999999999999E-2</c:v>
                </c:pt>
                <c:pt idx="233">
                  <c:v>1.2E-2</c:v>
                </c:pt>
                <c:pt idx="234">
                  <c:v>1.0999999999999999E-2</c:v>
                </c:pt>
                <c:pt idx="235">
                  <c:v>0.01</c:v>
                </c:pt>
                <c:pt idx="236">
                  <c:v>8.9999999999999993E-3</c:v>
                </c:pt>
                <c:pt idx="237">
                  <c:v>8.9999999999999993E-3</c:v>
                </c:pt>
                <c:pt idx="238">
                  <c:v>8.0000000000000002E-3</c:v>
                </c:pt>
                <c:pt idx="239">
                  <c:v>7.0000000000000001E-3</c:v>
                </c:pt>
                <c:pt idx="240">
                  <c:v>6.0000000000000001E-3</c:v>
                </c:pt>
                <c:pt idx="241">
                  <c:v>6.0000000000000001E-3</c:v>
                </c:pt>
                <c:pt idx="242">
                  <c:v>5.0000000000000001E-3</c:v>
                </c:pt>
                <c:pt idx="243">
                  <c:v>5.0000000000000001E-3</c:v>
                </c:pt>
                <c:pt idx="244">
                  <c:v>4.0000000000000001E-3</c:v>
                </c:pt>
                <c:pt idx="245">
                  <c:v>4.0000000000000001E-3</c:v>
                </c:pt>
                <c:pt idx="246">
                  <c:v>3.0000000000000001E-3</c:v>
                </c:pt>
                <c:pt idx="247">
                  <c:v>3.0000000000000001E-3</c:v>
                </c:pt>
                <c:pt idx="248">
                  <c:v>2E-3</c:v>
                </c:pt>
                <c:pt idx="249">
                  <c:v>2E-3</c:v>
                </c:pt>
                <c:pt idx="250">
                  <c:v>2E-3</c:v>
                </c:pt>
                <c:pt idx="251">
                  <c:v>1E-3</c:v>
                </c:pt>
                <c:pt idx="252">
                  <c:v>1E-3</c:v>
                </c:pt>
                <c:pt idx="253">
                  <c:v>1E-3</c:v>
                </c:pt>
                <c:pt idx="254">
                  <c:v>1E-3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-1E-3</c:v>
                </c:pt>
                <c:pt idx="261">
                  <c:v>-1E-3</c:v>
                </c:pt>
                <c:pt idx="262">
                  <c:v>-1E-3</c:v>
                </c:pt>
                <c:pt idx="263">
                  <c:v>-1E-3</c:v>
                </c:pt>
                <c:pt idx="264">
                  <c:v>-2E-3</c:v>
                </c:pt>
                <c:pt idx="265">
                  <c:v>-2E-3</c:v>
                </c:pt>
                <c:pt idx="266">
                  <c:v>-2E-3</c:v>
                </c:pt>
                <c:pt idx="267">
                  <c:v>-2E-3</c:v>
                </c:pt>
                <c:pt idx="268">
                  <c:v>-3.0000000000000001E-3</c:v>
                </c:pt>
                <c:pt idx="269">
                  <c:v>-3.0000000000000001E-3</c:v>
                </c:pt>
                <c:pt idx="270">
                  <c:v>-3.0000000000000001E-3</c:v>
                </c:pt>
                <c:pt idx="271">
                  <c:v>-3.0000000000000001E-3</c:v>
                </c:pt>
                <c:pt idx="272">
                  <c:v>-4.0000000000000001E-3</c:v>
                </c:pt>
                <c:pt idx="273">
                  <c:v>-4.0000000000000001E-3</c:v>
                </c:pt>
                <c:pt idx="274">
                  <c:v>-4.0000000000000001E-3</c:v>
                </c:pt>
                <c:pt idx="275">
                  <c:v>-4.0000000000000001E-3</c:v>
                </c:pt>
                <c:pt idx="276">
                  <c:v>-4.0000000000000001E-3</c:v>
                </c:pt>
                <c:pt idx="277">
                  <c:v>-4.0000000000000001E-3</c:v>
                </c:pt>
                <c:pt idx="278">
                  <c:v>-4.0000000000000001E-3</c:v>
                </c:pt>
                <c:pt idx="279">
                  <c:v>-5.0000000000000001E-3</c:v>
                </c:pt>
                <c:pt idx="280">
                  <c:v>-5.0000000000000001E-3</c:v>
                </c:pt>
                <c:pt idx="281">
                  <c:v>-5.0000000000000001E-3</c:v>
                </c:pt>
                <c:pt idx="282">
                  <c:v>-4.0000000000000001E-3</c:v>
                </c:pt>
                <c:pt idx="283">
                  <c:v>-4.0000000000000001E-3</c:v>
                </c:pt>
                <c:pt idx="284">
                  <c:v>-4.0000000000000001E-3</c:v>
                </c:pt>
                <c:pt idx="285">
                  <c:v>-4.0000000000000001E-3</c:v>
                </c:pt>
                <c:pt idx="286">
                  <c:v>-4.0000000000000001E-3</c:v>
                </c:pt>
                <c:pt idx="287">
                  <c:v>-4.0000000000000001E-3</c:v>
                </c:pt>
                <c:pt idx="288">
                  <c:v>-3.0000000000000001E-3</c:v>
                </c:pt>
                <c:pt idx="289">
                  <c:v>-3.0000000000000001E-3</c:v>
                </c:pt>
                <c:pt idx="290">
                  <c:v>-2E-3</c:v>
                </c:pt>
                <c:pt idx="291">
                  <c:v>-1E-3</c:v>
                </c:pt>
                <c:pt idx="292">
                  <c:v>1E-3</c:v>
                </c:pt>
                <c:pt idx="293">
                  <c:v>2E-3</c:v>
                </c:pt>
                <c:pt idx="294">
                  <c:v>4.0000000000000001E-3</c:v>
                </c:pt>
                <c:pt idx="295">
                  <c:v>7.0000000000000001E-3</c:v>
                </c:pt>
                <c:pt idx="296">
                  <c:v>8.9999999999999993E-3</c:v>
                </c:pt>
                <c:pt idx="297">
                  <c:v>1.2E-2</c:v>
                </c:pt>
                <c:pt idx="298">
                  <c:v>1.6E-2</c:v>
                </c:pt>
                <c:pt idx="299">
                  <c:v>0.02</c:v>
                </c:pt>
                <c:pt idx="300">
                  <c:v>2.4E-2</c:v>
                </c:pt>
                <c:pt idx="301">
                  <c:v>2.9000000000000001E-2</c:v>
                </c:pt>
                <c:pt idx="302">
                  <c:v>3.4000000000000002E-2</c:v>
                </c:pt>
                <c:pt idx="303">
                  <c:v>0.04</c:v>
                </c:pt>
                <c:pt idx="304">
                  <c:v>4.7E-2</c:v>
                </c:pt>
                <c:pt idx="305">
                  <c:v>5.3999999999999999E-2</c:v>
                </c:pt>
                <c:pt idx="306">
                  <c:v>6.3E-2</c:v>
                </c:pt>
                <c:pt idx="307">
                  <c:v>7.1999999999999995E-2</c:v>
                </c:pt>
                <c:pt idx="308">
                  <c:v>8.2000000000000003E-2</c:v>
                </c:pt>
                <c:pt idx="309">
                  <c:v>9.2999999999999999E-2</c:v>
                </c:pt>
                <c:pt idx="310">
                  <c:v>0.105</c:v>
                </c:pt>
                <c:pt idx="311">
                  <c:v>0.11799999999999999</c:v>
                </c:pt>
                <c:pt idx="312">
                  <c:v>0.13200000000000001</c:v>
                </c:pt>
                <c:pt idx="313">
                  <c:v>0.14699999999999999</c:v>
                </c:pt>
                <c:pt idx="314">
                  <c:v>0.16300000000000001</c:v>
                </c:pt>
                <c:pt idx="315">
                  <c:v>0.18</c:v>
                </c:pt>
                <c:pt idx="316">
                  <c:v>0.19700000000000001</c:v>
                </c:pt>
                <c:pt idx="317">
                  <c:v>0.215</c:v>
                </c:pt>
                <c:pt idx="318">
                  <c:v>0.23400000000000001</c:v>
                </c:pt>
                <c:pt idx="319">
                  <c:v>0.253</c:v>
                </c:pt>
                <c:pt idx="320">
                  <c:v>0.27200000000000002</c:v>
                </c:pt>
                <c:pt idx="321">
                  <c:v>0.29199999999999998</c:v>
                </c:pt>
                <c:pt idx="322">
                  <c:v>0.311</c:v>
                </c:pt>
                <c:pt idx="323">
                  <c:v>0.33</c:v>
                </c:pt>
                <c:pt idx="324">
                  <c:v>0.34899999999999998</c:v>
                </c:pt>
                <c:pt idx="325">
                  <c:v>0.36699999999999999</c:v>
                </c:pt>
                <c:pt idx="326">
                  <c:v>0.38500000000000001</c:v>
                </c:pt>
                <c:pt idx="327">
                  <c:v>0.40100000000000002</c:v>
                </c:pt>
                <c:pt idx="328">
                  <c:v>0.41499999999999998</c:v>
                </c:pt>
                <c:pt idx="329">
                  <c:v>0.42699999999999999</c:v>
                </c:pt>
                <c:pt idx="330">
                  <c:v>0.436</c:v>
                </c:pt>
                <c:pt idx="331">
                  <c:v>0.443</c:v>
                </c:pt>
                <c:pt idx="332">
                  <c:v>0.44700000000000001</c:v>
                </c:pt>
                <c:pt idx="333">
                  <c:v>0.44800000000000001</c:v>
                </c:pt>
                <c:pt idx="334">
                  <c:v>0.44500000000000001</c:v>
                </c:pt>
                <c:pt idx="335">
                  <c:v>0.441</c:v>
                </c:pt>
                <c:pt idx="336">
                  <c:v>0.434</c:v>
                </c:pt>
                <c:pt idx="337">
                  <c:v>0.42699999999999999</c:v>
                </c:pt>
                <c:pt idx="338">
                  <c:v>0.41799999999999998</c:v>
                </c:pt>
                <c:pt idx="339">
                  <c:v>0.41</c:v>
                </c:pt>
                <c:pt idx="340">
                  <c:v>0.40300000000000002</c:v>
                </c:pt>
                <c:pt idx="341">
                  <c:v>0.39800000000000002</c:v>
                </c:pt>
                <c:pt idx="342">
                  <c:v>0.39400000000000002</c:v>
                </c:pt>
                <c:pt idx="343">
                  <c:v>0.39300000000000002</c:v>
                </c:pt>
                <c:pt idx="344">
                  <c:v>0.39500000000000002</c:v>
                </c:pt>
                <c:pt idx="345">
                  <c:v>0.39900000000000002</c:v>
                </c:pt>
                <c:pt idx="346">
                  <c:v>0.40600000000000003</c:v>
                </c:pt>
                <c:pt idx="347">
                  <c:v>0.41599999999999998</c:v>
                </c:pt>
                <c:pt idx="348">
                  <c:v>0.42899999999999999</c:v>
                </c:pt>
                <c:pt idx="349">
                  <c:v>0.44400000000000001</c:v>
                </c:pt>
                <c:pt idx="350">
                  <c:v>0.46200000000000002</c:v>
                </c:pt>
                <c:pt idx="351">
                  <c:v>0.48199999999999998</c:v>
                </c:pt>
                <c:pt idx="352">
                  <c:v>0.505</c:v>
                </c:pt>
                <c:pt idx="353">
                  <c:v>0.52700000000000002</c:v>
                </c:pt>
                <c:pt idx="354">
                  <c:v>0.55000000000000004</c:v>
                </c:pt>
                <c:pt idx="355">
                  <c:v>0.57199999999999995</c:v>
                </c:pt>
                <c:pt idx="356">
                  <c:v>0.59299999999999997</c:v>
                </c:pt>
                <c:pt idx="357">
                  <c:v>0.61399999999999999</c:v>
                </c:pt>
                <c:pt idx="358">
                  <c:v>0.63200000000000001</c:v>
                </c:pt>
                <c:pt idx="359">
                  <c:v>0.64800000000000002</c:v>
                </c:pt>
                <c:pt idx="360">
                  <c:v>0.66200000000000003</c:v>
                </c:pt>
                <c:pt idx="361">
                  <c:v>0.67300000000000004</c:v>
                </c:pt>
                <c:pt idx="362">
                  <c:v>0.68100000000000005</c:v>
                </c:pt>
                <c:pt idx="363">
                  <c:v>0.68600000000000005</c:v>
                </c:pt>
                <c:pt idx="364">
                  <c:v>0.68700000000000006</c:v>
                </c:pt>
                <c:pt idx="365">
                  <c:v>0.68600000000000005</c:v>
                </c:pt>
                <c:pt idx="366">
                  <c:v>0.68200000000000005</c:v>
                </c:pt>
                <c:pt idx="367">
                  <c:v>0.67500000000000004</c:v>
                </c:pt>
                <c:pt idx="368">
                  <c:v>0.66600000000000004</c:v>
                </c:pt>
                <c:pt idx="369">
                  <c:v>0.65500000000000003</c:v>
                </c:pt>
                <c:pt idx="370">
                  <c:v>0.64300000000000002</c:v>
                </c:pt>
                <c:pt idx="371">
                  <c:v>0.63100000000000001</c:v>
                </c:pt>
                <c:pt idx="372">
                  <c:v>0.61899999999999999</c:v>
                </c:pt>
                <c:pt idx="373">
                  <c:v>0.60899999999999999</c:v>
                </c:pt>
                <c:pt idx="374">
                  <c:v>0.6</c:v>
                </c:pt>
                <c:pt idx="375">
                  <c:v>0.59199999999999997</c:v>
                </c:pt>
                <c:pt idx="376">
                  <c:v>0.58699999999999997</c:v>
                </c:pt>
                <c:pt idx="377">
                  <c:v>0.58299999999999996</c:v>
                </c:pt>
                <c:pt idx="378">
                  <c:v>0.58099999999999996</c:v>
                </c:pt>
                <c:pt idx="379">
                  <c:v>0.57899999999999996</c:v>
                </c:pt>
                <c:pt idx="380">
                  <c:v>0.57899999999999996</c:v>
                </c:pt>
                <c:pt idx="381">
                  <c:v>0.57999999999999996</c:v>
                </c:pt>
                <c:pt idx="382">
                  <c:v>0.57999999999999996</c:v>
                </c:pt>
                <c:pt idx="383">
                  <c:v>0.58099999999999996</c:v>
                </c:pt>
                <c:pt idx="384">
                  <c:v>0.58099999999999996</c:v>
                </c:pt>
                <c:pt idx="385">
                  <c:v>0.57999999999999996</c:v>
                </c:pt>
                <c:pt idx="386">
                  <c:v>0.57899999999999996</c:v>
                </c:pt>
                <c:pt idx="387">
                  <c:v>0.57599999999999996</c:v>
                </c:pt>
                <c:pt idx="388">
                  <c:v>0.57199999999999995</c:v>
                </c:pt>
                <c:pt idx="389">
                  <c:v>0.56699999999999995</c:v>
                </c:pt>
                <c:pt idx="390">
                  <c:v>0.56100000000000005</c:v>
                </c:pt>
                <c:pt idx="391">
                  <c:v>0.55400000000000005</c:v>
                </c:pt>
                <c:pt idx="392">
                  <c:v>0.54700000000000004</c:v>
                </c:pt>
                <c:pt idx="393">
                  <c:v>0.53900000000000003</c:v>
                </c:pt>
                <c:pt idx="394">
                  <c:v>0.53200000000000003</c:v>
                </c:pt>
                <c:pt idx="395">
                  <c:v>0.52500000000000002</c:v>
                </c:pt>
                <c:pt idx="396">
                  <c:v>0.51800000000000002</c:v>
                </c:pt>
                <c:pt idx="397">
                  <c:v>0.51300000000000001</c:v>
                </c:pt>
                <c:pt idx="398">
                  <c:v>0.50800000000000001</c:v>
                </c:pt>
                <c:pt idx="399">
                  <c:v>0.505</c:v>
                </c:pt>
                <c:pt idx="400">
                  <c:v>0.504</c:v>
                </c:pt>
                <c:pt idx="401">
                  <c:v>0.504</c:v>
                </c:pt>
                <c:pt idx="402">
                  <c:v>0.505</c:v>
                </c:pt>
                <c:pt idx="403">
                  <c:v>0.50800000000000001</c:v>
                </c:pt>
                <c:pt idx="404">
                  <c:v>0.51200000000000001</c:v>
                </c:pt>
                <c:pt idx="405">
                  <c:v>0.51700000000000002</c:v>
                </c:pt>
                <c:pt idx="406">
                  <c:v>0.52300000000000002</c:v>
                </c:pt>
                <c:pt idx="407">
                  <c:v>0.52900000000000003</c:v>
                </c:pt>
                <c:pt idx="408">
                  <c:v>0.53600000000000003</c:v>
                </c:pt>
                <c:pt idx="409">
                  <c:v>0.54300000000000004</c:v>
                </c:pt>
                <c:pt idx="410">
                  <c:v>0.55000000000000004</c:v>
                </c:pt>
                <c:pt idx="411">
                  <c:v>0.55800000000000005</c:v>
                </c:pt>
                <c:pt idx="412">
                  <c:v>0.56499999999999995</c:v>
                </c:pt>
                <c:pt idx="413">
                  <c:v>0.57199999999999995</c:v>
                </c:pt>
                <c:pt idx="414">
                  <c:v>0.57999999999999996</c:v>
                </c:pt>
                <c:pt idx="415">
                  <c:v>0.58699999999999997</c:v>
                </c:pt>
                <c:pt idx="416">
                  <c:v>0.59399999999999997</c:v>
                </c:pt>
                <c:pt idx="417">
                  <c:v>0.60099999999999998</c:v>
                </c:pt>
                <c:pt idx="418">
                  <c:v>0.60699999999999998</c:v>
                </c:pt>
                <c:pt idx="419">
                  <c:v>0.61299999999999999</c:v>
                </c:pt>
                <c:pt idx="420">
                  <c:v>0.61899999999999999</c:v>
                </c:pt>
                <c:pt idx="421">
                  <c:v>0.626</c:v>
                </c:pt>
                <c:pt idx="422">
                  <c:v>0.64600000000000002</c:v>
                </c:pt>
                <c:pt idx="423">
                  <c:v>0.65200000000000002</c:v>
                </c:pt>
                <c:pt idx="424">
                  <c:v>0.65800000000000003</c:v>
                </c:pt>
                <c:pt idx="425">
                  <c:v>0.66300000000000003</c:v>
                </c:pt>
                <c:pt idx="426">
                  <c:v>0.67</c:v>
                </c:pt>
                <c:pt idx="427">
                  <c:v>0.67500000000000004</c:v>
                </c:pt>
                <c:pt idx="428">
                  <c:v>0.67900000000000005</c:v>
                </c:pt>
                <c:pt idx="429">
                  <c:v>0.68500000000000005</c:v>
                </c:pt>
                <c:pt idx="430">
                  <c:v>0.68899999999999995</c:v>
                </c:pt>
                <c:pt idx="431">
                  <c:v>0.69299999999999995</c:v>
                </c:pt>
                <c:pt idx="432">
                  <c:v>0.69799999999999995</c:v>
                </c:pt>
                <c:pt idx="433">
                  <c:v>0.70199999999999996</c:v>
                </c:pt>
                <c:pt idx="434">
                  <c:v>0.70599999999999996</c:v>
                </c:pt>
                <c:pt idx="435">
                  <c:v>0.71</c:v>
                </c:pt>
                <c:pt idx="436">
                  <c:v>0.71199999999999997</c:v>
                </c:pt>
                <c:pt idx="437">
                  <c:v>0.71499999999999997</c:v>
                </c:pt>
                <c:pt idx="438">
                  <c:v>0.71899999999999997</c:v>
                </c:pt>
                <c:pt idx="439">
                  <c:v>0.72199999999999998</c:v>
                </c:pt>
                <c:pt idx="440">
                  <c:v>0.72499999999999998</c:v>
                </c:pt>
                <c:pt idx="441">
                  <c:v>0.72799999999999998</c:v>
                </c:pt>
                <c:pt idx="442">
                  <c:v>0.73099999999999998</c:v>
                </c:pt>
                <c:pt idx="443">
                  <c:v>0.73299999999999998</c:v>
                </c:pt>
                <c:pt idx="444">
                  <c:v>0.73699999999999999</c:v>
                </c:pt>
                <c:pt idx="445">
                  <c:v>0.74099999999999999</c:v>
                </c:pt>
                <c:pt idx="446">
                  <c:v>0.74399999999999999</c:v>
                </c:pt>
                <c:pt idx="447">
                  <c:v>0.747</c:v>
                </c:pt>
                <c:pt idx="448">
                  <c:v>0.752</c:v>
                </c:pt>
                <c:pt idx="449">
                  <c:v>0.75700000000000001</c:v>
                </c:pt>
                <c:pt idx="450">
                  <c:v>0.76200000000000001</c:v>
                </c:pt>
                <c:pt idx="451">
                  <c:v>0.76800000000000002</c:v>
                </c:pt>
                <c:pt idx="452">
                  <c:v>0.77300000000000002</c:v>
                </c:pt>
                <c:pt idx="453">
                  <c:v>0.78</c:v>
                </c:pt>
                <c:pt idx="454">
                  <c:v>0.78700000000000003</c:v>
                </c:pt>
                <c:pt idx="455">
                  <c:v>0.79300000000000004</c:v>
                </c:pt>
                <c:pt idx="456">
                  <c:v>0.8</c:v>
                </c:pt>
                <c:pt idx="457">
                  <c:v>0.80900000000000005</c:v>
                </c:pt>
                <c:pt idx="458">
                  <c:v>0.81399999999999995</c:v>
                </c:pt>
                <c:pt idx="459">
                  <c:v>0.82099999999999995</c:v>
                </c:pt>
                <c:pt idx="460">
                  <c:v>0.82699999999999996</c:v>
                </c:pt>
                <c:pt idx="461">
                  <c:v>0.82599999999999996</c:v>
                </c:pt>
                <c:pt idx="462">
                  <c:v>0.82799999999999996</c:v>
                </c:pt>
                <c:pt idx="463">
                  <c:v>0.83299999999999996</c:v>
                </c:pt>
                <c:pt idx="464">
                  <c:v>0.83899999999999997</c:v>
                </c:pt>
                <c:pt idx="465">
                  <c:v>0.84199999999999997</c:v>
                </c:pt>
                <c:pt idx="466">
                  <c:v>0.84599999999999997</c:v>
                </c:pt>
                <c:pt idx="467">
                  <c:v>0.85</c:v>
                </c:pt>
                <c:pt idx="468">
                  <c:v>0.85299999999999998</c:v>
                </c:pt>
                <c:pt idx="469">
                  <c:v>0.85699999999999998</c:v>
                </c:pt>
                <c:pt idx="470">
                  <c:v>0.86099999999999999</c:v>
                </c:pt>
                <c:pt idx="471">
                  <c:v>0.86399999999999999</c:v>
                </c:pt>
                <c:pt idx="472">
                  <c:v>0.86599999999999999</c:v>
                </c:pt>
                <c:pt idx="473">
                  <c:v>0.86899999999999999</c:v>
                </c:pt>
                <c:pt idx="474">
                  <c:v>0.87</c:v>
                </c:pt>
                <c:pt idx="475">
                  <c:v>0.86899999999999999</c:v>
                </c:pt>
                <c:pt idx="476">
                  <c:v>0.86899999999999999</c:v>
                </c:pt>
                <c:pt idx="477">
                  <c:v>0.86799999999999999</c:v>
                </c:pt>
                <c:pt idx="478">
                  <c:v>0.86699999999999999</c:v>
                </c:pt>
                <c:pt idx="479">
                  <c:v>0.86599999999999999</c:v>
                </c:pt>
                <c:pt idx="480">
                  <c:v>0.86499999999999999</c:v>
                </c:pt>
                <c:pt idx="481">
                  <c:v>0.86299999999999999</c:v>
                </c:pt>
                <c:pt idx="482">
                  <c:v>0.86099999999999999</c:v>
                </c:pt>
                <c:pt idx="483">
                  <c:v>0.85899999999999999</c:v>
                </c:pt>
                <c:pt idx="484">
                  <c:v>0.85699999999999998</c:v>
                </c:pt>
                <c:pt idx="485">
                  <c:v>0.85199999999999998</c:v>
                </c:pt>
                <c:pt idx="486">
                  <c:v>0.84899999999999998</c:v>
                </c:pt>
                <c:pt idx="487">
                  <c:v>0.84399999999999997</c:v>
                </c:pt>
                <c:pt idx="488">
                  <c:v>0.83799999999999997</c:v>
                </c:pt>
                <c:pt idx="489">
                  <c:v>0.83199999999999996</c:v>
                </c:pt>
                <c:pt idx="490">
                  <c:v>0.82499999999999996</c:v>
                </c:pt>
                <c:pt idx="491">
                  <c:v>0.81799999999999995</c:v>
                </c:pt>
                <c:pt idx="492">
                  <c:v>0.81</c:v>
                </c:pt>
                <c:pt idx="493">
                  <c:v>0.80100000000000005</c:v>
                </c:pt>
                <c:pt idx="494">
                  <c:v>0.79400000000000004</c:v>
                </c:pt>
                <c:pt idx="495">
                  <c:v>0.78700000000000003</c:v>
                </c:pt>
                <c:pt idx="496">
                  <c:v>0.78</c:v>
                </c:pt>
                <c:pt idx="497">
                  <c:v>0.77500000000000002</c:v>
                </c:pt>
                <c:pt idx="498">
                  <c:v>0.77</c:v>
                </c:pt>
                <c:pt idx="499">
                  <c:v>0.76700000000000002</c:v>
                </c:pt>
                <c:pt idx="500">
                  <c:v>0.76400000000000001</c:v>
                </c:pt>
                <c:pt idx="501">
                  <c:v>0.76200000000000001</c:v>
                </c:pt>
                <c:pt idx="502">
                  <c:v>0.76</c:v>
                </c:pt>
                <c:pt idx="503">
                  <c:v>0.75800000000000001</c:v>
                </c:pt>
                <c:pt idx="504">
                  <c:v>0.755</c:v>
                </c:pt>
                <c:pt idx="505">
                  <c:v>0.753</c:v>
                </c:pt>
                <c:pt idx="506">
                  <c:v>0.753</c:v>
                </c:pt>
                <c:pt idx="507">
                  <c:v>0.753</c:v>
                </c:pt>
                <c:pt idx="508">
                  <c:v>0.755</c:v>
                </c:pt>
                <c:pt idx="509">
                  <c:v>0.75700000000000001</c:v>
                </c:pt>
                <c:pt idx="510">
                  <c:v>0.75900000000000001</c:v>
                </c:pt>
                <c:pt idx="511">
                  <c:v>0.76200000000000001</c:v>
                </c:pt>
                <c:pt idx="512">
                  <c:v>0.76500000000000001</c:v>
                </c:pt>
                <c:pt idx="513">
                  <c:v>0.76800000000000002</c:v>
                </c:pt>
                <c:pt idx="514">
                  <c:v>0.77300000000000002</c:v>
                </c:pt>
                <c:pt idx="515">
                  <c:v>0.78100000000000003</c:v>
                </c:pt>
                <c:pt idx="516">
                  <c:v>0.79200000000000004</c:v>
                </c:pt>
                <c:pt idx="517">
                  <c:v>0.80500000000000005</c:v>
                </c:pt>
                <c:pt idx="518">
                  <c:v>0.82</c:v>
                </c:pt>
                <c:pt idx="519">
                  <c:v>0.83599999999999997</c:v>
                </c:pt>
                <c:pt idx="520">
                  <c:v>0.85399999999999998</c:v>
                </c:pt>
                <c:pt idx="521">
                  <c:v>0.872</c:v>
                </c:pt>
                <c:pt idx="522">
                  <c:v>0.88900000000000001</c:v>
                </c:pt>
                <c:pt idx="523">
                  <c:v>0.90700000000000003</c:v>
                </c:pt>
                <c:pt idx="524">
                  <c:v>0.92200000000000004</c:v>
                </c:pt>
                <c:pt idx="525">
                  <c:v>0.93700000000000006</c:v>
                </c:pt>
                <c:pt idx="526">
                  <c:v>0.95</c:v>
                </c:pt>
                <c:pt idx="527">
                  <c:v>0.96</c:v>
                </c:pt>
                <c:pt idx="528">
                  <c:v>0.96799999999999997</c:v>
                </c:pt>
                <c:pt idx="529">
                  <c:v>0.97299999999999998</c:v>
                </c:pt>
                <c:pt idx="530">
                  <c:v>0.97599999999999998</c:v>
                </c:pt>
                <c:pt idx="531">
                  <c:v>0.97699999999999998</c:v>
                </c:pt>
                <c:pt idx="532">
                  <c:v>0.97499999999999998</c:v>
                </c:pt>
                <c:pt idx="533">
                  <c:v>0.97299999999999998</c:v>
                </c:pt>
                <c:pt idx="534">
                  <c:v>0.97</c:v>
                </c:pt>
                <c:pt idx="535">
                  <c:v>0.96599999999999997</c:v>
                </c:pt>
                <c:pt idx="536">
                  <c:v>0.96</c:v>
                </c:pt>
                <c:pt idx="537">
                  <c:v>0.95399999999999996</c:v>
                </c:pt>
                <c:pt idx="538">
                  <c:v>0.94799999999999995</c:v>
                </c:pt>
                <c:pt idx="539">
                  <c:v>0.94099999999999995</c:v>
                </c:pt>
                <c:pt idx="540">
                  <c:v>0.93500000000000005</c:v>
                </c:pt>
                <c:pt idx="541">
                  <c:v>0.92900000000000005</c:v>
                </c:pt>
                <c:pt idx="542">
                  <c:v>0.92200000000000004</c:v>
                </c:pt>
                <c:pt idx="543">
                  <c:v>0.91400000000000003</c:v>
                </c:pt>
                <c:pt idx="544">
                  <c:v>0.90500000000000003</c:v>
                </c:pt>
                <c:pt idx="545">
                  <c:v>0.89400000000000002</c:v>
                </c:pt>
                <c:pt idx="546">
                  <c:v>0.88200000000000001</c:v>
                </c:pt>
                <c:pt idx="547">
                  <c:v>0.86899999999999999</c:v>
                </c:pt>
                <c:pt idx="548">
                  <c:v>0.85699999999999998</c:v>
                </c:pt>
                <c:pt idx="549">
                  <c:v>0.84299999999999997</c:v>
                </c:pt>
                <c:pt idx="550">
                  <c:v>0.83099999999999996</c:v>
                </c:pt>
                <c:pt idx="551">
                  <c:v>0.82</c:v>
                </c:pt>
                <c:pt idx="552">
                  <c:v>0.81100000000000005</c:v>
                </c:pt>
                <c:pt idx="553">
                  <c:v>0.80400000000000005</c:v>
                </c:pt>
                <c:pt idx="554">
                  <c:v>0.8</c:v>
                </c:pt>
                <c:pt idx="555">
                  <c:v>0.79900000000000004</c:v>
                </c:pt>
                <c:pt idx="556">
                  <c:v>0.8</c:v>
                </c:pt>
                <c:pt idx="557">
                  <c:v>0.80500000000000005</c:v>
                </c:pt>
                <c:pt idx="558">
                  <c:v>0.81299999999999994</c:v>
                </c:pt>
                <c:pt idx="559">
                  <c:v>0.82599999999999996</c:v>
                </c:pt>
                <c:pt idx="560">
                  <c:v>0.84</c:v>
                </c:pt>
                <c:pt idx="561">
                  <c:v>0.85699999999999998</c:v>
                </c:pt>
                <c:pt idx="562">
                  <c:v>0.876</c:v>
                </c:pt>
                <c:pt idx="563">
                  <c:v>0.89800000000000002</c:v>
                </c:pt>
                <c:pt idx="564">
                  <c:v>0.92</c:v>
                </c:pt>
                <c:pt idx="565">
                  <c:v>0.94499999999999995</c:v>
                </c:pt>
                <c:pt idx="566">
                  <c:v>0.97199999999999998</c:v>
                </c:pt>
                <c:pt idx="567">
                  <c:v>1</c:v>
                </c:pt>
                <c:pt idx="568">
                  <c:v>1.03</c:v>
                </c:pt>
                <c:pt idx="569">
                  <c:v>1.0629999999999999</c:v>
                </c:pt>
                <c:pt idx="570">
                  <c:v>1.099</c:v>
                </c:pt>
                <c:pt idx="571">
                  <c:v>1.1359999999999999</c:v>
                </c:pt>
                <c:pt idx="572">
                  <c:v>1.175</c:v>
                </c:pt>
                <c:pt idx="573">
                  <c:v>1.216</c:v>
                </c:pt>
                <c:pt idx="574">
                  <c:v>1.258</c:v>
                </c:pt>
                <c:pt idx="575">
                  <c:v>1.3009999999999999</c:v>
                </c:pt>
                <c:pt idx="576">
                  <c:v>1.3480000000000001</c:v>
                </c:pt>
                <c:pt idx="577">
                  <c:v>1.391</c:v>
                </c:pt>
                <c:pt idx="578">
                  <c:v>1.4370000000000001</c:v>
                </c:pt>
                <c:pt idx="579">
                  <c:v>1.4830000000000001</c:v>
                </c:pt>
                <c:pt idx="580">
                  <c:v>1.526</c:v>
                </c:pt>
                <c:pt idx="581">
                  <c:v>1.569</c:v>
                </c:pt>
                <c:pt idx="582">
                  <c:v>1.613</c:v>
                </c:pt>
                <c:pt idx="583">
                  <c:v>1.653</c:v>
                </c:pt>
                <c:pt idx="584">
                  <c:v>1.6910000000000001</c:v>
                </c:pt>
                <c:pt idx="585">
                  <c:v>1.724</c:v>
                </c:pt>
                <c:pt idx="586">
                  <c:v>1.758</c:v>
                </c:pt>
                <c:pt idx="587">
                  <c:v>1.788</c:v>
                </c:pt>
                <c:pt idx="588">
                  <c:v>1.8160000000000001</c:v>
                </c:pt>
                <c:pt idx="589">
                  <c:v>1.8360000000000001</c:v>
                </c:pt>
                <c:pt idx="590">
                  <c:v>1.849</c:v>
                </c:pt>
                <c:pt idx="591">
                  <c:v>1.8480000000000001</c:v>
                </c:pt>
                <c:pt idx="592">
                  <c:v>1.839</c:v>
                </c:pt>
                <c:pt idx="593">
                  <c:v>1.806</c:v>
                </c:pt>
                <c:pt idx="594">
                  <c:v>1.758</c:v>
                </c:pt>
                <c:pt idx="595">
                  <c:v>1.6839999999999999</c:v>
                </c:pt>
                <c:pt idx="596">
                  <c:v>1.5740000000000001</c:v>
                </c:pt>
                <c:pt idx="597">
                  <c:v>1.4259999999999999</c:v>
                </c:pt>
                <c:pt idx="598">
                  <c:v>1.226</c:v>
                </c:pt>
                <c:pt idx="599">
                  <c:v>0.96699999999999997</c:v>
                </c:pt>
                <c:pt idx="600">
                  <c:v>0.6560000000000000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F1C9-4266-924C-4F616B8627F9}"/>
            </c:ext>
          </c:extLst>
        </c:ser>
        <c:ser>
          <c:idx val="1"/>
          <c:order val="1"/>
          <c:tx>
            <c:strRef>
              <c:f>'Methanol-F'!$C$2</c:f>
              <c:strCache>
                <c:ptCount val="1"/>
                <c:pt idx="0">
                  <c:v>Kale</c:v>
                </c:pt>
              </c:strCache>
            </c:strRef>
          </c:tx>
          <c:marker>
            <c:symbol val="none"/>
          </c:marker>
          <c:xVal>
            <c:numRef>
              <c:f>'Methanol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Methanol-F'!$C$3:$C$603</c:f>
              <c:numCache>
                <c:formatCode>General</c:formatCode>
                <c:ptCount val="601"/>
                <c:pt idx="0">
                  <c:v>-5.0000000000000001E-3</c:v>
                </c:pt>
                <c:pt idx="1">
                  <c:v>-5.0000000000000001E-3</c:v>
                </c:pt>
                <c:pt idx="2">
                  <c:v>-5.0000000000000001E-3</c:v>
                </c:pt>
                <c:pt idx="3">
                  <c:v>-5.0000000000000001E-3</c:v>
                </c:pt>
                <c:pt idx="4">
                  <c:v>-5.0000000000000001E-3</c:v>
                </c:pt>
                <c:pt idx="5">
                  <c:v>-5.0000000000000001E-3</c:v>
                </c:pt>
                <c:pt idx="6">
                  <c:v>-6.0000000000000001E-3</c:v>
                </c:pt>
                <c:pt idx="7">
                  <c:v>-6.0000000000000001E-3</c:v>
                </c:pt>
                <c:pt idx="8">
                  <c:v>-6.0000000000000001E-3</c:v>
                </c:pt>
                <c:pt idx="9">
                  <c:v>-6.0000000000000001E-3</c:v>
                </c:pt>
                <c:pt idx="10">
                  <c:v>-6.0000000000000001E-3</c:v>
                </c:pt>
                <c:pt idx="11">
                  <c:v>-6.0000000000000001E-3</c:v>
                </c:pt>
                <c:pt idx="12">
                  <c:v>-7.0000000000000001E-3</c:v>
                </c:pt>
                <c:pt idx="13">
                  <c:v>-7.0000000000000001E-3</c:v>
                </c:pt>
                <c:pt idx="14">
                  <c:v>-7.0000000000000001E-3</c:v>
                </c:pt>
                <c:pt idx="15">
                  <c:v>-7.0000000000000001E-3</c:v>
                </c:pt>
                <c:pt idx="16">
                  <c:v>-7.0000000000000001E-3</c:v>
                </c:pt>
                <c:pt idx="17">
                  <c:v>-7.0000000000000001E-3</c:v>
                </c:pt>
                <c:pt idx="18">
                  <c:v>-7.0000000000000001E-3</c:v>
                </c:pt>
                <c:pt idx="19">
                  <c:v>-8.0000000000000002E-3</c:v>
                </c:pt>
                <c:pt idx="20">
                  <c:v>-8.0000000000000002E-3</c:v>
                </c:pt>
                <c:pt idx="21">
                  <c:v>-8.0000000000000002E-3</c:v>
                </c:pt>
                <c:pt idx="22">
                  <c:v>-8.0000000000000002E-3</c:v>
                </c:pt>
                <c:pt idx="23">
                  <c:v>-8.0000000000000002E-3</c:v>
                </c:pt>
                <c:pt idx="24">
                  <c:v>-8.0000000000000002E-3</c:v>
                </c:pt>
                <c:pt idx="25">
                  <c:v>-8.9999999999999993E-3</c:v>
                </c:pt>
                <c:pt idx="26">
                  <c:v>-8.9999999999999993E-3</c:v>
                </c:pt>
                <c:pt idx="27">
                  <c:v>-8.9999999999999993E-3</c:v>
                </c:pt>
                <c:pt idx="28">
                  <c:v>-8.9999999999999993E-3</c:v>
                </c:pt>
                <c:pt idx="29">
                  <c:v>-8.9999999999999993E-3</c:v>
                </c:pt>
                <c:pt idx="30">
                  <c:v>-8.9999999999999993E-3</c:v>
                </c:pt>
                <c:pt idx="31">
                  <c:v>-8.9999999999999993E-3</c:v>
                </c:pt>
                <c:pt idx="32">
                  <c:v>-8.9999999999999993E-3</c:v>
                </c:pt>
                <c:pt idx="33">
                  <c:v>-0.01</c:v>
                </c:pt>
                <c:pt idx="34">
                  <c:v>-0.01</c:v>
                </c:pt>
                <c:pt idx="35">
                  <c:v>-0.01</c:v>
                </c:pt>
                <c:pt idx="36">
                  <c:v>-0.01</c:v>
                </c:pt>
                <c:pt idx="37">
                  <c:v>-0.01</c:v>
                </c:pt>
                <c:pt idx="38">
                  <c:v>-0.01</c:v>
                </c:pt>
                <c:pt idx="39">
                  <c:v>-0.01</c:v>
                </c:pt>
                <c:pt idx="40">
                  <c:v>-0.01</c:v>
                </c:pt>
                <c:pt idx="41">
                  <c:v>-1.0999999999999999E-2</c:v>
                </c:pt>
                <c:pt idx="42">
                  <c:v>-1.0999999999999999E-2</c:v>
                </c:pt>
                <c:pt idx="43">
                  <c:v>-1.0999999999999999E-2</c:v>
                </c:pt>
                <c:pt idx="44">
                  <c:v>-1.0999999999999999E-2</c:v>
                </c:pt>
                <c:pt idx="45">
                  <c:v>-1.0999999999999999E-2</c:v>
                </c:pt>
                <c:pt idx="46">
                  <c:v>-1.0999999999999999E-2</c:v>
                </c:pt>
                <c:pt idx="47">
                  <c:v>-1.0999999999999999E-2</c:v>
                </c:pt>
                <c:pt idx="48">
                  <c:v>-1.0999999999999999E-2</c:v>
                </c:pt>
                <c:pt idx="49">
                  <c:v>-1.2E-2</c:v>
                </c:pt>
                <c:pt idx="50">
                  <c:v>-1.2E-2</c:v>
                </c:pt>
                <c:pt idx="51">
                  <c:v>-1.2E-2</c:v>
                </c:pt>
                <c:pt idx="52">
                  <c:v>-1.2E-2</c:v>
                </c:pt>
                <c:pt idx="53">
                  <c:v>-1.2E-2</c:v>
                </c:pt>
                <c:pt idx="54">
                  <c:v>-1.2E-2</c:v>
                </c:pt>
                <c:pt idx="55">
                  <c:v>-1.2999999999999999E-2</c:v>
                </c:pt>
                <c:pt idx="56">
                  <c:v>-1.4E-2</c:v>
                </c:pt>
                <c:pt idx="57">
                  <c:v>-1.4999999999999999E-2</c:v>
                </c:pt>
                <c:pt idx="58">
                  <c:v>-1.6E-2</c:v>
                </c:pt>
                <c:pt idx="59">
                  <c:v>-1.7000000000000001E-2</c:v>
                </c:pt>
                <c:pt idx="60">
                  <c:v>-1.7999999999999999E-2</c:v>
                </c:pt>
                <c:pt idx="61">
                  <c:v>-1.9E-2</c:v>
                </c:pt>
                <c:pt idx="62">
                  <c:v>-0.02</c:v>
                </c:pt>
                <c:pt idx="63">
                  <c:v>-0.02</c:v>
                </c:pt>
                <c:pt idx="64">
                  <c:v>-0.02</c:v>
                </c:pt>
                <c:pt idx="65">
                  <c:v>-0.02</c:v>
                </c:pt>
                <c:pt idx="66">
                  <c:v>-0.02</c:v>
                </c:pt>
                <c:pt idx="67">
                  <c:v>-0.02</c:v>
                </c:pt>
                <c:pt idx="68">
                  <c:v>-0.02</c:v>
                </c:pt>
                <c:pt idx="69">
                  <c:v>-0.02</c:v>
                </c:pt>
                <c:pt idx="70">
                  <c:v>-0.02</c:v>
                </c:pt>
                <c:pt idx="71">
                  <c:v>-2.1000000000000001E-2</c:v>
                </c:pt>
                <c:pt idx="72">
                  <c:v>-2.1000000000000001E-2</c:v>
                </c:pt>
                <c:pt idx="73">
                  <c:v>-2.1000000000000001E-2</c:v>
                </c:pt>
                <c:pt idx="74">
                  <c:v>-2.1000000000000001E-2</c:v>
                </c:pt>
                <c:pt idx="75">
                  <c:v>-2.1000000000000001E-2</c:v>
                </c:pt>
                <c:pt idx="76">
                  <c:v>-2.1000000000000001E-2</c:v>
                </c:pt>
                <c:pt idx="77">
                  <c:v>-2.1000000000000001E-2</c:v>
                </c:pt>
                <c:pt idx="78">
                  <c:v>-2.1000000000000001E-2</c:v>
                </c:pt>
                <c:pt idx="79">
                  <c:v>-2.1000000000000001E-2</c:v>
                </c:pt>
                <c:pt idx="80">
                  <c:v>-2.1999999999999999E-2</c:v>
                </c:pt>
                <c:pt idx="81">
                  <c:v>-2.1999999999999999E-2</c:v>
                </c:pt>
                <c:pt idx="82">
                  <c:v>-2.1999999999999999E-2</c:v>
                </c:pt>
                <c:pt idx="83">
                  <c:v>-2.1999999999999999E-2</c:v>
                </c:pt>
                <c:pt idx="84">
                  <c:v>-2.1999999999999999E-2</c:v>
                </c:pt>
                <c:pt idx="85">
                  <c:v>-2.1999999999999999E-2</c:v>
                </c:pt>
                <c:pt idx="86">
                  <c:v>-2.1999999999999999E-2</c:v>
                </c:pt>
                <c:pt idx="87">
                  <c:v>-2.1999999999999999E-2</c:v>
                </c:pt>
                <c:pt idx="88">
                  <c:v>-2.1999999999999999E-2</c:v>
                </c:pt>
                <c:pt idx="89">
                  <c:v>-2.1999999999999999E-2</c:v>
                </c:pt>
                <c:pt idx="90">
                  <c:v>-2.1999999999999999E-2</c:v>
                </c:pt>
                <c:pt idx="91">
                  <c:v>-2.1999999999999999E-2</c:v>
                </c:pt>
                <c:pt idx="92">
                  <c:v>-2.1999999999999999E-2</c:v>
                </c:pt>
                <c:pt idx="93">
                  <c:v>-2.1999999999999999E-2</c:v>
                </c:pt>
                <c:pt idx="94">
                  <c:v>-2.1999999999999999E-2</c:v>
                </c:pt>
                <c:pt idx="95">
                  <c:v>-2.1999999999999999E-2</c:v>
                </c:pt>
                <c:pt idx="96">
                  <c:v>-2.1999999999999999E-2</c:v>
                </c:pt>
                <c:pt idx="97">
                  <c:v>-2.1999999999999999E-2</c:v>
                </c:pt>
                <c:pt idx="98">
                  <c:v>-2.1999999999999999E-2</c:v>
                </c:pt>
                <c:pt idx="99">
                  <c:v>-2.1999999999999999E-2</c:v>
                </c:pt>
                <c:pt idx="100">
                  <c:v>-2.1999999999999999E-2</c:v>
                </c:pt>
                <c:pt idx="101">
                  <c:v>-2.1000000000000001E-2</c:v>
                </c:pt>
                <c:pt idx="102">
                  <c:v>-2.1000000000000001E-2</c:v>
                </c:pt>
                <c:pt idx="103">
                  <c:v>-2.1000000000000001E-2</c:v>
                </c:pt>
                <c:pt idx="104">
                  <c:v>-0.02</c:v>
                </c:pt>
                <c:pt idx="105">
                  <c:v>-0.02</c:v>
                </c:pt>
                <c:pt idx="106">
                  <c:v>-1.9E-2</c:v>
                </c:pt>
                <c:pt idx="107">
                  <c:v>-1.7999999999999999E-2</c:v>
                </c:pt>
                <c:pt idx="108">
                  <c:v>-1.7999999999999999E-2</c:v>
                </c:pt>
                <c:pt idx="109">
                  <c:v>-1.6E-2</c:v>
                </c:pt>
                <c:pt idx="110">
                  <c:v>-1.4999999999999999E-2</c:v>
                </c:pt>
                <c:pt idx="111">
                  <c:v>-1.2999999999999999E-2</c:v>
                </c:pt>
                <c:pt idx="112">
                  <c:v>-1.0999999999999999E-2</c:v>
                </c:pt>
                <c:pt idx="113">
                  <c:v>-8.0000000000000002E-3</c:v>
                </c:pt>
                <c:pt idx="114">
                  <c:v>-5.0000000000000001E-3</c:v>
                </c:pt>
                <c:pt idx="115">
                  <c:v>-2E-3</c:v>
                </c:pt>
                <c:pt idx="116">
                  <c:v>2E-3</c:v>
                </c:pt>
                <c:pt idx="117">
                  <c:v>8.0000000000000002E-3</c:v>
                </c:pt>
                <c:pt idx="118">
                  <c:v>1.2999999999999999E-2</c:v>
                </c:pt>
                <c:pt idx="119">
                  <c:v>0.02</c:v>
                </c:pt>
                <c:pt idx="120">
                  <c:v>2.8000000000000001E-2</c:v>
                </c:pt>
                <c:pt idx="121">
                  <c:v>3.5999999999999997E-2</c:v>
                </c:pt>
                <c:pt idx="122">
                  <c:v>4.5999999999999999E-2</c:v>
                </c:pt>
                <c:pt idx="123">
                  <c:v>5.6000000000000001E-2</c:v>
                </c:pt>
                <c:pt idx="124">
                  <c:v>6.8000000000000005E-2</c:v>
                </c:pt>
                <c:pt idx="125">
                  <c:v>7.9000000000000001E-2</c:v>
                </c:pt>
                <c:pt idx="126">
                  <c:v>9.0999999999999998E-2</c:v>
                </c:pt>
                <c:pt idx="127">
                  <c:v>0.104</c:v>
                </c:pt>
                <c:pt idx="128">
                  <c:v>0.11600000000000001</c:v>
                </c:pt>
                <c:pt idx="129">
                  <c:v>0.128</c:v>
                </c:pt>
                <c:pt idx="130">
                  <c:v>0.13900000000000001</c:v>
                </c:pt>
                <c:pt idx="131">
                  <c:v>0.15</c:v>
                </c:pt>
                <c:pt idx="132">
                  <c:v>0.159</c:v>
                </c:pt>
                <c:pt idx="133">
                  <c:v>0.16600000000000001</c:v>
                </c:pt>
                <c:pt idx="134">
                  <c:v>0.17100000000000001</c:v>
                </c:pt>
                <c:pt idx="135">
                  <c:v>0.17499999999999999</c:v>
                </c:pt>
                <c:pt idx="136">
                  <c:v>0.17599999999999999</c:v>
                </c:pt>
                <c:pt idx="137">
                  <c:v>0.17499999999999999</c:v>
                </c:pt>
                <c:pt idx="138">
                  <c:v>0.17199999999999999</c:v>
                </c:pt>
                <c:pt idx="139">
                  <c:v>0.16700000000000001</c:v>
                </c:pt>
                <c:pt idx="140">
                  <c:v>0.16</c:v>
                </c:pt>
                <c:pt idx="141">
                  <c:v>0.153</c:v>
                </c:pt>
                <c:pt idx="142">
                  <c:v>0.14499999999999999</c:v>
                </c:pt>
                <c:pt idx="143">
                  <c:v>0.13700000000000001</c:v>
                </c:pt>
                <c:pt idx="144">
                  <c:v>0.128</c:v>
                </c:pt>
                <c:pt idx="145">
                  <c:v>0.12</c:v>
                </c:pt>
                <c:pt idx="146">
                  <c:v>0.111</c:v>
                </c:pt>
                <c:pt idx="147">
                  <c:v>0.10299999999999999</c:v>
                </c:pt>
                <c:pt idx="148">
                  <c:v>9.6000000000000002E-2</c:v>
                </c:pt>
                <c:pt idx="149">
                  <c:v>8.7999999999999995E-2</c:v>
                </c:pt>
                <c:pt idx="150">
                  <c:v>8.2000000000000003E-2</c:v>
                </c:pt>
                <c:pt idx="151">
                  <c:v>7.5999999999999998E-2</c:v>
                </c:pt>
                <c:pt idx="152">
                  <c:v>7.0000000000000007E-2</c:v>
                </c:pt>
                <c:pt idx="153">
                  <c:v>6.5000000000000002E-2</c:v>
                </c:pt>
                <c:pt idx="154">
                  <c:v>0.06</c:v>
                </c:pt>
                <c:pt idx="155">
                  <c:v>5.6000000000000001E-2</c:v>
                </c:pt>
                <c:pt idx="156">
                  <c:v>5.1999999999999998E-2</c:v>
                </c:pt>
                <c:pt idx="157">
                  <c:v>4.8000000000000001E-2</c:v>
                </c:pt>
                <c:pt idx="158">
                  <c:v>4.4999999999999998E-2</c:v>
                </c:pt>
                <c:pt idx="159">
                  <c:v>4.2000000000000003E-2</c:v>
                </c:pt>
                <c:pt idx="160">
                  <c:v>3.9E-2</c:v>
                </c:pt>
                <c:pt idx="161">
                  <c:v>3.6999999999999998E-2</c:v>
                </c:pt>
                <c:pt idx="162">
                  <c:v>3.5000000000000003E-2</c:v>
                </c:pt>
                <c:pt idx="163">
                  <c:v>3.3000000000000002E-2</c:v>
                </c:pt>
                <c:pt idx="164">
                  <c:v>3.1E-2</c:v>
                </c:pt>
                <c:pt idx="165">
                  <c:v>2.9000000000000001E-2</c:v>
                </c:pt>
                <c:pt idx="166">
                  <c:v>2.8000000000000001E-2</c:v>
                </c:pt>
                <c:pt idx="167">
                  <c:v>2.7E-2</c:v>
                </c:pt>
                <c:pt idx="168">
                  <c:v>2.5999999999999999E-2</c:v>
                </c:pt>
                <c:pt idx="169">
                  <c:v>2.5000000000000001E-2</c:v>
                </c:pt>
                <c:pt idx="170">
                  <c:v>2.4E-2</c:v>
                </c:pt>
                <c:pt idx="171">
                  <c:v>2.3E-2</c:v>
                </c:pt>
                <c:pt idx="172">
                  <c:v>2.3E-2</c:v>
                </c:pt>
                <c:pt idx="173">
                  <c:v>2.3E-2</c:v>
                </c:pt>
                <c:pt idx="174">
                  <c:v>2.3E-2</c:v>
                </c:pt>
                <c:pt idx="175">
                  <c:v>2.3E-2</c:v>
                </c:pt>
                <c:pt idx="176">
                  <c:v>2.3E-2</c:v>
                </c:pt>
                <c:pt idx="177">
                  <c:v>2.3E-2</c:v>
                </c:pt>
                <c:pt idx="178">
                  <c:v>2.3E-2</c:v>
                </c:pt>
                <c:pt idx="179">
                  <c:v>2.3E-2</c:v>
                </c:pt>
                <c:pt idx="180">
                  <c:v>2.3E-2</c:v>
                </c:pt>
                <c:pt idx="181">
                  <c:v>2.3E-2</c:v>
                </c:pt>
                <c:pt idx="182">
                  <c:v>2.3E-2</c:v>
                </c:pt>
                <c:pt idx="183">
                  <c:v>2.4E-2</c:v>
                </c:pt>
                <c:pt idx="184">
                  <c:v>2.4E-2</c:v>
                </c:pt>
                <c:pt idx="185">
                  <c:v>2.4E-2</c:v>
                </c:pt>
                <c:pt idx="186">
                  <c:v>2.3E-2</c:v>
                </c:pt>
                <c:pt idx="187">
                  <c:v>2.3E-2</c:v>
                </c:pt>
                <c:pt idx="188">
                  <c:v>2.3E-2</c:v>
                </c:pt>
                <c:pt idx="189">
                  <c:v>2.3E-2</c:v>
                </c:pt>
                <c:pt idx="190">
                  <c:v>2.1999999999999999E-2</c:v>
                </c:pt>
                <c:pt idx="191">
                  <c:v>2.1000000000000001E-2</c:v>
                </c:pt>
                <c:pt idx="192">
                  <c:v>0.02</c:v>
                </c:pt>
                <c:pt idx="193">
                  <c:v>0.02</c:v>
                </c:pt>
                <c:pt idx="194">
                  <c:v>1.9E-2</c:v>
                </c:pt>
                <c:pt idx="195">
                  <c:v>1.7999999999999999E-2</c:v>
                </c:pt>
                <c:pt idx="196">
                  <c:v>1.7000000000000001E-2</c:v>
                </c:pt>
                <c:pt idx="197">
                  <c:v>1.6E-2</c:v>
                </c:pt>
                <c:pt idx="198">
                  <c:v>1.4999999999999999E-2</c:v>
                </c:pt>
                <c:pt idx="199">
                  <c:v>1.2999999999999999E-2</c:v>
                </c:pt>
                <c:pt idx="200">
                  <c:v>1.2999999999999999E-2</c:v>
                </c:pt>
                <c:pt idx="201">
                  <c:v>1.0999999999999999E-2</c:v>
                </c:pt>
                <c:pt idx="202">
                  <c:v>0.01</c:v>
                </c:pt>
                <c:pt idx="203">
                  <c:v>8.9999999999999993E-3</c:v>
                </c:pt>
                <c:pt idx="204">
                  <c:v>8.0000000000000002E-3</c:v>
                </c:pt>
                <c:pt idx="205">
                  <c:v>7.0000000000000001E-3</c:v>
                </c:pt>
                <c:pt idx="206">
                  <c:v>6.0000000000000001E-3</c:v>
                </c:pt>
                <c:pt idx="207">
                  <c:v>5.0000000000000001E-3</c:v>
                </c:pt>
                <c:pt idx="208">
                  <c:v>5.0000000000000001E-3</c:v>
                </c:pt>
                <c:pt idx="209">
                  <c:v>4.0000000000000001E-3</c:v>
                </c:pt>
                <c:pt idx="210">
                  <c:v>3.0000000000000001E-3</c:v>
                </c:pt>
                <c:pt idx="211">
                  <c:v>2E-3</c:v>
                </c:pt>
                <c:pt idx="212">
                  <c:v>1E-3</c:v>
                </c:pt>
                <c:pt idx="213">
                  <c:v>0</c:v>
                </c:pt>
                <c:pt idx="214">
                  <c:v>-1E-3</c:v>
                </c:pt>
                <c:pt idx="215">
                  <c:v>-2E-3</c:v>
                </c:pt>
                <c:pt idx="216">
                  <c:v>-3.0000000000000001E-3</c:v>
                </c:pt>
                <c:pt idx="217">
                  <c:v>-4.0000000000000001E-3</c:v>
                </c:pt>
                <c:pt idx="218">
                  <c:v>-5.0000000000000001E-3</c:v>
                </c:pt>
                <c:pt idx="219">
                  <c:v>-6.0000000000000001E-3</c:v>
                </c:pt>
                <c:pt idx="220">
                  <c:v>-7.0000000000000001E-3</c:v>
                </c:pt>
                <c:pt idx="221">
                  <c:v>-8.0000000000000002E-3</c:v>
                </c:pt>
                <c:pt idx="222">
                  <c:v>-8.0000000000000002E-3</c:v>
                </c:pt>
                <c:pt idx="223">
                  <c:v>-8.0000000000000002E-3</c:v>
                </c:pt>
                <c:pt idx="224">
                  <c:v>-8.9999999999999993E-3</c:v>
                </c:pt>
                <c:pt idx="225">
                  <c:v>-8.9999999999999993E-3</c:v>
                </c:pt>
                <c:pt idx="226">
                  <c:v>-8.9999999999999993E-3</c:v>
                </c:pt>
                <c:pt idx="227">
                  <c:v>-8.9999999999999993E-3</c:v>
                </c:pt>
                <c:pt idx="228">
                  <c:v>-0.01</c:v>
                </c:pt>
                <c:pt idx="229">
                  <c:v>-0.01</c:v>
                </c:pt>
                <c:pt idx="230">
                  <c:v>-1.0999999999999999E-2</c:v>
                </c:pt>
                <c:pt idx="231">
                  <c:v>-1.0999999999999999E-2</c:v>
                </c:pt>
                <c:pt idx="232">
                  <c:v>-1.2E-2</c:v>
                </c:pt>
                <c:pt idx="233">
                  <c:v>-1.2E-2</c:v>
                </c:pt>
                <c:pt idx="234">
                  <c:v>-1.2999999999999999E-2</c:v>
                </c:pt>
                <c:pt idx="235">
                  <c:v>-1.2999999999999999E-2</c:v>
                </c:pt>
                <c:pt idx="236">
                  <c:v>-1.4E-2</c:v>
                </c:pt>
                <c:pt idx="237">
                  <c:v>-1.4E-2</c:v>
                </c:pt>
                <c:pt idx="238">
                  <c:v>-1.4999999999999999E-2</c:v>
                </c:pt>
                <c:pt idx="239">
                  <c:v>-1.4999999999999999E-2</c:v>
                </c:pt>
                <c:pt idx="240">
                  <c:v>-1.6E-2</c:v>
                </c:pt>
                <c:pt idx="241">
                  <c:v>-1.6E-2</c:v>
                </c:pt>
                <c:pt idx="242">
                  <c:v>-1.6E-2</c:v>
                </c:pt>
                <c:pt idx="243">
                  <c:v>-1.7000000000000001E-2</c:v>
                </c:pt>
                <c:pt idx="244">
                  <c:v>-1.7000000000000001E-2</c:v>
                </c:pt>
                <c:pt idx="245">
                  <c:v>-1.7000000000000001E-2</c:v>
                </c:pt>
                <c:pt idx="246">
                  <c:v>-1.7999999999999999E-2</c:v>
                </c:pt>
                <c:pt idx="247">
                  <c:v>-1.7999999999999999E-2</c:v>
                </c:pt>
                <c:pt idx="248">
                  <c:v>-1.7999999999999999E-2</c:v>
                </c:pt>
                <c:pt idx="249">
                  <c:v>-1.7999999999999999E-2</c:v>
                </c:pt>
                <c:pt idx="250">
                  <c:v>-1.9E-2</c:v>
                </c:pt>
                <c:pt idx="251">
                  <c:v>-1.9E-2</c:v>
                </c:pt>
                <c:pt idx="252">
                  <c:v>-1.9E-2</c:v>
                </c:pt>
                <c:pt idx="253">
                  <c:v>-1.9E-2</c:v>
                </c:pt>
                <c:pt idx="254">
                  <c:v>-1.9E-2</c:v>
                </c:pt>
                <c:pt idx="255">
                  <c:v>-1.9E-2</c:v>
                </c:pt>
                <c:pt idx="256">
                  <c:v>-0.02</c:v>
                </c:pt>
                <c:pt idx="257">
                  <c:v>-0.02</c:v>
                </c:pt>
                <c:pt idx="258">
                  <c:v>-0.02</c:v>
                </c:pt>
                <c:pt idx="259">
                  <c:v>-0.02</c:v>
                </c:pt>
                <c:pt idx="260">
                  <c:v>-0.02</c:v>
                </c:pt>
                <c:pt idx="261">
                  <c:v>-0.02</c:v>
                </c:pt>
                <c:pt idx="262">
                  <c:v>-2.1000000000000001E-2</c:v>
                </c:pt>
                <c:pt idx="263">
                  <c:v>-2.1000000000000001E-2</c:v>
                </c:pt>
                <c:pt idx="264">
                  <c:v>-2.1000000000000001E-2</c:v>
                </c:pt>
                <c:pt idx="265">
                  <c:v>-2.1000000000000001E-2</c:v>
                </c:pt>
                <c:pt idx="266">
                  <c:v>-2.1000000000000001E-2</c:v>
                </c:pt>
                <c:pt idx="267">
                  <c:v>-2.1999999999999999E-2</c:v>
                </c:pt>
                <c:pt idx="268">
                  <c:v>-2.1999999999999999E-2</c:v>
                </c:pt>
                <c:pt idx="269">
                  <c:v>-2.1999999999999999E-2</c:v>
                </c:pt>
                <c:pt idx="270">
                  <c:v>-2.1999999999999999E-2</c:v>
                </c:pt>
                <c:pt idx="271">
                  <c:v>-2.1999999999999999E-2</c:v>
                </c:pt>
                <c:pt idx="272">
                  <c:v>-2.3E-2</c:v>
                </c:pt>
                <c:pt idx="273">
                  <c:v>-2.3E-2</c:v>
                </c:pt>
                <c:pt idx="274">
                  <c:v>-2.3E-2</c:v>
                </c:pt>
                <c:pt idx="275">
                  <c:v>-2.3E-2</c:v>
                </c:pt>
                <c:pt idx="276">
                  <c:v>-2.3E-2</c:v>
                </c:pt>
                <c:pt idx="277">
                  <c:v>-2.4E-2</c:v>
                </c:pt>
                <c:pt idx="278">
                  <c:v>-2.4E-2</c:v>
                </c:pt>
                <c:pt idx="279">
                  <c:v>-2.4E-2</c:v>
                </c:pt>
                <c:pt idx="280">
                  <c:v>-2.4E-2</c:v>
                </c:pt>
                <c:pt idx="281">
                  <c:v>-2.4E-2</c:v>
                </c:pt>
                <c:pt idx="282">
                  <c:v>-2.4E-2</c:v>
                </c:pt>
                <c:pt idx="283">
                  <c:v>-2.4E-2</c:v>
                </c:pt>
                <c:pt idx="284">
                  <c:v>-2.4E-2</c:v>
                </c:pt>
                <c:pt idx="285">
                  <c:v>-2.4E-2</c:v>
                </c:pt>
                <c:pt idx="286">
                  <c:v>-2.4E-2</c:v>
                </c:pt>
                <c:pt idx="287">
                  <c:v>-2.4E-2</c:v>
                </c:pt>
                <c:pt idx="288">
                  <c:v>-2.4E-2</c:v>
                </c:pt>
                <c:pt idx="289">
                  <c:v>-2.3E-2</c:v>
                </c:pt>
                <c:pt idx="290">
                  <c:v>-2.3E-2</c:v>
                </c:pt>
                <c:pt idx="291">
                  <c:v>-2.1999999999999999E-2</c:v>
                </c:pt>
                <c:pt idx="292">
                  <c:v>-2.1999999999999999E-2</c:v>
                </c:pt>
                <c:pt idx="293">
                  <c:v>-2.1000000000000001E-2</c:v>
                </c:pt>
                <c:pt idx="294">
                  <c:v>-0.02</c:v>
                </c:pt>
                <c:pt idx="295">
                  <c:v>-1.7999999999999999E-2</c:v>
                </c:pt>
                <c:pt idx="296">
                  <c:v>-1.7000000000000001E-2</c:v>
                </c:pt>
                <c:pt idx="297">
                  <c:v>-1.4999999999999999E-2</c:v>
                </c:pt>
                <c:pt idx="298">
                  <c:v>-1.2999999999999999E-2</c:v>
                </c:pt>
                <c:pt idx="299">
                  <c:v>-1.0999999999999999E-2</c:v>
                </c:pt>
                <c:pt idx="300">
                  <c:v>-8.0000000000000002E-3</c:v>
                </c:pt>
                <c:pt idx="301">
                  <c:v>-6.0000000000000001E-3</c:v>
                </c:pt>
                <c:pt idx="302">
                  <c:v>-2E-3</c:v>
                </c:pt>
                <c:pt idx="303">
                  <c:v>1E-3</c:v>
                </c:pt>
                <c:pt idx="304">
                  <c:v>5.0000000000000001E-3</c:v>
                </c:pt>
                <c:pt idx="305">
                  <c:v>0.01</c:v>
                </c:pt>
                <c:pt idx="306">
                  <c:v>1.4999999999999999E-2</c:v>
                </c:pt>
                <c:pt idx="307">
                  <c:v>0.02</c:v>
                </c:pt>
                <c:pt idx="308">
                  <c:v>2.5999999999999999E-2</c:v>
                </c:pt>
                <c:pt idx="309">
                  <c:v>3.2000000000000001E-2</c:v>
                </c:pt>
                <c:pt idx="310">
                  <c:v>0.04</c:v>
                </c:pt>
                <c:pt idx="311">
                  <c:v>4.8000000000000001E-2</c:v>
                </c:pt>
                <c:pt idx="312">
                  <c:v>5.6000000000000001E-2</c:v>
                </c:pt>
                <c:pt idx="313">
                  <c:v>6.5000000000000002E-2</c:v>
                </c:pt>
                <c:pt idx="314">
                  <c:v>7.3999999999999996E-2</c:v>
                </c:pt>
                <c:pt idx="315">
                  <c:v>8.5000000000000006E-2</c:v>
                </c:pt>
                <c:pt idx="316">
                  <c:v>9.5000000000000001E-2</c:v>
                </c:pt>
                <c:pt idx="317">
                  <c:v>0.106</c:v>
                </c:pt>
                <c:pt idx="318">
                  <c:v>0.11700000000000001</c:v>
                </c:pt>
                <c:pt idx="319">
                  <c:v>0.128</c:v>
                </c:pt>
                <c:pt idx="320">
                  <c:v>0.13900000000000001</c:v>
                </c:pt>
                <c:pt idx="321">
                  <c:v>0.15</c:v>
                </c:pt>
                <c:pt idx="322">
                  <c:v>0.16</c:v>
                </c:pt>
                <c:pt idx="323">
                  <c:v>0.17100000000000001</c:v>
                </c:pt>
                <c:pt idx="324">
                  <c:v>0.18099999999999999</c:v>
                </c:pt>
                <c:pt idx="325">
                  <c:v>0.19</c:v>
                </c:pt>
                <c:pt idx="326">
                  <c:v>0.2</c:v>
                </c:pt>
                <c:pt idx="327">
                  <c:v>0.20799999999999999</c:v>
                </c:pt>
                <c:pt idx="328">
                  <c:v>0.215</c:v>
                </c:pt>
                <c:pt idx="329">
                  <c:v>0.222</c:v>
                </c:pt>
                <c:pt idx="330">
                  <c:v>0.22600000000000001</c:v>
                </c:pt>
                <c:pt idx="331">
                  <c:v>0.23</c:v>
                </c:pt>
                <c:pt idx="332">
                  <c:v>0.23200000000000001</c:v>
                </c:pt>
                <c:pt idx="333">
                  <c:v>0.23200000000000001</c:v>
                </c:pt>
                <c:pt idx="334">
                  <c:v>0.23100000000000001</c:v>
                </c:pt>
                <c:pt idx="335">
                  <c:v>0.22800000000000001</c:v>
                </c:pt>
                <c:pt idx="336">
                  <c:v>0.22500000000000001</c:v>
                </c:pt>
                <c:pt idx="337">
                  <c:v>0.221</c:v>
                </c:pt>
                <c:pt idx="338">
                  <c:v>0.216</c:v>
                </c:pt>
                <c:pt idx="339">
                  <c:v>0.21199999999999999</c:v>
                </c:pt>
                <c:pt idx="340">
                  <c:v>0.20799999999999999</c:v>
                </c:pt>
                <c:pt idx="341">
                  <c:v>0.20399999999999999</c:v>
                </c:pt>
                <c:pt idx="342">
                  <c:v>0.20200000000000001</c:v>
                </c:pt>
                <c:pt idx="343">
                  <c:v>0.2</c:v>
                </c:pt>
                <c:pt idx="344">
                  <c:v>0.2</c:v>
                </c:pt>
                <c:pt idx="345">
                  <c:v>0.20100000000000001</c:v>
                </c:pt>
                <c:pt idx="346">
                  <c:v>0.20399999999999999</c:v>
                </c:pt>
                <c:pt idx="347">
                  <c:v>0.20799999999999999</c:v>
                </c:pt>
                <c:pt idx="348">
                  <c:v>0.214</c:v>
                </c:pt>
                <c:pt idx="349">
                  <c:v>0.221</c:v>
                </c:pt>
                <c:pt idx="350">
                  <c:v>0.22900000000000001</c:v>
                </c:pt>
                <c:pt idx="351">
                  <c:v>0.23799999999999999</c:v>
                </c:pt>
                <c:pt idx="352">
                  <c:v>0.248</c:v>
                </c:pt>
                <c:pt idx="353">
                  <c:v>0.25900000000000001</c:v>
                </c:pt>
                <c:pt idx="354">
                  <c:v>0.27</c:v>
                </c:pt>
                <c:pt idx="355">
                  <c:v>0.28100000000000003</c:v>
                </c:pt>
                <c:pt idx="356">
                  <c:v>0.29099999999999998</c:v>
                </c:pt>
                <c:pt idx="357">
                  <c:v>0.30099999999999999</c:v>
                </c:pt>
                <c:pt idx="358">
                  <c:v>0.31</c:v>
                </c:pt>
                <c:pt idx="359">
                  <c:v>0.318</c:v>
                </c:pt>
                <c:pt idx="360">
                  <c:v>0.32500000000000001</c:v>
                </c:pt>
                <c:pt idx="361">
                  <c:v>0.33</c:v>
                </c:pt>
                <c:pt idx="362">
                  <c:v>0.33400000000000002</c:v>
                </c:pt>
                <c:pt idx="363">
                  <c:v>0.33600000000000002</c:v>
                </c:pt>
                <c:pt idx="364">
                  <c:v>0.33600000000000002</c:v>
                </c:pt>
                <c:pt idx="365">
                  <c:v>0.33400000000000002</c:v>
                </c:pt>
                <c:pt idx="366">
                  <c:v>0.33200000000000002</c:v>
                </c:pt>
                <c:pt idx="367">
                  <c:v>0.32800000000000001</c:v>
                </c:pt>
                <c:pt idx="368">
                  <c:v>0.32200000000000001</c:v>
                </c:pt>
                <c:pt idx="369">
                  <c:v>0.316</c:v>
                </c:pt>
                <c:pt idx="370">
                  <c:v>0.309</c:v>
                </c:pt>
                <c:pt idx="371">
                  <c:v>0.30199999999999999</c:v>
                </c:pt>
                <c:pt idx="372">
                  <c:v>0.29599999999999999</c:v>
                </c:pt>
                <c:pt idx="373">
                  <c:v>0.28999999999999998</c:v>
                </c:pt>
                <c:pt idx="374">
                  <c:v>0.28399999999999997</c:v>
                </c:pt>
                <c:pt idx="375">
                  <c:v>0.27900000000000003</c:v>
                </c:pt>
                <c:pt idx="376">
                  <c:v>0.27500000000000002</c:v>
                </c:pt>
                <c:pt idx="377">
                  <c:v>0.27200000000000002</c:v>
                </c:pt>
                <c:pt idx="378">
                  <c:v>0.26900000000000002</c:v>
                </c:pt>
                <c:pt idx="379">
                  <c:v>0.26700000000000002</c:v>
                </c:pt>
                <c:pt idx="380">
                  <c:v>0.26600000000000001</c:v>
                </c:pt>
                <c:pt idx="381">
                  <c:v>0.26500000000000001</c:v>
                </c:pt>
                <c:pt idx="382">
                  <c:v>0.26300000000000001</c:v>
                </c:pt>
                <c:pt idx="383">
                  <c:v>0.26200000000000001</c:v>
                </c:pt>
                <c:pt idx="384">
                  <c:v>0.26100000000000001</c:v>
                </c:pt>
                <c:pt idx="385">
                  <c:v>0.25900000000000001</c:v>
                </c:pt>
                <c:pt idx="386">
                  <c:v>0.25600000000000001</c:v>
                </c:pt>
                <c:pt idx="387">
                  <c:v>0.253</c:v>
                </c:pt>
                <c:pt idx="388">
                  <c:v>0.249</c:v>
                </c:pt>
                <c:pt idx="389">
                  <c:v>0.245</c:v>
                </c:pt>
                <c:pt idx="390">
                  <c:v>0.24</c:v>
                </c:pt>
                <c:pt idx="391">
                  <c:v>0.23400000000000001</c:v>
                </c:pt>
                <c:pt idx="392">
                  <c:v>0.22900000000000001</c:v>
                </c:pt>
                <c:pt idx="393">
                  <c:v>0.223</c:v>
                </c:pt>
                <c:pt idx="394">
                  <c:v>0.217</c:v>
                </c:pt>
                <c:pt idx="395">
                  <c:v>0.21199999999999999</c:v>
                </c:pt>
                <c:pt idx="396">
                  <c:v>0.20599999999999999</c:v>
                </c:pt>
                <c:pt idx="397">
                  <c:v>0.20100000000000001</c:v>
                </c:pt>
                <c:pt idx="398">
                  <c:v>0.19700000000000001</c:v>
                </c:pt>
                <c:pt idx="399">
                  <c:v>0.193</c:v>
                </c:pt>
                <c:pt idx="400">
                  <c:v>0.19</c:v>
                </c:pt>
                <c:pt idx="401">
                  <c:v>0.188</c:v>
                </c:pt>
                <c:pt idx="402">
                  <c:v>0.186</c:v>
                </c:pt>
                <c:pt idx="403">
                  <c:v>0.185</c:v>
                </c:pt>
                <c:pt idx="404">
                  <c:v>0.184</c:v>
                </c:pt>
                <c:pt idx="405">
                  <c:v>0.184</c:v>
                </c:pt>
                <c:pt idx="406">
                  <c:v>0.184</c:v>
                </c:pt>
                <c:pt idx="407">
                  <c:v>0.184</c:v>
                </c:pt>
                <c:pt idx="408">
                  <c:v>0.184</c:v>
                </c:pt>
                <c:pt idx="409">
                  <c:v>0.184</c:v>
                </c:pt>
                <c:pt idx="410">
                  <c:v>0.185</c:v>
                </c:pt>
                <c:pt idx="411">
                  <c:v>0.185</c:v>
                </c:pt>
                <c:pt idx="412">
                  <c:v>0.185</c:v>
                </c:pt>
                <c:pt idx="413">
                  <c:v>0.185</c:v>
                </c:pt>
                <c:pt idx="414">
                  <c:v>0.185</c:v>
                </c:pt>
                <c:pt idx="415">
                  <c:v>0.185</c:v>
                </c:pt>
                <c:pt idx="416">
                  <c:v>0.185</c:v>
                </c:pt>
                <c:pt idx="417">
                  <c:v>0.185</c:v>
                </c:pt>
                <c:pt idx="418">
                  <c:v>0.184</c:v>
                </c:pt>
                <c:pt idx="419">
                  <c:v>0.184</c:v>
                </c:pt>
                <c:pt idx="420">
                  <c:v>0.183</c:v>
                </c:pt>
                <c:pt idx="421">
                  <c:v>0.187</c:v>
                </c:pt>
                <c:pt idx="422">
                  <c:v>0.2</c:v>
                </c:pt>
                <c:pt idx="423">
                  <c:v>0.20100000000000001</c:v>
                </c:pt>
                <c:pt idx="424">
                  <c:v>0.2</c:v>
                </c:pt>
                <c:pt idx="425">
                  <c:v>0.2</c:v>
                </c:pt>
                <c:pt idx="426">
                  <c:v>0.2</c:v>
                </c:pt>
                <c:pt idx="427">
                  <c:v>0.2</c:v>
                </c:pt>
                <c:pt idx="428">
                  <c:v>0.19900000000000001</c:v>
                </c:pt>
                <c:pt idx="429">
                  <c:v>0.19900000000000001</c:v>
                </c:pt>
                <c:pt idx="430">
                  <c:v>0.19900000000000001</c:v>
                </c:pt>
                <c:pt idx="431">
                  <c:v>0.19800000000000001</c:v>
                </c:pt>
                <c:pt idx="432">
                  <c:v>0.19800000000000001</c:v>
                </c:pt>
                <c:pt idx="433">
                  <c:v>0.19800000000000001</c:v>
                </c:pt>
                <c:pt idx="434">
                  <c:v>0.19800000000000001</c:v>
                </c:pt>
                <c:pt idx="435">
                  <c:v>0.19800000000000001</c:v>
                </c:pt>
                <c:pt idx="436">
                  <c:v>0.19800000000000001</c:v>
                </c:pt>
                <c:pt idx="437">
                  <c:v>0.19800000000000001</c:v>
                </c:pt>
                <c:pt idx="438">
                  <c:v>0.19800000000000001</c:v>
                </c:pt>
                <c:pt idx="439">
                  <c:v>0.19900000000000001</c:v>
                </c:pt>
                <c:pt idx="440">
                  <c:v>0.2</c:v>
                </c:pt>
                <c:pt idx="441">
                  <c:v>0.20100000000000001</c:v>
                </c:pt>
                <c:pt idx="442">
                  <c:v>0.20200000000000001</c:v>
                </c:pt>
                <c:pt idx="443">
                  <c:v>0.20300000000000001</c:v>
                </c:pt>
                <c:pt idx="444">
                  <c:v>0.20499999999999999</c:v>
                </c:pt>
                <c:pt idx="445">
                  <c:v>0.20699999999999999</c:v>
                </c:pt>
                <c:pt idx="446">
                  <c:v>0.20899999999999999</c:v>
                </c:pt>
                <c:pt idx="447">
                  <c:v>0.21099999999999999</c:v>
                </c:pt>
                <c:pt idx="448">
                  <c:v>0.214</c:v>
                </c:pt>
                <c:pt idx="449">
                  <c:v>0.217</c:v>
                </c:pt>
                <c:pt idx="450">
                  <c:v>0.221</c:v>
                </c:pt>
                <c:pt idx="451">
                  <c:v>0.22500000000000001</c:v>
                </c:pt>
                <c:pt idx="452">
                  <c:v>0.22900000000000001</c:v>
                </c:pt>
                <c:pt idx="453">
                  <c:v>0.23300000000000001</c:v>
                </c:pt>
                <c:pt idx="454">
                  <c:v>0.23699999999999999</c:v>
                </c:pt>
                <c:pt idx="455">
                  <c:v>0.24199999999999999</c:v>
                </c:pt>
                <c:pt idx="456">
                  <c:v>0.246</c:v>
                </c:pt>
                <c:pt idx="457">
                  <c:v>0.25</c:v>
                </c:pt>
                <c:pt idx="458">
                  <c:v>0.254</c:v>
                </c:pt>
                <c:pt idx="459">
                  <c:v>0.25900000000000001</c:v>
                </c:pt>
                <c:pt idx="460">
                  <c:v>0.26200000000000001</c:v>
                </c:pt>
                <c:pt idx="461">
                  <c:v>0.253</c:v>
                </c:pt>
                <c:pt idx="462">
                  <c:v>0.25</c:v>
                </c:pt>
                <c:pt idx="463">
                  <c:v>0.252</c:v>
                </c:pt>
                <c:pt idx="464">
                  <c:v>0.254</c:v>
                </c:pt>
                <c:pt idx="465">
                  <c:v>0.255</c:v>
                </c:pt>
                <c:pt idx="466">
                  <c:v>0.25700000000000001</c:v>
                </c:pt>
                <c:pt idx="467">
                  <c:v>0.25700000000000001</c:v>
                </c:pt>
                <c:pt idx="468">
                  <c:v>0.25800000000000001</c:v>
                </c:pt>
                <c:pt idx="469">
                  <c:v>0.25900000000000001</c:v>
                </c:pt>
                <c:pt idx="470">
                  <c:v>0.25900000000000001</c:v>
                </c:pt>
                <c:pt idx="471">
                  <c:v>0.26</c:v>
                </c:pt>
                <c:pt idx="472">
                  <c:v>0.26</c:v>
                </c:pt>
                <c:pt idx="473">
                  <c:v>0.25900000000000001</c:v>
                </c:pt>
                <c:pt idx="474">
                  <c:v>0.25800000000000001</c:v>
                </c:pt>
                <c:pt idx="475">
                  <c:v>0.25800000000000001</c:v>
                </c:pt>
                <c:pt idx="476">
                  <c:v>0.25600000000000001</c:v>
                </c:pt>
                <c:pt idx="477">
                  <c:v>0.255</c:v>
                </c:pt>
                <c:pt idx="478">
                  <c:v>0.253</c:v>
                </c:pt>
                <c:pt idx="479">
                  <c:v>0.252</c:v>
                </c:pt>
                <c:pt idx="480">
                  <c:v>0.25</c:v>
                </c:pt>
                <c:pt idx="481">
                  <c:v>0.249</c:v>
                </c:pt>
                <c:pt idx="482">
                  <c:v>0.247</c:v>
                </c:pt>
                <c:pt idx="483">
                  <c:v>0.246</c:v>
                </c:pt>
                <c:pt idx="484">
                  <c:v>0.245</c:v>
                </c:pt>
                <c:pt idx="485">
                  <c:v>0.24299999999999999</c:v>
                </c:pt>
                <c:pt idx="486">
                  <c:v>0.24199999999999999</c:v>
                </c:pt>
                <c:pt idx="487">
                  <c:v>0.24</c:v>
                </c:pt>
                <c:pt idx="488">
                  <c:v>0.23799999999999999</c:v>
                </c:pt>
                <c:pt idx="489">
                  <c:v>0.23699999999999999</c:v>
                </c:pt>
                <c:pt idx="490">
                  <c:v>0.23499999999999999</c:v>
                </c:pt>
                <c:pt idx="491">
                  <c:v>0.23300000000000001</c:v>
                </c:pt>
                <c:pt idx="492">
                  <c:v>0.23100000000000001</c:v>
                </c:pt>
                <c:pt idx="493">
                  <c:v>0.23</c:v>
                </c:pt>
                <c:pt idx="494">
                  <c:v>0.22900000000000001</c:v>
                </c:pt>
                <c:pt idx="495">
                  <c:v>0.22700000000000001</c:v>
                </c:pt>
                <c:pt idx="496">
                  <c:v>0.22700000000000001</c:v>
                </c:pt>
                <c:pt idx="497">
                  <c:v>0.22700000000000001</c:v>
                </c:pt>
                <c:pt idx="498">
                  <c:v>0.22600000000000001</c:v>
                </c:pt>
                <c:pt idx="499">
                  <c:v>0.22700000000000001</c:v>
                </c:pt>
                <c:pt idx="500">
                  <c:v>0.22700000000000001</c:v>
                </c:pt>
                <c:pt idx="501">
                  <c:v>0.22800000000000001</c:v>
                </c:pt>
                <c:pt idx="502">
                  <c:v>0.22800000000000001</c:v>
                </c:pt>
                <c:pt idx="503">
                  <c:v>0.23</c:v>
                </c:pt>
                <c:pt idx="504">
                  <c:v>0.23100000000000001</c:v>
                </c:pt>
                <c:pt idx="505">
                  <c:v>0.23300000000000001</c:v>
                </c:pt>
                <c:pt idx="506">
                  <c:v>0.23499999999999999</c:v>
                </c:pt>
                <c:pt idx="507">
                  <c:v>0.23799999999999999</c:v>
                </c:pt>
                <c:pt idx="508">
                  <c:v>0.24099999999999999</c:v>
                </c:pt>
                <c:pt idx="509">
                  <c:v>0.245</c:v>
                </c:pt>
                <c:pt idx="510">
                  <c:v>0.249</c:v>
                </c:pt>
                <c:pt idx="511">
                  <c:v>0.252</c:v>
                </c:pt>
                <c:pt idx="512">
                  <c:v>0.254</c:v>
                </c:pt>
                <c:pt idx="513">
                  <c:v>0.254</c:v>
                </c:pt>
                <c:pt idx="514">
                  <c:v>0.25600000000000001</c:v>
                </c:pt>
                <c:pt idx="515">
                  <c:v>0.25900000000000001</c:v>
                </c:pt>
                <c:pt idx="516">
                  <c:v>0.26200000000000001</c:v>
                </c:pt>
                <c:pt idx="517">
                  <c:v>0.26600000000000001</c:v>
                </c:pt>
                <c:pt idx="518">
                  <c:v>0.27</c:v>
                </c:pt>
                <c:pt idx="519">
                  <c:v>0.27400000000000002</c:v>
                </c:pt>
                <c:pt idx="520">
                  <c:v>0.27800000000000002</c:v>
                </c:pt>
                <c:pt idx="521">
                  <c:v>0.28100000000000003</c:v>
                </c:pt>
                <c:pt idx="522">
                  <c:v>0.28499999999999998</c:v>
                </c:pt>
                <c:pt idx="523">
                  <c:v>0.28899999999999998</c:v>
                </c:pt>
                <c:pt idx="524">
                  <c:v>0.29399999999999998</c:v>
                </c:pt>
                <c:pt idx="525">
                  <c:v>0.3</c:v>
                </c:pt>
                <c:pt idx="526">
                  <c:v>0.30599999999999999</c:v>
                </c:pt>
                <c:pt idx="527">
                  <c:v>0.313</c:v>
                </c:pt>
                <c:pt idx="528">
                  <c:v>0.31900000000000001</c:v>
                </c:pt>
                <c:pt idx="529">
                  <c:v>0.32600000000000001</c:v>
                </c:pt>
                <c:pt idx="530">
                  <c:v>0.33200000000000002</c:v>
                </c:pt>
                <c:pt idx="531">
                  <c:v>0.33700000000000002</c:v>
                </c:pt>
                <c:pt idx="532">
                  <c:v>0.34100000000000003</c:v>
                </c:pt>
                <c:pt idx="533">
                  <c:v>0.34499999999999997</c:v>
                </c:pt>
                <c:pt idx="534">
                  <c:v>0.34699999999999998</c:v>
                </c:pt>
                <c:pt idx="535">
                  <c:v>0.34799999999999998</c:v>
                </c:pt>
                <c:pt idx="536">
                  <c:v>0.34799999999999998</c:v>
                </c:pt>
                <c:pt idx="537">
                  <c:v>0.34699999999999998</c:v>
                </c:pt>
                <c:pt idx="538">
                  <c:v>0.34599999999999997</c:v>
                </c:pt>
                <c:pt idx="539">
                  <c:v>0.34599999999999997</c:v>
                </c:pt>
                <c:pt idx="540">
                  <c:v>0.34499999999999997</c:v>
                </c:pt>
                <c:pt idx="541">
                  <c:v>0.34499999999999997</c:v>
                </c:pt>
                <c:pt idx="542">
                  <c:v>0.34499999999999997</c:v>
                </c:pt>
                <c:pt idx="543">
                  <c:v>0.34599999999999997</c:v>
                </c:pt>
                <c:pt idx="544">
                  <c:v>0.34699999999999998</c:v>
                </c:pt>
                <c:pt idx="545">
                  <c:v>0.34699999999999998</c:v>
                </c:pt>
                <c:pt idx="546">
                  <c:v>0.34899999999999998</c:v>
                </c:pt>
                <c:pt idx="547">
                  <c:v>0.35</c:v>
                </c:pt>
                <c:pt idx="548">
                  <c:v>0.35199999999999998</c:v>
                </c:pt>
                <c:pt idx="549">
                  <c:v>0.35499999999999998</c:v>
                </c:pt>
                <c:pt idx="550">
                  <c:v>0.35799999999999998</c:v>
                </c:pt>
                <c:pt idx="551">
                  <c:v>0.36099999999999999</c:v>
                </c:pt>
                <c:pt idx="552">
                  <c:v>0.36599999999999999</c:v>
                </c:pt>
                <c:pt idx="553">
                  <c:v>0.37</c:v>
                </c:pt>
                <c:pt idx="554">
                  <c:v>0.375</c:v>
                </c:pt>
                <c:pt idx="555">
                  <c:v>0.38</c:v>
                </c:pt>
                <c:pt idx="556">
                  <c:v>0.38400000000000001</c:v>
                </c:pt>
                <c:pt idx="557">
                  <c:v>0.38900000000000001</c:v>
                </c:pt>
                <c:pt idx="558">
                  <c:v>0.39400000000000002</c:v>
                </c:pt>
                <c:pt idx="559">
                  <c:v>0.4</c:v>
                </c:pt>
                <c:pt idx="560">
                  <c:v>0.40600000000000003</c:v>
                </c:pt>
                <c:pt idx="561">
                  <c:v>0.41299999999999998</c:v>
                </c:pt>
                <c:pt idx="562">
                  <c:v>0.42199999999999999</c:v>
                </c:pt>
                <c:pt idx="563">
                  <c:v>0.432</c:v>
                </c:pt>
                <c:pt idx="564">
                  <c:v>0.44400000000000001</c:v>
                </c:pt>
                <c:pt idx="565">
                  <c:v>0.45700000000000002</c:v>
                </c:pt>
                <c:pt idx="566">
                  <c:v>0.47199999999999998</c:v>
                </c:pt>
                <c:pt idx="567">
                  <c:v>0.49099999999999999</c:v>
                </c:pt>
                <c:pt idx="568">
                  <c:v>0.51400000000000001</c:v>
                </c:pt>
                <c:pt idx="569">
                  <c:v>0.54100000000000004</c:v>
                </c:pt>
                <c:pt idx="570">
                  <c:v>0.57299999999999995</c:v>
                </c:pt>
                <c:pt idx="571">
                  <c:v>0.61199999999999999</c:v>
                </c:pt>
                <c:pt idx="572">
                  <c:v>0.65700000000000003</c:v>
                </c:pt>
                <c:pt idx="573">
                  <c:v>0.70799999999999996</c:v>
                </c:pt>
                <c:pt idx="574">
                  <c:v>0.76300000000000001</c:v>
                </c:pt>
                <c:pt idx="575">
                  <c:v>0.82</c:v>
                </c:pt>
                <c:pt idx="576">
                  <c:v>0.878</c:v>
                </c:pt>
                <c:pt idx="577">
                  <c:v>0.93600000000000005</c:v>
                </c:pt>
                <c:pt idx="578">
                  <c:v>0.99299999999999999</c:v>
                </c:pt>
                <c:pt idx="579">
                  <c:v>1.0509999999999999</c:v>
                </c:pt>
                <c:pt idx="580">
                  <c:v>1.1100000000000001</c:v>
                </c:pt>
                <c:pt idx="581">
                  <c:v>1.167</c:v>
                </c:pt>
                <c:pt idx="582">
                  <c:v>1.226</c:v>
                </c:pt>
                <c:pt idx="583">
                  <c:v>1.2849999999999999</c:v>
                </c:pt>
                <c:pt idx="584">
                  <c:v>1.343</c:v>
                </c:pt>
                <c:pt idx="585">
                  <c:v>1.4039999999999999</c:v>
                </c:pt>
                <c:pt idx="586">
                  <c:v>1.4630000000000001</c:v>
                </c:pt>
                <c:pt idx="587">
                  <c:v>1.52</c:v>
                </c:pt>
                <c:pt idx="588">
                  <c:v>1.5760000000000001</c:v>
                </c:pt>
                <c:pt idx="589">
                  <c:v>1.6279999999999999</c:v>
                </c:pt>
                <c:pt idx="590">
                  <c:v>1.669</c:v>
                </c:pt>
                <c:pt idx="591">
                  <c:v>1.6950000000000001</c:v>
                </c:pt>
                <c:pt idx="592">
                  <c:v>1.7170000000000001</c:v>
                </c:pt>
                <c:pt idx="593">
                  <c:v>1.7090000000000001</c:v>
                </c:pt>
                <c:pt idx="594">
                  <c:v>1.6830000000000001</c:v>
                </c:pt>
                <c:pt idx="595">
                  <c:v>1.6259999999999999</c:v>
                </c:pt>
                <c:pt idx="596">
                  <c:v>1.5169999999999999</c:v>
                </c:pt>
                <c:pt idx="597">
                  <c:v>1.375</c:v>
                </c:pt>
                <c:pt idx="598">
                  <c:v>1.1859999999999999</c:v>
                </c:pt>
                <c:pt idx="599">
                  <c:v>0.92200000000000004</c:v>
                </c:pt>
                <c:pt idx="600">
                  <c:v>0.59799999999999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F1C9-4266-924C-4F616B8627F9}"/>
            </c:ext>
          </c:extLst>
        </c:ser>
        <c:ser>
          <c:idx val="2"/>
          <c:order val="2"/>
          <c:tx>
            <c:strRef>
              <c:f>'Methanol-F'!$D$2</c:f>
              <c:strCache>
                <c:ptCount val="1"/>
                <c:pt idx="0">
                  <c:v>Collards</c:v>
                </c:pt>
              </c:strCache>
            </c:strRef>
          </c:tx>
          <c:spPr>
            <a:ln>
              <a:prstDash val="sysDot"/>
            </a:ln>
          </c:spPr>
          <c:marker>
            <c:symbol val="none"/>
          </c:marker>
          <c:xVal>
            <c:numRef>
              <c:f>'Methanol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Methanol-F'!$D$3:$D$603</c:f>
              <c:numCache>
                <c:formatCode>General</c:formatCode>
                <c:ptCount val="601"/>
                <c:pt idx="0">
                  <c:v>-8.0000000000000002E-3</c:v>
                </c:pt>
                <c:pt idx="1">
                  <c:v>-8.0000000000000002E-3</c:v>
                </c:pt>
                <c:pt idx="2">
                  <c:v>-8.0000000000000002E-3</c:v>
                </c:pt>
                <c:pt idx="3">
                  <c:v>-8.0000000000000002E-3</c:v>
                </c:pt>
                <c:pt idx="4">
                  <c:v>-8.0000000000000002E-3</c:v>
                </c:pt>
                <c:pt idx="5">
                  <c:v>-8.0000000000000002E-3</c:v>
                </c:pt>
                <c:pt idx="6">
                  <c:v>-8.0000000000000002E-3</c:v>
                </c:pt>
                <c:pt idx="7">
                  <c:v>-8.9999999999999993E-3</c:v>
                </c:pt>
                <c:pt idx="8">
                  <c:v>-8.9999999999999993E-3</c:v>
                </c:pt>
                <c:pt idx="9">
                  <c:v>-8.9999999999999993E-3</c:v>
                </c:pt>
                <c:pt idx="10">
                  <c:v>-8.9999999999999993E-3</c:v>
                </c:pt>
                <c:pt idx="11">
                  <c:v>-8.9999999999999993E-3</c:v>
                </c:pt>
                <c:pt idx="12">
                  <c:v>-8.9999999999999993E-3</c:v>
                </c:pt>
                <c:pt idx="13">
                  <c:v>-0.01</c:v>
                </c:pt>
                <c:pt idx="14">
                  <c:v>-0.01</c:v>
                </c:pt>
                <c:pt idx="15">
                  <c:v>-0.01</c:v>
                </c:pt>
                <c:pt idx="16">
                  <c:v>-0.01</c:v>
                </c:pt>
                <c:pt idx="17">
                  <c:v>-0.01</c:v>
                </c:pt>
                <c:pt idx="18">
                  <c:v>-0.01</c:v>
                </c:pt>
                <c:pt idx="19">
                  <c:v>-1.0999999999999999E-2</c:v>
                </c:pt>
                <c:pt idx="20">
                  <c:v>-1.0999999999999999E-2</c:v>
                </c:pt>
                <c:pt idx="21">
                  <c:v>-1.0999999999999999E-2</c:v>
                </c:pt>
                <c:pt idx="22">
                  <c:v>-1.0999999999999999E-2</c:v>
                </c:pt>
                <c:pt idx="23">
                  <c:v>-1.0999999999999999E-2</c:v>
                </c:pt>
                <c:pt idx="24">
                  <c:v>-1.0999999999999999E-2</c:v>
                </c:pt>
                <c:pt idx="25">
                  <c:v>-1.0999999999999999E-2</c:v>
                </c:pt>
                <c:pt idx="26">
                  <c:v>-1.0999999999999999E-2</c:v>
                </c:pt>
                <c:pt idx="27">
                  <c:v>-1.2E-2</c:v>
                </c:pt>
                <c:pt idx="28">
                  <c:v>-1.2E-2</c:v>
                </c:pt>
                <c:pt idx="29">
                  <c:v>-1.2E-2</c:v>
                </c:pt>
                <c:pt idx="30">
                  <c:v>-1.2E-2</c:v>
                </c:pt>
                <c:pt idx="31">
                  <c:v>-1.2E-2</c:v>
                </c:pt>
                <c:pt idx="32">
                  <c:v>-1.2E-2</c:v>
                </c:pt>
                <c:pt idx="33">
                  <c:v>-1.2E-2</c:v>
                </c:pt>
                <c:pt idx="34">
                  <c:v>-1.2E-2</c:v>
                </c:pt>
                <c:pt idx="35">
                  <c:v>-1.2E-2</c:v>
                </c:pt>
                <c:pt idx="36">
                  <c:v>-1.2999999999999999E-2</c:v>
                </c:pt>
                <c:pt idx="37">
                  <c:v>-1.2999999999999999E-2</c:v>
                </c:pt>
                <c:pt idx="38">
                  <c:v>-1.2999999999999999E-2</c:v>
                </c:pt>
                <c:pt idx="39">
                  <c:v>-1.2999999999999999E-2</c:v>
                </c:pt>
                <c:pt idx="40">
                  <c:v>-1.2999999999999999E-2</c:v>
                </c:pt>
                <c:pt idx="41">
                  <c:v>-1.2999999999999999E-2</c:v>
                </c:pt>
                <c:pt idx="42">
                  <c:v>-1.4E-2</c:v>
                </c:pt>
                <c:pt idx="43">
                  <c:v>-1.4E-2</c:v>
                </c:pt>
                <c:pt idx="44">
                  <c:v>-1.4E-2</c:v>
                </c:pt>
                <c:pt idx="45">
                  <c:v>-1.4E-2</c:v>
                </c:pt>
                <c:pt idx="46">
                  <c:v>-1.4E-2</c:v>
                </c:pt>
                <c:pt idx="47">
                  <c:v>-1.4E-2</c:v>
                </c:pt>
                <c:pt idx="48">
                  <c:v>-1.4E-2</c:v>
                </c:pt>
                <c:pt idx="49">
                  <c:v>-1.4E-2</c:v>
                </c:pt>
                <c:pt idx="50">
                  <c:v>-1.4E-2</c:v>
                </c:pt>
                <c:pt idx="51">
                  <c:v>-1.4E-2</c:v>
                </c:pt>
                <c:pt idx="52">
                  <c:v>-1.4E-2</c:v>
                </c:pt>
                <c:pt idx="53">
                  <c:v>-1.4E-2</c:v>
                </c:pt>
                <c:pt idx="54">
                  <c:v>-1.4999999999999999E-2</c:v>
                </c:pt>
                <c:pt idx="55">
                  <c:v>-1.4999999999999999E-2</c:v>
                </c:pt>
                <c:pt idx="56">
                  <c:v>-1.6E-2</c:v>
                </c:pt>
                <c:pt idx="57">
                  <c:v>-1.7000000000000001E-2</c:v>
                </c:pt>
                <c:pt idx="58">
                  <c:v>-1.7999999999999999E-2</c:v>
                </c:pt>
                <c:pt idx="59">
                  <c:v>-1.9E-2</c:v>
                </c:pt>
                <c:pt idx="60">
                  <c:v>-2.1000000000000001E-2</c:v>
                </c:pt>
                <c:pt idx="61">
                  <c:v>-2.1999999999999999E-2</c:v>
                </c:pt>
                <c:pt idx="62">
                  <c:v>-2.1999999999999999E-2</c:v>
                </c:pt>
                <c:pt idx="63">
                  <c:v>-2.3E-2</c:v>
                </c:pt>
                <c:pt idx="64">
                  <c:v>-2.3E-2</c:v>
                </c:pt>
                <c:pt idx="65">
                  <c:v>-2.3E-2</c:v>
                </c:pt>
                <c:pt idx="66">
                  <c:v>-2.1999999999999999E-2</c:v>
                </c:pt>
                <c:pt idx="67">
                  <c:v>-2.3E-2</c:v>
                </c:pt>
                <c:pt idx="68">
                  <c:v>-2.3E-2</c:v>
                </c:pt>
                <c:pt idx="69">
                  <c:v>-2.3E-2</c:v>
                </c:pt>
                <c:pt idx="70">
                  <c:v>-2.3E-2</c:v>
                </c:pt>
                <c:pt idx="71">
                  <c:v>-2.3E-2</c:v>
                </c:pt>
                <c:pt idx="72">
                  <c:v>-2.3E-2</c:v>
                </c:pt>
                <c:pt idx="73">
                  <c:v>-2.3E-2</c:v>
                </c:pt>
                <c:pt idx="74">
                  <c:v>-2.3E-2</c:v>
                </c:pt>
                <c:pt idx="75">
                  <c:v>-2.3E-2</c:v>
                </c:pt>
                <c:pt idx="76">
                  <c:v>-2.4E-2</c:v>
                </c:pt>
                <c:pt idx="77">
                  <c:v>-2.4E-2</c:v>
                </c:pt>
                <c:pt idx="78">
                  <c:v>-2.4E-2</c:v>
                </c:pt>
                <c:pt idx="79">
                  <c:v>-2.4E-2</c:v>
                </c:pt>
                <c:pt idx="80">
                  <c:v>-2.4E-2</c:v>
                </c:pt>
                <c:pt idx="81">
                  <c:v>-2.4E-2</c:v>
                </c:pt>
                <c:pt idx="82">
                  <c:v>-2.4E-2</c:v>
                </c:pt>
                <c:pt idx="83">
                  <c:v>-2.4E-2</c:v>
                </c:pt>
                <c:pt idx="84">
                  <c:v>-2.5000000000000001E-2</c:v>
                </c:pt>
                <c:pt idx="85">
                  <c:v>-2.5000000000000001E-2</c:v>
                </c:pt>
                <c:pt idx="86">
                  <c:v>-2.5000000000000001E-2</c:v>
                </c:pt>
                <c:pt idx="87">
                  <c:v>-2.5000000000000001E-2</c:v>
                </c:pt>
                <c:pt idx="88">
                  <c:v>-2.5000000000000001E-2</c:v>
                </c:pt>
                <c:pt idx="89">
                  <c:v>-2.5000000000000001E-2</c:v>
                </c:pt>
                <c:pt idx="90">
                  <c:v>-2.5000000000000001E-2</c:v>
                </c:pt>
                <c:pt idx="91">
                  <c:v>-2.5000000000000001E-2</c:v>
                </c:pt>
                <c:pt idx="92">
                  <c:v>-2.5000000000000001E-2</c:v>
                </c:pt>
                <c:pt idx="93">
                  <c:v>-2.5000000000000001E-2</c:v>
                </c:pt>
                <c:pt idx="94">
                  <c:v>-2.5000000000000001E-2</c:v>
                </c:pt>
                <c:pt idx="95">
                  <c:v>-2.5999999999999999E-2</c:v>
                </c:pt>
                <c:pt idx="96">
                  <c:v>-2.5999999999999999E-2</c:v>
                </c:pt>
                <c:pt idx="97">
                  <c:v>-2.5999999999999999E-2</c:v>
                </c:pt>
                <c:pt idx="98">
                  <c:v>-2.5999999999999999E-2</c:v>
                </c:pt>
                <c:pt idx="99">
                  <c:v>-2.5999999999999999E-2</c:v>
                </c:pt>
                <c:pt idx="100">
                  <c:v>-2.5999999999999999E-2</c:v>
                </c:pt>
                <c:pt idx="101">
                  <c:v>-2.5999999999999999E-2</c:v>
                </c:pt>
                <c:pt idx="102">
                  <c:v>-2.5999999999999999E-2</c:v>
                </c:pt>
                <c:pt idx="103">
                  <c:v>-2.5999999999999999E-2</c:v>
                </c:pt>
                <c:pt idx="104">
                  <c:v>-2.5999999999999999E-2</c:v>
                </c:pt>
                <c:pt idx="105">
                  <c:v>-2.5999999999999999E-2</c:v>
                </c:pt>
                <c:pt idx="106">
                  <c:v>-2.5999999999999999E-2</c:v>
                </c:pt>
                <c:pt idx="107">
                  <c:v>-2.5999999999999999E-2</c:v>
                </c:pt>
                <c:pt idx="108">
                  <c:v>-2.5999999999999999E-2</c:v>
                </c:pt>
                <c:pt idx="109">
                  <c:v>-2.5000000000000001E-2</c:v>
                </c:pt>
                <c:pt idx="110">
                  <c:v>-2.5000000000000001E-2</c:v>
                </c:pt>
                <c:pt idx="111">
                  <c:v>-2.5000000000000001E-2</c:v>
                </c:pt>
                <c:pt idx="112">
                  <c:v>-2.4E-2</c:v>
                </c:pt>
                <c:pt idx="113">
                  <c:v>-2.4E-2</c:v>
                </c:pt>
                <c:pt idx="114">
                  <c:v>-2.3E-2</c:v>
                </c:pt>
                <c:pt idx="115">
                  <c:v>-2.1999999999999999E-2</c:v>
                </c:pt>
                <c:pt idx="116">
                  <c:v>-2.1000000000000001E-2</c:v>
                </c:pt>
                <c:pt idx="117">
                  <c:v>-0.02</c:v>
                </c:pt>
                <c:pt idx="118">
                  <c:v>-1.9E-2</c:v>
                </c:pt>
                <c:pt idx="119">
                  <c:v>-1.7000000000000001E-2</c:v>
                </c:pt>
                <c:pt idx="120">
                  <c:v>-1.6E-2</c:v>
                </c:pt>
                <c:pt idx="121">
                  <c:v>-1.4E-2</c:v>
                </c:pt>
                <c:pt idx="122">
                  <c:v>-1.0999999999999999E-2</c:v>
                </c:pt>
                <c:pt idx="123">
                  <c:v>-8.9999999999999993E-3</c:v>
                </c:pt>
                <c:pt idx="124">
                  <c:v>-7.0000000000000001E-3</c:v>
                </c:pt>
                <c:pt idx="125">
                  <c:v>-4.0000000000000001E-3</c:v>
                </c:pt>
                <c:pt idx="126">
                  <c:v>-1E-3</c:v>
                </c:pt>
                <c:pt idx="127">
                  <c:v>2E-3</c:v>
                </c:pt>
                <c:pt idx="128">
                  <c:v>5.0000000000000001E-3</c:v>
                </c:pt>
                <c:pt idx="129">
                  <c:v>7.0000000000000001E-3</c:v>
                </c:pt>
                <c:pt idx="130">
                  <c:v>0.01</c:v>
                </c:pt>
                <c:pt idx="131">
                  <c:v>1.2E-2</c:v>
                </c:pt>
                <c:pt idx="132">
                  <c:v>1.4E-2</c:v>
                </c:pt>
                <c:pt idx="133">
                  <c:v>1.6E-2</c:v>
                </c:pt>
                <c:pt idx="134">
                  <c:v>1.7000000000000001E-2</c:v>
                </c:pt>
                <c:pt idx="135">
                  <c:v>1.7999999999999999E-2</c:v>
                </c:pt>
                <c:pt idx="136">
                  <c:v>1.7999999999999999E-2</c:v>
                </c:pt>
                <c:pt idx="137">
                  <c:v>1.7999999999999999E-2</c:v>
                </c:pt>
                <c:pt idx="138">
                  <c:v>1.7000000000000001E-2</c:v>
                </c:pt>
                <c:pt idx="139">
                  <c:v>1.6E-2</c:v>
                </c:pt>
                <c:pt idx="140">
                  <c:v>1.4E-2</c:v>
                </c:pt>
                <c:pt idx="141">
                  <c:v>1.2E-2</c:v>
                </c:pt>
                <c:pt idx="142">
                  <c:v>0.01</c:v>
                </c:pt>
                <c:pt idx="143">
                  <c:v>8.0000000000000002E-3</c:v>
                </c:pt>
                <c:pt idx="144">
                  <c:v>6.0000000000000001E-3</c:v>
                </c:pt>
                <c:pt idx="145">
                  <c:v>4.0000000000000001E-3</c:v>
                </c:pt>
                <c:pt idx="146">
                  <c:v>2E-3</c:v>
                </c:pt>
                <c:pt idx="147">
                  <c:v>0</c:v>
                </c:pt>
                <c:pt idx="148">
                  <c:v>-2E-3</c:v>
                </c:pt>
                <c:pt idx="149">
                  <c:v>-4.0000000000000001E-3</c:v>
                </c:pt>
                <c:pt idx="150">
                  <c:v>-5.0000000000000001E-3</c:v>
                </c:pt>
                <c:pt idx="151">
                  <c:v>-7.0000000000000001E-3</c:v>
                </c:pt>
                <c:pt idx="152">
                  <c:v>-8.0000000000000002E-3</c:v>
                </c:pt>
                <c:pt idx="153">
                  <c:v>-8.9999999999999993E-3</c:v>
                </c:pt>
                <c:pt idx="154">
                  <c:v>-1.0999999999999999E-2</c:v>
                </c:pt>
                <c:pt idx="155">
                  <c:v>-1.2E-2</c:v>
                </c:pt>
                <c:pt idx="156">
                  <c:v>-1.2999999999999999E-2</c:v>
                </c:pt>
                <c:pt idx="157">
                  <c:v>-1.2999999999999999E-2</c:v>
                </c:pt>
                <c:pt idx="158">
                  <c:v>-1.4E-2</c:v>
                </c:pt>
                <c:pt idx="159">
                  <c:v>-1.4999999999999999E-2</c:v>
                </c:pt>
                <c:pt idx="160">
                  <c:v>-1.4999999999999999E-2</c:v>
                </c:pt>
                <c:pt idx="161">
                  <c:v>-1.6E-2</c:v>
                </c:pt>
                <c:pt idx="162">
                  <c:v>-1.7000000000000001E-2</c:v>
                </c:pt>
                <c:pt idx="163">
                  <c:v>-1.7000000000000001E-2</c:v>
                </c:pt>
                <c:pt idx="164">
                  <c:v>-1.7999999999999999E-2</c:v>
                </c:pt>
                <c:pt idx="165">
                  <c:v>-1.7999999999999999E-2</c:v>
                </c:pt>
                <c:pt idx="166">
                  <c:v>-1.7999999999999999E-2</c:v>
                </c:pt>
                <c:pt idx="167">
                  <c:v>-1.9E-2</c:v>
                </c:pt>
                <c:pt idx="168">
                  <c:v>-1.9E-2</c:v>
                </c:pt>
                <c:pt idx="169">
                  <c:v>-1.9E-2</c:v>
                </c:pt>
                <c:pt idx="170">
                  <c:v>-1.9E-2</c:v>
                </c:pt>
                <c:pt idx="171">
                  <c:v>-0.02</c:v>
                </c:pt>
                <c:pt idx="172">
                  <c:v>-0.02</c:v>
                </c:pt>
                <c:pt idx="173">
                  <c:v>-0.02</c:v>
                </c:pt>
                <c:pt idx="174">
                  <c:v>-0.02</c:v>
                </c:pt>
                <c:pt idx="175">
                  <c:v>-0.02</c:v>
                </c:pt>
                <c:pt idx="176">
                  <c:v>-0.02</c:v>
                </c:pt>
                <c:pt idx="177">
                  <c:v>-0.02</c:v>
                </c:pt>
                <c:pt idx="178">
                  <c:v>-0.02</c:v>
                </c:pt>
                <c:pt idx="179">
                  <c:v>-0.02</c:v>
                </c:pt>
                <c:pt idx="180">
                  <c:v>-0.02</c:v>
                </c:pt>
                <c:pt idx="181">
                  <c:v>-0.02</c:v>
                </c:pt>
                <c:pt idx="182">
                  <c:v>-0.02</c:v>
                </c:pt>
                <c:pt idx="183">
                  <c:v>-0.02</c:v>
                </c:pt>
                <c:pt idx="184">
                  <c:v>-0.02</c:v>
                </c:pt>
                <c:pt idx="185">
                  <c:v>-0.02</c:v>
                </c:pt>
                <c:pt idx="186">
                  <c:v>-0.02</c:v>
                </c:pt>
                <c:pt idx="187">
                  <c:v>-0.02</c:v>
                </c:pt>
                <c:pt idx="188">
                  <c:v>-0.02</c:v>
                </c:pt>
                <c:pt idx="189">
                  <c:v>-0.02</c:v>
                </c:pt>
                <c:pt idx="190">
                  <c:v>-2.1000000000000001E-2</c:v>
                </c:pt>
                <c:pt idx="191">
                  <c:v>-2.1000000000000001E-2</c:v>
                </c:pt>
                <c:pt idx="192">
                  <c:v>-2.1000000000000001E-2</c:v>
                </c:pt>
                <c:pt idx="193">
                  <c:v>-2.1000000000000001E-2</c:v>
                </c:pt>
                <c:pt idx="194">
                  <c:v>-2.1000000000000001E-2</c:v>
                </c:pt>
                <c:pt idx="195">
                  <c:v>-2.1999999999999999E-2</c:v>
                </c:pt>
                <c:pt idx="196">
                  <c:v>-2.1999999999999999E-2</c:v>
                </c:pt>
                <c:pt idx="197">
                  <c:v>-2.1999999999999999E-2</c:v>
                </c:pt>
                <c:pt idx="198">
                  <c:v>-2.1999999999999999E-2</c:v>
                </c:pt>
                <c:pt idx="199">
                  <c:v>-2.3E-2</c:v>
                </c:pt>
                <c:pt idx="200">
                  <c:v>-2.3E-2</c:v>
                </c:pt>
                <c:pt idx="201">
                  <c:v>-2.4E-2</c:v>
                </c:pt>
                <c:pt idx="202">
                  <c:v>-2.5000000000000001E-2</c:v>
                </c:pt>
                <c:pt idx="203">
                  <c:v>-2.5000000000000001E-2</c:v>
                </c:pt>
                <c:pt idx="204">
                  <c:v>-2.5000000000000001E-2</c:v>
                </c:pt>
                <c:pt idx="205">
                  <c:v>-2.5000000000000001E-2</c:v>
                </c:pt>
                <c:pt idx="206">
                  <c:v>-2.5999999999999999E-2</c:v>
                </c:pt>
                <c:pt idx="207">
                  <c:v>-2.5999999999999999E-2</c:v>
                </c:pt>
                <c:pt idx="208">
                  <c:v>-2.5999999999999999E-2</c:v>
                </c:pt>
                <c:pt idx="209">
                  <c:v>-2.5999999999999999E-2</c:v>
                </c:pt>
                <c:pt idx="210">
                  <c:v>-2.7E-2</c:v>
                </c:pt>
                <c:pt idx="211">
                  <c:v>-2.7E-2</c:v>
                </c:pt>
                <c:pt idx="212">
                  <c:v>-2.7E-2</c:v>
                </c:pt>
                <c:pt idx="213">
                  <c:v>-2.8000000000000001E-2</c:v>
                </c:pt>
                <c:pt idx="214">
                  <c:v>-2.8000000000000001E-2</c:v>
                </c:pt>
                <c:pt idx="215">
                  <c:v>-2.9000000000000001E-2</c:v>
                </c:pt>
                <c:pt idx="216">
                  <c:v>-2.9000000000000001E-2</c:v>
                </c:pt>
                <c:pt idx="217">
                  <c:v>-0.03</c:v>
                </c:pt>
                <c:pt idx="218">
                  <c:v>-3.1E-2</c:v>
                </c:pt>
                <c:pt idx="219">
                  <c:v>-3.1E-2</c:v>
                </c:pt>
                <c:pt idx="220">
                  <c:v>-3.2000000000000001E-2</c:v>
                </c:pt>
                <c:pt idx="221">
                  <c:v>-3.2000000000000001E-2</c:v>
                </c:pt>
                <c:pt idx="222">
                  <c:v>-3.2000000000000001E-2</c:v>
                </c:pt>
                <c:pt idx="223">
                  <c:v>-3.2000000000000001E-2</c:v>
                </c:pt>
                <c:pt idx="224">
                  <c:v>-3.2000000000000001E-2</c:v>
                </c:pt>
                <c:pt idx="225">
                  <c:v>-3.2000000000000001E-2</c:v>
                </c:pt>
                <c:pt idx="226">
                  <c:v>-3.2000000000000001E-2</c:v>
                </c:pt>
                <c:pt idx="227">
                  <c:v>-3.2000000000000001E-2</c:v>
                </c:pt>
                <c:pt idx="228">
                  <c:v>-3.2000000000000001E-2</c:v>
                </c:pt>
                <c:pt idx="229">
                  <c:v>-3.2000000000000001E-2</c:v>
                </c:pt>
                <c:pt idx="230">
                  <c:v>-3.2000000000000001E-2</c:v>
                </c:pt>
                <c:pt idx="231">
                  <c:v>-3.2000000000000001E-2</c:v>
                </c:pt>
                <c:pt idx="232">
                  <c:v>-3.2000000000000001E-2</c:v>
                </c:pt>
                <c:pt idx="233">
                  <c:v>-3.2000000000000001E-2</c:v>
                </c:pt>
                <c:pt idx="234">
                  <c:v>-3.2000000000000001E-2</c:v>
                </c:pt>
                <c:pt idx="235">
                  <c:v>-3.2000000000000001E-2</c:v>
                </c:pt>
                <c:pt idx="236">
                  <c:v>-3.3000000000000002E-2</c:v>
                </c:pt>
                <c:pt idx="237">
                  <c:v>-3.3000000000000002E-2</c:v>
                </c:pt>
                <c:pt idx="238">
                  <c:v>-3.3000000000000002E-2</c:v>
                </c:pt>
                <c:pt idx="239">
                  <c:v>-3.3000000000000002E-2</c:v>
                </c:pt>
                <c:pt idx="240">
                  <c:v>-3.3000000000000002E-2</c:v>
                </c:pt>
                <c:pt idx="241">
                  <c:v>-3.3000000000000002E-2</c:v>
                </c:pt>
                <c:pt idx="242">
                  <c:v>-3.3000000000000002E-2</c:v>
                </c:pt>
                <c:pt idx="243">
                  <c:v>-3.3000000000000002E-2</c:v>
                </c:pt>
                <c:pt idx="244">
                  <c:v>-3.3000000000000002E-2</c:v>
                </c:pt>
                <c:pt idx="245">
                  <c:v>-3.3000000000000002E-2</c:v>
                </c:pt>
                <c:pt idx="246">
                  <c:v>-3.3000000000000002E-2</c:v>
                </c:pt>
                <c:pt idx="247">
                  <c:v>-3.4000000000000002E-2</c:v>
                </c:pt>
                <c:pt idx="248">
                  <c:v>-3.4000000000000002E-2</c:v>
                </c:pt>
                <c:pt idx="249">
                  <c:v>-3.4000000000000002E-2</c:v>
                </c:pt>
                <c:pt idx="250">
                  <c:v>-3.4000000000000002E-2</c:v>
                </c:pt>
                <c:pt idx="251">
                  <c:v>-3.4000000000000002E-2</c:v>
                </c:pt>
                <c:pt idx="252">
                  <c:v>-3.4000000000000002E-2</c:v>
                </c:pt>
                <c:pt idx="253">
                  <c:v>-3.4000000000000002E-2</c:v>
                </c:pt>
                <c:pt idx="254">
                  <c:v>-3.4000000000000002E-2</c:v>
                </c:pt>
                <c:pt idx="255">
                  <c:v>-3.4000000000000002E-2</c:v>
                </c:pt>
                <c:pt idx="256">
                  <c:v>-3.4000000000000002E-2</c:v>
                </c:pt>
                <c:pt idx="257">
                  <c:v>-3.4000000000000002E-2</c:v>
                </c:pt>
                <c:pt idx="258">
                  <c:v>-3.4000000000000002E-2</c:v>
                </c:pt>
                <c:pt idx="259">
                  <c:v>-3.5000000000000003E-2</c:v>
                </c:pt>
                <c:pt idx="260">
                  <c:v>-3.5000000000000003E-2</c:v>
                </c:pt>
                <c:pt idx="261">
                  <c:v>-3.5000000000000003E-2</c:v>
                </c:pt>
                <c:pt idx="262">
                  <c:v>-3.5000000000000003E-2</c:v>
                </c:pt>
                <c:pt idx="263">
                  <c:v>-3.5000000000000003E-2</c:v>
                </c:pt>
                <c:pt idx="264">
                  <c:v>-3.5000000000000003E-2</c:v>
                </c:pt>
                <c:pt idx="265">
                  <c:v>-3.5000000000000003E-2</c:v>
                </c:pt>
                <c:pt idx="266">
                  <c:v>-3.5000000000000003E-2</c:v>
                </c:pt>
                <c:pt idx="267">
                  <c:v>-3.5000000000000003E-2</c:v>
                </c:pt>
                <c:pt idx="268">
                  <c:v>-3.5999999999999997E-2</c:v>
                </c:pt>
                <c:pt idx="269">
                  <c:v>-3.5999999999999997E-2</c:v>
                </c:pt>
                <c:pt idx="270">
                  <c:v>-3.5999999999999997E-2</c:v>
                </c:pt>
                <c:pt idx="271">
                  <c:v>-3.5999999999999997E-2</c:v>
                </c:pt>
                <c:pt idx="272">
                  <c:v>-3.5999999999999997E-2</c:v>
                </c:pt>
                <c:pt idx="273">
                  <c:v>-3.5999999999999997E-2</c:v>
                </c:pt>
                <c:pt idx="274">
                  <c:v>-3.5999999999999997E-2</c:v>
                </c:pt>
                <c:pt idx="275">
                  <c:v>-3.5999999999999997E-2</c:v>
                </c:pt>
                <c:pt idx="276">
                  <c:v>-3.6999999999999998E-2</c:v>
                </c:pt>
                <c:pt idx="277">
                  <c:v>-3.6999999999999998E-2</c:v>
                </c:pt>
                <c:pt idx="278">
                  <c:v>-3.6999999999999998E-2</c:v>
                </c:pt>
                <c:pt idx="279">
                  <c:v>-3.6999999999999998E-2</c:v>
                </c:pt>
                <c:pt idx="280">
                  <c:v>-3.6999999999999998E-2</c:v>
                </c:pt>
                <c:pt idx="281">
                  <c:v>-3.6999999999999998E-2</c:v>
                </c:pt>
                <c:pt idx="282">
                  <c:v>-3.6999999999999998E-2</c:v>
                </c:pt>
                <c:pt idx="283">
                  <c:v>-3.6999999999999998E-2</c:v>
                </c:pt>
                <c:pt idx="284">
                  <c:v>-3.7999999999999999E-2</c:v>
                </c:pt>
                <c:pt idx="285">
                  <c:v>-3.7999999999999999E-2</c:v>
                </c:pt>
                <c:pt idx="286">
                  <c:v>-3.7999999999999999E-2</c:v>
                </c:pt>
                <c:pt idx="287">
                  <c:v>-3.7999999999999999E-2</c:v>
                </c:pt>
                <c:pt idx="288">
                  <c:v>-3.7999999999999999E-2</c:v>
                </c:pt>
                <c:pt idx="289">
                  <c:v>-3.7999999999999999E-2</c:v>
                </c:pt>
                <c:pt idx="290">
                  <c:v>-3.7999999999999999E-2</c:v>
                </c:pt>
                <c:pt idx="291">
                  <c:v>-3.7999999999999999E-2</c:v>
                </c:pt>
                <c:pt idx="292">
                  <c:v>-3.7999999999999999E-2</c:v>
                </c:pt>
                <c:pt idx="293">
                  <c:v>-3.7999999999999999E-2</c:v>
                </c:pt>
                <c:pt idx="294">
                  <c:v>-3.7999999999999999E-2</c:v>
                </c:pt>
                <c:pt idx="295">
                  <c:v>-3.6999999999999998E-2</c:v>
                </c:pt>
                <c:pt idx="296">
                  <c:v>-3.6999999999999998E-2</c:v>
                </c:pt>
                <c:pt idx="297">
                  <c:v>-3.6999999999999998E-2</c:v>
                </c:pt>
                <c:pt idx="298">
                  <c:v>-3.5999999999999997E-2</c:v>
                </c:pt>
                <c:pt idx="299">
                  <c:v>-3.5999999999999997E-2</c:v>
                </c:pt>
                <c:pt idx="300">
                  <c:v>-3.5999999999999997E-2</c:v>
                </c:pt>
                <c:pt idx="301">
                  <c:v>-3.5000000000000003E-2</c:v>
                </c:pt>
                <c:pt idx="302">
                  <c:v>-3.4000000000000002E-2</c:v>
                </c:pt>
                <c:pt idx="303">
                  <c:v>-3.4000000000000002E-2</c:v>
                </c:pt>
                <c:pt idx="304">
                  <c:v>-3.3000000000000002E-2</c:v>
                </c:pt>
                <c:pt idx="305">
                  <c:v>-3.2000000000000001E-2</c:v>
                </c:pt>
                <c:pt idx="306">
                  <c:v>-3.1E-2</c:v>
                </c:pt>
                <c:pt idx="307">
                  <c:v>-2.9000000000000001E-2</c:v>
                </c:pt>
                <c:pt idx="308">
                  <c:v>-2.8000000000000001E-2</c:v>
                </c:pt>
                <c:pt idx="309">
                  <c:v>-2.5999999999999999E-2</c:v>
                </c:pt>
                <c:pt idx="310">
                  <c:v>-2.5000000000000001E-2</c:v>
                </c:pt>
                <c:pt idx="311">
                  <c:v>-2.3E-2</c:v>
                </c:pt>
                <c:pt idx="312">
                  <c:v>-2.1000000000000001E-2</c:v>
                </c:pt>
                <c:pt idx="313">
                  <c:v>-1.9E-2</c:v>
                </c:pt>
                <c:pt idx="314">
                  <c:v>-1.7000000000000001E-2</c:v>
                </c:pt>
                <c:pt idx="315">
                  <c:v>-1.4999999999999999E-2</c:v>
                </c:pt>
                <c:pt idx="316">
                  <c:v>-1.2999999999999999E-2</c:v>
                </c:pt>
                <c:pt idx="317">
                  <c:v>-0.01</c:v>
                </c:pt>
                <c:pt idx="318">
                  <c:v>-8.0000000000000002E-3</c:v>
                </c:pt>
                <c:pt idx="319">
                  <c:v>-5.0000000000000001E-3</c:v>
                </c:pt>
                <c:pt idx="320">
                  <c:v>-3.0000000000000001E-3</c:v>
                </c:pt>
                <c:pt idx="321">
                  <c:v>-1E-3</c:v>
                </c:pt>
                <c:pt idx="322">
                  <c:v>1E-3</c:v>
                </c:pt>
                <c:pt idx="323">
                  <c:v>3.0000000000000001E-3</c:v>
                </c:pt>
                <c:pt idx="324">
                  <c:v>5.0000000000000001E-3</c:v>
                </c:pt>
                <c:pt idx="325">
                  <c:v>7.0000000000000001E-3</c:v>
                </c:pt>
                <c:pt idx="326">
                  <c:v>8.9999999999999993E-3</c:v>
                </c:pt>
                <c:pt idx="327">
                  <c:v>1.0999999999999999E-2</c:v>
                </c:pt>
                <c:pt idx="328">
                  <c:v>1.2999999999999999E-2</c:v>
                </c:pt>
                <c:pt idx="329">
                  <c:v>1.4E-2</c:v>
                </c:pt>
                <c:pt idx="330">
                  <c:v>1.4999999999999999E-2</c:v>
                </c:pt>
                <c:pt idx="331">
                  <c:v>1.6E-2</c:v>
                </c:pt>
                <c:pt idx="332">
                  <c:v>1.7000000000000001E-2</c:v>
                </c:pt>
                <c:pt idx="333">
                  <c:v>1.7000000000000001E-2</c:v>
                </c:pt>
                <c:pt idx="334">
                  <c:v>1.6E-2</c:v>
                </c:pt>
                <c:pt idx="335">
                  <c:v>1.6E-2</c:v>
                </c:pt>
                <c:pt idx="336">
                  <c:v>1.4999999999999999E-2</c:v>
                </c:pt>
                <c:pt idx="337">
                  <c:v>1.4E-2</c:v>
                </c:pt>
                <c:pt idx="338">
                  <c:v>1.2999999999999999E-2</c:v>
                </c:pt>
                <c:pt idx="339">
                  <c:v>1.2E-2</c:v>
                </c:pt>
                <c:pt idx="340">
                  <c:v>1.0999999999999999E-2</c:v>
                </c:pt>
                <c:pt idx="341">
                  <c:v>0.01</c:v>
                </c:pt>
                <c:pt idx="342">
                  <c:v>8.9999999999999993E-3</c:v>
                </c:pt>
                <c:pt idx="343">
                  <c:v>8.9999999999999993E-3</c:v>
                </c:pt>
                <c:pt idx="344">
                  <c:v>8.9999999999999993E-3</c:v>
                </c:pt>
                <c:pt idx="345">
                  <c:v>8.9999999999999993E-3</c:v>
                </c:pt>
                <c:pt idx="346">
                  <c:v>0.01</c:v>
                </c:pt>
                <c:pt idx="347">
                  <c:v>1.0999999999999999E-2</c:v>
                </c:pt>
                <c:pt idx="348">
                  <c:v>1.2E-2</c:v>
                </c:pt>
                <c:pt idx="349">
                  <c:v>1.4E-2</c:v>
                </c:pt>
                <c:pt idx="350">
                  <c:v>1.4999999999999999E-2</c:v>
                </c:pt>
                <c:pt idx="351">
                  <c:v>1.7999999999999999E-2</c:v>
                </c:pt>
                <c:pt idx="352">
                  <c:v>0.02</c:v>
                </c:pt>
                <c:pt idx="353">
                  <c:v>2.3E-2</c:v>
                </c:pt>
                <c:pt idx="354">
                  <c:v>2.5000000000000001E-2</c:v>
                </c:pt>
                <c:pt idx="355">
                  <c:v>2.8000000000000001E-2</c:v>
                </c:pt>
                <c:pt idx="356">
                  <c:v>0.03</c:v>
                </c:pt>
                <c:pt idx="357">
                  <c:v>3.2000000000000001E-2</c:v>
                </c:pt>
                <c:pt idx="358">
                  <c:v>3.5000000000000003E-2</c:v>
                </c:pt>
                <c:pt idx="359">
                  <c:v>3.5999999999999997E-2</c:v>
                </c:pt>
                <c:pt idx="360">
                  <c:v>3.7999999999999999E-2</c:v>
                </c:pt>
                <c:pt idx="361">
                  <c:v>3.9E-2</c:v>
                </c:pt>
                <c:pt idx="362">
                  <c:v>0.04</c:v>
                </c:pt>
                <c:pt idx="363">
                  <c:v>0.04</c:v>
                </c:pt>
                <c:pt idx="364">
                  <c:v>4.1000000000000002E-2</c:v>
                </c:pt>
                <c:pt idx="365">
                  <c:v>0.04</c:v>
                </c:pt>
                <c:pt idx="366">
                  <c:v>0.04</c:v>
                </c:pt>
                <c:pt idx="367">
                  <c:v>3.9E-2</c:v>
                </c:pt>
                <c:pt idx="368">
                  <c:v>3.6999999999999998E-2</c:v>
                </c:pt>
                <c:pt idx="369">
                  <c:v>3.5999999999999997E-2</c:v>
                </c:pt>
                <c:pt idx="370">
                  <c:v>3.5000000000000003E-2</c:v>
                </c:pt>
                <c:pt idx="371">
                  <c:v>3.3000000000000002E-2</c:v>
                </c:pt>
                <c:pt idx="372">
                  <c:v>3.1E-2</c:v>
                </c:pt>
                <c:pt idx="373">
                  <c:v>0.03</c:v>
                </c:pt>
                <c:pt idx="374">
                  <c:v>2.9000000000000001E-2</c:v>
                </c:pt>
                <c:pt idx="375">
                  <c:v>2.8000000000000001E-2</c:v>
                </c:pt>
                <c:pt idx="376">
                  <c:v>2.7E-2</c:v>
                </c:pt>
                <c:pt idx="377">
                  <c:v>2.5999999999999999E-2</c:v>
                </c:pt>
                <c:pt idx="378">
                  <c:v>2.5999999999999999E-2</c:v>
                </c:pt>
                <c:pt idx="379">
                  <c:v>2.5000000000000001E-2</c:v>
                </c:pt>
                <c:pt idx="380">
                  <c:v>2.5000000000000001E-2</c:v>
                </c:pt>
                <c:pt idx="381">
                  <c:v>2.5000000000000001E-2</c:v>
                </c:pt>
                <c:pt idx="382">
                  <c:v>2.4E-2</c:v>
                </c:pt>
                <c:pt idx="383">
                  <c:v>2.4E-2</c:v>
                </c:pt>
                <c:pt idx="384">
                  <c:v>2.4E-2</c:v>
                </c:pt>
                <c:pt idx="385">
                  <c:v>2.3E-2</c:v>
                </c:pt>
                <c:pt idx="386">
                  <c:v>2.3E-2</c:v>
                </c:pt>
                <c:pt idx="387">
                  <c:v>2.1999999999999999E-2</c:v>
                </c:pt>
                <c:pt idx="388">
                  <c:v>2.1000000000000001E-2</c:v>
                </c:pt>
                <c:pt idx="389">
                  <c:v>0.02</c:v>
                </c:pt>
                <c:pt idx="390">
                  <c:v>1.9E-2</c:v>
                </c:pt>
                <c:pt idx="391">
                  <c:v>1.7999999999999999E-2</c:v>
                </c:pt>
                <c:pt idx="392">
                  <c:v>1.7000000000000001E-2</c:v>
                </c:pt>
                <c:pt idx="393">
                  <c:v>1.6E-2</c:v>
                </c:pt>
                <c:pt idx="394">
                  <c:v>1.4E-2</c:v>
                </c:pt>
                <c:pt idx="395">
                  <c:v>1.2999999999999999E-2</c:v>
                </c:pt>
                <c:pt idx="396">
                  <c:v>1.2E-2</c:v>
                </c:pt>
                <c:pt idx="397">
                  <c:v>1.2E-2</c:v>
                </c:pt>
                <c:pt idx="398">
                  <c:v>1.0999999999999999E-2</c:v>
                </c:pt>
                <c:pt idx="399">
                  <c:v>1.0999999999999999E-2</c:v>
                </c:pt>
                <c:pt idx="400">
                  <c:v>0.01</c:v>
                </c:pt>
                <c:pt idx="401">
                  <c:v>0.01</c:v>
                </c:pt>
                <c:pt idx="402">
                  <c:v>1.0999999999999999E-2</c:v>
                </c:pt>
                <c:pt idx="403">
                  <c:v>1.0999999999999999E-2</c:v>
                </c:pt>
                <c:pt idx="404">
                  <c:v>1.2E-2</c:v>
                </c:pt>
                <c:pt idx="405">
                  <c:v>1.2E-2</c:v>
                </c:pt>
                <c:pt idx="406">
                  <c:v>1.2999999999999999E-2</c:v>
                </c:pt>
                <c:pt idx="407">
                  <c:v>1.4E-2</c:v>
                </c:pt>
                <c:pt idx="408">
                  <c:v>1.4999999999999999E-2</c:v>
                </c:pt>
                <c:pt idx="409">
                  <c:v>1.6E-2</c:v>
                </c:pt>
                <c:pt idx="410">
                  <c:v>1.7999999999999999E-2</c:v>
                </c:pt>
                <c:pt idx="411">
                  <c:v>1.9E-2</c:v>
                </c:pt>
                <c:pt idx="412">
                  <c:v>2.1000000000000001E-2</c:v>
                </c:pt>
                <c:pt idx="413">
                  <c:v>2.1999999999999999E-2</c:v>
                </c:pt>
                <c:pt idx="414">
                  <c:v>2.4E-2</c:v>
                </c:pt>
                <c:pt idx="415">
                  <c:v>2.5999999999999999E-2</c:v>
                </c:pt>
                <c:pt idx="416">
                  <c:v>2.8000000000000001E-2</c:v>
                </c:pt>
                <c:pt idx="417">
                  <c:v>0.03</c:v>
                </c:pt>
                <c:pt idx="418">
                  <c:v>3.2000000000000001E-2</c:v>
                </c:pt>
                <c:pt idx="419">
                  <c:v>3.4000000000000002E-2</c:v>
                </c:pt>
                <c:pt idx="420">
                  <c:v>3.5999999999999997E-2</c:v>
                </c:pt>
                <c:pt idx="421">
                  <c:v>4.2000000000000003E-2</c:v>
                </c:pt>
                <c:pt idx="422">
                  <c:v>0.06</c:v>
                </c:pt>
                <c:pt idx="423">
                  <c:v>6.2E-2</c:v>
                </c:pt>
                <c:pt idx="424">
                  <c:v>6.5000000000000002E-2</c:v>
                </c:pt>
                <c:pt idx="425">
                  <c:v>6.7000000000000004E-2</c:v>
                </c:pt>
                <c:pt idx="426">
                  <c:v>7.0000000000000007E-2</c:v>
                </c:pt>
                <c:pt idx="427">
                  <c:v>7.1999999999999995E-2</c:v>
                </c:pt>
                <c:pt idx="428">
                  <c:v>7.3999999999999996E-2</c:v>
                </c:pt>
                <c:pt idx="429">
                  <c:v>7.6999999999999999E-2</c:v>
                </c:pt>
                <c:pt idx="430">
                  <c:v>0.08</c:v>
                </c:pt>
                <c:pt idx="431">
                  <c:v>8.2000000000000003E-2</c:v>
                </c:pt>
                <c:pt idx="432">
                  <c:v>8.5000000000000006E-2</c:v>
                </c:pt>
                <c:pt idx="433">
                  <c:v>8.6999999999999994E-2</c:v>
                </c:pt>
                <c:pt idx="434">
                  <c:v>0.09</c:v>
                </c:pt>
                <c:pt idx="435">
                  <c:v>9.1999999999999998E-2</c:v>
                </c:pt>
                <c:pt idx="436">
                  <c:v>9.5000000000000001E-2</c:v>
                </c:pt>
                <c:pt idx="437">
                  <c:v>9.8000000000000004E-2</c:v>
                </c:pt>
                <c:pt idx="438">
                  <c:v>0.1</c:v>
                </c:pt>
                <c:pt idx="439">
                  <c:v>0.10299999999999999</c:v>
                </c:pt>
                <c:pt idx="440">
                  <c:v>0.105</c:v>
                </c:pt>
                <c:pt idx="441">
                  <c:v>0.108</c:v>
                </c:pt>
                <c:pt idx="442">
                  <c:v>0.11</c:v>
                </c:pt>
                <c:pt idx="443">
                  <c:v>0.113</c:v>
                </c:pt>
                <c:pt idx="444">
                  <c:v>0.115</c:v>
                </c:pt>
                <c:pt idx="445">
                  <c:v>0.11799999999999999</c:v>
                </c:pt>
                <c:pt idx="446">
                  <c:v>0.12</c:v>
                </c:pt>
                <c:pt idx="447">
                  <c:v>0.123</c:v>
                </c:pt>
                <c:pt idx="448">
                  <c:v>0.126</c:v>
                </c:pt>
                <c:pt idx="449">
                  <c:v>0.128</c:v>
                </c:pt>
                <c:pt idx="450">
                  <c:v>0.13100000000000001</c:v>
                </c:pt>
                <c:pt idx="451">
                  <c:v>0.13400000000000001</c:v>
                </c:pt>
                <c:pt idx="452">
                  <c:v>0.13700000000000001</c:v>
                </c:pt>
                <c:pt idx="453">
                  <c:v>0.13900000000000001</c:v>
                </c:pt>
                <c:pt idx="454">
                  <c:v>0.14199999999999999</c:v>
                </c:pt>
                <c:pt idx="455">
                  <c:v>0.14499999999999999</c:v>
                </c:pt>
                <c:pt idx="456">
                  <c:v>0.14799999999999999</c:v>
                </c:pt>
                <c:pt idx="457">
                  <c:v>0.15</c:v>
                </c:pt>
                <c:pt idx="458">
                  <c:v>0.152</c:v>
                </c:pt>
                <c:pt idx="459">
                  <c:v>0.154</c:v>
                </c:pt>
                <c:pt idx="460">
                  <c:v>0.156</c:v>
                </c:pt>
                <c:pt idx="461">
                  <c:v>0.14699999999999999</c:v>
                </c:pt>
                <c:pt idx="462">
                  <c:v>0.14199999999999999</c:v>
                </c:pt>
                <c:pt idx="463">
                  <c:v>0.14399999999999999</c:v>
                </c:pt>
                <c:pt idx="464">
                  <c:v>0.14499999999999999</c:v>
                </c:pt>
                <c:pt idx="465">
                  <c:v>0.14599999999999999</c:v>
                </c:pt>
                <c:pt idx="466">
                  <c:v>0.14699999999999999</c:v>
                </c:pt>
                <c:pt idx="467">
                  <c:v>0.14699999999999999</c:v>
                </c:pt>
                <c:pt idx="468">
                  <c:v>0.14799999999999999</c:v>
                </c:pt>
                <c:pt idx="469">
                  <c:v>0.14899999999999999</c:v>
                </c:pt>
                <c:pt idx="470">
                  <c:v>0.14899999999999999</c:v>
                </c:pt>
                <c:pt idx="471">
                  <c:v>0.14899999999999999</c:v>
                </c:pt>
                <c:pt idx="472">
                  <c:v>0.14899999999999999</c:v>
                </c:pt>
                <c:pt idx="473">
                  <c:v>0.14899999999999999</c:v>
                </c:pt>
                <c:pt idx="474">
                  <c:v>0.14899999999999999</c:v>
                </c:pt>
                <c:pt idx="475">
                  <c:v>0.14799999999999999</c:v>
                </c:pt>
                <c:pt idx="476">
                  <c:v>0.14699999999999999</c:v>
                </c:pt>
                <c:pt idx="477">
                  <c:v>0.14599999999999999</c:v>
                </c:pt>
                <c:pt idx="478">
                  <c:v>0.14499999999999999</c:v>
                </c:pt>
                <c:pt idx="479">
                  <c:v>0.14399999999999999</c:v>
                </c:pt>
                <c:pt idx="480">
                  <c:v>0.14199999999999999</c:v>
                </c:pt>
                <c:pt idx="481">
                  <c:v>0.14099999999999999</c:v>
                </c:pt>
                <c:pt idx="482">
                  <c:v>0.14000000000000001</c:v>
                </c:pt>
                <c:pt idx="483">
                  <c:v>0.13800000000000001</c:v>
                </c:pt>
                <c:pt idx="484">
                  <c:v>0.13600000000000001</c:v>
                </c:pt>
                <c:pt idx="485">
                  <c:v>0.13400000000000001</c:v>
                </c:pt>
                <c:pt idx="486">
                  <c:v>0.13300000000000001</c:v>
                </c:pt>
                <c:pt idx="487">
                  <c:v>0.13100000000000001</c:v>
                </c:pt>
                <c:pt idx="488">
                  <c:v>0.129</c:v>
                </c:pt>
                <c:pt idx="489">
                  <c:v>0.127</c:v>
                </c:pt>
                <c:pt idx="490">
                  <c:v>0.125</c:v>
                </c:pt>
                <c:pt idx="491">
                  <c:v>0.123</c:v>
                </c:pt>
                <c:pt idx="492">
                  <c:v>0.121</c:v>
                </c:pt>
                <c:pt idx="493">
                  <c:v>0.11899999999999999</c:v>
                </c:pt>
                <c:pt idx="494">
                  <c:v>0.11700000000000001</c:v>
                </c:pt>
                <c:pt idx="495">
                  <c:v>0.11600000000000001</c:v>
                </c:pt>
                <c:pt idx="496">
                  <c:v>0.115</c:v>
                </c:pt>
                <c:pt idx="497">
                  <c:v>0.114</c:v>
                </c:pt>
                <c:pt idx="498">
                  <c:v>0.113</c:v>
                </c:pt>
                <c:pt idx="499">
                  <c:v>0.112</c:v>
                </c:pt>
                <c:pt idx="500">
                  <c:v>0.112</c:v>
                </c:pt>
                <c:pt idx="501">
                  <c:v>0.112</c:v>
                </c:pt>
                <c:pt idx="502">
                  <c:v>0.112</c:v>
                </c:pt>
                <c:pt idx="503">
                  <c:v>0.112</c:v>
                </c:pt>
                <c:pt idx="504">
                  <c:v>0.112</c:v>
                </c:pt>
                <c:pt idx="505">
                  <c:v>0.113</c:v>
                </c:pt>
                <c:pt idx="506">
                  <c:v>0.113</c:v>
                </c:pt>
                <c:pt idx="507">
                  <c:v>0.114</c:v>
                </c:pt>
                <c:pt idx="508">
                  <c:v>0.115</c:v>
                </c:pt>
                <c:pt idx="509">
                  <c:v>0.11600000000000001</c:v>
                </c:pt>
                <c:pt idx="510">
                  <c:v>0.11700000000000001</c:v>
                </c:pt>
                <c:pt idx="511">
                  <c:v>0.11799999999999999</c:v>
                </c:pt>
                <c:pt idx="512">
                  <c:v>0.11799999999999999</c:v>
                </c:pt>
                <c:pt idx="513">
                  <c:v>0.11799999999999999</c:v>
                </c:pt>
                <c:pt idx="514">
                  <c:v>0.11899999999999999</c:v>
                </c:pt>
                <c:pt idx="515">
                  <c:v>0.11899999999999999</c:v>
                </c:pt>
                <c:pt idx="516">
                  <c:v>0.12</c:v>
                </c:pt>
                <c:pt idx="517">
                  <c:v>0.122</c:v>
                </c:pt>
                <c:pt idx="518">
                  <c:v>0.123</c:v>
                </c:pt>
                <c:pt idx="519">
                  <c:v>0.125</c:v>
                </c:pt>
                <c:pt idx="520">
                  <c:v>0.127</c:v>
                </c:pt>
                <c:pt idx="521">
                  <c:v>0.129</c:v>
                </c:pt>
                <c:pt idx="522">
                  <c:v>0.13200000000000001</c:v>
                </c:pt>
                <c:pt idx="523">
                  <c:v>0.13500000000000001</c:v>
                </c:pt>
                <c:pt idx="524">
                  <c:v>0.13900000000000001</c:v>
                </c:pt>
                <c:pt idx="525">
                  <c:v>0.14299999999999999</c:v>
                </c:pt>
                <c:pt idx="526">
                  <c:v>0.14899999999999999</c:v>
                </c:pt>
                <c:pt idx="527">
                  <c:v>0.155</c:v>
                </c:pt>
                <c:pt idx="528">
                  <c:v>0.161</c:v>
                </c:pt>
                <c:pt idx="529">
                  <c:v>0.16600000000000001</c:v>
                </c:pt>
                <c:pt idx="530">
                  <c:v>0.17</c:v>
                </c:pt>
                <c:pt idx="531">
                  <c:v>0.17399999999999999</c:v>
                </c:pt>
                <c:pt idx="532">
                  <c:v>0.17599999999999999</c:v>
                </c:pt>
                <c:pt idx="533">
                  <c:v>0.17599999999999999</c:v>
                </c:pt>
                <c:pt idx="534">
                  <c:v>0.17599999999999999</c:v>
                </c:pt>
                <c:pt idx="535">
                  <c:v>0.17499999999999999</c:v>
                </c:pt>
                <c:pt idx="536">
                  <c:v>0.17299999999999999</c:v>
                </c:pt>
                <c:pt idx="537">
                  <c:v>0.17100000000000001</c:v>
                </c:pt>
                <c:pt idx="538">
                  <c:v>0.16900000000000001</c:v>
                </c:pt>
                <c:pt idx="539">
                  <c:v>0.16700000000000001</c:v>
                </c:pt>
                <c:pt idx="540">
                  <c:v>0.16600000000000001</c:v>
                </c:pt>
                <c:pt idx="541">
                  <c:v>0.16500000000000001</c:v>
                </c:pt>
                <c:pt idx="542">
                  <c:v>0.16500000000000001</c:v>
                </c:pt>
                <c:pt idx="543">
                  <c:v>0.16400000000000001</c:v>
                </c:pt>
                <c:pt idx="544">
                  <c:v>0.16500000000000001</c:v>
                </c:pt>
                <c:pt idx="545">
                  <c:v>0.16500000000000001</c:v>
                </c:pt>
                <c:pt idx="546">
                  <c:v>0.16600000000000001</c:v>
                </c:pt>
                <c:pt idx="547">
                  <c:v>0.16700000000000001</c:v>
                </c:pt>
                <c:pt idx="548">
                  <c:v>0.17</c:v>
                </c:pt>
                <c:pt idx="549">
                  <c:v>0.17199999999999999</c:v>
                </c:pt>
                <c:pt idx="550">
                  <c:v>0.17599999999999999</c:v>
                </c:pt>
                <c:pt idx="551">
                  <c:v>0.18</c:v>
                </c:pt>
                <c:pt idx="552">
                  <c:v>0.184</c:v>
                </c:pt>
                <c:pt idx="553">
                  <c:v>0.189</c:v>
                </c:pt>
                <c:pt idx="554">
                  <c:v>0.193</c:v>
                </c:pt>
                <c:pt idx="555">
                  <c:v>0.19700000000000001</c:v>
                </c:pt>
                <c:pt idx="556">
                  <c:v>0.20100000000000001</c:v>
                </c:pt>
                <c:pt idx="557">
                  <c:v>0.20399999999999999</c:v>
                </c:pt>
                <c:pt idx="558">
                  <c:v>0.20699999999999999</c:v>
                </c:pt>
                <c:pt idx="559">
                  <c:v>0.21</c:v>
                </c:pt>
                <c:pt idx="560">
                  <c:v>0.21299999999999999</c:v>
                </c:pt>
                <c:pt idx="561">
                  <c:v>0.216</c:v>
                </c:pt>
                <c:pt idx="562">
                  <c:v>0.22</c:v>
                </c:pt>
                <c:pt idx="563">
                  <c:v>0.224</c:v>
                </c:pt>
                <c:pt idx="564">
                  <c:v>0.22900000000000001</c:v>
                </c:pt>
                <c:pt idx="565">
                  <c:v>0.23499999999999999</c:v>
                </c:pt>
                <c:pt idx="566">
                  <c:v>0.24099999999999999</c:v>
                </c:pt>
                <c:pt idx="567">
                  <c:v>0.248</c:v>
                </c:pt>
                <c:pt idx="568">
                  <c:v>0.25600000000000001</c:v>
                </c:pt>
                <c:pt idx="569">
                  <c:v>0.26600000000000001</c:v>
                </c:pt>
                <c:pt idx="570">
                  <c:v>0.27800000000000002</c:v>
                </c:pt>
                <c:pt idx="571">
                  <c:v>0.29199999999999998</c:v>
                </c:pt>
                <c:pt idx="572">
                  <c:v>0.307</c:v>
                </c:pt>
                <c:pt idx="573">
                  <c:v>0.32500000000000001</c:v>
                </c:pt>
                <c:pt idx="574">
                  <c:v>0.34499999999999997</c:v>
                </c:pt>
                <c:pt idx="575">
                  <c:v>0.36499999999999999</c:v>
                </c:pt>
                <c:pt idx="576">
                  <c:v>0.38800000000000001</c:v>
                </c:pt>
                <c:pt idx="577">
                  <c:v>0.40899999999999997</c:v>
                </c:pt>
                <c:pt idx="578">
                  <c:v>0.432</c:v>
                </c:pt>
                <c:pt idx="579">
                  <c:v>0.45400000000000001</c:v>
                </c:pt>
                <c:pt idx="580">
                  <c:v>0.47799999999999998</c:v>
                </c:pt>
                <c:pt idx="581">
                  <c:v>0.502</c:v>
                </c:pt>
                <c:pt idx="582">
                  <c:v>0.52700000000000002</c:v>
                </c:pt>
                <c:pt idx="583">
                  <c:v>0.55300000000000005</c:v>
                </c:pt>
                <c:pt idx="584">
                  <c:v>0.57999999999999996</c:v>
                </c:pt>
                <c:pt idx="585">
                  <c:v>0.60899999999999999</c:v>
                </c:pt>
                <c:pt idx="586">
                  <c:v>0.64</c:v>
                </c:pt>
                <c:pt idx="587">
                  <c:v>0.67700000000000005</c:v>
                </c:pt>
                <c:pt idx="588">
                  <c:v>0.71399999999999997</c:v>
                </c:pt>
                <c:pt idx="589">
                  <c:v>0.752</c:v>
                </c:pt>
                <c:pt idx="590">
                  <c:v>0.79100000000000004</c:v>
                </c:pt>
                <c:pt idx="591">
                  <c:v>0.82899999999999996</c:v>
                </c:pt>
                <c:pt idx="592">
                  <c:v>0.86499999999999999</c:v>
                </c:pt>
                <c:pt idx="593">
                  <c:v>0.89700000000000002</c:v>
                </c:pt>
                <c:pt idx="594">
                  <c:v>0.92200000000000004</c:v>
                </c:pt>
                <c:pt idx="595">
                  <c:v>0.93799999999999994</c:v>
                </c:pt>
                <c:pt idx="596">
                  <c:v>0.93899999999999995</c:v>
                </c:pt>
                <c:pt idx="597">
                  <c:v>0.91400000000000003</c:v>
                </c:pt>
                <c:pt idx="598">
                  <c:v>0.84699999999999998</c:v>
                </c:pt>
                <c:pt idx="599">
                  <c:v>0.71399999999999997</c:v>
                </c:pt>
                <c:pt idx="600">
                  <c:v>0.49099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F1C9-4266-924C-4F616B8627F9}"/>
            </c:ext>
          </c:extLst>
        </c:ser>
        <c:ser>
          <c:idx val="3"/>
          <c:order val="3"/>
          <c:tx>
            <c:strRef>
              <c:f>'Methanol-F'!$E$2</c:f>
              <c:strCache>
                <c:ptCount val="1"/>
                <c:pt idx="0">
                  <c:v>Mustard</c:v>
                </c:pt>
              </c:strCache>
            </c:strRef>
          </c:tx>
          <c:spPr>
            <a:ln>
              <a:prstDash val="dash"/>
            </a:ln>
          </c:spPr>
          <c:marker>
            <c:symbol val="none"/>
          </c:marker>
          <c:xVal>
            <c:numRef>
              <c:f>'Methanol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Methanol-F'!$E$3:$E$603</c:f>
              <c:numCache>
                <c:formatCode>General</c:formatCode>
                <c:ptCount val="601"/>
                <c:pt idx="0">
                  <c:v>-6.0000000000000001E-3</c:v>
                </c:pt>
                <c:pt idx="1">
                  <c:v>-5.0000000000000001E-3</c:v>
                </c:pt>
                <c:pt idx="2">
                  <c:v>-6.0000000000000001E-3</c:v>
                </c:pt>
                <c:pt idx="3">
                  <c:v>-6.0000000000000001E-3</c:v>
                </c:pt>
                <c:pt idx="4">
                  <c:v>-6.0000000000000001E-3</c:v>
                </c:pt>
                <c:pt idx="5">
                  <c:v>-6.0000000000000001E-3</c:v>
                </c:pt>
                <c:pt idx="6">
                  <c:v>-6.0000000000000001E-3</c:v>
                </c:pt>
                <c:pt idx="7">
                  <c:v>-6.0000000000000001E-3</c:v>
                </c:pt>
                <c:pt idx="8">
                  <c:v>-6.0000000000000001E-3</c:v>
                </c:pt>
                <c:pt idx="9">
                  <c:v>-7.0000000000000001E-3</c:v>
                </c:pt>
                <c:pt idx="10">
                  <c:v>-7.0000000000000001E-3</c:v>
                </c:pt>
                <c:pt idx="11">
                  <c:v>-7.0000000000000001E-3</c:v>
                </c:pt>
                <c:pt idx="12">
                  <c:v>-7.0000000000000001E-3</c:v>
                </c:pt>
                <c:pt idx="13">
                  <c:v>-7.0000000000000001E-3</c:v>
                </c:pt>
                <c:pt idx="14">
                  <c:v>-7.0000000000000001E-3</c:v>
                </c:pt>
                <c:pt idx="15">
                  <c:v>-8.0000000000000002E-3</c:v>
                </c:pt>
                <c:pt idx="16">
                  <c:v>-8.0000000000000002E-3</c:v>
                </c:pt>
                <c:pt idx="17">
                  <c:v>-8.0000000000000002E-3</c:v>
                </c:pt>
                <c:pt idx="18">
                  <c:v>-8.0000000000000002E-3</c:v>
                </c:pt>
                <c:pt idx="19">
                  <c:v>-8.0000000000000002E-3</c:v>
                </c:pt>
                <c:pt idx="20">
                  <c:v>-8.0000000000000002E-3</c:v>
                </c:pt>
                <c:pt idx="21">
                  <c:v>-8.0000000000000002E-3</c:v>
                </c:pt>
                <c:pt idx="22">
                  <c:v>-8.0000000000000002E-3</c:v>
                </c:pt>
                <c:pt idx="23">
                  <c:v>-8.9999999999999993E-3</c:v>
                </c:pt>
                <c:pt idx="24">
                  <c:v>-8.9999999999999993E-3</c:v>
                </c:pt>
                <c:pt idx="25">
                  <c:v>-8.9999999999999993E-3</c:v>
                </c:pt>
                <c:pt idx="26">
                  <c:v>-8.9999999999999993E-3</c:v>
                </c:pt>
                <c:pt idx="27">
                  <c:v>-8.9999999999999993E-3</c:v>
                </c:pt>
                <c:pt idx="28">
                  <c:v>-8.9999999999999993E-3</c:v>
                </c:pt>
                <c:pt idx="29">
                  <c:v>-8.9999999999999993E-3</c:v>
                </c:pt>
                <c:pt idx="30">
                  <c:v>-0.01</c:v>
                </c:pt>
                <c:pt idx="31">
                  <c:v>-0.01</c:v>
                </c:pt>
                <c:pt idx="32">
                  <c:v>-0.01</c:v>
                </c:pt>
                <c:pt idx="33">
                  <c:v>-0.01</c:v>
                </c:pt>
                <c:pt idx="34">
                  <c:v>-0.01</c:v>
                </c:pt>
                <c:pt idx="35">
                  <c:v>-0.01</c:v>
                </c:pt>
                <c:pt idx="36">
                  <c:v>-0.01</c:v>
                </c:pt>
                <c:pt idx="37">
                  <c:v>-0.01</c:v>
                </c:pt>
                <c:pt idx="38">
                  <c:v>-0.01</c:v>
                </c:pt>
                <c:pt idx="39">
                  <c:v>-0.01</c:v>
                </c:pt>
                <c:pt idx="40">
                  <c:v>-1.0999999999999999E-2</c:v>
                </c:pt>
                <c:pt idx="41">
                  <c:v>-1.0999999999999999E-2</c:v>
                </c:pt>
                <c:pt idx="42">
                  <c:v>-1.2E-2</c:v>
                </c:pt>
                <c:pt idx="43">
                  <c:v>-1.2E-2</c:v>
                </c:pt>
                <c:pt idx="44">
                  <c:v>-1.2E-2</c:v>
                </c:pt>
                <c:pt idx="45">
                  <c:v>-1.2E-2</c:v>
                </c:pt>
                <c:pt idx="46">
                  <c:v>-1.2E-2</c:v>
                </c:pt>
                <c:pt idx="47">
                  <c:v>-1.2E-2</c:v>
                </c:pt>
                <c:pt idx="48">
                  <c:v>-1.2E-2</c:v>
                </c:pt>
                <c:pt idx="49">
                  <c:v>-1.2E-2</c:v>
                </c:pt>
                <c:pt idx="50">
                  <c:v>-1.2E-2</c:v>
                </c:pt>
                <c:pt idx="51">
                  <c:v>-1.2E-2</c:v>
                </c:pt>
                <c:pt idx="52">
                  <c:v>-1.2E-2</c:v>
                </c:pt>
                <c:pt idx="53">
                  <c:v>-1.2E-2</c:v>
                </c:pt>
                <c:pt idx="54">
                  <c:v>-1.2999999999999999E-2</c:v>
                </c:pt>
                <c:pt idx="55">
                  <c:v>-1.2999999999999999E-2</c:v>
                </c:pt>
                <c:pt idx="56">
                  <c:v>-1.4E-2</c:v>
                </c:pt>
                <c:pt idx="57">
                  <c:v>-1.4999999999999999E-2</c:v>
                </c:pt>
                <c:pt idx="58">
                  <c:v>-1.6E-2</c:v>
                </c:pt>
                <c:pt idx="59">
                  <c:v>-1.7999999999999999E-2</c:v>
                </c:pt>
                <c:pt idx="60">
                  <c:v>-1.9E-2</c:v>
                </c:pt>
                <c:pt idx="61">
                  <c:v>-0.02</c:v>
                </c:pt>
                <c:pt idx="62">
                  <c:v>-2.1000000000000001E-2</c:v>
                </c:pt>
                <c:pt idx="63">
                  <c:v>-2.1000000000000001E-2</c:v>
                </c:pt>
                <c:pt idx="64">
                  <c:v>-2.1000000000000001E-2</c:v>
                </c:pt>
                <c:pt idx="65">
                  <c:v>-2.1000000000000001E-2</c:v>
                </c:pt>
                <c:pt idx="66">
                  <c:v>-2.1000000000000001E-2</c:v>
                </c:pt>
                <c:pt idx="67">
                  <c:v>-2.1000000000000001E-2</c:v>
                </c:pt>
                <c:pt idx="68">
                  <c:v>-2.1000000000000001E-2</c:v>
                </c:pt>
                <c:pt idx="69">
                  <c:v>-2.1000000000000001E-2</c:v>
                </c:pt>
                <c:pt idx="70">
                  <c:v>-2.1000000000000001E-2</c:v>
                </c:pt>
                <c:pt idx="71">
                  <c:v>-2.1000000000000001E-2</c:v>
                </c:pt>
                <c:pt idx="72">
                  <c:v>-2.1000000000000001E-2</c:v>
                </c:pt>
                <c:pt idx="73">
                  <c:v>-2.1000000000000001E-2</c:v>
                </c:pt>
                <c:pt idx="74">
                  <c:v>-2.1999999999999999E-2</c:v>
                </c:pt>
                <c:pt idx="75">
                  <c:v>-2.1999999999999999E-2</c:v>
                </c:pt>
                <c:pt idx="76">
                  <c:v>-2.1999999999999999E-2</c:v>
                </c:pt>
                <c:pt idx="77">
                  <c:v>-2.1999999999999999E-2</c:v>
                </c:pt>
                <c:pt idx="78">
                  <c:v>-2.1999999999999999E-2</c:v>
                </c:pt>
                <c:pt idx="79">
                  <c:v>-2.1999999999999999E-2</c:v>
                </c:pt>
                <c:pt idx="80">
                  <c:v>-2.1999999999999999E-2</c:v>
                </c:pt>
                <c:pt idx="81">
                  <c:v>-2.1999999999999999E-2</c:v>
                </c:pt>
                <c:pt idx="82">
                  <c:v>-2.1999999999999999E-2</c:v>
                </c:pt>
                <c:pt idx="83">
                  <c:v>-2.1999999999999999E-2</c:v>
                </c:pt>
                <c:pt idx="84">
                  <c:v>-2.3E-2</c:v>
                </c:pt>
                <c:pt idx="85">
                  <c:v>-2.3E-2</c:v>
                </c:pt>
                <c:pt idx="86">
                  <c:v>-2.3E-2</c:v>
                </c:pt>
                <c:pt idx="87">
                  <c:v>-2.3E-2</c:v>
                </c:pt>
                <c:pt idx="88">
                  <c:v>-2.3E-2</c:v>
                </c:pt>
                <c:pt idx="89">
                  <c:v>-2.3E-2</c:v>
                </c:pt>
                <c:pt idx="90">
                  <c:v>-2.3E-2</c:v>
                </c:pt>
                <c:pt idx="91">
                  <c:v>-2.3E-2</c:v>
                </c:pt>
                <c:pt idx="92">
                  <c:v>-2.3E-2</c:v>
                </c:pt>
                <c:pt idx="93">
                  <c:v>-2.3E-2</c:v>
                </c:pt>
                <c:pt idx="94">
                  <c:v>-2.3E-2</c:v>
                </c:pt>
                <c:pt idx="95">
                  <c:v>-2.3E-2</c:v>
                </c:pt>
                <c:pt idx="96">
                  <c:v>-2.4E-2</c:v>
                </c:pt>
                <c:pt idx="97">
                  <c:v>-2.4E-2</c:v>
                </c:pt>
                <c:pt idx="98">
                  <c:v>-2.4E-2</c:v>
                </c:pt>
                <c:pt idx="99">
                  <c:v>-2.4E-2</c:v>
                </c:pt>
                <c:pt idx="100">
                  <c:v>-2.4E-2</c:v>
                </c:pt>
                <c:pt idx="101">
                  <c:v>-2.4E-2</c:v>
                </c:pt>
                <c:pt idx="102">
                  <c:v>-2.4E-2</c:v>
                </c:pt>
                <c:pt idx="103">
                  <c:v>-2.4E-2</c:v>
                </c:pt>
                <c:pt idx="104">
                  <c:v>-2.4E-2</c:v>
                </c:pt>
                <c:pt idx="105">
                  <c:v>-2.3E-2</c:v>
                </c:pt>
                <c:pt idx="106">
                  <c:v>-2.3E-2</c:v>
                </c:pt>
                <c:pt idx="107">
                  <c:v>-2.3E-2</c:v>
                </c:pt>
                <c:pt idx="108">
                  <c:v>-2.3E-2</c:v>
                </c:pt>
                <c:pt idx="109">
                  <c:v>-2.3E-2</c:v>
                </c:pt>
                <c:pt idx="110">
                  <c:v>-2.1999999999999999E-2</c:v>
                </c:pt>
                <c:pt idx="111">
                  <c:v>-2.1999999999999999E-2</c:v>
                </c:pt>
                <c:pt idx="112">
                  <c:v>-2.1000000000000001E-2</c:v>
                </c:pt>
                <c:pt idx="113">
                  <c:v>-0.02</c:v>
                </c:pt>
                <c:pt idx="114">
                  <c:v>-1.9E-2</c:v>
                </c:pt>
                <c:pt idx="115">
                  <c:v>-1.7999999999999999E-2</c:v>
                </c:pt>
                <c:pt idx="116">
                  <c:v>-1.7000000000000001E-2</c:v>
                </c:pt>
                <c:pt idx="117">
                  <c:v>-1.4999999999999999E-2</c:v>
                </c:pt>
                <c:pt idx="118">
                  <c:v>-1.4E-2</c:v>
                </c:pt>
                <c:pt idx="119">
                  <c:v>-1.0999999999999999E-2</c:v>
                </c:pt>
                <c:pt idx="120">
                  <c:v>-8.9999999999999993E-3</c:v>
                </c:pt>
                <c:pt idx="121">
                  <c:v>-6.0000000000000001E-3</c:v>
                </c:pt>
                <c:pt idx="122">
                  <c:v>-3.0000000000000001E-3</c:v>
                </c:pt>
                <c:pt idx="123">
                  <c:v>0</c:v>
                </c:pt>
                <c:pt idx="124">
                  <c:v>3.0000000000000001E-3</c:v>
                </c:pt>
                <c:pt idx="125">
                  <c:v>7.0000000000000001E-3</c:v>
                </c:pt>
                <c:pt idx="126">
                  <c:v>1.0999999999999999E-2</c:v>
                </c:pt>
                <c:pt idx="127">
                  <c:v>1.4999999999999999E-2</c:v>
                </c:pt>
                <c:pt idx="128">
                  <c:v>1.9E-2</c:v>
                </c:pt>
                <c:pt idx="129">
                  <c:v>2.3E-2</c:v>
                </c:pt>
                <c:pt idx="130">
                  <c:v>2.5999999999999999E-2</c:v>
                </c:pt>
                <c:pt idx="131">
                  <c:v>0.03</c:v>
                </c:pt>
                <c:pt idx="132">
                  <c:v>3.3000000000000002E-2</c:v>
                </c:pt>
                <c:pt idx="133">
                  <c:v>3.5000000000000003E-2</c:v>
                </c:pt>
                <c:pt idx="134">
                  <c:v>3.6999999999999998E-2</c:v>
                </c:pt>
                <c:pt idx="135">
                  <c:v>3.7999999999999999E-2</c:v>
                </c:pt>
                <c:pt idx="136">
                  <c:v>3.7999999999999999E-2</c:v>
                </c:pt>
                <c:pt idx="137">
                  <c:v>3.7999999999999999E-2</c:v>
                </c:pt>
                <c:pt idx="138">
                  <c:v>3.6999999999999998E-2</c:v>
                </c:pt>
                <c:pt idx="139">
                  <c:v>3.5000000000000003E-2</c:v>
                </c:pt>
                <c:pt idx="140">
                  <c:v>3.3000000000000002E-2</c:v>
                </c:pt>
                <c:pt idx="141">
                  <c:v>3.1E-2</c:v>
                </c:pt>
                <c:pt idx="142">
                  <c:v>2.9000000000000001E-2</c:v>
                </c:pt>
                <c:pt idx="143">
                  <c:v>2.5999999999999999E-2</c:v>
                </c:pt>
                <c:pt idx="144">
                  <c:v>2.3E-2</c:v>
                </c:pt>
                <c:pt idx="145">
                  <c:v>0.02</c:v>
                </c:pt>
                <c:pt idx="146">
                  <c:v>1.7999999999999999E-2</c:v>
                </c:pt>
                <c:pt idx="147">
                  <c:v>1.4999999999999999E-2</c:v>
                </c:pt>
                <c:pt idx="148">
                  <c:v>1.2999999999999999E-2</c:v>
                </c:pt>
                <c:pt idx="149">
                  <c:v>0.01</c:v>
                </c:pt>
                <c:pt idx="150">
                  <c:v>8.0000000000000002E-3</c:v>
                </c:pt>
                <c:pt idx="151">
                  <c:v>6.0000000000000001E-3</c:v>
                </c:pt>
                <c:pt idx="152">
                  <c:v>4.0000000000000001E-3</c:v>
                </c:pt>
                <c:pt idx="153">
                  <c:v>2E-3</c:v>
                </c:pt>
                <c:pt idx="154">
                  <c:v>1E-3</c:v>
                </c:pt>
                <c:pt idx="155">
                  <c:v>-1E-3</c:v>
                </c:pt>
                <c:pt idx="156">
                  <c:v>-2E-3</c:v>
                </c:pt>
                <c:pt idx="157">
                  <c:v>-3.0000000000000001E-3</c:v>
                </c:pt>
                <c:pt idx="158">
                  <c:v>-5.0000000000000001E-3</c:v>
                </c:pt>
                <c:pt idx="159">
                  <c:v>-6.0000000000000001E-3</c:v>
                </c:pt>
                <c:pt idx="160">
                  <c:v>-6.0000000000000001E-3</c:v>
                </c:pt>
                <c:pt idx="161">
                  <c:v>-7.0000000000000001E-3</c:v>
                </c:pt>
                <c:pt idx="162">
                  <c:v>-8.0000000000000002E-3</c:v>
                </c:pt>
                <c:pt idx="163">
                  <c:v>-8.9999999999999993E-3</c:v>
                </c:pt>
                <c:pt idx="164">
                  <c:v>-0.01</c:v>
                </c:pt>
                <c:pt idx="165">
                  <c:v>-0.01</c:v>
                </c:pt>
                <c:pt idx="166">
                  <c:v>-1.0999999999999999E-2</c:v>
                </c:pt>
                <c:pt idx="167">
                  <c:v>-1.0999999999999999E-2</c:v>
                </c:pt>
                <c:pt idx="168">
                  <c:v>-1.2E-2</c:v>
                </c:pt>
                <c:pt idx="169">
                  <c:v>-1.2E-2</c:v>
                </c:pt>
                <c:pt idx="170">
                  <c:v>-1.2E-2</c:v>
                </c:pt>
                <c:pt idx="171">
                  <c:v>-1.2999999999999999E-2</c:v>
                </c:pt>
                <c:pt idx="172">
                  <c:v>-1.2999999999999999E-2</c:v>
                </c:pt>
                <c:pt idx="173">
                  <c:v>-1.2999999999999999E-2</c:v>
                </c:pt>
                <c:pt idx="174">
                  <c:v>-1.2999999999999999E-2</c:v>
                </c:pt>
                <c:pt idx="175">
                  <c:v>-1.2999999999999999E-2</c:v>
                </c:pt>
                <c:pt idx="176">
                  <c:v>-1.2999999999999999E-2</c:v>
                </c:pt>
                <c:pt idx="177">
                  <c:v>-1.2999999999999999E-2</c:v>
                </c:pt>
                <c:pt idx="178">
                  <c:v>-1.2999999999999999E-2</c:v>
                </c:pt>
                <c:pt idx="179">
                  <c:v>-1.2999999999999999E-2</c:v>
                </c:pt>
                <c:pt idx="180">
                  <c:v>-1.2999999999999999E-2</c:v>
                </c:pt>
                <c:pt idx="181">
                  <c:v>-1.2999999999999999E-2</c:v>
                </c:pt>
                <c:pt idx="182">
                  <c:v>-1.2999999999999999E-2</c:v>
                </c:pt>
                <c:pt idx="183">
                  <c:v>-1.2999999999999999E-2</c:v>
                </c:pt>
                <c:pt idx="184">
                  <c:v>-1.2999999999999999E-2</c:v>
                </c:pt>
                <c:pt idx="185">
                  <c:v>-1.2999999999999999E-2</c:v>
                </c:pt>
                <c:pt idx="186">
                  <c:v>-1.2999999999999999E-2</c:v>
                </c:pt>
                <c:pt idx="187">
                  <c:v>-1.2999999999999999E-2</c:v>
                </c:pt>
                <c:pt idx="188">
                  <c:v>-1.2999999999999999E-2</c:v>
                </c:pt>
                <c:pt idx="189">
                  <c:v>-1.2999999999999999E-2</c:v>
                </c:pt>
                <c:pt idx="190">
                  <c:v>-1.4E-2</c:v>
                </c:pt>
                <c:pt idx="191">
                  <c:v>-1.4E-2</c:v>
                </c:pt>
                <c:pt idx="192">
                  <c:v>-1.4E-2</c:v>
                </c:pt>
                <c:pt idx="193">
                  <c:v>-1.4E-2</c:v>
                </c:pt>
                <c:pt idx="194">
                  <c:v>-1.4999999999999999E-2</c:v>
                </c:pt>
                <c:pt idx="195">
                  <c:v>-1.4999999999999999E-2</c:v>
                </c:pt>
                <c:pt idx="196">
                  <c:v>-1.4999999999999999E-2</c:v>
                </c:pt>
                <c:pt idx="197">
                  <c:v>-1.6E-2</c:v>
                </c:pt>
                <c:pt idx="198">
                  <c:v>-1.6E-2</c:v>
                </c:pt>
                <c:pt idx="199">
                  <c:v>-1.7000000000000001E-2</c:v>
                </c:pt>
                <c:pt idx="200">
                  <c:v>-1.7000000000000001E-2</c:v>
                </c:pt>
                <c:pt idx="201">
                  <c:v>-1.7999999999999999E-2</c:v>
                </c:pt>
                <c:pt idx="202">
                  <c:v>-1.9E-2</c:v>
                </c:pt>
                <c:pt idx="203">
                  <c:v>-1.9E-2</c:v>
                </c:pt>
                <c:pt idx="204">
                  <c:v>-1.9E-2</c:v>
                </c:pt>
                <c:pt idx="205">
                  <c:v>-0.02</c:v>
                </c:pt>
                <c:pt idx="206">
                  <c:v>-0.02</c:v>
                </c:pt>
                <c:pt idx="207">
                  <c:v>-0.02</c:v>
                </c:pt>
                <c:pt idx="208">
                  <c:v>-2.1000000000000001E-2</c:v>
                </c:pt>
                <c:pt idx="209">
                  <c:v>-2.1000000000000001E-2</c:v>
                </c:pt>
                <c:pt idx="210">
                  <c:v>-2.1000000000000001E-2</c:v>
                </c:pt>
                <c:pt idx="211">
                  <c:v>-2.1999999999999999E-2</c:v>
                </c:pt>
                <c:pt idx="212">
                  <c:v>-2.1999999999999999E-2</c:v>
                </c:pt>
                <c:pt idx="213">
                  <c:v>-2.3E-2</c:v>
                </c:pt>
                <c:pt idx="214">
                  <c:v>-2.3E-2</c:v>
                </c:pt>
                <c:pt idx="215">
                  <c:v>-2.4E-2</c:v>
                </c:pt>
                <c:pt idx="216">
                  <c:v>-2.5000000000000001E-2</c:v>
                </c:pt>
                <c:pt idx="217">
                  <c:v>-2.5000000000000001E-2</c:v>
                </c:pt>
                <c:pt idx="218">
                  <c:v>-2.5999999999999999E-2</c:v>
                </c:pt>
                <c:pt idx="219">
                  <c:v>-2.7E-2</c:v>
                </c:pt>
                <c:pt idx="220">
                  <c:v>-2.7E-2</c:v>
                </c:pt>
                <c:pt idx="221">
                  <c:v>-2.7E-2</c:v>
                </c:pt>
                <c:pt idx="222">
                  <c:v>-2.8000000000000001E-2</c:v>
                </c:pt>
                <c:pt idx="223">
                  <c:v>-2.8000000000000001E-2</c:v>
                </c:pt>
                <c:pt idx="224">
                  <c:v>-2.8000000000000001E-2</c:v>
                </c:pt>
                <c:pt idx="225">
                  <c:v>-2.7E-2</c:v>
                </c:pt>
                <c:pt idx="226">
                  <c:v>-2.7E-2</c:v>
                </c:pt>
                <c:pt idx="227">
                  <c:v>-2.8000000000000001E-2</c:v>
                </c:pt>
                <c:pt idx="228">
                  <c:v>-2.8000000000000001E-2</c:v>
                </c:pt>
                <c:pt idx="229">
                  <c:v>-2.8000000000000001E-2</c:v>
                </c:pt>
                <c:pt idx="230">
                  <c:v>-2.8000000000000001E-2</c:v>
                </c:pt>
                <c:pt idx="231">
                  <c:v>-2.8000000000000001E-2</c:v>
                </c:pt>
                <c:pt idx="232">
                  <c:v>-2.8000000000000001E-2</c:v>
                </c:pt>
                <c:pt idx="233">
                  <c:v>-2.8000000000000001E-2</c:v>
                </c:pt>
                <c:pt idx="234">
                  <c:v>-2.9000000000000001E-2</c:v>
                </c:pt>
                <c:pt idx="235">
                  <c:v>-2.9000000000000001E-2</c:v>
                </c:pt>
                <c:pt idx="236">
                  <c:v>-2.9000000000000001E-2</c:v>
                </c:pt>
                <c:pt idx="237">
                  <c:v>-2.9000000000000001E-2</c:v>
                </c:pt>
                <c:pt idx="238">
                  <c:v>-2.9000000000000001E-2</c:v>
                </c:pt>
                <c:pt idx="239">
                  <c:v>-2.9000000000000001E-2</c:v>
                </c:pt>
                <c:pt idx="240">
                  <c:v>-2.9000000000000001E-2</c:v>
                </c:pt>
                <c:pt idx="241">
                  <c:v>-2.9000000000000001E-2</c:v>
                </c:pt>
                <c:pt idx="242">
                  <c:v>-0.03</c:v>
                </c:pt>
                <c:pt idx="243">
                  <c:v>-0.03</c:v>
                </c:pt>
                <c:pt idx="244">
                  <c:v>-0.03</c:v>
                </c:pt>
                <c:pt idx="245">
                  <c:v>-0.03</c:v>
                </c:pt>
                <c:pt idx="246">
                  <c:v>-0.03</c:v>
                </c:pt>
                <c:pt idx="247">
                  <c:v>-0.03</c:v>
                </c:pt>
                <c:pt idx="248">
                  <c:v>-0.03</c:v>
                </c:pt>
                <c:pt idx="249">
                  <c:v>-0.03</c:v>
                </c:pt>
                <c:pt idx="250">
                  <c:v>-0.03</c:v>
                </c:pt>
                <c:pt idx="251">
                  <c:v>-3.1E-2</c:v>
                </c:pt>
                <c:pt idx="252">
                  <c:v>-3.1E-2</c:v>
                </c:pt>
                <c:pt idx="253">
                  <c:v>-3.1E-2</c:v>
                </c:pt>
                <c:pt idx="254">
                  <c:v>-3.1E-2</c:v>
                </c:pt>
                <c:pt idx="255">
                  <c:v>-3.1E-2</c:v>
                </c:pt>
                <c:pt idx="256">
                  <c:v>-3.1E-2</c:v>
                </c:pt>
                <c:pt idx="257">
                  <c:v>-3.1E-2</c:v>
                </c:pt>
                <c:pt idx="258">
                  <c:v>-3.1E-2</c:v>
                </c:pt>
                <c:pt idx="259">
                  <c:v>-3.1E-2</c:v>
                </c:pt>
                <c:pt idx="260">
                  <c:v>-3.1E-2</c:v>
                </c:pt>
                <c:pt idx="261">
                  <c:v>-3.1E-2</c:v>
                </c:pt>
                <c:pt idx="262">
                  <c:v>-3.2000000000000001E-2</c:v>
                </c:pt>
                <c:pt idx="263">
                  <c:v>-3.2000000000000001E-2</c:v>
                </c:pt>
                <c:pt idx="264">
                  <c:v>-3.2000000000000001E-2</c:v>
                </c:pt>
                <c:pt idx="265">
                  <c:v>-3.2000000000000001E-2</c:v>
                </c:pt>
                <c:pt idx="266">
                  <c:v>-3.2000000000000001E-2</c:v>
                </c:pt>
                <c:pt idx="267">
                  <c:v>-3.2000000000000001E-2</c:v>
                </c:pt>
                <c:pt idx="268">
                  <c:v>-3.2000000000000001E-2</c:v>
                </c:pt>
                <c:pt idx="269">
                  <c:v>-3.2000000000000001E-2</c:v>
                </c:pt>
                <c:pt idx="270">
                  <c:v>-3.3000000000000002E-2</c:v>
                </c:pt>
                <c:pt idx="271">
                  <c:v>-3.3000000000000002E-2</c:v>
                </c:pt>
                <c:pt idx="272">
                  <c:v>-3.3000000000000002E-2</c:v>
                </c:pt>
                <c:pt idx="273">
                  <c:v>-3.3000000000000002E-2</c:v>
                </c:pt>
                <c:pt idx="274">
                  <c:v>-3.3000000000000002E-2</c:v>
                </c:pt>
                <c:pt idx="275">
                  <c:v>-3.3000000000000002E-2</c:v>
                </c:pt>
                <c:pt idx="276">
                  <c:v>-3.3000000000000002E-2</c:v>
                </c:pt>
                <c:pt idx="277">
                  <c:v>-3.4000000000000002E-2</c:v>
                </c:pt>
                <c:pt idx="278">
                  <c:v>-3.4000000000000002E-2</c:v>
                </c:pt>
                <c:pt idx="279">
                  <c:v>-3.4000000000000002E-2</c:v>
                </c:pt>
                <c:pt idx="280">
                  <c:v>-3.4000000000000002E-2</c:v>
                </c:pt>
                <c:pt idx="281">
                  <c:v>-3.4000000000000002E-2</c:v>
                </c:pt>
                <c:pt idx="282">
                  <c:v>-3.4000000000000002E-2</c:v>
                </c:pt>
                <c:pt idx="283">
                  <c:v>-3.4000000000000002E-2</c:v>
                </c:pt>
                <c:pt idx="284">
                  <c:v>-3.4000000000000002E-2</c:v>
                </c:pt>
                <c:pt idx="285">
                  <c:v>-3.4000000000000002E-2</c:v>
                </c:pt>
                <c:pt idx="286">
                  <c:v>-3.4000000000000002E-2</c:v>
                </c:pt>
                <c:pt idx="287">
                  <c:v>-3.4000000000000002E-2</c:v>
                </c:pt>
                <c:pt idx="288">
                  <c:v>-3.4000000000000002E-2</c:v>
                </c:pt>
                <c:pt idx="289">
                  <c:v>-3.4000000000000002E-2</c:v>
                </c:pt>
                <c:pt idx="290">
                  <c:v>-3.4000000000000002E-2</c:v>
                </c:pt>
                <c:pt idx="291">
                  <c:v>-3.4000000000000002E-2</c:v>
                </c:pt>
                <c:pt idx="292">
                  <c:v>-3.4000000000000002E-2</c:v>
                </c:pt>
                <c:pt idx="293">
                  <c:v>-3.4000000000000002E-2</c:v>
                </c:pt>
                <c:pt idx="294">
                  <c:v>-3.3000000000000002E-2</c:v>
                </c:pt>
                <c:pt idx="295">
                  <c:v>-3.3000000000000002E-2</c:v>
                </c:pt>
                <c:pt idx="296">
                  <c:v>-3.3000000000000002E-2</c:v>
                </c:pt>
                <c:pt idx="297">
                  <c:v>-3.2000000000000001E-2</c:v>
                </c:pt>
                <c:pt idx="298">
                  <c:v>-3.1E-2</c:v>
                </c:pt>
                <c:pt idx="299">
                  <c:v>-3.1E-2</c:v>
                </c:pt>
                <c:pt idx="300">
                  <c:v>-0.03</c:v>
                </c:pt>
                <c:pt idx="301">
                  <c:v>-2.9000000000000001E-2</c:v>
                </c:pt>
                <c:pt idx="302">
                  <c:v>-2.8000000000000001E-2</c:v>
                </c:pt>
                <c:pt idx="303">
                  <c:v>-2.5999999999999999E-2</c:v>
                </c:pt>
                <c:pt idx="304">
                  <c:v>-2.5000000000000001E-2</c:v>
                </c:pt>
                <c:pt idx="305">
                  <c:v>-2.3E-2</c:v>
                </c:pt>
                <c:pt idx="306">
                  <c:v>-2.1999999999999999E-2</c:v>
                </c:pt>
                <c:pt idx="307">
                  <c:v>-0.02</c:v>
                </c:pt>
                <c:pt idx="308">
                  <c:v>-1.7000000000000001E-2</c:v>
                </c:pt>
                <c:pt idx="309">
                  <c:v>-1.4999999999999999E-2</c:v>
                </c:pt>
                <c:pt idx="310">
                  <c:v>-1.2E-2</c:v>
                </c:pt>
                <c:pt idx="311">
                  <c:v>-8.9999999999999993E-3</c:v>
                </c:pt>
                <c:pt idx="312">
                  <c:v>-6.0000000000000001E-3</c:v>
                </c:pt>
                <c:pt idx="313">
                  <c:v>-2E-3</c:v>
                </c:pt>
                <c:pt idx="314">
                  <c:v>1E-3</c:v>
                </c:pt>
                <c:pt idx="315">
                  <c:v>5.0000000000000001E-3</c:v>
                </c:pt>
                <c:pt idx="316">
                  <c:v>8.9999999999999993E-3</c:v>
                </c:pt>
                <c:pt idx="317">
                  <c:v>1.2999999999999999E-2</c:v>
                </c:pt>
                <c:pt idx="318">
                  <c:v>1.7000000000000001E-2</c:v>
                </c:pt>
                <c:pt idx="319">
                  <c:v>2.1999999999999999E-2</c:v>
                </c:pt>
                <c:pt idx="320">
                  <c:v>2.5999999999999999E-2</c:v>
                </c:pt>
                <c:pt idx="321">
                  <c:v>0.03</c:v>
                </c:pt>
                <c:pt idx="322">
                  <c:v>3.4000000000000002E-2</c:v>
                </c:pt>
                <c:pt idx="323">
                  <c:v>3.7999999999999999E-2</c:v>
                </c:pt>
                <c:pt idx="324">
                  <c:v>4.2000000000000003E-2</c:v>
                </c:pt>
                <c:pt idx="325">
                  <c:v>4.5999999999999999E-2</c:v>
                </c:pt>
                <c:pt idx="326">
                  <c:v>0.05</c:v>
                </c:pt>
                <c:pt idx="327">
                  <c:v>5.2999999999999999E-2</c:v>
                </c:pt>
                <c:pt idx="328">
                  <c:v>5.6000000000000001E-2</c:v>
                </c:pt>
                <c:pt idx="329">
                  <c:v>5.8999999999999997E-2</c:v>
                </c:pt>
                <c:pt idx="330">
                  <c:v>6.0999999999999999E-2</c:v>
                </c:pt>
                <c:pt idx="331">
                  <c:v>6.3E-2</c:v>
                </c:pt>
                <c:pt idx="332">
                  <c:v>6.4000000000000001E-2</c:v>
                </c:pt>
                <c:pt idx="333">
                  <c:v>6.4000000000000001E-2</c:v>
                </c:pt>
                <c:pt idx="334">
                  <c:v>6.4000000000000001E-2</c:v>
                </c:pt>
                <c:pt idx="335">
                  <c:v>6.3E-2</c:v>
                </c:pt>
                <c:pt idx="336">
                  <c:v>6.0999999999999999E-2</c:v>
                </c:pt>
                <c:pt idx="337">
                  <c:v>0.06</c:v>
                </c:pt>
                <c:pt idx="338">
                  <c:v>5.8000000000000003E-2</c:v>
                </c:pt>
                <c:pt idx="339">
                  <c:v>5.6000000000000001E-2</c:v>
                </c:pt>
                <c:pt idx="340">
                  <c:v>5.3999999999999999E-2</c:v>
                </c:pt>
                <c:pt idx="341">
                  <c:v>5.1999999999999998E-2</c:v>
                </c:pt>
                <c:pt idx="342">
                  <c:v>5.0999999999999997E-2</c:v>
                </c:pt>
                <c:pt idx="343">
                  <c:v>0.05</c:v>
                </c:pt>
                <c:pt idx="344">
                  <c:v>4.9000000000000002E-2</c:v>
                </c:pt>
                <c:pt idx="345">
                  <c:v>4.9000000000000002E-2</c:v>
                </c:pt>
                <c:pt idx="346">
                  <c:v>0.05</c:v>
                </c:pt>
                <c:pt idx="347">
                  <c:v>5.0999999999999997E-2</c:v>
                </c:pt>
                <c:pt idx="348">
                  <c:v>5.1999999999999998E-2</c:v>
                </c:pt>
                <c:pt idx="349">
                  <c:v>5.5E-2</c:v>
                </c:pt>
                <c:pt idx="350">
                  <c:v>5.7000000000000002E-2</c:v>
                </c:pt>
                <c:pt idx="351">
                  <c:v>0.06</c:v>
                </c:pt>
                <c:pt idx="352">
                  <c:v>6.4000000000000001E-2</c:v>
                </c:pt>
                <c:pt idx="353">
                  <c:v>6.8000000000000005E-2</c:v>
                </c:pt>
                <c:pt idx="354">
                  <c:v>7.1999999999999995E-2</c:v>
                </c:pt>
                <c:pt idx="355">
                  <c:v>7.4999999999999997E-2</c:v>
                </c:pt>
                <c:pt idx="356">
                  <c:v>7.9000000000000001E-2</c:v>
                </c:pt>
                <c:pt idx="357">
                  <c:v>8.3000000000000004E-2</c:v>
                </c:pt>
                <c:pt idx="358">
                  <c:v>8.5999999999999993E-2</c:v>
                </c:pt>
                <c:pt idx="359">
                  <c:v>8.8999999999999996E-2</c:v>
                </c:pt>
                <c:pt idx="360">
                  <c:v>9.0999999999999998E-2</c:v>
                </c:pt>
                <c:pt idx="361">
                  <c:v>9.2999999999999999E-2</c:v>
                </c:pt>
                <c:pt idx="362">
                  <c:v>9.4E-2</c:v>
                </c:pt>
                <c:pt idx="363">
                  <c:v>9.4E-2</c:v>
                </c:pt>
                <c:pt idx="364">
                  <c:v>9.4E-2</c:v>
                </c:pt>
                <c:pt idx="365">
                  <c:v>9.2999999999999999E-2</c:v>
                </c:pt>
                <c:pt idx="366">
                  <c:v>9.1999999999999998E-2</c:v>
                </c:pt>
                <c:pt idx="367">
                  <c:v>9.0999999999999998E-2</c:v>
                </c:pt>
                <c:pt idx="368">
                  <c:v>8.7999999999999995E-2</c:v>
                </c:pt>
                <c:pt idx="369">
                  <c:v>8.5999999999999993E-2</c:v>
                </c:pt>
                <c:pt idx="370">
                  <c:v>8.3000000000000004E-2</c:v>
                </c:pt>
                <c:pt idx="371">
                  <c:v>0.08</c:v>
                </c:pt>
                <c:pt idx="372">
                  <c:v>7.6999999999999999E-2</c:v>
                </c:pt>
                <c:pt idx="373">
                  <c:v>7.3999999999999996E-2</c:v>
                </c:pt>
                <c:pt idx="374">
                  <c:v>7.1999999999999995E-2</c:v>
                </c:pt>
                <c:pt idx="375">
                  <c:v>7.0000000000000007E-2</c:v>
                </c:pt>
                <c:pt idx="376">
                  <c:v>6.8000000000000005E-2</c:v>
                </c:pt>
                <c:pt idx="377">
                  <c:v>6.7000000000000004E-2</c:v>
                </c:pt>
                <c:pt idx="378">
                  <c:v>6.6000000000000003E-2</c:v>
                </c:pt>
                <c:pt idx="379">
                  <c:v>6.5000000000000002E-2</c:v>
                </c:pt>
                <c:pt idx="380">
                  <c:v>6.5000000000000002E-2</c:v>
                </c:pt>
                <c:pt idx="381">
                  <c:v>6.4000000000000001E-2</c:v>
                </c:pt>
                <c:pt idx="382">
                  <c:v>6.4000000000000001E-2</c:v>
                </c:pt>
                <c:pt idx="383">
                  <c:v>6.4000000000000001E-2</c:v>
                </c:pt>
                <c:pt idx="384">
                  <c:v>6.3E-2</c:v>
                </c:pt>
                <c:pt idx="385">
                  <c:v>6.3E-2</c:v>
                </c:pt>
                <c:pt idx="386">
                  <c:v>6.2E-2</c:v>
                </c:pt>
                <c:pt idx="387">
                  <c:v>6.0999999999999999E-2</c:v>
                </c:pt>
                <c:pt idx="388">
                  <c:v>0.06</c:v>
                </c:pt>
                <c:pt idx="389">
                  <c:v>5.8999999999999997E-2</c:v>
                </c:pt>
                <c:pt idx="390">
                  <c:v>5.7000000000000002E-2</c:v>
                </c:pt>
                <c:pt idx="391">
                  <c:v>5.6000000000000001E-2</c:v>
                </c:pt>
                <c:pt idx="392">
                  <c:v>5.3999999999999999E-2</c:v>
                </c:pt>
                <c:pt idx="393">
                  <c:v>5.1999999999999998E-2</c:v>
                </c:pt>
                <c:pt idx="394">
                  <c:v>0.05</c:v>
                </c:pt>
                <c:pt idx="395">
                  <c:v>4.9000000000000002E-2</c:v>
                </c:pt>
                <c:pt idx="396">
                  <c:v>4.8000000000000001E-2</c:v>
                </c:pt>
                <c:pt idx="397">
                  <c:v>4.5999999999999999E-2</c:v>
                </c:pt>
                <c:pt idx="398">
                  <c:v>4.5999999999999999E-2</c:v>
                </c:pt>
                <c:pt idx="399">
                  <c:v>4.4999999999999998E-2</c:v>
                </c:pt>
                <c:pt idx="400">
                  <c:v>4.4999999999999998E-2</c:v>
                </c:pt>
                <c:pt idx="401">
                  <c:v>4.4999999999999998E-2</c:v>
                </c:pt>
                <c:pt idx="402">
                  <c:v>4.5999999999999999E-2</c:v>
                </c:pt>
                <c:pt idx="403">
                  <c:v>4.7E-2</c:v>
                </c:pt>
                <c:pt idx="404">
                  <c:v>4.8000000000000001E-2</c:v>
                </c:pt>
                <c:pt idx="405">
                  <c:v>0.05</c:v>
                </c:pt>
                <c:pt idx="406">
                  <c:v>5.0999999999999997E-2</c:v>
                </c:pt>
                <c:pt idx="407">
                  <c:v>5.2999999999999999E-2</c:v>
                </c:pt>
                <c:pt idx="408">
                  <c:v>5.5E-2</c:v>
                </c:pt>
                <c:pt idx="409">
                  <c:v>5.8000000000000003E-2</c:v>
                </c:pt>
                <c:pt idx="410">
                  <c:v>0.06</c:v>
                </c:pt>
                <c:pt idx="411">
                  <c:v>6.3E-2</c:v>
                </c:pt>
                <c:pt idx="412">
                  <c:v>6.6000000000000003E-2</c:v>
                </c:pt>
                <c:pt idx="413">
                  <c:v>6.9000000000000006E-2</c:v>
                </c:pt>
                <c:pt idx="414">
                  <c:v>7.1999999999999995E-2</c:v>
                </c:pt>
                <c:pt idx="415">
                  <c:v>7.4999999999999997E-2</c:v>
                </c:pt>
                <c:pt idx="416">
                  <c:v>7.8E-2</c:v>
                </c:pt>
                <c:pt idx="417">
                  <c:v>8.1000000000000003E-2</c:v>
                </c:pt>
                <c:pt idx="418">
                  <c:v>8.4000000000000005E-2</c:v>
                </c:pt>
                <c:pt idx="419">
                  <c:v>8.7999999999999995E-2</c:v>
                </c:pt>
                <c:pt idx="420">
                  <c:v>9.0999999999999998E-2</c:v>
                </c:pt>
                <c:pt idx="421">
                  <c:v>9.7000000000000003E-2</c:v>
                </c:pt>
                <c:pt idx="422">
                  <c:v>0.11600000000000001</c:v>
                </c:pt>
                <c:pt idx="423">
                  <c:v>0.11899999999999999</c:v>
                </c:pt>
                <c:pt idx="424">
                  <c:v>0.123</c:v>
                </c:pt>
                <c:pt idx="425">
                  <c:v>0.126</c:v>
                </c:pt>
                <c:pt idx="426">
                  <c:v>0.13</c:v>
                </c:pt>
                <c:pt idx="427">
                  <c:v>0.13300000000000001</c:v>
                </c:pt>
                <c:pt idx="428">
                  <c:v>0.13700000000000001</c:v>
                </c:pt>
                <c:pt idx="429">
                  <c:v>0.14000000000000001</c:v>
                </c:pt>
                <c:pt idx="430">
                  <c:v>0.14399999999999999</c:v>
                </c:pt>
                <c:pt idx="431">
                  <c:v>0.14699999999999999</c:v>
                </c:pt>
                <c:pt idx="432">
                  <c:v>0.15</c:v>
                </c:pt>
                <c:pt idx="433">
                  <c:v>0.154</c:v>
                </c:pt>
                <c:pt idx="434">
                  <c:v>0.157</c:v>
                </c:pt>
                <c:pt idx="435">
                  <c:v>0.16</c:v>
                </c:pt>
                <c:pt idx="436">
                  <c:v>0.16400000000000001</c:v>
                </c:pt>
                <c:pt idx="437">
                  <c:v>0.16700000000000001</c:v>
                </c:pt>
                <c:pt idx="438">
                  <c:v>0.17</c:v>
                </c:pt>
                <c:pt idx="439">
                  <c:v>0.17299999999999999</c:v>
                </c:pt>
                <c:pt idx="440">
                  <c:v>0.17599999999999999</c:v>
                </c:pt>
                <c:pt idx="441">
                  <c:v>0.17899999999999999</c:v>
                </c:pt>
                <c:pt idx="442">
                  <c:v>0.183</c:v>
                </c:pt>
                <c:pt idx="443">
                  <c:v>0.186</c:v>
                </c:pt>
                <c:pt idx="444">
                  <c:v>0.189</c:v>
                </c:pt>
                <c:pt idx="445">
                  <c:v>0.192</c:v>
                </c:pt>
                <c:pt idx="446">
                  <c:v>0.19500000000000001</c:v>
                </c:pt>
                <c:pt idx="447">
                  <c:v>0.19900000000000001</c:v>
                </c:pt>
                <c:pt idx="448">
                  <c:v>0.20200000000000001</c:v>
                </c:pt>
                <c:pt idx="449">
                  <c:v>0.20599999999999999</c:v>
                </c:pt>
                <c:pt idx="450">
                  <c:v>0.20899999999999999</c:v>
                </c:pt>
                <c:pt idx="451">
                  <c:v>0.21299999999999999</c:v>
                </c:pt>
                <c:pt idx="452">
                  <c:v>0.216</c:v>
                </c:pt>
                <c:pt idx="453">
                  <c:v>0.22</c:v>
                </c:pt>
                <c:pt idx="454">
                  <c:v>0.223</c:v>
                </c:pt>
                <c:pt idx="455">
                  <c:v>0.22700000000000001</c:v>
                </c:pt>
                <c:pt idx="456">
                  <c:v>0.23100000000000001</c:v>
                </c:pt>
                <c:pt idx="457">
                  <c:v>0.23400000000000001</c:v>
                </c:pt>
                <c:pt idx="458">
                  <c:v>0.23699999999999999</c:v>
                </c:pt>
                <c:pt idx="459">
                  <c:v>0.24</c:v>
                </c:pt>
                <c:pt idx="460">
                  <c:v>0.24299999999999999</c:v>
                </c:pt>
                <c:pt idx="461">
                  <c:v>0.23400000000000001</c:v>
                </c:pt>
                <c:pt idx="462">
                  <c:v>0.23100000000000001</c:v>
                </c:pt>
                <c:pt idx="463">
                  <c:v>0.23400000000000001</c:v>
                </c:pt>
                <c:pt idx="464">
                  <c:v>0.23499999999999999</c:v>
                </c:pt>
                <c:pt idx="465">
                  <c:v>0.23699999999999999</c:v>
                </c:pt>
                <c:pt idx="466">
                  <c:v>0.23899999999999999</c:v>
                </c:pt>
                <c:pt idx="467">
                  <c:v>0.24</c:v>
                </c:pt>
                <c:pt idx="468">
                  <c:v>0.24199999999999999</c:v>
                </c:pt>
                <c:pt idx="469">
                  <c:v>0.24299999999999999</c:v>
                </c:pt>
                <c:pt idx="470">
                  <c:v>0.24299999999999999</c:v>
                </c:pt>
                <c:pt idx="471">
                  <c:v>0.24399999999999999</c:v>
                </c:pt>
                <c:pt idx="472">
                  <c:v>0.245</c:v>
                </c:pt>
                <c:pt idx="473">
                  <c:v>0.245</c:v>
                </c:pt>
                <c:pt idx="474">
                  <c:v>0.245</c:v>
                </c:pt>
                <c:pt idx="475">
                  <c:v>0.24399999999999999</c:v>
                </c:pt>
                <c:pt idx="476">
                  <c:v>0.24299999999999999</c:v>
                </c:pt>
                <c:pt idx="477">
                  <c:v>0.24199999999999999</c:v>
                </c:pt>
                <c:pt idx="478">
                  <c:v>0.24099999999999999</c:v>
                </c:pt>
                <c:pt idx="479">
                  <c:v>0.24</c:v>
                </c:pt>
                <c:pt idx="480">
                  <c:v>0.23799999999999999</c:v>
                </c:pt>
                <c:pt idx="481">
                  <c:v>0.23699999999999999</c:v>
                </c:pt>
                <c:pt idx="482">
                  <c:v>0.23499999999999999</c:v>
                </c:pt>
                <c:pt idx="483">
                  <c:v>0.23300000000000001</c:v>
                </c:pt>
                <c:pt idx="484">
                  <c:v>0.23100000000000001</c:v>
                </c:pt>
                <c:pt idx="485">
                  <c:v>0.22900000000000001</c:v>
                </c:pt>
                <c:pt idx="486">
                  <c:v>0.22600000000000001</c:v>
                </c:pt>
                <c:pt idx="487">
                  <c:v>0.224</c:v>
                </c:pt>
                <c:pt idx="488">
                  <c:v>0.221</c:v>
                </c:pt>
                <c:pt idx="489">
                  <c:v>0.218</c:v>
                </c:pt>
                <c:pt idx="490">
                  <c:v>0.215</c:v>
                </c:pt>
                <c:pt idx="491">
                  <c:v>0.21199999999999999</c:v>
                </c:pt>
                <c:pt idx="492">
                  <c:v>0.20899999999999999</c:v>
                </c:pt>
                <c:pt idx="493">
                  <c:v>0.20699999999999999</c:v>
                </c:pt>
                <c:pt idx="494">
                  <c:v>0.20399999999999999</c:v>
                </c:pt>
                <c:pt idx="495">
                  <c:v>0.20200000000000001</c:v>
                </c:pt>
                <c:pt idx="496">
                  <c:v>0.19900000000000001</c:v>
                </c:pt>
                <c:pt idx="497">
                  <c:v>0.19700000000000001</c:v>
                </c:pt>
                <c:pt idx="498">
                  <c:v>0.19500000000000001</c:v>
                </c:pt>
                <c:pt idx="499">
                  <c:v>0.193</c:v>
                </c:pt>
                <c:pt idx="500">
                  <c:v>0.192</c:v>
                </c:pt>
                <c:pt idx="501">
                  <c:v>0.191</c:v>
                </c:pt>
                <c:pt idx="502">
                  <c:v>0.189</c:v>
                </c:pt>
                <c:pt idx="503">
                  <c:v>0.188</c:v>
                </c:pt>
                <c:pt idx="504">
                  <c:v>0.186</c:v>
                </c:pt>
                <c:pt idx="505">
                  <c:v>0.185</c:v>
                </c:pt>
                <c:pt idx="506">
                  <c:v>0.183</c:v>
                </c:pt>
                <c:pt idx="507">
                  <c:v>0.183</c:v>
                </c:pt>
                <c:pt idx="508">
                  <c:v>0.182</c:v>
                </c:pt>
                <c:pt idx="509">
                  <c:v>0.18099999999999999</c:v>
                </c:pt>
                <c:pt idx="510">
                  <c:v>0.18</c:v>
                </c:pt>
                <c:pt idx="511">
                  <c:v>0.18</c:v>
                </c:pt>
                <c:pt idx="512">
                  <c:v>0.17899999999999999</c:v>
                </c:pt>
                <c:pt idx="513">
                  <c:v>0.17699999999999999</c:v>
                </c:pt>
                <c:pt idx="514">
                  <c:v>0.17599999999999999</c:v>
                </c:pt>
                <c:pt idx="515">
                  <c:v>0.17499999999999999</c:v>
                </c:pt>
                <c:pt idx="516">
                  <c:v>0.17499999999999999</c:v>
                </c:pt>
                <c:pt idx="517">
                  <c:v>0.17599999999999999</c:v>
                </c:pt>
                <c:pt idx="518">
                  <c:v>0.17599999999999999</c:v>
                </c:pt>
                <c:pt idx="519">
                  <c:v>0.17799999999999999</c:v>
                </c:pt>
                <c:pt idx="520">
                  <c:v>0.17899999999999999</c:v>
                </c:pt>
                <c:pt idx="521">
                  <c:v>0.18099999999999999</c:v>
                </c:pt>
                <c:pt idx="522">
                  <c:v>0.184</c:v>
                </c:pt>
                <c:pt idx="523">
                  <c:v>0.189</c:v>
                </c:pt>
                <c:pt idx="524">
                  <c:v>0.19400000000000001</c:v>
                </c:pt>
                <c:pt idx="525">
                  <c:v>0.20100000000000001</c:v>
                </c:pt>
                <c:pt idx="526">
                  <c:v>0.20899999999999999</c:v>
                </c:pt>
                <c:pt idx="527">
                  <c:v>0.217</c:v>
                </c:pt>
                <c:pt idx="528">
                  <c:v>0.22600000000000001</c:v>
                </c:pt>
                <c:pt idx="529">
                  <c:v>0.23400000000000001</c:v>
                </c:pt>
                <c:pt idx="530">
                  <c:v>0.24099999999999999</c:v>
                </c:pt>
                <c:pt idx="531">
                  <c:v>0.246</c:v>
                </c:pt>
                <c:pt idx="532">
                  <c:v>0.25</c:v>
                </c:pt>
                <c:pt idx="533">
                  <c:v>0.253</c:v>
                </c:pt>
                <c:pt idx="534">
                  <c:v>0.254</c:v>
                </c:pt>
                <c:pt idx="535">
                  <c:v>0.255</c:v>
                </c:pt>
                <c:pt idx="536">
                  <c:v>0.255</c:v>
                </c:pt>
                <c:pt idx="537">
                  <c:v>0.254</c:v>
                </c:pt>
                <c:pt idx="538">
                  <c:v>0.254</c:v>
                </c:pt>
                <c:pt idx="539">
                  <c:v>0.255</c:v>
                </c:pt>
                <c:pt idx="540">
                  <c:v>0.25600000000000001</c:v>
                </c:pt>
                <c:pt idx="541">
                  <c:v>0.25800000000000001</c:v>
                </c:pt>
                <c:pt idx="542">
                  <c:v>0.26100000000000001</c:v>
                </c:pt>
                <c:pt idx="543">
                  <c:v>0.26400000000000001</c:v>
                </c:pt>
                <c:pt idx="544">
                  <c:v>0.26600000000000001</c:v>
                </c:pt>
                <c:pt idx="545">
                  <c:v>0.26800000000000002</c:v>
                </c:pt>
                <c:pt idx="546">
                  <c:v>0.27</c:v>
                </c:pt>
                <c:pt idx="547">
                  <c:v>0.27100000000000002</c:v>
                </c:pt>
                <c:pt idx="548">
                  <c:v>0.27200000000000002</c:v>
                </c:pt>
                <c:pt idx="549">
                  <c:v>0.27300000000000002</c:v>
                </c:pt>
                <c:pt idx="550">
                  <c:v>0.27300000000000002</c:v>
                </c:pt>
                <c:pt idx="551">
                  <c:v>0.27400000000000002</c:v>
                </c:pt>
                <c:pt idx="552">
                  <c:v>0.27500000000000002</c:v>
                </c:pt>
                <c:pt idx="553">
                  <c:v>0.27700000000000002</c:v>
                </c:pt>
                <c:pt idx="554">
                  <c:v>0.27800000000000002</c:v>
                </c:pt>
                <c:pt idx="555">
                  <c:v>0.27900000000000003</c:v>
                </c:pt>
                <c:pt idx="556">
                  <c:v>0.28000000000000003</c:v>
                </c:pt>
                <c:pt idx="557">
                  <c:v>0.28100000000000003</c:v>
                </c:pt>
                <c:pt idx="558">
                  <c:v>0.28199999999999997</c:v>
                </c:pt>
                <c:pt idx="559">
                  <c:v>0.28399999999999997</c:v>
                </c:pt>
                <c:pt idx="560">
                  <c:v>0.28699999999999998</c:v>
                </c:pt>
                <c:pt idx="561">
                  <c:v>0.29099999999999998</c:v>
                </c:pt>
                <c:pt idx="562">
                  <c:v>0.29599999999999999</c:v>
                </c:pt>
                <c:pt idx="563">
                  <c:v>0.30299999999999999</c:v>
                </c:pt>
                <c:pt idx="564">
                  <c:v>0.312</c:v>
                </c:pt>
                <c:pt idx="565">
                  <c:v>0.32200000000000001</c:v>
                </c:pt>
                <c:pt idx="566">
                  <c:v>0.33500000000000002</c:v>
                </c:pt>
                <c:pt idx="567">
                  <c:v>0.35</c:v>
                </c:pt>
                <c:pt idx="568">
                  <c:v>0.36899999999999999</c:v>
                </c:pt>
                <c:pt idx="569">
                  <c:v>0.39</c:v>
                </c:pt>
                <c:pt idx="570">
                  <c:v>0.41499999999999998</c:v>
                </c:pt>
                <c:pt idx="571">
                  <c:v>0.443</c:v>
                </c:pt>
                <c:pt idx="572">
                  <c:v>0.47599999999999998</c:v>
                </c:pt>
                <c:pt idx="573">
                  <c:v>0.51300000000000001</c:v>
                </c:pt>
                <c:pt idx="574">
                  <c:v>0.55500000000000005</c:v>
                </c:pt>
                <c:pt idx="575">
                  <c:v>0.60099999999999998</c:v>
                </c:pt>
                <c:pt idx="576">
                  <c:v>0.65</c:v>
                </c:pt>
                <c:pt idx="577">
                  <c:v>0.70299999999999996</c:v>
                </c:pt>
                <c:pt idx="578">
                  <c:v>0.75900000000000001</c:v>
                </c:pt>
                <c:pt idx="579">
                  <c:v>0.81799999999999995</c:v>
                </c:pt>
                <c:pt idx="580">
                  <c:v>0.878</c:v>
                </c:pt>
                <c:pt idx="581">
                  <c:v>0.94099999999999995</c:v>
                </c:pt>
                <c:pt idx="582">
                  <c:v>1.004</c:v>
                </c:pt>
                <c:pt idx="583">
                  <c:v>1.07</c:v>
                </c:pt>
                <c:pt idx="584">
                  <c:v>1.137</c:v>
                </c:pt>
                <c:pt idx="585">
                  <c:v>1.2090000000000001</c:v>
                </c:pt>
                <c:pt idx="586">
                  <c:v>1.278</c:v>
                </c:pt>
                <c:pt idx="587">
                  <c:v>1.347</c:v>
                </c:pt>
                <c:pt idx="588">
                  <c:v>1.413</c:v>
                </c:pt>
                <c:pt idx="589">
                  <c:v>1.474</c:v>
                </c:pt>
                <c:pt idx="590">
                  <c:v>1.5289999999999999</c:v>
                </c:pt>
                <c:pt idx="591">
                  <c:v>1.575</c:v>
                </c:pt>
                <c:pt idx="592">
                  <c:v>1.605</c:v>
                </c:pt>
                <c:pt idx="593">
                  <c:v>1.6180000000000001</c:v>
                </c:pt>
                <c:pt idx="594">
                  <c:v>1.611</c:v>
                </c:pt>
                <c:pt idx="595">
                  <c:v>1.5649999999999999</c:v>
                </c:pt>
                <c:pt idx="596">
                  <c:v>1.486</c:v>
                </c:pt>
                <c:pt idx="597">
                  <c:v>1.359</c:v>
                </c:pt>
                <c:pt idx="598">
                  <c:v>1.17</c:v>
                </c:pt>
                <c:pt idx="599">
                  <c:v>0.92200000000000004</c:v>
                </c:pt>
                <c:pt idx="600">
                  <c:v>0.6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F1C9-4266-924C-4F616B8627F9}"/>
            </c:ext>
          </c:extLst>
        </c:ser>
        <c:ser>
          <c:idx val="4"/>
          <c:order val="4"/>
          <c:tx>
            <c:strRef>
              <c:f>'Methanol-F'!$F$2</c:f>
              <c:strCache>
                <c:ptCount val="1"/>
                <c:pt idx="0">
                  <c:v>Watermelon plant </c:v>
                </c:pt>
              </c:strCache>
            </c:strRef>
          </c:tx>
          <c:marker>
            <c:symbol val="none"/>
          </c:marker>
          <c:xVal>
            <c:numRef>
              <c:f>'Methanol-F'!$A$3:$A$603</c:f>
              <c:numCache>
                <c:formatCode>General</c:formatCode>
                <c:ptCount val="601"/>
                <c:pt idx="0">
                  <c:v>800</c:v>
                </c:pt>
                <c:pt idx="1">
                  <c:v>799</c:v>
                </c:pt>
                <c:pt idx="2">
                  <c:v>798</c:v>
                </c:pt>
                <c:pt idx="3">
                  <c:v>797</c:v>
                </c:pt>
                <c:pt idx="4">
                  <c:v>796</c:v>
                </c:pt>
                <c:pt idx="5">
                  <c:v>795</c:v>
                </c:pt>
                <c:pt idx="6">
                  <c:v>794</c:v>
                </c:pt>
                <c:pt idx="7">
                  <c:v>793</c:v>
                </c:pt>
                <c:pt idx="8">
                  <c:v>792</c:v>
                </c:pt>
                <c:pt idx="9">
                  <c:v>791</c:v>
                </c:pt>
                <c:pt idx="10">
                  <c:v>790</c:v>
                </c:pt>
                <c:pt idx="11">
                  <c:v>789</c:v>
                </c:pt>
                <c:pt idx="12">
                  <c:v>788</c:v>
                </c:pt>
                <c:pt idx="13">
                  <c:v>787</c:v>
                </c:pt>
                <c:pt idx="14">
                  <c:v>786</c:v>
                </c:pt>
                <c:pt idx="15">
                  <c:v>785</c:v>
                </c:pt>
                <c:pt idx="16">
                  <c:v>784</c:v>
                </c:pt>
                <c:pt idx="17">
                  <c:v>783</c:v>
                </c:pt>
                <c:pt idx="18">
                  <c:v>782</c:v>
                </c:pt>
                <c:pt idx="19">
                  <c:v>781</c:v>
                </c:pt>
                <c:pt idx="20">
                  <c:v>780</c:v>
                </c:pt>
                <c:pt idx="21">
                  <c:v>779</c:v>
                </c:pt>
                <c:pt idx="22">
                  <c:v>778</c:v>
                </c:pt>
                <c:pt idx="23">
                  <c:v>777</c:v>
                </c:pt>
                <c:pt idx="24">
                  <c:v>776</c:v>
                </c:pt>
                <c:pt idx="25">
                  <c:v>775</c:v>
                </c:pt>
                <c:pt idx="26">
                  <c:v>774</c:v>
                </c:pt>
                <c:pt idx="27">
                  <c:v>773</c:v>
                </c:pt>
                <c:pt idx="28">
                  <c:v>772</c:v>
                </c:pt>
                <c:pt idx="29">
                  <c:v>771</c:v>
                </c:pt>
                <c:pt idx="30">
                  <c:v>770</c:v>
                </c:pt>
                <c:pt idx="31">
                  <c:v>769</c:v>
                </c:pt>
                <c:pt idx="32">
                  <c:v>768</c:v>
                </c:pt>
                <c:pt idx="33">
                  <c:v>767</c:v>
                </c:pt>
                <c:pt idx="34">
                  <c:v>766</c:v>
                </c:pt>
                <c:pt idx="35">
                  <c:v>765</c:v>
                </c:pt>
                <c:pt idx="36">
                  <c:v>764</c:v>
                </c:pt>
                <c:pt idx="37">
                  <c:v>763</c:v>
                </c:pt>
                <c:pt idx="38">
                  <c:v>762</c:v>
                </c:pt>
                <c:pt idx="39">
                  <c:v>761</c:v>
                </c:pt>
                <c:pt idx="40">
                  <c:v>760</c:v>
                </c:pt>
                <c:pt idx="41">
                  <c:v>759</c:v>
                </c:pt>
                <c:pt idx="42">
                  <c:v>758</c:v>
                </c:pt>
                <c:pt idx="43">
                  <c:v>757</c:v>
                </c:pt>
                <c:pt idx="44">
                  <c:v>756</c:v>
                </c:pt>
                <c:pt idx="45">
                  <c:v>755</c:v>
                </c:pt>
                <c:pt idx="46">
                  <c:v>754</c:v>
                </c:pt>
                <c:pt idx="47">
                  <c:v>753</c:v>
                </c:pt>
                <c:pt idx="48">
                  <c:v>752</c:v>
                </c:pt>
                <c:pt idx="49">
                  <c:v>751</c:v>
                </c:pt>
                <c:pt idx="50">
                  <c:v>750</c:v>
                </c:pt>
                <c:pt idx="51">
                  <c:v>749</c:v>
                </c:pt>
                <c:pt idx="52">
                  <c:v>748</c:v>
                </c:pt>
                <c:pt idx="53">
                  <c:v>747</c:v>
                </c:pt>
                <c:pt idx="54">
                  <c:v>746</c:v>
                </c:pt>
                <c:pt idx="55">
                  <c:v>745</c:v>
                </c:pt>
                <c:pt idx="56">
                  <c:v>744</c:v>
                </c:pt>
                <c:pt idx="57">
                  <c:v>743</c:v>
                </c:pt>
                <c:pt idx="58">
                  <c:v>742</c:v>
                </c:pt>
                <c:pt idx="59">
                  <c:v>741</c:v>
                </c:pt>
                <c:pt idx="60">
                  <c:v>740</c:v>
                </c:pt>
                <c:pt idx="61">
                  <c:v>739</c:v>
                </c:pt>
                <c:pt idx="62">
                  <c:v>738</c:v>
                </c:pt>
                <c:pt idx="63">
                  <c:v>737</c:v>
                </c:pt>
                <c:pt idx="64">
                  <c:v>736</c:v>
                </c:pt>
                <c:pt idx="65">
                  <c:v>735</c:v>
                </c:pt>
                <c:pt idx="66">
                  <c:v>734</c:v>
                </c:pt>
                <c:pt idx="67">
                  <c:v>733</c:v>
                </c:pt>
                <c:pt idx="68">
                  <c:v>732</c:v>
                </c:pt>
                <c:pt idx="69">
                  <c:v>731</c:v>
                </c:pt>
                <c:pt idx="70">
                  <c:v>730</c:v>
                </c:pt>
                <c:pt idx="71">
                  <c:v>729</c:v>
                </c:pt>
                <c:pt idx="72">
                  <c:v>728</c:v>
                </c:pt>
                <c:pt idx="73">
                  <c:v>727</c:v>
                </c:pt>
                <c:pt idx="74">
                  <c:v>726</c:v>
                </c:pt>
                <c:pt idx="75">
                  <c:v>725</c:v>
                </c:pt>
                <c:pt idx="76">
                  <c:v>724</c:v>
                </c:pt>
                <c:pt idx="77">
                  <c:v>723</c:v>
                </c:pt>
                <c:pt idx="78">
                  <c:v>722</c:v>
                </c:pt>
                <c:pt idx="79">
                  <c:v>721</c:v>
                </c:pt>
                <c:pt idx="80">
                  <c:v>720</c:v>
                </c:pt>
                <c:pt idx="81">
                  <c:v>719</c:v>
                </c:pt>
                <c:pt idx="82">
                  <c:v>718</c:v>
                </c:pt>
                <c:pt idx="83">
                  <c:v>717</c:v>
                </c:pt>
                <c:pt idx="84">
                  <c:v>716</c:v>
                </c:pt>
                <c:pt idx="85">
                  <c:v>715</c:v>
                </c:pt>
                <c:pt idx="86">
                  <c:v>714</c:v>
                </c:pt>
                <c:pt idx="87">
                  <c:v>713</c:v>
                </c:pt>
                <c:pt idx="88">
                  <c:v>712</c:v>
                </c:pt>
                <c:pt idx="89">
                  <c:v>711</c:v>
                </c:pt>
                <c:pt idx="90">
                  <c:v>710</c:v>
                </c:pt>
                <c:pt idx="91">
                  <c:v>709</c:v>
                </c:pt>
                <c:pt idx="92">
                  <c:v>708</c:v>
                </c:pt>
                <c:pt idx="93">
                  <c:v>707</c:v>
                </c:pt>
                <c:pt idx="94">
                  <c:v>706</c:v>
                </c:pt>
                <c:pt idx="95">
                  <c:v>705</c:v>
                </c:pt>
                <c:pt idx="96">
                  <c:v>704</c:v>
                </c:pt>
                <c:pt idx="97">
                  <c:v>703</c:v>
                </c:pt>
                <c:pt idx="98">
                  <c:v>702</c:v>
                </c:pt>
                <c:pt idx="99">
                  <c:v>701</c:v>
                </c:pt>
                <c:pt idx="100">
                  <c:v>700</c:v>
                </c:pt>
                <c:pt idx="101">
                  <c:v>699</c:v>
                </c:pt>
                <c:pt idx="102">
                  <c:v>698</c:v>
                </c:pt>
                <c:pt idx="103">
                  <c:v>697</c:v>
                </c:pt>
                <c:pt idx="104">
                  <c:v>696</c:v>
                </c:pt>
                <c:pt idx="105">
                  <c:v>695</c:v>
                </c:pt>
                <c:pt idx="106">
                  <c:v>694</c:v>
                </c:pt>
                <c:pt idx="107">
                  <c:v>693</c:v>
                </c:pt>
                <c:pt idx="108">
                  <c:v>692</c:v>
                </c:pt>
                <c:pt idx="109">
                  <c:v>691</c:v>
                </c:pt>
                <c:pt idx="110">
                  <c:v>690</c:v>
                </c:pt>
                <c:pt idx="111">
                  <c:v>689</c:v>
                </c:pt>
                <c:pt idx="112">
                  <c:v>688</c:v>
                </c:pt>
                <c:pt idx="113">
                  <c:v>687</c:v>
                </c:pt>
                <c:pt idx="114">
                  <c:v>686</c:v>
                </c:pt>
                <c:pt idx="115">
                  <c:v>685</c:v>
                </c:pt>
                <c:pt idx="116">
                  <c:v>684</c:v>
                </c:pt>
                <c:pt idx="117">
                  <c:v>683</c:v>
                </c:pt>
                <c:pt idx="118">
                  <c:v>682</c:v>
                </c:pt>
                <c:pt idx="119">
                  <c:v>681</c:v>
                </c:pt>
                <c:pt idx="120">
                  <c:v>680</c:v>
                </c:pt>
                <c:pt idx="121">
                  <c:v>679</c:v>
                </c:pt>
                <c:pt idx="122">
                  <c:v>678</c:v>
                </c:pt>
                <c:pt idx="123">
                  <c:v>677</c:v>
                </c:pt>
                <c:pt idx="124">
                  <c:v>676</c:v>
                </c:pt>
                <c:pt idx="125">
                  <c:v>675</c:v>
                </c:pt>
                <c:pt idx="126">
                  <c:v>674</c:v>
                </c:pt>
                <c:pt idx="127">
                  <c:v>673</c:v>
                </c:pt>
                <c:pt idx="128">
                  <c:v>672</c:v>
                </c:pt>
                <c:pt idx="129">
                  <c:v>671</c:v>
                </c:pt>
                <c:pt idx="130">
                  <c:v>670</c:v>
                </c:pt>
                <c:pt idx="131">
                  <c:v>669</c:v>
                </c:pt>
                <c:pt idx="132">
                  <c:v>668</c:v>
                </c:pt>
                <c:pt idx="133">
                  <c:v>667</c:v>
                </c:pt>
                <c:pt idx="134">
                  <c:v>666</c:v>
                </c:pt>
                <c:pt idx="135">
                  <c:v>665</c:v>
                </c:pt>
                <c:pt idx="136">
                  <c:v>664</c:v>
                </c:pt>
                <c:pt idx="137">
                  <c:v>663</c:v>
                </c:pt>
                <c:pt idx="138">
                  <c:v>662</c:v>
                </c:pt>
                <c:pt idx="139">
                  <c:v>661</c:v>
                </c:pt>
                <c:pt idx="140">
                  <c:v>660</c:v>
                </c:pt>
                <c:pt idx="141">
                  <c:v>659</c:v>
                </c:pt>
                <c:pt idx="142">
                  <c:v>658</c:v>
                </c:pt>
                <c:pt idx="143">
                  <c:v>657</c:v>
                </c:pt>
                <c:pt idx="144">
                  <c:v>656</c:v>
                </c:pt>
                <c:pt idx="145">
                  <c:v>655</c:v>
                </c:pt>
                <c:pt idx="146">
                  <c:v>654</c:v>
                </c:pt>
                <c:pt idx="147">
                  <c:v>653</c:v>
                </c:pt>
                <c:pt idx="148">
                  <c:v>652</c:v>
                </c:pt>
                <c:pt idx="149">
                  <c:v>651</c:v>
                </c:pt>
                <c:pt idx="150">
                  <c:v>650</c:v>
                </c:pt>
                <c:pt idx="151">
                  <c:v>649</c:v>
                </c:pt>
                <c:pt idx="152">
                  <c:v>648</c:v>
                </c:pt>
                <c:pt idx="153">
                  <c:v>647</c:v>
                </c:pt>
                <c:pt idx="154">
                  <c:v>646</c:v>
                </c:pt>
                <c:pt idx="155">
                  <c:v>645</c:v>
                </c:pt>
                <c:pt idx="156">
                  <c:v>644</c:v>
                </c:pt>
                <c:pt idx="157">
                  <c:v>643</c:v>
                </c:pt>
                <c:pt idx="158">
                  <c:v>642</c:v>
                </c:pt>
                <c:pt idx="159">
                  <c:v>641</c:v>
                </c:pt>
                <c:pt idx="160">
                  <c:v>640</c:v>
                </c:pt>
                <c:pt idx="161">
                  <c:v>639</c:v>
                </c:pt>
                <c:pt idx="162">
                  <c:v>638</c:v>
                </c:pt>
                <c:pt idx="163">
                  <c:v>637</c:v>
                </c:pt>
                <c:pt idx="164">
                  <c:v>636</c:v>
                </c:pt>
                <c:pt idx="165">
                  <c:v>635</c:v>
                </c:pt>
                <c:pt idx="166">
                  <c:v>634</c:v>
                </c:pt>
                <c:pt idx="167">
                  <c:v>633</c:v>
                </c:pt>
                <c:pt idx="168">
                  <c:v>632</c:v>
                </c:pt>
                <c:pt idx="169">
                  <c:v>631</c:v>
                </c:pt>
                <c:pt idx="170">
                  <c:v>630</c:v>
                </c:pt>
                <c:pt idx="171">
                  <c:v>629</c:v>
                </c:pt>
                <c:pt idx="172">
                  <c:v>628</c:v>
                </c:pt>
                <c:pt idx="173">
                  <c:v>627</c:v>
                </c:pt>
                <c:pt idx="174">
                  <c:v>626</c:v>
                </c:pt>
                <c:pt idx="175">
                  <c:v>625</c:v>
                </c:pt>
                <c:pt idx="176">
                  <c:v>624</c:v>
                </c:pt>
                <c:pt idx="177">
                  <c:v>623</c:v>
                </c:pt>
                <c:pt idx="178">
                  <c:v>622</c:v>
                </c:pt>
                <c:pt idx="179">
                  <c:v>621</c:v>
                </c:pt>
                <c:pt idx="180">
                  <c:v>620</c:v>
                </c:pt>
                <c:pt idx="181">
                  <c:v>619</c:v>
                </c:pt>
                <c:pt idx="182">
                  <c:v>618</c:v>
                </c:pt>
                <c:pt idx="183">
                  <c:v>617</c:v>
                </c:pt>
                <c:pt idx="184">
                  <c:v>616</c:v>
                </c:pt>
                <c:pt idx="185">
                  <c:v>615</c:v>
                </c:pt>
                <c:pt idx="186">
                  <c:v>614</c:v>
                </c:pt>
                <c:pt idx="187">
                  <c:v>613</c:v>
                </c:pt>
                <c:pt idx="188">
                  <c:v>612</c:v>
                </c:pt>
                <c:pt idx="189">
                  <c:v>611</c:v>
                </c:pt>
                <c:pt idx="190">
                  <c:v>610</c:v>
                </c:pt>
                <c:pt idx="191">
                  <c:v>609</c:v>
                </c:pt>
                <c:pt idx="192">
                  <c:v>608</c:v>
                </c:pt>
                <c:pt idx="193">
                  <c:v>607</c:v>
                </c:pt>
                <c:pt idx="194">
                  <c:v>606</c:v>
                </c:pt>
                <c:pt idx="195">
                  <c:v>605</c:v>
                </c:pt>
                <c:pt idx="196">
                  <c:v>604</c:v>
                </c:pt>
                <c:pt idx="197">
                  <c:v>603</c:v>
                </c:pt>
                <c:pt idx="198">
                  <c:v>602</c:v>
                </c:pt>
                <c:pt idx="199">
                  <c:v>601</c:v>
                </c:pt>
                <c:pt idx="200">
                  <c:v>600</c:v>
                </c:pt>
                <c:pt idx="201">
                  <c:v>599</c:v>
                </c:pt>
                <c:pt idx="202">
                  <c:v>598</c:v>
                </c:pt>
                <c:pt idx="203">
                  <c:v>597</c:v>
                </c:pt>
                <c:pt idx="204">
                  <c:v>596</c:v>
                </c:pt>
                <c:pt idx="205">
                  <c:v>595</c:v>
                </c:pt>
                <c:pt idx="206">
                  <c:v>594</c:v>
                </c:pt>
                <c:pt idx="207">
                  <c:v>593</c:v>
                </c:pt>
                <c:pt idx="208">
                  <c:v>592</c:v>
                </c:pt>
                <c:pt idx="209">
                  <c:v>591</c:v>
                </c:pt>
                <c:pt idx="210">
                  <c:v>590</c:v>
                </c:pt>
                <c:pt idx="211">
                  <c:v>589</c:v>
                </c:pt>
                <c:pt idx="212">
                  <c:v>588</c:v>
                </c:pt>
                <c:pt idx="213">
                  <c:v>587</c:v>
                </c:pt>
                <c:pt idx="214">
                  <c:v>586</c:v>
                </c:pt>
                <c:pt idx="215">
                  <c:v>585</c:v>
                </c:pt>
                <c:pt idx="216">
                  <c:v>584</c:v>
                </c:pt>
                <c:pt idx="217">
                  <c:v>583</c:v>
                </c:pt>
                <c:pt idx="218">
                  <c:v>582</c:v>
                </c:pt>
                <c:pt idx="219">
                  <c:v>581</c:v>
                </c:pt>
                <c:pt idx="220">
                  <c:v>580</c:v>
                </c:pt>
                <c:pt idx="221">
                  <c:v>579</c:v>
                </c:pt>
                <c:pt idx="222">
                  <c:v>578</c:v>
                </c:pt>
                <c:pt idx="223">
                  <c:v>577</c:v>
                </c:pt>
                <c:pt idx="224">
                  <c:v>576</c:v>
                </c:pt>
                <c:pt idx="225">
                  <c:v>575</c:v>
                </c:pt>
                <c:pt idx="226">
                  <c:v>574</c:v>
                </c:pt>
                <c:pt idx="227">
                  <c:v>573</c:v>
                </c:pt>
                <c:pt idx="228">
                  <c:v>572</c:v>
                </c:pt>
                <c:pt idx="229">
                  <c:v>571</c:v>
                </c:pt>
                <c:pt idx="230">
                  <c:v>570</c:v>
                </c:pt>
                <c:pt idx="231">
                  <c:v>569</c:v>
                </c:pt>
                <c:pt idx="232">
                  <c:v>568</c:v>
                </c:pt>
                <c:pt idx="233">
                  <c:v>567</c:v>
                </c:pt>
                <c:pt idx="234">
                  <c:v>566</c:v>
                </c:pt>
                <c:pt idx="235">
                  <c:v>565</c:v>
                </c:pt>
                <c:pt idx="236">
                  <c:v>564</c:v>
                </c:pt>
                <c:pt idx="237">
                  <c:v>563</c:v>
                </c:pt>
                <c:pt idx="238">
                  <c:v>562</c:v>
                </c:pt>
                <c:pt idx="239">
                  <c:v>561</c:v>
                </c:pt>
                <c:pt idx="240">
                  <c:v>560</c:v>
                </c:pt>
                <c:pt idx="241">
                  <c:v>559</c:v>
                </c:pt>
                <c:pt idx="242">
                  <c:v>558</c:v>
                </c:pt>
                <c:pt idx="243">
                  <c:v>557</c:v>
                </c:pt>
                <c:pt idx="244">
                  <c:v>556</c:v>
                </c:pt>
                <c:pt idx="245">
                  <c:v>555</c:v>
                </c:pt>
                <c:pt idx="246">
                  <c:v>554</c:v>
                </c:pt>
                <c:pt idx="247">
                  <c:v>553</c:v>
                </c:pt>
                <c:pt idx="248">
                  <c:v>552</c:v>
                </c:pt>
                <c:pt idx="249">
                  <c:v>551</c:v>
                </c:pt>
                <c:pt idx="250">
                  <c:v>550</c:v>
                </c:pt>
                <c:pt idx="251">
                  <c:v>549</c:v>
                </c:pt>
                <c:pt idx="252">
                  <c:v>548</c:v>
                </c:pt>
                <c:pt idx="253">
                  <c:v>547</c:v>
                </c:pt>
                <c:pt idx="254">
                  <c:v>546</c:v>
                </c:pt>
                <c:pt idx="255">
                  <c:v>545</c:v>
                </c:pt>
                <c:pt idx="256">
                  <c:v>544</c:v>
                </c:pt>
                <c:pt idx="257">
                  <c:v>543</c:v>
                </c:pt>
                <c:pt idx="258">
                  <c:v>542</c:v>
                </c:pt>
                <c:pt idx="259">
                  <c:v>541</c:v>
                </c:pt>
                <c:pt idx="260">
                  <c:v>540</c:v>
                </c:pt>
                <c:pt idx="261">
                  <c:v>539</c:v>
                </c:pt>
                <c:pt idx="262">
                  <c:v>538</c:v>
                </c:pt>
                <c:pt idx="263">
                  <c:v>537</c:v>
                </c:pt>
                <c:pt idx="264">
                  <c:v>536</c:v>
                </c:pt>
                <c:pt idx="265">
                  <c:v>535</c:v>
                </c:pt>
                <c:pt idx="266">
                  <c:v>534</c:v>
                </c:pt>
                <c:pt idx="267">
                  <c:v>533</c:v>
                </c:pt>
                <c:pt idx="268">
                  <c:v>532</c:v>
                </c:pt>
                <c:pt idx="269">
                  <c:v>531</c:v>
                </c:pt>
                <c:pt idx="270">
                  <c:v>530</c:v>
                </c:pt>
                <c:pt idx="271">
                  <c:v>529</c:v>
                </c:pt>
                <c:pt idx="272">
                  <c:v>528</c:v>
                </c:pt>
                <c:pt idx="273">
                  <c:v>527</c:v>
                </c:pt>
                <c:pt idx="274">
                  <c:v>526</c:v>
                </c:pt>
                <c:pt idx="275">
                  <c:v>525</c:v>
                </c:pt>
                <c:pt idx="276">
                  <c:v>524</c:v>
                </c:pt>
                <c:pt idx="277">
                  <c:v>523</c:v>
                </c:pt>
                <c:pt idx="278">
                  <c:v>522</c:v>
                </c:pt>
                <c:pt idx="279">
                  <c:v>521</c:v>
                </c:pt>
                <c:pt idx="280">
                  <c:v>520</c:v>
                </c:pt>
                <c:pt idx="281">
                  <c:v>519</c:v>
                </c:pt>
                <c:pt idx="282">
                  <c:v>518</c:v>
                </c:pt>
                <c:pt idx="283">
                  <c:v>517</c:v>
                </c:pt>
                <c:pt idx="284">
                  <c:v>516</c:v>
                </c:pt>
                <c:pt idx="285">
                  <c:v>515</c:v>
                </c:pt>
                <c:pt idx="286">
                  <c:v>514</c:v>
                </c:pt>
                <c:pt idx="287">
                  <c:v>513</c:v>
                </c:pt>
                <c:pt idx="288">
                  <c:v>512</c:v>
                </c:pt>
                <c:pt idx="289">
                  <c:v>511</c:v>
                </c:pt>
                <c:pt idx="290">
                  <c:v>510</c:v>
                </c:pt>
                <c:pt idx="291">
                  <c:v>509</c:v>
                </c:pt>
                <c:pt idx="292">
                  <c:v>508</c:v>
                </c:pt>
                <c:pt idx="293">
                  <c:v>507</c:v>
                </c:pt>
                <c:pt idx="294">
                  <c:v>506</c:v>
                </c:pt>
                <c:pt idx="295">
                  <c:v>505</c:v>
                </c:pt>
                <c:pt idx="296">
                  <c:v>504</c:v>
                </c:pt>
                <c:pt idx="297">
                  <c:v>503</c:v>
                </c:pt>
                <c:pt idx="298">
                  <c:v>502</c:v>
                </c:pt>
                <c:pt idx="299">
                  <c:v>501</c:v>
                </c:pt>
                <c:pt idx="300">
                  <c:v>500</c:v>
                </c:pt>
                <c:pt idx="301">
                  <c:v>499</c:v>
                </c:pt>
                <c:pt idx="302">
                  <c:v>498</c:v>
                </c:pt>
                <c:pt idx="303">
                  <c:v>497</c:v>
                </c:pt>
                <c:pt idx="304">
                  <c:v>496</c:v>
                </c:pt>
                <c:pt idx="305">
                  <c:v>495</c:v>
                </c:pt>
                <c:pt idx="306">
                  <c:v>494</c:v>
                </c:pt>
                <c:pt idx="307">
                  <c:v>493</c:v>
                </c:pt>
                <c:pt idx="308">
                  <c:v>492</c:v>
                </c:pt>
                <c:pt idx="309">
                  <c:v>491</c:v>
                </c:pt>
                <c:pt idx="310">
                  <c:v>490</c:v>
                </c:pt>
                <c:pt idx="311">
                  <c:v>489</c:v>
                </c:pt>
                <c:pt idx="312">
                  <c:v>488</c:v>
                </c:pt>
                <c:pt idx="313">
                  <c:v>487</c:v>
                </c:pt>
                <c:pt idx="314">
                  <c:v>486</c:v>
                </c:pt>
                <c:pt idx="315">
                  <c:v>485</c:v>
                </c:pt>
                <c:pt idx="316">
                  <c:v>484</c:v>
                </c:pt>
                <c:pt idx="317">
                  <c:v>483</c:v>
                </c:pt>
                <c:pt idx="318">
                  <c:v>482</c:v>
                </c:pt>
                <c:pt idx="319">
                  <c:v>481</c:v>
                </c:pt>
                <c:pt idx="320">
                  <c:v>480</c:v>
                </c:pt>
                <c:pt idx="321">
                  <c:v>479</c:v>
                </c:pt>
                <c:pt idx="322">
                  <c:v>478</c:v>
                </c:pt>
                <c:pt idx="323">
                  <c:v>477</c:v>
                </c:pt>
                <c:pt idx="324">
                  <c:v>476</c:v>
                </c:pt>
                <c:pt idx="325">
                  <c:v>475</c:v>
                </c:pt>
                <c:pt idx="326">
                  <c:v>474</c:v>
                </c:pt>
                <c:pt idx="327">
                  <c:v>473</c:v>
                </c:pt>
                <c:pt idx="328">
                  <c:v>472</c:v>
                </c:pt>
                <c:pt idx="329">
                  <c:v>471</c:v>
                </c:pt>
                <c:pt idx="330">
                  <c:v>470</c:v>
                </c:pt>
                <c:pt idx="331">
                  <c:v>469</c:v>
                </c:pt>
                <c:pt idx="332">
                  <c:v>468</c:v>
                </c:pt>
                <c:pt idx="333">
                  <c:v>467</c:v>
                </c:pt>
                <c:pt idx="334">
                  <c:v>466</c:v>
                </c:pt>
                <c:pt idx="335">
                  <c:v>465</c:v>
                </c:pt>
                <c:pt idx="336">
                  <c:v>464</c:v>
                </c:pt>
                <c:pt idx="337">
                  <c:v>463</c:v>
                </c:pt>
                <c:pt idx="338">
                  <c:v>462</c:v>
                </c:pt>
                <c:pt idx="339">
                  <c:v>461</c:v>
                </c:pt>
                <c:pt idx="340">
                  <c:v>460</c:v>
                </c:pt>
                <c:pt idx="341">
                  <c:v>459</c:v>
                </c:pt>
                <c:pt idx="342">
                  <c:v>458</c:v>
                </c:pt>
                <c:pt idx="343">
                  <c:v>457</c:v>
                </c:pt>
                <c:pt idx="344">
                  <c:v>456</c:v>
                </c:pt>
                <c:pt idx="345">
                  <c:v>455</c:v>
                </c:pt>
                <c:pt idx="346">
                  <c:v>454</c:v>
                </c:pt>
                <c:pt idx="347">
                  <c:v>453</c:v>
                </c:pt>
                <c:pt idx="348">
                  <c:v>452</c:v>
                </c:pt>
                <c:pt idx="349">
                  <c:v>451</c:v>
                </c:pt>
                <c:pt idx="350">
                  <c:v>450</c:v>
                </c:pt>
                <c:pt idx="351">
                  <c:v>449</c:v>
                </c:pt>
                <c:pt idx="352">
                  <c:v>448</c:v>
                </c:pt>
                <c:pt idx="353">
                  <c:v>447</c:v>
                </c:pt>
                <c:pt idx="354">
                  <c:v>446</c:v>
                </c:pt>
                <c:pt idx="355">
                  <c:v>445</c:v>
                </c:pt>
                <c:pt idx="356">
                  <c:v>444</c:v>
                </c:pt>
                <c:pt idx="357">
                  <c:v>443</c:v>
                </c:pt>
                <c:pt idx="358">
                  <c:v>442</c:v>
                </c:pt>
                <c:pt idx="359">
                  <c:v>441</c:v>
                </c:pt>
                <c:pt idx="360">
                  <c:v>440</c:v>
                </c:pt>
                <c:pt idx="361">
                  <c:v>439</c:v>
                </c:pt>
                <c:pt idx="362">
                  <c:v>438</c:v>
                </c:pt>
                <c:pt idx="363">
                  <c:v>437</c:v>
                </c:pt>
                <c:pt idx="364">
                  <c:v>436</c:v>
                </c:pt>
                <c:pt idx="365">
                  <c:v>435</c:v>
                </c:pt>
                <c:pt idx="366">
                  <c:v>434</c:v>
                </c:pt>
                <c:pt idx="367">
                  <c:v>433</c:v>
                </c:pt>
                <c:pt idx="368">
                  <c:v>432</c:v>
                </c:pt>
                <c:pt idx="369">
                  <c:v>431</c:v>
                </c:pt>
                <c:pt idx="370">
                  <c:v>430</c:v>
                </c:pt>
                <c:pt idx="371">
                  <c:v>429</c:v>
                </c:pt>
                <c:pt idx="372">
                  <c:v>428</c:v>
                </c:pt>
                <c:pt idx="373">
                  <c:v>427</c:v>
                </c:pt>
                <c:pt idx="374">
                  <c:v>426</c:v>
                </c:pt>
                <c:pt idx="375">
                  <c:v>425</c:v>
                </c:pt>
                <c:pt idx="376">
                  <c:v>424</c:v>
                </c:pt>
                <c:pt idx="377">
                  <c:v>423</c:v>
                </c:pt>
                <c:pt idx="378">
                  <c:v>422</c:v>
                </c:pt>
                <c:pt idx="379">
                  <c:v>421</c:v>
                </c:pt>
                <c:pt idx="380">
                  <c:v>420</c:v>
                </c:pt>
                <c:pt idx="381">
                  <c:v>419</c:v>
                </c:pt>
                <c:pt idx="382">
                  <c:v>418</c:v>
                </c:pt>
                <c:pt idx="383">
                  <c:v>417</c:v>
                </c:pt>
                <c:pt idx="384">
                  <c:v>416</c:v>
                </c:pt>
                <c:pt idx="385">
                  <c:v>415</c:v>
                </c:pt>
                <c:pt idx="386">
                  <c:v>414</c:v>
                </c:pt>
                <c:pt idx="387">
                  <c:v>413</c:v>
                </c:pt>
                <c:pt idx="388">
                  <c:v>412</c:v>
                </c:pt>
                <c:pt idx="389">
                  <c:v>411</c:v>
                </c:pt>
                <c:pt idx="390">
                  <c:v>410</c:v>
                </c:pt>
                <c:pt idx="391">
                  <c:v>409</c:v>
                </c:pt>
                <c:pt idx="392">
                  <c:v>408</c:v>
                </c:pt>
                <c:pt idx="393">
                  <c:v>407</c:v>
                </c:pt>
                <c:pt idx="394">
                  <c:v>406</c:v>
                </c:pt>
                <c:pt idx="395">
                  <c:v>405</c:v>
                </c:pt>
                <c:pt idx="396">
                  <c:v>404</c:v>
                </c:pt>
                <c:pt idx="397">
                  <c:v>403</c:v>
                </c:pt>
                <c:pt idx="398">
                  <c:v>402</c:v>
                </c:pt>
                <c:pt idx="399">
                  <c:v>401</c:v>
                </c:pt>
                <c:pt idx="400">
                  <c:v>400</c:v>
                </c:pt>
                <c:pt idx="401">
                  <c:v>399</c:v>
                </c:pt>
                <c:pt idx="402">
                  <c:v>398</c:v>
                </c:pt>
                <c:pt idx="403">
                  <c:v>397</c:v>
                </c:pt>
                <c:pt idx="404">
                  <c:v>396</c:v>
                </c:pt>
                <c:pt idx="405">
                  <c:v>395</c:v>
                </c:pt>
                <c:pt idx="406">
                  <c:v>394</c:v>
                </c:pt>
                <c:pt idx="407">
                  <c:v>393</c:v>
                </c:pt>
                <c:pt idx="408">
                  <c:v>392</c:v>
                </c:pt>
                <c:pt idx="409">
                  <c:v>391</c:v>
                </c:pt>
                <c:pt idx="410">
                  <c:v>390</c:v>
                </c:pt>
                <c:pt idx="411">
                  <c:v>389</c:v>
                </c:pt>
                <c:pt idx="412">
                  <c:v>388</c:v>
                </c:pt>
                <c:pt idx="413">
                  <c:v>387</c:v>
                </c:pt>
                <c:pt idx="414">
                  <c:v>386</c:v>
                </c:pt>
                <c:pt idx="415">
                  <c:v>385</c:v>
                </c:pt>
                <c:pt idx="416">
                  <c:v>384</c:v>
                </c:pt>
                <c:pt idx="417">
                  <c:v>383</c:v>
                </c:pt>
                <c:pt idx="418">
                  <c:v>382</c:v>
                </c:pt>
                <c:pt idx="419">
                  <c:v>381</c:v>
                </c:pt>
                <c:pt idx="420">
                  <c:v>380</c:v>
                </c:pt>
                <c:pt idx="421">
                  <c:v>379</c:v>
                </c:pt>
                <c:pt idx="422">
                  <c:v>378</c:v>
                </c:pt>
                <c:pt idx="423">
                  <c:v>377</c:v>
                </c:pt>
                <c:pt idx="424">
                  <c:v>376</c:v>
                </c:pt>
                <c:pt idx="425">
                  <c:v>375</c:v>
                </c:pt>
                <c:pt idx="426">
                  <c:v>374</c:v>
                </c:pt>
                <c:pt idx="427">
                  <c:v>373</c:v>
                </c:pt>
                <c:pt idx="428">
                  <c:v>372</c:v>
                </c:pt>
                <c:pt idx="429">
                  <c:v>371</c:v>
                </c:pt>
                <c:pt idx="430">
                  <c:v>370</c:v>
                </c:pt>
                <c:pt idx="431">
                  <c:v>369</c:v>
                </c:pt>
                <c:pt idx="432">
                  <c:v>368</c:v>
                </c:pt>
                <c:pt idx="433">
                  <c:v>367</c:v>
                </c:pt>
                <c:pt idx="434">
                  <c:v>366</c:v>
                </c:pt>
                <c:pt idx="435">
                  <c:v>365</c:v>
                </c:pt>
                <c:pt idx="436">
                  <c:v>364</c:v>
                </c:pt>
                <c:pt idx="437">
                  <c:v>363</c:v>
                </c:pt>
                <c:pt idx="438">
                  <c:v>362</c:v>
                </c:pt>
                <c:pt idx="439">
                  <c:v>361</c:v>
                </c:pt>
                <c:pt idx="440">
                  <c:v>360</c:v>
                </c:pt>
                <c:pt idx="441">
                  <c:v>359</c:v>
                </c:pt>
                <c:pt idx="442">
                  <c:v>358</c:v>
                </c:pt>
                <c:pt idx="443">
                  <c:v>357</c:v>
                </c:pt>
                <c:pt idx="444">
                  <c:v>356</c:v>
                </c:pt>
                <c:pt idx="445">
                  <c:v>355</c:v>
                </c:pt>
                <c:pt idx="446">
                  <c:v>354</c:v>
                </c:pt>
                <c:pt idx="447">
                  <c:v>353</c:v>
                </c:pt>
                <c:pt idx="448">
                  <c:v>352</c:v>
                </c:pt>
                <c:pt idx="449">
                  <c:v>351</c:v>
                </c:pt>
                <c:pt idx="450">
                  <c:v>350</c:v>
                </c:pt>
                <c:pt idx="451">
                  <c:v>349</c:v>
                </c:pt>
                <c:pt idx="452">
                  <c:v>348</c:v>
                </c:pt>
                <c:pt idx="453">
                  <c:v>347</c:v>
                </c:pt>
                <c:pt idx="454">
                  <c:v>346</c:v>
                </c:pt>
                <c:pt idx="455">
                  <c:v>345</c:v>
                </c:pt>
                <c:pt idx="456">
                  <c:v>344</c:v>
                </c:pt>
                <c:pt idx="457">
                  <c:v>343</c:v>
                </c:pt>
                <c:pt idx="458">
                  <c:v>342</c:v>
                </c:pt>
                <c:pt idx="459">
                  <c:v>341</c:v>
                </c:pt>
                <c:pt idx="460">
                  <c:v>340</c:v>
                </c:pt>
                <c:pt idx="461">
                  <c:v>339</c:v>
                </c:pt>
                <c:pt idx="462">
                  <c:v>338</c:v>
                </c:pt>
                <c:pt idx="463">
                  <c:v>337</c:v>
                </c:pt>
                <c:pt idx="464">
                  <c:v>336</c:v>
                </c:pt>
                <c:pt idx="465">
                  <c:v>335</c:v>
                </c:pt>
                <c:pt idx="466">
                  <c:v>334</c:v>
                </c:pt>
                <c:pt idx="467">
                  <c:v>333</c:v>
                </c:pt>
                <c:pt idx="468">
                  <c:v>332</c:v>
                </c:pt>
                <c:pt idx="469">
                  <c:v>331</c:v>
                </c:pt>
                <c:pt idx="470">
                  <c:v>330</c:v>
                </c:pt>
                <c:pt idx="471">
                  <c:v>329</c:v>
                </c:pt>
                <c:pt idx="472">
                  <c:v>328</c:v>
                </c:pt>
                <c:pt idx="473">
                  <c:v>327</c:v>
                </c:pt>
                <c:pt idx="474">
                  <c:v>326</c:v>
                </c:pt>
                <c:pt idx="475">
                  <c:v>325</c:v>
                </c:pt>
                <c:pt idx="476">
                  <c:v>324</c:v>
                </c:pt>
                <c:pt idx="477">
                  <c:v>323</c:v>
                </c:pt>
                <c:pt idx="478">
                  <c:v>322</c:v>
                </c:pt>
                <c:pt idx="479">
                  <c:v>321</c:v>
                </c:pt>
                <c:pt idx="480">
                  <c:v>320</c:v>
                </c:pt>
                <c:pt idx="481">
                  <c:v>319</c:v>
                </c:pt>
                <c:pt idx="482">
                  <c:v>318</c:v>
                </c:pt>
                <c:pt idx="483">
                  <c:v>317</c:v>
                </c:pt>
                <c:pt idx="484">
                  <c:v>316</c:v>
                </c:pt>
                <c:pt idx="485">
                  <c:v>315</c:v>
                </c:pt>
                <c:pt idx="486">
                  <c:v>314</c:v>
                </c:pt>
                <c:pt idx="487">
                  <c:v>313</c:v>
                </c:pt>
                <c:pt idx="488">
                  <c:v>312</c:v>
                </c:pt>
                <c:pt idx="489">
                  <c:v>311</c:v>
                </c:pt>
                <c:pt idx="490">
                  <c:v>310</c:v>
                </c:pt>
                <c:pt idx="491">
                  <c:v>309</c:v>
                </c:pt>
                <c:pt idx="492">
                  <c:v>308</c:v>
                </c:pt>
                <c:pt idx="493">
                  <c:v>307</c:v>
                </c:pt>
                <c:pt idx="494">
                  <c:v>306</c:v>
                </c:pt>
                <c:pt idx="495">
                  <c:v>305</c:v>
                </c:pt>
                <c:pt idx="496">
                  <c:v>304</c:v>
                </c:pt>
                <c:pt idx="497">
                  <c:v>303</c:v>
                </c:pt>
                <c:pt idx="498">
                  <c:v>302</c:v>
                </c:pt>
                <c:pt idx="499">
                  <c:v>301</c:v>
                </c:pt>
                <c:pt idx="500">
                  <c:v>300</c:v>
                </c:pt>
                <c:pt idx="501">
                  <c:v>299</c:v>
                </c:pt>
                <c:pt idx="502">
                  <c:v>298</c:v>
                </c:pt>
                <c:pt idx="503">
                  <c:v>297</c:v>
                </c:pt>
                <c:pt idx="504">
                  <c:v>296</c:v>
                </c:pt>
                <c:pt idx="505">
                  <c:v>295</c:v>
                </c:pt>
                <c:pt idx="506">
                  <c:v>294</c:v>
                </c:pt>
                <c:pt idx="507">
                  <c:v>293</c:v>
                </c:pt>
                <c:pt idx="508">
                  <c:v>292</c:v>
                </c:pt>
                <c:pt idx="509">
                  <c:v>291</c:v>
                </c:pt>
                <c:pt idx="510">
                  <c:v>290</c:v>
                </c:pt>
                <c:pt idx="511">
                  <c:v>289</c:v>
                </c:pt>
                <c:pt idx="512">
                  <c:v>288</c:v>
                </c:pt>
                <c:pt idx="513">
                  <c:v>287</c:v>
                </c:pt>
                <c:pt idx="514">
                  <c:v>286</c:v>
                </c:pt>
                <c:pt idx="515">
                  <c:v>285</c:v>
                </c:pt>
                <c:pt idx="516">
                  <c:v>284</c:v>
                </c:pt>
                <c:pt idx="517">
                  <c:v>283</c:v>
                </c:pt>
                <c:pt idx="518">
                  <c:v>282</c:v>
                </c:pt>
                <c:pt idx="519">
                  <c:v>281</c:v>
                </c:pt>
                <c:pt idx="520">
                  <c:v>280</c:v>
                </c:pt>
                <c:pt idx="521">
                  <c:v>279</c:v>
                </c:pt>
                <c:pt idx="522">
                  <c:v>278</c:v>
                </c:pt>
                <c:pt idx="523">
                  <c:v>277</c:v>
                </c:pt>
                <c:pt idx="524">
                  <c:v>276</c:v>
                </c:pt>
                <c:pt idx="525">
                  <c:v>275</c:v>
                </c:pt>
                <c:pt idx="526">
                  <c:v>274</c:v>
                </c:pt>
                <c:pt idx="527">
                  <c:v>273</c:v>
                </c:pt>
                <c:pt idx="528">
                  <c:v>272</c:v>
                </c:pt>
                <c:pt idx="529">
                  <c:v>271</c:v>
                </c:pt>
                <c:pt idx="530">
                  <c:v>270</c:v>
                </c:pt>
                <c:pt idx="531">
                  <c:v>269</c:v>
                </c:pt>
                <c:pt idx="532">
                  <c:v>268</c:v>
                </c:pt>
                <c:pt idx="533">
                  <c:v>267</c:v>
                </c:pt>
                <c:pt idx="534">
                  <c:v>266</c:v>
                </c:pt>
                <c:pt idx="535">
                  <c:v>265</c:v>
                </c:pt>
                <c:pt idx="536">
                  <c:v>264</c:v>
                </c:pt>
                <c:pt idx="537">
                  <c:v>263</c:v>
                </c:pt>
                <c:pt idx="538">
                  <c:v>262</c:v>
                </c:pt>
                <c:pt idx="539">
                  <c:v>261</c:v>
                </c:pt>
                <c:pt idx="540">
                  <c:v>260</c:v>
                </c:pt>
                <c:pt idx="541">
                  <c:v>259</c:v>
                </c:pt>
                <c:pt idx="542">
                  <c:v>258</c:v>
                </c:pt>
                <c:pt idx="543">
                  <c:v>257</c:v>
                </c:pt>
                <c:pt idx="544">
                  <c:v>256</c:v>
                </c:pt>
                <c:pt idx="545">
                  <c:v>255</c:v>
                </c:pt>
                <c:pt idx="546">
                  <c:v>254</c:v>
                </c:pt>
                <c:pt idx="547">
                  <c:v>253</c:v>
                </c:pt>
                <c:pt idx="548">
                  <c:v>252</c:v>
                </c:pt>
                <c:pt idx="549">
                  <c:v>251</c:v>
                </c:pt>
                <c:pt idx="550">
                  <c:v>250</c:v>
                </c:pt>
                <c:pt idx="551">
                  <c:v>249</c:v>
                </c:pt>
                <c:pt idx="552">
                  <c:v>248</c:v>
                </c:pt>
                <c:pt idx="553">
                  <c:v>247</c:v>
                </c:pt>
                <c:pt idx="554">
                  <c:v>246</c:v>
                </c:pt>
                <c:pt idx="555">
                  <c:v>245</c:v>
                </c:pt>
                <c:pt idx="556">
                  <c:v>244</c:v>
                </c:pt>
                <c:pt idx="557">
                  <c:v>243</c:v>
                </c:pt>
                <c:pt idx="558">
                  <c:v>242</c:v>
                </c:pt>
                <c:pt idx="559">
                  <c:v>241</c:v>
                </c:pt>
                <c:pt idx="560">
                  <c:v>240</c:v>
                </c:pt>
                <c:pt idx="561">
                  <c:v>239</c:v>
                </c:pt>
                <c:pt idx="562">
                  <c:v>238</c:v>
                </c:pt>
                <c:pt idx="563">
                  <c:v>237</c:v>
                </c:pt>
                <c:pt idx="564">
                  <c:v>236</c:v>
                </c:pt>
                <c:pt idx="565">
                  <c:v>235</c:v>
                </c:pt>
                <c:pt idx="566">
                  <c:v>234</c:v>
                </c:pt>
                <c:pt idx="567">
                  <c:v>233</c:v>
                </c:pt>
                <c:pt idx="568">
                  <c:v>232</c:v>
                </c:pt>
                <c:pt idx="569">
                  <c:v>231</c:v>
                </c:pt>
                <c:pt idx="570">
                  <c:v>230</c:v>
                </c:pt>
                <c:pt idx="571">
                  <c:v>229</c:v>
                </c:pt>
                <c:pt idx="572">
                  <c:v>228</c:v>
                </c:pt>
                <c:pt idx="573">
                  <c:v>227</c:v>
                </c:pt>
                <c:pt idx="574">
                  <c:v>226</c:v>
                </c:pt>
                <c:pt idx="575">
                  <c:v>225</c:v>
                </c:pt>
                <c:pt idx="576">
                  <c:v>224</c:v>
                </c:pt>
                <c:pt idx="577">
                  <c:v>223</c:v>
                </c:pt>
                <c:pt idx="578">
                  <c:v>222</c:v>
                </c:pt>
                <c:pt idx="579">
                  <c:v>221</c:v>
                </c:pt>
                <c:pt idx="580">
                  <c:v>220</c:v>
                </c:pt>
                <c:pt idx="581">
                  <c:v>219</c:v>
                </c:pt>
                <c:pt idx="582">
                  <c:v>218</c:v>
                </c:pt>
                <c:pt idx="583">
                  <c:v>217</c:v>
                </c:pt>
                <c:pt idx="584">
                  <c:v>216</c:v>
                </c:pt>
                <c:pt idx="585">
                  <c:v>215</c:v>
                </c:pt>
                <c:pt idx="586">
                  <c:v>214</c:v>
                </c:pt>
                <c:pt idx="587">
                  <c:v>213</c:v>
                </c:pt>
                <c:pt idx="588">
                  <c:v>212</c:v>
                </c:pt>
                <c:pt idx="589">
                  <c:v>211</c:v>
                </c:pt>
                <c:pt idx="590">
                  <c:v>210</c:v>
                </c:pt>
                <c:pt idx="591">
                  <c:v>209</c:v>
                </c:pt>
                <c:pt idx="592">
                  <c:v>208</c:v>
                </c:pt>
                <c:pt idx="593">
                  <c:v>207</c:v>
                </c:pt>
                <c:pt idx="594">
                  <c:v>206</c:v>
                </c:pt>
                <c:pt idx="595">
                  <c:v>205</c:v>
                </c:pt>
                <c:pt idx="596">
                  <c:v>204</c:v>
                </c:pt>
                <c:pt idx="597">
                  <c:v>203</c:v>
                </c:pt>
                <c:pt idx="598">
                  <c:v>202</c:v>
                </c:pt>
                <c:pt idx="599">
                  <c:v>201</c:v>
                </c:pt>
                <c:pt idx="600">
                  <c:v>200</c:v>
                </c:pt>
              </c:numCache>
            </c:numRef>
          </c:xVal>
          <c:yVal>
            <c:numRef>
              <c:f>'Methanol-F'!$F$3:$F$603</c:f>
              <c:numCache>
                <c:formatCode>General</c:formatCode>
                <c:ptCount val="601"/>
                <c:pt idx="0">
                  <c:v>1.4999999999999999E-2</c:v>
                </c:pt>
                <c:pt idx="1">
                  <c:v>1.4999999999999999E-2</c:v>
                </c:pt>
                <c:pt idx="2">
                  <c:v>1.4999999999999999E-2</c:v>
                </c:pt>
                <c:pt idx="3">
                  <c:v>1.4999999999999999E-2</c:v>
                </c:pt>
                <c:pt idx="4">
                  <c:v>1.4999999999999999E-2</c:v>
                </c:pt>
                <c:pt idx="5">
                  <c:v>1.4999999999999999E-2</c:v>
                </c:pt>
                <c:pt idx="6">
                  <c:v>1.4999999999999999E-2</c:v>
                </c:pt>
                <c:pt idx="7">
                  <c:v>1.4999999999999999E-2</c:v>
                </c:pt>
                <c:pt idx="8">
                  <c:v>1.4999999999999999E-2</c:v>
                </c:pt>
                <c:pt idx="9">
                  <c:v>1.4999999999999999E-2</c:v>
                </c:pt>
                <c:pt idx="10">
                  <c:v>1.4999999999999999E-2</c:v>
                </c:pt>
                <c:pt idx="11">
                  <c:v>1.4999999999999999E-2</c:v>
                </c:pt>
                <c:pt idx="12">
                  <c:v>1.4999999999999999E-2</c:v>
                </c:pt>
                <c:pt idx="13">
                  <c:v>1.4999999999999999E-2</c:v>
                </c:pt>
                <c:pt idx="14">
                  <c:v>1.4999999999999999E-2</c:v>
                </c:pt>
                <c:pt idx="15">
                  <c:v>1.4999999999999999E-2</c:v>
                </c:pt>
                <c:pt idx="16">
                  <c:v>1.4999999999999999E-2</c:v>
                </c:pt>
                <c:pt idx="17">
                  <c:v>1.4999999999999999E-2</c:v>
                </c:pt>
                <c:pt idx="18">
                  <c:v>1.4999999999999999E-2</c:v>
                </c:pt>
                <c:pt idx="19">
                  <c:v>1.4999999999999999E-2</c:v>
                </c:pt>
                <c:pt idx="20">
                  <c:v>1.4999999999999999E-2</c:v>
                </c:pt>
                <c:pt idx="21">
                  <c:v>1.4999999999999999E-2</c:v>
                </c:pt>
                <c:pt idx="22">
                  <c:v>1.4999999999999999E-2</c:v>
                </c:pt>
                <c:pt idx="23">
                  <c:v>1.4999999999999999E-2</c:v>
                </c:pt>
                <c:pt idx="24">
                  <c:v>1.4999999999999999E-2</c:v>
                </c:pt>
                <c:pt idx="25">
                  <c:v>1.4999999999999999E-2</c:v>
                </c:pt>
                <c:pt idx="26">
                  <c:v>1.4E-2</c:v>
                </c:pt>
                <c:pt idx="27">
                  <c:v>1.4E-2</c:v>
                </c:pt>
                <c:pt idx="28">
                  <c:v>1.4E-2</c:v>
                </c:pt>
                <c:pt idx="29">
                  <c:v>1.4E-2</c:v>
                </c:pt>
                <c:pt idx="30">
                  <c:v>1.4E-2</c:v>
                </c:pt>
                <c:pt idx="31">
                  <c:v>1.4E-2</c:v>
                </c:pt>
                <c:pt idx="32">
                  <c:v>1.4E-2</c:v>
                </c:pt>
                <c:pt idx="33">
                  <c:v>1.4E-2</c:v>
                </c:pt>
                <c:pt idx="34">
                  <c:v>1.4E-2</c:v>
                </c:pt>
                <c:pt idx="35">
                  <c:v>1.4E-2</c:v>
                </c:pt>
                <c:pt idx="36">
                  <c:v>1.4E-2</c:v>
                </c:pt>
                <c:pt idx="37">
                  <c:v>1.4E-2</c:v>
                </c:pt>
                <c:pt idx="38">
                  <c:v>1.4E-2</c:v>
                </c:pt>
                <c:pt idx="39">
                  <c:v>1.4E-2</c:v>
                </c:pt>
                <c:pt idx="40">
                  <c:v>1.4E-2</c:v>
                </c:pt>
                <c:pt idx="41">
                  <c:v>1.4E-2</c:v>
                </c:pt>
                <c:pt idx="42">
                  <c:v>1.2999999999999999E-2</c:v>
                </c:pt>
                <c:pt idx="43">
                  <c:v>1.2999999999999999E-2</c:v>
                </c:pt>
                <c:pt idx="44">
                  <c:v>1.2999999999999999E-2</c:v>
                </c:pt>
                <c:pt idx="45">
                  <c:v>1.2999999999999999E-2</c:v>
                </c:pt>
                <c:pt idx="46">
                  <c:v>1.2999999999999999E-2</c:v>
                </c:pt>
                <c:pt idx="47">
                  <c:v>1.2999999999999999E-2</c:v>
                </c:pt>
                <c:pt idx="48">
                  <c:v>1.2999999999999999E-2</c:v>
                </c:pt>
                <c:pt idx="49">
                  <c:v>1.2999999999999999E-2</c:v>
                </c:pt>
                <c:pt idx="50">
                  <c:v>1.2999999999999999E-2</c:v>
                </c:pt>
                <c:pt idx="51">
                  <c:v>1.2999999999999999E-2</c:v>
                </c:pt>
                <c:pt idx="52">
                  <c:v>1.2999999999999999E-2</c:v>
                </c:pt>
                <c:pt idx="53">
                  <c:v>1.2999999999999999E-2</c:v>
                </c:pt>
                <c:pt idx="54">
                  <c:v>1.2999999999999999E-2</c:v>
                </c:pt>
                <c:pt idx="55">
                  <c:v>1.2999999999999999E-2</c:v>
                </c:pt>
                <c:pt idx="56">
                  <c:v>1.2999999999999999E-2</c:v>
                </c:pt>
                <c:pt idx="57">
                  <c:v>1.2999999999999999E-2</c:v>
                </c:pt>
                <c:pt idx="58">
                  <c:v>1.2999999999999999E-2</c:v>
                </c:pt>
                <c:pt idx="59">
                  <c:v>1.2999999999999999E-2</c:v>
                </c:pt>
                <c:pt idx="60">
                  <c:v>1.2999999999999999E-2</c:v>
                </c:pt>
                <c:pt idx="61">
                  <c:v>1.2999999999999999E-2</c:v>
                </c:pt>
                <c:pt idx="62">
                  <c:v>1.2999999999999999E-2</c:v>
                </c:pt>
                <c:pt idx="63">
                  <c:v>1.2E-2</c:v>
                </c:pt>
                <c:pt idx="64">
                  <c:v>1.2E-2</c:v>
                </c:pt>
                <c:pt idx="65">
                  <c:v>1.2E-2</c:v>
                </c:pt>
                <c:pt idx="66">
                  <c:v>1.2E-2</c:v>
                </c:pt>
                <c:pt idx="67">
                  <c:v>1.2E-2</c:v>
                </c:pt>
                <c:pt idx="68">
                  <c:v>1.2E-2</c:v>
                </c:pt>
                <c:pt idx="69">
                  <c:v>1.2E-2</c:v>
                </c:pt>
                <c:pt idx="70">
                  <c:v>1.2E-2</c:v>
                </c:pt>
                <c:pt idx="71">
                  <c:v>1.2E-2</c:v>
                </c:pt>
                <c:pt idx="72">
                  <c:v>1.2E-2</c:v>
                </c:pt>
                <c:pt idx="73">
                  <c:v>1.2E-2</c:v>
                </c:pt>
                <c:pt idx="74">
                  <c:v>1.2E-2</c:v>
                </c:pt>
                <c:pt idx="75">
                  <c:v>1.2E-2</c:v>
                </c:pt>
                <c:pt idx="76">
                  <c:v>1.2E-2</c:v>
                </c:pt>
                <c:pt idx="77">
                  <c:v>1.2E-2</c:v>
                </c:pt>
                <c:pt idx="78">
                  <c:v>1.2E-2</c:v>
                </c:pt>
                <c:pt idx="79">
                  <c:v>1.2E-2</c:v>
                </c:pt>
                <c:pt idx="80">
                  <c:v>1.2E-2</c:v>
                </c:pt>
                <c:pt idx="81">
                  <c:v>1.2E-2</c:v>
                </c:pt>
                <c:pt idx="82">
                  <c:v>1.2E-2</c:v>
                </c:pt>
                <c:pt idx="83">
                  <c:v>1.2E-2</c:v>
                </c:pt>
                <c:pt idx="84">
                  <c:v>1.2E-2</c:v>
                </c:pt>
                <c:pt idx="85">
                  <c:v>1.2E-2</c:v>
                </c:pt>
                <c:pt idx="86">
                  <c:v>1.2E-2</c:v>
                </c:pt>
                <c:pt idx="87">
                  <c:v>1.2E-2</c:v>
                </c:pt>
                <c:pt idx="88">
                  <c:v>1.2E-2</c:v>
                </c:pt>
                <c:pt idx="89">
                  <c:v>1.2E-2</c:v>
                </c:pt>
                <c:pt idx="90">
                  <c:v>1.2E-2</c:v>
                </c:pt>
                <c:pt idx="91">
                  <c:v>1.2999999999999999E-2</c:v>
                </c:pt>
                <c:pt idx="92">
                  <c:v>1.2999999999999999E-2</c:v>
                </c:pt>
                <c:pt idx="93">
                  <c:v>1.2999999999999999E-2</c:v>
                </c:pt>
                <c:pt idx="94">
                  <c:v>1.2999999999999999E-2</c:v>
                </c:pt>
                <c:pt idx="95">
                  <c:v>1.2999999999999999E-2</c:v>
                </c:pt>
                <c:pt idx="96">
                  <c:v>1.2999999999999999E-2</c:v>
                </c:pt>
                <c:pt idx="97">
                  <c:v>1.2999999999999999E-2</c:v>
                </c:pt>
                <c:pt idx="98">
                  <c:v>1.2999999999999999E-2</c:v>
                </c:pt>
                <c:pt idx="99">
                  <c:v>1.4E-2</c:v>
                </c:pt>
                <c:pt idx="100">
                  <c:v>1.4E-2</c:v>
                </c:pt>
                <c:pt idx="101">
                  <c:v>1.4E-2</c:v>
                </c:pt>
                <c:pt idx="102">
                  <c:v>1.4E-2</c:v>
                </c:pt>
                <c:pt idx="103">
                  <c:v>1.4999999999999999E-2</c:v>
                </c:pt>
                <c:pt idx="104">
                  <c:v>1.4999999999999999E-2</c:v>
                </c:pt>
                <c:pt idx="105">
                  <c:v>1.6E-2</c:v>
                </c:pt>
                <c:pt idx="106">
                  <c:v>1.7000000000000001E-2</c:v>
                </c:pt>
                <c:pt idx="107">
                  <c:v>1.7999999999999999E-2</c:v>
                </c:pt>
                <c:pt idx="108">
                  <c:v>1.9E-2</c:v>
                </c:pt>
                <c:pt idx="109">
                  <c:v>0.02</c:v>
                </c:pt>
                <c:pt idx="110">
                  <c:v>2.1999999999999999E-2</c:v>
                </c:pt>
                <c:pt idx="111">
                  <c:v>2.4E-2</c:v>
                </c:pt>
                <c:pt idx="112">
                  <c:v>2.5999999999999999E-2</c:v>
                </c:pt>
                <c:pt idx="113">
                  <c:v>2.9000000000000001E-2</c:v>
                </c:pt>
                <c:pt idx="114">
                  <c:v>3.3000000000000002E-2</c:v>
                </c:pt>
                <c:pt idx="115">
                  <c:v>3.6999999999999998E-2</c:v>
                </c:pt>
                <c:pt idx="116">
                  <c:v>4.2000000000000003E-2</c:v>
                </c:pt>
                <c:pt idx="117">
                  <c:v>4.8000000000000001E-2</c:v>
                </c:pt>
                <c:pt idx="118">
                  <c:v>5.5E-2</c:v>
                </c:pt>
                <c:pt idx="119">
                  <c:v>6.3E-2</c:v>
                </c:pt>
                <c:pt idx="120">
                  <c:v>7.0999999999999994E-2</c:v>
                </c:pt>
                <c:pt idx="121">
                  <c:v>8.1000000000000003E-2</c:v>
                </c:pt>
                <c:pt idx="122">
                  <c:v>9.2999999999999999E-2</c:v>
                </c:pt>
                <c:pt idx="123">
                  <c:v>0.104</c:v>
                </c:pt>
                <c:pt idx="124">
                  <c:v>0.11700000000000001</c:v>
                </c:pt>
                <c:pt idx="125">
                  <c:v>0.13</c:v>
                </c:pt>
                <c:pt idx="126">
                  <c:v>0.14399999999999999</c:v>
                </c:pt>
                <c:pt idx="127">
                  <c:v>0.158</c:v>
                </c:pt>
                <c:pt idx="128">
                  <c:v>0.17199999999999999</c:v>
                </c:pt>
                <c:pt idx="129">
                  <c:v>0.186</c:v>
                </c:pt>
                <c:pt idx="130">
                  <c:v>0.19900000000000001</c:v>
                </c:pt>
                <c:pt idx="131">
                  <c:v>0.21</c:v>
                </c:pt>
                <c:pt idx="132">
                  <c:v>0.22</c:v>
                </c:pt>
                <c:pt idx="133">
                  <c:v>0.22800000000000001</c:v>
                </c:pt>
                <c:pt idx="134">
                  <c:v>0.23300000000000001</c:v>
                </c:pt>
                <c:pt idx="135">
                  <c:v>0.23599999999999999</c:v>
                </c:pt>
                <c:pt idx="136">
                  <c:v>0.23699999999999999</c:v>
                </c:pt>
                <c:pt idx="137">
                  <c:v>0.23499999999999999</c:v>
                </c:pt>
                <c:pt idx="138">
                  <c:v>0.23100000000000001</c:v>
                </c:pt>
                <c:pt idx="139">
                  <c:v>0.224</c:v>
                </c:pt>
                <c:pt idx="140">
                  <c:v>0.217</c:v>
                </c:pt>
                <c:pt idx="141">
                  <c:v>0.20799999999999999</c:v>
                </c:pt>
                <c:pt idx="142">
                  <c:v>0.19800000000000001</c:v>
                </c:pt>
                <c:pt idx="143">
                  <c:v>0.188</c:v>
                </c:pt>
                <c:pt idx="144">
                  <c:v>0.17799999999999999</c:v>
                </c:pt>
                <c:pt idx="145">
                  <c:v>0.16800000000000001</c:v>
                </c:pt>
                <c:pt idx="146">
                  <c:v>0.158</c:v>
                </c:pt>
                <c:pt idx="147">
                  <c:v>0.14899999999999999</c:v>
                </c:pt>
                <c:pt idx="148">
                  <c:v>0.14000000000000001</c:v>
                </c:pt>
                <c:pt idx="149">
                  <c:v>0.13200000000000001</c:v>
                </c:pt>
                <c:pt idx="150">
                  <c:v>0.124</c:v>
                </c:pt>
                <c:pt idx="151">
                  <c:v>0.11700000000000001</c:v>
                </c:pt>
                <c:pt idx="152">
                  <c:v>0.111</c:v>
                </c:pt>
                <c:pt idx="153">
                  <c:v>0.105</c:v>
                </c:pt>
                <c:pt idx="154">
                  <c:v>0.1</c:v>
                </c:pt>
                <c:pt idx="155">
                  <c:v>9.6000000000000002E-2</c:v>
                </c:pt>
                <c:pt idx="156">
                  <c:v>9.1999999999999998E-2</c:v>
                </c:pt>
                <c:pt idx="157">
                  <c:v>8.7999999999999995E-2</c:v>
                </c:pt>
                <c:pt idx="158">
                  <c:v>8.5000000000000006E-2</c:v>
                </c:pt>
                <c:pt idx="159">
                  <c:v>8.2000000000000003E-2</c:v>
                </c:pt>
                <c:pt idx="160">
                  <c:v>7.9000000000000001E-2</c:v>
                </c:pt>
                <c:pt idx="161">
                  <c:v>7.6999999999999999E-2</c:v>
                </c:pt>
                <c:pt idx="162">
                  <c:v>7.4999999999999997E-2</c:v>
                </c:pt>
                <c:pt idx="163">
                  <c:v>7.2999999999999995E-2</c:v>
                </c:pt>
                <c:pt idx="164">
                  <c:v>7.0999999999999994E-2</c:v>
                </c:pt>
                <c:pt idx="165">
                  <c:v>7.0000000000000007E-2</c:v>
                </c:pt>
                <c:pt idx="166">
                  <c:v>6.8000000000000005E-2</c:v>
                </c:pt>
                <c:pt idx="167">
                  <c:v>6.7000000000000004E-2</c:v>
                </c:pt>
                <c:pt idx="168">
                  <c:v>6.6000000000000003E-2</c:v>
                </c:pt>
                <c:pt idx="169">
                  <c:v>6.6000000000000003E-2</c:v>
                </c:pt>
                <c:pt idx="170">
                  <c:v>6.5000000000000002E-2</c:v>
                </c:pt>
                <c:pt idx="171">
                  <c:v>6.4000000000000001E-2</c:v>
                </c:pt>
                <c:pt idx="172">
                  <c:v>6.4000000000000001E-2</c:v>
                </c:pt>
                <c:pt idx="173">
                  <c:v>6.4000000000000001E-2</c:v>
                </c:pt>
                <c:pt idx="174">
                  <c:v>6.4000000000000001E-2</c:v>
                </c:pt>
                <c:pt idx="175">
                  <c:v>6.4000000000000001E-2</c:v>
                </c:pt>
                <c:pt idx="176">
                  <c:v>6.4000000000000001E-2</c:v>
                </c:pt>
                <c:pt idx="177">
                  <c:v>6.4000000000000001E-2</c:v>
                </c:pt>
                <c:pt idx="178">
                  <c:v>6.5000000000000002E-2</c:v>
                </c:pt>
                <c:pt idx="179">
                  <c:v>6.5000000000000002E-2</c:v>
                </c:pt>
                <c:pt idx="180">
                  <c:v>6.5000000000000002E-2</c:v>
                </c:pt>
                <c:pt idx="181">
                  <c:v>6.5000000000000002E-2</c:v>
                </c:pt>
                <c:pt idx="182">
                  <c:v>6.5000000000000002E-2</c:v>
                </c:pt>
                <c:pt idx="183">
                  <c:v>6.6000000000000003E-2</c:v>
                </c:pt>
                <c:pt idx="184">
                  <c:v>6.6000000000000003E-2</c:v>
                </c:pt>
                <c:pt idx="185">
                  <c:v>6.6000000000000003E-2</c:v>
                </c:pt>
                <c:pt idx="186">
                  <c:v>6.5000000000000002E-2</c:v>
                </c:pt>
                <c:pt idx="187">
                  <c:v>6.5000000000000002E-2</c:v>
                </c:pt>
                <c:pt idx="188">
                  <c:v>6.5000000000000002E-2</c:v>
                </c:pt>
                <c:pt idx="189">
                  <c:v>6.4000000000000001E-2</c:v>
                </c:pt>
                <c:pt idx="190">
                  <c:v>6.3E-2</c:v>
                </c:pt>
                <c:pt idx="191">
                  <c:v>6.2E-2</c:v>
                </c:pt>
                <c:pt idx="192">
                  <c:v>6.2E-2</c:v>
                </c:pt>
                <c:pt idx="193">
                  <c:v>6.0999999999999999E-2</c:v>
                </c:pt>
                <c:pt idx="194">
                  <c:v>5.8999999999999997E-2</c:v>
                </c:pt>
                <c:pt idx="195">
                  <c:v>5.8000000000000003E-2</c:v>
                </c:pt>
                <c:pt idx="196">
                  <c:v>5.7000000000000002E-2</c:v>
                </c:pt>
                <c:pt idx="197">
                  <c:v>5.6000000000000001E-2</c:v>
                </c:pt>
                <c:pt idx="198">
                  <c:v>5.5E-2</c:v>
                </c:pt>
                <c:pt idx="199">
                  <c:v>5.2999999999999999E-2</c:v>
                </c:pt>
                <c:pt idx="200">
                  <c:v>5.2999999999999999E-2</c:v>
                </c:pt>
                <c:pt idx="201">
                  <c:v>5.0999999999999997E-2</c:v>
                </c:pt>
                <c:pt idx="202">
                  <c:v>0.05</c:v>
                </c:pt>
                <c:pt idx="203">
                  <c:v>4.9000000000000002E-2</c:v>
                </c:pt>
                <c:pt idx="204">
                  <c:v>4.8000000000000001E-2</c:v>
                </c:pt>
                <c:pt idx="205">
                  <c:v>4.7E-2</c:v>
                </c:pt>
                <c:pt idx="206">
                  <c:v>4.5999999999999999E-2</c:v>
                </c:pt>
                <c:pt idx="207">
                  <c:v>4.4999999999999998E-2</c:v>
                </c:pt>
                <c:pt idx="208">
                  <c:v>4.4999999999999998E-2</c:v>
                </c:pt>
                <c:pt idx="209">
                  <c:v>4.3999999999999997E-2</c:v>
                </c:pt>
                <c:pt idx="210">
                  <c:v>4.2999999999999997E-2</c:v>
                </c:pt>
                <c:pt idx="211">
                  <c:v>4.2000000000000003E-2</c:v>
                </c:pt>
                <c:pt idx="212">
                  <c:v>4.2000000000000003E-2</c:v>
                </c:pt>
                <c:pt idx="213">
                  <c:v>4.1000000000000002E-2</c:v>
                </c:pt>
                <c:pt idx="214">
                  <c:v>0.04</c:v>
                </c:pt>
                <c:pt idx="215">
                  <c:v>0.04</c:v>
                </c:pt>
                <c:pt idx="216">
                  <c:v>3.9E-2</c:v>
                </c:pt>
                <c:pt idx="217">
                  <c:v>3.9E-2</c:v>
                </c:pt>
                <c:pt idx="218">
                  <c:v>3.7999999999999999E-2</c:v>
                </c:pt>
                <c:pt idx="219">
                  <c:v>3.6999999999999998E-2</c:v>
                </c:pt>
                <c:pt idx="220">
                  <c:v>3.6999999999999998E-2</c:v>
                </c:pt>
                <c:pt idx="221">
                  <c:v>3.5999999999999997E-2</c:v>
                </c:pt>
                <c:pt idx="222">
                  <c:v>3.5999999999999997E-2</c:v>
                </c:pt>
                <c:pt idx="223">
                  <c:v>3.5000000000000003E-2</c:v>
                </c:pt>
                <c:pt idx="224">
                  <c:v>3.4000000000000002E-2</c:v>
                </c:pt>
                <c:pt idx="225">
                  <c:v>3.4000000000000002E-2</c:v>
                </c:pt>
                <c:pt idx="226">
                  <c:v>3.3000000000000002E-2</c:v>
                </c:pt>
                <c:pt idx="227">
                  <c:v>3.3000000000000002E-2</c:v>
                </c:pt>
                <c:pt idx="228">
                  <c:v>3.2000000000000001E-2</c:v>
                </c:pt>
                <c:pt idx="229">
                  <c:v>3.2000000000000001E-2</c:v>
                </c:pt>
                <c:pt idx="230">
                  <c:v>3.1E-2</c:v>
                </c:pt>
                <c:pt idx="231">
                  <c:v>3.1E-2</c:v>
                </c:pt>
                <c:pt idx="232">
                  <c:v>0.03</c:v>
                </c:pt>
                <c:pt idx="233">
                  <c:v>2.9000000000000001E-2</c:v>
                </c:pt>
                <c:pt idx="234">
                  <c:v>2.9000000000000001E-2</c:v>
                </c:pt>
                <c:pt idx="235">
                  <c:v>2.8000000000000001E-2</c:v>
                </c:pt>
                <c:pt idx="236">
                  <c:v>2.8000000000000001E-2</c:v>
                </c:pt>
                <c:pt idx="237">
                  <c:v>2.7E-2</c:v>
                </c:pt>
                <c:pt idx="238">
                  <c:v>2.7E-2</c:v>
                </c:pt>
                <c:pt idx="239">
                  <c:v>2.5999999999999999E-2</c:v>
                </c:pt>
                <c:pt idx="240">
                  <c:v>2.5999999999999999E-2</c:v>
                </c:pt>
                <c:pt idx="241">
                  <c:v>2.5999999999999999E-2</c:v>
                </c:pt>
                <c:pt idx="242">
                  <c:v>2.5000000000000001E-2</c:v>
                </c:pt>
                <c:pt idx="243">
                  <c:v>2.5000000000000001E-2</c:v>
                </c:pt>
                <c:pt idx="244">
                  <c:v>2.4E-2</c:v>
                </c:pt>
                <c:pt idx="245">
                  <c:v>2.4E-2</c:v>
                </c:pt>
                <c:pt idx="246">
                  <c:v>2.4E-2</c:v>
                </c:pt>
                <c:pt idx="247">
                  <c:v>2.4E-2</c:v>
                </c:pt>
                <c:pt idx="248">
                  <c:v>2.3E-2</c:v>
                </c:pt>
                <c:pt idx="249">
                  <c:v>2.3E-2</c:v>
                </c:pt>
                <c:pt idx="250">
                  <c:v>2.3E-2</c:v>
                </c:pt>
                <c:pt idx="251">
                  <c:v>2.1999999999999999E-2</c:v>
                </c:pt>
                <c:pt idx="252">
                  <c:v>2.1999999999999999E-2</c:v>
                </c:pt>
                <c:pt idx="253">
                  <c:v>2.1999999999999999E-2</c:v>
                </c:pt>
                <c:pt idx="254">
                  <c:v>2.1999999999999999E-2</c:v>
                </c:pt>
                <c:pt idx="255">
                  <c:v>2.1000000000000001E-2</c:v>
                </c:pt>
                <c:pt idx="256">
                  <c:v>2.1000000000000001E-2</c:v>
                </c:pt>
                <c:pt idx="257">
                  <c:v>2.1000000000000001E-2</c:v>
                </c:pt>
                <c:pt idx="258">
                  <c:v>2.1000000000000001E-2</c:v>
                </c:pt>
                <c:pt idx="259">
                  <c:v>0.02</c:v>
                </c:pt>
                <c:pt idx="260">
                  <c:v>0.02</c:v>
                </c:pt>
                <c:pt idx="261">
                  <c:v>0.02</c:v>
                </c:pt>
                <c:pt idx="262">
                  <c:v>0.02</c:v>
                </c:pt>
                <c:pt idx="263">
                  <c:v>0.02</c:v>
                </c:pt>
                <c:pt idx="264">
                  <c:v>1.9E-2</c:v>
                </c:pt>
                <c:pt idx="265">
                  <c:v>1.9E-2</c:v>
                </c:pt>
                <c:pt idx="266">
                  <c:v>1.9E-2</c:v>
                </c:pt>
                <c:pt idx="267">
                  <c:v>1.9E-2</c:v>
                </c:pt>
                <c:pt idx="268">
                  <c:v>1.9E-2</c:v>
                </c:pt>
                <c:pt idx="269">
                  <c:v>1.7999999999999999E-2</c:v>
                </c:pt>
                <c:pt idx="270">
                  <c:v>1.7999999999999999E-2</c:v>
                </c:pt>
                <c:pt idx="271">
                  <c:v>1.7999999999999999E-2</c:v>
                </c:pt>
                <c:pt idx="272">
                  <c:v>1.7999999999999999E-2</c:v>
                </c:pt>
                <c:pt idx="273">
                  <c:v>1.7999999999999999E-2</c:v>
                </c:pt>
                <c:pt idx="274">
                  <c:v>1.7000000000000001E-2</c:v>
                </c:pt>
                <c:pt idx="275">
                  <c:v>1.7000000000000001E-2</c:v>
                </c:pt>
                <c:pt idx="276">
                  <c:v>1.7000000000000001E-2</c:v>
                </c:pt>
                <c:pt idx="277">
                  <c:v>1.7000000000000001E-2</c:v>
                </c:pt>
                <c:pt idx="278">
                  <c:v>1.7000000000000001E-2</c:v>
                </c:pt>
                <c:pt idx="279">
                  <c:v>1.7000000000000001E-2</c:v>
                </c:pt>
                <c:pt idx="280">
                  <c:v>1.7000000000000001E-2</c:v>
                </c:pt>
                <c:pt idx="281">
                  <c:v>1.7999999999999999E-2</c:v>
                </c:pt>
                <c:pt idx="282">
                  <c:v>1.7999999999999999E-2</c:v>
                </c:pt>
                <c:pt idx="283">
                  <c:v>1.7999999999999999E-2</c:v>
                </c:pt>
                <c:pt idx="284">
                  <c:v>1.7999999999999999E-2</c:v>
                </c:pt>
                <c:pt idx="285">
                  <c:v>1.7999999999999999E-2</c:v>
                </c:pt>
                <c:pt idx="286">
                  <c:v>1.9E-2</c:v>
                </c:pt>
                <c:pt idx="287">
                  <c:v>1.9E-2</c:v>
                </c:pt>
                <c:pt idx="288">
                  <c:v>0.02</c:v>
                </c:pt>
                <c:pt idx="289">
                  <c:v>0.02</c:v>
                </c:pt>
                <c:pt idx="290">
                  <c:v>2.1000000000000001E-2</c:v>
                </c:pt>
                <c:pt idx="291">
                  <c:v>2.1999999999999999E-2</c:v>
                </c:pt>
                <c:pt idx="292">
                  <c:v>2.3E-2</c:v>
                </c:pt>
                <c:pt idx="293">
                  <c:v>2.4E-2</c:v>
                </c:pt>
                <c:pt idx="294">
                  <c:v>2.5999999999999999E-2</c:v>
                </c:pt>
                <c:pt idx="295">
                  <c:v>2.7E-2</c:v>
                </c:pt>
                <c:pt idx="296">
                  <c:v>2.9000000000000001E-2</c:v>
                </c:pt>
                <c:pt idx="297">
                  <c:v>3.1E-2</c:v>
                </c:pt>
                <c:pt idx="298">
                  <c:v>3.3000000000000002E-2</c:v>
                </c:pt>
                <c:pt idx="299">
                  <c:v>3.5999999999999997E-2</c:v>
                </c:pt>
                <c:pt idx="300">
                  <c:v>3.9E-2</c:v>
                </c:pt>
                <c:pt idx="301">
                  <c:v>4.2999999999999997E-2</c:v>
                </c:pt>
                <c:pt idx="302">
                  <c:v>4.5999999999999999E-2</c:v>
                </c:pt>
                <c:pt idx="303">
                  <c:v>5.0999999999999997E-2</c:v>
                </c:pt>
                <c:pt idx="304">
                  <c:v>5.5E-2</c:v>
                </c:pt>
                <c:pt idx="305">
                  <c:v>0.06</c:v>
                </c:pt>
                <c:pt idx="306">
                  <c:v>6.6000000000000003E-2</c:v>
                </c:pt>
                <c:pt idx="307">
                  <c:v>7.2999999999999995E-2</c:v>
                </c:pt>
                <c:pt idx="308">
                  <c:v>0.08</c:v>
                </c:pt>
                <c:pt idx="309">
                  <c:v>8.7999999999999995E-2</c:v>
                </c:pt>
                <c:pt idx="310">
                  <c:v>9.7000000000000003E-2</c:v>
                </c:pt>
                <c:pt idx="311">
                  <c:v>0.106</c:v>
                </c:pt>
                <c:pt idx="312">
                  <c:v>0.11600000000000001</c:v>
                </c:pt>
                <c:pt idx="313">
                  <c:v>0.127</c:v>
                </c:pt>
                <c:pt idx="314">
                  <c:v>0.13800000000000001</c:v>
                </c:pt>
                <c:pt idx="315">
                  <c:v>0.15</c:v>
                </c:pt>
                <c:pt idx="316">
                  <c:v>0.16200000000000001</c:v>
                </c:pt>
                <c:pt idx="317">
                  <c:v>0.17399999999999999</c:v>
                </c:pt>
                <c:pt idx="318">
                  <c:v>0.187</c:v>
                </c:pt>
                <c:pt idx="319">
                  <c:v>0.2</c:v>
                </c:pt>
                <c:pt idx="320">
                  <c:v>0.21199999999999999</c:v>
                </c:pt>
                <c:pt idx="321">
                  <c:v>0.224</c:v>
                </c:pt>
                <c:pt idx="322">
                  <c:v>0.23599999999999999</c:v>
                </c:pt>
                <c:pt idx="323">
                  <c:v>0.247</c:v>
                </c:pt>
                <c:pt idx="324">
                  <c:v>0.25700000000000001</c:v>
                </c:pt>
                <c:pt idx="325">
                  <c:v>0.26700000000000002</c:v>
                </c:pt>
                <c:pt idx="326">
                  <c:v>0.27600000000000002</c:v>
                </c:pt>
                <c:pt idx="327">
                  <c:v>0.28299999999999997</c:v>
                </c:pt>
                <c:pt idx="328">
                  <c:v>0.28899999999999998</c:v>
                </c:pt>
                <c:pt idx="329">
                  <c:v>0.29399999999999998</c:v>
                </c:pt>
                <c:pt idx="330">
                  <c:v>0.29699999999999999</c:v>
                </c:pt>
                <c:pt idx="331">
                  <c:v>0.29899999999999999</c:v>
                </c:pt>
                <c:pt idx="332">
                  <c:v>0.29899999999999999</c:v>
                </c:pt>
                <c:pt idx="333">
                  <c:v>0.29799999999999999</c:v>
                </c:pt>
                <c:pt idx="334">
                  <c:v>0.29499999999999998</c:v>
                </c:pt>
                <c:pt idx="335">
                  <c:v>0.29199999999999998</c:v>
                </c:pt>
                <c:pt idx="336">
                  <c:v>0.28799999999999998</c:v>
                </c:pt>
                <c:pt idx="337">
                  <c:v>0.28399999999999997</c:v>
                </c:pt>
                <c:pt idx="338">
                  <c:v>0.27900000000000003</c:v>
                </c:pt>
                <c:pt idx="339">
                  <c:v>0.27500000000000002</c:v>
                </c:pt>
                <c:pt idx="340">
                  <c:v>0.27200000000000002</c:v>
                </c:pt>
                <c:pt idx="341">
                  <c:v>0.27</c:v>
                </c:pt>
                <c:pt idx="342">
                  <c:v>0.26900000000000002</c:v>
                </c:pt>
                <c:pt idx="343">
                  <c:v>0.27</c:v>
                </c:pt>
                <c:pt idx="344">
                  <c:v>0.27200000000000002</c:v>
                </c:pt>
                <c:pt idx="345">
                  <c:v>0.27500000000000002</c:v>
                </c:pt>
                <c:pt idx="346">
                  <c:v>0.28000000000000003</c:v>
                </c:pt>
                <c:pt idx="347">
                  <c:v>0.28699999999999998</c:v>
                </c:pt>
                <c:pt idx="348">
                  <c:v>0.29499999999999998</c:v>
                </c:pt>
                <c:pt idx="349">
                  <c:v>0.30399999999999999</c:v>
                </c:pt>
                <c:pt idx="350">
                  <c:v>0.315</c:v>
                </c:pt>
                <c:pt idx="351">
                  <c:v>0.32600000000000001</c:v>
                </c:pt>
                <c:pt idx="352">
                  <c:v>0.33900000000000002</c:v>
                </c:pt>
                <c:pt idx="353">
                  <c:v>0.35099999999999998</c:v>
                </c:pt>
                <c:pt idx="354">
                  <c:v>0.36499999999999999</c:v>
                </c:pt>
                <c:pt idx="355">
                  <c:v>0.377</c:v>
                </c:pt>
                <c:pt idx="356">
                  <c:v>0.38800000000000001</c:v>
                </c:pt>
                <c:pt idx="357">
                  <c:v>0.39900000000000002</c:v>
                </c:pt>
                <c:pt idx="358">
                  <c:v>0.40799999999999997</c:v>
                </c:pt>
                <c:pt idx="359">
                  <c:v>0.41599999999999998</c:v>
                </c:pt>
                <c:pt idx="360">
                  <c:v>0.42199999999999999</c:v>
                </c:pt>
                <c:pt idx="361">
                  <c:v>0.42699999999999999</c:v>
                </c:pt>
                <c:pt idx="362">
                  <c:v>0.42899999999999999</c:v>
                </c:pt>
                <c:pt idx="363">
                  <c:v>0.43</c:v>
                </c:pt>
                <c:pt idx="364">
                  <c:v>0.43</c:v>
                </c:pt>
                <c:pt idx="365">
                  <c:v>0.42799999999999999</c:v>
                </c:pt>
                <c:pt idx="366">
                  <c:v>0.42399999999999999</c:v>
                </c:pt>
                <c:pt idx="367">
                  <c:v>0.41899999999999998</c:v>
                </c:pt>
                <c:pt idx="368">
                  <c:v>0.41299999999999998</c:v>
                </c:pt>
                <c:pt idx="369">
                  <c:v>0.40600000000000003</c:v>
                </c:pt>
                <c:pt idx="370">
                  <c:v>0.39900000000000002</c:v>
                </c:pt>
                <c:pt idx="371">
                  <c:v>0.39200000000000002</c:v>
                </c:pt>
                <c:pt idx="372">
                  <c:v>0.38600000000000001</c:v>
                </c:pt>
                <c:pt idx="373">
                  <c:v>0.38</c:v>
                </c:pt>
                <c:pt idx="374">
                  <c:v>0.374</c:v>
                </c:pt>
                <c:pt idx="375">
                  <c:v>0.37</c:v>
                </c:pt>
                <c:pt idx="376">
                  <c:v>0.36599999999999999</c:v>
                </c:pt>
                <c:pt idx="377">
                  <c:v>0.36299999999999999</c:v>
                </c:pt>
                <c:pt idx="378">
                  <c:v>0.36099999999999999</c:v>
                </c:pt>
                <c:pt idx="379">
                  <c:v>0.35899999999999999</c:v>
                </c:pt>
                <c:pt idx="380">
                  <c:v>0.35699999999999998</c:v>
                </c:pt>
                <c:pt idx="381">
                  <c:v>0.35599999999999998</c:v>
                </c:pt>
                <c:pt idx="382">
                  <c:v>0.35399999999999998</c:v>
                </c:pt>
                <c:pt idx="383">
                  <c:v>0.35199999999999998</c:v>
                </c:pt>
                <c:pt idx="384">
                  <c:v>0.35</c:v>
                </c:pt>
                <c:pt idx="385">
                  <c:v>0.34699999999999998</c:v>
                </c:pt>
                <c:pt idx="386">
                  <c:v>0.34300000000000003</c:v>
                </c:pt>
                <c:pt idx="387">
                  <c:v>0.33900000000000002</c:v>
                </c:pt>
                <c:pt idx="388">
                  <c:v>0.33400000000000002</c:v>
                </c:pt>
                <c:pt idx="389">
                  <c:v>0.32900000000000001</c:v>
                </c:pt>
                <c:pt idx="390">
                  <c:v>0.32300000000000001</c:v>
                </c:pt>
                <c:pt idx="391">
                  <c:v>0.316</c:v>
                </c:pt>
                <c:pt idx="392">
                  <c:v>0.309</c:v>
                </c:pt>
                <c:pt idx="393">
                  <c:v>0.30199999999999999</c:v>
                </c:pt>
                <c:pt idx="394">
                  <c:v>0.29499999999999998</c:v>
                </c:pt>
                <c:pt idx="395">
                  <c:v>0.28899999999999998</c:v>
                </c:pt>
                <c:pt idx="396">
                  <c:v>0.28299999999999997</c:v>
                </c:pt>
                <c:pt idx="397">
                  <c:v>0.27700000000000002</c:v>
                </c:pt>
                <c:pt idx="398">
                  <c:v>0.27200000000000002</c:v>
                </c:pt>
                <c:pt idx="399">
                  <c:v>0.26700000000000002</c:v>
                </c:pt>
                <c:pt idx="400">
                  <c:v>0.26400000000000001</c:v>
                </c:pt>
                <c:pt idx="401">
                  <c:v>0.26100000000000001</c:v>
                </c:pt>
                <c:pt idx="402">
                  <c:v>0.25900000000000001</c:v>
                </c:pt>
                <c:pt idx="403">
                  <c:v>0.25700000000000001</c:v>
                </c:pt>
                <c:pt idx="404">
                  <c:v>0.25600000000000001</c:v>
                </c:pt>
                <c:pt idx="405">
                  <c:v>0.255</c:v>
                </c:pt>
                <c:pt idx="406">
                  <c:v>0.254</c:v>
                </c:pt>
                <c:pt idx="407">
                  <c:v>0.253</c:v>
                </c:pt>
                <c:pt idx="408">
                  <c:v>0.253</c:v>
                </c:pt>
                <c:pt idx="409">
                  <c:v>0.253</c:v>
                </c:pt>
                <c:pt idx="410">
                  <c:v>0.252</c:v>
                </c:pt>
                <c:pt idx="411">
                  <c:v>0.252</c:v>
                </c:pt>
                <c:pt idx="412">
                  <c:v>0.251</c:v>
                </c:pt>
                <c:pt idx="413">
                  <c:v>0.251</c:v>
                </c:pt>
                <c:pt idx="414">
                  <c:v>0.251</c:v>
                </c:pt>
                <c:pt idx="415">
                  <c:v>0.251</c:v>
                </c:pt>
                <c:pt idx="416">
                  <c:v>0.25</c:v>
                </c:pt>
                <c:pt idx="417">
                  <c:v>0.25</c:v>
                </c:pt>
                <c:pt idx="418">
                  <c:v>0.25</c:v>
                </c:pt>
                <c:pt idx="419">
                  <c:v>0.251</c:v>
                </c:pt>
                <c:pt idx="420">
                  <c:v>0.251</c:v>
                </c:pt>
                <c:pt idx="421">
                  <c:v>0.249</c:v>
                </c:pt>
                <c:pt idx="422">
                  <c:v>0.251</c:v>
                </c:pt>
                <c:pt idx="423">
                  <c:v>0.252</c:v>
                </c:pt>
                <c:pt idx="424">
                  <c:v>0.254</c:v>
                </c:pt>
                <c:pt idx="425">
                  <c:v>0.25600000000000001</c:v>
                </c:pt>
                <c:pt idx="426">
                  <c:v>0.25900000000000001</c:v>
                </c:pt>
                <c:pt idx="427">
                  <c:v>0.26200000000000001</c:v>
                </c:pt>
                <c:pt idx="428">
                  <c:v>0.26500000000000001</c:v>
                </c:pt>
                <c:pt idx="429">
                  <c:v>0.26900000000000002</c:v>
                </c:pt>
                <c:pt idx="430">
                  <c:v>0.27400000000000002</c:v>
                </c:pt>
                <c:pt idx="431">
                  <c:v>0.27900000000000003</c:v>
                </c:pt>
                <c:pt idx="432">
                  <c:v>0.28599999999999998</c:v>
                </c:pt>
                <c:pt idx="433">
                  <c:v>0.29199999999999998</c:v>
                </c:pt>
                <c:pt idx="434">
                  <c:v>0.3</c:v>
                </c:pt>
                <c:pt idx="435">
                  <c:v>0.308</c:v>
                </c:pt>
                <c:pt idx="436">
                  <c:v>0.317</c:v>
                </c:pt>
                <c:pt idx="437">
                  <c:v>0.32800000000000001</c:v>
                </c:pt>
                <c:pt idx="438">
                  <c:v>0.33900000000000002</c:v>
                </c:pt>
                <c:pt idx="439">
                  <c:v>0.35199999999999998</c:v>
                </c:pt>
                <c:pt idx="440">
                  <c:v>0.36399999999999999</c:v>
                </c:pt>
                <c:pt idx="441">
                  <c:v>0.378</c:v>
                </c:pt>
                <c:pt idx="442">
                  <c:v>0.39300000000000002</c:v>
                </c:pt>
                <c:pt idx="443">
                  <c:v>0.40899999999999997</c:v>
                </c:pt>
                <c:pt idx="444">
                  <c:v>0.42399999999999999</c:v>
                </c:pt>
                <c:pt idx="445">
                  <c:v>0.442</c:v>
                </c:pt>
                <c:pt idx="446">
                  <c:v>0.46</c:v>
                </c:pt>
                <c:pt idx="447">
                  <c:v>0.47799999999999998</c:v>
                </c:pt>
                <c:pt idx="448">
                  <c:v>0.498</c:v>
                </c:pt>
                <c:pt idx="449">
                  <c:v>0.51800000000000002</c:v>
                </c:pt>
                <c:pt idx="450">
                  <c:v>0.53900000000000003</c:v>
                </c:pt>
                <c:pt idx="451">
                  <c:v>0.56100000000000005</c:v>
                </c:pt>
                <c:pt idx="452">
                  <c:v>0.58199999999999996</c:v>
                </c:pt>
                <c:pt idx="453">
                  <c:v>0.60399999999999998</c:v>
                </c:pt>
                <c:pt idx="454">
                  <c:v>0.625</c:v>
                </c:pt>
                <c:pt idx="455">
                  <c:v>0.64600000000000002</c:v>
                </c:pt>
                <c:pt idx="456">
                  <c:v>0.66800000000000004</c:v>
                </c:pt>
                <c:pt idx="457">
                  <c:v>0.68799999999999994</c:v>
                </c:pt>
                <c:pt idx="458">
                  <c:v>0.70599999999999996</c:v>
                </c:pt>
                <c:pt idx="459">
                  <c:v>0.72599999999999998</c:v>
                </c:pt>
                <c:pt idx="460">
                  <c:v>0.74199999999999999</c:v>
                </c:pt>
                <c:pt idx="461">
                  <c:v>0.77</c:v>
                </c:pt>
                <c:pt idx="462">
                  <c:v>0.78300000000000003</c:v>
                </c:pt>
                <c:pt idx="463">
                  <c:v>0.79600000000000004</c:v>
                </c:pt>
                <c:pt idx="464">
                  <c:v>0.80700000000000005</c:v>
                </c:pt>
                <c:pt idx="465">
                  <c:v>0.81599999999999995</c:v>
                </c:pt>
                <c:pt idx="466">
                  <c:v>0.82499999999999996</c:v>
                </c:pt>
                <c:pt idx="467">
                  <c:v>0.83199999999999996</c:v>
                </c:pt>
                <c:pt idx="468">
                  <c:v>0.83799999999999997</c:v>
                </c:pt>
                <c:pt idx="469">
                  <c:v>0.84299999999999997</c:v>
                </c:pt>
                <c:pt idx="470">
                  <c:v>0.84599999999999997</c:v>
                </c:pt>
                <c:pt idx="471">
                  <c:v>0.84699999999999998</c:v>
                </c:pt>
                <c:pt idx="472">
                  <c:v>0.84799999999999998</c:v>
                </c:pt>
                <c:pt idx="473">
                  <c:v>0.84599999999999997</c:v>
                </c:pt>
                <c:pt idx="474">
                  <c:v>0.84399999999999997</c:v>
                </c:pt>
                <c:pt idx="475">
                  <c:v>0.84</c:v>
                </c:pt>
                <c:pt idx="476">
                  <c:v>0.83499999999999996</c:v>
                </c:pt>
                <c:pt idx="477">
                  <c:v>0.82799999999999996</c:v>
                </c:pt>
                <c:pt idx="478">
                  <c:v>0.82099999999999995</c:v>
                </c:pt>
                <c:pt idx="479">
                  <c:v>0.81299999999999994</c:v>
                </c:pt>
                <c:pt idx="480">
                  <c:v>0.80500000000000005</c:v>
                </c:pt>
                <c:pt idx="481">
                  <c:v>0.79600000000000004</c:v>
                </c:pt>
                <c:pt idx="482">
                  <c:v>0.78600000000000003</c:v>
                </c:pt>
                <c:pt idx="483">
                  <c:v>0.77600000000000002</c:v>
                </c:pt>
                <c:pt idx="484">
                  <c:v>0.76600000000000001</c:v>
                </c:pt>
                <c:pt idx="485">
                  <c:v>0.75700000000000001</c:v>
                </c:pt>
                <c:pt idx="486">
                  <c:v>0.747</c:v>
                </c:pt>
                <c:pt idx="487">
                  <c:v>0.73599999999999999</c:v>
                </c:pt>
                <c:pt idx="488">
                  <c:v>0.72599999999999998</c:v>
                </c:pt>
                <c:pt idx="489">
                  <c:v>0.71599999999999997</c:v>
                </c:pt>
                <c:pt idx="490">
                  <c:v>0.70599999999999996</c:v>
                </c:pt>
                <c:pt idx="491">
                  <c:v>0.69599999999999995</c:v>
                </c:pt>
                <c:pt idx="492">
                  <c:v>0.68700000000000006</c:v>
                </c:pt>
                <c:pt idx="493">
                  <c:v>0.67800000000000005</c:v>
                </c:pt>
                <c:pt idx="494">
                  <c:v>0.66900000000000004</c:v>
                </c:pt>
                <c:pt idx="495">
                  <c:v>0.66</c:v>
                </c:pt>
                <c:pt idx="496">
                  <c:v>0.65200000000000002</c:v>
                </c:pt>
                <c:pt idx="497">
                  <c:v>0.64500000000000002</c:v>
                </c:pt>
                <c:pt idx="498">
                  <c:v>0.63800000000000001</c:v>
                </c:pt>
                <c:pt idx="499">
                  <c:v>0.63100000000000001</c:v>
                </c:pt>
                <c:pt idx="500">
                  <c:v>0.624</c:v>
                </c:pt>
                <c:pt idx="501">
                  <c:v>0.61699999999999999</c:v>
                </c:pt>
                <c:pt idx="502">
                  <c:v>0.61</c:v>
                </c:pt>
                <c:pt idx="503">
                  <c:v>0.60299999999999998</c:v>
                </c:pt>
                <c:pt idx="504">
                  <c:v>0.59499999999999997</c:v>
                </c:pt>
                <c:pt idx="505">
                  <c:v>0.58699999999999997</c:v>
                </c:pt>
                <c:pt idx="506">
                  <c:v>0.57999999999999996</c:v>
                </c:pt>
                <c:pt idx="507">
                  <c:v>0.57199999999999995</c:v>
                </c:pt>
                <c:pt idx="508">
                  <c:v>0.56499999999999995</c:v>
                </c:pt>
                <c:pt idx="509">
                  <c:v>0.55900000000000005</c:v>
                </c:pt>
                <c:pt idx="510">
                  <c:v>0.55300000000000005</c:v>
                </c:pt>
                <c:pt idx="511">
                  <c:v>0.54600000000000004</c:v>
                </c:pt>
                <c:pt idx="512">
                  <c:v>0.54</c:v>
                </c:pt>
                <c:pt idx="513">
                  <c:v>0.53400000000000003</c:v>
                </c:pt>
                <c:pt idx="514">
                  <c:v>0.52900000000000003</c:v>
                </c:pt>
                <c:pt idx="515">
                  <c:v>0.52600000000000002</c:v>
                </c:pt>
                <c:pt idx="516">
                  <c:v>0.52500000000000002</c:v>
                </c:pt>
                <c:pt idx="517">
                  <c:v>0.52700000000000002</c:v>
                </c:pt>
                <c:pt idx="518">
                  <c:v>0.53</c:v>
                </c:pt>
                <c:pt idx="519">
                  <c:v>0.53600000000000003</c:v>
                </c:pt>
                <c:pt idx="520">
                  <c:v>0.54300000000000004</c:v>
                </c:pt>
                <c:pt idx="521">
                  <c:v>0.55100000000000005</c:v>
                </c:pt>
                <c:pt idx="522">
                  <c:v>0.55900000000000005</c:v>
                </c:pt>
                <c:pt idx="523">
                  <c:v>0.56499999999999995</c:v>
                </c:pt>
                <c:pt idx="524">
                  <c:v>0.56899999999999995</c:v>
                </c:pt>
                <c:pt idx="525">
                  <c:v>0.56999999999999995</c:v>
                </c:pt>
                <c:pt idx="526">
                  <c:v>0.56999999999999995</c:v>
                </c:pt>
                <c:pt idx="527">
                  <c:v>0.57299999999999995</c:v>
                </c:pt>
                <c:pt idx="528">
                  <c:v>0.57699999999999996</c:v>
                </c:pt>
                <c:pt idx="529">
                  <c:v>0.58099999999999996</c:v>
                </c:pt>
                <c:pt idx="530">
                  <c:v>0.58199999999999996</c:v>
                </c:pt>
                <c:pt idx="531">
                  <c:v>0.57999999999999996</c:v>
                </c:pt>
                <c:pt idx="532">
                  <c:v>0.57599999999999996</c:v>
                </c:pt>
                <c:pt idx="533">
                  <c:v>0.57199999999999995</c:v>
                </c:pt>
                <c:pt idx="534">
                  <c:v>0.56799999999999995</c:v>
                </c:pt>
                <c:pt idx="535">
                  <c:v>0.56399999999999995</c:v>
                </c:pt>
                <c:pt idx="536">
                  <c:v>0.56000000000000005</c:v>
                </c:pt>
                <c:pt idx="537">
                  <c:v>0.55500000000000005</c:v>
                </c:pt>
                <c:pt idx="538">
                  <c:v>0.55100000000000005</c:v>
                </c:pt>
                <c:pt idx="539">
                  <c:v>0.54800000000000004</c:v>
                </c:pt>
                <c:pt idx="540">
                  <c:v>0.54600000000000004</c:v>
                </c:pt>
                <c:pt idx="541">
                  <c:v>0.54500000000000004</c:v>
                </c:pt>
                <c:pt idx="542">
                  <c:v>0.54400000000000004</c:v>
                </c:pt>
                <c:pt idx="543">
                  <c:v>0.54600000000000004</c:v>
                </c:pt>
                <c:pt idx="544">
                  <c:v>0.54800000000000004</c:v>
                </c:pt>
                <c:pt idx="545">
                  <c:v>0.55000000000000004</c:v>
                </c:pt>
                <c:pt idx="546">
                  <c:v>0.55300000000000005</c:v>
                </c:pt>
                <c:pt idx="547">
                  <c:v>0.55600000000000005</c:v>
                </c:pt>
                <c:pt idx="548">
                  <c:v>0.55900000000000005</c:v>
                </c:pt>
                <c:pt idx="549">
                  <c:v>0.56100000000000005</c:v>
                </c:pt>
                <c:pt idx="550">
                  <c:v>0.56299999999999994</c:v>
                </c:pt>
                <c:pt idx="551">
                  <c:v>0.56399999999999995</c:v>
                </c:pt>
                <c:pt idx="552">
                  <c:v>0.56499999999999995</c:v>
                </c:pt>
                <c:pt idx="553">
                  <c:v>0.56599999999999995</c:v>
                </c:pt>
                <c:pt idx="554">
                  <c:v>0.56799999999999995</c:v>
                </c:pt>
                <c:pt idx="555">
                  <c:v>0.56899999999999995</c:v>
                </c:pt>
                <c:pt idx="556">
                  <c:v>0.57199999999999995</c:v>
                </c:pt>
                <c:pt idx="557">
                  <c:v>0.57399999999999995</c:v>
                </c:pt>
                <c:pt idx="558">
                  <c:v>0.57899999999999996</c:v>
                </c:pt>
                <c:pt idx="559">
                  <c:v>0.58599999999999997</c:v>
                </c:pt>
                <c:pt idx="560">
                  <c:v>0.59499999999999997</c:v>
                </c:pt>
                <c:pt idx="561">
                  <c:v>0.60699999999999998</c:v>
                </c:pt>
                <c:pt idx="562">
                  <c:v>0.624</c:v>
                </c:pt>
                <c:pt idx="563">
                  <c:v>0.64800000000000002</c:v>
                </c:pt>
                <c:pt idx="564">
                  <c:v>0.67900000000000005</c:v>
                </c:pt>
                <c:pt idx="565">
                  <c:v>0.72</c:v>
                </c:pt>
                <c:pt idx="566">
                  <c:v>0.77100000000000002</c:v>
                </c:pt>
                <c:pt idx="567">
                  <c:v>0.83399999999999996</c:v>
                </c:pt>
                <c:pt idx="568">
                  <c:v>0.90500000000000003</c:v>
                </c:pt>
                <c:pt idx="569">
                  <c:v>0.98399999999999999</c:v>
                </c:pt>
                <c:pt idx="570">
                  <c:v>1.0660000000000001</c:v>
                </c:pt>
                <c:pt idx="571">
                  <c:v>1.147</c:v>
                </c:pt>
                <c:pt idx="572">
                  <c:v>1.224</c:v>
                </c:pt>
                <c:pt idx="573">
                  <c:v>1.294</c:v>
                </c:pt>
                <c:pt idx="574">
                  <c:v>1.3540000000000001</c:v>
                </c:pt>
                <c:pt idx="575">
                  <c:v>1.407</c:v>
                </c:pt>
                <c:pt idx="576">
                  <c:v>1.452</c:v>
                </c:pt>
                <c:pt idx="577">
                  <c:v>1.4870000000000001</c:v>
                </c:pt>
                <c:pt idx="578">
                  <c:v>1.514</c:v>
                </c:pt>
                <c:pt idx="579">
                  <c:v>1.5349999999999999</c:v>
                </c:pt>
                <c:pt idx="580">
                  <c:v>1.5509999999999999</c:v>
                </c:pt>
                <c:pt idx="581">
                  <c:v>1.5669999999999999</c:v>
                </c:pt>
                <c:pt idx="582">
                  <c:v>1.583</c:v>
                </c:pt>
                <c:pt idx="583">
                  <c:v>1.601</c:v>
                </c:pt>
                <c:pt idx="584">
                  <c:v>1.6160000000000001</c:v>
                </c:pt>
                <c:pt idx="585">
                  <c:v>1.631</c:v>
                </c:pt>
                <c:pt idx="586">
                  <c:v>1.6459999999999999</c:v>
                </c:pt>
                <c:pt idx="587">
                  <c:v>1.6619999999999999</c:v>
                </c:pt>
                <c:pt idx="588">
                  <c:v>1.68</c:v>
                </c:pt>
                <c:pt idx="589">
                  <c:v>1.6950000000000001</c:v>
                </c:pt>
                <c:pt idx="590">
                  <c:v>1.7070000000000001</c:v>
                </c:pt>
                <c:pt idx="591">
                  <c:v>1.7070000000000001</c:v>
                </c:pt>
                <c:pt idx="592">
                  <c:v>1.6970000000000001</c:v>
                </c:pt>
                <c:pt idx="593">
                  <c:v>1.6759999999999999</c:v>
                </c:pt>
                <c:pt idx="594">
                  <c:v>1.625</c:v>
                </c:pt>
                <c:pt idx="595">
                  <c:v>1.556</c:v>
                </c:pt>
                <c:pt idx="596">
                  <c:v>1.4450000000000001</c:v>
                </c:pt>
                <c:pt idx="597">
                  <c:v>1.2909999999999999</c:v>
                </c:pt>
                <c:pt idx="598">
                  <c:v>1.077</c:v>
                </c:pt>
                <c:pt idx="599">
                  <c:v>0.81100000000000005</c:v>
                </c:pt>
                <c:pt idx="600">
                  <c:v>0.461000000000000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F1C9-4266-924C-4F616B8627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50944"/>
        <c:axId val="646754864"/>
      </c:scatterChart>
      <c:valAx>
        <c:axId val="646750944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Wavelength</a:t>
                </a:r>
                <a:r>
                  <a:rPr lang="en-US" baseline="0"/>
                  <a:t> (nm)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0.35672900262467194"/>
              <c:y val="0.894409448818897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46754864"/>
        <c:crosses val="autoZero"/>
        <c:crossBetween val="midCat"/>
      </c:valAx>
      <c:valAx>
        <c:axId val="646754864"/>
        <c:scaling>
          <c:orientation val="minMax"/>
          <c:max val="1.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bsorbance</a:t>
                </a:r>
              </a:p>
            </c:rich>
          </c:tx>
          <c:layout>
            <c:manualLayout>
              <c:xMode val="edge"/>
              <c:yMode val="edge"/>
              <c:x val="1.317694663167104E-2"/>
              <c:y val="0.1796456692913385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646750944"/>
        <c:crosses val="autoZero"/>
        <c:crossBetween val="midCat"/>
        <c:majorUnit val="0.5"/>
      </c:valAx>
    </c:plotArea>
    <c:legend>
      <c:legendPos val="t"/>
      <c:layout>
        <c:manualLayout>
          <c:xMode val="edge"/>
          <c:yMode val="edge"/>
          <c:x val="0.59513888888888888"/>
          <c:y val="0.2361111111111111"/>
          <c:w val="0.4"/>
          <c:h val="0.34779800962379703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656747356601929"/>
          <c:y val="2.838127631151071E-2"/>
          <c:w val="0.81353044516765749"/>
          <c:h val="0.73323680286398141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10:$K$13</c:f>
                <c:numCache>
                  <c:formatCode>General</c:formatCode>
                  <c:ptCount val="4"/>
                  <c:pt idx="0">
                    <c:v>2.8075790282732906E-2</c:v>
                  </c:pt>
                  <c:pt idx="1">
                    <c:v>2.4129857024027309E-2</c:v>
                  </c:pt>
                  <c:pt idx="2">
                    <c:v>2.1954498400100147E-2</c:v>
                  </c:pt>
                  <c:pt idx="3">
                    <c:v>1.624807680927192E-2</c:v>
                  </c:pt>
                </c:numCache>
              </c:numRef>
            </c:plus>
            <c:minus>
              <c:numRef>
                <c:f>Sheet1!$K$10:$K$13</c:f>
                <c:numCache>
                  <c:formatCode>General</c:formatCode>
                  <c:ptCount val="4"/>
                  <c:pt idx="0">
                    <c:v>2.8075790282732906E-2</c:v>
                  </c:pt>
                  <c:pt idx="1">
                    <c:v>2.4129857024027309E-2</c:v>
                  </c:pt>
                  <c:pt idx="2">
                    <c:v>2.1954498400100147E-2</c:v>
                  </c:pt>
                  <c:pt idx="3">
                    <c:v>1.624807680927192E-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xVal>
            <c:numRef>
              <c:f>Sheet1!$I$10:$I$13</c:f>
              <c:numCache>
                <c:formatCode>General</c:formatCode>
                <c:ptCount val="4"/>
                <c:pt idx="0">
                  <c:v>5.8</c:v>
                </c:pt>
                <c:pt idx="1">
                  <c:v>6.4</c:v>
                </c:pt>
                <c:pt idx="2">
                  <c:v>7</c:v>
                </c:pt>
                <c:pt idx="3">
                  <c:v>8</c:v>
                </c:pt>
              </c:numCache>
            </c:numRef>
          </c:xVal>
          <c:yVal>
            <c:numRef>
              <c:f>Sheet1!$J$10:$J$13</c:f>
              <c:numCache>
                <c:formatCode>0.000</c:formatCode>
                <c:ptCount val="4"/>
                <c:pt idx="0">
                  <c:v>0.21425</c:v>
                </c:pt>
                <c:pt idx="1">
                  <c:v>0.22175</c:v>
                </c:pt>
                <c:pt idx="2">
                  <c:v>0.21299999999999997</c:v>
                </c:pt>
                <c:pt idx="3">
                  <c:v>0.2050000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4F9-47DD-8D6B-8DF25C51D0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46730952"/>
        <c:axId val="646751336"/>
      </c:scatterChart>
      <c:valAx>
        <c:axId val="646730952"/>
        <c:scaling>
          <c:orientation val="minMax"/>
          <c:max val="8.4"/>
          <c:min val="5.2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H 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646751336"/>
        <c:crosses val="autoZero"/>
        <c:crossBetween val="midCat"/>
        <c:majorUnit val="0.60000000000000009"/>
      </c:valAx>
      <c:valAx>
        <c:axId val="646751336"/>
        <c:scaling>
          <c:orientation val="minMax"/>
          <c:max val="0.5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bsorbance</a:t>
                </a:r>
              </a:p>
            </c:rich>
          </c:tx>
          <c:layout/>
          <c:overlay val="0"/>
        </c:title>
        <c:numFmt formatCode="0.0" sourceLinked="0"/>
        <c:majorTickMark val="none"/>
        <c:minorTickMark val="none"/>
        <c:tickLblPos val="nextTo"/>
        <c:crossAx val="646730952"/>
        <c:crosses val="autoZero"/>
        <c:crossBetween val="midCat"/>
        <c:minorUnit val="0.1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8333</cdr:x>
      <cdr:y>0.22222</cdr:y>
    </cdr:from>
    <cdr:to>
      <cdr:x>0.68333</cdr:x>
      <cdr:y>0.5555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209800" y="6096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0D256B-B00B-4F58-9A70-0AD019837C3B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CC198B-0575-4FB6-881B-EE1A615A48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261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18268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9086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85351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0919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0495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8075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1104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2048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606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5440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56970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87997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CC198B-0575-4FB6-881B-EE1A615A4833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19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14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548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494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691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80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24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621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467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15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014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323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6D96C-0E85-4889-A3D3-C09E04001B2D}" type="datetimeFigureOut">
              <a:rPr lang="en-US" smtClean="0"/>
              <a:t>1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8C5CB-566B-4826-87F8-C26B36FE47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064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b-patil@tamu.edu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8600" y="228600"/>
            <a:ext cx="8610600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2000" b="1" dirty="0"/>
          </a:p>
          <a:p>
            <a:endParaRPr lang="en-US" sz="2000" b="1" dirty="0"/>
          </a:p>
          <a:p>
            <a:endParaRPr lang="en-US" sz="2000" b="1" dirty="0"/>
          </a:p>
          <a:p>
            <a:r>
              <a:rPr lang="en-GB" sz="2400" b="1" dirty="0"/>
              <a:t>Leaf Disc Assays for Rapid Measurement of Antioxidant Activity </a:t>
            </a:r>
            <a:endParaRPr lang="en-US" sz="2400" dirty="0"/>
          </a:p>
          <a:p>
            <a:pPr algn="ctr"/>
            <a:endParaRPr lang="en-US" sz="2400" dirty="0"/>
          </a:p>
          <a:p>
            <a:pPr algn="ctr"/>
            <a:r>
              <a:rPr lang="en-US" b="1" dirty="0"/>
              <a:t>Deepak M. Kasote</a:t>
            </a:r>
            <a:r>
              <a:rPr lang="en-US" b="1" baseline="30000" dirty="0"/>
              <a:t>1</a:t>
            </a:r>
            <a:r>
              <a:rPr lang="en-US" b="1" dirty="0"/>
              <a:t>, </a:t>
            </a:r>
            <a:r>
              <a:rPr lang="en-US" b="1" dirty="0" err="1"/>
              <a:t>Gudaddarangavvanahally</a:t>
            </a:r>
            <a:r>
              <a:rPr lang="en-US" b="1" dirty="0"/>
              <a:t> K. Jayaprakasha</a:t>
            </a:r>
            <a:r>
              <a:rPr lang="en-US" b="1" baseline="30000" dirty="0"/>
              <a:t>1</a:t>
            </a:r>
            <a:r>
              <a:rPr lang="en-US" dirty="0"/>
              <a:t>, </a:t>
            </a:r>
            <a:r>
              <a:rPr lang="en-US" b="1" dirty="0"/>
              <a:t>and </a:t>
            </a:r>
          </a:p>
          <a:p>
            <a:pPr algn="ctr"/>
            <a:r>
              <a:rPr lang="en-US" b="1" dirty="0"/>
              <a:t>Bhimanagouda S. Patil</a:t>
            </a:r>
            <a:r>
              <a:rPr lang="en-US" b="1" baseline="30000" dirty="0"/>
              <a:t>1,*</a:t>
            </a:r>
          </a:p>
          <a:p>
            <a:endParaRPr lang="en-US" dirty="0"/>
          </a:p>
          <a:p>
            <a:endParaRPr lang="en-US" dirty="0"/>
          </a:p>
          <a:p>
            <a:r>
              <a:rPr lang="en-US" baseline="30000" dirty="0"/>
              <a:t>1</a:t>
            </a:r>
            <a:r>
              <a:rPr lang="en-US" dirty="0"/>
              <a:t>Vegetable and Fruit Improvement Center, Department of Horticultural Sciences, Texas A&amp;M University, 1500 Research Parkway, A120, College Station, TX 77845, USA</a:t>
            </a:r>
          </a:p>
          <a:p>
            <a:r>
              <a:rPr lang="en-US" dirty="0"/>
              <a:t> </a:t>
            </a:r>
          </a:p>
          <a:p>
            <a:r>
              <a:rPr lang="en-US" dirty="0"/>
              <a:t>*Correspondence and requests for materials should be addressed to </a:t>
            </a:r>
          </a:p>
          <a:p>
            <a:r>
              <a:rPr lang="en-US" dirty="0"/>
              <a:t>B.S.P. (email: </a:t>
            </a:r>
            <a:r>
              <a:rPr lang="en-US" u="sng" dirty="0">
                <a:hlinkClick r:id="rId3"/>
              </a:rPr>
              <a:t>b-patil@tamu.edu</a:t>
            </a:r>
            <a:r>
              <a:rPr lang="en-US" u="sng" dirty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9268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64069" y="4640483"/>
            <a:ext cx="6477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pH on stability of 0.2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nO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₄ solution.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4483541"/>
              </p:ext>
            </p:extLst>
          </p:nvPr>
        </p:nvGraphicFramePr>
        <p:xfrm>
          <a:off x="2291129" y="2063628"/>
          <a:ext cx="4561742" cy="2730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9754059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5800" y="5600191"/>
            <a:ext cx="8305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isc(s) dependent reduction of KMnO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0.5 mM) solution by spinach, kale, collards, mustard and watermelon leaf disc(s) after 30 min of incubation.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1620" y="685800"/>
            <a:ext cx="6340475" cy="4876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832335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76300" y="838200"/>
            <a:ext cx="67437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ity and accuracy studies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, DPPH**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leaf disc assay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0067229"/>
              </p:ext>
            </p:extLst>
          </p:nvPr>
        </p:nvGraphicFramePr>
        <p:xfrm>
          <a:off x="1143000" y="1600200"/>
          <a:ext cx="6477000" cy="1543685"/>
        </p:xfrm>
        <a:graphic>
          <a:graphicData uri="http://schemas.openxmlformats.org/drawingml/2006/table">
            <a:tbl>
              <a:tblPr firstRow="1" firstCol="1" bandRow="1"/>
              <a:tblGrid>
                <a:gridCol w="161318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4130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3141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8871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8871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3141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8871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993519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</a:tblGrid>
              <a:tr h="203835">
                <a:tc row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af material 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af disc range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rrelation coefficient (r</a:t>
                      </a:r>
                      <a:r>
                        <a:rPr lang="en-US" sz="1200" b="1" baseline="30000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ntra-assay precision (%CV)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38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BT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DPP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PR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BT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DPP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PR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pinac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5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663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9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41.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2.9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7.4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ale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1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67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45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2.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8.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llard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78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616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4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6.6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55.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6.5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ustard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5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13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0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4.4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8.8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Watermelon plant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99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2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32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0.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37.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4.7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72361" y="3302000"/>
            <a:ext cx="716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Results at 60 min of incubation time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Results at 20 min of incubation tim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00647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58505" y="914400"/>
            <a:ext cx="7239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ity and accuracy studies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, DPPH**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R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leaf disc assay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4767362"/>
              </p:ext>
            </p:extLst>
          </p:nvPr>
        </p:nvGraphicFramePr>
        <p:xfrm>
          <a:off x="838200" y="1524000"/>
          <a:ext cx="6705600" cy="1543685"/>
        </p:xfrm>
        <a:graphic>
          <a:graphicData uri="http://schemas.openxmlformats.org/drawingml/2006/table">
            <a:tbl>
              <a:tblPr firstRow="1" firstCol="1" bandRow="1"/>
              <a:tblGrid>
                <a:gridCol w="171695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2372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8598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4823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4823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8598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74823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748237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</a:tblGrid>
              <a:tr h="203835">
                <a:tc row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af material 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Leaf disc range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rrelation coefficient (r</a:t>
                      </a:r>
                      <a:r>
                        <a:rPr lang="en-US" sz="1200" b="1" baseline="30000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Intra-assay precision (%CV)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38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BT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DPP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PR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BT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DPP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222222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PR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pinach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857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0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9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36.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4.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8.29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ale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63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29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6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2.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30.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5.0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llards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857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79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55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2.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0.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8.06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ustard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20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-0.96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899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5.76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5.2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2.35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Watermelon plant</a:t>
                      </a:r>
                      <a:endParaRPr lang="en-US" sz="11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-4</a:t>
                      </a:r>
                      <a:endParaRPr lang="en-US" sz="11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924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646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0.373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12.8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34.1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7.52</a:t>
                      </a: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38200" y="3124200"/>
            <a:ext cx="716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Results at 120 min of incubation time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Results at 30 min of incubation tim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5381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4575691"/>
              </p:ext>
            </p:extLst>
          </p:nvPr>
        </p:nvGraphicFramePr>
        <p:xfrm>
          <a:off x="2286000" y="1600200"/>
          <a:ext cx="50292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304800" y="4800600"/>
            <a:ext cx="85344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timal dilution for ABTS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gen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ltr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olet-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sibl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rption spectra o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ueous ABTS reagent at its different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lution ratios. Based on absorption maxima at 730 nm, 1:30 dilution was selected for leaf disc assay.</a:t>
            </a:r>
          </a:p>
        </p:txBody>
      </p:sp>
    </p:spTree>
    <p:extLst>
      <p:ext uri="{BB962C8B-B14F-4D97-AF65-F5344CB8AC3E}">
        <p14:creationId xmlns:p14="http://schemas.microsoft.com/office/powerpoint/2010/main" val="36261913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828800" y="4179277"/>
            <a:ext cx="8382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absorption spectrum of DPPH reagent at concentration 0.102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3692377"/>
              </p:ext>
            </p:extLst>
          </p:nvPr>
        </p:nvGraphicFramePr>
        <p:xfrm>
          <a:off x="2438400" y="1447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760565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1752182"/>
              </p:ext>
            </p:extLst>
          </p:nvPr>
        </p:nvGraphicFramePr>
        <p:xfrm>
          <a:off x="2286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angle 4"/>
          <p:cNvSpPr/>
          <p:nvPr/>
        </p:nvSpPr>
        <p:spPr>
          <a:xfrm>
            <a:off x="381000" y="5105400"/>
            <a:ext cx="8382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absorption spectrum of aqueous KMnO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lution at concentration 1.00, 0.50 and 0.25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134872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914400" y="5273040"/>
            <a:ext cx="7543800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.</a:t>
            </a: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Leaf disc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number dependent color change in the DPPH, ABTS and PPR leaf disc assays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45720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87388" algn="l"/>
              </a:tabLst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7B385379-9BDB-4318-9069-928FEA3D2E69}"/>
              </a:ext>
            </a:extLst>
          </p:cNvPr>
          <p:cNvGrpSpPr/>
          <p:nvPr/>
        </p:nvGrpSpPr>
        <p:grpSpPr>
          <a:xfrm>
            <a:off x="1874225" y="685798"/>
            <a:ext cx="4602775" cy="4434842"/>
            <a:chOff x="1874225" y="685798"/>
            <a:chExt cx="4602775" cy="4434842"/>
          </a:xfrm>
        </p:grpSpPr>
        <p:pic>
          <p:nvPicPr>
            <p:cNvPr id="1025" name="Picture 1"/>
            <p:cNvPicPr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7114" y="685800"/>
              <a:ext cx="3939886" cy="44348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 rot="16200000">
              <a:off x="947114" y="1612909"/>
              <a:ext cx="237744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ubation of reagents with leaf disc 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183335" y="3906530"/>
              <a:ext cx="1905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gents after incuba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071114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066800" y="6208447"/>
            <a:ext cx="70104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87388" algn="l"/>
              </a:tabLst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5. </a:t>
            </a:r>
            <a:r>
              <a: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lation between the weight of different vegetable leaf disc(s) with percent activity in ABTS (A-E), DPPH (F-J) and PPR (K-O) of incubation time.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753427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87388" algn="l"/>
              </a:tabLst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970032" y="220808"/>
            <a:ext cx="4594336" cy="5987639"/>
            <a:chOff x="1970032" y="220808"/>
            <a:chExt cx="4594336" cy="5987639"/>
          </a:xfrm>
        </p:grpSpPr>
        <p:pic>
          <p:nvPicPr>
            <p:cNvPr id="2049" name="Picture 36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0032" y="432487"/>
              <a:ext cx="4594336" cy="57759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396276" y="220808"/>
              <a:ext cx="11089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US" sz="1050" dirty="0" err="1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BTS</a:t>
              </a:r>
              <a:r>
                <a:rPr lang="en-US" altLang="en-US" sz="105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at 30 min</a:t>
              </a:r>
              <a:endParaRPr lang="en-US" sz="105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3886200" y="228502"/>
              <a:ext cx="1104790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105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DPPH at 10 min </a:t>
              </a:r>
              <a:endParaRPr lang="en-US" sz="1050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5385972" y="237590"/>
              <a:ext cx="1032655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en-US" sz="1050" dirty="0" err="1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PR</a:t>
              </a:r>
              <a:r>
                <a:rPr lang="en-US" altLang="en-US" sz="105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at 30 min </a:t>
              </a:r>
              <a:endParaRPr 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35174620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438400" y="762000"/>
            <a:ext cx="3657600" cy="3829050"/>
            <a:chOff x="0" y="0"/>
            <a:chExt cx="3657600" cy="3829050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0036902"/>
                </p:ext>
              </p:extLst>
            </p:nvPr>
          </p:nvGraphicFramePr>
          <p:xfrm>
            <a:off x="0" y="85725"/>
            <a:ext cx="36576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13542696"/>
                </p:ext>
              </p:extLst>
            </p:nvPr>
          </p:nvGraphicFramePr>
          <p:xfrm>
            <a:off x="0" y="2000250"/>
            <a:ext cx="36576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" name="TextBox 6"/>
            <p:cNvSpPr txBox="1"/>
            <p:nvPr/>
          </p:nvSpPr>
          <p:spPr>
            <a:xfrm>
              <a:off x="19050" y="0"/>
              <a:ext cx="377796" cy="28020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/>
                <a:t>[A]</a:t>
              </a:r>
            </a:p>
          </p:txBody>
        </p:sp>
        <p:sp>
          <p:nvSpPr>
            <p:cNvPr id="14" name="TextBox 7"/>
            <p:cNvSpPr txBox="1"/>
            <p:nvPr/>
          </p:nvSpPr>
          <p:spPr>
            <a:xfrm>
              <a:off x="19050" y="1981200"/>
              <a:ext cx="377796" cy="28020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/>
                <a:t>[B]</a:t>
              </a:r>
            </a:p>
          </p:txBody>
        </p:sp>
      </p:grpSp>
      <p:sp>
        <p:nvSpPr>
          <p:cNvPr id="8" name="Rectangle 7"/>
          <p:cNvSpPr/>
          <p:nvPr/>
        </p:nvSpPr>
        <p:spPr>
          <a:xfrm>
            <a:off x="1676400" y="4676775"/>
            <a:ext cx="63246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V-visible absorption spectra of various lea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spended in wate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t, which shows hydrophili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unds oozes out from the leaf disc into the water after 30 min of incubation, (B)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ning UV-visible absorption spectra of various leaf disc suspended in wate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tract, which indicate lipophilic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ydrophilic antioxidants including chlorophyll comes out from the leaf disc into the methanol after 10 min of incubation.</a:t>
            </a:r>
          </a:p>
        </p:txBody>
      </p:sp>
    </p:spTree>
    <p:extLst>
      <p:ext uri="{BB962C8B-B14F-4D97-AF65-F5344CB8AC3E}">
        <p14:creationId xmlns:p14="http://schemas.microsoft.com/office/powerpoint/2010/main" val="27900375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571500" y="5203841"/>
            <a:ext cx="80010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just"/>
            <a:r>
              <a:rPr lang="en-US" altLang="en-US" sz="1400" b="1" dirty="0"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Fig. S</a:t>
            </a:r>
            <a:r>
              <a:rPr kumimoji="0" lang="en-US" altLang="en-US" sz="1400" b="1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itchFamily="18" charset="0"/>
                <a:cs typeface="Times New Roman" panose="02020603050405020304" pitchFamily="18" charset="0"/>
              </a:rPr>
              <a:t>7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LC profiles of various leaf disc suspended and cell-free aqueous extracts at 280 nm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 in absorption intensities of leaf disc suspended and cell-free extracts is not only linked with different amount of leaf tissue used for extraction, but also with diverse extraction efficiency in these two methods.</a:t>
            </a:r>
            <a:endParaRPr kumimoji="0" lang="en-US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3152775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687388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87388" algn="l"/>
              </a:tabLst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1219200"/>
            <a:ext cx="6656832" cy="3761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0459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81000" y="3733800"/>
            <a:ext cx="83058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reaction media (water and methanol) on percent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dical scavenging activity of unprimed, hydroprimed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loprime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100 and 200 ppm concentration of magnesium sulfate (MgSO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zinc sulfate (ZnSO</a:t>
            </a:r>
            <a:r>
              <a:rPr lang="en-US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) diploid (A) and triploid (B) watermelon seedling samples.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anoli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gent shows more radical scavenging activity than the aqueous regent. Compare to DPPH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anoli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TS reagent based leaf disc estimates more antioxidant capacity. Results are expressed as Mean ±S.E. 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805" y="990600"/>
            <a:ext cx="7736190" cy="2513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1434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918</TotalTime>
  <Words>710</Words>
  <Application>Microsoft Office PowerPoint</Application>
  <PresentationFormat>On-screen Show (4:3)</PresentationFormat>
  <Paragraphs>163</Paragraphs>
  <Slides>13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ote, Deepak M</dc:creator>
  <cp:lastModifiedBy>Kasote, Deepak M</cp:lastModifiedBy>
  <cp:revision>124</cp:revision>
  <cp:lastPrinted>2018-05-22T13:28:25Z</cp:lastPrinted>
  <dcterms:created xsi:type="dcterms:W3CDTF">2017-10-26T21:56:17Z</dcterms:created>
  <dcterms:modified xsi:type="dcterms:W3CDTF">2019-01-09T21:16:17Z</dcterms:modified>
</cp:coreProperties>
</file>